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73" r:id="rId3"/>
    <p:sldId id="274" r:id="rId4"/>
    <p:sldId id="271" r:id="rId5"/>
    <p:sldId id="272" r:id="rId6"/>
    <p:sldId id="270" r:id="rId7"/>
  </p:sldIdLst>
  <p:sldSz cx="12192000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60" d="100"/>
          <a:sy n="60" d="100"/>
        </p:scale>
        <p:origin x="96" y="11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81357058-C6DE-59F0-C0E0-1EFFA6A75B7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Alcím 2">
            <a:extLst>
              <a:ext uri="{FF2B5EF4-FFF2-40B4-BE49-F238E27FC236}">
                <a16:creationId xmlns:a16="http://schemas.microsoft.com/office/drawing/2014/main" id="{0AB3FDFD-D3F7-F4B4-889C-AD3AFB76710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/>
              <a:t>Kattintson ide az alcím mintájának szerkesztéséhez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828DFD10-7F25-DA70-D64D-E9C5E3501C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203AC-F278-4A60-84DA-28A411227A19}" type="datetimeFigureOut">
              <a:rPr lang="hu-HU" smtClean="0"/>
              <a:t>2024. 11. 20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9A377FE9-A468-3586-B937-B234C44441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A33C7807-0E7C-A359-356E-EDE1B8FB28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27FCB-FBCB-40F0-9415-DE9D0E4A7E0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7232931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0256B41E-08B3-F3F5-7D67-965CE01D10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59053B23-7BDD-1022-47DF-154B6C0E8C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80C8404B-1886-6EDF-AFF9-4A5DE76F6F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203AC-F278-4A60-84DA-28A411227A19}" type="datetimeFigureOut">
              <a:rPr lang="hu-HU" smtClean="0"/>
              <a:t>2024. 11. 20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3941F462-75B2-BD15-9339-7F79B15189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EA1E9DF2-FCC2-CF82-4F68-572065F1C9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27FCB-FBCB-40F0-9415-DE9D0E4A7E0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3251860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>
            <a:extLst>
              <a:ext uri="{FF2B5EF4-FFF2-40B4-BE49-F238E27FC236}">
                <a16:creationId xmlns:a16="http://schemas.microsoft.com/office/drawing/2014/main" id="{A4318DA1-6ECF-A106-958A-A94CA35D522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4B892D17-8A5B-4162-5F94-F1B14AF272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07E9E83A-0227-FFE0-6C87-AB4D2934FA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203AC-F278-4A60-84DA-28A411227A19}" type="datetimeFigureOut">
              <a:rPr lang="hu-HU" smtClean="0"/>
              <a:t>2024. 11. 20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44DA93F7-4EB9-18BB-D5D9-A858EC8EEC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96BA8732-FDD9-CB3C-40CE-D72756E269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27FCB-FBCB-40F0-9415-DE9D0E4A7E0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1104742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B4DC8DF7-2488-06F2-A803-397D3CCE37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14649682-6191-DABA-98B9-8E3B1D24C5C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9BDA4BD8-2B6A-B8AE-515E-1DB00CCF43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203AC-F278-4A60-84DA-28A411227A19}" type="datetimeFigureOut">
              <a:rPr lang="hu-HU" smtClean="0"/>
              <a:t>2024. 11. 20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B970FB38-9BF0-7FB3-0422-23CC445032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BF2DD084-29FC-5BC0-FB2D-ADF6CD9475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27FCB-FBCB-40F0-9415-DE9D0E4A7E0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5670527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0C53CA63-F826-AB6B-0A84-AA9B5B125A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EC1A2412-B093-458E-F45E-4471873A17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A33D30A9-0361-A8F7-F548-3E79C4B4AA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203AC-F278-4A60-84DA-28A411227A19}" type="datetimeFigureOut">
              <a:rPr lang="hu-HU" smtClean="0"/>
              <a:t>2024. 11. 20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A42F2718-CEBF-DA77-C5FC-7AF36B904C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E12FCFB5-3DB2-B208-7DAE-42E15CC37A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27FCB-FBCB-40F0-9415-DE9D0E4A7E0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5297580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EE27AA23-5778-AABB-0114-C1A5A7D061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E2DCC073-0483-5A96-31CE-771DF0EA51E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972F8E58-581C-01BF-15DD-E79D6D2A53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2DA6FF77-B55C-A4A3-7063-024513C71E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203AC-F278-4A60-84DA-28A411227A19}" type="datetimeFigureOut">
              <a:rPr lang="hu-HU" smtClean="0"/>
              <a:t>2024. 11. 20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45272A75-C60F-B8F3-6B3F-EADD8004AF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61B10583-2774-7E64-9F47-2005AE1939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27FCB-FBCB-40F0-9415-DE9D0E4A7E0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941290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25BD376C-D346-209C-2BE2-4DF5C51169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C8FDFBBD-27A8-086C-A4D5-A37E26F298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38A47F0F-D186-837E-C188-2658BBF1F2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Szöveg helye 4">
            <a:extLst>
              <a:ext uri="{FF2B5EF4-FFF2-40B4-BE49-F238E27FC236}">
                <a16:creationId xmlns:a16="http://schemas.microsoft.com/office/drawing/2014/main" id="{EC0FC471-F6A3-43EC-F742-ADE4AF8F10D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Tartalom helye 5">
            <a:extLst>
              <a:ext uri="{FF2B5EF4-FFF2-40B4-BE49-F238E27FC236}">
                <a16:creationId xmlns:a16="http://schemas.microsoft.com/office/drawing/2014/main" id="{F5756E2D-64D1-AC9A-744E-2A2A2F1D73B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7" name="Dátum helye 6">
            <a:extLst>
              <a:ext uri="{FF2B5EF4-FFF2-40B4-BE49-F238E27FC236}">
                <a16:creationId xmlns:a16="http://schemas.microsoft.com/office/drawing/2014/main" id="{2E51E702-BF3F-373D-6399-00E7C4D640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203AC-F278-4A60-84DA-28A411227A19}" type="datetimeFigureOut">
              <a:rPr lang="hu-HU" smtClean="0"/>
              <a:t>2024. 11. 20.</a:t>
            </a:fld>
            <a:endParaRPr lang="hu-HU"/>
          </a:p>
        </p:txBody>
      </p:sp>
      <p:sp>
        <p:nvSpPr>
          <p:cNvPr id="8" name="Élőláb helye 7">
            <a:extLst>
              <a:ext uri="{FF2B5EF4-FFF2-40B4-BE49-F238E27FC236}">
                <a16:creationId xmlns:a16="http://schemas.microsoft.com/office/drawing/2014/main" id="{DB5F6979-65AA-BEC3-E113-06BC19F700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>
            <a:extLst>
              <a:ext uri="{FF2B5EF4-FFF2-40B4-BE49-F238E27FC236}">
                <a16:creationId xmlns:a16="http://schemas.microsoft.com/office/drawing/2014/main" id="{36E6F181-59DE-F80B-48D5-45EF99DB0D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27FCB-FBCB-40F0-9415-DE9D0E4A7E0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9684768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9E9BA05A-D81F-2A7A-D8DE-116AA1D80B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Dátum helye 2">
            <a:extLst>
              <a:ext uri="{FF2B5EF4-FFF2-40B4-BE49-F238E27FC236}">
                <a16:creationId xmlns:a16="http://schemas.microsoft.com/office/drawing/2014/main" id="{A7E3364C-F2AB-FB4C-4E08-3A6F502A6C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203AC-F278-4A60-84DA-28A411227A19}" type="datetimeFigureOut">
              <a:rPr lang="hu-HU" smtClean="0"/>
              <a:t>2024. 11. 20.</a:t>
            </a:fld>
            <a:endParaRPr lang="hu-HU"/>
          </a:p>
        </p:txBody>
      </p:sp>
      <p:sp>
        <p:nvSpPr>
          <p:cNvPr id="4" name="Élőláb helye 3">
            <a:extLst>
              <a:ext uri="{FF2B5EF4-FFF2-40B4-BE49-F238E27FC236}">
                <a16:creationId xmlns:a16="http://schemas.microsoft.com/office/drawing/2014/main" id="{C9E99AEF-93F9-907E-9B00-1D5D452C13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>
            <a:extLst>
              <a:ext uri="{FF2B5EF4-FFF2-40B4-BE49-F238E27FC236}">
                <a16:creationId xmlns:a16="http://schemas.microsoft.com/office/drawing/2014/main" id="{94418DB4-7840-DEBF-847B-9B85738558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27FCB-FBCB-40F0-9415-DE9D0E4A7E0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1814476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>
            <a:extLst>
              <a:ext uri="{FF2B5EF4-FFF2-40B4-BE49-F238E27FC236}">
                <a16:creationId xmlns:a16="http://schemas.microsoft.com/office/drawing/2014/main" id="{2383E56F-CEAE-C8AD-47BB-1AA8255F14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203AC-F278-4A60-84DA-28A411227A19}" type="datetimeFigureOut">
              <a:rPr lang="hu-HU" smtClean="0"/>
              <a:t>2024. 11. 20.</a:t>
            </a:fld>
            <a:endParaRPr lang="hu-HU"/>
          </a:p>
        </p:txBody>
      </p:sp>
      <p:sp>
        <p:nvSpPr>
          <p:cNvPr id="3" name="Élőláb helye 2">
            <a:extLst>
              <a:ext uri="{FF2B5EF4-FFF2-40B4-BE49-F238E27FC236}">
                <a16:creationId xmlns:a16="http://schemas.microsoft.com/office/drawing/2014/main" id="{F7FCA59F-23A5-A52C-41F8-400F6BDCF9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>
            <a:extLst>
              <a:ext uri="{FF2B5EF4-FFF2-40B4-BE49-F238E27FC236}">
                <a16:creationId xmlns:a16="http://schemas.microsoft.com/office/drawing/2014/main" id="{DECDD9A1-8745-A26D-A13A-E8D843B197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27FCB-FBCB-40F0-9415-DE9D0E4A7E0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3835605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8D728FE8-EA2E-1540-C146-2F6D46B014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83FABCBD-06DF-C6DD-C6B3-F9676FED88D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28C962C4-899E-3774-1B5A-87D40B5B64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001D7663-0C34-B098-0CB0-113148BC9A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203AC-F278-4A60-84DA-28A411227A19}" type="datetimeFigureOut">
              <a:rPr lang="hu-HU" smtClean="0"/>
              <a:t>2024. 11. 20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32A14BD7-257B-92CA-A49B-69B738A391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FE1DCD2C-7350-EDB4-B683-58A29CD8EF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27FCB-FBCB-40F0-9415-DE9D0E4A7E0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8676750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39146A51-EB3E-0FB2-E1BE-6C51D335FD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Kép helye 2">
            <a:extLst>
              <a:ext uri="{FF2B5EF4-FFF2-40B4-BE49-F238E27FC236}">
                <a16:creationId xmlns:a16="http://schemas.microsoft.com/office/drawing/2014/main" id="{6E6EA26D-1B40-C47C-7AF8-CFEA1BA5567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FC7496B7-C050-4B13-B059-8400E48694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A97EC356-D15D-F0E9-80C1-CCBC239939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203AC-F278-4A60-84DA-28A411227A19}" type="datetimeFigureOut">
              <a:rPr lang="hu-HU" smtClean="0"/>
              <a:t>2024. 11. 20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64F1085C-CC0C-EDCA-28CF-8415BBF7EB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94F0505C-2102-8235-09BB-2834102645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27FCB-FBCB-40F0-9415-DE9D0E4A7E0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2177298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>
            <a:extLst>
              <a:ext uri="{FF2B5EF4-FFF2-40B4-BE49-F238E27FC236}">
                <a16:creationId xmlns:a16="http://schemas.microsoft.com/office/drawing/2014/main" id="{56C8F0AB-F80B-5696-CBFC-ABB1DD1D85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DE9C4377-ABFF-4D5F-FF52-AF5C127FE1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8835DC24-D4BC-081B-81AB-B2FCE3A4CB8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C203AC-F278-4A60-84DA-28A411227A19}" type="datetimeFigureOut">
              <a:rPr lang="hu-HU" smtClean="0"/>
              <a:t>2024. 11. 20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D00B323E-1A27-0E67-EA2F-62F18A57659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8626B98F-ADDE-043B-E23A-B97CA1BF54A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927FCB-FBCB-40F0-9415-DE9D0E4A7E02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6547895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Csoportba foglalás 3">
            <a:extLst>
              <a:ext uri="{FF2B5EF4-FFF2-40B4-BE49-F238E27FC236}">
                <a16:creationId xmlns:a16="http://schemas.microsoft.com/office/drawing/2014/main" id="{ABDA4716-DF77-44C5-90F7-B559A266AC67}"/>
              </a:ext>
            </a:extLst>
          </p:cNvPr>
          <p:cNvGrpSpPr/>
          <p:nvPr/>
        </p:nvGrpSpPr>
        <p:grpSpPr>
          <a:xfrm>
            <a:off x="-290549" y="66133"/>
            <a:ext cx="12583386" cy="6714482"/>
            <a:chOff x="-290549" y="66133"/>
            <a:chExt cx="12583386" cy="6714482"/>
          </a:xfrm>
        </p:grpSpPr>
        <p:pic>
          <p:nvPicPr>
            <p:cNvPr id="170" name="Kép 169">
              <a:extLst>
                <a:ext uri="{FF2B5EF4-FFF2-40B4-BE49-F238E27FC236}">
                  <a16:creationId xmlns:a16="http://schemas.microsoft.com/office/drawing/2014/main" id="{0B46DB48-DBF7-B6AE-355A-FFCA2BADF07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8638" t="11393" r="1526" b="17312"/>
            <a:stretch/>
          </p:blipFill>
          <p:spPr>
            <a:xfrm>
              <a:off x="5261436" y="2802584"/>
              <a:ext cx="1817432" cy="1521152"/>
            </a:xfrm>
            <a:prstGeom prst="rect">
              <a:avLst/>
            </a:prstGeom>
          </p:spPr>
        </p:pic>
        <p:grpSp>
          <p:nvGrpSpPr>
            <p:cNvPr id="143" name="Csoportba foglalás 142">
              <a:extLst>
                <a:ext uri="{FF2B5EF4-FFF2-40B4-BE49-F238E27FC236}">
                  <a16:creationId xmlns:a16="http://schemas.microsoft.com/office/drawing/2014/main" id="{507ED04F-2E68-93DE-63D7-9702D3EA083B}"/>
                </a:ext>
              </a:extLst>
            </p:cNvPr>
            <p:cNvGrpSpPr/>
            <p:nvPr/>
          </p:nvGrpSpPr>
          <p:grpSpPr>
            <a:xfrm>
              <a:off x="31731" y="685538"/>
              <a:ext cx="2461245" cy="1917637"/>
              <a:chOff x="31731" y="685538"/>
              <a:chExt cx="2461245" cy="1917637"/>
            </a:xfrm>
          </p:grpSpPr>
          <p:pic>
            <p:nvPicPr>
              <p:cNvPr id="13" name="Kép 12">
                <a:extLst>
                  <a:ext uri="{FF2B5EF4-FFF2-40B4-BE49-F238E27FC236}">
                    <a16:creationId xmlns:a16="http://schemas.microsoft.com/office/drawing/2014/main" id="{1795C817-21A4-CD34-8F04-B9B7237B1A5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18120" t="11146" b="14669"/>
              <a:stretch/>
            </p:blipFill>
            <p:spPr>
              <a:xfrm>
                <a:off x="463550" y="734937"/>
                <a:ext cx="1863993" cy="1582813"/>
              </a:xfrm>
              <a:prstGeom prst="rect">
                <a:avLst/>
              </a:prstGeom>
            </p:spPr>
          </p:pic>
          <p:sp>
            <p:nvSpPr>
              <p:cNvPr id="18" name="Szövegdoboz 17">
                <a:extLst>
                  <a:ext uri="{FF2B5EF4-FFF2-40B4-BE49-F238E27FC236}">
                    <a16:creationId xmlns:a16="http://schemas.microsoft.com/office/drawing/2014/main" id="{528D7C83-A5B9-4424-C5AE-683DE805EC85}"/>
                  </a:ext>
                </a:extLst>
              </p:cNvPr>
              <p:cNvSpPr txBox="1"/>
              <p:nvPr/>
            </p:nvSpPr>
            <p:spPr>
              <a:xfrm>
                <a:off x="2002286" y="2249451"/>
                <a:ext cx="49069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24</a:t>
                </a:r>
              </a:p>
            </p:txBody>
          </p:sp>
          <p:sp>
            <p:nvSpPr>
              <p:cNvPr id="19" name="Szövegdoboz 18">
                <a:extLst>
                  <a:ext uri="{FF2B5EF4-FFF2-40B4-BE49-F238E27FC236}">
                    <a16:creationId xmlns:a16="http://schemas.microsoft.com/office/drawing/2014/main" id="{671B1D4F-D027-6F85-5A5F-BFB00EC6ABF3}"/>
                  </a:ext>
                </a:extLst>
              </p:cNvPr>
              <p:cNvSpPr txBox="1"/>
              <p:nvPr/>
            </p:nvSpPr>
            <p:spPr>
              <a:xfrm>
                <a:off x="512219" y="2341565"/>
                <a:ext cx="1733011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SSC-H</a:t>
                </a:r>
              </a:p>
            </p:txBody>
          </p:sp>
          <p:sp>
            <p:nvSpPr>
              <p:cNvPr id="20" name="Szövegdoboz 19">
                <a:extLst>
                  <a:ext uri="{FF2B5EF4-FFF2-40B4-BE49-F238E27FC236}">
                    <a16:creationId xmlns:a16="http://schemas.microsoft.com/office/drawing/2014/main" id="{6FD142C1-361F-0CA9-CBEB-685B3FE6A940}"/>
                  </a:ext>
                </a:extLst>
              </p:cNvPr>
              <p:cNvSpPr txBox="1"/>
              <p:nvPr/>
            </p:nvSpPr>
            <p:spPr>
              <a:xfrm rot="16200000">
                <a:off x="-557696" y="1395662"/>
                <a:ext cx="144046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SSC-W</a:t>
                </a:r>
              </a:p>
            </p:txBody>
          </p:sp>
          <p:sp>
            <p:nvSpPr>
              <p:cNvPr id="21" name="Szövegdoboz 20">
                <a:extLst>
                  <a:ext uri="{FF2B5EF4-FFF2-40B4-BE49-F238E27FC236}">
                    <a16:creationId xmlns:a16="http://schemas.microsoft.com/office/drawing/2014/main" id="{57E16F24-7AAC-6DC6-B402-425FC0B7A634}"/>
                  </a:ext>
                </a:extLst>
              </p:cNvPr>
              <p:cNvSpPr txBox="1"/>
              <p:nvPr/>
            </p:nvSpPr>
            <p:spPr>
              <a:xfrm>
                <a:off x="271901" y="2121131"/>
                <a:ext cx="24031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2" name="Szövegdoboz 21">
                <a:extLst>
                  <a:ext uri="{FF2B5EF4-FFF2-40B4-BE49-F238E27FC236}">
                    <a16:creationId xmlns:a16="http://schemas.microsoft.com/office/drawing/2014/main" id="{869785C3-B848-4BCA-F8E9-BA5FAF801C37}"/>
                  </a:ext>
                </a:extLst>
              </p:cNvPr>
              <p:cNvSpPr txBox="1"/>
              <p:nvPr/>
            </p:nvSpPr>
            <p:spPr>
              <a:xfrm>
                <a:off x="671326" y="2250927"/>
                <a:ext cx="57100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256</a:t>
                </a:r>
              </a:p>
            </p:txBody>
          </p:sp>
          <p:sp>
            <p:nvSpPr>
              <p:cNvPr id="23" name="Szövegdoboz 22">
                <a:extLst>
                  <a:ext uri="{FF2B5EF4-FFF2-40B4-BE49-F238E27FC236}">
                    <a16:creationId xmlns:a16="http://schemas.microsoft.com/office/drawing/2014/main" id="{C4ECEFC7-4BFD-CB1F-F466-D45DC220EAF8}"/>
                  </a:ext>
                </a:extLst>
              </p:cNvPr>
              <p:cNvSpPr txBox="1"/>
              <p:nvPr/>
            </p:nvSpPr>
            <p:spPr>
              <a:xfrm>
                <a:off x="1523260" y="2253702"/>
                <a:ext cx="57100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768</a:t>
                </a:r>
              </a:p>
            </p:txBody>
          </p:sp>
          <p:sp>
            <p:nvSpPr>
              <p:cNvPr id="24" name="Szövegdoboz 23">
                <a:extLst>
                  <a:ext uri="{FF2B5EF4-FFF2-40B4-BE49-F238E27FC236}">
                    <a16:creationId xmlns:a16="http://schemas.microsoft.com/office/drawing/2014/main" id="{5B3F8C48-BE13-1118-524D-6C74EBE5A2C6}"/>
                  </a:ext>
                </a:extLst>
              </p:cNvPr>
              <p:cNvSpPr txBox="1"/>
              <p:nvPr/>
            </p:nvSpPr>
            <p:spPr>
              <a:xfrm>
                <a:off x="166429" y="1399802"/>
                <a:ext cx="39388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512</a:t>
                </a:r>
              </a:p>
            </p:txBody>
          </p:sp>
          <p:sp>
            <p:nvSpPr>
              <p:cNvPr id="25" name="Szövegdoboz 24">
                <a:extLst>
                  <a:ext uri="{FF2B5EF4-FFF2-40B4-BE49-F238E27FC236}">
                    <a16:creationId xmlns:a16="http://schemas.microsoft.com/office/drawing/2014/main" id="{6B38A502-C48F-8FD3-6C0F-11EC9AF5F658}"/>
                  </a:ext>
                </a:extLst>
              </p:cNvPr>
              <p:cNvSpPr txBox="1"/>
              <p:nvPr/>
            </p:nvSpPr>
            <p:spPr>
              <a:xfrm>
                <a:off x="294799" y="2250927"/>
                <a:ext cx="4425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6" name="Szövegdoboz 25">
                <a:extLst>
                  <a:ext uri="{FF2B5EF4-FFF2-40B4-BE49-F238E27FC236}">
                    <a16:creationId xmlns:a16="http://schemas.microsoft.com/office/drawing/2014/main" id="{6E226529-A639-4834-46C3-E6A565B18331}"/>
                  </a:ext>
                </a:extLst>
              </p:cNvPr>
              <p:cNvSpPr txBox="1"/>
              <p:nvPr/>
            </p:nvSpPr>
            <p:spPr>
              <a:xfrm>
                <a:off x="156441" y="1761760"/>
                <a:ext cx="39388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256</a:t>
                </a:r>
              </a:p>
            </p:txBody>
          </p:sp>
          <p:sp>
            <p:nvSpPr>
              <p:cNvPr id="27" name="Szövegdoboz 26">
                <a:extLst>
                  <a:ext uri="{FF2B5EF4-FFF2-40B4-BE49-F238E27FC236}">
                    <a16:creationId xmlns:a16="http://schemas.microsoft.com/office/drawing/2014/main" id="{5CCAE0AE-692B-D637-F9B1-81FCC3E2EDBD}"/>
                  </a:ext>
                </a:extLst>
              </p:cNvPr>
              <p:cNvSpPr txBox="1"/>
              <p:nvPr/>
            </p:nvSpPr>
            <p:spPr>
              <a:xfrm>
                <a:off x="119048" y="685538"/>
                <a:ext cx="44250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24</a:t>
                </a:r>
              </a:p>
            </p:txBody>
          </p:sp>
          <p:sp>
            <p:nvSpPr>
              <p:cNvPr id="28" name="Szövegdoboz 27">
                <a:extLst>
                  <a:ext uri="{FF2B5EF4-FFF2-40B4-BE49-F238E27FC236}">
                    <a16:creationId xmlns:a16="http://schemas.microsoft.com/office/drawing/2014/main" id="{36AE184B-AB3E-B3A5-A380-9324917AA998}"/>
                  </a:ext>
                </a:extLst>
              </p:cNvPr>
              <p:cNvSpPr txBox="1"/>
              <p:nvPr/>
            </p:nvSpPr>
            <p:spPr>
              <a:xfrm>
                <a:off x="166430" y="1043206"/>
                <a:ext cx="39388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768</a:t>
                </a:r>
              </a:p>
            </p:txBody>
          </p:sp>
          <p:sp>
            <p:nvSpPr>
              <p:cNvPr id="29" name="Szövegdoboz 28">
                <a:extLst>
                  <a:ext uri="{FF2B5EF4-FFF2-40B4-BE49-F238E27FC236}">
                    <a16:creationId xmlns:a16="http://schemas.microsoft.com/office/drawing/2014/main" id="{9C2F2BB3-2A39-A6FC-B469-581E5718DCE2}"/>
                  </a:ext>
                </a:extLst>
              </p:cNvPr>
              <p:cNvSpPr txBox="1"/>
              <p:nvPr/>
            </p:nvSpPr>
            <p:spPr>
              <a:xfrm>
                <a:off x="1097479" y="2250867"/>
                <a:ext cx="57100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512</a:t>
                </a:r>
              </a:p>
            </p:txBody>
          </p:sp>
        </p:grpSp>
        <p:grpSp>
          <p:nvGrpSpPr>
            <p:cNvPr id="136" name="Csoportba foglalás 135">
              <a:extLst>
                <a:ext uri="{FF2B5EF4-FFF2-40B4-BE49-F238E27FC236}">
                  <a16:creationId xmlns:a16="http://schemas.microsoft.com/office/drawing/2014/main" id="{6D8B07F2-F806-5657-5B03-78F4CDCF6FFC}"/>
                </a:ext>
              </a:extLst>
            </p:cNvPr>
            <p:cNvGrpSpPr/>
            <p:nvPr/>
          </p:nvGrpSpPr>
          <p:grpSpPr>
            <a:xfrm>
              <a:off x="7438362" y="2766152"/>
              <a:ext cx="2197877" cy="1878156"/>
              <a:chOff x="7438362" y="2766152"/>
              <a:chExt cx="2197877" cy="1878156"/>
            </a:xfrm>
          </p:grpSpPr>
          <p:pic>
            <p:nvPicPr>
              <p:cNvPr id="5" name="Kép 4">
                <a:extLst>
                  <a:ext uri="{FF2B5EF4-FFF2-40B4-BE49-F238E27FC236}">
                    <a16:creationId xmlns:a16="http://schemas.microsoft.com/office/drawing/2014/main" id="{AFF264C6-9FCD-1315-BBAE-D6C25E09C74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19015" t="11392" b="17314"/>
              <a:stretch/>
            </p:blipFill>
            <p:spPr>
              <a:xfrm>
                <a:off x="7699761" y="2811566"/>
                <a:ext cx="1843587" cy="1521152"/>
              </a:xfrm>
              <a:prstGeom prst="rect">
                <a:avLst/>
              </a:prstGeom>
            </p:spPr>
          </p:pic>
          <p:sp>
            <p:nvSpPr>
              <p:cNvPr id="30" name="Szövegdoboz 29">
                <a:extLst>
                  <a:ext uri="{FF2B5EF4-FFF2-40B4-BE49-F238E27FC236}">
                    <a16:creationId xmlns:a16="http://schemas.microsoft.com/office/drawing/2014/main" id="{41273392-7D7C-6003-676D-28D2B4A360DD}"/>
                  </a:ext>
                </a:extLst>
              </p:cNvPr>
              <p:cNvSpPr txBox="1"/>
              <p:nvPr/>
            </p:nvSpPr>
            <p:spPr>
              <a:xfrm>
                <a:off x="7519072" y="4178077"/>
                <a:ext cx="20540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31" name="Szövegdoboz 30">
                <a:extLst>
                  <a:ext uri="{FF2B5EF4-FFF2-40B4-BE49-F238E27FC236}">
                    <a16:creationId xmlns:a16="http://schemas.microsoft.com/office/drawing/2014/main" id="{D588646A-2BF3-859B-6CF7-55FE07E16E82}"/>
                  </a:ext>
                </a:extLst>
              </p:cNvPr>
              <p:cNvSpPr txBox="1"/>
              <p:nvPr/>
            </p:nvSpPr>
            <p:spPr>
              <a:xfrm>
                <a:off x="7440056" y="3468686"/>
                <a:ext cx="3391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32" name="Szövegdoboz 31">
                <a:extLst>
                  <a:ext uri="{FF2B5EF4-FFF2-40B4-BE49-F238E27FC236}">
                    <a16:creationId xmlns:a16="http://schemas.microsoft.com/office/drawing/2014/main" id="{9D09B630-6480-125E-8320-B16D4003DB1C}"/>
                  </a:ext>
                </a:extLst>
              </p:cNvPr>
              <p:cNvSpPr txBox="1"/>
              <p:nvPr/>
            </p:nvSpPr>
            <p:spPr>
              <a:xfrm>
                <a:off x="7446432" y="3822294"/>
                <a:ext cx="33918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33" name="Szövegdoboz 32">
                <a:extLst>
                  <a:ext uri="{FF2B5EF4-FFF2-40B4-BE49-F238E27FC236}">
                    <a16:creationId xmlns:a16="http://schemas.microsoft.com/office/drawing/2014/main" id="{8603E857-9102-75D2-36C1-FDDED6D6D976}"/>
                  </a:ext>
                </a:extLst>
              </p:cNvPr>
              <p:cNvSpPr txBox="1"/>
              <p:nvPr/>
            </p:nvSpPr>
            <p:spPr>
              <a:xfrm>
                <a:off x="7438362" y="2766152"/>
                <a:ext cx="3391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34" name="Szövegdoboz 33">
                <a:extLst>
                  <a:ext uri="{FF2B5EF4-FFF2-40B4-BE49-F238E27FC236}">
                    <a16:creationId xmlns:a16="http://schemas.microsoft.com/office/drawing/2014/main" id="{A0AC7398-C145-DFEE-011A-DF30354D157E}"/>
                  </a:ext>
                </a:extLst>
              </p:cNvPr>
              <p:cNvSpPr txBox="1"/>
              <p:nvPr/>
            </p:nvSpPr>
            <p:spPr>
              <a:xfrm>
                <a:off x="7443184" y="3128739"/>
                <a:ext cx="3391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38" name="Szövegdoboz 37">
                <a:extLst>
                  <a:ext uri="{FF2B5EF4-FFF2-40B4-BE49-F238E27FC236}">
                    <a16:creationId xmlns:a16="http://schemas.microsoft.com/office/drawing/2014/main" id="{E6A40751-DACF-6431-7479-66DF6E5F4B1E}"/>
                  </a:ext>
                </a:extLst>
              </p:cNvPr>
              <p:cNvSpPr txBox="1"/>
              <p:nvPr/>
            </p:nvSpPr>
            <p:spPr>
              <a:xfrm>
                <a:off x="7535302" y="4291605"/>
                <a:ext cx="4425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40" name="Szövegdoboz 39">
                <a:extLst>
                  <a:ext uri="{FF2B5EF4-FFF2-40B4-BE49-F238E27FC236}">
                    <a16:creationId xmlns:a16="http://schemas.microsoft.com/office/drawing/2014/main" id="{291FB84A-AA9E-F774-1F76-7AB184FD481C}"/>
                  </a:ext>
                </a:extLst>
              </p:cNvPr>
              <p:cNvSpPr txBox="1"/>
              <p:nvPr/>
            </p:nvSpPr>
            <p:spPr>
              <a:xfrm>
                <a:off x="8018746" y="4289937"/>
                <a:ext cx="33918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41" name="Szövegdoboz 40">
                <a:extLst>
                  <a:ext uri="{FF2B5EF4-FFF2-40B4-BE49-F238E27FC236}">
                    <a16:creationId xmlns:a16="http://schemas.microsoft.com/office/drawing/2014/main" id="{86722ADD-CB83-8FBE-BC9F-CFC43106DA25}"/>
                  </a:ext>
                </a:extLst>
              </p:cNvPr>
              <p:cNvSpPr txBox="1"/>
              <p:nvPr/>
            </p:nvSpPr>
            <p:spPr>
              <a:xfrm>
                <a:off x="8441665" y="4280412"/>
                <a:ext cx="3391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42" name="Szövegdoboz 41">
                <a:extLst>
                  <a:ext uri="{FF2B5EF4-FFF2-40B4-BE49-F238E27FC236}">
                    <a16:creationId xmlns:a16="http://schemas.microsoft.com/office/drawing/2014/main" id="{F07C34D7-8A59-93E1-88B0-9AA106B57ED9}"/>
                  </a:ext>
                </a:extLst>
              </p:cNvPr>
              <p:cNvSpPr txBox="1"/>
              <p:nvPr/>
            </p:nvSpPr>
            <p:spPr>
              <a:xfrm>
                <a:off x="8867786" y="4284629"/>
                <a:ext cx="3391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43" name="Szövegdoboz 42">
                <a:extLst>
                  <a:ext uri="{FF2B5EF4-FFF2-40B4-BE49-F238E27FC236}">
                    <a16:creationId xmlns:a16="http://schemas.microsoft.com/office/drawing/2014/main" id="{FF3D93F2-1F9E-7A1F-F430-40BFE95A9AE3}"/>
                  </a:ext>
                </a:extLst>
              </p:cNvPr>
              <p:cNvSpPr txBox="1"/>
              <p:nvPr/>
            </p:nvSpPr>
            <p:spPr>
              <a:xfrm>
                <a:off x="9297056" y="4284123"/>
                <a:ext cx="3391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44" name="Szövegdoboz 43">
                <a:extLst>
                  <a:ext uri="{FF2B5EF4-FFF2-40B4-BE49-F238E27FC236}">
                    <a16:creationId xmlns:a16="http://schemas.microsoft.com/office/drawing/2014/main" id="{A47667EB-3C35-F519-340E-FC23F2ABEC3D}"/>
                  </a:ext>
                </a:extLst>
              </p:cNvPr>
              <p:cNvSpPr txBox="1"/>
              <p:nvPr/>
            </p:nvSpPr>
            <p:spPr>
              <a:xfrm>
                <a:off x="7740704" y="4382698"/>
                <a:ext cx="170629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CD4</a:t>
                </a:r>
              </a:p>
            </p:txBody>
          </p:sp>
        </p:grpSp>
        <p:sp>
          <p:nvSpPr>
            <p:cNvPr id="45" name="Szövegdoboz 44">
              <a:extLst>
                <a:ext uri="{FF2B5EF4-FFF2-40B4-BE49-F238E27FC236}">
                  <a16:creationId xmlns:a16="http://schemas.microsoft.com/office/drawing/2014/main" id="{F9066A1B-37D7-3029-0DE7-9A489C5BAD63}"/>
                </a:ext>
              </a:extLst>
            </p:cNvPr>
            <p:cNvSpPr txBox="1"/>
            <p:nvPr/>
          </p:nvSpPr>
          <p:spPr>
            <a:xfrm rot="16200000">
              <a:off x="6738759" y="3429175"/>
              <a:ext cx="144046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</a:p>
          </p:txBody>
        </p:sp>
        <p:grpSp>
          <p:nvGrpSpPr>
            <p:cNvPr id="137" name="Csoportba foglalás 136">
              <a:extLst>
                <a:ext uri="{FF2B5EF4-FFF2-40B4-BE49-F238E27FC236}">
                  <a16:creationId xmlns:a16="http://schemas.microsoft.com/office/drawing/2014/main" id="{70CC92FE-1634-01DF-39E5-6E402291707B}"/>
                </a:ext>
              </a:extLst>
            </p:cNvPr>
            <p:cNvGrpSpPr/>
            <p:nvPr/>
          </p:nvGrpSpPr>
          <p:grpSpPr>
            <a:xfrm>
              <a:off x="4893273" y="2740583"/>
              <a:ext cx="2312816" cy="1901971"/>
              <a:chOff x="4893273" y="2740583"/>
              <a:chExt cx="2312816" cy="1901971"/>
            </a:xfrm>
          </p:grpSpPr>
          <p:sp>
            <p:nvSpPr>
              <p:cNvPr id="46" name="Szövegdoboz 45">
                <a:extLst>
                  <a:ext uri="{FF2B5EF4-FFF2-40B4-BE49-F238E27FC236}">
                    <a16:creationId xmlns:a16="http://schemas.microsoft.com/office/drawing/2014/main" id="{46AC15DC-919A-CC57-6650-EDA0D3E0E7D7}"/>
                  </a:ext>
                </a:extLst>
              </p:cNvPr>
              <p:cNvSpPr txBox="1"/>
              <p:nvPr/>
            </p:nvSpPr>
            <p:spPr>
              <a:xfrm>
                <a:off x="5088922" y="4152508"/>
                <a:ext cx="20540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47" name="Szövegdoboz 46">
                <a:extLst>
                  <a:ext uri="{FF2B5EF4-FFF2-40B4-BE49-F238E27FC236}">
                    <a16:creationId xmlns:a16="http://schemas.microsoft.com/office/drawing/2014/main" id="{8C65EC2A-45C9-9636-6AF8-1341CA3E0089}"/>
                  </a:ext>
                </a:extLst>
              </p:cNvPr>
              <p:cNvSpPr txBox="1"/>
              <p:nvPr/>
            </p:nvSpPr>
            <p:spPr>
              <a:xfrm>
                <a:off x="5009906" y="3443117"/>
                <a:ext cx="3391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48" name="Szövegdoboz 47">
                <a:extLst>
                  <a:ext uri="{FF2B5EF4-FFF2-40B4-BE49-F238E27FC236}">
                    <a16:creationId xmlns:a16="http://schemas.microsoft.com/office/drawing/2014/main" id="{3973EC1A-4C13-B7BD-5C8E-526E697ECDF1}"/>
                  </a:ext>
                </a:extLst>
              </p:cNvPr>
              <p:cNvSpPr txBox="1"/>
              <p:nvPr/>
            </p:nvSpPr>
            <p:spPr>
              <a:xfrm>
                <a:off x="5016282" y="3796725"/>
                <a:ext cx="33918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49" name="Szövegdoboz 48">
                <a:extLst>
                  <a:ext uri="{FF2B5EF4-FFF2-40B4-BE49-F238E27FC236}">
                    <a16:creationId xmlns:a16="http://schemas.microsoft.com/office/drawing/2014/main" id="{E1678A08-42D0-244C-8921-BA86FBC7BCC7}"/>
                  </a:ext>
                </a:extLst>
              </p:cNvPr>
              <p:cNvSpPr txBox="1"/>
              <p:nvPr/>
            </p:nvSpPr>
            <p:spPr>
              <a:xfrm>
                <a:off x="5008212" y="2740583"/>
                <a:ext cx="3391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50" name="Szövegdoboz 49">
                <a:extLst>
                  <a:ext uri="{FF2B5EF4-FFF2-40B4-BE49-F238E27FC236}">
                    <a16:creationId xmlns:a16="http://schemas.microsoft.com/office/drawing/2014/main" id="{8F161F82-1D72-7701-5E1C-098C51BC8CA6}"/>
                  </a:ext>
                </a:extLst>
              </p:cNvPr>
              <p:cNvSpPr txBox="1"/>
              <p:nvPr/>
            </p:nvSpPr>
            <p:spPr>
              <a:xfrm>
                <a:off x="5013034" y="3103170"/>
                <a:ext cx="3391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51" name="Szövegdoboz 50">
                <a:extLst>
                  <a:ext uri="{FF2B5EF4-FFF2-40B4-BE49-F238E27FC236}">
                    <a16:creationId xmlns:a16="http://schemas.microsoft.com/office/drawing/2014/main" id="{06C398A5-CC2E-DAD3-43F0-5FD968AC8D11}"/>
                  </a:ext>
                </a:extLst>
              </p:cNvPr>
              <p:cNvSpPr txBox="1"/>
              <p:nvPr/>
            </p:nvSpPr>
            <p:spPr>
              <a:xfrm>
                <a:off x="5105152" y="4289851"/>
                <a:ext cx="4425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52" name="Szövegdoboz 51">
                <a:extLst>
                  <a:ext uri="{FF2B5EF4-FFF2-40B4-BE49-F238E27FC236}">
                    <a16:creationId xmlns:a16="http://schemas.microsoft.com/office/drawing/2014/main" id="{6E5725E6-B9C2-DFAD-5059-ACD533C10F79}"/>
                  </a:ext>
                </a:extLst>
              </p:cNvPr>
              <p:cNvSpPr txBox="1"/>
              <p:nvPr/>
            </p:nvSpPr>
            <p:spPr>
              <a:xfrm>
                <a:off x="5588596" y="4288183"/>
                <a:ext cx="33918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53" name="Szövegdoboz 52">
                <a:extLst>
                  <a:ext uri="{FF2B5EF4-FFF2-40B4-BE49-F238E27FC236}">
                    <a16:creationId xmlns:a16="http://schemas.microsoft.com/office/drawing/2014/main" id="{70B28B9E-F670-1AFB-CD87-96933E624290}"/>
                  </a:ext>
                </a:extLst>
              </p:cNvPr>
              <p:cNvSpPr txBox="1"/>
              <p:nvPr/>
            </p:nvSpPr>
            <p:spPr>
              <a:xfrm>
                <a:off x="6011515" y="4278658"/>
                <a:ext cx="3391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54" name="Szövegdoboz 53">
                <a:extLst>
                  <a:ext uri="{FF2B5EF4-FFF2-40B4-BE49-F238E27FC236}">
                    <a16:creationId xmlns:a16="http://schemas.microsoft.com/office/drawing/2014/main" id="{46919BDA-C5CF-2B45-52B4-2C58C943D7F1}"/>
                  </a:ext>
                </a:extLst>
              </p:cNvPr>
              <p:cNvSpPr txBox="1"/>
              <p:nvPr/>
            </p:nvSpPr>
            <p:spPr>
              <a:xfrm>
                <a:off x="6437636" y="4282875"/>
                <a:ext cx="3391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55" name="Szövegdoboz 54">
                <a:extLst>
                  <a:ext uri="{FF2B5EF4-FFF2-40B4-BE49-F238E27FC236}">
                    <a16:creationId xmlns:a16="http://schemas.microsoft.com/office/drawing/2014/main" id="{C104BCD3-A192-59FB-8AF2-3482F71A9998}"/>
                  </a:ext>
                </a:extLst>
              </p:cNvPr>
              <p:cNvSpPr txBox="1"/>
              <p:nvPr/>
            </p:nvSpPr>
            <p:spPr>
              <a:xfrm>
                <a:off x="6866906" y="4282369"/>
                <a:ext cx="3391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56" name="Szövegdoboz 55">
                <a:extLst>
                  <a:ext uri="{FF2B5EF4-FFF2-40B4-BE49-F238E27FC236}">
                    <a16:creationId xmlns:a16="http://schemas.microsoft.com/office/drawing/2014/main" id="{48A6E29B-C37D-347C-8BDA-49DEFA9371E2}"/>
                  </a:ext>
                </a:extLst>
              </p:cNvPr>
              <p:cNvSpPr txBox="1"/>
              <p:nvPr/>
            </p:nvSpPr>
            <p:spPr>
              <a:xfrm>
                <a:off x="5310554" y="4380944"/>
                <a:ext cx="170629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CD3</a:t>
                </a:r>
              </a:p>
            </p:txBody>
          </p:sp>
          <p:sp>
            <p:nvSpPr>
              <p:cNvPr id="57" name="Szövegdoboz 56">
                <a:extLst>
                  <a:ext uri="{FF2B5EF4-FFF2-40B4-BE49-F238E27FC236}">
                    <a16:creationId xmlns:a16="http://schemas.microsoft.com/office/drawing/2014/main" id="{7D39DC87-1B99-B608-A858-62DF756AD417}"/>
                  </a:ext>
                </a:extLst>
              </p:cNvPr>
              <p:cNvSpPr txBox="1"/>
              <p:nvPr/>
            </p:nvSpPr>
            <p:spPr>
              <a:xfrm rot="16200000">
                <a:off x="4303846" y="3403606"/>
                <a:ext cx="144046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CD56</a:t>
                </a:r>
              </a:p>
            </p:txBody>
          </p:sp>
        </p:grpSp>
        <p:grpSp>
          <p:nvGrpSpPr>
            <p:cNvPr id="138" name="Csoportba foglalás 137">
              <a:extLst>
                <a:ext uri="{FF2B5EF4-FFF2-40B4-BE49-F238E27FC236}">
                  <a16:creationId xmlns:a16="http://schemas.microsoft.com/office/drawing/2014/main" id="{3CAB68CE-8985-D78D-C1D2-0FEFCC91AE05}"/>
                </a:ext>
              </a:extLst>
            </p:cNvPr>
            <p:cNvGrpSpPr/>
            <p:nvPr/>
          </p:nvGrpSpPr>
          <p:grpSpPr>
            <a:xfrm>
              <a:off x="2405377" y="2761753"/>
              <a:ext cx="2461245" cy="1904937"/>
              <a:chOff x="2405377" y="2761753"/>
              <a:chExt cx="2461245" cy="1904937"/>
            </a:xfrm>
          </p:grpSpPr>
          <p:pic>
            <p:nvPicPr>
              <p:cNvPr id="9" name="Kép 8">
                <a:extLst>
                  <a:ext uri="{FF2B5EF4-FFF2-40B4-BE49-F238E27FC236}">
                    <a16:creationId xmlns:a16="http://schemas.microsoft.com/office/drawing/2014/main" id="{75CBFE39-15B1-AEC5-985C-C7C50B1BCC6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18263" t="11711" b="14865"/>
              <a:stretch/>
            </p:blipFill>
            <p:spPr>
              <a:xfrm>
                <a:off x="2837400" y="2811565"/>
                <a:ext cx="1860710" cy="1566567"/>
              </a:xfrm>
              <a:prstGeom prst="rect">
                <a:avLst/>
              </a:prstGeom>
            </p:spPr>
          </p:pic>
          <p:sp>
            <p:nvSpPr>
              <p:cNvPr id="58" name="Szövegdoboz 57">
                <a:extLst>
                  <a:ext uri="{FF2B5EF4-FFF2-40B4-BE49-F238E27FC236}">
                    <a16:creationId xmlns:a16="http://schemas.microsoft.com/office/drawing/2014/main" id="{ABC9E144-D716-E19D-0BD6-BEC306891793}"/>
                  </a:ext>
                </a:extLst>
              </p:cNvPr>
              <p:cNvSpPr txBox="1"/>
              <p:nvPr/>
            </p:nvSpPr>
            <p:spPr>
              <a:xfrm>
                <a:off x="4375932" y="4312966"/>
                <a:ext cx="49069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24</a:t>
                </a:r>
              </a:p>
            </p:txBody>
          </p:sp>
          <p:sp>
            <p:nvSpPr>
              <p:cNvPr id="59" name="Szövegdoboz 58">
                <a:extLst>
                  <a:ext uri="{FF2B5EF4-FFF2-40B4-BE49-F238E27FC236}">
                    <a16:creationId xmlns:a16="http://schemas.microsoft.com/office/drawing/2014/main" id="{DE63ACCA-2B0A-74ED-9081-D37BC45F596F}"/>
                  </a:ext>
                </a:extLst>
              </p:cNvPr>
              <p:cNvSpPr txBox="1"/>
              <p:nvPr/>
            </p:nvSpPr>
            <p:spPr>
              <a:xfrm>
                <a:off x="2885865" y="4405080"/>
                <a:ext cx="1733011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FSC-A</a:t>
                </a:r>
              </a:p>
            </p:txBody>
          </p:sp>
          <p:sp>
            <p:nvSpPr>
              <p:cNvPr id="60" name="Szövegdoboz 59">
                <a:extLst>
                  <a:ext uri="{FF2B5EF4-FFF2-40B4-BE49-F238E27FC236}">
                    <a16:creationId xmlns:a16="http://schemas.microsoft.com/office/drawing/2014/main" id="{1431DBE6-16C8-0D69-C171-F0936AB6D62E}"/>
                  </a:ext>
                </a:extLst>
              </p:cNvPr>
              <p:cNvSpPr txBox="1"/>
              <p:nvPr/>
            </p:nvSpPr>
            <p:spPr>
              <a:xfrm rot="16200000">
                <a:off x="1815950" y="3459177"/>
                <a:ext cx="144046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SSC-A</a:t>
                </a:r>
              </a:p>
            </p:txBody>
          </p:sp>
          <p:sp>
            <p:nvSpPr>
              <p:cNvPr id="61" name="Szövegdoboz 60">
                <a:extLst>
                  <a:ext uri="{FF2B5EF4-FFF2-40B4-BE49-F238E27FC236}">
                    <a16:creationId xmlns:a16="http://schemas.microsoft.com/office/drawing/2014/main" id="{A429E5F9-EAB7-8334-CB02-993A90327D40}"/>
                  </a:ext>
                </a:extLst>
              </p:cNvPr>
              <p:cNvSpPr txBox="1"/>
              <p:nvPr/>
            </p:nvSpPr>
            <p:spPr>
              <a:xfrm>
                <a:off x="2645547" y="4184646"/>
                <a:ext cx="24031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62" name="Szövegdoboz 61">
                <a:extLst>
                  <a:ext uri="{FF2B5EF4-FFF2-40B4-BE49-F238E27FC236}">
                    <a16:creationId xmlns:a16="http://schemas.microsoft.com/office/drawing/2014/main" id="{64CE2573-1C87-2EAA-533D-D27FFFF30E3F}"/>
                  </a:ext>
                </a:extLst>
              </p:cNvPr>
              <p:cNvSpPr txBox="1"/>
              <p:nvPr/>
            </p:nvSpPr>
            <p:spPr>
              <a:xfrm>
                <a:off x="3041797" y="4314442"/>
                <a:ext cx="57100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256</a:t>
                </a:r>
              </a:p>
            </p:txBody>
          </p:sp>
          <p:sp>
            <p:nvSpPr>
              <p:cNvPr id="63" name="Szövegdoboz 62">
                <a:extLst>
                  <a:ext uri="{FF2B5EF4-FFF2-40B4-BE49-F238E27FC236}">
                    <a16:creationId xmlns:a16="http://schemas.microsoft.com/office/drawing/2014/main" id="{8C89E548-580E-227A-151E-2BD044EA99C1}"/>
                  </a:ext>
                </a:extLst>
              </p:cNvPr>
              <p:cNvSpPr txBox="1"/>
              <p:nvPr/>
            </p:nvSpPr>
            <p:spPr>
              <a:xfrm>
                <a:off x="3903256" y="4317217"/>
                <a:ext cx="57100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768</a:t>
                </a:r>
              </a:p>
            </p:txBody>
          </p:sp>
          <p:sp>
            <p:nvSpPr>
              <p:cNvPr id="64" name="Szövegdoboz 63">
                <a:extLst>
                  <a:ext uri="{FF2B5EF4-FFF2-40B4-BE49-F238E27FC236}">
                    <a16:creationId xmlns:a16="http://schemas.microsoft.com/office/drawing/2014/main" id="{71872BF3-FF5D-55DD-CCB0-2AA4379FDA24}"/>
                  </a:ext>
                </a:extLst>
              </p:cNvPr>
              <p:cNvSpPr txBox="1"/>
              <p:nvPr/>
            </p:nvSpPr>
            <p:spPr>
              <a:xfrm>
                <a:off x="2540075" y="3485542"/>
                <a:ext cx="39388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512</a:t>
                </a:r>
              </a:p>
            </p:txBody>
          </p:sp>
          <p:sp>
            <p:nvSpPr>
              <p:cNvPr id="65" name="Szövegdoboz 64">
                <a:extLst>
                  <a:ext uri="{FF2B5EF4-FFF2-40B4-BE49-F238E27FC236}">
                    <a16:creationId xmlns:a16="http://schemas.microsoft.com/office/drawing/2014/main" id="{C817CB70-EBF3-7093-A51D-ED38CDC94C88}"/>
                  </a:ext>
                </a:extLst>
              </p:cNvPr>
              <p:cNvSpPr txBox="1"/>
              <p:nvPr/>
            </p:nvSpPr>
            <p:spPr>
              <a:xfrm>
                <a:off x="2668445" y="4314442"/>
                <a:ext cx="4425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66" name="Szövegdoboz 65">
                <a:extLst>
                  <a:ext uri="{FF2B5EF4-FFF2-40B4-BE49-F238E27FC236}">
                    <a16:creationId xmlns:a16="http://schemas.microsoft.com/office/drawing/2014/main" id="{AD5C4B74-47BF-640B-A495-F8F053D3F061}"/>
                  </a:ext>
                </a:extLst>
              </p:cNvPr>
              <p:cNvSpPr txBox="1"/>
              <p:nvPr/>
            </p:nvSpPr>
            <p:spPr>
              <a:xfrm>
                <a:off x="2526912" y="3844325"/>
                <a:ext cx="39388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256</a:t>
                </a:r>
              </a:p>
            </p:txBody>
          </p:sp>
          <p:sp>
            <p:nvSpPr>
              <p:cNvPr id="67" name="Szövegdoboz 66">
                <a:extLst>
                  <a:ext uri="{FF2B5EF4-FFF2-40B4-BE49-F238E27FC236}">
                    <a16:creationId xmlns:a16="http://schemas.microsoft.com/office/drawing/2014/main" id="{92362FC0-1DF9-A129-BB49-396229D91319}"/>
                  </a:ext>
                </a:extLst>
              </p:cNvPr>
              <p:cNvSpPr txBox="1"/>
              <p:nvPr/>
            </p:nvSpPr>
            <p:spPr>
              <a:xfrm>
                <a:off x="2492694" y="2761753"/>
                <a:ext cx="44250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24</a:t>
                </a:r>
              </a:p>
            </p:txBody>
          </p:sp>
          <p:sp>
            <p:nvSpPr>
              <p:cNvPr id="68" name="Szövegdoboz 67">
                <a:extLst>
                  <a:ext uri="{FF2B5EF4-FFF2-40B4-BE49-F238E27FC236}">
                    <a16:creationId xmlns:a16="http://schemas.microsoft.com/office/drawing/2014/main" id="{1BEE174A-9B77-739E-178E-7B8BEEC19987}"/>
                  </a:ext>
                </a:extLst>
              </p:cNvPr>
              <p:cNvSpPr txBox="1"/>
              <p:nvPr/>
            </p:nvSpPr>
            <p:spPr>
              <a:xfrm>
                <a:off x="2540076" y="3128946"/>
                <a:ext cx="39388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768</a:t>
                </a:r>
              </a:p>
            </p:txBody>
          </p:sp>
          <p:sp>
            <p:nvSpPr>
              <p:cNvPr id="69" name="Szövegdoboz 68">
                <a:extLst>
                  <a:ext uri="{FF2B5EF4-FFF2-40B4-BE49-F238E27FC236}">
                    <a16:creationId xmlns:a16="http://schemas.microsoft.com/office/drawing/2014/main" id="{1D7983FB-6049-D7CA-BC48-CEF1B0A1A09B}"/>
                  </a:ext>
                </a:extLst>
              </p:cNvPr>
              <p:cNvSpPr txBox="1"/>
              <p:nvPr/>
            </p:nvSpPr>
            <p:spPr>
              <a:xfrm>
                <a:off x="3471125" y="4314382"/>
                <a:ext cx="57100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512</a:t>
                </a:r>
              </a:p>
            </p:txBody>
          </p:sp>
        </p:grpSp>
        <p:grpSp>
          <p:nvGrpSpPr>
            <p:cNvPr id="144" name="Csoportba foglalás 143">
              <a:extLst>
                <a:ext uri="{FF2B5EF4-FFF2-40B4-BE49-F238E27FC236}">
                  <a16:creationId xmlns:a16="http://schemas.microsoft.com/office/drawing/2014/main" id="{3A74D48B-CB86-19AA-851E-C00AC89320A4}"/>
                </a:ext>
              </a:extLst>
            </p:cNvPr>
            <p:cNvGrpSpPr/>
            <p:nvPr/>
          </p:nvGrpSpPr>
          <p:grpSpPr>
            <a:xfrm>
              <a:off x="31449" y="2759494"/>
              <a:ext cx="2461245" cy="1904937"/>
              <a:chOff x="31449" y="2759494"/>
              <a:chExt cx="2461245" cy="1904937"/>
            </a:xfrm>
          </p:grpSpPr>
          <p:pic>
            <p:nvPicPr>
              <p:cNvPr id="11" name="Kép 10">
                <a:extLst>
                  <a:ext uri="{FF2B5EF4-FFF2-40B4-BE49-F238E27FC236}">
                    <a16:creationId xmlns:a16="http://schemas.microsoft.com/office/drawing/2014/main" id="{77EA0FD6-5DDB-7F90-5CFB-0B1117846F2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18081" t="12667" b="16064"/>
              <a:stretch/>
            </p:blipFill>
            <p:spPr>
              <a:xfrm>
                <a:off x="462674" y="2831959"/>
                <a:ext cx="1864868" cy="1520604"/>
              </a:xfrm>
              <a:prstGeom prst="rect">
                <a:avLst/>
              </a:prstGeom>
            </p:spPr>
          </p:pic>
          <p:sp>
            <p:nvSpPr>
              <p:cNvPr id="70" name="Szövegdoboz 69">
                <a:extLst>
                  <a:ext uri="{FF2B5EF4-FFF2-40B4-BE49-F238E27FC236}">
                    <a16:creationId xmlns:a16="http://schemas.microsoft.com/office/drawing/2014/main" id="{D5EA2EFE-9A5A-7393-1468-4844F18097FA}"/>
                  </a:ext>
                </a:extLst>
              </p:cNvPr>
              <p:cNvSpPr txBox="1"/>
              <p:nvPr/>
            </p:nvSpPr>
            <p:spPr>
              <a:xfrm>
                <a:off x="2002004" y="4310707"/>
                <a:ext cx="49069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24</a:t>
                </a:r>
              </a:p>
            </p:txBody>
          </p:sp>
          <p:sp>
            <p:nvSpPr>
              <p:cNvPr id="71" name="Szövegdoboz 70">
                <a:extLst>
                  <a:ext uri="{FF2B5EF4-FFF2-40B4-BE49-F238E27FC236}">
                    <a16:creationId xmlns:a16="http://schemas.microsoft.com/office/drawing/2014/main" id="{54AC7647-EEBD-4010-872F-69F19E069D06}"/>
                  </a:ext>
                </a:extLst>
              </p:cNvPr>
              <p:cNvSpPr txBox="1"/>
              <p:nvPr/>
            </p:nvSpPr>
            <p:spPr>
              <a:xfrm>
                <a:off x="511937" y="4402821"/>
                <a:ext cx="1733011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FSC-H</a:t>
                </a:r>
              </a:p>
            </p:txBody>
          </p:sp>
          <p:sp>
            <p:nvSpPr>
              <p:cNvPr id="72" name="Szövegdoboz 71">
                <a:extLst>
                  <a:ext uri="{FF2B5EF4-FFF2-40B4-BE49-F238E27FC236}">
                    <a16:creationId xmlns:a16="http://schemas.microsoft.com/office/drawing/2014/main" id="{A36DA860-1769-7308-3424-94C7F1BF77AC}"/>
                  </a:ext>
                </a:extLst>
              </p:cNvPr>
              <p:cNvSpPr txBox="1"/>
              <p:nvPr/>
            </p:nvSpPr>
            <p:spPr>
              <a:xfrm rot="16200000">
                <a:off x="-557978" y="3456918"/>
                <a:ext cx="144046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FSC-W</a:t>
                </a:r>
              </a:p>
            </p:txBody>
          </p:sp>
          <p:sp>
            <p:nvSpPr>
              <p:cNvPr id="73" name="Szövegdoboz 72">
                <a:extLst>
                  <a:ext uri="{FF2B5EF4-FFF2-40B4-BE49-F238E27FC236}">
                    <a16:creationId xmlns:a16="http://schemas.microsoft.com/office/drawing/2014/main" id="{4F2E3DDF-986E-A41E-DF55-89E6C89C8376}"/>
                  </a:ext>
                </a:extLst>
              </p:cNvPr>
              <p:cNvSpPr txBox="1"/>
              <p:nvPr/>
            </p:nvSpPr>
            <p:spPr>
              <a:xfrm>
                <a:off x="271619" y="4182387"/>
                <a:ext cx="24031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74" name="Szövegdoboz 73">
                <a:extLst>
                  <a:ext uri="{FF2B5EF4-FFF2-40B4-BE49-F238E27FC236}">
                    <a16:creationId xmlns:a16="http://schemas.microsoft.com/office/drawing/2014/main" id="{63E350E3-41A0-3F67-373D-F2BA09DEEE95}"/>
                  </a:ext>
                </a:extLst>
              </p:cNvPr>
              <p:cNvSpPr txBox="1"/>
              <p:nvPr/>
            </p:nvSpPr>
            <p:spPr>
              <a:xfrm>
                <a:off x="667869" y="4312183"/>
                <a:ext cx="57100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256</a:t>
                </a:r>
              </a:p>
            </p:txBody>
          </p:sp>
          <p:sp>
            <p:nvSpPr>
              <p:cNvPr id="75" name="Szövegdoboz 74">
                <a:extLst>
                  <a:ext uri="{FF2B5EF4-FFF2-40B4-BE49-F238E27FC236}">
                    <a16:creationId xmlns:a16="http://schemas.microsoft.com/office/drawing/2014/main" id="{63C71787-843E-CAA8-741A-EBA71629AB44}"/>
                  </a:ext>
                </a:extLst>
              </p:cNvPr>
              <p:cNvSpPr txBox="1"/>
              <p:nvPr/>
            </p:nvSpPr>
            <p:spPr>
              <a:xfrm>
                <a:off x="1529328" y="4314958"/>
                <a:ext cx="57100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768</a:t>
                </a:r>
              </a:p>
            </p:txBody>
          </p:sp>
          <p:sp>
            <p:nvSpPr>
              <p:cNvPr id="76" name="Szövegdoboz 75">
                <a:extLst>
                  <a:ext uri="{FF2B5EF4-FFF2-40B4-BE49-F238E27FC236}">
                    <a16:creationId xmlns:a16="http://schemas.microsoft.com/office/drawing/2014/main" id="{ED845331-710A-DC65-7234-CE4673A8C505}"/>
                  </a:ext>
                </a:extLst>
              </p:cNvPr>
              <p:cNvSpPr txBox="1"/>
              <p:nvPr/>
            </p:nvSpPr>
            <p:spPr>
              <a:xfrm>
                <a:off x="166147" y="3483283"/>
                <a:ext cx="39388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512</a:t>
                </a:r>
              </a:p>
            </p:txBody>
          </p:sp>
          <p:sp>
            <p:nvSpPr>
              <p:cNvPr id="77" name="Szövegdoboz 76">
                <a:extLst>
                  <a:ext uri="{FF2B5EF4-FFF2-40B4-BE49-F238E27FC236}">
                    <a16:creationId xmlns:a16="http://schemas.microsoft.com/office/drawing/2014/main" id="{0B09CF9D-83CC-7126-CF65-0E620F9178FA}"/>
                  </a:ext>
                </a:extLst>
              </p:cNvPr>
              <p:cNvSpPr txBox="1"/>
              <p:nvPr/>
            </p:nvSpPr>
            <p:spPr>
              <a:xfrm>
                <a:off x="294517" y="4312183"/>
                <a:ext cx="4425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78" name="Szövegdoboz 77">
                <a:extLst>
                  <a:ext uri="{FF2B5EF4-FFF2-40B4-BE49-F238E27FC236}">
                    <a16:creationId xmlns:a16="http://schemas.microsoft.com/office/drawing/2014/main" id="{DE4402D0-48CE-9B3C-E125-92786B7AB92A}"/>
                  </a:ext>
                </a:extLst>
              </p:cNvPr>
              <p:cNvSpPr txBox="1"/>
              <p:nvPr/>
            </p:nvSpPr>
            <p:spPr>
              <a:xfrm>
                <a:off x="152984" y="3842066"/>
                <a:ext cx="39388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256</a:t>
                </a:r>
              </a:p>
            </p:txBody>
          </p:sp>
          <p:sp>
            <p:nvSpPr>
              <p:cNvPr id="79" name="Szövegdoboz 78">
                <a:extLst>
                  <a:ext uri="{FF2B5EF4-FFF2-40B4-BE49-F238E27FC236}">
                    <a16:creationId xmlns:a16="http://schemas.microsoft.com/office/drawing/2014/main" id="{FDA16F55-89C7-0360-B46D-677CE21F7631}"/>
                  </a:ext>
                </a:extLst>
              </p:cNvPr>
              <p:cNvSpPr txBox="1"/>
              <p:nvPr/>
            </p:nvSpPr>
            <p:spPr>
              <a:xfrm>
                <a:off x="118766" y="2759494"/>
                <a:ext cx="44250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24</a:t>
                </a:r>
              </a:p>
            </p:txBody>
          </p:sp>
          <p:sp>
            <p:nvSpPr>
              <p:cNvPr id="80" name="Szövegdoboz 79">
                <a:extLst>
                  <a:ext uri="{FF2B5EF4-FFF2-40B4-BE49-F238E27FC236}">
                    <a16:creationId xmlns:a16="http://schemas.microsoft.com/office/drawing/2014/main" id="{3894DBF6-7B7F-CBE2-668A-B11A327F31EA}"/>
                  </a:ext>
                </a:extLst>
              </p:cNvPr>
              <p:cNvSpPr txBox="1"/>
              <p:nvPr/>
            </p:nvSpPr>
            <p:spPr>
              <a:xfrm>
                <a:off x="166148" y="3126687"/>
                <a:ext cx="39388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768</a:t>
                </a:r>
              </a:p>
            </p:txBody>
          </p:sp>
          <p:sp>
            <p:nvSpPr>
              <p:cNvPr id="81" name="Szövegdoboz 80">
                <a:extLst>
                  <a:ext uri="{FF2B5EF4-FFF2-40B4-BE49-F238E27FC236}">
                    <a16:creationId xmlns:a16="http://schemas.microsoft.com/office/drawing/2014/main" id="{94D2D51B-E64B-F99B-982A-9C23BA8474F2}"/>
                  </a:ext>
                </a:extLst>
              </p:cNvPr>
              <p:cNvSpPr txBox="1"/>
              <p:nvPr/>
            </p:nvSpPr>
            <p:spPr>
              <a:xfrm>
                <a:off x="1097197" y="4312123"/>
                <a:ext cx="57100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512</a:t>
                </a:r>
              </a:p>
            </p:txBody>
          </p:sp>
        </p:grpSp>
        <p:grpSp>
          <p:nvGrpSpPr>
            <p:cNvPr id="139" name="Csoportba foglalás 138">
              <a:extLst>
                <a:ext uri="{FF2B5EF4-FFF2-40B4-BE49-F238E27FC236}">
                  <a16:creationId xmlns:a16="http://schemas.microsoft.com/office/drawing/2014/main" id="{648C3623-B89B-E24C-8164-8936C8C7681F}"/>
                </a:ext>
              </a:extLst>
            </p:cNvPr>
            <p:cNvGrpSpPr/>
            <p:nvPr/>
          </p:nvGrpSpPr>
          <p:grpSpPr>
            <a:xfrm>
              <a:off x="2405377" y="4880083"/>
              <a:ext cx="2385538" cy="1889888"/>
              <a:chOff x="2405377" y="4880083"/>
              <a:chExt cx="2385538" cy="1889888"/>
            </a:xfrm>
          </p:grpSpPr>
          <p:pic>
            <p:nvPicPr>
              <p:cNvPr id="17" name="Kép 16">
                <a:extLst>
                  <a:ext uri="{FF2B5EF4-FFF2-40B4-BE49-F238E27FC236}">
                    <a16:creationId xmlns:a16="http://schemas.microsoft.com/office/drawing/2014/main" id="{20DA7AE6-87DD-CE19-6087-10F0491A146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18302" t="11424" r="2118" b="16642"/>
              <a:stretch/>
            </p:blipFill>
            <p:spPr>
              <a:xfrm>
                <a:off x="2837400" y="4939059"/>
                <a:ext cx="1811607" cy="1534766"/>
              </a:xfrm>
              <a:prstGeom prst="rect">
                <a:avLst/>
              </a:prstGeom>
            </p:spPr>
          </p:pic>
          <p:sp>
            <p:nvSpPr>
              <p:cNvPr id="88" name="Szövegdoboz 87">
                <a:extLst>
                  <a:ext uri="{FF2B5EF4-FFF2-40B4-BE49-F238E27FC236}">
                    <a16:creationId xmlns:a16="http://schemas.microsoft.com/office/drawing/2014/main" id="{2201F61C-91A6-BCD9-01CC-A8104E5AD284}"/>
                  </a:ext>
                </a:extLst>
              </p:cNvPr>
              <p:cNvSpPr txBox="1"/>
              <p:nvPr/>
            </p:nvSpPr>
            <p:spPr>
              <a:xfrm>
                <a:off x="2682835" y="6407744"/>
                <a:ext cx="4425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89" name="Szövegdoboz 88">
                <a:extLst>
                  <a:ext uri="{FF2B5EF4-FFF2-40B4-BE49-F238E27FC236}">
                    <a16:creationId xmlns:a16="http://schemas.microsoft.com/office/drawing/2014/main" id="{D50DEAD2-2D4D-2137-8D03-004796B90BA5}"/>
                  </a:ext>
                </a:extLst>
              </p:cNvPr>
              <p:cNvSpPr txBox="1"/>
              <p:nvPr/>
            </p:nvSpPr>
            <p:spPr>
              <a:xfrm>
                <a:off x="3163898" y="6410838"/>
                <a:ext cx="33918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90" name="Szövegdoboz 89">
                <a:extLst>
                  <a:ext uri="{FF2B5EF4-FFF2-40B4-BE49-F238E27FC236}">
                    <a16:creationId xmlns:a16="http://schemas.microsoft.com/office/drawing/2014/main" id="{B5D87EDB-FAC6-74F2-C0B3-FB9996881ACA}"/>
                  </a:ext>
                </a:extLst>
              </p:cNvPr>
              <p:cNvSpPr txBox="1"/>
              <p:nvPr/>
            </p:nvSpPr>
            <p:spPr>
              <a:xfrm>
                <a:off x="3596341" y="6406075"/>
                <a:ext cx="3391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91" name="Szövegdoboz 90">
                <a:extLst>
                  <a:ext uri="{FF2B5EF4-FFF2-40B4-BE49-F238E27FC236}">
                    <a16:creationId xmlns:a16="http://schemas.microsoft.com/office/drawing/2014/main" id="{472F31AB-11B3-1D60-FD0D-F01C71416DCE}"/>
                  </a:ext>
                </a:extLst>
              </p:cNvPr>
              <p:cNvSpPr txBox="1"/>
              <p:nvPr/>
            </p:nvSpPr>
            <p:spPr>
              <a:xfrm>
                <a:off x="4022462" y="6410292"/>
                <a:ext cx="3391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92" name="Szövegdoboz 91">
                <a:extLst>
                  <a:ext uri="{FF2B5EF4-FFF2-40B4-BE49-F238E27FC236}">
                    <a16:creationId xmlns:a16="http://schemas.microsoft.com/office/drawing/2014/main" id="{086F5994-31A9-8F98-84D6-96E11EAF1846}"/>
                  </a:ext>
                </a:extLst>
              </p:cNvPr>
              <p:cNvSpPr txBox="1"/>
              <p:nvPr/>
            </p:nvSpPr>
            <p:spPr>
              <a:xfrm>
                <a:off x="4451732" y="6409786"/>
                <a:ext cx="3391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93" name="Szövegdoboz 92">
                <a:extLst>
                  <a:ext uri="{FF2B5EF4-FFF2-40B4-BE49-F238E27FC236}">
                    <a16:creationId xmlns:a16="http://schemas.microsoft.com/office/drawing/2014/main" id="{C9A4720C-1938-E071-7A67-F84E5A2652AA}"/>
                  </a:ext>
                </a:extLst>
              </p:cNvPr>
              <p:cNvSpPr txBox="1"/>
              <p:nvPr/>
            </p:nvSpPr>
            <p:spPr>
              <a:xfrm>
                <a:off x="2895380" y="6508361"/>
                <a:ext cx="170629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CD3</a:t>
                </a:r>
              </a:p>
            </p:txBody>
          </p:sp>
          <p:sp>
            <p:nvSpPr>
              <p:cNvPr id="94" name="Szövegdoboz 93">
                <a:extLst>
                  <a:ext uri="{FF2B5EF4-FFF2-40B4-BE49-F238E27FC236}">
                    <a16:creationId xmlns:a16="http://schemas.microsoft.com/office/drawing/2014/main" id="{96C23E9A-D65A-1375-6150-4BC486CDBA3F}"/>
                  </a:ext>
                </a:extLst>
              </p:cNvPr>
              <p:cNvSpPr txBox="1"/>
              <p:nvPr/>
            </p:nvSpPr>
            <p:spPr>
              <a:xfrm rot="16200000">
                <a:off x="1815950" y="5577507"/>
                <a:ext cx="144046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SSC-A</a:t>
                </a:r>
              </a:p>
            </p:txBody>
          </p:sp>
          <p:sp>
            <p:nvSpPr>
              <p:cNvPr id="95" name="Szövegdoboz 94">
                <a:extLst>
                  <a:ext uri="{FF2B5EF4-FFF2-40B4-BE49-F238E27FC236}">
                    <a16:creationId xmlns:a16="http://schemas.microsoft.com/office/drawing/2014/main" id="{17A6D7F0-7DD8-367A-3A29-EDA090A0D328}"/>
                  </a:ext>
                </a:extLst>
              </p:cNvPr>
              <p:cNvSpPr txBox="1"/>
              <p:nvPr/>
            </p:nvSpPr>
            <p:spPr>
              <a:xfrm>
                <a:off x="2655071" y="6310119"/>
                <a:ext cx="24031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96" name="Szövegdoboz 95">
                <a:extLst>
                  <a:ext uri="{FF2B5EF4-FFF2-40B4-BE49-F238E27FC236}">
                    <a16:creationId xmlns:a16="http://schemas.microsoft.com/office/drawing/2014/main" id="{8CECF35C-15A0-808C-B2E7-7ADCF51D549C}"/>
                  </a:ext>
                </a:extLst>
              </p:cNvPr>
              <p:cNvSpPr txBox="1"/>
              <p:nvPr/>
            </p:nvSpPr>
            <p:spPr>
              <a:xfrm>
                <a:off x="2540075" y="5591967"/>
                <a:ext cx="39388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512</a:t>
                </a:r>
              </a:p>
            </p:txBody>
          </p:sp>
          <p:sp>
            <p:nvSpPr>
              <p:cNvPr id="97" name="Szövegdoboz 96">
                <a:extLst>
                  <a:ext uri="{FF2B5EF4-FFF2-40B4-BE49-F238E27FC236}">
                    <a16:creationId xmlns:a16="http://schemas.microsoft.com/office/drawing/2014/main" id="{E7E15805-49EE-D9EE-FD7D-13B38EE867ED}"/>
                  </a:ext>
                </a:extLst>
              </p:cNvPr>
              <p:cNvSpPr txBox="1"/>
              <p:nvPr/>
            </p:nvSpPr>
            <p:spPr>
              <a:xfrm>
                <a:off x="2526912" y="5948369"/>
                <a:ext cx="39388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256</a:t>
                </a:r>
              </a:p>
            </p:txBody>
          </p:sp>
          <p:sp>
            <p:nvSpPr>
              <p:cNvPr id="98" name="Szövegdoboz 97">
                <a:extLst>
                  <a:ext uri="{FF2B5EF4-FFF2-40B4-BE49-F238E27FC236}">
                    <a16:creationId xmlns:a16="http://schemas.microsoft.com/office/drawing/2014/main" id="{1C47894E-49A3-D8D3-F8A3-19C7731D842D}"/>
                  </a:ext>
                </a:extLst>
              </p:cNvPr>
              <p:cNvSpPr txBox="1"/>
              <p:nvPr/>
            </p:nvSpPr>
            <p:spPr>
              <a:xfrm>
                <a:off x="2492694" y="4880083"/>
                <a:ext cx="44250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24</a:t>
                </a:r>
              </a:p>
            </p:txBody>
          </p:sp>
          <p:sp>
            <p:nvSpPr>
              <p:cNvPr id="99" name="Szövegdoboz 98">
                <a:extLst>
                  <a:ext uri="{FF2B5EF4-FFF2-40B4-BE49-F238E27FC236}">
                    <a16:creationId xmlns:a16="http://schemas.microsoft.com/office/drawing/2014/main" id="{52B998D0-AB74-EDE0-8AF6-3E1576E82F38}"/>
                  </a:ext>
                </a:extLst>
              </p:cNvPr>
              <p:cNvSpPr txBox="1"/>
              <p:nvPr/>
            </p:nvSpPr>
            <p:spPr>
              <a:xfrm>
                <a:off x="2540076" y="5247276"/>
                <a:ext cx="39388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768</a:t>
                </a:r>
              </a:p>
            </p:txBody>
          </p:sp>
        </p:grpSp>
        <p:grpSp>
          <p:nvGrpSpPr>
            <p:cNvPr id="140" name="Csoportba foglalás 139">
              <a:extLst>
                <a:ext uri="{FF2B5EF4-FFF2-40B4-BE49-F238E27FC236}">
                  <a16:creationId xmlns:a16="http://schemas.microsoft.com/office/drawing/2014/main" id="{C050958D-DD8D-4563-297C-9074DEBA7206}"/>
                </a:ext>
              </a:extLst>
            </p:cNvPr>
            <p:cNvGrpSpPr/>
            <p:nvPr/>
          </p:nvGrpSpPr>
          <p:grpSpPr>
            <a:xfrm>
              <a:off x="4887082" y="4902459"/>
              <a:ext cx="2308053" cy="1878156"/>
              <a:chOff x="4887082" y="4902459"/>
              <a:chExt cx="2308053" cy="1878156"/>
            </a:xfrm>
          </p:grpSpPr>
          <p:pic>
            <p:nvPicPr>
              <p:cNvPr id="16" name="Kép 15">
                <a:extLst>
                  <a:ext uri="{FF2B5EF4-FFF2-40B4-BE49-F238E27FC236}">
                    <a16:creationId xmlns:a16="http://schemas.microsoft.com/office/drawing/2014/main" id="{4611A23B-4EA6-694B-7182-DA3978E9C27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19413" t="11024" r="1967" b="17043"/>
              <a:stretch/>
            </p:blipFill>
            <p:spPr>
              <a:xfrm>
                <a:off x="5267325" y="4939058"/>
                <a:ext cx="1789778" cy="1534767"/>
              </a:xfrm>
              <a:prstGeom prst="rect">
                <a:avLst/>
              </a:prstGeom>
            </p:spPr>
          </p:pic>
          <p:sp>
            <p:nvSpPr>
              <p:cNvPr id="100" name="Szövegdoboz 99">
                <a:extLst>
                  <a:ext uri="{FF2B5EF4-FFF2-40B4-BE49-F238E27FC236}">
                    <a16:creationId xmlns:a16="http://schemas.microsoft.com/office/drawing/2014/main" id="{1D35CCBA-4D2C-0285-BBB4-53CB07BB56E1}"/>
                  </a:ext>
                </a:extLst>
              </p:cNvPr>
              <p:cNvSpPr txBox="1"/>
              <p:nvPr/>
            </p:nvSpPr>
            <p:spPr>
              <a:xfrm>
                <a:off x="5077968" y="6314384"/>
                <a:ext cx="20540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01" name="Szövegdoboz 100">
                <a:extLst>
                  <a:ext uri="{FF2B5EF4-FFF2-40B4-BE49-F238E27FC236}">
                    <a16:creationId xmlns:a16="http://schemas.microsoft.com/office/drawing/2014/main" id="{064B1F63-C89A-9EA7-BC94-FACE815F0285}"/>
                  </a:ext>
                </a:extLst>
              </p:cNvPr>
              <p:cNvSpPr txBox="1"/>
              <p:nvPr/>
            </p:nvSpPr>
            <p:spPr>
              <a:xfrm>
                <a:off x="4998952" y="5604993"/>
                <a:ext cx="3391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102" name="Szövegdoboz 101">
                <a:extLst>
                  <a:ext uri="{FF2B5EF4-FFF2-40B4-BE49-F238E27FC236}">
                    <a16:creationId xmlns:a16="http://schemas.microsoft.com/office/drawing/2014/main" id="{AE352C11-2E43-7FD7-0A9D-9E0FF0B38141}"/>
                  </a:ext>
                </a:extLst>
              </p:cNvPr>
              <p:cNvSpPr txBox="1"/>
              <p:nvPr/>
            </p:nvSpPr>
            <p:spPr>
              <a:xfrm>
                <a:off x="5005328" y="5958601"/>
                <a:ext cx="33918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103" name="Szövegdoboz 102">
                <a:extLst>
                  <a:ext uri="{FF2B5EF4-FFF2-40B4-BE49-F238E27FC236}">
                    <a16:creationId xmlns:a16="http://schemas.microsoft.com/office/drawing/2014/main" id="{BAA2BDD9-AB89-5738-B59E-EA924ACDFB8E}"/>
                  </a:ext>
                </a:extLst>
              </p:cNvPr>
              <p:cNvSpPr txBox="1"/>
              <p:nvPr/>
            </p:nvSpPr>
            <p:spPr>
              <a:xfrm>
                <a:off x="4997258" y="4902459"/>
                <a:ext cx="3391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104" name="Szövegdoboz 103">
                <a:extLst>
                  <a:ext uri="{FF2B5EF4-FFF2-40B4-BE49-F238E27FC236}">
                    <a16:creationId xmlns:a16="http://schemas.microsoft.com/office/drawing/2014/main" id="{58C82D7E-117A-919D-88E0-8A114CBE8C02}"/>
                  </a:ext>
                </a:extLst>
              </p:cNvPr>
              <p:cNvSpPr txBox="1"/>
              <p:nvPr/>
            </p:nvSpPr>
            <p:spPr>
              <a:xfrm>
                <a:off x="5002080" y="5265046"/>
                <a:ext cx="3391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105" name="Szövegdoboz 104">
                <a:extLst>
                  <a:ext uri="{FF2B5EF4-FFF2-40B4-BE49-F238E27FC236}">
                    <a16:creationId xmlns:a16="http://schemas.microsoft.com/office/drawing/2014/main" id="{5C7A1CE4-8144-D852-B268-B0E770FB384C}"/>
                  </a:ext>
                </a:extLst>
              </p:cNvPr>
              <p:cNvSpPr txBox="1"/>
              <p:nvPr/>
            </p:nvSpPr>
            <p:spPr>
              <a:xfrm>
                <a:off x="5094198" y="6427912"/>
                <a:ext cx="4425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06" name="Szövegdoboz 105">
                <a:extLst>
                  <a:ext uri="{FF2B5EF4-FFF2-40B4-BE49-F238E27FC236}">
                    <a16:creationId xmlns:a16="http://schemas.microsoft.com/office/drawing/2014/main" id="{A4FE994F-1D9D-345E-E6D9-C6FD1EBB7672}"/>
                  </a:ext>
                </a:extLst>
              </p:cNvPr>
              <p:cNvSpPr txBox="1"/>
              <p:nvPr/>
            </p:nvSpPr>
            <p:spPr>
              <a:xfrm>
                <a:off x="5577642" y="6426244"/>
                <a:ext cx="33918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107" name="Szövegdoboz 106">
                <a:extLst>
                  <a:ext uri="{FF2B5EF4-FFF2-40B4-BE49-F238E27FC236}">
                    <a16:creationId xmlns:a16="http://schemas.microsoft.com/office/drawing/2014/main" id="{F8C30F95-2A87-0813-ED79-10216CAF04EA}"/>
                  </a:ext>
                </a:extLst>
              </p:cNvPr>
              <p:cNvSpPr txBox="1"/>
              <p:nvPr/>
            </p:nvSpPr>
            <p:spPr>
              <a:xfrm>
                <a:off x="6000561" y="6416719"/>
                <a:ext cx="3391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108" name="Szövegdoboz 107">
                <a:extLst>
                  <a:ext uri="{FF2B5EF4-FFF2-40B4-BE49-F238E27FC236}">
                    <a16:creationId xmlns:a16="http://schemas.microsoft.com/office/drawing/2014/main" id="{79908461-3B07-D418-D509-E7992BA72BD2}"/>
                  </a:ext>
                </a:extLst>
              </p:cNvPr>
              <p:cNvSpPr txBox="1"/>
              <p:nvPr/>
            </p:nvSpPr>
            <p:spPr>
              <a:xfrm>
                <a:off x="6426682" y="6420936"/>
                <a:ext cx="3391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109" name="Szövegdoboz 108">
                <a:extLst>
                  <a:ext uri="{FF2B5EF4-FFF2-40B4-BE49-F238E27FC236}">
                    <a16:creationId xmlns:a16="http://schemas.microsoft.com/office/drawing/2014/main" id="{24DD5F4E-2F8B-D543-51CA-0D8CD21B26BF}"/>
                  </a:ext>
                </a:extLst>
              </p:cNvPr>
              <p:cNvSpPr txBox="1"/>
              <p:nvPr/>
            </p:nvSpPr>
            <p:spPr>
              <a:xfrm>
                <a:off x="6855952" y="6420430"/>
                <a:ext cx="3391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110" name="Szövegdoboz 109">
                <a:extLst>
                  <a:ext uri="{FF2B5EF4-FFF2-40B4-BE49-F238E27FC236}">
                    <a16:creationId xmlns:a16="http://schemas.microsoft.com/office/drawing/2014/main" id="{AC45355F-D3A2-919F-4D1F-FC1829A6AF2C}"/>
                  </a:ext>
                </a:extLst>
              </p:cNvPr>
              <p:cNvSpPr txBox="1"/>
              <p:nvPr/>
            </p:nvSpPr>
            <p:spPr>
              <a:xfrm>
                <a:off x="5299600" y="6519005"/>
                <a:ext cx="170629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CD16</a:t>
                </a:r>
              </a:p>
            </p:txBody>
          </p:sp>
          <p:sp>
            <p:nvSpPr>
              <p:cNvPr id="111" name="Szövegdoboz 110">
                <a:extLst>
                  <a:ext uri="{FF2B5EF4-FFF2-40B4-BE49-F238E27FC236}">
                    <a16:creationId xmlns:a16="http://schemas.microsoft.com/office/drawing/2014/main" id="{9903920F-C4E9-3539-1010-CE194B9E89D5}"/>
                  </a:ext>
                </a:extLst>
              </p:cNvPr>
              <p:cNvSpPr txBox="1"/>
              <p:nvPr/>
            </p:nvSpPr>
            <p:spPr>
              <a:xfrm rot="16200000">
                <a:off x="4297655" y="5565482"/>
                <a:ext cx="144046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HLA-DR</a:t>
                </a:r>
              </a:p>
            </p:txBody>
          </p:sp>
        </p:grpSp>
        <p:grpSp>
          <p:nvGrpSpPr>
            <p:cNvPr id="142" name="Csoportba foglalás 141">
              <a:extLst>
                <a:ext uri="{FF2B5EF4-FFF2-40B4-BE49-F238E27FC236}">
                  <a16:creationId xmlns:a16="http://schemas.microsoft.com/office/drawing/2014/main" id="{DDE69D9B-5DFE-C4D1-2D07-8AA4B7873DED}"/>
                </a:ext>
              </a:extLst>
            </p:cNvPr>
            <p:cNvGrpSpPr/>
            <p:nvPr/>
          </p:nvGrpSpPr>
          <p:grpSpPr>
            <a:xfrm>
              <a:off x="7357554" y="4891046"/>
              <a:ext cx="2308053" cy="1878156"/>
              <a:chOff x="7357554" y="4891046"/>
              <a:chExt cx="2308053" cy="1878156"/>
            </a:xfrm>
          </p:grpSpPr>
          <p:pic>
            <p:nvPicPr>
              <p:cNvPr id="15" name="Kép 14">
                <a:extLst>
                  <a:ext uri="{FF2B5EF4-FFF2-40B4-BE49-F238E27FC236}">
                    <a16:creationId xmlns:a16="http://schemas.microsoft.com/office/drawing/2014/main" id="{F26290A8-DC96-AFFF-0E78-5738683D084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18772" t="12376" r="1330" b="16642"/>
              <a:stretch/>
            </p:blipFill>
            <p:spPr>
              <a:xfrm>
                <a:off x="7724473" y="4959350"/>
                <a:ext cx="1818875" cy="1514476"/>
              </a:xfrm>
              <a:prstGeom prst="rect">
                <a:avLst/>
              </a:prstGeom>
            </p:spPr>
          </p:pic>
          <p:sp>
            <p:nvSpPr>
              <p:cNvPr id="112" name="Szövegdoboz 111">
                <a:extLst>
                  <a:ext uri="{FF2B5EF4-FFF2-40B4-BE49-F238E27FC236}">
                    <a16:creationId xmlns:a16="http://schemas.microsoft.com/office/drawing/2014/main" id="{6979EEF0-090C-F8CB-D448-74EA4184D06A}"/>
                  </a:ext>
                </a:extLst>
              </p:cNvPr>
              <p:cNvSpPr txBox="1"/>
              <p:nvPr/>
            </p:nvSpPr>
            <p:spPr>
              <a:xfrm>
                <a:off x="7548440" y="6302971"/>
                <a:ext cx="20540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13" name="Szövegdoboz 112">
                <a:extLst>
                  <a:ext uri="{FF2B5EF4-FFF2-40B4-BE49-F238E27FC236}">
                    <a16:creationId xmlns:a16="http://schemas.microsoft.com/office/drawing/2014/main" id="{8DCB95AF-E10C-C727-8720-7C98772152D5}"/>
                  </a:ext>
                </a:extLst>
              </p:cNvPr>
              <p:cNvSpPr txBox="1"/>
              <p:nvPr/>
            </p:nvSpPr>
            <p:spPr>
              <a:xfrm>
                <a:off x="7469424" y="5593580"/>
                <a:ext cx="3391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114" name="Szövegdoboz 113">
                <a:extLst>
                  <a:ext uri="{FF2B5EF4-FFF2-40B4-BE49-F238E27FC236}">
                    <a16:creationId xmlns:a16="http://schemas.microsoft.com/office/drawing/2014/main" id="{6AA1F0E9-1DF3-06FC-D728-1FE1B2D7F0C9}"/>
                  </a:ext>
                </a:extLst>
              </p:cNvPr>
              <p:cNvSpPr txBox="1"/>
              <p:nvPr/>
            </p:nvSpPr>
            <p:spPr>
              <a:xfrm>
                <a:off x="7475800" y="5947188"/>
                <a:ext cx="33918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115" name="Szövegdoboz 114">
                <a:extLst>
                  <a:ext uri="{FF2B5EF4-FFF2-40B4-BE49-F238E27FC236}">
                    <a16:creationId xmlns:a16="http://schemas.microsoft.com/office/drawing/2014/main" id="{56E3F8E3-12A4-EA7A-E50B-B20EC7BC5F8B}"/>
                  </a:ext>
                </a:extLst>
              </p:cNvPr>
              <p:cNvSpPr txBox="1"/>
              <p:nvPr/>
            </p:nvSpPr>
            <p:spPr>
              <a:xfrm>
                <a:off x="7467730" y="4891046"/>
                <a:ext cx="3391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116" name="Szövegdoboz 115">
                <a:extLst>
                  <a:ext uri="{FF2B5EF4-FFF2-40B4-BE49-F238E27FC236}">
                    <a16:creationId xmlns:a16="http://schemas.microsoft.com/office/drawing/2014/main" id="{BF7EAED4-2A3B-0C99-9AA2-13290C1B7176}"/>
                  </a:ext>
                </a:extLst>
              </p:cNvPr>
              <p:cNvSpPr txBox="1"/>
              <p:nvPr/>
            </p:nvSpPr>
            <p:spPr>
              <a:xfrm>
                <a:off x="7472552" y="5253633"/>
                <a:ext cx="3391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117" name="Szövegdoboz 116">
                <a:extLst>
                  <a:ext uri="{FF2B5EF4-FFF2-40B4-BE49-F238E27FC236}">
                    <a16:creationId xmlns:a16="http://schemas.microsoft.com/office/drawing/2014/main" id="{BD72325E-7780-37BE-7C0D-06E6AAE3DE15}"/>
                  </a:ext>
                </a:extLst>
              </p:cNvPr>
              <p:cNvSpPr txBox="1"/>
              <p:nvPr/>
            </p:nvSpPr>
            <p:spPr>
              <a:xfrm>
                <a:off x="7564670" y="6416499"/>
                <a:ext cx="4425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18" name="Szövegdoboz 117">
                <a:extLst>
                  <a:ext uri="{FF2B5EF4-FFF2-40B4-BE49-F238E27FC236}">
                    <a16:creationId xmlns:a16="http://schemas.microsoft.com/office/drawing/2014/main" id="{0AC27117-9304-C2A0-3341-4912A05CA993}"/>
                  </a:ext>
                </a:extLst>
              </p:cNvPr>
              <p:cNvSpPr txBox="1"/>
              <p:nvPr/>
            </p:nvSpPr>
            <p:spPr>
              <a:xfrm>
                <a:off x="8048114" y="6414831"/>
                <a:ext cx="33918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119" name="Szövegdoboz 118">
                <a:extLst>
                  <a:ext uri="{FF2B5EF4-FFF2-40B4-BE49-F238E27FC236}">
                    <a16:creationId xmlns:a16="http://schemas.microsoft.com/office/drawing/2014/main" id="{183181FD-927D-B8BD-B14E-8E6D427CF70C}"/>
                  </a:ext>
                </a:extLst>
              </p:cNvPr>
              <p:cNvSpPr txBox="1"/>
              <p:nvPr/>
            </p:nvSpPr>
            <p:spPr>
              <a:xfrm>
                <a:off x="8471033" y="6405306"/>
                <a:ext cx="3391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120" name="Szövegdoboz 119">
                <a:extLst>
                  <a:ext uri="{FF2B5EF4-FFF2-40B4-BE49-F238E27FC236}">
                    <a16:creationId xmlns:a16="http://schemas.microsoft.com/office/drawing/2014/main" id="{174A1CD1-EBA8-9720-C561-1998AABAD485}"/>
                  </a:ext>
                </a:extLst>
              </p:cNvPr>
              <p:cNvSpPr txBox="1"/>
              <p:nvPr/>
            </p:nvSpPr>
            <p:spPr>
              <a:xfrm>
                <a:off x="8897154" y="6409523"/>
                <a:ext cx="3391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121" name="Szövegdoboz 120">
                <a:extLst>
                  <a:ext uri="{FF2B5EF4-FFF2-40B4-BE49-F238E27FC236}">
                    <a16:creationId xmlns:a16="http://schemas.microsoft.com/office/drawing/2014/main" id="{A3092E64-8355-6DA2-D475-B8D95EF5B70F}"/>
                  </a:ext>
                </a:extLst>
              </p:cNvPr>
              <p:cNvSpPr txBox="1"/>
              <p:nvPr/>
            </p:nvSpPr>
            <p:spPr>
              <a:xfrm>
                <a:off x="9326424" y="6409017"/>
                <a:ext cx="3391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122" name="Szövegdoboz 121">
                <a:extLst>
                  <a:ext uri="{FF2B5EF4-FFF2-40B4-BE49-F238E27FC236}">
                    <a16:creationId xmlns:a16="http://schemas.microsoft.com/office/drawing/2014/main" id="{92E64223-5469-1478-65C3-06ADEE78A664}"/>
                  </a:ext>
                </a:extLst>
              </p:cNvPr>
              <p:cNvSpPr txBox="1"/>
              <p:nvPr/>
            </p:nvSpPr>
            <p:spPr>
              <a:xfrm>
                <a:off x="7770072" y="6507592"/>
                <a:ext cx="170629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CD14</a:t>
                </a:r>
              </a:p>
            </p:txBody>
          </p:sp>
          <p:sp>
            <p:nvSpPr>
              <p:cNvPr id="123" name="Szövegdoboz 122">
                <a:extLst>
                  <a:ext uri="{FF2B5EF4-FFF2-40B4-BE49-F238E27FC236}">
                    <a16:creationId xmlns:a16="http://schemas.microsoft.com/office/drawing/2014/main" id="{E9323090-D4AA-78F7-FD7D-7253933787EF}"/>
                  </a:ext>
                </a:extLst>
              </p:cNvPr>
              <p:cNvSpPr txBox="1"/>
              <p:nvPr/>
            </p:nvSpPr>
            <p:spPr>
              <a:xfrm rot="16200000">
                <a:off x="6768127" y="5554069"/>
                <a:ext cx="144046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HLA-DR</a:t>
                </a:r>
              </a:p>
            </p:txBody>
          </p:sp>
        </p:grpSp>
        <p:grpSp>
          <p:nvGrpSpPr>
            <p:cNvPr id="141" name="Csoportba foglalás 140">
              <a:extLst>
                <a:ext uri="{FF2B5EF4-FFF2-40B4-BE49-F238E27FC236}">
                  <a16:creationId xmlns:a16="http://schemas.microsoft.com/office/drawing/2014/main" id="{31376940-6857-B3CA-26ED-37ED7E1D45BE}"/>
                </a:ext>
              </a:extLst>
            </p:cNvPr>
            <p:cNvGrpSpPr/>
            <p:nvPr/>
          </p:nvGrpSpPr>
          <p:grpSpPr>
            <a:xfrm>
              <a:off x="9812151" y="4894951"/>
              <a:ext cx="2308119" cy="1878156"/>
              <a:chOff x="9812151" y="4894951"/>
              <a:chExt cx="2308119" cy="1878156"/>
            </a:xfrm>
          </p:grpSpPr>
          <p:pic>
            <p:nvPicPr>
              <p:cNvPr id="14" name="Kép 13">
                <a:extLst>
                  <a:ext uri="{FF2B5EF4-FFF2-40B4-BE49-F238E27FC236}">
                    <a16:creationId xmlns:a16="http://schemas.microsoft.com/office/drawing/2014/main" id="{7AC75A3E-1532-3DF4-8B19-4075851DD47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l="18968" t="12376" r="2074" b="16642"/>
              <a:stretch/>
            </p:blipFill>
            <p:spPr>
              <a:xfrm>
                <a:off x="10181815" y="4959350"/>
                <a:ext cx="1797460" cy="1514475"/>
              </a:xfrm>
              <a:prstGeom prst="rect">
                <a:avLst/>
              </a:prstGeom>
            </p:spPr>
          </p:pic>
          <p:sp>
            <p:nvSpPr>
              <p:cNvPr id="124" name="Szövegdoboz 123">
                <a:extLst>
                  <a:ext uri="{FF2B5EF4-FFF2-40B4-BE49-F238E27FC236}">
                    <a16:creationId xmlns:a16="http://schemas.microsoft.com/office/drawing/2014/main" id="{7769449A-5A09-7228-D157-0C77EC633C3D}"/>
                  </a:ext>
                </a:extLst>
              </p:cNvPr>
              <p:cNvSpPr txBox="1"/>
              <p:nvPr/>
            </p:nvSpPr>
            <p:spPr>
              <a:xfrm>
                <a:off x="10003037" y="6306876"/>
                <a:ext cx="20540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25" name="Szövegdoboz 124">
                <a:extLst>
                  <a:ext uri="{FF2B5EF4-FFF2-40B4-BE49-F238E27FC236}">
                    <a16:creationId xmlns:a16="http://schemas.microsoft.com/office/drawing/2014/main" id="{5159ACC8-61E4-90E0-4221-401E4E144249}"/>
                  </a:ext>
                </a:extLst>
              </p:cNvPr>
              <p:cNvSpPr txBox="1"/>
              <p:nvPr/>
            </p:nvSpPr>
            <p:spPr>
              <a:xfrm>
                <a:off x="9924021" y="5597485"/>
                <a:ext cx="3391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126" name="Szövegdoboz 125">
                <a:extLst>
                  <a:ext uri="{FF2B5EF4-FFF2-40B4-BE49-F238E27FC236}">
                    <a16:creationId xmlns:a16="http://schemas.microsoft.com/office/drawing/2014/main" id="{0533977E-1AB1-7EBC-2B88-5CD8EABAC94B}"/>
                  </a:ext>
                </a:extLst>
              </p:cNvPr>
              <p:cNvSpPr txBox="1"/>
              <p:nvPr/>
            </p:nvSpPr>
            <p:spPr>
              <a:xfrm>
                <a:off x="9930397" y="5951093"/>
                <a:ext cx="33918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127" name="Szövegdoboz 126">
                <a:extLst>
                  <a:ext uri="{FF2B5EF4-FFF2-40B4-BE49-F238E27FC236}">
                    <a16:creationId xmlns:a16="http://schemas.microsoft.com/office/drawing/2014/main" id="{01957872-EAC0-A28C-B636-259349AEDF7D}"/>
                  </a:ext>
                </a:extLst>
              </p:cNvPr>
              <p:cNvSpPr txBox="1"/>
              <p:nvPr/>
            </p:nvSpPr>
            <p:spPr>
              <a:xfrm>
                <a:off x="9922327" y="4894951"/>
                <a:ext cx="3391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128" name="Szövegdoboz 127">
                <a:extLst>
                  <a:ext uri="{FF2B5EF4-FFF2-40B4-BE49-F238E27FC236}">
                    <a16:creationId xmlns:a16="http://schemas.microsoft.com/office/drawing/2014/main" id="{4BF044F1-0B8A-D906-5D1D-81B22038880A}"/>
                  </a:ext>
                </a:extLst>
              </p:cNvPr>
              <p:cNvSpPr txBox="1"/>
              <p:nvPr/>
            </p:nvSpPr>
            <p:spPr>
              <a:xfrm>
                <a:off x="9927149" y="5257538"/>
                <a:ext cx="3391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129" name="Szövegdoboz 128">
                <a:extLst>
                  <a:ext uri="{FF2B5EF4-FFF2-40B4-BE49-F238E27FC236}">
                    <a16:creationId xmlns:a16="http://schemas.microsoft.com/office/drawing/2014/main" id="{3437429F-1405-992A-2EC9-D4714FF446F5}"/>
                  </a:ext>
                </a:extLst>
              </p:cNvPr>
              <p:cNvSpPr txBox="1"/>
              <p:nvPr/>
            </p:nvSpPr>
            <p:spPr>
              <a:xfrm>
                <a:off x="10019267" y="6420404"/>
                <a:ext cx="4425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30" name="Szövegdoboz 129">
                <a:extLst>
                  <a:ext uri="{FF2B5EF4-FFF2-40B4-BE49-F238E27FC236}">
                    <a16:creationId xmlns:a16="http://schemas.microsoft.com/office/drawing/2014/main" id="{F2C09785-32A0-D81E-F4F9-942B4BE0FE90}"/>
                  </a:ext>
                </a:extLst>
              </p:cNvPr>
              <p:cNvSpPr txBox="1"/>
              <p:nvPr/>
            </p:nvSpPr>
            <p:spPr>
              <a:xfrm>
                <a:off x="10502711" y="6418736"/>
                <a:ext cx="33918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131" name="Szövegdoboz 130">
                <a:extLst>
                  <a:ext uri="{FF2B5EF4-FFF2-40B4-BE49-F238E27FC236}">
                    <a16:creationId xmlns:a16="http://schemas.microsoft.com/office/drawing/2014/main" id="{BE70A907-D427-8222-83B9-8EF95650E32F}"/>
                  </a:ext>
                </a:extLst>
              </p:cNvPr>
              <p:cNvSpPr txBox="1"/>
              <p:nvPr/>
            </p:nvSpPr>
            <p:spPr>
              <a:xfrm>
                <a:off x="10925630" y="6409211"/>
                <a:ext cx="3391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132" name="Szövegdoboz 131">
                <a:extLst>
                  <a:ext uri="{FF2B5EF4-FFF2-40B4-BE49-F238E27FC236}">
                    <a16:creationId xmlns:a16="http://schemas.microsoft.com/office/drawing/2014/main" id="{44FF3DD5-303F-92F0-1040-36308AD73C6A}"/>
                  </a:ext>
                </a:extLst>
              </p:cNvPr>
              <p:cNvSpPr txBox="1"/>
              <p:nvPr/>
            </p:nvSpPr>
            <p:spPr>
              <a:xfrm>
                <a:off x="11351751" y="6413428"/>
                <a:ext cx="3391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133" name="Szövegdoboz 132">
                <a:extLst>
                  <a:ext uri="{FF2B5EF4-FFF2-40B4-BE49-F238E27FC236}">
                    <a16:creationId xmlns:a16="http://schemas.microsoft.com/office/drawing/2014/main" id="{1B931B75-7949-BE5B-BF83-72B34A284C17}"/>
                  </a:ext>
                </a:extLst>
              </p:cNvPr>
              <p:cNvSpPr txBox="1"/>
              <p:nvPr/>
            </p:nvSpPr>
            <p:spPr>
              <a:xfrm>
                <a:off x="10224669" y="6511497"/>
                <a:ext cx="170629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CD16</a:t>
                </a:r>
              </a:p>
            </p:txBody>
          </p:sp>
          <p:sp>
            <p:nvSpPr>
              <p:cNvPr id="134" name="Szövegdoboz 133">
                <a:extLst>
                  <a:ext uri="{FF2B5EF4-FFF2-40B4-BE49-F238E27FC236}">
                    <a16:creationId xmlns:a16="http://schemas.microsoft.com/office/drawing/2014/main" id="{6BD0152C-904A-3397-11B0-E5C3EF1BABB9}"/>
                  </a:ext>
                </a:extLst>
              </p:cNvPr>
              <p:cNvSpPr txBox="1"/>
              <p:nvPr/>
            </p:nvSpPr>
            <p:spPr>
              <a:xfrm rot="16200000">
                <a:off x="9222724" y="5557974"/>
                <a:ext cx="144046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>
                    <a:latin typeface="Arial" panose="020B0604020202020204" pitchFamily="34" charset="0"/>
                    <a:cs typeface="Arial" panose="020B0604020202020204" pitchFamily="34" charset="0"/>
                  </a:rPr>
                  <a:t>CD14</a:t>
                </a:r>
              </a:p>
            </p:txBody>
          </p:sp>
          <p:sp>
            <p:nvSpPr>
              <p:cNvPr id="135" name="Szövegdoboz 134">
                <a:extLst>
                  <a:ext uri="{FF2B5EF4-FFF2-40B4-BE49-F238E27FC236}">
                    <a16:creationId xmlns:a16="http://schemas.microsoft.com/office/drawing/2014/main" id="{491393CE-D66E-F932-ED0A-C9A32F49F4D3}"/>
                  </a:ext>
                </a:extLst>
              </p:cNvPr>
              <p:cNvSpPr txBox="1"/>
              <p:nvPr/>
            </p:nvSpPr>
            <p:spPr>
              <a:xfrm>
                <a:off x="11781087" y="6409625"/>
                <a:ext cx="33918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</p:grpSp>
        <p:sp>
          <p:nvSpPr>
            <p:cNvPr id="145" name="Téglalap 144">
              <a:extLst>
                <a:ext uri="{FF2B5EF4-FFF2-40B4-BE49-F238E27FC236}">
                  <a16:creationId xmlns:a16="http://schemas.microsoft.com/office/drawing/2014/main" id="{C7B90797-A62C-1B0F-989D-79FE065AB340}"/>
                </a:ext>
              </a:extLst>
            </p:cNvPr>
            <p:cNvSpPr/>
            <p:nvPr/>
          </p:nvSpPr>
          <p:spPr>
            <a:xfrm>
              <a:off x="546866" y="1551773"/>
              <a:ext cx="1547399" cy="385432"/>
            </a:xfrm>
            <a:prstGeom prst="rect">
              <a:avLst/>
            </a:prstGeom>
            <a:noFill/>
            <a:ln w="190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6" name="Szövegdoboz 145">
              <a:extLst>
                <a:ext uri="{FF2B5EF4-FFF2-40B4-BE49-F238E27FC236}">
                  <a16:creationId xmlns:a16="http://schemas.microsoft.com/office/drawing/2014/main" id="{991B820A-772B-542B-98D9-AC62088D5E84}"/>
                </a:ext>
              </a:extLst>
            </p:cNvPr>
            <p:cNvSpPr txBox="1"/>
            <p:nvPr/>
          </p:nvSpPr>
          <p:spPr>
            <a:xfrm>
              <a:off x="-16935" y="66133"/>
              <a:ext cx="331167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>
                  <a:latin typeface="Arial" panose="020B0604020202020204" pitchFamily="34" charset="0"/>
                  <a:cs typeface="Arial" panose="020B0604020202020204" pitchFamily="34" charset="0"/>
                </a:rPr>
                <a:t>Supplementary figure 1.</a:t>
              </a:r>
            </a:p>
          </p:txBody>
        </p:sp>
        <p:sp>
          <p:nvSpPr>
            <p:cNvPr id="2" name="Szövegdoboz 1">
              <a:extLst>
                <a:ext uri="{FF2B5EF4-FFF2-40B4-BE49-F238E27FC236}">
                  <a16:creationId xmlns:a16="http://schemas.microsoft.com/office/drawing/2014/main" id="{C6E3E874-3D35-5D03-9DED-92324692F986}"/>
                </a:ext>
              </a:extLst>
            </p:cNvPr>
            <p:cNvSpPr txBox="1"/>
            <p:nvPr/>
          </p:nvSpPr>
          <p:spPr>
            <a:xfrm>
              <a:off x="-290549" y="421462"/>
              <a:ext cx="102748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3" name="Szövegdoboz 2">
              <a:extLst>
                <a:ext uri="{FF2B5EF4-FFF2-40B4-BE49-F238E27FC236}">
                  <a16:creationId xmlns:a16="http://schemas.microsoft.com/office/drawing/2014/main" id="{578F7402-CE6F-A19A-6572-414231287424}"/>
                </a:ext>
              </a:extLst>
            </p:cNvPr>
            <p:cNvSpPr txBox="1"/>
            <p:nvPr/>
          </p:nvSpPr>
          <p:spPr>
            <a:xfrm>
              <a:off x="2439" y="2384726"/>
              <a:ext cx="45700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6" name="Szövegdoboz 5">
              <a:extLst>
                <a:ext uri="{FF2B5EF4-FFF2-40B4-BE49-F238E27FC236}">
                  <a16:creationId xmlns:a16="http://schemas.microsoft.com/office/drawing/2014/main" id="{BE217D20-2DA3-6DD0-111B-8C8180BBB0BC}"/>
                </a:ext>
              </a:extLst>
            </p:cNvPr>
            <p:cNvSpPr txBox="1"/>
            <p:nvPr/>
          </p:nvSpPr>
          <p:spPr>
            <a:xfrm>
              <a:off x="2661802" y="2391769"/>
              <a:ext cx="45700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0" name="Szövegdoboz 9">
              <a:extLst>
                <a:ext uri="{FF2B5EF4-FFF2-40B4-BE49-F238E27FC236}">
                  <a16:creationId xmlns:a16="http://schemas.microsoft.com/office/drawing/2014/main" id="{55134FBC-26C5-5821-5524-63D18E411B06}"/>
                </a:ext>
              </a:extLst>
            </p:cNvPr>
            <p:cNvSpPr txBox="1"/>
            <p:nvPr/>
          </p:nvSpPr>
          <p:spPr>
            <a:xfrm>
              <a:off x="5088922" y="2388776"/>
              <a:ext cx="45700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12" name="Szövegdoboz 11">
              <a:extLst>
                <a:ext uri="{FF2B5EF4-FFF2-40B4-BE49-F238E27FC236}">
                  <a16:creationId xmlns:a16="http://schemas.microsoft.com/office/drawing/2014/main" id="{8F3523FC-7E93-87B0-B814-DC6096E337B1}"/>
                </a:ext>
              </a:extLst>
            </p:cNvPr>
            <p:cNvSpPr txBox="1"/>
            <p:nvPr/>
          </p:nvSpPr>
          <p:spPr>
            <a:xfrm>
              <a:off x="7513695" y="2384426"/>
              <a:ext cx="45700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sp>
          <p:nvSpPr>
            <p:cNvPr id="35" name="Szövegdoboz 34">
              <a:extLst>
                <a:ext uri="{FF2B5EF4-FFF2-40B4-BE49-F238E27FC236}">
                  <a16:creationId xmlns:a16="http://schemas.microsoft.com/office/drawing/2014/main" id="{7AEE56ED-CD34-E63A-58D5-1C9BAA784654}"/>
                </a:ext>
              </a:extLst>
            </p:cNvPr>
            <p:cNvSpPr txBox="1"/>
            <p:nvPr/>
          </p:nvSpPr>
          <p:spPr>
            <a:xfrm>
              <a:off x="2669585" y="4590482"/>
              <a:ext cx="45700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</a:p>
          </p:txBody>
        </p:sp>
        <p:sp>
          <p:nvSpPr>
            <p:cNvPr id="36" name="Szövegdoboz 35">
              <a:extLst>
                <a:ext uri="{FF2B5EF4-FFF2-40B4-BE49-F238E27FC236}">
                  <a16:creationId xmlns:a16="http://schemas.microsoft.com/office/drawing/2014/main" id="{B908ADE1-33DC-4D40-6D5C-5E4F44A50B42}"/>
                </a:ext>
              </a:extLst>
            </p:cNvPr>
            <p:cNvSpPr txBox="1"/>
            <p:nvPr/>
          </p:nvSpPr>
          <p:spPr>
            <a:xfrm>
              <a:off x="5096705" y="4587489"/>
              <a:ext cx="45700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</a:p>
          </p:txBody>
        </p:sp>
        <p:sp>
          <p:nvSpPr>
            <p:cNvPr id="37" name="Szövegdoboz 36">
              <a:extLst>
                <a:ext uri="{FF2B5EF4-FFF2-40B4-BE49-F238E27FC236}">
                  <a16:creationId xmlns:a16="http://schemas.microsoft.com/office/drawing/2014/main" id="{2FF11254-202C-CB70-D20C-8983FED7A55D}"/>
                </a:ext>
              </a:extLst>
            </p:cNvPr>
            <p:cNvSpPr txBox="1"/>
            <p:nvPr/>
          </p:nvSpPr>
          <p:spPr>
            <a:xfrm>
              <a:off x="7521478" y="4583139"/>
              <a:ext cx="45700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</a:p>
          </p:txBody>
        </p:sp>
        <p:sp>
          <p:nvSpPr>
            <p:cNvPr id="39" name="Szövegdoboz 38">
              <a:extLst>
                <a:ext uri="{FF2B5EF4-FFF2-40B4-BE49-F238E27FC236}">
                  <a16:creationId xmlns:a16="http://schemas.microsoft.com/office/drawing/2014/main" id="{D4FA97FB-698B-E6C4-6C62-F2585E2B382C}"/>
                </a:ext>
              </a:extLst>
            </p:cNvPr>
            <p:cNvSpPr txBox="1"/>
            <p:nvPr/>
          </p:nvSpPr>
          <p:spPr>
            <a:xfrm>
              <a:off x="9979936" y="4583139"/>
              <a:ext cx="45700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>
                  <a:latin typeface="Arial" panose="020B0604020202020204" pitchFamily="34" charset="0"/>
                  <a:cs typeface="Arial" panose="020B0604020202020204" pitchFamily="34" charset="0"/>
                </a:rPr>
                <a:t>J</a:t>
              </a:r>
            </a:p>
          </p:txBody>
        </p:sp>
        <p:pic>
          <p:nvPicPr>
            <p:cNvPr id="83" name="Kép 82">
              <a:extLst>
                <a:ext uri="{FF2B5EF4-FFF2-40B4-BE49-F238E27FC236}">
                  <a16:creationId xmlns:a16="http://schemas.microsoft.com/office/drawing/2014/main" id="{F8ABD138-8C57-B1A8-0605-8979238A853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8581" t="12381" r="1902" b="16324"/>
            <a:stretch/>
          </p:blipFill>
          <p:spPr>
            <a:xfrm>
              <a:off x="5310554" y="607717"/>
              <a:ext cx="1810175" cy="1521153"/>
            </a:xfrm>
            <a:prstGeom prst="rect">
              <a:avLst/>
            </a:prstGeom>
          </p:spPr>
        </p:pic>
        <p:sp>
          <p:nvSpPr>
            <p:cNvPr id="84" name="Szövegdoboz 83">
              <a:extLst>
                <a:ext uri="{FF2B5EF4-FFF2-40B4-BE49-F238E27FC236}">
                  <a16:creationId xmlns:a16="http://schemas.microsoft.com/office/drawing/2014/main" id="{251D084C-7488-1C00-4547-530832907C99}"/>
                </a:ext>
              </a:extLst>
            </p:cNvPr>
            <p:cNvSpPr txBox="1"/>
            <p:nvPr/>
          </p:nvSpPr>
          <p:spPr>
            <a:xfrm>
              <a:off x="5135716" y="1953832"/>
              <a:ext cx="19152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85" name="Szövegdoboz 84">
              <a:extLst>
                <a:ext uri="{FF2B5EF4-FFF2-40B4-BE49-F238E27FC236}">
                  <a16:creationId xmlns:a16="http://schemas.microsoft.com/office/drawing/2014/main" id="{8730FFE5-896A-265E-6203-5518A4EE0C6E}"/>
                </a:ext>
              </a:extLst>
            </p:cNvPr>
            <p:cNvSpPr txBox="1"/>
            <p:nvPr/>
          </p:nvSpPr>
          <p:spPr>
            <a:xfrm>
              <a:off x="5056700" y="1244441"/>
              <a:ext cx="31626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700" baseline="3000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86" name="Szövegdoboz 85">
              <a:extLst>
                <a:ext uri="{FF2B5EF4-FFF2-40B4-BE49-F238E27FC236}">
                  <a16:creationId xmlns:a16="http://schemas.microsoft.com/office/drawing/2014/main" id="{83A87D6E-2D54-99C0-357C-6B4CBE33D10B}"/>
                </a:ext>
              </a:extLst>
            </p:cNvPr>
            <p:cNvSpPr txBox="1"/>
            <p:nvPr/>
          </p:nvSpPr>
          <p:spPr>
            <a:xfrm>
              <a:off x="5063076" y="1598049"/>
              <a:ext cx="316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700" baseline="3000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87" name="Szövegdoboz 86">
              <a:extLst>
                <a:ext uri="{FF2B5EF4-FFF2-40B4-BE49-F238E27FC236}">
                  <a16:creationId xmlns:a16="http://schemas.microsoft.com/office/drawing/2014/main" id="{B3DF72D2-09BD-3967-127E-26D6EE3B6AE5}"/>
                </a:ext>
              </a:extLst>
            </p:cNvPr>
            <p:cNvSpPr txBox="1"/>
            <p:nvPr/>
          </p:nvSpPr>
          <p:spPr>
            <a:xfrm>
              <a:off x="5055006" y="541907"/>
              <a:ext cx="31626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700" baseline="3000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47" name="Szövegdoboz 146">
              <a:extLst>
                <a:ext uri="{FF2B5EF4-FFF2-40B4-BE49-F238E27FC236}">
                  <a16:creationId xmlns:a16="http://schemas.microsoft.com/office/drawing/2014/main" id="{BBD358C4-2EE3-09E6-9E55-C4F8ADD39440}"/>
                </a:ext>
              </a:extLst>
            </p:cNvPr>
            <p:cNvSpPr txBox="1"/>
            <p:nvPr/>
          </p:nvSpPr>
          <p:spPr>
            <a:xfrm>
              <a:off x="5059828" y="904494"/>
              <a:ext cx="31626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700" baseline="3000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48" name="Szövegdoboz 147">
              <a:extLst>
                <a:ext uri="{FF2B5EF4-FFF2-40B4-BE49-F238E27FC236}">
                  <a16:creationId xmlns:a16="http://schemas.microsoft.com/office/drawing/2014/main" id="{33B49457-7FF5-9D35-2E5C-7E25FDCC512E}"/>
                </a:ext>
              </a:extLst>
            </p:cNvPr>
            <p:cNvSpPr txBox="1"/>
            <p:nvPr/>
          </p:nvSpPr>
          <p:spPr>
            <a:xfrm rot="16200000">
              <a:off x="4263905" y="1286674"/>
              <a:ext cx="159625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>
                  <a:latin typeface="Arial" panose="020B0604020202020204" pitchFamily="34" charset="0"/>
                  <a:cs typeface="Arial" panose="020B0604020202020204" pitchFamily="34" charset="0"/>
                </a:rPr>
                <a:t>CD56</a:t>
              </a:r>
            </a:p>
          </p:txBody>
        </p:sp>
        <p:sp>
          <p:nvSpPr>
            <p:cNvPr id="149" name="Szövegdoboz 148">
              <a:extLst>
                <a:ext uri="{FF2B5EF4-FFF2-40B4-BE49-F238E27FC236}">
                  <a16:creationId xmlns:a16="http://schemas.microsoft.com/office/drawing/2014/main" id="{39F683AF-8E29-21DA-F291-9DA291E10604}"/>
                </a:ext>
              </a:extLst>
            </p:cNvPr>
            <p:cNvSpPr txBox="1"/>
            <p:nvPr/>
          </p:nvSpPr>
          <p:spPr>
            <a:xfrm>
              <a:off x="6838520" y="2078312"/>
              <a:ext cx="4906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1024</a:t>
              </a:r>
            </a:p>
          </p:txBody>
        </p:sp>
        <p:sp>
          <p:nvSpPr>
            <p:cNvPr id="150" name="Szövegdoboz 149">
              <a:extLst>
                <a:ext uri="{FF2B5EF4-FFF2-40B4-BE49-F238E27FC236}">
                  <a16:creationId xmlns:a16="http://schemas.microsoft.com/office/drawing/2014/main" id="{CA7F0508-6F68-815F-F34B-03E8A98E6CC6}"/>
                </a:ext>
              </a:extLst>
            </p:cNvPr>
            <p:cNvSpPr txBox="1"/>
            <p:nvPr/>
          </p:nvSpPr>
          <p:spPr>
            <a:xfrm>
              <a:off x="5348453" y="2170426"/>
              <a:ext cx="173301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sp>
          <p:nvSpPr>
            <p:cNvPr id="151" name="Szövegdoboz 150">
              <a:extLst>
                <a:ext uri="{FF2B5EF4-FFF2-40B4-BE49-F238E27FC236}">
                  <a16:creationId xmlns:a16="http://schemas.microsoft.com/office/drawing/2014/main" id="{0FE0773B-3FDA-1CFE-C6F1-75091F9BEC04}"/>
                </a:ext>
              </a:extLst>
            </p:cNvPr>
            <p:cNvSpPr txBox="1"/>
            <p:nvPr/>
          </p:nvSpPr>
          <p:spPr>
            <a:xfrm>
              <a:off x="5504385" y="2079788"/>
              <a:ext cx="5710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256</a:t>
              </a:r>
            </a:p>
          </p:txBody>
        </p:sp>
        <p:sp>
          <p:nvSpPr>
            <p:cNvPr id="152" name="Szövegdoboz 151">
              <a:extLst>
                <a:ext uri="{FF2B5EF4-FFF2-40B4-BE49-F238E27FC236}">
                  <a16:creationId xmlns:a16="http://schemas.microsoft.com/office/drawing/2014/main" id="{AE8B6A7B-1637-C2FD-F090-B11EB10757E5}"/>
                </a:ext>
              </a:extLst>
            </p:cNvPr>
            <p:cNvSpPr txBox="1"/>
            <p:nvPr/>
          </p:nvSpPr>
          <p:spPr>
            <a:xfrm>
              <a:off x="6365844" y="2082563"/>
              <a:ext cx="5710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768</a:t>
              </a:r>
            </a:p>
          </p:txBody>
        </p:sp>
        <p:sp>
          <p:nvSpPr>
            <p:cNvPr id="153" name="Szövegdoboz 152">
              <a:extLst>
                <a:ext uri="{FF2B5EF4-FFF2-40B4-BE49-F238E27FC236}">
                  <a16:creationId xmlns:a16="http://schemas.microsoft.com/office/drawing/2014/main" id="{F3432766-36C1-5784-AB38-C6EC474DCC55}"/>
                </a:ext>
              </a:extLst>
            </p:cNvPr>
            <p:cNvSpPr txBox="1"/>
            <p:nvPr/>
          </p:nvSpPr>
          <p:spPr>
            <a:xfrm>
              <a:off x="5131033" y="2079788"/>
              <a:ext cx="44250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54" name="Szövegdoboz 153">
              <a:extLst>
                <a:ext uri="{FF2B5EF4-FFF2-40B4-BE49-F238E27FC236}">
                  <a16:creationId xmlns:a16="http://schemas.microsoft.com/office/drawing/2014/main" id="{174F3B81-5895-24C4-EBDF-600599DADFDE}"/>
                </a:ext>
              </a:extLst>
            </p:cNvPr>
            <p:cNvSpPr txBox="1"/>
            <p:nvPr/>
          </p:nvSpPr>
          <p:spPr>
            <a:xfrm>
              <a:off x="5933713" y="2079728"/>
              <a:ext cx="5710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512</a:t>
              </a:r>
            </a:p>
          </p:txBody>
        </p:sp>
        <p:sp>
          <p:nvSpPr>
            <p:cNvPr id="155" name="Szövegdoboz 154">
              <a:extLst>
                <a:ext uri="{FF2B5EF4-FFF2-40B4-BE49-F238E27FC236}">
                  <a16:creationId xmlns:a16="http://schemas.microsoft.com/office/drawing/2014/main" id="{CD89EE37-120D-017A-1757-DBB380A3E3A8}"/>
                </a:ext>
              </a:extLst>
            </p:cNvPr>
            <p:cNvSpPr txBox="1"/>
            <p:nvPr/>
          </p:nvSpPr>
          <p:spPr>
            <a:xfrm>
              <a:off x="5074866" y="243008"/>
              <a:ext cx="45700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cxnSp>
          <p:nvCxnSpPr>
            <p:cNvPr id="156" name="Egyenes összekötő nyíllal 155">
              <a:extLst>
                <a:ext uri="{FF2B5EF4-FFF2-40B4-BE49-F238E27FC236}">
                  <a16:creationId xmlns:a16="http://schemas.microsoft.com/office/drawing/2014/main" id="{F5C2BB38-366A-2D9E-95EC-11CECC7D8B4B}"/>
                </a:ext>
              </a:extLst>
            </p:cNvPr>
            <p:cNvCxnSpPr/>
            <p:nvPr/>
          </p:nvCxnSpPr>
          <p:spPr>
            <a:xfrm>
              <a:off x="1926913" y="1817781"/>
              <a:ext cx="218" cy="878988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7" name="Téglalap 156">
              <a:extLst>
                <a:ext uri="{FF2B5EF4-FFF2-40B4-BE49-F238E27FC236}">
                  <a16:creationId xmlns:a16="http://schemas.microsoft.com/office/drawing/2014/main" id="{B1ADFD5E-D854-D4DD-4BA2-6EC7DF78E4A4}"/>
                </a:ext>
              </a:extLst>
            </p:cNvPr>
            <p:cNvSpPr/>
            <p:nvPr/>
          </p:nvSpPr>
          <p:spPr>
            <a:xfrm>
              <a:off x="562924" y="3683338"/>
              <a:ext cx="1130937" cy="292076"/>
            </a:xfrm>
            <a:prstGeom prst="rect">
              <a:avLst/>
            </a:prstGeom>
            <a:noFill/>
            <a:ln w="190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58" name="Egyenes összekötő nyíllal 157">
              <a:extLst>
                <a:ext uri="{FF2B5EF4-FFF2-40B4-BE49-F238E27FC236}">
                  <a16:creationId xmlns:a16="http://schemas.microsoft.com/office/drawing/2014/main" id="{06BC63E0-289C-23FC-38FB-87CD6F2F4EB4}"/>
                </a:ext>
              </a:extLst>
            </p:cNvPr>
            <p:cNvCxnSpPr/>
            <p:nvPr/>
          </p:nvCxnSpPr>
          <p:spPr>
            <a:xfrm flipV="1">
              <a:off x="1527913" y="3896108"/>
              <a:ext cx="936825" cy="644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9" name="Ellipszis 158">
              <a:extLst>
                <a:ext uri="{FF2B5EF4-FFF2-40B4-BE49-F238E27FC236}">
                  <a16:creationId xmlns:a16="http://schemas.microsoft.com/office/drawing/2014/main" id="{BD9F5022-6724-186A-5955-4416A2AF239A}"/>
                </a:ext>
              </a:extLst>
            </p:cNvPr>
            <p:cNvSpPr/>
            <p:nvPr/>
          </p:nvSpPr>
          <p:spPr>
            <a:xfrm>
              <a:off x="3444932" y="3830160"/>
              <a:ext cx="435961" cy="434095"/>
            </a:xfrm>
            <a:prstGeom prst="ellipse">
              <a:avLst/>
            </a:prstGeom>
            <a:noFill/>
            <a:ln w="190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0" name="Ellipszis 159">
              <a:extLst>
                <a:ext uri="{FF2B5EF4-FFF2-40B4-BE49-F238E27FC236}">
                  <a16:creationId xmlns:a16="http://schemas.microsoft.com/office/drawing/2014/main" id="{1D1E02D2-C9EA-133F-B7B6-0F45B6896A38}"/>
                </a:ext>
              </a:extLst>
            </p:cNvPr>
            <p:cNvSpPr/>
            <p:nvPr/>
          </p:nvSpPr>
          <p:spPr>
            <a:xfrm rot="2048304">
              <a:off x="3799255" y="3121500"/>
              <a:ext cx="685928" cy="939294"/>
            </a:xfrm>
            <a:prstGeom prst="ellipse">
              <a:avLst/>
            </a:prstGeom>
            <a:noFill/>
            <a:ln w="190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61" name="Egyenes összekötő nyíllal 160">
              <a:extLst>
                <a:ext uri="{FF2B5EF4-FFF2-40B4-BE49-F238E27FC236}">
                  <a16:creationId xmlns:a16="http://schemas.microsoft.com/office/drawing/2014/main" id="{F819BD68-AD7C-F587-3527-849BAC72EE73}"/>
                </a:ext>
              </a:extLst>
            </p:cNvPr>
            <p:cNvCxnSpPr/>
            <p:nvPr/>
          </p:nvCxnSpPr>
          <p:spPr>
            <a:xfrm flipV="1">
              <a:off x="3882419" y="4013082"/>
              <a:ext cx="1133561" cy="644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Egyenes összekötő nyíllal 161">
              <a:extLst>
                <a:ext uri="{FF2B5EF4-FFF2-40B4-BE49-F238E27FC236}">
                  <a16:creationId xmlns:a16="http://schemas.microsoft.com/office/drawing/2014/main" id="{044AA4EB-17FC-E202-3E4E-17C5E7BCB400}"/>
                </a:ext>
              </a:extLst>
            </p:cNvPr>
            <p:cNvCxnSpPr/>
            <p:nvPr/>
          </p:nvCxnSpPr>
          <p:spPr>
            <a:xfrm>
              <a:off x="4351172" y="3759153"/>
              <a:ext cx="218" cy="966887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3" name="Téglalap 162">
              <a:extLst>
                <a:ext uri="{FF2B5EF4-FFF2-40B4-BE49-F238E27FC236}">
                  <a16:creationId xmlns:a16="http://schemas.microsoft.com/office/drawing/2014/main" id="{02E74BD2-7003-DA88-9B01-E57974E60465}"/>
                </a:ext>
              </a:extLst>
            </p:cNvPr>
            <p:cNvSpPr/>
            <p:nvPr/>
          </p:nvSpPr>
          <p:spPr>
            <a:xfrm>
              <a:off x="2975728" y="5201404"/>
              <a:ext cx="767598" cy="1023789"/>
            </a:xfrm>
            <a:prstGeom prst="rect">
              <a:avLst/>
            </a:prstGeom>
            <a:noFill/>
            <a:ln w="190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4" name="Téglalap 163">
              <a:extLst>
                <a:ext uri="{FF2B5EF4-FFF2-40B4-BE49-F238E27FC236}">
                  <a16:creationId xmlns:a16="http://schemas.microsoft.com/office/drawing/2014/main" id="{DF805E70-5893-6ECC-BCF4-A8382EE67955}"/>
                </a:ext>
              </a:extLst>
            </p:cNvPr>
            <p:cNvSpPr/>
            <p:nvPr/>
          </p:nvSpPr>
          <p:spPr>
            <a:xfrm>
              <a:off x="6184308" y="3842066"/>
              <a:ext cx="432402" cy="441516"/>
            </a:xfrm>
            <a:prstGeom prst="rect">
              <a:avLst/>
            </a:prstGeom>
            <a:noFill/>
            <a:ln w="190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5" name="Téglalap 164">
              <a:extLst>
                <a:ext uri="{FF2B5EF4-FFF2-40B4-BE49-F238E27FC236}">
                  <a16:creationId xmlns:a16="http://schemas.microsoft.com/office/drawing/2014/main" id="{4338AEAA-E579-EA46-8896-171604AFAD22}"/>
                </a:ext>
              </a:extLst>
            </p:cNvPr>
            <p:cNvSpPr/>
            <p:nvPr/>
          </p:nvSpPr>
          <p:spPr>
            <a:xfrm>
              <a:off x="6181022" y="3353386"/>
              <a:ext cx="435687" cy="479912"/>
            </a:xfrm>
            <a:prstGeom prst="rect">
              <a:avLst/>
            </a:prstGeom>
            <a:noFill/>
            <a:ln w="190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6" name="Téglalap 165">
              <a:extLst>
                <a:ext uri="{FF2B5EF4-FFF2-40B4-BE49-F238E27FC236}">
                  <a16:creationId xmlns:a16="http://schemas.microsoft.com/office/drawing/2014/main" id="{80A8B214-C174-94BE-F412-97E028397660}"/>
                </a:ext>
              </a:extLst>
            </p:cNvPr>
            <p:cNvSpPr/>
            <p:nvPr/>
          </p:nvSpPr>
          <p:spPr>
            <a:xfrm>
              <a:off x="5379338" y="3147318"/>
              <a:ext cx="620995" cy="694748"/>
            </a:xfrm>
            <a:prstGeom prst="rect">
              <a:avLst/>
            </a:prstGeom>
            <a:noFill/>
            <a:ln w="190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1" name="Téglalap 170">
              <a:extLst>
                <a:ext uri="{FF2B5EF4-FFF2-40B4-BE49-F238E27FC236}">
                  <a16:creationId xmlns:a16="http://schemas.microsoft.com/office/drawing/2014/main" id="{C63F64DB-50D1-92E8-5020-5B9AFDB5621A}"/>
                </a:ext>
              </a:extLst>
            </p:cNvPr>
            <p:cNvSpPr/>
            <p:nvPr/>
          </p:nvSpPr>
          <p:spPr>
            <a:xfrm>
              <a:off x="5390521" y="1160078"/>
              <a:ext cx="537258" cy="437971"/>
            </a:xfrm>
            <a:prstGeom prst="rect">
              <a:avLst/>
            </a:prstGeom>
            <a:noFill/>
            <a:ln w="190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2" name="Téglalap 171">
              <a:extLst>
                <a:ext uri="{FF2B5EF4-FFF2-40B4-BE49-F238E27FC236}">
                  <a16:creationId xmlns:a16="http://schemas.microsoft.com/office/drawing/2014/main" id="{05D2CDCE-38AC-41B1-1E0A-605725AD3B27}"/>
                </a:ext>
              </a:extLst>
            </p:cNvPr>
            <p:cNvSpPr/>
            <p:nvPr/>
          </p:nvSpPr>
          <p:spPr>
            <a:xfrm>
              <a:off x="5390521" y="926296"/>
              <a:ext cx="537257" cy="227274"/>
            </a:xfrm>
            <a:prstGeom prst="rect">
              <a:avLst/>
            </a:prstGeom>
            <a:noFill/>
            <a:ln w="190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3" name="Téglalap 172">
              <a:extLst>
                <a:ext uri="{FF2B5EF4-FFF2-40B4-BE49-F238E27FC236}">
                  <a16:creationId xmlns:a16="http://schemas.microsoft.com/office/drawing/2014/main" id="{9758D9C2-E534-2FFF-B21E-7367BE3E9B19}"/>
                </a:ext>
              </a:extLst>
            </p:cNvPr>
            <p:cNvSpPr/>
            <p:nvPr/>
          </p:nvSpPr>
          <p:spPr>
            <a:xfrm>
              <a:off x="7775142" y="3299278"/>
              <a:ext cx="695891" cy="323799"/>
            </a:xfrm>
            <a:prstGeom prst="rect">
              <a:avLst/>
            </a:prstGeom>
            <a:noFill/>
            <a:ln w="190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4" name="Téglalap 173">
              <a:extLst>
                <a:ext uri="{FF2B5EF4-FFF2-40B4-BE49-F238E27FC236}">
                  <a16:creationId xmlns:a16="http://schemas.microsoft.com/office/drawing/2014/main" id="{699F918F-8FBA-238A-144D-66BF3A75808C}"/>
                </a:ext>
              </a:extLst>
            </p:cNvPr>
            <p:cNvSpPr/>
            <p:nvPr/>
          </p:nvSpPr>
          <p:spPr>
            <a:xfrm>
              <a:off x="8615337" y="3835400"/>
              <a:ext cx="388963" cy="430143"/>
            </a:xfrm>
            <a:prstGeom prst="rect">
              <a:avLst/>
            </a:prstGeom>
            <a:noFill/>
            <a:ln w="190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5" name="Szövegdoboz 174">
              <a:extLst>
                <a:ext uri="{FF2B5EF4-FFF2-40B4-BE49-F238E27FC236}">
                  <a16:creationId xmlns:a16="http://schemas.microsoft.com/office/drawing/2014/main" id="{B0989D91-BACE-1FE9-F8DE-7A159A07BC41}"/>
                </a:ext>
              </a:extLst>
            </p:cNvPr>
            <p:cNvSpPr txBox="1"/>
            <p:nvPr/>
          </p:nvSpPr>
          <p:spPr>
            <a:xfrm>
              <a:off x="1097197" y="1328010"/>
              <a:ext cx="12842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>
                  <a:latin typeface="Arial" panose="020B0604020202020204" pitchFamily="34" charset="0"/>
                  <a:cs typeface="Arial" panose="020B0604020202020204" pitchFamily="34" charset="0"/>
                </a:rPr>
                <a:t>Doublet 1</a:t>
              </a:r>
            </a:p>
          </p:txBody>
        </p:sp>
        <p:sp>
          <p:nvSpPr>
            <p:cNvPr id="176" name="Szövegdoboz 175">
              <a:extLst>
                <a:ext uri="{FF2B5EF4-FFF2-40B4-BE49-F238E27FC236}">
                  <a16:creationId xmlns:a16="http://schemas.microsoft.com/office/drawing/2014/main" id="{5FE7A767-5748-4CDD-5EF7-4419B401DDB9}"/>
                </a:ext>
              </a:extLst>
            </p:cNvPr>
            <p:cNvSpPr txBox="1"/>
            <p:nvPr/>
          </p:nvSpPr>
          <p:spPr>
            <a:xfrm>
              <a:off x="5666511" y="1274964"/>
              <a:ext cx="12842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>
                  <a:latin typeface="Arial" panose="020B0604020202020204" pitchFamily="34" charset="0"/>
                  <a:cs typeface="Arial" panose="020B0604020202020204" pitchFamily="34" charset="0"/>
                </a:rPr>
                <a:t>NKdim cells</a:t>
              </a:r>
            </a:p>
          </p:txBody>
        </p:sp>
        <p:sp>
          <p:nvSpPr>
            <p:cNvPr id="177" name="Szövegdoboz 176">
              <a:extLst>
                <a:ext uri="{FF2B5EF4-FFF2-40B4-BE49-F238E27FC236}">
                  <a16:creationId xmlns:a16="http://schemas.microsoft.com/office/drawing/2014/main" id="{F57E65EC-C9FE-A639-3741-65EC5FF3E435}"/>
                </a:ext>
              </a:extLst>
            </p:cNvPr>
            <p:cNvSpPr txBox="1"/>
            <p:nvPr/>
          </p:nvSpPr>
          <p:spPr>
            <a:xfrm>
              <a:off x="3413835" y="2878457"/>
              <a:ext cx="12842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>
                  <a:latin typeface="Arial" panose="020B0604020202020204" pitchFamily="34" charset="0"/>
                  <a:cs typeface="Arial" panose="020B0604020202020204" pitchFamily="34" charset="0"/>
                </a:rPr>
                <a:t>Monocyte gate</a:t>
              </a:r>
            </a:p>
          </p:txBody>
        </p:sp>
        <p:sp>
          <p:nvSpPr>
            <p:cNvPr id="178" name="Szövegdoboz 177">
              <a:extLst>
                <a:ext uri="{FF2B5EF4-FFF2-40B4-BE49-F238E27FC236}">
                  <a16:creationId xmlns:a16="http://schemas.microsoft.com/office/drawing/2014/main" id="{202C9A28-B967-8679-DBA8-7B2D50C7A572}"/>
                </a:ext>
              </a:extLst>
            </p:cNvPr>
            <p:cNvSpPr txBox="1"/>
            <p:nvPr/>
          </p:nvSpPr>
          <p:spPr>
            <a:xfrm>
              <a:off x="3592897" y="4095359"/>
              <a:ext cx="12842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>
                  <a:latin typeface="Arial" panose="020B0604020202020204" pitchFamily="34" charset="0"/>
                  <a:cs typeface="Arial" panose="020B0604020202020204" pitchFamily="34" charset="0"/>
                </a:rPr>
                <a:t>Lymphogate</a:t>
              </a:r>
            </a:p>
          </p:txBody>
        </p:sp>
        <p:sp>
          <p:nvSpPr>
            <p:cNvPr id="179" name="Szövegdoboz 178">
              <a:extLst>
                <a:ext uri="{FF2B5EF4-FFF2-40B4-BE49-F238E27FC236}">
                  <a16:creationId xmlns:a16="http://schemas.microsoft.com/office/drawing/2014/main" id="{DED6DC3A-91A8-887C-8710-946F2B8A49DF}"/>
                </a:ext>
              </a:extLst>
            </p:cNvPr>
            <p:cNvSpPr txBox="1"/>
            <p:nvPr/>
          </p:nvSpPr>
          <p:spPr>
            <a:xfrm>
              <a:off x="1165455" y="3472778"/>
              <a:ext cx="12842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>
                  <a:latin typeface="Arial" panose="020B0604020202020204" pitchFamily="34" charset="0"/>
                  <a:cs typeface="Arial" panose="020B0604020202020204" pitchFamily="34" charset="0"/>
                </a:rPr>
                <a:t>Doublet 2</a:t>
              </a:r>
            </a:p>
          </p:txBody>
        </p:sp>
        <p:sp>
          <p:nvSpPr>
            <p:cNvPr id="180" name="Szövegdoboz 179">
              <a:extLst>
                <a:ext uri="{FF2B5EF4-FFF2-40B4-BE49-F238E27FC236}">
                  <a16:creationId xmlns:a16="http://schemas.microsoft.com/office/drawing/2014/main" id="{FE2D7031-5EE1-28E8-E969-68FFDC2168F8}"/>
                </a:ext>
              </a:extLst>
            </p:cNvPr>
            <p:cNvSpPr txBox="1"/>
            <p:nvPr/>
          </p:nvSpPr>
          <p:spPr>
            <a:xfrm>
              <a:off x="5723706" y="899125"/>
              <a:ext cx="12842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>
                  <a:latin typeface="Arial" panose="020B0604020202020204" pitchFamily="34" charset="0"/>
                  <a:cs typeface="Arial" panose="020B0604020202020204" pitchFamily="34" charset="0"/>
                </a:rPr>
                <a:t>NKbright cells</a:t>
              </a:r>
            </a:p>
          </p:txBody>
        </p:sp>
        <p:sp>
          <p:nvSpPr>
            <p:cNvPr id="181" name="Szövegdoboz 180">
              <a:extLst>
                <a:ext uri="{FF2B5EF4-FFF2-40B4-BE49-F238E27FC236}">
                  <a16:creationId xmlns:a16="http://schemas.microsoft.com/office/drawing/2014/main" id="{FA15EEE2-DEF8-D474-0310-5FF40E35E524}"/>
                </a:ext>
              </a:extLst>
            </p:cNvPr>
            <p:cNvSpPr txBox="1"/>
            <p:nvPr/>
          </p:nvSpPr>
          <p:spPr>
            <a:xfrm>
              <a:off x="5024077" y="2923874"/>
              <a:ext cx="12842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>
                  <a:latin typeface="Arial" panose="020B0604020202020204" pitchFamily="34" charset="0"/>
                  <a:cs typeface="Arial" panose="020B0604020202020204" pitchFamily="34" charset="0"/>
                </a:rPr>
                <a:t>NK cells</a:t>
              </a:r>
            </a:p>
          </p:txBody>
        </p:sp>
        <p:sp>
          <p:nvSpPr>
            <p:cNvPr id="182" name="Szövegdoboz 181">
              <a:extLst>
                <a:ext uri="{FF2B5EF4-FFF2-40B4-BE49-F238E27FC236}">
                  <a16:creationId xmlns:a16="http://schemas.microsoft.com/office/drawing/2014/main" id="{800EAEB6-C6E9-6FB1-3F14-BBF21227D332}"/>
                </a:ext>
              </a:extLst>
            </p:cNvPr>
            <p:cNvSpPr txBox="1"/>
            <p:nvPr/>
          </p:nvSpPr>
          <p:spPr>
            <a:xfrm>
              <a:off x="5824842" y="3156727"/>
              <a:ext cx="12842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>
                  <a:latin typeface="Arial" panose="020B0604020202020204" pitchFamily="34" charset="0"/>
                  <a:cs typeface="Arial" panose="020B0604020202020204" pitchFamily="34" charset="0"/>
                </a:rPr>
                <a:t>NKT cells</a:t>
              </a:r>
            </a:p>
          </p:txBody>
        </p:sp>
        <p:sp>
          <p:nvSpPr>
            <p:cNvPr id="183" name="Szövegdoboz 182">
              <a:extLst>
                <a:ext uri="{FF2B5EF4-FFF2-40B4-BE49-F238E27FC236}">
                  <a16:creationId xmlns:a16="http://schemas.microsoft.com/office/drawing/2014/main" id="{ABC37EDE-E25A-F660-2B86-246EA73B1A05}"/>
                </a:ext>
              </a:extLst>
            </p:cNvPr>
            <p:cNvSpPr txBox="1"/>
            <p:nvPr/>
          </p:nvSpPr>
          <p:spPr>
            <a:xfrm>
              <a:off x="6515967" y="3923626"/>
              <a:ext cx="6385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>
                  <a:latin typeface="Arial" panose="020B0604020202020204" pitchFamily="34" charset="0"/>
                  <a:cs typeface="Arial" panose="020B0604020202020204" pitchFamily="34" charset="0"/>
                </a:rPr>
                <a:t>CD3+T </a:t>
              </a:r>
            </a:p>
            <a:p>
              <a:pPr algn="ctr"/>
              <a:r>
                <a:rPr lang="en-US" sz="1000" b="1"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</a:p>
          </p:txBody>
        </p:sp>
        <p:cxnSp>
          <p:nvCxnSpPr>
            <p:cNvPr id="184" name="Egyenes összekötő nyíllal 183">
              <a:extLst>
                <a:ext uri="{FF2B5EF4-FFF2-40B4-BE49-F238E27FC236}">
                  <a16:creationId xmlns:a16="http://schemas.microsoft.com/office/drawing/2014/main" id="{13A40BA2-6DF8-8639-9479-4C03DE30BE1A}"/>
                </a:ext>
              </a:extLst>
            </p:cNvPr>
            <p:cNvCxnSpPr/>
            <p:nvPr/>
          </p:nvCxnSpPr>
          <p:spPr>
            <a:xfrm flipV="1">
              <a:off x="6464884" y="3937122"/>
              <a:ext cx="936827" cy="644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5" name="Szövegdoboz 184">
              <a:extLst>
                <a:ext uri="{FF2B5EF4-FFF2-40B4-BE49-F238E27FC236}">
                  <a16:creationId xmlns:a16="http://schemas.microsoft.com/office/drawing/2014/main" id="{1BF1972D-D2B2-3724-3B84-5595715111A1}"/>
                </a:ext>
              </a:extLst>
            </p:cNvPr>
            <p:cNvSpPr txBox="1"/>
            <p:nvPr/>
          </p:nvSpPr>
          <p:spPr>
            <a:xfrm>
              <a:off x="7543766" y="3082881"/>
              <a:ext cx="12842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>
                  <a:latin typeface="Arial" panose="020B0604020202020204" pitchFamily="34" charset="0"/>
                  <a:cs typeface="Arial" panose="020B0604020202020204" pitchFamily="34" charset="0"/>
                </a:rPr>
                <a:t>CD8+ T cells</a:t>
              </a:r>
            </a:p>
          </p:txBody>
        </p:sp>
        <p:sp>
          <p:nvSpPr>
            <p:cNvPr id="186" name="Szövegdoboz 185">
              <a:extLst>
                <a:ext uri="{FF2B5EF4-FFF2-40B4-BE49-F238E27FC236}">
                  <a16:creationId xmlns:a16="http://schemas.microsoft.com/office/drawing/2014/main" id="{58A248A0-18B9-0A60-488D-71D21A09CC22}"/>
                </a:ext>
              </a:extLst>
            </p:cNvPr>
            <p:cNvSpPr txBox="1"/>
            <p:nvPr/>
          </p:nvSpPr>
          <p:spPr>
            <a:xfrm>
              <a:off x="8564831" y="3848613"/>
              <a:ext cx="128427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>
                  <a:latin typeface="Arial" panose="020B0604020202020204" pitchFamily="34" charset="0"/>
                  <a:cs typeface="Arial" panose="020B0604020202020204" pitchFamily="34" charset="0"/>
                </a:rPr>
                <a:t>CD4+ </a:t>
              </a:r>
            </a:p>
            <a:p>
              <a:pPr algn="ctr"/>
              <a:r>
                <a:rPr lang="en-US" sz="1000" b="1">
                  <a:latin typeface="Arial" panose="020B0604020202020204" pitchFamily="34" charset="0"/>
                  <a:cs typeface="Arial" panose="020B0604020202020204" pitchFamily="34" charset="0"/>
                </a:rPr>
                <a:t>T cells</a:t>
              </a:r>
            </a:p>
          </p:txBody>
        </p:sp>
        <p:cxnSp>
          <p:nvCxnSpPr>
            <p:cNvPr id="187" name="Egyenes összekötő nyíllal 186">
              <a:extLst>
                <a:ext uri="{FF2B5EF4-FFF2-40B4-BE49-F238E27FC236}">
                  <a16:creationId xmlns:a16="http://schemas.microsoft.com/office/drawing/2014/main" id="{E6782387-5D58-4949-D693-386C7CEBC5C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41943" y="2348418"/>
              <a:ext cx="0" cy="869202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0" name="Szövegdoboz 189">
              <a:extLst>
                <a:ext uri="{FF2B5EF4-FFF2-40B4-BE49-F238E27FC236}">
                  <a16:creationId xmlns:a16="http://schemas.microsoft.com/office/drawing/2014/main" id="{1FBDEF38-632C-2497-9A81-909379EB4635}"/>
                </a:ext>
              </a:extLst>
            </p:cNvPr>
            <p:cNvSpPr txBox="1"/>
            <p:nvPr/>
          </p:nvSpPr>
          <p:spPr>
            <a:xfrm>
              <a:off x="2741061" y="4983756"/>
              <a:ext cx="12842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>
                  <a:latin typeface="Arial" panose="020B0604020202020204" pitchFamily="34" charset="0"/>
                  <a:cs typeface="Arial" panose="020B0604020202020204" pitchFamily="34" charset="0"/>
                </a:rPr>
                <a:t>CD3- cells</a:t>
              </a:r>
            </a:p>
          </p:txBody>
        </p:sp>
        <p:cxnSp>
          <p:nvCxnSpPr>
            <p:cNvPr id="191" name="Egyenes összekötő nyíllal 190">
              <a:extLst>
                <a:ext uri="{FF2B5EF4-FFF2-40B4-BE49-F238E27FC236}">
                  <a16:creationId xmlns:a16="http://schemas.microsoft.com/office/drawing/2014/main" id="{BC399051-A523-EF78-002E-034D8DD76169}"/>
                </a:ext>
              </a:extLst>
            </p:cNvPr>
            <p:cNvCxnSpPr/>
            <p:nvPr/>
          </p:nvCxnSpPr>
          <p:spPr>
            <a:xfrm flipV="1">
              <a:off x="3664769" y="5333223"/>
              <a:ext cx="1246917" cy="644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58" name="Csoportba foglalás 257">
              <a:extLst>
                <a:ext uri="{FF2B5EF4-FFF2-40B4-BE49-F238E27FC236}">
                  <a16:creationId xmlns:a16="http://schemas.microsoft.com/office/drawing/2014/main" id="{78DD85F1-2791-55D0-54FB-8F127BF37C69}"/>
                </a:ext>
              </a:extLst>
            </p:cNvPr>
            <p:cNvGrpSpPr/>
            <p:nvPr/>
          </p:nvGrpSpPr>
          <p:grpSpPr>
            <a:xfrm>
              <a:off x="5729303" y="5319728"/>
              <a:ext cx="1251690" cy="705392"/>
              <a:chOff x="5729303" y="5378602"/>
              <a:chExt cx="1251690" cy="646517"/>
            </a:xfrm>
          </p:grpSpPr>
          <p:cxnSp>
            <p:nvCxnSpPr>
              <p:cNvPr id="192" name="Egyenes összekötő 191">
                <a:extLst>
                  <a:ext uri="{FF2B5EF4-FFF2-40B4-BE49-F238E27FC236}">
                    <a16:creationId xmlns:a16="http://schemas.microsoft.com/office/drawing/2014/main" id="{1D1A9A9A-F2CB-687E-A27F-1B3B3555B02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729303" y="5416218"/>
                <a:ext cx="122347" cy="27297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3" name="Egyenes összekötő 192">
                <a:extLst>
                  <a:ext uri="{FF2B5EF4-FFF2-40B4-BE49-F238E27FC236}">
                    <a16:creationId xmlns:a16="http://schemas.microsoft.com/office/drawing/2014/main" id="{4AE1BDC4-5129-0866-9C38-9EAE0374FA0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729303" y="5689188"/>
                <a:ext cx="118381" cy="308851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4" name="Egyenes összekötő 193">
                <a:extLst>
                  <a:ext uri="{FF2B5EF4-FFF2-40B4-BE49-F238E27FC236}">
                    <a16:creationId xmlns:a16="http://schemas.microsoft.com/office/drawing/2014/main" id="{3E698F92-7790-5F59-3216-3FAA9B0675C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25878" y="5998039"/>
                <a:ext cx="396486" cy="10776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5" name="Egyenes összekötő 194">
                <a:extLst>
                  <a:ext uri="{FF2B5EF4-FFF2-40B4-BE49-F238E27FC236}">
                    <a16:creationId xmlns:a16="http://schemas.microsoft.com/office/drawing/2014/main" id="{8C2C9B58-BC09-FA09-6321-3A7EEEEC656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22364" y="5737007"/>
                <a:ext cx="98586" cy="28811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6" name="Egyenes összekötő 195">
                <a:extLst>
                  <a:ext uri="{FF2B5EF4-FFF2-40B4-BE49-F238E27FC236}">
                    <a16:creationId xmlns:a16="http://schemas.microsoft.com/office/drawing/2014/main" id="{3991E5C5-E313-E40D-88F9-D73A9E97D40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844506" y="5378602"/>
                <a:ext cx="886360" cy="4635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7" name="Egyenes összekötő 196">
                <a:extLst>
                  <a:ext uri="{FF2B5EF4-FFF2-40B4-BE49-F238E27FC236}">
                    <a16:creationId xmlns:a16="http://schemas.microsoft.com/office/drawing/2014/main" id="{2E3FA1E1-AA58-8A4C-C850-15D44BC8F06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720223" y="5379131"/>
                <a:ext cx="230563" cy="203905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8" name="Egyenes összekötő 197">
                <a:extLst>
                  <a:ext uri="{FF2B5EF4-FFF2-40B4-BE49-F238E27FC236}">
                    <a16:creationId xmlns:a16="http://schemas.microsoft.com/office/drawing/2014/main" id="{479A3DA0-1077-14CA-23AD-2F8AA033538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50786" y="5568386"/>
                <a:ext cx="25777" cy="37342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9" name="Egyenes összekötő 198">
                <a:extLst>
                  <a:ext uri="{FF2B5EF4-FFF2-40B4-BE49-F238E27FC236}">
                    <a16:creationId xmlns:a16="http://schemas.microsoft.com/office/drawing/2014/main" id="{E87C3CEA-DF9B-A8D0-4E5F-8361720EA50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700948" y="5938294"/>
                <a:ext cx="280045" cy="6386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0" name="Egyenes összekötő 199">
                <a:extLst>
                  <a:ext uri="{FF2B5EF4-FFF2-40B4-BE49-F238E27FC236}">
                    <a16:creationId xmlns:a16="http://schemas.microsoft.com/office/drawing/2014/main" id="{58AD34A6-CFFF-AED0-8CDD-010FA7EB85C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550577" y="5720894"/>
                <a:ext cx="157184" cy="21998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1" name="Egyenes összekötő 200">
                <a:extLst>
                  <a:ext uri="{FF2B5EF4-FFF2-40B4-BE49-F238E27FC236}">
                    <a16:creationId xmlns:a16="http://schemas.microsoft.com/office/drawing/2014/main" id="{4C8D84B7-87B7-FA16-1DAC-5536A056185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322546" y="5719797"/>
                <a:ext cx="228031" cy="25933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61" name="Egyenes összekötő nyíllal 260">
              <a:extLst>
                <a:ext uri="{FF2B5EF4-FFF2-40B4-BE49-F238E27FC236}">
                  <a16:creationId xmlns:a16="http://schemas.microsoft.com/office/drawing/2014/main" id="{1E2382DF-72CF-BBE4-17DB-690E7A1A90C8}"/>
                </a:ext>
              </a:extLst>
            </p:cNvPr>
            <p:cNvCxnSpPr/>
            <p:nvPr/>
          </p:nvCxnSpPr>
          <p:spPr>
            <a:xfrm flipV="1">
              <a:off x="6611871" y="5412595"/>
              <a:ext cx="774237" cy="644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2" name="Egyenes összekötő 261">
              <a:extLst>
                <a:ext uri="{FF2B5EF4-FFF2-40B4-BE49-F238E27FC236}">
                  <a16:creationId xmlns:a16="http://schemas.microsoft.com/office/drawing/2014/main" id="{656303D6-F839-3CAE-8E79-5380404274A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804830" y="5369053"/>
              <a:ext cx="364142" cy="12030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3" name="Egyenes összekötő 262">
              <a:extLst>
                <a:ext uri="{FF2B5EF4-FFF2-40B4-BE49-F238E27FC236}">
                  <a16:creationId xmlns:a16="http://schemas.microsoft.com/office/drawing/2014/main" id="{D8467BC7-9A0F-6757-BBFD-9D0EF9FFB73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132578" y="5369053"/>
              <a:ext cx="36394" cy="85614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4" name="Egyenes összekötő 263">
              <a:extLst>
                <a:ext uri="{FF2B5EF4-FFF2-40B4-BE49-F238E27FC236}">
                  <a16:creationId xmlns:a16="http://schemas.microsoft.com/office/drawing/2014/main" id="{EDCFD5CF-6936-ED39-40A1-C9347BCE5ACC}"/>
                </a:ext>
              </a:extLst>
            </p:cNvPr>
            <p:cNvCxnSpPr>
              <a:cxnSpLocks/>
            </p:cNvCxnSpPr>
            <p:nvPr/>
          </p:nvCxnSpPr>
          <p:spPr>
            <a:xfrm>
              <a:off x="8667978" y="6214445"/>
              <a:ext cx="471797" cy="1074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5" name="Egyenes összekötő 264">
              <a:extLst>
                <a:ext uri="{FF2B5EF4-FFF2-40B4-BE49-F238E27FC236}">
                  <a16:creationId xmlns:a16="http://schemas.microsoft.com/office/drawing/2014/main" id="{28464668-4F54-5CC5-61D1-A8BBF382102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660585" y="5842261"/>
              <a:ext cx="47666" cy="38293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6" name="Egyenes összekötő 265">
              <a:extLst>
                <a:ext uri="{FF2B5EF4-FFF2-40B4-BE49-F238E27FC236}">
                  <a16:creationId xmlns:a16="http://schemas.microsoft.com/office/drawing/2014/main" id="{5D135238-4A63-9D94-015B-2AC0427E211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300534" y="5485280"/>
              <a:ext cx="527507" cy="51029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7" name="Egyenes összekötő 266">
              <a:extLst>
                <a:ext uri="{FF2B5EF4-FFF2-40B4-BE49-F238E27FC236}">
                  <a16:creationId xmlns:a16="http://schemas.microsoft.com/office/drawing/2014/main" id="{687FC2E2-0D2D-7161-7749-111311AE7D8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417719" y="5842261"/>
              <a:ext cx="290532" cy="23693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8" name="Egyenes összekötő 267">
              <a:extLst>
                <a:ext uri="{FF2B5EF4-FFF2-40B4-BE49-F238E27FC236}">
                  <a16:creationId xmlns:a16="http://schemas.microsoft.com/office/drawing/2014/main" id="{2CA7D387-5B80-91A2-C6CB-FFDB2DADFE36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8300534" y="5992846"/>
              <a:ext cx="117185" cy="863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0" name="Egyenes összekötő nyíllal 299">
              <a:extLst>
                <a:ext uri="{FF2B5EF4-FFF2-40B4-BE49-F238E27FC236}">
                  <a16:creationId xmlns:a16="http://schemas.microsoft.com/office/drawing/2014/main" id="{467E043B-B3F4-F4A4-8931-F8FC8DDA0545}"/>
                </a:ext>
              </a:extLst>
            </p:cNvPr>
            <p:cNvCxnSpPr/>
            <p:nvPr/>
          </p:nvCxnSpPr>
          <p:spPr>
            <a:xfrm flipV="1">
              <a:off x="9037377" y="6156034"/>
              <a:ext cx="774237" cy="644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1" name="Egyenes összekötő 300">
              <a:extLst>
                <a:ext uri="{FF2B5EF4-FFF2-40B4-BE49-F238E27FC236}">
                  <a16:creationId xmlns:a16="http://schemas.microsoft.com/office/drawing/2014/main" id="{B8157584-8815-38C8-6EEB-18FF3D1A138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665619" y="5258636"/>
              <a:ext cx="556405" cy="3250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2" name="Egyenes összekötő 301">
              <a:extLst>
                <a:ext uri="{FF2B5EF4-FFF2-40B4-BE49-F238E27FC236}">
                  <a16:creationId xmlns:a16="http://schemas.microsoft.com/office/drawing/2014/main" id="{CFF0F070-7048-078C-5646-067A6297EA8E}"/>
                </a:ext>
              </a:extLst>
            </p:cNvPr>
            <p:cNvCxnSpPr/>
            <p:nvPr/>
          </p:nvCxnSpPr>
          <p:spPr>
            <a:xfrm flipH="1">
              <a:off x="10673342" y="5275912"/>
              <a:ext cx="2927" cy="27524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3" name="Egyenes összekötő 302">
              <a:extLst>
                <a:ext uri="{FF2B5EF4-FFF2-40B4-BE49-F238E27FC236}">
                  <a16:creationId xmlns:a16="http://schemas.microsoft.com/office/drawing/2014/main" id="{E984CAE6-DF2F-C59C-1C1B-AF1039DC5B91}"/>
                </a:ext>
              </a:extLst>
            </p:cNvPr>
            <p:cNvCxnSpPr>
              <a:cxnSpLocks/>
            </p:cNvCxnSpPr>
            <p:nvPr/>
          </p:nvCxnSpPr>
          <p:spPr>
            <a:xfrm>
              <a:off x="10673342" y="5533792"/>
              <a:ext cx="499840" cy="2233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4" name="Egyenes összekötő 303">
              <a:extLst>
                <a:ext uri="{FF2B5EF4-FFF2-40B4-BE49-F238E27FC236}">
                  <a16:creationId xmlns:a16="http://schemas.microsoft.com/office/drawing/2014/main" id="{BAC67BC2-E992-1139-AE44-64A35994DFDE}"/>
                </a:ext>
              </a:extLst>
            </p:cNvPr>
            <p:cNvCxnSpPr/>
            <p:nvPr/>
          </p:nvCxnSpPr>
          <p:spPr>
            <a:xfrm flipV="1">
              <a:off x="11175469" y="5251528"/>
              <a:ext cx="41953" cy="30097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5" name="Egyenes összekötő 304">
              <a:extLst>
                <a:ext uri="{FF2B5EF4-FFF2-40B4-BE49-F238E27FC236}">
                  <a16:creationId xmlns:a16="http://schemas.microsoft.com/office/drawing/2014/main" id="{358BA36E-EB3B-46EF-4747-96A3514A6CAB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1786840" y="5523681"/>
              <a:ext cx="109084" cy="34426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6" name="Egyenes összekötő 305">
              <a:extLst>
                <a:ext uri="{FF2B5EF4-FFF2-40B4-BE49-F238E27FC236}">
                  <a16:creationId xmlns:a16="http://schemas.microsoft.com/office/drawing/2014/main" id="{6908B582-410C-FD44-5B0B-5F6784B9DF53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1498156" y="5578362"/>
              <a:ext cx="18986" cy="34945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7" name="Egyenes összekötő 306">
              <a:extLst>
                <a:ext uri="{FF2B5EF4-FFF2-40B4-BE49-F238E27FC236}">
                  <a16:creationId xmlns:a16="http://schemas.microsoft.com/office/drawing/2014/main" id="{A815D507-65FD-E332-E400-D325C485094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513963" y="5857875"/>
              <a:ext cx="382762" cy="6674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8" name="Egyenes összekötő 307">
              <a:extLst>
                <a:ext uri="{FF2B5EF4-FFF2-40B4-BE49-F238E27FC236}">
                  <a16:creationId xmlns:a16="http://schemas.microsoft.com/office/drawing/2014/main" id="{02B455B3-1750-EC09-7EBC-488A41E5238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487120" y="5531678"/>
              <a:ext cx="304345" cy="4668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9" name="Egyenes összekötő 308">
              <a:extLst>
                <a:ext uri="{FF2B5EF4-FFF2-40B4-BE49-F238E27FC236}">
                  <a16:creationId xmlns:a16="http://schemas.microsoft.com/office/drawing/2014/main" id="{CDF1FE11-98F4-AAFB-3D0B-558CAB340934}"/>
                </a:ext>
              </a:extLst>
            </p:cNvPr>
            <p:cNvCxnSpPr>
              <a:cxnSpLocks/>
            </p:cNvCxnSpPr>
            <p:nvPr/>
          </p:nvCxnSpPr>
          <p:spPr>
            <a:xfrm>
              <a:off x="11167795" y="5556441"/>
              <a:ext cx="330361" cy="2388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0" name="Egyenes összekötő 309">
              <a:extLst>
                <a:ext uri="{FF2B5EF4-FFF2-40B4-BE49-F238E27FC236}">
                  <a16:creationId xmlns:a16="http://schemas.microsoft.com/office/drawing/2014/main" id="{FE9AFE06-1252-0CBF-0CB4-796022FB4526}"/>
                </a:ext>
              </a:extLst>
            </p:cNvPr>
            <p:cNvCxnSpPr/>
            <p:nvPr/>
          </p:nvCxnSpPr>
          <p:spPr>
            <a:xfrm>
              <a:off x="11205200" y="5260653"/>
              <a:ext cx="513680" cy="8195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1" name="Egyenes összekötő 310">
              <a:extLst>
                <a:ext uri="{FF2B5EF4-FFF2-40B4-BE49-F238E27FC236}">
                  <a16:creationId xmlns:a16="http://schemas.microsoft.com/office/drawing/2014/main" id="{092E4BF6-45E3-880C-5531-088223EDE58B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1709356" y="5339602"/>
              <a:ext cx="82109" cy="20317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5" name="Szövegdoboz 324">
              <a:extLst>
                <a:ext uri="{FF2B5EF4-FFF2-40B4-BE49-F238E27FC236}">
                  <a16:creationId xmlns:a16="http://schemas.microsoft.com/office/drawing/2014/main" id="{A74D4E8A-F55B-306E-38D4-AF81B579A697}"/>
                </a:ext>
              </a:extLst>
            </p:cNvPr>
            <p:cNvSpPr txBox="1"/>
            <p:nvPr/>
          </p:nvSpPr>
          <p:spPr>
            <a:xfrm>
              <a:off x="10170127" y="5080990"/>
              <a:ext cx="9250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>
                  <a:latin typeface="Arial" panose="020B0604020202020204" pitchFamily="34" charset="0"/>
                  <a:cs typeface="Arial" panose="020B0604020202020204" pitchFamily="34" charset="0"/>
                </a:rPr>
                <a:t>Classicals</a:t>
              </a:r>
            </a:p>
          </p:txBody>
        </p:sp>
        <p:sp>
          <p:nvSpPr>
            <p:cNvPr id="326" name="Szövegdoboz 325">
              <a:extLst>
                <a:ext uri="{FF2B5EF4-FFF2-40B4-BE49-F238E27FC236}">
                  <a16:creationId xmlns:a16="http://schemas.microsoft.com/office/drawing/2014/main" id="{960C26C1-083F-DC4A-72BF-AA4403B9D346}"/>
                </a:ext>
              </a:extLst>
            </p:cNvPr>
            <p:cNvSpPr txBox="1"/>
            <p:nvPr/>
          </p:nvSpPr>
          <p:spPr>
            <a:xfrm>
              <a:off x="10770126" y="5045897"/>
              <a:ext cx="152271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>
                  <a:latin typeface="Arial" panose="020B0604020202020204" pitchFamily="34" charset="0"/>
                  <a:cs typeface="Arial" panose="020B0604020202020204" pitchFamily="34" charset="0"/>
                </a:rPr>
                <a:t>Intermediates</a:t>
              </a:r>
            </a:p>
          </p:txBody>
        </p:sp>
        <p:sp>
          <p:nvSpPr>
            <p:cNvPr id="327" name="Szövegdoboz 326">
              <a:extLst>
                <a:ext uri="{FF2B5EF4-FFF2-40B4-BE49-F238E27FC236}">
                  <a16:creationId xmlns:a16="http://schemas.microsoft.com/office/drawing/2014/main" id="{A03FD866-B7C9-6229-11C2-27BEC804549B}"/>
                </a:ext>
              </a:extLst>
            </p:cNvPr>
            <p:cNvSpPr txBox="1"/>
            <p:nvPr/>
          </p:nvSpPr>
          <p:spPr>
            <a:xfrm>
              <a:off x="11010386" y="5866463"/>
              <a:ext cx="101351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>
                  <a:latin typeface="Arial" panose="020B0604020202020204" pitchFamily="34" charset="0"/>
                  <a:cs typeface="Arial" panose="020B0604020202020204" pitchFamily="34" charset="0"/>
                </a:rPr>
                <a:t>Non-classicals</a:t>
              </a:r>
            </a:p>
          </p:txBody>
        </p:sp>
        <p:sp>
          <p:nvSpPr>
            <p:cNvPr id="331" name="Szövegdoboz 330">
              <a:extLst>
                <a:ext uri="{FF2B5EF4-FFF2-40B4-BE49-F238E27FC236}">
                  <a16:creationId xmlns:a16="http://schemas.microsoft.com/office/drawing/2014/main" id="{278EBD51-8AB6-EFF9-DE94-021C63BFA3D5}"/>
                </a:ext>
              </a:extLst>
            </p:cNvPr>
            <p:cNvSpPr txBox="1"/>
            <p:nvPr/>
          </p:nvSpPr>
          <p:spPr>
            <a:xfrm>
              <a:off x="3667570" y="5509683"/>
              <a:ext cx="115313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Excluding </a:t>
              </a:r>
              <a:endParaRPr lang="hu-HU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D3+ T cells</a:t>
              </a:r>
            </a:p>
          </p:txBody>
        </p:sp>
        <p:sp>
          <p:nvSpPr>
            <p:cNvPr id="332" name="Téglalap 331">
              <a:extLst>
                <a:ext uri="{FF2B5EF4-FFF2-40B4-BE49-F238E27FC236}">
                  <a16:creationId xmlns:a16="http://schemas.microsoft.com/office/drawing/2014/main" id="{7728C96A-551C-35D0-0C2C-16208A0CAE6F}"/>
                </a:ext>
              </a:extLst>
            </p:cNvPr>
            <p:cNvSpPr/>
            <p:nvPr/>
          </p:nvSpPr>
          <p:spPr>
            <a:xfrm>
              <a:off x="3798260" y="5866463"/>
              <a:ext cx="458985" cy="361807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4" name="Szövegdoboz 333">
              <a:extLst>
                <a:ext uri="{FF2B5EF4-FFF2-40B4-BE49-F238E27FC236}">
                  <a16:creationId xmlns:a16="http://schemas.microsoft.com/office/drawing/2014/main" id="{DF374DC7-7C8C-EC9C-6BCA-837664F938A9}"/>
                </a:ext>
              </a:extLst>
            </p:cNvPr>
            <p:cNvSpPr txBox="1"/>
            <p:nvPr/>
          </p:nvSpPr>
          <p:spPr>
            <a:xfrm>
              <a:off x="5664900" y="6205822"/>
              <a:ext cx="14592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>
                  <a:latin typeface="Arial" panose="020B0604020202020204" pitchFamily="34" charset="0"/>
                  <a:cs typeface="Arial" panose="020B0604020202020204" pitchFamily="34" charset="0"/>
                </a:rPr>
                <a:t>Excluding NK cells</a:t>
              </a:r>
            </a:p>
          </p:txBody>
        </p:sp>
        <p:sp>
          <p:nvSpPr>
            <p:cNvPr id="335" name="Téglalap 334">
              <a:extLst>
                <a:ext uri="{FF2B5EF4-FFF2-40B4-BE49-F238E27FC236}">
                  <a16:creationId xmlns:a16="http://schemas.microsoft.com/office/drawing/2014/main" id="{44E33023-76D8-3567-60BA-D3D91D8A2E3F}"/>
                </a:ext>
              </a:extLst>
            </p:cNvPr>
            <p:cNvSpPr/>
            <p:nvPr/>
          </p:nvSpPr>
          <p:spPr>
            <a:xfrm>
              <a:off x="6696903" y="5950843"/>
              <a:ext cx="293345" cy="299117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6" name="Ellipszis 335">
              <a:extLst>
                <a:ext uri="{FF2B5EF4-FFF2-40B4-BE49-F238E27FC236}">
                  <a16:creationId xmlns:a16="http://schemas.microsoft.com/office/drawing/2014/main" id="{107B4FDD-ABC5-A638-F342-9CC852BE99F7}"/>
                </a:ext>
              </a:extLst>
            </p:cNvPr>
            <p:cNvSpPr/>
            <p:nvPr/>
          </p:nvSpPr>
          <p:spPr>
            <a:xfrm rot="19435556">
              <a:off x="8085419" y="5424128"/>
              <a:ext cx="616927" cy="413770"/>
            </a:xfrm>
            <a:prstGeom prst="ellipse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7" name="Szövegdoboz 336">
              <a:extLst>
                <a:ext uri="{FF2B5EF4-FFF2-40B4-BE49-F238E27FC236}">
                  <a16:creationId xmlns:a16="http://schemas.microsoft.com/office/drawing/2014/main" id="{77533C6B-0FCE-9658-235F-7CD0559E2989}"/>
                </a:ext>
              </a:extLst>
            </p:cNvPr>
            <p:cNvSpPr txBox="1"/>
            <p:nvPr/>
          </p:nvSpPr>
          <p:spPr>
            <a:xfrm>
              <a:off x="7475172" y="5087598"/>
              <a:ext cx="194771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>
                  <a:latin typeface="Arial" panose="020B0604020202020204" pitchFamily="34" charset="0"/>
                  <a:cs typeface="Arial" panose="020B0604020202020204" pitchFamily="34" charset="0"/>
                </a:rPr>
                <a:t>Excluding B cell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792916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Csoportba foglalás 1">
            <a:extLst>
              <a:ext uri="{FF2B5EF4-FFF2-40B4-BE49-F238E27FC236}">
                <a16:creationId xmlns:a16="http://schemas.microsoft.com/office/drawing/2014/main" id="{75E5CB09-B889-4FFE-9D61-EA9AECDC6776}"/>
              </a:ext>
            </a:extLst>
          </p:cNvPr>
          <p:cNvGrpSpPr/>
          <p:nvPr/>
        </p:nvGrpSpPr>
        <p:grpSpPr>
          <a:xfrm>
            <a:off x="-16935" y="66133"/>
            <a:ext cx="9378649" cy="4200124"/>
            <a:chOff x="-16935" y="66133"/>
            <a:chExt cx="9378649" cy="4200124"/>
          </a:xfrm>
        </p:grpSpPr>
        <p:sp>
          <p:nvSpPr>
            <p:cNvPr id="4" name="Szövegdoboz 3">
              <a:extLst>
                <a:ext uri="{FF2B5EF4-FFF2-40B4-BE49-F238E27FC236}">
                  <a16:creationId xmlns:a16="http://schemas.microsoft.com/office/drawing/2014/main" id="{F3B5C8B2-2CA8-F6C4-253B-003B3A5EDF96}"/>
                </a:ext>
              </a:extLst>
            </p:cNvPr>
            <p:cNvSpPr txBox="1"/>
            <p:nvPr/>
          </p:nvSpPr>
          <p:spPr>
            <a:xfrm>
              <a:off x="-16935" y="66133"/>
              <a:ext cx="331167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2.</a:t>
              </a:r>
            </a:p>
          </p:txBody>
        </p:sp>
        <p:grpSp>
          <p:nvGrpSpPr>
            <p:cNvPr id="75" name="Csoportba foglalás 74">
              <a:extLst>
                <a:ext uri="{FF2B5EF4-FFF2-40B4-BE49-F238E27FC236}">
                  <a16:creationId xmlns:a16="http://schemas.microsoft.com/office/drawing/2014/main" id="{DA338100-999B-747B-4E24-B6FC7C5A757A}"/>
                </a:ext>
              </a:extLst>
            </p:cNvPr>
            <p:cNvGrpSpPr/>
            <p:nvPr/>
          </p:nvGrpSpPr>
          <p:grpSpPr>
            <a:xfrm>
              <a:off x="362818" y="1549203"/>
              <a:ext cx="8998896" cy="2717054"/>
              <a:chOff x="382658" y="1356766"/>
              <a:chExt cx="11208790" cy="3999172"/>
            </a:xfrm>
          </p:grpSpPr>
          <p:grpSp>
            <p:nvGrpSpPr>
              <p:cNvPr id="76" name="Csoportba foglalás 75">
                <a:extLst>
                  <a:ext uri="{FF2B5EF4-FFF2-40B4-BE49-F238E27FC236}">
                    <a16:creationId xmlns:a16="http://schemas.microsoft.com/office/drawing/2014/main" id="{5686AFC6-5C11-88C8-4EE4-22160224FB65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8274990" y="1356766"/>
                <a:ext cx="3316458" cy="3353026"/>
                <a:chOff x="4395420" y="1401763"/>
                <a:chExt cx="3684956" cy="3725586"/>
              </a:xfrm>
            </p:grpSpPr>
            <p:sp>
              <p:nvSpPr>
                <p:cNvPr id="162" name="Oval 188">
                  <a:extLst>
                    <a:ext uri="{FF2B5EF4-FFF2-40B4-BE49-F238E27FC236}">
                      <a16:creationId xmlns:a16="http://schemas.microsoft.com/office/drawing/2014/main" id="{8DF78DFE-BB72-DBC6-B515-ADC7EA78F79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862638" y="3325813"/>
                  <a:ext cx="65088" cy="63500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63" name="Oval 189">
                  <a:extLst>
                    <a:ext uri="{FF2B5EF4-FFF2-40B4-BE49-F238E27FC236}">
                      <a16:creationId xmlns:a16="http://schemas.microsoft.com/office/drawing/2014/main" id="{81AA6F61-987E-9743-F594-7654D01BEA7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262563" y="2403475"/>
                  <a:ext cx="63500" cy="63500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64" name="Oval 190">
                  <a:extLst>
                    <a:ext uri="{FF2B5EF4-FFF2-40B4-BE49-F238E27FC236}">
                      <a16:creationId xmlns:a16="http://schemas.microsoft.com/office/drawing/2014/main" id="{EEE84DAA-6256-09FC-A561-0B861E1E596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981575" y="2533650"/>
                  <a:ext cx="61913" cy="65087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65" name="Oval 191">
                  <a:extLst>
                    <a:ext uri="{FF2B5EF4-FFF2-40B4-BE49-F238E27FC236}">
                      <a16:creationId xmlns:a16="http://schemas.microsoft.com/office/drawing/2014/main" id="{3FB61C03-A463-4905-8743-F1F189A4746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813300" y="2909888"/>
                  <a:ext cx="61913" cy="65087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66" name="Oval 192">
                  <a:extLst>
                    <a:ext uri="{FF2B5EF4-FFF2-40B4-BE49-F238E27FC236}">
                      <a16:creationId xmlns:a16="http://schemas.microsoft.com/office/drawing/2014/main" id="{506DF256-7465-E1BB-FFF3-49F89695147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865813" y="3381375"/>
                  <a:ext cx="63500" cy="65087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67" name="Oval 193">
                  <a:extLst>
                    <a:ext uri="{FF2B5EF4-FFF2-40B4-BE49-F238E27FC236}">
                      <a16:creationId xmlns:a16="http://schemas.microsoft.com/office/drawing/2014/main" id="{435A4936-DAD2-05CE-92BF-1F2EAC89E2E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953000" y="3533775"/>
                  <a:ext cx="65088" cy="63500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68" name="Oval 194">
                  <a:extLst>
                    <a:ext uri="{FF2B5EF4-FFF2-40B4-BE49-F238E27FC236}">
                      <a16:creationId xmlns:a16="http://schemas.microsoft.com/office/drawing/2014/main" id="{6EA7C0BC-A02E-3A77-7598-4690296C6A2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835525" y="3478213"/>
                  <a:ext cx="63500" cy="65087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69" name="Oval 195">
                  <a:extLst>
                    <a:ext uri="{FF2B5EF4-FFF2-40B4-BE49-F238E27FC236}">
                      <a16:creationId xmlns:a16="http://schemas.microsoft.com/office/drawing/2014/main" id="{2D710339-787B-6A67-82EE-03E05E4BC4B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752975" y="1858963"/>
                  <a:ext cx="65088" cy="65087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70" name="Oval 196">
                  <a:extLst>
                    <a:ext uri="{FF2B5EF4-FFF2-40B4-BE49-F238E27FC236}">
                      <a16:creationId xmlns:a16="http://schemas.microsoft.com/office/drawing/2014/main" id="{ACC2BEAD-D3DC-2885-4B81-B7FFA7AE75B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740400" y="3592513"/>
                  <a:ext cx="65088" cy="61912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71" name="Oval 197">
                  <a:extLst>
                    <a:ext uri="{FF2B5EF4-FFF2-40B4-BE49-F238E27FC236}">
                      <a16:creationId xmlns:a16="http://schemas.microsoft.com/office/drawing/2014/main" id="{23C43521-10E5-4D5D-A192-524D2397C2A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953125" y="3084513"/>
                  <a:ext cx="65088" cy="61912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72" name="Oval 198">
                  <a:extLst>
                    <a:ext uri="{FF2B5EF4-FFF2-40B4-BE49-F238E27FC236}">
                      <a16:creationId xmlns:a16="http://schemas.microsoft.com/office/drawing/2014/main" id="{19E28E5B-AE20-0052-0D77-F3679D4C1B5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891463" y="3663950"/>
                  <a:ext cx="61913" cy="63500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73" name="Oval 199">
                  <a:extLst>
                    <a:ext uri="{FF2B5EF4-FFF2-40B4-BE49-F238E27FC236}">
                      <a16:creationId xmlns:a16="http://schemas.microsoft.com/office/drawing/2014/main" id="{7E31AD6F-FA63-137B-B04E-AB806607C0C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932363" y="3538538"/>
                  <a:ext cx="63500" cy="65087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74" name="Oval 200">
                  <a:extLst>
                    <a:ext uri="{FF2B5EF4-FFF2-40B4-BE49-F238E27FC236}">
                      <a16:creationId xmlns:a16="http://schemas.microsoft.com/office/drawing/2014/main" id="{E001D81A-A038-CF52-7A5D-072E7A8CF45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748213" y="3160713"/>
                  <a:ext cx="65088" cy="63500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75" name="Oval 201">
                  <a:extLst>
                    <a:ext uri="{FF2B5EF4-FFF2-40B4-BE49-F238E27FC236}">
                      <a16:creationId xmlns:a16="http://schemas.microsoft.com/office/drawing/2014/main" id="{5F034162-94F7-5E2A-EFE1-D0F22163D6F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172200" y="3003550"/>
                  <a:ext cx="65088" cy="63500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76" name="Oval 202">
                  <a:extLst>
                    <a:ext uri="{FF2B5EF4-FFF2-40B4-BE49-F238E27FC236}">
                      <a16:creationId xmlns:a16="http://schemas.microsoft.com/office/drawing/2014/main" id="{E7444D1B-DEA4-1993-8B08-07BEF0F1EAB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486400" y="4033838"/>
                  <a:ext cx="65088" cy="61912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77" name="Oval 203">
                  <a:extLst>
                    <a:ext uri="{FF2B5EF4-FFF2-40B4-BE49-F238E27FC236}">
                      <a16:creationId xmlns:a16="http://schemas.microsoft.com/office/drawing/2014/main" id="{B7498A4D-458C-A178-9963-77FBEB764F0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757738" y="4692650"/>
                  <a:ext cx="65088" cy="65087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78" name="Freeform 204">
                  <a:extLst>
                    <a:ext uri="{FF2B5EF4-FFF2-40B4-BE49-F238E27FC236}">
                      <a16:creationId xmlns:a16="http://schemas.microsoft.com/office/drawing/2014/main" id="{31201116-29D5-B6A4-9582-2AC7D72B667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781550" y="3206750"/>
                  <a:ext cx="3140075" cy="396875"/>
                </a:xfrm>
                <a:custGeom>
                  <a:avLst/>
                  <a:gdLst>
                    <a:gd name="T0" fmla="*/ 26 w 1978"/>
                    <a:gd name="T1" fmla="*/ 3 h 250"/>
                    <a:gd name="T2" fmla="*/ 76 w 1978"/>
                    <a:gd name="T3" fmla="*/ 10 h 250"/>
                    <a:gd name="T4" fmla="*/ 126 w 1978"/>
                    <a:gd name="T5" fmla="*/ 17 h 250"/>
                    <a:gd name="T6" fmla="*/ 175 w 1978"/>
                    <a:gd name="T7" fmla="*/ 22 h 250"/>
                    <a:gd name="T8" fmla="*/ 225 w 1978"/>
                    <a:gd name="T9" fmla="*/ 29 h 250"/>
                    <a:gd name="T10" fmla="*/ 275 w 1978"/>
                    <a:gd name="T11" fmla="*/ 36 h 250"/>
                    <a:gd name="T12" fmla="*/ 325 w 1978"/>
                    <a:gd name="T13" fmla="*/ 41 h 250"/>
                    <a:gd name="T14" fmla="*/ 375 w 1978"/>
                    <a:gd name="T15" fmla="*/ 48 h 250"/>
                    <a:gd name="T16" fmla="*/ 425 w 1978"/>
                    <a:gd name="T17" fmla="*/ 55 h 250"/>
                    <a:gd name="T18" fmla="*/ 475 w 1978"/>
                    <a:gd name="T19" fmla="*/ 60 h 250"/>
                    <a:gd name="T20" fmla="*/ 525 w 1978"/>
                    <a:gd name="T21" fmla="*/ 67 h 250"/>
                    <a:gd name="T22" fmla="*/ 576 w 1978"/>
                    <a:gd name="T23" fmla="*/ 73 h 250"/>
                    <a:gd name="T24" fmla="*/ 626 w 1978"/>
                    <a:gd name="T25" fmla="*/ 79 h 250"/>
                    <a:gd name="T26" fmla="*/ 676 w 1978"/>
                    <a:gd name="T27" fmla="*/ 86 h 250"/>
                    <a:gd name="T28" fmla="*/ 726 w 1978"/>
                    <a:gd name="T29" fmla="*/ 91 h 250"/>
                    <a:gd name="T30" fmla="*/ 776 w 1978"/>
                    <a:gd name="T31" fmla="*/ 98 h 250"/>
                    <a:gd name="T32" fmla="*/ 826 w 1978"/>
                    <a:gd name="T33" fmla="*/ 105 h 250"/>
                    <a:gd name="T34" fmla="*/ 876 w 1978"/>
                    <a:gd name="T35" fmla="*/ 110 h 250"/>
                    <a:gd name="T36" fmla="*/ 926 w 1978"/>
                    <a:gd name="T37" fmla="*/ 117 h 250"/>
                    <a:gd name="T38" fmla="*/ 977 w 1978"/>
                    <a:gd name="T39" fmla="*/ 124 h 250"/>
                    <a:gd name="T40" fmla="*/ 1027 w 1978"/>
                    <a:gd name="T41" fmla="*/ 129 h 250"/>
                    <a:gd name="T42" fmla="*/ 1077 w 1978"/>
                    <a:gd name="T43" fmla="*/ 136 h 250"/>
                    <a:gd name="T44" fmla="*/ 1127 w 1978"/>
                    <a:gd name="T45" fmla="*/ 143 h 250"/>
                    <a:gd name="T46" fmla="*/ 1177 w 1978"/>
                    <a:gd name="T47" fmla="*/ 148 h 250"/>
                    <a:gd name="T48" fmla="*/ 1227 w 1978"/>
                    <a:gd name="T49" fmla="*/ 155 h 250"/>
                    <a:gd name="T50" fmla="*/ 1277 w 1978"/>
                    <a:gd name="T51" fmla="*/ 162 h 250"/>
                    <a:gd name="T52" fmla="*/ 1327 w 1978"/>
                    <a:gd name="T53" fmla="*/ 167 h 250"/>
                    <a:gd name="T54" fmla="*/ 1378 w 1978"/>
                    <a:gd name="T55" fmla="*/ 174 h 250"/>
                    <a:gd name="T56" fmla="*/ 1428 w 1978"/>
                    <a:gd name="T57" fmla="*/ 181 h 250"/>
                    <a:gd name="T58" fmla="*/ 1478 w 1978"/>
                    <a:gd name="T59" fmla="*/ 186 h 250"/>
                    <a:gd name="T60" fmla="*/ 1528 w 1978"/>
                    <a:gd name="T61" fmla="*/ 193 h 250"/>
                    <a:gd name="T62" fmla="*/ 1578 w 1978"/>
                    <a:gd name="T63" fmla="*/ 199 h 250"/>
                    <a:gd name="T64" fmla="*/ 1628 w 1978"/>
                    <a:gd name="T65" fmla="*/ 205 h 250"/>
                    <a:gd name="T66" fmla="*/ 1678 w 1978"/>
                    <a:gd name="T67" fmla="*/ 212 h 250"/>
                    <a:gd name="T68" fmla="*/ 1729 w 1978"/>
                    <a:gd name="T69" fmla="*/ 217 h 250"/>
                    <a:gd name="T70" fmla="*/ 1779 w 1978"/>
                    <a:gd name="T71" fmla="*/ 224 h 250"/>
                    <a:gd name="T72" fmla="*/ 1829 w 1978"/>
                    <a:gd name="T73" fmla="*/ 231 h 250"/>
                    <a:gd name="T74" fmla="*/ 1879 w 1978"/>
                    <a:gd name="T75" fmla="*/ 236 h 250"/>
                    <a:gd name="T76" fmla="*/ 1929 w 1978"/>
                    <a:gd name="T77" fmla="*/ 243 h 250"/>
                    <a:gd name="T78" fmla="*/ 1978 w 1978"/>
                    <a:gd name="T79" fmla="*/ 250 h 25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</a:cxnLst>
                  <a:rect l="0" t="0" r="r" b="b"/>
                  <a:pathLst>
                    <a:path w="1978" h="250">
                      <a:moveTo>
                        <a:pt x="0" y="0"/>
                      </a:moveTo>
                      <a:lnTo>
                        <a:pt x="26" y="3"/>
                      </a:lnTo>
                      <a:lnTo>
                        <a:pt x="50" y="7"/>
                      </a:lnTo>
                      <a:lnTo>
                        <a:pt x="76" y="10"/>
                      </a:lnTo>
                      <a:lnTo>
                        <a:pt x="100" y="13"/>
                      </a:lnTo>
                      <a:lnTo>
                        <a:pt x="126" y="17"/>
                      </a:lnTo>
                      <a:lnTo>
                        <a:pt x="150" y="19"/>
                      </a:lnTo>
                      <a:lnTo>
                        <a:pt x="175" y="22"/>
                      </a:lnTo>
                      <a:lnTo>
                        <a:pt x="200" y="26"/>
                      </a:lnTo>
                      <a:lnTo>
                        <a:pt x="225" y="29"/>
                      </a:lnTo>
                      <a:lnTo>
                        <a:pt x="250" y="32"/>
                      </a:lnTo>
                      <a:lnTo>
                        <a:pt x="275" y="36"/>
                      </a:lnTo>
                      <a:lnTo>
                        <a:pt x="301" y="38"/>
                      </a:lnTo>
                      <a:lnTo>
                        <a:pt x="325" y="41"/>
                      </a:lnTo>
                      <a:lnTo>
                        <a:pt x="351" y="45"/>
                      </a:lnTo>
                      <a:lnTo>
                        <a:pt x="375" y="48"/>
                      </a:lnTo>
                      <a:lnTo>
                        <a:pt x="401" y="50"/>
                      </a:lnTo>
                      <a:lnTo>
                        <a:pt x="425" y="55"/>
                      </a:lnTo>
                      <a:lnTo>
                        <a:pt x="451" y="57"/>
                      </a:lnTo>
                      <a:lnTo>
                        <a:pt x="475" y="60"/>
                      </a:lnTo>
                      <a:lnTo>
                        <a:pt x="501" y="64"/>
                      </a:lnTo>
                      <a:lnTo>
                        <a:pt x="525" y="67"/>
                      </a:lnTo>
                      <a:lnTo>
                        <a:pt x="551" y="69"/>
                      </a:lnTo>
                      <a:lnTo>
                        <a:pt x="576" y="73"/>
                      </a:lnTo>
                      <a:lnTo>
                        <a:pt x="601" y="76"/>
                      </a:lnTo>
                      <a:lnTo>
                        <a:pt x="626" y="79"/>
                      </a:lnTo>
                      <a:lnTo>
                        <a:pt x="651" y="83"/>
                      </a:lnTo>
                      <a:lnTo>
                        <a:pt x="676" y="86"/>
                      </a:lnTo>
                      <a:lnTo>
                        <a:pt x="702" y="88"/>
                      </a:lnTo>
                      <a:lnTo>
                        <a:pt x="726" y="91"/>
                      </a:lnTo>
                      <a:lnTo>
                        <a:pt x="752" y="95"/>
                      </a:lnTo>
                      <a:lnTo>
                        <a:pt x="776" y="98"/>
                      </a:lnTo>
                      <a:lnTo>
                        <a:pt x="802" y="101"/>
                      </a:lnTo>
                      <a:lnTo>
                        <a:pt x="826" y="105"/>
                      </a:lnTo>
                      <a:lnTo>
                        <a:pt x="852" y="107"/>
                      </a:lnTo>
                      <a:lnTo>
                        <a:pt x="876" y="110"/>
                      </a:lnTo>
                      <a:lnTo>
                        <a:pt x="902" y="114"/>
                      </a:lnTo>
                      <a:lnTo>
                        <a:pt x="926" y="117"/>
                      </a:lnTo>
                      <a:lnTo>
                        <a:pt x="952" y="120"/>
                      </a:lnTo>
                      <a:lnTo>
                        <a:pt x="977" y="124"/>
                      </a:lnTo>
                      <a:lnTo>
                        <a:pt x="1002" y="126"/>
                      </a:lnTo>
                      <a:lnTo>
                        <a:pt x="1027" y="129"/>
                      </a:lnTo>
                      <a:lnTo>
                        <a:pt x="1052" y="133"/>
                      </a:lnTo>
                      <a:lnTo>
                        <a:pt x="1077" y="136"/>
                      </a:lnTo>
                      <a:lnTo>
                        <a:pt x="1101" y="139"/>
                      </a:lnTo>
                      <a:lnTo>
                        <a:pt x="1127" y="143"/>
                      </a:lnTo>
                      <a:lnTo>
                        <a:pt x="1151" y="145"/>
                      </a:lnTo>
                      <a:lnTo>
                        <a:pt x="1177" y="148"/>
                      </a:lnTo>
                      <a:lnTo>
                        <a:pt x="1201" y="152"/>
                      </a:lnTo>
                      <a:lnTo>
                        <a:pt x="1227" y="155"/>
                      </a:lnTo>
                      <a:lnTo>
                        <a:pt x="1252" y="157"/>
                      </a:lnTo>
                      <a:lnTo>
                        <a:pt x="1277" y="162"/>
                      </a:lnTo>
                      <a:lnTo>
                        <a:pt x="1302" y="164"/>
                      </a:lnTo>
                      <a:lnTo>
                        <a:pt x="1327" y="167"/>
                      </a:lnTo>
                      <a:lnTo>
                        <a:pt x="1352" y="171"/>
                      </a:lnTo>
                      <a:lnTo>
                        <a:pt x="1378" y="174"/>
                      </a:lnTo>
                      <a:lnTo>
                        <a:pt x="1402" y="176"/>
                      </a:lnTo>
                      <a:lnTo>
                        <a:pt x="1428" y="181"/>
                      </a:lnTo>
                      <a:lnTo>
                        <a:pt x="1452" y="183"/>
                      </a:lnTo>
                      <a:lnTo>
                        <a:pt x="1478" y="186"/>
                      </a:lnTo>
                      <a:lnTo>
                        <a:pt x="1502" y="190"/>
                      </a:lnTo>
                      <a:lnTo>
                        <a:pt x="1528" y="193"/>
                      </a:lnTo>
                      <a:lnTo>
                        <a:pt x="1552" y="195"/>
                      </a:lnTo>
                      <a:lnTo>
                        <a:pt x="1578" y="199"/>
                      </a:lnTo>
                      <a:lnTo>
                        <a:pt x="1603" y="202"/>
                      </a:lnTo>
                      <a:lnTo>
                        <a:pt x="1628" y="205"/>
                      </a:lnTo>
                      <a:lnTo>
                        <a:pt x="1653" y="208"/>
                      </a:lnTo>
                      <a:lnTo>
                        <a:pt x="1678" y="212"/>
                      </a:lnTo>
                      <a:lnTo>
                        <a:pt x="1703" y="214"/>
                      </a:lnTo>
                      <a:lnTo>
                        <a:pt x="1729" y="217"/>
                      </a:lnTo>
                      <a:lnTo>
                        <a:pt x="1753" y="221"/>
                      </a:lnTo>
                      <a:lnTo>
                        <a:pt x="1779" y="224"/>
                      </a:lnTo>
                      <a:lnTo>
                        <a:pt x="1803" y="227"/>
                      </a:lnTo>
                      <a:lnTo>
                        <a:pt x="1829" y="231"/>
                      </a:lnTo>
                      <a:lnTo>
                        <a:pt x="1853" y="233"/>
                      </a:lnTo>
                      <a:lnTo>
                        <a:pt x="1879" y="236"/>
                      </a:lnTo>
                      <a:lnTo>
                        <a:pt x="1903" y="240"/>
                      </a:lnTo>
                      <a:lnTo>
                        <a:pt x="1929" y="243"/>
                      </a:lnTo>
                      <a:lnTo>
                        <a:pt x="1953" y="246"/>
                      </a:lnTo>
                      <a:lnTo>
                        <a:pt x="1978" y="250"/>
                      </a:lnTo>
                    </a:path>
                  </a:pathLst>
                </a:custGeom>
                <a:noFill/>
                <a:ln w="365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79" name="Freeform 205">
                  <a:extLst>
                    <a:ext uri="{FF2B5EF4-FFF2-40B4-BE49-F238E27FC236}">
                      <a16:creationId xmlns:a16="http://schemas.microsoft.com/office/drawing/2014/main" id="{5245720E-ED5A-F89B-4D73-8656800A3F7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781550" y="2427288"/>
                  <a:ext cx="3140075" cy="2349500"/>
                </a:xfrm>
                <a:custGeom>
                  <a:avLst/>
                  <a:gdLst>
                    <a:gd name="T0" fmla="*/ 50 w 1978"/>
                    <a:gd name="T1" fmla="*/ 210 h 1480"/>
                    <a:gd name="T2" fmla="*/ 126 w 1978"/>
                    <a:gd name="T3" fmla="*/ 238 h 1480"/>
                    <a:gd name="T4" fmla="*/ 200 w 1978"/>
                    <a:gd name="T5" fmla="*/ 264 h 1480"/>
                    <a:gd name="T6" fmla="*/ 275 w 1978"/>
                    <a:gd name="T7" fmla="*/ 285 h 1480"/>
                    <a:gd name="T8" fmla="*/ 351 w 1978"/>
                    <a:gd name="T9" fmla="*/ 303 h 1480"/>
                    <a:gd name="T10" fmla="*/ 425 w 1978"/>
                    <a:gd name="T11" fmla="*/ 317 h 1480"/>
                    <a:gd name="T12" fmla="*/ 501 w 1978"/>
                    <a:gd name="T13" fmla="*/ 323 h 1480"/>
                    <a:gd name="T14" fmla="*/ 576 w 1978"/>
                    <a:gd name="T15" fmla="*/ 326 h 1480"/>
                    <a:gd name="T16" fmla="*/ 651 w 1978"/>
                    <a:gd name="T17" fmla="*/ 323 h 1480"/>
                    <a:gd name="T18" fmla="*/ 726 w 1978"/>
                    <a:gd name="T19" fmla="*/ 318 h 1480"/>
                    <a:gd name="T20" fmla="*/ 802 w 1978"/>
                    <a:gd name="T21" fmla="*/ 308 h 1480"/>
                    <a:gd name="T22" fmla="*/ 876 w 1978"/>
                    <a:gd name="T23" fmla="*/ 296 h 1480"/>
                    <a:gd name="T24" fmla="*/ 952 w 1978"/>
                    <a:gd name="T25" fmla="*/ 283 h 1480"/>
                    <a:gd name="T26" fmla="*/ 1027 w 1978"/>
                    <a:gd name="T27" fmla="*/ 266 h 1480"/>
                    <a:gd name="T28" fmla="*/ 1101 w 1978"/>
                    <a:gd name="T29" fmla="*/ 249 h 1480"/>
                    <a:gd name="T30" fmla="*/ 1177 w 1978"/>
                    <a:gd name="T31" fmla="*/ 230 h 1480"/>
                    <a:gd name="T32" fmla="*/ 1252 w 1978"/>
                    <a:gd name="T33" fmla="*/ 211 h 1480"/>
                    <a:gd name="T34" fmla="*/ 1327 w 1978"/>
                    <a:gd name="T35" fmla="*/ 191 h 1480"/>
                    <a:gd name="T36" fmla="*/ 1402 w 1978"/>
                    <a:gd name="T37" fmla="*/ 170 h 1480"/>
                    <a:gd name="T38" fmla="*/ 1478 w 1978"/>
                    <a:gd name="T39" fmla="*/ 149 h 1480"/>
                    <a:gd name="T40" fmla="*/ 1552 w 1978"/>
                    <a:gd name="T41" fmla="*/ 127 h 1480"/>
                    <a:gd name="T42" fmla="*/ 1628 w 1978"/>
                    <a:gd name="T43" fmla="*/ 105 h 1480"/>
                    <a:gd name="T44" fmla="*/ 1703 w 1978"/>
                    <a:gd name="T45" fmla="*/ 84 h 1480"/>
                    <a:gd name="T46" fmla="*/ 1779 w 1978"/>
                    <a:gd name="T47" fmla="*/ 61 h 1480"/>
                    <a:gd name="T48" fmla="*/ 1853 w 1978"/>
                    <a:gd name="T49" fmla="*/ 38 h 1480"/>
                    <a:gd name="T50" fmla="*/ 1929 w 1978"/>
                    <a:gd name="T51" fmla="*/ 14 h 1480"/>
                    <a:gd name="T52" fmla="*/ 1978 w 1978"/>
                    <a:gd name="T53" fmla="*/ 1480 h 1480"/>
                    <a:gd name="T54" fmla="*/ 1903 w 1978"/>
                    <a:gd name="T55" fmla="*/ 1438 h 1480"/>
                    <a:gd name="T56" fmla="*/ 1829 w 1978"/>
                    <a:gd name="T57" fmla="*/ 1398 h 1480"/>
                    <a:gd name="T58" fmla="*/ 1753 w 1978"/>
                    <a:gd name="T59" fmla="*/ 1356 h 1480"/>
                    <a:gd name="T60" fmla="*/ 1678 w 1978"/>
                    <a:gd name="T61" fmla="*/ 1314 h 1480"/>
                    <a:gd name="T62" fmla="*/ 1603 w 1978"/>
                    <a:gd name="T63" fmla="*/ 1273 h 1480"/>
                    <a:gd name="T64" fmla="*/ 1528 w 1978"/>
                    <a:gd name="T65" fmla="*/ 1232 h 1480"/>
                    <a:gd name="T66" fmla="*/ 1452 w 1978"/>
                    <a:gd name="T67" fmla="*/ 1192 h 1480"/>
                    <a:gd name="T68" fmla="*/ 1378 w 1978"/>
                    <a:gd name="T69" fmla="*/ 1152 h 1480"/>
                    <a:gd name="T70" fmla="*/ 1302 w 1978"/>
                    <a:gd name="T71" fmla="*/ 1113 h 1480"/>
                    <a:gd name="T72" fmla="*/ 1227 w 1978"/>
                    <a:gd name="T73" fmla="*/ 1074 h 1480"/>
                    <a:gd name="T74" fmla="*/ 1151 w 1978"/>
                    <a:gd name="T75" fmla="*/ 1036 h 1480"/>
                    <a:gd name="T76" fmla="*/ 1077 w 1978"/>
                    <a:gd name="T77" fmla="*/ 999 h 1480"/>
                    <a:gd name="T78" fmla="*/ 1002 w 1978"/>
                    <a:gd name="T79" fmla="*/ 963 h 1480"/>
                    <a:gd name="T80" fmla="*/ 926 w 1978"/>
                    <a:gd name="T81" fmla="*/ 929 h 1480"/>
                    <a:gd name="T82" fmla="*/ 852 w 1978"/>
                    <a:gd name="T83" fmla="*/ 896 h 1480"/>
                    <a:gd name="T84" fmla="*/ 776 w 1978"/>
                    <a:gd name="T85" fmla="*/ 867 h 1480"/>
                    <a:gd name="T86" fmla="*/ 702 w 1978"/>
                    <a:gd name="T87" fmla="*/ 840 h 1480"/>
                    <a:gd name="T88" fmla="*/ 626 w 1978"/>
                    <a:gd name="T89" fmla="*/ 815 h 1480"/>
                    <a:gd name="T90" fmla="*/ 551 w 1978"/>
                    <a:gd name="T91" fmla="*/ 796 h 1480"/>
                    <a:gd name="T92" fmla="*/ 475 w 1978"/>
                    <a:gd name="T93" fmla="*/ 781 h 1480"/>
                    <a:gd name="T94" fmla="*/ 401 w 1978"/>
                    <a:gd name="T95" fmla="*/ 772 h 1480"/>
                    <a:gd name="T96" fmla="*/ 325 w 1978"/>
                    <a:gd name="T97" fmla="*/ 766 h 1480"/>
                    <a:gd name="T98" fmla="*/ 250 w 1978"/>
                    <a:gd name="T99" fmla="*/ 766 h 1480"/>
                    <a:gd name="T100" fmla="*/ 175 w 1978"/>
                    <a:gd name="T101" fmla="*/ 772 h 1480"/>
                    <a:gd name="T102" fmla="*/ 100 w 1978"/>
                    <a:gd name="T103" fmla="*/ 779 h 1480"/>
                    <a:gd name="T104" fmla="*/ 26 w 1978"/>
                    <a:gd name="T105" fmla="*/ 789 h 148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</a:cxnLst>
                  <a:rect l="0" t="0" r="r" b="b"/>
                  <a:pathLst>
                    <a:path w="1978" h="1480">
                      <a:moveTo>
                        <a:pt x="0" y="189"/>
                      </a:moveTo>
                      <a:lnTo>
                        <a:pt x="26" y="199"/>
                      </a:lnTo>
                      <a:lnTo>
                        <a:pt x="50" y="210"/>
                      </a:lnTo>
                      <a:lnTo>
                        <a:pt x="76" y="219"/>
                      </a:lnTo>
                      <a:lnTo>
                        <a:pt x="100" y="229"/>
                      </a:lnTo>
                      <a:lnTo>
                        <a:pt x="126" y="238"/>
                      </a:lnTo>
                      <a:lnTo>
                        <a:pt x="150" y="247"/>
                      </a:lnTo>
                      <a:lnTo>
                        <a:pt x="175" y="256"/>
                      </a:lnTo>
                      <a:lnTo>
                        <a:pt x="200" y="264"/>
                      </a:lnTo>
                      <a:lnTo>
                        <a:pt x="225" y="272"/>
                      </a:lnTo>
                      <a:lnTo>
                        <a:pt x="250" y="279"/>
                      </a:lnTo>
                      <a:lnTo>
                        <a:pt x="275" y="285"/>
                      </a:lnTo>
                      <a:lnTo>
                        <a:pt x="301" y="292"/>
                      </a:lnTo>
                      <a:lnTo>
                        <a:pt x="325" y="298"/>
                      </a:lnTo>
                      <a:lnTo>
                        <a:pt x="351" y="303"/>
                      </a:lnTo>
                      <a:lnTo>
                        <a:pt x="375" y="308"/>
                      </a:lnTo>
                      <a:lnTo>
                        <a:pt x="401" y="313"/>
                      </a:lnTo>
                      <a:lnTo>
                        <a:pt x="425" y="317"/>
                      </a:lnTo>
                      <a:lnTo>
                        <a:pt x="451" y="319"/>
                      </a:lnTo>
                      <a:lnTo>
                        <a:pt x="475" y="322"/>
                      </a:lnTo>
                      <a:lnTo>
                        <a:pt x="501" y="323"/>
                      </a:lnTo>
                      <a:lnTo>
                        <a:pt x="525" y="325"/>
                      </a:lnTo>
                      <a:lnTo>
                        <a:pt x="551" y="326"/>
                      </a:lnTo>
                      <a:lnTo>
                        <a:pt x="576" y="326"/>
                      </a:lnTo>
                      <a:lnTo>
                        <a:pt x="601" y="326"/>
                      </a:lnTo>
                      <a:lnTo>
                        <a:pt x="626" y="325"/>
                      </a:lnTo>
                      <a:lnTo>
                        <a:pt x="651" y="323"/>
                      </a:lnTo>
                      <a:lnTo>
                        <a:pt x="676" y="322"/>
                      </a:lnTo>
                      <a:lnTo>
                        <a:pt x="702" y="321"/>
                      </a:lnTo>
                      <a:lnTo>
                        <a:pt x="726" y="318"/>
                      </a:lnTo>
                      <a:lnTo>
                        <a:pt x="752" y="315"/>
                      </a:lnTo>
                      <a:lnTo>
                        <a:pt x="776" y="313"/>
                      </a:lnTo>
                      <a:lnTo>
                        <a:pt x="802" y="308"/>
                      </a:lnTo>
                      <a:lnTo>
                        <a:pt x="826" y="304"/>
                      </a:lnTo>
                      <a:lnTo>
                        <a:pt x="852" y="300"/>
                      </a:lnTo>
                      <a:lnTo>
                        <a:pt x="876" y="296"/>
                      </a:lnTo>
                      <a:lnTo>
                        <a:pt x="902" y="292"/>
                      </a:lnTo>
                      <a:lnTo>
                        <a:pt x="926" y="287"/>
                      </a:lnTo>
                      <a:lnTo>
                        <a:pt x="952" y="283"/>
                      </a:lnTo>
                      <a:lnTo>
                        <a:pt x="977" y="277"/>
                      </a:lnTo>
                      <a:lnTo>
                        <a:pt x="1002" y="272"/>
                      </a:lnTo>
                      <a:lnTo>
                        <a:pt x="1027" y="266"/>
                      </a:lnTo>
                      <a:lnTo>
                        <a:pt x="1052" y="261"/>
                      </a:lnTo>
                      <a:lnTo>
                        <a:pt x="1077" y="254"/>
                      </a:lnTo>
                      <a:lnTo>
                        <a:pt x="1101" y="249"/>
                      </a:lnTo>
                      <a:lnTo>
                        <a:pt x="1127" y="243"/>
                      </a:lnTo>
                      <a:lnTo>
                        <a:pt x="1151" y="237"/>
                      </a:lnTo>
                      <a:lnTo>
                        <a:pt x="1177" y="230"/>
                      </a:lnTo>
                      <a:lnTo>
                        <a:pt x="1201" y="224"/>
                      </a:lnTo>
                      <a:lnTo>
                        <a:pt x="1227" y="218"/>
                      </a:lnTo>
                      <a:lnTo>
                        <a:pt x="1252" y="211"/>
                      </a:lnTo>
                      <a:lnTo>
                        <a:pt x="1277" y="204"/>
                      </a:lnTo>
                      <a:lnTo>
                        <a:pt x="1302" y="197"/>
                      </a:lnTo>
                      <a:lnTo>
                        <a:pt x="1327" y="191"/>
                      </a:lnTo>
                      <a:lnTo>
                        <a:pt x="1352" y="184"/>
                      </a:lnTo>
                      <a:lnTo>
                        <a:pt x="1378" y="177"/>
                      </a:lnTo>
                      <a:lnTo>
                        <a:pt x="1402" y="170"/>
                      </a:lnTo>
                      <a:lnTo>
                        <a:pt x="1428" y="163"/>
                      </a:lnTo>
                      <a:lnTo>
                        <a:pt x="1452" y="157"/>
                      </a:lnTo>
                      <a:lnTo>
                        <a:pt x="1478" y="149"/>
                      </a:lnTo>
                      <a:lnTo>
                        <a:pt x="1502" y="142"/>
                      </a:lnTo>
                      <a:lnTo>
                        <a:pt x="1528" y="135"/>
                      </a:lnTo>
                      <a:lnTo>
                        <a:pt x="1552" y="127"/>
                      </a:lnTo>
                      <a:lnTo>
                        <a:pt x="1578" y="120"/>
                      </a:lnTo>
                      <a:lnTo>
                        <a:pt x="1603" y="113"/>
                      </a:lnTo>
                      <a:lnTo>
                        <a:pt x="1628" y="105"/>
                      </a:lnTo>
                      <a:lnTo>
                        <a:pt x="1653" y="98"/>
                      </a:lnTo>
                      <a:lnTo>
                        <a:pt x="1678" y="90"/>
                      </a:lnTo>
                      <a:lnTo>
                        <a:pt x="1703" y="84"/>
                      </a:lnTo>
                      <a:lnTo>
                        <a:pt x="1729" y="75"/>
                      </a:lnTo>
                      <a:lnTo>
                        <a:pt x="1753" y="69"/>
                      </a:lnTo>
                      <a:lnTo>
                        <a:pt x="1779" y="61"/>
                      </a:lnTo>
                      <a:lnTo>
                        <a:pt x="1803" y="52"/>
                      </a:lnTo>
                      <a:lnTo>
                        <a:pt x="1829" y="46"/>
                      </a:lnTo>
                      <a:lnTo>
                        <a:pt x="1853" y="38"/>
                      </a:lnTo>
                      <a:lnTo>
                        <a:pt x="1879" y="31"/>
                      </a:lnTo>
                      <a:lnTo>
                        <a:pt x="1903" y="23"/>
                      </a:lnTo>
                      <a:lnTo>
                        <a:pt x="1929" y="14"/>
                      </a:lnTo>
                      <a:lnTo>
                        <a:pt x="1953" y="8"/>
                      </a:lnTo>
                      <a:lnTo>
                        <a:pt x="1978" y="0"/>
                      </a:lnTo>
                      <a:lnTo>
                        <a:pt x="1978" y="1480"/>
                      </a:lnTo>
                      <a:lnTo>
                        <a:pt x="1953" y="1467"/>
                      </a:lnTo>
                      <a:lnTo>
                        <a:pt x="1929" y="1453"/>
                      </a:lnTo>
                      <a:lnTo>
                        <a:pt x="1903" y="1438"/>
                      </a:lnTo>
                      <a:lnTo>
                        <a:pt x="1879" y="1425"/>
                      </a:lnTo>
                      <a:lnTo>
                        <a:pt x="1853" y="1411"/>
                      </a:lnTo>
                      <a:lnTo>
                        <a:pt x="1829" y="1398"/>
                      </a:lnTo>
                      <a:lnTo>
                        <a:pt x="1803" y="1383"/>
                      </a:lnTo>
                      <a:lnTo>
                        <a:pt x="1779" y="1369"/>
                      </a:lnTo>
                      <a:lnTo>
                        <a:pt x="1753" y="1356"/>
                      </a:lnTo>
                      <a:lnTo>
                        <a:pt x="1729" y="1342"/>
                      </a:lnTo>
                      <a:lnTo>
                        <a:pt x="1703" y="1329"/>
                      </a:lnTo>
                      <a:lnTo>
                        <a:pt x="1678" y="1314"/>
                      </a:lnTo>
                      <a:lnTo>
                        <a:pt x="1653" y="1300"/>
                      </a:lnTo>
                      <a:lnTo>
                        <a:pt x="1628" y="1287"/>
                      </a:lnTo>
                      <a:lnTo>
                        <a:pt x="1603" y="1273"/>
                      </a:lnTo>
                      <a:lnTo>
                        <a:pt x="1578" y="1259"/>
                      </a:lnTo>
                      <a:lnTo>
                        <a:pt x="1552" y="1246"/>
                      </a:lnTo>
                      <a:lnTo>
                        <a:pt x="1528" y="1232"/>
                      </a:lnTo>
                      <a:lnTo>
                        <a:pt x="1502" y="1219"/>
                      </a:lnTo>
                      <a:lnTo>
                        <a:pt x="1478" y="1205"/>
                      </a:lnTo>
                      <a:lnTo>
                        <a:pt x="1452" y="1192"/>
                      </a:lnTo>
                      <a:lnTo>
                        <a:pt x="1428" y="1178"/>
                      </a:lnTo>
                      <a:lnTo>
                        <a:pt x="1402" y="1166"/>
                      </a:lnTo>
                      <a:lnTo>
                        <a:pt x="1378" y="1152"/>
                      </a:lnTo>
                      <a:lnTo>
                        <a:pt x="1352" y="1139"/>
                      </a:lnTo>
                      <a:lnTo>
                        <a:pt x="1327" y="1125"/>
                      </a:lnTo>
                      <a:lnTo>
                        <a:pt x="1302" y="1113"/>
                      </a:lnTo>
                      <a:lnTo>
                        <a:pt x="1277" y="1100"/>
                      </a:lnTo>
                      <a:lnTo>
                        <a:pt x="1252" y="1086"/>
                      </a:lnTo>
                      <a:lnTo>
                        <a:pt x="1227" y="1074"/>
                      </a:lnTo>
                      <a:lnTo>
                        <a:pt x="1201" y="1062"/>
                      </a:lnTo>
                      <a:lnTo>
                        <a:pt x="1177" y="1048"/>
                      </a:lnTo>
                      <a:lnTo>
                        <a:pt x="1151" y="1036"/>
                      </a:lnTo>
                      <a:lnTo>
                        <a:pt x="1127" y="1024"/>
                      </a:lnTo>
                      <a:lnTo>
                        <a:pt x="1101" y="1012"/>
                      </a:lnTo>
                      <a:lnTo>
                        <a:pt x="1077" y="999"/>
                      </a:lnTo>
                      <a:lnTo>
                        <a:pt x="1052" y="987"/>
                      </a:lnTo>
                      <a:lnTo>
                        <a:pt x="1027" y="975"/>
                      </a:lnTo>
                      <a:lnTo>
                        <a:pt x="1002" y="963"/>
                      </a:lnTo>
                      <a:lnTo>
                        <a:pt x="977" y="952"/>
                      </a:lnTo>
                      <a:lnTo>
                        <a:pt x="952" y="940"/>
                      </a:lnTo>
                      <a:lnTo>
                        <a:pt x="926" y="929"/>
                      </a:lnTo>
                      <a:lnTo>
                        <a:pt x="902" y="918"/>
                      </a:lnTo>
                      <a:lnTo>
                        <a:pt x="876" y="907"/>
                      </a:lnTo>
                      <a:lnTo>
                        <a:pt x="852" y="896"/>
                      </a:lnTo>
                      <a:lnTo>
                        <a:pt x="826" y="886"/>
                      </a:lnTo>
                      <a:lnTo>
                        <a:pt x="802" y="876"/>
                      </a:lnTo>
                      <a:lnTo>
                        <a:pt x="776" y="867"/>
                      </a:lnTo>
                      <a:lnTo>
                        <a:pt x="752" y="857"/>
                      </a:lnTo>
                      <a:lnTo>
                        <a:pt x="726" y="848"/>
                      </a:lnTo>
                      <a:lnTo>
                        <a:pt x="702" y="840"/>
                      </a:lnTo>
                      <a:lnTo>
                        <a:pt x="676" y="831"/>
                      </a:lnTo>
                      <a:lnTo>
                        <a:pt x="651" y="823"/>
                      </a:lnTo>
                      <a:lnTo>
                        <a:pt x="626" y="815"/>
                      </a:lnTo>
                      <a:lnTo>
                        <a:pt x="601" y="808"/>
                      </a:lnTo>
                      <a:lnTo>
                        <a:pt x="576" y="802"/>
                      </a:lnTo>
                      <a:lnTo>
                        <a:pt x="551" y="796"/>
                      </a:lnTo>
                      <a:lnTo>
                        <a:pt x="525" y="791"/>
                      </a:lnTo>
                      <a:lnTo>
                        <a:pt x="501" y="785"/>
                      </a:lnTo>
                      <a:lnTo>
                        <a:pt x="475" y="781"/>
                      </a:lnTo>
                      <a:lnTo>
                        <a:pt x="451" y="777"/>
                      </a:lnTo>
                      <a:lnTo>
                        <a:pt x="425" y="774"/>
                      </a:lnTo>
                      <a:lnTo>
                        <a:pt x="401" y="772"/>
                      </a:lnTo>
                      <a:lnTo>
                        <a:pt x="375" y="769"/>
                      </a:lnTo>
                      <a:lnTo>
                        <a:pt x="351" y="768"/>
                      </a:lnTo>
                      <a:lnTo>
                        <a:pt x="325" y="766"/>
                      </a:lnTo>
                      <a:lnTo>
                        <a:pt x="301" y="766"/>
                      </a:lnTo>
                      <a:lnTo>
                        <a:pt x="275" y="766"/>
                      </a:lnTo>
                      <a:lnTo>
                        <a:pt x="250" y="766"/>
                      </a:lnTo>
                      <a:lnTo>
                        <a:pt x="225" y="768"/>
                      </a:lnTo>
                      <a:lnTo>
                        <a:pt x="200" y="769"/>
                      </a:lnTo>
                      <a:lnTo>
                        <a:pt x="175" y="772"/>
                      </a:lnTo>
                      <a:lnTo>
                        <a:pt x="150" y="773"/>
                      </a:lnTo>
                      <a:lnTo>
                        <a:pt x="126" y="776"/>
                      </a:lnTo>
                      <a:lnTo>
                        <a:pt x="100" y="779"/>
                      </a:lnTo>
                      <a:lnTo>
                        <a:pt x="76" y="783"/>
                      </a:lnTo>
                      <a:lnTo>
                        <a:pt x="50" y="787"/>
                      </a:lnTo>
                      <a:lnTo>
                        <a:pt x="26" y="789"/>
                      </a:lnTo>
                      <a:lnTo>
                        <a:pt x="0" y="795"/>
                      </a:lnTo>
                      <a:lnTo>
                        <a:pt x="0" y="189"/>
                      </a:lnTo>
                      <a:close/>
                    </a:path>
                  </a:pathLst>
                </a:cu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80" name="Freeform 206">
                  <a:extLst>
                    <a:ext uri="{FF2B5EF4-FFF2-40B4-BE49-F238E27FC236}">
                      <a16:creationId xmlns:a16="http://schemas.microsoft.com/office/drawing/2014/main" id="{8CB0B42E-0F65-6DE8-FAFB-D5C44795FFF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781550" y="2427288"/>
                  <a:ext cx="3140075" cy="517525"/>
                </a:xfrm>
                <a:custGeom>
                  <a:avLst/>
                  <a:gdLst>
                    <a:gd name="T0" fmla="*/ 26 w 1978"/>
                    <a:gd name="T1" fmla="*/ 199 h 326"/>
                    <a:gd name="T2" fmla="*/ 76 w 1978"/>
                    <a:gd name="T3" fmla="*/ 219 h 326"/>
                    <a:gd name="T4" fmla="*/ 126 w 1978"/>
                    <a:gd name="T5" fmla="*/ 238 h 326"/>
                    <a:gd name="T6" fmla="*/ 175 w 1978"/>
                    <a:gd name="T7" fmla="*/ 256 h 326"/>
                    <a:gd name="T8" fmla="*/ 225 w 1978"/>
                    <a:gd name="T9" fmla="*/ 272 h 326"/>
                    <a:gd name="T10" fmla="*/ 275 w 1978"/>
                    <a:gd name="T11" fmla="*/ 285 h 326"/>
                    <a:gd name="T12" fmla="*/ 325 w 1978"/>
                    <a:gd name="T13" fmla="*/ 298 h 326"/>
                    <a:gd name="T14" fmla="*/ 375 w 1978"/>
                    <a:gd name="T15" fmla="*/ 308 h 326"/>
                    <a:gd name="T16" fmla="*/ 425 w 1978"/>
                    <a:gd name="T17" fmla="*/ 317 h 326"/>
                    <a:gd name="T18" fmla="*/ 475 w 1978"/>
                    <a:gd name="T19" fmla="*/ 322 h 326"/>
                    <a:gd name="T20" fmla="*/ 525 w 1978"/>
                    <a:gd name="T21" fmla="*/ 325 h 326"/>
                    <a:gd name="T22" fmla="*/ 576 w 1978"/>
                    <a:gd name="T23" fmla="*/ 326 h 326"/>
                    <a:gd name="T24" fmla="*/ 626 w 1978"/>
                    <a:gd name="T25" fmla="*/ 325 h 326"/>
                    <a:gd name="T26" fmla="*/ 676 w 1978"/>
                    <a:gd name="T27" fmla="*/ 322 h 326"/>
                    <a:gd name="T28" fmla="*/ 726 w 1978"/>
                    <a:gd name="T29" fmla="*/ 318 h 326"/>
                    <a:gd name="T30" fmla="*/ 776 w 1978"/>
                    <a:gd name="T31" fmla="*/ 313 h 326"/>
                    <a:gd name="T32" fmla="*/ 826 w 1978"/>
                    <a:gd name="T33" fmla="*/ 304 h 326"/>
                    <a:gd name="T34" fmla="*/ 876 w 1978"/>
                    <a:gd name="T35" fmla="*/ 296 h 326"/>
                    <a:gd name="T36" fmla="*/ 926 w 1978"/>
                    <a:gd name="T37" fmla="*/ 287 h 326"/>
                    <a:gd name="T38" fmla="*/ 977 w 1978"/>
                    <a:gd name="T39" fmla="*/ 277 h 326"/>
                    <a:gd name="T40" fmla="*/ 1027 w 1978"/>
                    <a:gd name="T41" fmla="*/ 266 h 326"/>
                    <a:gd name="T42" fmla="*/ 1077 w 1978"/>
                    <a:gd name="T43" fmla="*/ 254 h 326"/>
                    <a:gd name="T44" fmla="*/ 1127 w 1978"/>
                    <a:gd name="T45" fmla="*/ 243 h 326"/>
                    <a:gd name="T46" fmla="*/ 1177 w 1978"/>
                    <a:gd name="T47" fmla="*/ 230 h 326"/>
                    <a:gd name="T48" fmla="*/ 1227 w 1978"/>
                    <a:gd name="T49" fmla="*/ 218 h 326"/>
                    <a:gd name="T50" fmla="*/ 1277 w 1978"/>
                    <a:gd name="T51" fmla="*/ 204 h 326"/>
                    <a:gd name="T52" fmla="*/ 1327 w 1978"/>
                    <a:gd name="T53" fmla="*/ 191 h 326"/>
                    <a:gd name="T54" fmla="*/ 1378 w 1978"/>
                    <a:gd name="T55" fmla="*/ 177 h 326"/>
                    <a:gd name="T56" fmla="*/ 1428 w 1978"/>
                    <a:gd name="T57" fmla="*/ 163 h 326"/>
                    <a:gd name="T58" fmla="*/ 1478 w 1978"/>
                    <a:gd name="T59" fmla="*/ 149 h 326"/>
                    <a:gd name="T60" fmla="*/ 1528 w 1978"/>
                    <a:gd name="T61" fmla="*/ 135 h 326"/>
                    <a:gd name="T62" fmla="*/ 1578 w 1978"/>
                    <a:gd name="T63" fmla="*/ 120 h 326"/>
                    <a:gd name="T64" fmla="*/ 1628 w 1978"/>
                    <a:gd name="T65" fmla="*/ 105 h 326"/>
                    <a:gd name="T66" fmla="*/ 1678 w 1978"/>
                    <a:gd name="T67" fmla="*/ 90 h 326"/>
                    <a:gd name="T68" fmla="*/ 1729 w 1978"/>
                    <a:gd name="T69" fmla="*/ 75 h 326"/>
                    <a:gd name="T70" fmla="*/ 1779 w 1978"/>
                    <a:gd name="T71" fmla="*/ 61 h 326"/>
                    <a:gd name="T72" fmla="*/ 1829 w 1978"/>
                    <a:gd name="T73" fmla="*/ 46 h 326"/>
                    <a:gd name="T74" fmla="*/ 1879 w 1978"/>
                    <a:gd name="T75" fmla="*/ 31 h 326"/>
                    <a:gd name="T76" fmla="*/ 1929 w 1978"/>
                    <a:gd name="T77" fmla="*/ 14 h 326"/>
                    <a:gd name="T78" fmla="*/ 1978 w 1978"/>
                    <a:gd name="T79" fmla="*/ 0 h 32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</a:cxnLst>
                  <a:rect l="0" t="0" r="r" b="b"/>
                  <a:pathLst>
                    <a:path w="1978" h="326">
                      <a:moveTo>
                        <a:pt x="0" y="189"/>
                      </a:moveTo>
                      <a:lnTo>
                        <a:pt x="26" y="199"/>
                      </a:lnTo>
                      <a:lnTo>
                        <a:pt x="50" y="210"/>
                      </a:lnTo>
                      <a:lnTo>
                        <a:pt x="76" y="219"/>
                      </a:lnTo>
                      <a:lnTo>
                        <a:pt x="100" y="229"/>
                      </a:lnTo>
                      <a:lnTo>
                        <a:pt x="126" y="238"/>
                      </a:lnTo>
                      <a:lnTo>
                        <a:pt x="150" y="247"/>
                      </a:lnTo>
                      <a:lnTo>
                        <a:pt x="175" y="256"/>
                      </a:lnTo>
                      <a:lnTo>
                        <a:pt x="200" y="264"/>
                      </a:lnTo>
                      <a:lnTo>
                        <a:pt x="225" y="272"/>
                      </a:lnTo>
                      <a:lnTo>
                        <a:pt x="250" y="279"/>
                      </a:lnTo>
                      <a:lnTo>
                        <a:pt x="275" y="285"/>
                      </a:lnTo>
                      <a:lnTo>
                        <a:pt x="301" y="292"/>
                      </a:lnTo>
                      <a:lnTo>
                        <a:pt x="325" y="298"/>
                      </a:lnTo>
                      <a:lnTo>
                        <a:pt x="351" y="303"/>
                      </a:lnTo>
                      <a:lnTo>
                        <a:pt x="375" y="308"/>
                      </a:lnTo>
                      <a:lnTo>
                        <a:pt x="401" y="313"/>
                      </a:lnTo>
                      <a:lnTo>
                        <a:pt x="425" y="317"/>
                      </a:lnTo>
                      <a:lnTo>
                        <a:pt x="451" y="319"/>
                      </a:lnTo>
                      <a:lnTo>
                        <a:pt x="475" y="322"/>
                      </a:lnTo>
                      <a:lnTo>
                        <a:pt x="501" y="323"/>
                      </a:lnTo>
                      <a:lnTo>
                        <a:pt x="525" y="325"/>
                      </a:lnTo>
                      <a:lnTo>
                        <a:pt x="551" y="326"/>
                      </a:lnTo>
                      <a:lnTo>
                        <a:pt x="576" y="326"/>
                      </a:lnTo>
                      <a:lnTo>
                        <a:pt x="601" y="326"/>
                      </a:lnTo>
                      <a:lnTo>
                        <a:pt x="626" y="325"/>
                      </a:lnTo>
                      <a:lnTo>
                        <a:pt x="651" y="323"/>
                      </a:lnTo>
                      <a:lnTo>
                        <a:pt x="676" y="322"/>
                      </a:lnTo>
                      <a:lnTo>
                        <a:pt x="702" y="321"/>
                      </a:lnTo>
                      <a:lnTo>
                        <a:pt x="726" y="318"/>
                      </a:lnTo>
                      <a:lnTo>
                        <a:pt x="752" y="315"/>
                      </a:lnTo>
                      <a:lnTo>
                        <a:pt x="776" y="313"/>
                      </a:lnTo>
                      <a:lnTo>
                        <a:pt x="802" y="308"/>
                      </a:lnTo>
                      <a:lnTo>
                        <a:pt x="826" y="304"/>
                      </a:lnTo>
                      <a:lnTo>
                        <a:pt x="852" y="300"/>
                      </a:lnTo>
                      <a:lnTo>
                        <a:pt x="876" y="296"/>
                      </a:lnTo>
                      <a:lnTo>
                        <a:pt x="902" y="292"/>
                      </a:lnTo>
                      <a:lnTo>
                        <a:pt x="926" y="287"/>
                      </a:lnTo>
                      <a:lnTo>
                        <a:pt x="952" y="283"/>
                      </a:lnTo>
                      <a:lnTo>
                        <a:pt x="977" y="277"/>
                      </a:lnTo>
                      <a:lnTo>
                        <a:pt x="1002" y="272"/>
                      </a:lnTo>
                      <a:lnTo>
                        <a:pt x="1027" y="266"/>
                      </a:lnTo>
                      <a:lnTo>
                        <a:pt x="1052" y="261"/>
                      </a:lnTo>
                      <a:lnTo>
                        <a:pt x="1077" y="254"/>
                      </a:lnTo>
                      <a:lnTo>
                        <a:pt x="1101" y="249"/>
                      </a:lnTo>
                      <a:lnTo>
                        <a:pt x="1127" y="243"/>
                      </a:lnTo>
                      <a:lnTo>
                        <a:pt x="1151" y="237"/>
                      </a:lnTo>
                      <a:lnTo>
                        <a:pt x="1177" y="230"/>
                      </a:lnTo>
                      <a:lnTo>
                        <a:pt x="1201" y="224"/>
                      </a:lnTo>
                      <a:lnTo>
                        <a:pt x="1227" y="218"/>
                      </a:lnTo>
                      <a:lnTo>
                        <a:pt x="1252" y="211"/>
                      </a:lnTo>
                      <a:lnTo>
                        <a:pt x="1277" y="204"/>
                      </a:lnTo>
                      <a:lnTo>
                        <a:pt x="1302" y="197"/>
                      </a:lnTo>
                      <a:lnTo>
                        <a:pt x="1327" y="191"/>
                      </a:lnTo>
                      <a:lnTo>
                        <a:pt x="1352" y="184"/>
                      </a:lnTo>
                      <a:lnTo>
                        <a:pt x="1378" y="177"/>
                      </a:lnTo>
                      <a:lnTo>
                        <a:pt x="1402" y="170"/>
                      </a:lnTo>
                      <a:lnTo>
                        <a:pt x="1428" y="163"/>
                      </a:lnTo>
                      <a:lnTo>
                        <a:pt x="1452" y="157"/>
                      </a:lnTo>
                      <a:lnTo>
                        <a:pt x="1478" y="149"/>
                      </a:lnTo>
                      <a:lnTo>
                        <a:pt x="1502" y="142"/>
                      </a:lnTo>
                      <a:lnTo>
                        <a:pt x="1528" y="135"/>
                      </a:lnTo>
                      <a:lnTo>
                        <a:pt x="1552" y="127"/>
                      </a:lnTo>
                      <a:lnTo>
                        <a:pt x="1578" y="120"/>
                      </a:lnTo>
                      <a:lnTo>
                        <a:pt x="1603" y="113"/>
                      </a:lnTo>
                      <a:lnTo>
                        <a:pt x="1628" y="105"/>
                      </a:lnTo>
                      <a:lnTo>
                        <a:pt x="1653" y="98"/>
                      </a:lnTo>
                      <a:lnTo>
                        <a:pt x="1678" y="90"/>
                      </a:lnTo>
                      <a:lnTo>
                        <a:pt x="1703" y="84"/>
                      </a:lnTo>
                      <a:lnTo>
                        <a:pt x="1729" y="75"/>
                      </a:lnTo>
                      <a:lnTo>
                        <a:pt x="1753" y="69"/>
                      </a:lnTo>
                      <a:lnTo>
                        <a:pt x="1779" y="61"/>
                      </a:lnTo>
                      <a:lnTo>
                        <a:pt x="1803" y="52"/>
                      </a:lnTo>
                      <a:lnTo>
                        <a:pt x="1829" y="46"/>
                      </a:lnTo>
                      <a:lnTo>
                        <a:pt x="1853" y="38"/>
                      </a:lnTo>
                      <a:lnTo>
                        <a:pt x="1879" y="31"/>
                      </a:lnTo>
                      <a:lnTo>
                        <a:pt x="1903" y="23"/>
                      </a:lnTo>
                      <a:lnTo>
                        <a:pt x="1929" y="14"/>
                      </a:lnTo>
                      <a:lnTo>
                        <a:pt x="1953" y="8"/>
                      </a:lnTo>
                      <a:lnTo>
                        <a:pt x="1978" y="0"/>
                      </a:lnTo>
                    </a:path>
                  </a:pathLst>
                </a:cu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81" name="Freeform 207">
                  <a:extLst>
                    <a:ext uri="{FF2B5EF4-FFF2-40B4-BE49-F238E27FC236}">
                      <a16:creationId xmlns:a16="http://schemas.microsoft.com/office/drawing/2014/main" id="{ACFC309F-E246-9C7C-F4F8-FD5B173DCA0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781550" y="3643313"/>
                  <a:ext cx="3140075" cy="1133475"/>
                </a:xfrm>
                <a:custGeom>
                  <a:avLst/>
                  <a:gdLst>
                    <a:gd name="T0" fmla="*/ 1953 w 1978"/>
                    <a:gd name="T1" fmla="*/ 701 h 714"/>
                    <a:gd name="T2" fmla="*/ 1903 w 1978"/>
                    <a:gd name="T3" fmla="*/ 672 h 714"/>
                    <a:gd name="T4" fmla="*/ 1853 w 1978"/>
                    <a:gd name="T5" fmla="*/ 645 h 714"/>
                    <a:gd name="T6" fmla="*/ 1803 w 1978"/>
                    <a:gd name="T7" fmla="*/ 617 h 714"/>
                    <a:gd name="T8" fmla="*/ 1753 w 1978"/>
                    <a:gd name="T9" fmla="*/ 590 h 714"/>
                    <a:gd name="T10" fmla="*/ 1703 w 1978"/>
                    <a:gd name="T11" fmla="*/ 563 h 714"/>
                    <a:gd name="T12" fmla="*/ 1653 w 1978"/>
                    <a:gd name="T13" fmla="*/ 534 h 714"/>
                    <a:gd name="T14" fmla="*/ 1603 w 1978"/>
                    <a:gd name="T15" fmla="*/ 507 h 714"/>
                    <a:gd name="T16" fmla="*/ 1552 w 1978"/>
                    <a:gd name="T17" fmla="*/ 480 h 714"/>
                    <a:gd name="T18" fmla="*/ 1502 w 1978"/>
                    <a:gd name="T19" fmla="*/ 453 h 714"/>
                    <a:gd name="T20" fmla="*/ 1452 w 1978"/>
                    <a:gd name="T21" fmla="*/ 426 h 714"/>
                    <a:gd name="T22" fmla="*/ 1402 w 1978"/>
                    <a:gd name="T23" fmla="*/ 400 h 714"/>
                    <a:gd name="T24" fmla="*/ 1352 w 1978"/>
                    <a:gd name="T25" fmla="*/ 373 h 714"/>
                    <a:gd name="T26" fmla="*/ 1302 w 1978"/>
                    <a:gd name="T27" fmla="*/ 347 h 714"/>
                    <a:gd name="T28" fmla="*/ 1252 w 1978"/>
                    <a:gd name="T29" fmla="*/ 320 h 714"/>
                    <a:gd name="T30" fmla="*/ 1201 w 1978"/>
                    <a:gd name="T31" fmla="*/ 296 h 714"/>
                    <a:gd name="T32" fmla="*/ 1151 w 1978"/>
                    <a:gd name="T33" fmla="*/ 270 h 714"/>
                    <a:gd name="T34" fmla="*/ 1101 w 1978"/>
                    <a:gd name="T35" fmla="*/ 246 h 714"/>
                    <a:gd name="T36" fmla="*/ 1052 w 1978"/>
                    <a:gd name="T37" fmla="*/ 221 h 714"/>
                    <a:gd name="T38" fmla="*/ 1002 w 1978"/>
                    <a:gd name="T39" fmla="*/ 197 h 714"/>
                    <a:gd name="T40" fmla="*/ 952 w 1978"/>
                    <a:gd name="T41" fmla="*/ 174 h 714"/>
                    <a:gd name="T42" fmla="*/ 902 w 1978"/>
                    <a:gd name="T43" fmla="*/ 152 h 714"/>
                    <a:gd name="T44" fmla="*/ 852 w 1978"/>
                    <a:gd name="T45" fmla="*/ 130 h 714"/>
                    <a:gd name="T46" fmla="*/ 802 w 1978"/>
                    <a:gd name="T47" fmla="*/ 110 h 714"/>
                    <a:gd name="T48" fmla="*/ 752 w 1978"/>
                    <a:gd name="T49" fmla="*/ 91 h 714"/>
                    <a:gd name="T50" fmla="*/ 702 w 1978"/>
                    <a:gd name="T51" fmla="*/ 74 h 714"/>
                    <a:gd name="T52" fmla="*/ 651 w 1978"/>
                    <a:gd name="T53" fmla="*/ 57 h 714"/>
                    <a:gd name="T54" fmla="*/ 601 w 1978"/>
                    <a:gd name="T55" fmla="*/ 42 h 714"/>
                    <a:gd name="T56" fmla="*/ 551 w 1978"/>
                    <a:gd name="T57" fmla="*/ 30 h 714"/>
                    <a:gd name="T58" fmla="*/ 501 w 1978"/>
                    <a:gd name="T59" fmla="*/ 19 h 714"/>
                    <a:gd name="T60" fmla="*/ 451 w 1978"/>
                    <a:gd name="T61" fmla="*/ 11 h 714"/>
                    <a:gd name="T62" fmla="*/ 401 w 1978"/>
                    <a:gd name="T63" fmla="*/ 6 h 714"/>
                    <a:gd name="T64" fmla="*/ 351 w 1978"/>
                    <a:gd name="T65" fmla="*/ 2 h 714"/>
                    <a:gd name="T66" fmla="*/ 301 w 1978"/>
                    <a:gd name="T67" fmla="*/ 0 h 714"/>
                    <a:gd name="T68" fmla="*/ 250 w 1978"/>
                    <a:gd name="T69" fmla="*/ 0 h 714"/>
                    <a:gd name="T70" fmla="*/ 200 w 1978"/>
                    <a:gd name="T71" fmla="*/ 3 h 714"/>
                    <a:gd name="T72" fmla="*/ 150 w 1978"/>
                    <a:gd name="T73" fmla="*/ 7 h 714"/>
                    <a:gd name="T74" fmla="*/ 100 w 1978"/>
                    <a:gd name="T75" fmla="*/ 13 h 714"/>
                    <a:gd name="T76" fmla="*/ 50 w 1978"/>
                    <a:gd name="T77" fmla="*/ 21 h 714"/>
                    <a:gd name="T78" fmla="*/ 0 w 1978"/>
                    <a:gd name="T79" fmla="*/ 29 h 71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</a:cxnLst>
                  <a:rect l="0" t="0" r="r" b="b"/>
                  <a:pathLst>
                    <a:path w="1978" h="714">
                      <a:moveTo>
                        <a:pt x="1978" y="714"/>
                      </a:moveTo>
                      <a:lnTo>
                        <a:pt x="1953" y="701"/>
                      </a:lnTo>
                      <a:lnTo>
                        <a:pt x="1929" y="687"/>
                      </a:lnTo>
                      <a:lnTo>
                        <a:pt x="1903" y="672"/>
                      </a:lnTo>
                      <a:lnTo>
                        <a:pt x="1879" y="659"/>
                      </a:lnTo>
                      <a:lnTo>
                        <a:pt x="1853" y="645"/>
                      </a:lnTo>
                      <a:lnTo>
                        <a:pt x="1829" y="632"/>
                      </a:lnTo>
                      <a:lnTo>
                        <a:pt x="1803" y="617"/>
                      </a:lnTo>
                      <a:lnTo>
                        <a:pt x="1779" y="603"/>
                      </a:lnTo>
                      <a:lnTo>
                        <a:pt x="1753" y="590"/>
                      </a:lnTo>
                      <a:lnTo>
                        <a:pt x="1729" y="576"/>
                      </a:lnTo>
                      <a:lnTo>
                        <a:pt x="1703" y="563"/>
                      </a:lnTo>
                      <a:lnTo>
                        <a:pt x="1678" y="548"/>
                      </a:lnTo>
                      <a:lnTo>
                        <a:pt x="1653" y="534"/>
                      </a:lnTo>
                      <a:lnTo>
                        <a:pt x="1628" y="521"/>
                      </a:lnTo>
                      <a:lnTo>
                        <a:pt x="1603" y="507"/>
                      </a:lnTo>
                      <a:lnTo>
                        <a:pt x="1578" y="493"/>
                      </a:lnTo>
                      <a:lnTo>
                        <a:pt x="1552" y="480"/>
                      </a:lnTo>
                      <a:lnTo>
                        <a:pt x="1528" y="466"/>
                      </a:lnTo>
                      <a:lnTo>
                        <a:pt x="1502" y="453"/>
                      </a:lnTo>
                      <a:lnTo>
                        <a:pt x="1478" y="439"/>
                      </a:lnTo>
                      <a:lnTo>
                        <a:pt x="1452" y="426"/>
                      </a:lnTo>
                      <a:lnTo>
                        <a:pt x="1428" y="412"/>
                      </a:lnTo>
                      <a:lnTo>
                        <a:pt x="1402" y="400"/>
                      </a:lnTo>
                      <a:lnTo>
                        <a:pt x="1378" y="386"/>
                      </a:lnTo>
                      <a:lnTo>
                        <a:pt x="1352" y="373"/>
                      </a:lnTo>
                      <a:lnTo>
                        <a:pt x="1327" y="359"/>
                      </a:lnTo>
                      <a:lnTo>
                        <a:pt x="1302" y="347"/>
                      </a:lnTo>
                      <a:lnTo>
                        <a:pt x="1277" y="334"/>
                      </a:lnTo>
                      <a:lnTo>
                        <a:pt x="1252" y="320"/>
                      </a:lnTo>
                      <a:lnTo>
                        <a:pt x="1227" y="308"/>
                      </a:lnTo>
                      <a:lnTo>
                        <a:pt x="1201" y="296"/>
                      </a:lnTo>
                      <a:lnTo>
                        <a:pt x="1177" y="282"/>
                      </a:lnTo>
                      <a:lnTo>
                        <a:pt x="1151" y="270"/>
                      </a:lnTo>
                      <a:lnTo>
                        <a:pt x="1127" y="258"/>
                      </a:lnTo>
                      <a:lnTo>
                        <a:pt x="1101" y="246"/>
                      </a:lnTo>
                      <a:lnTo>
                        <a:pt x="1077" y="233"/>
                      </a:lnTo>
                      <a:lnTo>
                        <a:pt x="1052" y="221"/>
                      </a:lnTo>
                      <a:lnTo>
                        <a:pt x="1027" y="209"/>
                      </a:lnTo>
                      <a:lnTo>
                        <a:pt x="1002" y="197"/>
                      </a:lnTo>
                      <a:lnTo>
                        <a:pt x="977" y="186"/>
                      </a:lnTo>
                      <a:lnTo>
                        <a:pt x="952" y="174"/>
                      </a:lnTo>
                      <a:lnTo>
                        <a:pt x="926" y="163"/>
                      </a:lnTo>
                      <a:lnTo>
                        <a:pt x="902" y="152"/>
                      </a:lnTo>
                      <a:lnTo>
                        <a:pt x="876" y="141"/>
                      </a:lnTo>
                      <a:lnTo>
                        <a:pt x="852" y="130"/>
                      </a:lnTo>
                      <a:lnTo>
                        <a:pt x="826" y="120"/>
                      </a:lnTo>
                      <a:lnTo>
                        <a:pt x="802" y="110"/>
                      </a:lnTo>
                      <a:lnTo>
                        <a:pt x="776" y="101"/>
                      </a:lnTo>
                      <a:lnTo>
                        <a:pt x="752" y="91"/>
                      </a:lnTo>
                      <a:lnTo>
                        <a:pt x="726" y="82"/>
                      </a:lnTo>
                      <a:lnTo>
                        <a:pt x="702" y="74"/>
                      </a:lnTo>
                      <a:lnTo>
                        <a:pt x="676" y="65"/>
                      </a:lnTo>
                      <a:lnTo>
                        <a:pt x="651" y="57"/>
                      </a:lnTo>
                      <a:lnTo>
                        <a:pt x="626" y="49"/>
                      </a:lnTo>
                      <a:lnTo>
                        <a:pt x="601" y="42"/>
                      </a:lnTo>
                      <a:lnTo>
                        <a:pt x="576" y="36"/>
                      </a:lnTo>
                      <a:lnTo>
                        <a:pt x="551" y="30"/>
                      </a:lnTo>
                      <a:lnTo>
                        <a:pt x="525" y="25"/>
                      </a:lnTo>
                      <a:lnTo>
                        <a:pt x="501" y="19"/>
                      </a:lnTo>
                      <a:lnTo>
                        <a:pt x="475" y="15"/>
                      </a:lnTo>
                      <a:lnTo>
                        <a:pt x="451" y="11"/>
                      </a:lnTo>
                      <a:lnTo>
                        <a:pt x="425" y="8"/>
                      </a:lnTo>
                      <a:lnTo>
                        <a:pt x="401" y="6"/>
                      </a:lnTo>
                      <a:lnTo>
                        <a:pt x="375" y="3"/>
                      </a:lnTo>
                      <a:lnTo>
                        <a:pt x="351" y="2"/>
                      </a:lnTo>
                      <a:lnTo>
                        <a:pt x="325" y="0"/>
                      </a:lnTo>
                      <a:lnTo>
                        <a:pt x="301" y="0"/>
                      </a:lnTo>
                      <a:lnTo>
                        <a:pt x="275" y="0"/>
                      </a:lnTo>
                      <a:lnTo>
                        <a:pt x="250" y="0"/>
                      </a:lnTo>
                      <a:lnTo>
                        <a:pt x="225" y="2"/>
                      </a:lnTo>
                      <a:lnTo>
                        <a:pt x="200" y="3"/>
                      </a:lnTo>
                      <a:lnTo>
                        <a:pt x="175" y="6"/>
                      </a:lnTo>
                      <a:lnTo>
                        <a:pt x="150" y="7"/>
                      </a:lnTo>
                      <a:lnTo>
                        <a:pt x="126" y="10"/>
                      </a:lnTo>
                      <a:lnTo>
                        <a:pt x="100" y="13"/>
                      </a:lnTo>
                      <a:lnTo>
                        <a:pt x="76" y="17"/>
                      </a:lnTo>
                      <a:lnTo>
                        <a:pt x="50" y="21"/>
                      </a:lnTo>
                      <a:lnTo>
                        <a:pt x="26" y="23"/>
                      </a:lnTo>
                      <a:lnTo>
                        <a:pt x="0" y="29"/>
                      </a:lnTo>
                    </a:path>
                  </a:pathLst>
                </a:cu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82" name="Freeform 208">
                  <a:extLst>
                    <a:ext uri="{FF2B5EF4-FFF2-40B4-BE49-F238E27FC236}">
                      <a16:creationId xmlns:a16="http://schemas.microsoft.com/office/drawing/2014/main" id="{D8B68F83-3368-DFEA-2CB4-F48B2D26D80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781550" y="3206750"/>
                  <a:ext cx="3140075" cy="396875"/>
                </a:xfrm>
                <a:custGeom>
                  <a:avLst/>
                  <a:gdLst>
                    <a:gd name="T0" fmla="*/ 26 w 1978"/>
                    <a:gd name="T1" fmla="*/ 3 h 250"/>
                    <a:gd name="T2" fmla="*/ 76 w 1978"/>
                    <a:gd name="T3" fmla="*/ 10 h 250"/>
                    <a:gd name="T4" fmla="*/ 126 w 1978"/>
                    <a:gd name="T5" fmla="*/ 17 h 250"/>
                    <a:gd name="T6" fmla="*/ 175 w 1978"/>
                    <a:gd name="T7" fmla="*/ 22 h 250"/>
                    <a:gd name="T8" fmla="*/ 225 w 1978"/>
                    <a:gd name="T9" fmla="*/ 29 h 250"/>
                    <a:gd name="T10" fmla="*/ 275 w 1978"/>
                    <a:gd name="T11" fmla="*/ 36 h 250"/>
                    <a:gd name="T12" fmla="*/ 325 w 1978"/>
                    <a:gd name="T13" fmla="*/ 41 h 250"/>
                    <a:gd name="T14" fmla="*/ 375 w 1978"/>
                    <a:gd name="T15" fmla="*/ 48 h 250"/>
                    <a:gd name="T16" fmla="*/ 425 w 1978"/>
                    <a:gd name="T17" fmla="*/ 55 h 250"/>
                    <a:gd name="T18" fmla="*/ 475 w 1978"/>
                    <a:gd name="T19" fmla="*/ 60 h 250"/>
                    <a:gd name="T20" fmla="*/ 525 w 1978"/>
                    <a:gd name="T21" fmla="*/ 67 h 250"/>
                    <a:gd name="T22" fmla="*/ 576 w 1978"/>
                    <a:gd name="T23" fmla="*/ 73 h 250"/>
                    <a:gd name="T24" fmla="*/ 626 w 1978"/>
                    <a:gd name="T25" fmla="*/ 79 h 250"/>
                    <a:gd name="T26" fmla="*/ 676 w 1978"/>
                    <a:gd name="T27" fmla="*/ 86 h 250"/>
                    <a:gd name="T28" fmla="*/ 726 w 1978"/>
                    <a:gd name="T29" fmla="*/ 91 h 250"/>
                    <a:gd name="T30" fmla="*/ 776 w 1978"/>
                    <a:gd name="T31" fmla="*/ 98 h 250"/>
                    <a:gd name="T32" fmla="*/ 826 w 1978"/>
                    <a:gd name="T33" fmla="*/ 105 h 250"/>
                    <a:gd name="T34" fmla="*/ 876 w 1978"/>
                    <a:gd name="T35" fmla="*/ 110 h 250"/>
                    <a:gd name="T36" fmla="*/ 926 w 1978"/>
                    <a:gd name="T37" fmla="*/ 117 h 250"/>
                    <a:gd name="T38" fmla="*/ 977 w 1978"/>
                    <a:gd name="T39" fmla="*/ 124 h 250"/>
                    <a:gd name="T40" fmla="*/ 1027 w 1978"/>
                    <a:gd name="T41" fmla="*/ 129 h 250"/>
                    <a:gd name="T42" fmla="*/ 1077 w 1978"/>
                    <a:gd name="T43" fmla="*/ 136 h 250"/>
                    <a:gd name="T44" fmla="*/ 1127 w 1978"/>
                    <a:gd name="T45" fmla="*/ 143 h 250"/>
                    <a:gd name="T46" fmla="*/ 1177 w 1978"/>
                    <a:gd name="T47" fmla="*/ 148 h 250"/>
                    <a:gd name="T48" fmla="*/ 1227 w 1978"/>
                    <a:gd name="T49" fmla="*/ 155 h 250"/>
                    <a:gd name="T50" fmla="*/ 1277 w 1978"/>
                    <a:gd name="T51" fmla="*/ 162 h 250"/>
                    <a:gd name="T52" fmla="*/ 1327 w 1978"/>
                    <a:gd name="T53" fmla="*/ 167 h 250"/>
                    <a:gd name="T54" fmla="*/ 1378 w 1978"/>
                    <a:gd name="T55" fmla="*/ 174 h 250"/>
                    <a:gd name="T56" fmla="*/ 1428 w 1978"/>
                    <a:gd name="T57" fmla="*/ 181 h 250"/>
                    <a:gd name="T58" fmla="*/ 1478 w 1978"/>
                    <a:gd name="T59" fmla="*/ 186 h 250"/>
                    <a:gd name="T60" fmla="*/ 1528 w 1978"/>
                    <a:gd name="T61" fmla="*/ 193 h 250"/>
                    <a:gd name="T62" fmla="*/ 1578 w 1978"/>
                    <a:gd name="T63" fmla="*/ 199 h 250"/>
                    <a:gd name="T64" fmla="*/ 1628 w 1978"/>
                    <a:gd name="T65" fmla="*/ 205 h 250"/>
                    <a:gd name="T66" fmla="*/ 1678 w 1978"/>
                    <a:gd name="T67" fmla="*/ 212 h 250"/>
                    <a:gd name="T68" fmla="*/ 1729 w 1978"/>
                    <a:gd name="T69" fmla="*/ 217 h 250"/>
                    <a:gd name="T70" fmla="*/ 1779 w 1978"/>
                    <a:gd name="T71" fmla="*/ 224 h 250"/>
                    <a:gd name="T72" fmla="*/ 1829 w 1978"/>
                    <a:gd name="T73" fmla="*/ 231 h 250"/>
                    <a:gd name="T74" fmla="*/ 1879 w 1978"/>
                    <a:gd name="T75" fmla="*/ 236 h 250"/>
                    <a:gd name="T76" fmla="*/ 1929 w 1978"/>
                    <a:gd name="T77" fmla="*/ 243 h 250"/>
                    <a:gd name="T78" fmla="*/ 1978 w 1978"/>
                    <a:gd name="T79" fmla="*/ 250 h 25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</a:cxnLst>
                  <a:rect l="0" t="0" r="r" b="b"/>
                  <a:pathLst>
                    <a:path w="1978" h="250">
                      <a:moveTo>
                        <a:pt x="0" y="0"/>
                      </a:moveTo>
                      <a:lnTo>
                        <a:pt x="26" y="3"/>
                      </a:lnTo>
                      <a:lnTo>
                        <a:pt x="50" y="7"/>
                      </a:lnTo>
                      <a:lnTo>
                        <a:pt x="76" y="10"/>
                      </a:lnTo>
                      <a:lnTo>
                        <a:pt x="100" y="13"/>
                      </a:lnTo>
                      <a:lnTo>
                        <a:pt x="126" y="17"/>
                      </a:lnTo>
                      <a:lnTo>
                        <a:pt x="150" y="19"/>
                      </a:lnTo>
                      <a:lnTo>
                        <a:pt x="175" y="22"/>
                      </a:lnTo>
                      <a:lnTo>
                        <a:pt x="200" y="26"/>
                      </a:lnTo>
                      <a:lnTo>
                        <a:pt x="225" y="29"/>
                      </a:lnTo>
                      <a:lnTo>
                        <a:pt x="250" y="32"/>
                      </a:lnTo>
                      <a:lnTo>
                        <a:pt x="275" y="36"/>
                      </a:lnTo>
                      <a:lnTo>
                        <a:pt x="301" y="38"/>
                      </a:lnTo>
                      <a:lnTo>
                        <a:pt x="325" y="41"/>
                      </a:lnTo>
                      <a:lnTo>
                        <a:pt x="351" y="45"/>
                      </a:lnTo>
                      <a:lnTo>
                        <a:pt x="375" y="48"/>
                      </a:lnTo>
                      <a:lnTo>
                        <a:pt x="401" y="50"/>
                      </a:lnTo>
                      <a:lnTo>
                        <a:pt x="425" y="55"/>
                      </a:lnTo>
                      <a:lnTo>
                        <a:pt x="451" y="57"/>
                      </a:lnTo>
                      <a:lnTo>
                        <a:pt x="475" y="60"/>
                      </a:lnTo>
                      <a:lnTo>
                        <a:pt x="501" y="64"/>
                      </a:lnTo>
                      <a:lnTo>
                        <a:pt x="525" y="67"/>
                      </a:lnTo>
                      <a:lnTo>
                        <a:pt x="551" y="69"/>
                      </a:lnTo>
                      <a:lnTo>
                        <a:pt x="576" y="73"/>
                      </a:lnTo>
                      <a:lnTo>
                        <a:pt x="601" y="76"/>
                      </a:lnTo>
                      <a:lnTo>
                        <a:pt x="626" y="79"/>
                      </a:lnTo>
                      <a:lnTo>
                        <a:pt x="651" y="83"/>
                      </a:lnTo>
                      <a:lnTo>
                        <a:pt x="676" y="86"/>
                      </a:lnTo>
                      <a:lnTo>
                        <a:pt x="702" y="88"/>
                      </a:lnTo>
                      <a:lnTo>
                        <a:pt x="726" y="91"/>
                      </a:lnTo>
                      <a:lnTo>
                        <a:pt x="752" y="95"/>
                      </a:lnTo>
                      <a:lnTo>
                        <a:pt x="776" y="98"/>
                      </a:lnTo>
                      <a:lnTo>
                        <a:pt x="802" y="101"/>
                      </a:lnTo>
                      <a:lnTo>
                        <a:pt x="826" y="105"/>
                      </a:lnTo>
                      <a:lnTo>
                        <a:pt x="852" y="107"/>
                      </a:lnTo>
                      <a:lnTo>
                        <a:pt x="876" y="110"/>
                      </a:lnTo>
                      <a:lnTo>
                        <a:pt x="902" y="114"/>
                      </a:lnTo>
                      <a:lnTo>
                        <a:pt x="926" y="117"/>
                      </a:lnTo>
                      <a:lnTo>
                        <a:pt x="952" y="120"/>
                      </a:lnTo>
                      <a:lnTo>
                        <a:pt x="977" y="124"/>
                      </a:lnTo>
                      <a:lnTo>
                        <a:pt x="1002" y="126"/>
                      </a:lnTo>
                      <a:lnTo>
                        <a:pt x="1027" y="129"/>
                      </a:lnTo>
                      <a:lnTo>
                        <a:pt x="1052" y="133"/>
                      </a:lnTo>
                      <a:lnTo>
                        <a:pt x="1077" y="136"/>
                      </a:lnTo>
                      <a:lnTo>
                        <a:pt x="1101" y="139"/>
                      </a:lnTo>
                      <a:lnTo>
                        <a:pt x="1127" y="143"/>
                      </a:lnTo>
                      <a:lnTo>
                        <a:pt x="1151" y="145"/>
                      </a:lnTo>
                      <a:lnTo>
                        <a:pt x="1177" y="148"/>
                      </a:lnTo>
                      <a:lnTo>
                        <a:pt x="1201" y="152"/>
                      </a:lnTo>
                      <a:lnTo>
                        <a:pt x="1227" y="155"/>
                      </a:lnTo>
                      <a:lnTo>
                        <a:pt x="1252" y="157"/>
                      </a:lnTo>
                      <a:lnTo>
                        <a:pt x="1277" y="162"/>
                      </a:lnTo>
                      <a:lnTo>
                        <a:pt x="1302" y="164"/>
                      </a:lnTo>
                      <a:lnTo>
                        <a:pt x="1327" y="167"/>
                      </a:lnTo>
                      <a:lnTo>
                        <a:pt x="1352" y="171"/>
                      </a:lnTo>
                      <a:lnTo>
                        <a:pt x="1378" y="174"/>
                      </a:lnTo>
                      <a:lnTo>
                        <a:pt x="1402" y="176"/>
                      </a:lnTo>
                      <a:lnTo>
                        <a:pt x="1428" y="181"/>
                      </a:lnTo>
                      <a:lnTo>
                        <a:pt x="1452" y="183"/>
                      </a:lnTo>
                      <a:lnTo>
                        <a:pt x="1478" y="186"/>
                      </a:lnTo>
                      <a:lnTo>
                        <a:pt x="1502" y="190"/>
                      </a:lnTo>
                      <a:lnTo>
                        <a:pt x="1528" y="193"/>
                      </a:lnTo>
                      <a:lnTo>
                        <a:pt x="1552" y="195"/>
                      </a:lnTo>
                      <a:lnTo>
                        <a:pt x="1578" y="199"/>
                      </a:lnTo>
                      <a:lnTo>
                        <a:pt x="1603" y="202"/>
                      </a:lnTo>
                      <a:lnTo>
                        <a:pt x="1628" y="205"/>
                      </a:lnTo>
                      <a:lnTo>
                        <a:pt x="1653" y="208"/>
                      </a:lnTo>
                      <a:lnTo>
                        <a:pt x="1678" y="212"/>
                      </a:lnTo>
                      <a:lnTo>
                        <a:pt x="1703" y="214"/>
                      </a:lnTo>
                      <a:lnTo>
                        <a:pt x="1729" y="217"/>
                      </a:lnTo>
                      <a:lnTo>
                        <a:pt x="1753" y="221"/>
                      </a:lnTo>
                      <a:lnTo>
                        <a:pt x="1779" y="224"/>
                      </a:lnTo>
                      <a:lnTo>
                        <a:pt x="1803" y="227"/>
                      </a:lnTo>
                      <a:lnTo>
                        <a:pt x="1829" y="231"/>
                      </a:lnTo>
                      <a:lnTo>
                        <a:pt x="1853" y="233"/>
                      </a:lnTo>
                      <a:lnTo>
                        <a:pt x="1879" y="236"/>
                      </a:lnTo>
                      <a:lnTo>
                        <a:pt x="1903" y="240"/>
                      </a:lnTo>
                      <a:lnTo>
                        <a:pt x="1929" y="243"/>
                      </a:lnTo>
                      <a:lnTo>
                        <a:pt x="1953" y="246"/>
                      </a:lnTo>
                      <a:lnTo>
                        <a:pt x="1978" y="250"/>
                      </a:lnTo>
                    </a:path>
                  </a:pathLst>
                </a:custGeom>
                <a:noFill/>
                <a:ln w="0" cap="flat">
                  <a:solidFill>
                    <a:srgbClr val="3366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83" name="Rectangle 209">
                  <a:extLst>
                    <a:ext uri="{FF2B5EF4-FFF2-40B4-BE49-F238E27FC236}">
                      <a16:creationId xmlns:a16="http://schemas.microsoft.com/office/drawing/2014/main" id="{0733C904-0FBC-9CB8-AE83-1475F118D6C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635750" y="2755899"/>
                  <a:ext cx="814195" cy="5536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1100" b="0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R</a:t>
                  </a:r>
                  <a:r>
                    <a:rPr kumimoji="0" lang="en-US" altLang="hu-HU" sz="1100" b="0" i="0" u="none" strike="noStrike" cap="none" normalizeH="0" baseline="3000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2</a:t>
                  </a:r>
                  <a:r>
                    <a:rPr kumimoji="0" lang="en-US" altLang="hu-HU" sz="11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= 0.01</a:t>
                  </a:r>
                </a:p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n-US" altLang="hu-HU" sz="11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p=0.716</a:t>
                  </a:r>
                  <a:endParaRPr kumimoji="0" lang="en-US" altLang="hu-HU" sz="11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4" name="Line 210">
                  <a:extLst>
                    <a:ext uri="{FF2B5EF4-FFF2-40B4-BE49-F238E27FC236}">
                      <a16:creationId xmlns:a16="http://schemas.microsoft.com/office/drawing/2014/main" id="{CAEB8834-97B3-8729-8082-7C765E31693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624388" y="1746250"/>
                  <a:ext cx="0" cy="3176587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85" name="Rectangle 211">
                  <a:extLst>
                    <a:ext uri="{FF2B5EF4-FFF2-40B4-BE49-F238E27FC236}">
                      <a16:creationId xmlns:a16="http://schemas.microsoft.com/office/drawing/2014/main" id="{9D3CFAAA-214C-0D07-C6ED-93AA96C1193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95420" y="4404168"/>
                  <a:ext cx="159733" cy="2013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40</a:t>
                  </a:r>
                  <a:endParaRPr kumimoji="0" lang="en-US" altLang="hu-HU" sz="14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6" name="Rectangle 212">
                  <a:extLst>
                    <a:ext uri="{FF2B5EF4-FFF2-40B4-BE49-F238E27FC236}">
                      <a16:creationId xmlns:a16="http://schemas.microsoft.com/office/drawing/2014/main" id="{0F585703-EEA1-DDE9-3982-0DD6E7AEC3A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95420" y="3845366"/>
                  <a:ext cx="159733" cy="2013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50</a:t>
                  </a:r>
                  <a:endParaRPr kumimoji="0" lang="en-US" altLang="hu-HU" sz="14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7" name="Rectangle 213">
                  <a:extLst>
                    <a:ext uri="{FF2B5EF4-FFF2-40B4-BE49-F238E27FC236}">
                      <a16:creationId xmlns:a16="http://schemas.microsoft.com/office/drawing/2014/main" id="{803741D3-2C59-3DD7-9F6A-52EF385C0A7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95420" y="3288157"/>
                  <a:ext cx="159733" cy="2013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60</a:t>
                  </a:r>
                  <a:endParaRPr kumimoji="0" lang="en-US" altLang="hu-HU" sz="14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8" name="Rectangle 214">
                  <a:extLst>
                    <a:ext uri="{FF2B5EF4-FFF2-40B4-BE49-F238E27FC236}">
                      <a16:creationId xmlns:a16="http://schemas.microsoft.com/office/drawing/2014/main" id="{6B3B9EE6-A108-2166-7B05-23E2E7F3BC5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95420" y="2729356"/>
                  <a:ext cx="159733" cy="2013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70</a:t>
                  </a:r>
                  <a:endParaRPr kumimoji="0" lang="en-US" altLang="hu-HU" sz="14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9" name="Rectangle 215">
                  <a:extLst>
                    <a:ext uri="{FF2B5EF4-FFF2-40B4-BE49-F238E27FC236}">
                      <a16:creationId xmlns:a16="http://schemas.microsoft.com/office/drawing/2014/main" id="{6E2D228D-22A1-35F0-0350-0C586866C9C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95420" y="2172144"/>
                  <a:ext cx="159733" cy="2013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80</a:t>
                  </a:r>
                  <a:endParaRPr kumimoji="0" lang="en-US" altLang="hu-HU" sz="14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0" name="Line 216">
                  <a:extLst>
                    <a:ext uri="{FF2B5EF4-FFF2-40B4-BE49-F238E27FC236}">
                      <a16:creationId xmlns:a16="http://schemas.microsoft.com/office/drawing/2014/main" id="{F3DD8E15-DA35-A89E-BF8A-3464F496C2A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600575" y="4513263"/>
                  <a:ext cx="23813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91" name="Line 217">
                  <a:extLst>
                    <a:ext uri="{FF2B5EF4-FFF2-40B4-BE49-F238E27FC236}">
                      <a16:creationId xmlns:a16="http://schemas.microsoft.com/office/drawing/2014/main" id="{D3FF810C-E306-1DDA-C059-0CD2E018E30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600575" y="3956050"/>
                  <a:ext cx="23813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92" name="Line 218">
                  <a:extLst>
                    <a:ext uri="{FF2B5EF4-FFF2-40B4-BE49-F238E27FC236}">
                      <a16:creationId xmlns:a16="http://schemas.microsoft.com/office/drawing/2014/main" id="{CE156AB0-D91F-1AC6-66ED-B0E2FA8E3BE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600575" y="3397250"/>
                  <a:ext cx="23813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93" name="Line 219">
                  <a:extLst>
                    <a:ext uri="{FF2B5EF4-FFF2-40B4-BE49-F238E27FC236}">
                      <a16:creationId xmlns:a16="http://schemas.microsoft.com/office/drawing/2014/main" id="{526E9C75-9D56-D2D5-8B9B-82CAD3AAD50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600575" y="2840038"/>
                  <a:ext cx="23813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94" name="Line 220">
                  <a:extLst>
                    <a:ext uri="{FF2B5EF4-FFF2-40B4-BE49-F238E27FC236}">
                      <a16:creationId xmlns:a16="http://schemas.microsoft.com/office/drawing/2014/main" id="{2EC15F4C-A829-D740-7BBE-B7C32B90015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600575" y="2279650"/>
                  <a:ext cx="23813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95" name="Line 221">
                  <a:extLst>
                    <a:ext uri="{FF2B5EF4-FFF2-40B4-BE49-F238E27FC236}">
                      <a16:creationId xmlns:a16="http://schemas.microsoft.com/office/drawing/2014/main" id="{82279009-C058-9B34-8EEE-82B2D27E848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624388" y="4922838"/>
                  <a:ext cx="3455988" cy="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96" name="Line 222">
                  <a:extLst>
                    <a:ext uri="{FF2B5EF4-FFF2-40B4-BE49-F238E27FC236}">
                      <a16:creationId xmlns:a16="http://schemas.microsoft.com/office/drawing/2014/main" id="{580CB5EE-5A58-BC5C-6014-718C46C5F84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5208588" y="4922838"/>
                  <a:ext cx="0" cy="23812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97" name="Line 223">
                  <a:extLst>
                    <a:ext uri="{FF2B5EF4-FFF2-40B4-BE49-F238E27FC236}">
                      <a16:creationId xmlns:a16="http://schemas.microsoft.com/office/drawing/2014/main" id="{104A95E2-A018-C2ED-A627-9D449F5E852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6069013" y="4922838"/>
                  <a:ext cx="0" cy="23812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98" name="Line 224">
                  <a:extLst>
                    <a:ext uri="{FF2B5EF4-FFF2-40B4-BE49-F238E27FC236}">
                      <a16:creationId xmlns:a16="http://schemas.microsoft.com/office/drawing/2014/main" id="{F275731A-3143-7A3D-09E3-CEDFC5428E2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6932613" y="4922838"/>
                  <a:ext cx="0" cy="23812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99" name="Line 225">
                  <a:extLst>
                    <a:ext uri="{FF2B5EF4-FFF2-40B4-BE49-F238E27FC236}">
                      <a16:creationId xmlns:a16="http://schemas.microsoft.com/office/drawing/2014/main" id="{D57D6F73-8839-1957-0575-B4AB718B0D9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7794625" y="4922838"/>
                  <a:ext cx="0" cy="23812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200" name="Rectangle 226">
                  <a:extLst>
                    <a:ext uri="{FF2B5EF4-FFF2-40B4-BE49-F238E27FC236}">
                      <a16:creationId xmlns:a16="http://schemas.microsoft.com/office/drawing/2014/main" id="{96D7D60B-956B-7E74-B5DD-65DEE4E6D09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081404" y="4926011"/>
                  <a:ext cx="239599" cy="2013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250</a:t>
                  </a:r>
                  <a:endParaRPr kumimoji="0" lang="en-US" altLang="hu-HU" sz="14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1" name="Rectangle 227">
                  <a:extLst>
                    <a:ext uri="{FF2B5EF4-FFF2-40B4-BE49-F238E27FC236}">
                      <a16:creationId xmlns:a16="http://schemas.microsoft.com/office/drawing/2014/main" id="{FB937F06-6C0E-9E96-E00B-4FFD20041C5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943416" y="4926011"/>
                  <a:ext cx="239599" cy="2013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500</a:t>
                  </a:r>
                  <a:endParaRPr kumimoji="0" lang="en-US" altLang="hu-HU" sz="14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2" name="Rectangle 228">
                  <a:extLst>
                    <a:ext uri="{FF2B5EF4-FFF2-40B4-BE49-F238E27FC236}">
                      <a16:creationId xmlns:a16="http://schemas.microsoft.com/office/drawing/2014/main" id="{FB1F5367-AB63-1BAA-9406-866C6F58208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807016" y="4926009"/>
                  <a:ext cx="239599" cy="2013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750</a:t>
                  </a:r>
                  <a:endParaRPr kumimoji="0" lang="en-US" altLang="hu-HU" sz="14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3" name="Rectangle 229">
                  <a:extLst>
                    <a:ext uri="{FF2B5EF4-FFF2-40B4-BE49-F238E27FC236}">
                      <a16:creationId xmlns:a16="http://schemas.microsoft.com/office/drawing/2014/main" id="{8FC1BA1F-DCFA-D4A7-98E6-779642940B5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22809" y="4926009"/>
                  <a:ext cx="319465" cy="2013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1000</a:t>
                  </a:r>
                  <a:endParaRPr kumimoji="0" lang="en-US" altLang="hu-HU" sz="14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4" name="Rectangle 232">
                  <a:extLst>
                    <a:ext uri="{FF2B5EF4-FFF2-40B4-BE49-F238E27FC236}">
                      <a16:creationId xmlns:a16="http://schemas.microsoft.com/office/drawing/2014/main" id="{97865F0C-DA97-DDE8-0584-E8EAD8E68D9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24387" y="1401763"/>
                  <a:ext cx="3408359" cy="35234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hu-HU" altLang="hu-HU" sz="1400" b="1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Severe</a:t>
                  </a:r>
                  <a:r>
                    <a:rPr kumimoji="0" lang="hu-HU" altLang="hu-HU" sz="14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 COVID-19</a:t>
                  </a:r>
                  <a:endParaRPr kumimoji="0" lang="en-US" altLang="hu-HU" sz="11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</a:endParaRPr>
                </a:p>
              </p:txBody>
            </p:sp>
          </p:grpSp>
          <p:grpSp>
            <p:nvGrpSpPr>
              <p:cNvPr id="77" name="Csoportba foglalás 76">
                <a:extLst>
                  <a:ext uri="{FF2B5EF4-FFF2-40B4-BE49-F238E27FC236}">
                    <a16:creationId xmlns:a16="http://schemas.microsoft.com/office/drawing/2014/main" id="{7DE9B842-715F-98F5-912B-959DAD1F4160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4624204" y="1401766"/>
                <a:ext cx="3346795" cy="3360035"/>
                <a:chOff x="8473339" y="1401763"/>
                <a:chExt cx="3718661" cy="3733373"/>
              </a:xfrm>
            </p:grpSpPr>
            <p:sp>
              <p:nvSpPr>
                <p:cNvPr id="119" name="Oval 235">
                  <a:extLst>
                    <a:ext uri="{FF2B5EF4-FFF2-40B4-BE49-F238E27FC236}">
                      <a16:creationId xmlns:a16="http://schemas.microsoft.com/office/drawing/2014/main" id="{F1F0DEDE-0EF3-5BBB-5307-BE34C5D0DF5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128125" y="3211513"/>
                  <a:ext cx="61913" cy="65087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20" name="Oval 236">
                  <a:extLst>
                    <a:ext uri="{FF2B5EF4-FFF2-40B4-BE49-F238E27FC236}">
                      <a16:creationId xmlns:a16="http://schemas.microsoft.com/office/drawing/2014/main" id="{8E55CE54-C0B8-6BD1-C31D-C1C14F57F27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659938" y="2932113"/>
                  <a:ext cx="61913" cy="65087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21" name="Oval 237">
                  <a:extLst>
                    <a:ext uri="{FF2B5EF4-FFF2-40B4-BE49-F238E27FC236}">
                      <a16:creationId xmlns:a16="http://schemas.microsoft.com/office/drawing/2014/main" id="{D941B986-4871-DBEC-6C08-37EC6AD2565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347200" y="2811463"/>
                  <a:ext cx="61913" cy="65087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22" name="Oval 238">
                  <a:extLst>
                    <a:ext uri="{FF2B5EF4-FFF2-40B4-BE49-F238E27FC236}">
                      <a16:creationId xmlns:a16="http://schemas.microsoft.com/office/drawing/2014/main" id="{79363936-96AD-6BB3-1E0A-FEC5C3AB3CA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740900" y="2659063"/>
                  <a:ext cx="61913" cy="65087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23" name="Oval 239">
                  <a:extLst>
                    <a:ext uri="{FF2B5EF4-FFF2-40B4-BE49-F238E27FC236}">
                      <a16:creationId xmlns:a16="http://schemas.microsoft.com/office/drawing/2014/main" id="{08812FBB-971E-A0B3-036D-84FC01C150A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978900" y="1858963"/>
                  <a:ext cx="65088" cy="65087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24" name="Oval 240">
                  <a:extLst>
                    <a:ext uri="{FF2B5EF4-FFF2-40B4-BE49-F238E27FC236}">
                      <a16:creationId xmlns:a16="http://schemas.microsoft.com/office/drawing/2014/main" id="{F2B3D2EA-7ABF-45E2-9A9F-56A9DEF940B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953875" y="3363913"/>
                  <a:ext cx="65088" cy="63500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25" name="Oval 241">
                  <a:extLst>
                    <a:ext uri="{FF2B5EF4-FFF2-40B4-BE49-F238E27FC236}">
                      <a16:creationId xmlns:a16="http://schemas.microsoft.com/office/drawing/2014/main" id="{EA4FFC0C-5D13-9082-5BE6-22E0952BA9D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029700" y="3514725"/>
                  <a:ext cx="63500" cy="65087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26" name="Oval 242">
                  <a:extLst>
                    <a:ext uri="{FF2B5EF4-FFF2-40B4-BE49-F238E27FC236}">
                      <a16:creationId xmlns:a16="http://schemas.microsoft.com/office/drawing/2014/main" id="{656B693F-618B-350B-4258-17D3D45837E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355138" y="3319463"/>
                  <a:ext cx="65088" cy="61912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27" name="Oval 243">
                  <a:extLst>
                    <a:ext uri="{FF2B5EF4-FFF2-40B4-BE49-F238E27FC236}">
                      <a16:creationId xmlns:a16="http://schemas.microsoft.com/office/drawing/2014/main" id="{DF0350B4-16BD-52F1-5D66-D532CB04002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963275" y="4351338"/>
                  <a:ext cx="63500" cy="65087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28" name="Oval 244">
                  <a:extLst>
                    <a:ext uri="{FF2B5EF4-FFF2-40B4-BE49-F238E27FC236}">
                      <a16:creationId xmlns:a16="http://schemas.microsoft.com/office/drawing/2014/main" id="{EC6D297E-7430-8FE3-7D83-1F85E1D1DF9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009063" y="2982913"/>
                  <a:ext cx="63500" cy="63500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29" name="Oval 245">
                  <a:extLst>
                    <a:ext uri="{FF2B5EF4-FFF2-40B4-BE49-F238E27FC236}">
                      <a16:creationId xmlns:a16="http://schemas.microsoft.com/office/drawing/2014/main" id="{321297F1-92CD-43EA-720F-BAF475786A2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482138" y="2357438"/>
                  <a:ext cx="63500" cy="63500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30" name="Oval 246">
                  <a:extLst>
                    <a:ext uri="{FF2B5EF4-FFF2-40B4-BE49-F238E27FC236}">
                      <a16:creationId xmlns:a16="http://schemas.microsoft.com/office/drawing/2014/main" id="{3BA6ACDC-E59A-F811-A55B-40A9F4B2EF6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226550" y="3409950"/>
                  <a:ext cx="65088" cy="61912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31" name="Oval 247">
                  <a:extLst>
                    <a:ext uri="{FF2B5EF4-FFF2-40B4-BE49-F238E27FC236}">
                      <a16:creationId xmlns:a16="http://schemas.microsoft.com/office/drawing/2014/main" id="{983E0E5D-1F2C-08E0-E6A3-C2803909B84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048750" y="2157413"/>
                  <a:ext cx="63500" cy="65087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32" name="Oval 248">
                  <a:extLst>
                    <a:ext uri="{FF2B5EF4-FFF2-40B4-BE49-F238E27FC236}">
                      <a16:creationId xmlns:a16="http://schemas.microsoft.com/office/drawing/2014/main" id="{01E78405-8387-0483-515E-1C61F3B7F7D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467850" y="2846388"/>
                  <a:ext cx="61913" cy="61912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33" name="Oval 249">
                  <a:extLst>
                    <a:ext uri="{FF2B5EF4-FFF2-40B4-BE49-F238E27FC236}">
                      <a16:creationId xmlns:a16="http://schemas.microsoft.com/office/drawing/2014/main" id="{D900C890-6286-089D-D03B-4FC03321B42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813800" y="2676525"/>
                  <a:ext cx="65088" cy="63500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34" name="Oval 250">
                  <a:extLst>
                    <a:ext uri="{FF2B5EF4-FFF2-40B4-BE49-F238E27FC236}">
                      <a16:creationId xmlns:a16="http://schemas.microsoft.com/office/drawing/2014/main" id="{8B8C12A2-54FE-3369-90D6-1849BBC2E6F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969375" y="2811463"/>
                  <a:ext cx="63500" cy="65087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35" name="Freeform 251">
                  <a:extLst>
                    <a:ext uri="{FF2B5EF4-FFF2-40B4-BE49-F238E27FC236}">
                      <a16:creationId xmlns:a16="http://schemas.microsoft.com/office/drawing/2014/main" id="{F14791BB-E4F6-DCE3-3166-22B002AC38D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8845550" y="2736850"/>
                  <a:ext cx="3140075" cy="1127125"/>
                </a:xfrm>
                <a:custGeom>
                  <a:avLst/>
                  <a:gdLst>
                    <a:gd name="T0" fmla="*/ 25 w 1978"/>
                    <a:gd name="T1" fmla="*/ 8 h 710"/>
                    <a:gd name="T2" fmla="*/ 75 w 1978"/>
                    <a:gd name="T3" fmla="*/ 27 h 710"/>
                    <a:gd name="T4" fmla="*/ 125 w 1978"/>
                    <a:gd name="T5" fmla="*/ 44 h 710"/>
                    <a:gd name="T6" fmla="*/ 175 w 1978"/>
                    <a:gd name="T7" fmla="*/ 62 h 710"/>
                    <a:gd name="T8" fmla="*/ 225 w 1978"/>
                    <a:gd name="T9" fmla="*/ 80 h 710"/>
                    <a:gd name="T10" fmla="*/ 275 w 1978"/>
                    <a:gd name="T11" fmla="*/ 99 h 710"/>
                    <a:gd name="T12" fmla="*/ 326 w 1978"/>
                    <a:gd name="T13" fmla="*/ 116 h 710"/>
                    <a:gd name="T14" fmla="*/ 376 w 1978"/>
                    <a:gd name="T15" fmla="*/ 134 h 710"/>
                    <a:gd name="T16" fmla="*/ 426 w 1978"/>
                    <a:gd name="T17" fmla="*/ 153 h 710"/>
                    <a:gd name="T18" fmla="*/ 476 w 1978"/>
                    <a:gd name="T19" fmla="*/ 170 h 710"/>
                    <a:gd name="T20" fmla="*/ 526 w 1978"/>
                    <a:gd name="T21" fmla="*/ 188 h 710"/>
                    <a:gd name="T22" fmla="*/ 576 w 1978"/>
                    <a:gd name="T23" fmla="*/ 206 h 710"/>
                    <a:gd name="T24" fmla="*/ 626 w 1978"/>
                    <a:gd name="T25" fmla="*/ 225 h 710"/>
                    <a:gd name="T26" fmla="*/ 676 w 1978"/>
                    <a:gd name="T27" fmla="*/ 242 h 710"/>
                    <a:gd name="T28" fmla="*/ 727 w 1978"/>
                    <a:gd name="T29" fmla="*/ 260 h 710"/>
                    <a:gd name="T30" fmla="*/ 777 w 1978"/>
                    <a:gd name="T31" fmla="*/ 277 h 710"/>
                    <a:gd name="T32" fmla="*/ 827 w 1978"/>
                    <a:gd name="T33" fmla="*/ 296 h 710"/>
                    <a:gd name="T34" fmla="*/ 877 w 1978"/>
                    <a:gd name="T35" fmla="*/ 314 h 710"/>
                    <a:gd name="T36" fmla="*/ 927 w 1978"/>
                    <a:gd name="T37" fmla="*/ 332 h 710"/>
                    <a:gd name="T38" fmla="*/ 977 w 1978"/>
                    <a:gd name="T39" fmla="*/ 349 h 710"/>
                    <a:gd name="T40" fmla="*/ 1027 w 1978"/>
                    <a:gd name="T41" fmla="*/ 368 h 710"/>
                    <a:gd name="T42" fmla="*/ 1077 w 1978"/>
                    <a:gd name="T43" fmla="*/ 386 h 710"/>
                    <a:gd name="T44" fmla="*/ 1128 w 1978"/>
                    <a:gd name="T45" fmla="*/ 403 h 710"/>
                    <a:gd name="T46" fmla="*/ 1178 w 1978"/>
                    <a:gd name="T47" fmla="*/ 421 h 710"/>
                    <a:gd name="T48" fmla="*/ 1228 w 1978"/>
                    <a:gd name="T49" fmla="*/ 440 h 710"/>
                    <a:gd name="T50" fmla="*/ 1278 w 1978"/>
                    <a:gd name="T51" fmla="*/ 458 h 710"/>
                    <a:gd name="T52" fmla="*/ 1328 w 1978"/>
                    <a:gd name="T53" fmla="*/ 475 h 710"/>
                    <a:gd name="T54" fmla="*/ 1377 w 1978"/>
                    <a:gd name="T55" fmla="*/ 493 h 710"/>
                    <a:gd name="T56" fmla="*/ 1427 w 1978"/>
                    <a:gd name="T57" fmla="*/ 512 h 710"/>
                    <a:gd name="T58" fmla="*/ 1477 w 1978"/>
                    <a:gd name="T59" fmla="*/ 529 h 710"/>
                    <a:gd name="T60" fmla="*/ 1527 w 1978"/>
                    <a:gd name="T61" fmla="*/ 547 h 710"/>
                    <a:gd name="T62" fmla="*/ 1577 w 1978"/>
                    <a:gd name="T63" fmla="*/ 566 h 710"/>
                    <a:gd name="T64" fmla="*/ 1628 w 1978"/>
                    <a:gd name="T65" fmla="*/ 584 h 710"/>
                    <a:gd name="T66" fmla="*/ 1678 w 1978"/>
                    <a:gd name="T67" fmla="*/ 601 h 710"/>
                    <a:gd name="T68" fmla="*/ 1728 w 1978"/>
                    <a:gd name="T69" fmla="*/ 619 h 710"/>
                    <a:gd name="T70" fmla="*/ 1778 w 1978"/>
                    <a:gd name="T71" fmla="*/ 638 h 710"/>
                    <a:gd name="T72" fmla="*/ 1828 w 1978"/>
                    <a:gd name="T73" fmla="*/ 655 h 710"/>
                    <a:gd name="T74" fmla="*/ 1878 w 1978"/>
                    <a:gd name="T75" fmla="*/ 673 h 710"/>
                    <a:gd name="T76" fmla="*/ 1928 w 1978"/>
                    <a:gd name="T77" fmla="*/ 691 h 710"/>
                    <a:gd name="T78" fmla="*/ 1978 w 1978"/>
                    <a:gd name="T79" fmla="*/ 710 h 71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</a:cxnLst>
                  <a:rect l="0" t="0" r="r" b="b"/>
                  <a:pathLst>
                    <a:path w="1978" h="710">
                      <a:moveTo>
                        <a:pt x="0" y="0"/>
                      </a:moveTo>
                      <a:lnTo>
                        <a:pt x="25" y="8"/>
                      </a:lnTo>
                      <a:lnTo>
                        <a:pt x="51" y="17"/>
                      </a:lnTo>
                      <a:lnTo>
                        <a:pt x="75" y="27"/>
                      </a:lnTo>
                      <a:lnTo>
                        <a:pt x="101" y="35"/>
                      </a:lnTo>
                      <a:lnTo>
                        <a:pt x="125" y="44"/>
                      </a:lnTo>
                      <a:lnTo>
                        <a:pt x="151" y="54"/>
                      </a:lnTo>
                      <a:lnTo>
                        <a:pt x="175" y="62"/>
                      </a:lnTo>
                      <a:lnTo>
                        <a:pt x="201" y="71"/>
                      </a:lnTo>
                      <a:lnTo>
                        <a:pt x="225" y="80"/>
                      </a:lnTo>
                      <a:lnTo>
                        <a:pt x="251" y="89"/>
                      </a:lnTo>
                      <a:lnTo>
                        <a:pt x="275" y="99"/>
                      </a:lnTo>
                      <a:lnTo>
                        <a:pt x="301" y="107"/>
                      </a:lnTo>
                      <a:lnTo>
                        <a:pt x="326" y="116"/>
                      </a:lnTo>
                      <a:lnTo>
                        <a:pt x="351" y="126"/>
                      </a:lnTo>
                      <a:lnTo>
                        <a:pt x="376" y="134"/>
                      </a:lnTo>
                      <a:lnTo>
                        <a:pt x="401" y="143"/>
                      </a:lnTo>
                      <a:lnTo>
                        <a:pt x="426" y="153"/>
                      </a:lnTo>
                      <a:lnTo>
                        <a:pt x="452" y="161"/>
                      </a:lnTo>
                      <a:lnTo>
                        <a:pt x="476" y="170"/>
                      </a:lnTo>
                      <a:lnTo>
                        <a:pt x="500" y="178"/>
                      </a:lnTo>
                      <a:lnTo>
                        <a:pt x="526" y="188"/>
                      </a:lnTo>
                      <a:lnTo>
                        <a:pt x="550" y="197"/>
                      </a:lnTo>
                      <a:lnTo>
                        <a:pt x="576" y="206"/>
                      </a:lnTo>
                      <a:lnTo>
                        <a:pt x="601" y="215"/>
                      </a:lnTo>
                      <a:lnTo>
                        <a:pt x="626" y="225"/>
                      </a:lnTo>
                      <a:lnTo>
                        <a:pt x="651" y="233"/>
                      </a:lnTo>
                      <a:lnTo>
                        <a:pt x="676" y="242"/>
                      </a:lnTo>
                      <a:lnTo>
                        <a:pt x="701" y="250"/>
                      </a:lnTo>
                      <a:lnTo>
                        <a:pt x="727" y="260"/>
                      </a:lnTo>
                      <a:lnTo>
                        <a:pt x="751" y="269"/>
                      </a:lnTo>
                      <a:lnTo>
                        <a:pt x="777" y="277"/>
                      </a:lnTo>
                      <a:lnTo>
                        <a:pt x="801" y="287"/>
                      </a:lnTo>
                      <a:lnTo>
                        <a:pt x="827" y="296"/>
                      </a:lnTo>
                      <a:lnTo>
                        <a:pt x="851" y="304"/>
                      </a:lnTo>
                      <a:lnTo>
                        <a:pt x="877" y="314"/>
                      </a:lnTo>
                      <a:lnTo>
                        <a:pt x="901" y="323"/>
                      </a:lnTo>
                      <a:lnTo>
                        <a:pt x="927" y="332"/>
                      </a:lnTo>
                      <a:lnTo>
                        <a:pt x="951" y="341"/>
                      </a:lnTo>
                      <a:lnTo>
                        <a:pt x="977" y="349"/>
                      </a:lnTo>
                      <a:lnTo>
                        <a:pt x="1002" y="359"/>
                      </a:lnTo>
                      <a:lnTo>
                        <a:pt x="1027" y="368"/>
                      </a:lnTo>
                      <a:lnTo>
                        <a:pt x="1052" y="376"/>
                      </a:lnTo>
                      <a:lnTo>
                        <a:pt x="1077" y="386"/>
                      </a:lnTo>
                      <a:lnTo>
                        <a:pt x="1102" y="395"/>
                      </a:lnTo>
                      <a:lnTo>
                        <a:pt x="1128" y="403"/>
                      </a:lnTo>
                      <a:lnTo>
                        <a:pt x="1152" y="413"/>
                      </a:lnTo>
                      <a:lnTo>
                        <a:pt x="1178" y="421"/>
                      </a:lnTo>
                      <a:lnTo>
                        <a:pt x="1202" y="430"/>
                      </a:lnTo>
                      <a:lnTo>
                        <a:pt x="1228" y="440"/>
                      </a:lnTo>
                      <a:lnTo>
                        <a:pt x="1252" y="448"/>
                      </a:lnTo>
                      <a:lnTo>
                        <a:pt x="1278" y="458"/>
                      </a:lnTo>
                      <a:lnTo>
                        <a:pt x="1302" y="467"/>
                      </a:lnTo>
                      <a:lnTo>
                        <a:pt x="1328" y="475"/>
                      </a:lnTo>
                      <a:lnTo>
                        <a:pt x="1352" y="485"/>
                      </a:lnTo>
                      <a:lnTo>
                        <a:pt x="1377" y="493"/>
                      </a:lnTo>
                      <a:lnTo>
                        <a:pt x="1403" y="502"/>
                      </a:lnTo>
                      <a:lnTo>
                        <a:pt x="1427" y="512"/>
                      </a:lnTo>
                      <a:lnTo>
                        <a:pt x="1453" y="520"/>
                      </a:lnTo>
                      <a:lnTo>
                        <a:pt x="1477" y="529"/>
                      </a:lnTo>
                      <a:lnTo>
                        <a:pt x="1503" y="539"/>
                      </a:lnTo>
                      <a:lnTo>
                        <a:pt x="1527" y="547"/>
                      </a:lnTo>
                      <a:lnTo>
                        <a:pt x="1553" y="556"/>
                      </a:lnTo>
                      <a:lnTo>
                        <a:pt x="1577" y="566"/>
                      </a:lnTo>
                      <a:lnTo>
                        <a:pt x="1603" y="574"/>
                      </a:lnTo>
                      <a:lnTo>
                        <a:pt x="1628" y="584"/>
                      </a:lnTo>
                      <a:lnTo>
                        <a:pt x="1653" y="592"/>
                      </a:lnTo>
                      <a:lnTo>
                        <a:pt x="1678" y="601"/>
                      </a:lnTo>
                      <a:lnTo>
                        <a:pt x="1703" y="611"/>
                      </a:lnTo>
                      <a:lnTo>
                        <a:pt x="1728" y="619"/>
                      </a:lnTo>
                      <a:lnTo>
                        <a:pt x="1754" y="628"/>
                      </a:lnTo>
                      <a:lnTo>
                        <a:pt x="1778" y="638"/>
                      </a:lnTo>
                      <a:lnTo>
                        <a:pt x="1804" y="646"/>
                      </a:lnTo>
                      <a:lnTo>
                        <a:pt x="1828" y="655"/>
                      </a:lnTo>
                      <a:lnTo>
                        <a:pt x="1854" y="663"/>
                      </a:lnTo>
                      <a:lnTo>
                        <a:pt x="1878" y="673"/>
                      </a:lnTo>
                      <a:lnTo>
                        <a:pt x="1904" y="682"/>
                      </a:lnTo>
                      <a:lnTo>
                        <a:pt x="1928" y="691"/>
                      </a:lnTo>
                      <a:lnTo>
                        <a:pt x="1954" y="700"/>
                      </a:lnTo>
                      <a:lnTo>
                        <a:pt x="1978" y="710"/>
                      </a:lnTo>
                    </a:path>
                  </a:pathLst>
                </a:custGeom>
                <a:noFill/>
                <a:ln w="365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36" name="Freeform 252">
                  <a:extLst>
                    <a:ext uri="{FF2B5EF4-FFF2-40B4-BE49-F238E27FC236}">
                      <a16:creationId xmlns:a16="http://schemas.microsoft.com/office/drawing/2014/main" id="{91D599AE-A878-FC75-E2A9-3CD21134EA5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8845550" y="2357438"/>
                  <a:ext cx="3140075" cy="2419350"/>
                </a:xfrm>
                <a:custGeom>
                  <a:avLst/>
                  <a:gdLst>
                    <a:gd name="T0" fmla="*/ 51 w 1978"/>
                    <a:gd name="T1" fmla="*/ 30 h 1524"/>
                    <a:gd name="T2" fmla="*/ 125 w 1978"/>
                    <a:gd name="T3" fmla="*/ 72 h 1524"/>
                    <a:gd name="T4" fmla="*/ 201 w 1978"/>
                    <a:gd name="T5" fmla="*/ 111 h 1524"/>
                    <a:gd name="T6" fmla="*/ 275 w 1978"/>
                    <a:gd name="T7" fmla="*/ 149 h 1524"/>
                    <a:gd name="T8" fmla="*/ 351 w 1978"/>
                    <a:gd name="T9" fmla="*/ 182 h 1524"/>
                    <a:gd name="T10" fmla="*/ 426 w 1978"/>
                    <a:gd name="T11" fmla="*/ 212 h 1524"/>
                    <a:gd name="T12" fmla="*/ 500 w 1978"/>
                    <a:gd name="T13" fmla="*/ 237 h 1524"/>
                    <a:gd name="T14" fmla="*/ 576 w 1978"/>
                    <a:gd name="T15" fmla="*/ 259 h 1524"/>
                    <a:gd name="T16" fmla="*/ 651 w 1978"/>
                    <a:gd name="T17" fmla="*/ 278 h 1524"/>
                    <a:gd name="T18" fmla="*/ 727 w 1978"/>
                    <a:gd name="T19" fmla="*/ 293 h 1524"/>
                    <a:gd name="T20" fmla="*/ 801 w 1978"/>
                    <a:gd name="T21" fmla="*/ 305 h 1524"/>
                    <a:gd name="T22" fmla="*/ 877 w 1978"/>
                    <a:gd name="T23" fmla="*/ 316 h 1524"/>
                    <a:gd name="T24" fmla="*/ 951 w 1978"/>
                    <a:gd name="T25" fmla="*/ 324 h 1524"/>
                    <a:gd name="T26" fmla="*/ 1027 w 1978"/>
                    <a:gd name="T27" fmla="*/ 331 h 1524"/>
                    <a:gd name="T28" fmla="*/ 1102 w 1978"/>
                    <a:gd name="T29" fmla="*/ 338 h 1524"/>
                    <a:gd name="T30" fmla="*/ 1178 w 1978"/>
                    <a:gd name="T31" fmla="*/ 343 h 1524"/>
                    <a:gd name="T32" fmla="*/ 1252 w 1978"/>
                    <a:gd name="T33" fmla="*/ 347 h 1524"/>
                    <a:gd name="T34" fmla="*/ 1328 w 1978"/>
                    <a:gd name="T35" fmla="*/ 351 h 1524"/>
                    <a:gd name="T36" fmla="*/ 1403 w 1978"/>
                    <a:gd name="T37" fmla="*/ 354 h 1524"/>
                    <a:gd name="T38" fmla="*/ 1477 w 1978"/>
                    <a:gd name="T39" fmla="*/ 358 h 1524"/>
                    <a:gd name="T40" fmla="*/ 1553 w 1978"/>
                    <a:gd name="T41" fmla="*/ 361 h 1524"/>
                    <a:gd name="T42" fmla="*/ 1628 w 1978"/>
                    <a:gd name="T43" fmla="*/ 362 h 1524"/>
                    <a:gd name="T44" fmla="*/ 1703 w 1978"/>
                    <a:gd name="T45" fmla="*/ 365 h 1524"/>
                    <a:gd name="T46" fmla="*/ 1778 w 1978"/>
                    <a:gd name="T47" fmla="*/ 366 h 1524"/>
                    <a:gd name="T48" fmla="*/ 1854 w 1978"/>
                    <a:gd name="T49" fmla="*/ 369 h 1524"/>
                    <a:gd name="T50" fmla="*/ 1928 w 1978"/>
                    <a:gd name="T51" fmla="*/ 370 h 1524"/>
                    <a:gd name="T52" fmla="*/ 1978 w 1978"/>
                    <a:gd name="T53" fmla="*/ 1524 h 1524"/>
                    <a:gd name="T54" fmla="*/ 1904 w 1978"/>
                    <a:gd name="T55" fmla="*/ 1473 h 1524"/>
                    <a:gd name="T56" fmla="*/ 1828 w 1978"/>
                    <a:gd name="T57" fmla="*/ 1420 h 1524"/>
                    <a:gd name="T58" fmla="*/ 1754 w 1978"/>
                    <a:gd name="T59" fmla="*/ 1369 h 1524"/>
                    <a:gd name="T60" fmla="*/ 1678 w 1978"/>
                    <a:gd name="T61" fmla="*/ 1317 h 1524"/>
                    <a:gd name="T62" fmla="*/ 1603 w 1978"/>
                    <a:gd name="T63" fmla="*/ 1266 h 1524"/>
                    <a:gd name="T64" fmla="*/ 1527 w 1978"/>
                    <a:gd name="T65" fmla="*/ 1214 h 1524"/>
                    <a:gd name="T66" fmla="*/ 1453 w 1978"/>
                    <a:gd name="T67" fmla="*/ 1163 h 1524"/>
                    <a:gd name="T68" fmla="*/ 1377 w 1978"/>
                    <a:gd name="T69" fmla="*/ 1111 h 1524"/>
                    <a:gd name="T70" fmla="*/ 1302 w 1978"/>
                    <a:gd name="T71" fmla="*/ 1061 h 1524"/>
                    <a:gd name="T72" fmla="*/ 1228 w 1978"/>
                    <a:gd name="T73" fmla="*/ 1012 h 1524"/>
                    <a:gd name="T74" fmla="*/ 1152 w 1978"/>
                    <a:gd name="T75" fmla="*/ 962 h 1524"/>
                    <a:gd name="T76" fmla="*/ 1077 w 1978"/>
                    <a:gd name="T77" fmla="*/ 915 h 1524"/>
                    <a:gd name="T78" fmla="*/ 1002 w 1978"/>
                    <a:gd name="T79" fmla="*/ 866 h 1524"/>
                    <a:gd name="T80" fmla="*/ 927 w 1978"/>
                    <a:gd name="T81" fmla="*/ 820 h 1524"/>
                    <a:gd name="T82" fmla="*/ 851 w 1978"/>
                    <a:gd name="T83" fmla="*/ 775 h 1524"/>
                    <a:gd name="T84" fmla="*/ 777 w 1978"/>
                    <a:gd name="T85" fmla="*/ 733 h 1524"/>
                    <a:gd name="T86" fmla="*/ 701 w 1978"/>
                    <a:gd name="T87" fmla="*/ 692 h 1524"/>
                    <a:gd name="T88" fmla="*/ 626 w 1978"/>
                    <a:gd name="T89" fmla="*/ 655 h 1524"/>
                    <a:gd name="T90" fmla="*/ 550 w 1978"/>
                    <a:gd name="T91" fmla="*/ 619 h 1524"/>
                    <a:gd name="T92" fmla="*/ 476 w 1978"/>
                    <a:gd name="T93" fmla="*/ 588 h 1524"/>
                    <a:gd name="T94" fmla="*/ 401 w 1978"/>
                    <a:gd name="T95" fmla="*/ 562 h 1524"/>
                    <a:gd name="T96" fmla="*/ 326 w 1978"/>
                    <a:gd name="T97" fmla="*/ 539 h 1524"/>
                    <a:gd name="T98" fmla="*/ 251 w 1978"/>
                    <a:gd name="T99" fmla="*/ 519 h 1524"/>
                    <a:gd name="T100" fmla="*/ 175 w 1978"/>
                    <a:gd name="T101" fmla="*/ 504 h 1524"/>
                    <a:gd name="T102" fmla="*/ 101 w 1978"/>
                    <a:gd name="T103" fmla="*/ 491 h 1524"/>
                    <a:gd name="T104" fmla="*/ 25 w 1978"/>
                    <a:gd name="T105" fmla="*/ 480 h 152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</a:cxnLst>
                  <a:rect l="0" t="0" r="r" b="b"/>
                  <a:pathLst>
                    <a:path w="1978" h="1524">
                      <a:moveTo>
                        <a:pt x="0" y="0"/>
                      </a:moveTo>
                      <a:lnTo>
                        <a:pt x="25" y="15"/>
                      </a:lnTo>
                      <a:lnTo>
                        <a:pt x="51" y="30"/>
                      </a:lnTo>
                      <a:lnTo>
                        <a:pt x="75" y="44"/>
                      </a:lnTo>
                      <a:lnTo>
                        <a:pt x="101" y="58"/>
                      </a:lnTo>
                      <a:lnTo>
                        <a:pt x="125" y="72"/>
                      </a:lnTo>
                      <a:lnTo>
                        <a:pt x="151" y="86"/>
                      </a:lnTo>
                      <a:lnTo>
                        <a:pt x="175" y="99"/>
                      </a:lnTo>
                      <a:lnTo>
                        <a:pt x="201" y="111"/>
                      </a:lnTo>
                      <a:lnTo>
                        <a:pt x="225" y="125"/>
                      </a:lnTo>
                      <a:lnTo>
                        <a:pt x="251" y="137"/>
                      </a:lnTo>
                      <a:lnTo>
                        <a:pt x="275" y="149"/>
                      </a:lnTo>
                      <a:lnTo>
                        <a:pt x="301" y="160"/>
                      </a:lnTo>
                      <a:lnTo>
                        <a:pt x="326" y="171"/>
                      </a:lnTo>
                      <a:lnTo>
                        <a:pt x="351" y="182"/>
                      </a:lnTo>
                      <a:lnTo>
                        <a:pt x="376" y="193"/>
                      </a:lnTo>
                      <a:lnTo>
                        <a:pt x="401" y="202"/>
                      </a:lnTo>
                      <a:lnTo>
                        <a:pt x="426" y="212"/>
                      </a:lnTo>
                      <a:lnTo>
                        <a:pt x="452" y="221"/>
                      </a:lnTo>
                      <a:lnTo>
                        <a:pt x="476" y="229"/>
                      </a:lnTo>
                      <a:lnTo>
                        <a:pt x="500" y="237"/>
                      </a:lnTo>
                      <a:lnTo>
                        <a:pt x="526" y="245"/>
                      </a:lnTo>
                      <a:lnTo>
                        <a:pt x="550" y="252"/>
                      </a:lnTo>
                      <a:lnTo>
                        <a:pt x="576" y="259"/>
                      </a:lnTo>
                      <a:lnTo>
                        <a:pt x="601" y="266"/>
                      </a:lnTo>
                      <a:lnTo>
                        <a:pt x="626" y="271"/>
                      </a:lnTo>
                      <a:lnTo>
                        <a:pt x="651" y="278"/>
                      </a:lnTo>
                      <a:lnTo>
                        <a:pt x="676" y="283"/>
                      </a:lnTo>
                      <a:lnTo>
                        <a:pt x="701" y="287"/>
                      </a:lnTo>
                      <a:lnTo>
                        <a:pt x="727" y="293"/>
                      </a:lnTo>
                      <a:lnTo>
                        <a:pt x="751" y="297"/>
                      </a:lnTo>
                      <a:lnTo>
                        <a:pt x="777" y="301"/>
                      </a:lnTo>
                      <a:lnTo>
                        <a:pt x="801" y="305"/>
                      </a:lnTo>
                      <a:lnTo>
                        <a:pt x="827" y="309"/>
                      </a:lnTo>
                      <a:lnTo>
                        <a:pt x="851" y="312"/>
                      </a:lnTo>
                      <a:lnTo>
                        <a:pt x="877" y="316"/>
                      </a:lnTo>
                      <a:lnTo>
                        <a:pt x="901" y="319"/>
                      </a:lnTo>
                      <a:lnTo>
                        <a:pt x="927" y="321"/>
                      </a:lnTo>
                      <a:lnTo>
                        <a:pt x="951" y="324"/>
                      </a:lnTo>
                      <a:lnTo>
                        <a:pt x="977" y="327"/>
                      </a:lnTo>
                      <a:lnTo>
                        <a:pt x="1002" y="329"/>
                      </a:lnTo>
                      <a:lnTo>
                        <a:pt x="1027" y="331"/>
                      </a:lnTo>
                      <a:lnTo>
                        <a:pt x="1052" y="333"/>
                      </a:lnTo>
                      <a:lnTo>
                        <a:pt x="1077" y="335"/>
                      </a:lnTo>
                      <a:lnTo>
                        <a:pt x="1102" y="338"/>
                      </a:lnTo>
                      <a:lnTo>
                        <a:pt x="1128" y="339"/>
                      </a:lnTo>
                      <a:lnTo>
                        <a:pt x="1152" y="340"/>
                      </a:lnTo>
                      <a:lnTo>
                        <a:pt x="1178" y="343"/>
                      </a:lnTo>
                      <a:lnTo>
                        <a:pt x="1202" y="344"/>
                      </a:lnTo>
                      <a:lnTo>
                        <a:pt x="1228" y="346"/>
                      </a:lnTo>
                      <a:lnTo>
                        <a:pt x="1252" y="347"/>
                      </a:lnTo>
                      <a:lnTo>
                        <a:pt x="1278" y="348"/>
                      </a:lnTo>
                      <a:lnTo>
                        <a:pt x="1302" y="350"/>
                      </a:lnTo>
                      <a:lnTo>
                        <a:pt x="1328" y="351"/>
                      </a:lnTo>
                      <a:lnTo>
                        <a:pt x="1352" y="352"/>
                      </a:lnTo>
                      <a:lnTo>
                        <a:pt x="1377" y="354"/>
                      </a:lnTo>
                      <a:lnTo>
                        <a:pt x="1403" y="354"/>
                      </a:lnTo>
                      <a:lnTo>
                        <a:pt x="1427" y="355"/>
                      </a:lnTo>
                      <a:lnTo>
                        <a:pt x="1453" y="357"/>
                      </a:lnTo>
                      <a:lnTo>
                        <a:pt x="1477" y="358"/>
                      </a:lnTo>
                      <a:lnTo>
                        <a:pt x="1503" y="358"/>
                      </a:lnTo>
                      <a:lnTo>
                        <a:pt x="1527" y="359"/>
                      </a:lnTo>
                      <a:lnTo>
                        <a:pt x="1553" y="361"/>
                      </a:lnTo>
                      <a:lnTo>
                        <a:pt x="1577" y="361"/>
                      </a:lnTo>
                      <a:lnTo>
                        <a:pt x="1603" y="362"/>
                      </a:lnTo>
                      <a:lnTo>
                        <a:pt x="1628" y="362"/>
                      </a:lnTo>
                      <a:lnTo>
                        <a:pt x="1653" y="363"/>
                      </a:lnTo>
                      <a:lnTo>
                        <a:pt x="1678" y="363"/>
                      </a:lnTo>
                      <a:lnTo>
                        <a:pt x="1703" y="365"/>
                      </a:lnTo>
                      <a:lnTo>
                        <a:pt x="1728" y="365"/>
                      </a:lnTo>
                      <a:lnTo>
                        <a:pt x="1754" y="366"/>
                      </a:lnTo>
                      <a:lnTo>
                        <a:pt x="1778" y="366"/>
                      </a:lnTo>
                      <a:lnTo>
                        <a:pt x="1804" y="367"/>
                      </a:lnTo>
                      <a:lnTo>
                        <a:pt x="1828" y="367"/>
                      </a:lnTo>
                      <a:lnTo>
                        <a:pt x="1854" y="369"/>
                      </a:lnTo>
                      <a:lnTo>
                        <a:pt x="1878" y="369"/>
                      </a:lnTo>
                      <a:lnTo>
                        <a:pt x="1904" y="370"/>
                      </a:lnTo>
                      <a:lnTo>
                        <a:pt x="1928" y="370"/>
                      </a:lnTo>
                      <a:lnTo>
                        <a:pt x="1954" y="370"/>
                      </a:lnTo>
                      <a:lnTo>
                        <a:pt x="1978" y="371"/>
                      </a:lnTo>
                      <a:lnTo>
                        <a:pt x="1978" y="1524"/>
                      </a:lnTo>
                      <a:lnTo>
                        <a:pt x="1954" y="1508"/>
                      </a:lnTo>
                      <a:lnTo>
                        <a:pt x="1928" y="1490"/>
                      </a:lnTo>
                      <a:lnTo>
                        <a:pt x="1904" y="1473"/>
                      </a:lnTo>
                      <a:lnTo>
                        <a:pt x="1878" y="1455"/>
                      </a:lnTo>
                      <a:lnTo>
                        <a:pt x="1854" y="1438"/>
                      </a:lnTo>
                      <a:lnTo>
                        <a:pt x="1828" y="1420"/>
                      </a:lnTo>
                      <a:lnTo>
                        <a:pt x="1804" y="1404"/>
                      </a:lnTo>
                      <a:lnTo>
                        <a:pt x="1778" y="1386"/>
                      </a:lnTo>
                      <a:lnTo>
                        <a:pt x="1754" y="1369"/>
                      </a:lnTo>
                      <a:lnTo>
                        <a:pt x="1728" y="1351"/>
                      </a:lnTo>
                      <a:lnTo>
                        <a:pt x="1703" y="1333"/>
                      </a:lnTo>
                      <a:lnTo>
                        <a:pt x="1678" y="1317"/>
                      </a:lnTo>
                      <a:lnTo>
                        <a:pt x="1653" y="1299"/>
                      </a:lnTo>
                      <a:lnTo>
                        <a:pt x="1628" y="1282"/>
                      </a:lnTo>
                      <a:lnTo>
                        <a:pt x="1603" y="1266"/>
                      </a:lnTo>
                      <a:lnTo>
                        <a:pt x="1577" y="1248"/>
                      </a:lnTo>
                      <a:lnTo>
                        <a:pt x="1553" y="1230"/>
                      </a:lnTo>
                      <a:lnTo>
                        <a:pt x="1527" y="1214"/>
                      </a:lnTo>
                      <a:lnTo>
                        <a:pt x="1503" y="1196"/>
                      </a:lnTo>
                      <a:lnTo>
                        <a:pt x="1477" y="1179"/>
                      </a:lnTo>
                      <a:lnTo>
                        <a:pt x="1453" y="1163"/>
                      </a:lnTo>
                      <a:lnTo>
                        <a:pt x="1427" y="1145"/>
                      </a:lnTo>
                      <a:lnTo>
                        <a:pt x="1403" y="1129"/>
                      </a:lnTo>
                      <a:lnTo>
                        <a:pt x="1377" y="1111"/>
                      </a:lnTo>
                      <a:lnTo>
                        <a:pt x="1352" y="1095"/>
                      </a:lnTo>
                      <a:lnTo>
                        <a:pt x="1328" y="1079"/>
                      </a:lnTo>
                      <a:lnTo>
                        <a:pt x="1302" y="1061"/>
                      </a:lnTo>
                      <a:lnTo>
                        <a:pt x="1278" y="1045"/>
                      </a:lnTo>
                      <a:lnTo>
                        <a:pt x="1252" y="1028"/>
                      </a:lnTo>
                      <a:lnTo>
                        <a:pt x="1228" y="1012"/>
                      </a:lnTo>
                      <a:lnTo>
                        <a:pt x="1202" y="995"/>
                      </a:lnTo>
                      <a:lnTo>
                        <a:pt x="1178" y="978"/>
                      </a:lnTo>
                      <a:lnTo>
                        <a:pt x="1152" y="962"/>
                      </a:lnTo>
                      <a:lnTo>
                        <a:pt x="1128" y="946"/>
                      </a:lnTo>
                      <a:lnTo>
                        <a:pt x="1102" y="930"/>
                      </a:lnTo>
                      <a:lnTo>
                        <a:pt x="1077" y="915"/>
                      </a:lnTo>
                      <a:lnTo>
                        <a:pt x="1052" y="898"/>
                      </a:lnTo>
                      <a:lnTo>
                        <a:pt x="1027" y="882"/>
                      </a:lnTo>
                      <a:lnTo>
                        <a:pt x="1002" y="866"/>
                      </a:lnTo>
                      <a:lnTo>
                        <a:pt x="977" y="851"/>
                      </a:lnTo>
                      <a:lnTo>
                        <a:pt x="951" y="836"/>
                      </a:lnTo>
                      <a:lnTo>
                        <a:pt x="927" y="820"/>
                      </a:lnTo>
                      <a:lnTo>
                        <a:pt x="901" y="805"/>
                      </a:lnTo>
                      <a:lnTo>
                        <a:pt x="877" y="790"/>
                      </a:lnTo>
                      <a:lnTo>
                        <a:pt x="851" y="775"/>
                      </a:lnTo>
                      <a:lnTo>
                        <a:pt x="827" y="762"/>
                      </a:lnTo>
                      <a:lnTo>
                        <a:pt x="801" y="747"/>
                      </a:lnTo>
                      <a:lnTo>
                        <a:pt x="777" y="733"/>
                      </a:lnTo>
                      <a:lnTo>
                        <a:pt x="751" y="718"/>
                      </a:lnTo>
                      <a:lnTo>
                        <a:pt x="727" y="705"/>
                      </a:lnTo>
                      <a:lnTo>
                        <a:pt x="701" y="692"/>
                      </a:lnTo>
                      <a:lnTo>
                        <a:pt x="676" y="679"/>
                      </a:lnTo>
                      <a:lnTo>
                        <a:pt x="651" y="667"/>
                      </a:lnTo>
                      <a:lnTo>
                        <a:pt x="626" y="655"/>
                      </a:lnTo>
                      <a:lnTo>
                        <a:pt x="601" y="642"/>
                      </a:lnTo>
                      <a:lnTo>
                        <a:pt x="576" y="630"/>
                      </a:lnTo>
                      <a:lnTo>
                        <a:pt x="550" y="619"/>
                      </a:lnTo>
                      <a:lnTo>
                        <a:pt x="526" y="608"/>
                      </a:lnTo>
                      <a:lnTo>
                        <a:pt x="500" y="599"/>
                      </a:lnTo>
                      <a:lnTo>
                        <a:pt x="476" y="588"/>
                      </a:lnTo>
                      <a:lnTo>
                        <a:pt x="452" y="579"/>
                      </a:lnTo>
                      <a:lnTo>
                        <a:pt x="426" y="571"/>
                      </a:lnTo>
                      <a:lnTo>
                        <a:pt x="401" y="562"/>
                      </a:lnTo>
                      <a:lnTo>
                        <a:pt x="376" y="554"/>
                      </a:lnTo>
                      <a:lnTo>
                        <a:pt x="351" y="546"/>
                      </a:lnTo>
                      <a:lnTo>
                        <a:pt x="326" y="539"/>
                      </a:lnTo>
                      <a:lnTo>
                        <a:pt x="301" y="533"/>
                      </a:lnTo>
                      <a:lnTo>
                        <a:pt x="275" y="526"/>
                      </a:lnTo>
                      <a:lnTo>
                        <a:pt x="251" y="519"/>
                      </a:lnTo>
                      <a:lnTo>
                        <a:pt x="225" y="514"/>
                      </a:lnTo>
                      <a:lnTo>
                        <a:pt x="201" y="508"/>
                      </a:lnTo>
                      <a:lnTo>
                        <a:pt x="175" y="504"/>
                      </a:lnTo>
                      <a:lnTo>
                        <a:pt x="151" y="499"/>
                      </a:lnTo>
                      <a:lnTo>
                        <a:pt x="125" y="495"/>
                      </a:lnTo>
                      <a:lnTo>
                        <a:pt x="101" y="491"/>
                      </a:lnTo>
                      <a:lnTo>
                        <a:pt x="75" y="487"/>
                      </a:lnTo>
                      <a:lnTo>
                        <a:pt x="51" y="483"/>
                      </a:lnTo>
                      <a:lnTo>
                        <a:pt x="25" y="480"/>
                      </a:lnTo>
                      <a:lnTo>
                        <a:pt x="0" y="476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37" name="Freeform 253">
                  <a:extLst>
                    <a:ext uri="{FF2B5EF4-FFF2-40B4-BE49-F238E27FC236}">
                      <a16:creationId xmlns:a16="http://schemas.microsoft.com/office/drawing/2014/main" id="{E730C42D-DF4F-FC64-A27E-C6FD52FA7DC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8845550" y="2357438"/>
                  <a:ext cx="3140075" cy="588962"/>
                </a:xfrm>
                <a:custGeom>
                  <a:avLst/>
                  <a:gdLst>
                    <a:gd name="T0" fmla="*/ 25 w 1978"/>
                    <a:gd name="T1" fmla="*/ 15 h 371"/>
                    <a:gd name="T2" fmla="*/ 75 w 1978"/>
                    <a:gd name="T3" fmla="*/ 44 h 371"/>
                    <a:gd name="T4" fmla="*/ 125 w 1978"/>
                    <a:gd name="T5" fmla="*/ 72 h 371"/>
                    <a:gd name="T6" fmla="*/ 175 w 1978"/>
                    <a:gd name="T7" fmla="*/ 99 h 371"/>
                    <a:gd name="T8" fmla="*/ 225 w 1978"/>
                    <a:gd name="T9" fmla="*/ 125 h 371"/>
                    <a:gd name="T10" fmla="*/ 275 w 1978"/>
                    <a:gd name="T11" fmla="*/ 149 h 371"/>
                    <a:gd name="T12" fmla="*/ 326 w 1978"/>
                    <a:gd name="T13" fmla="*/ 171 h 371"/>
                    <a:gd name="T14" fmla="*/ 376 w 1978"/>
                    <a:gd name="T15" fmla="*/ 193 h 371"/>
                    <a:gd name="T16" fmla="*/ 426 w 1978"/>
                    <a:gd name="T17" fmla="*/ 212 h 371"/>
                    <a:gd name="T18" fmla="*/ 476 w 1978"/>
                    <a:gd name="T19" fmla="*/ 229 h 371"/>
                    <a:gd name="T20" fmla="*/ 526 w 1978"/>
                    <a:gd name="T21" fmla="*/ 245 h 371"/>
                    <a:gd name="T22" fmla="*/ 576 w 1978"/>
                    <a:gd name="T23" fmla="*/ 259 h 371"/>
                    <a:gd name="T24" fmla="*/ 626 w 1978"/>
                    <a:gd name="T25" fmla="*/ 271 h 371"/>
                    <a:gd name="T26" fmla="*/ 676 w 1978"/>
                    <a:gd name="T27" fmla="*/ 283 h 371"/>
                    <a:gd name="T28" fmla="*/ 727 w 1978"/>
                    <a:gd name="T29" fmla="*/ 293 h 371"/>
                    <a:gd name="T30" fmla="*/ 777 w 1978"/>
                    <a:gd name="T31" fmla="*/ 301 h 371"/>
                    <a:gd name="T32" fmla="*/ 827 w 1978"/>
                    <a:gd name="T33" fmla="*/ 309 h 371"/>
                    <a:gd name="T34" fmla="*/ 877 w 1978"/>
                    <a:gd name="T35" fmla="*/ 316 h 371"/>
                    <a:gd name="T36" fmla="*/ 927 w 1978"/>
                    <a:gd name="T37" fmla="*/ 321 h 371"/>
                    <a:gd name="T38" fmla="*/ 977 w 1978"/>
                    <a:gd name="T39" fmla="*/ 327 h 371"/>
                    <a:gd name="T40" fmla="*/ 1027 w 1978"/>
                    <a:gd name="T41" fmla="*/ 331 h 371"/>
                    <a:gd name="T42" fmla="*/ 1077 w 1978"/>
                    <a:gd name="T43" fmla="*/ 335 h 371"/>
                    <a:gd name="T44" fmla="*/ 1128 w 1978"/>
                    <a:gd name="T45" fmla="*/ 339 h 371"/>
                    <a:gd name="T46" fmla="*/ 1178 w 1978"/>
                    <a:gd name="T47" fmla="*/ 343 h 371"/>
                    <a:gd name="T48" fmla="*/ 1228 w 1978"/>
                    <a:gd name="T49" fmla="*/ 346 h 371"/>
                    <a:gd name="T50" fmla="*/ 1278 w 1978"/>
                    <a:gd name="T51" fmla="*/ 348 h 371"/>
                    <a:gd name="T52" fmla="*/ 1328 w 1978"/>
                    <a:gd name="T53" fmla="*/ 351 h 371"/>
                    <a:gd name="T54" fmla="*/ 1377 w 1978"/>
                    <a:gd name="T55" fmla="*/ 354 h 371"/>
                    <a:gd name="T56" fmla="*/ 1427 w 1978"/>
                    <a:gd name="T57" fmla="*/ 355 h 371"/>
                    <a:gd name="T58" fmla="*/ 1477 w 1978"/>
                    <a:gd name="T59" fmla="*/ 358 h 371"/>
                    <a:gd name="T60" fmla="*/ 1527 w 1978"/>
                    <a:gd name="T61" fmla="*/ 359 h 371"/>
                    <a:gd name="T62" fmla="*/ 1577 w 1978"/>
                    <a:gd name="T63" fmla="*/ 361 h 371"/>
                    <a:gd name="T64" fmla="*/ 1628 w 1978"/>
                    <a:gd name="T65" fmla="*/ 362 h 371"/>
                    <a:gd name="T66" fmla="*/ 1678 w 1978"/>
                    <a:gd name="T67" fmla="*/ 363 h 371"/>
                    <a:gd name="T68" fmla="*/ 1728 w 1978"/>
                    <a:gd name="T69" fmla="*/ 365 h 371"/>
                    <a:gd name="T70" fmla="*/ 1778 w 1978"/>
                    <a:gd name="T71" fmla="*/ 366 h 371"/>
                    <a:gd name="T72" fmla="*/ 1828 w 1978"/>
                    <a:gd name="T73" fmla="*/ 367 h 371"/>
                    <a:gd name="T74" fmla="*/ 1878 w 1978"/>
                    <a:gd name="T75" fmla="*/ 369 h 371"/>
                    <a:gd name="T76" fmla="*/ 1928 w 1978"/>
                    <a:gd name="T77" fmla="*/ 370 h 371"/>
                    <a:gd name="T78" fmla="*/ 1978 w 1978"/>
                    <a:gd name="T79" fmla="*/ 371 h 37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</a:cxnLst>
                  <a:rect l="0" t="0" r="r" b="b"/>
                  <a:pathLst>
                    <a:path w="1978" h="371">
                      <a:moveTo>
                        <a:pt x="0" y="0"/>
                      </a:moveTo>
                      <a:lnTo>
                        <a:pt x="25" y="15"/>
                      </a:lnTo>
                      <a:lnTo>
                        <a:pt x="51" y="30"/>
                      </a:lnTo>
                      <a:lnTo>
                        <a:pt x="75" y="44"/>
                      </a:lnTo>
                      <a:lnTo>
                        <a:pt x="101" y="58"/>
                      </a:lnTo>
                      <a:lnTo>
                        <a:pt x="125" y="72"/>
                      </a:lnTo>
                      <a:lnTo>
                        <a:pt x="151" y="86"/>
                      </a:lnTo>
                      <a:lnTo>
                        <a:pt x="175" y="99"/>
                      </a:lnTo>
                      <a:lnTo>
                        <a:pt x="201" y="111"/>
                      </a:lnTo>
                      <a:lnTo>
                        <a:pt x="225" y="125"/>
                      </a:lnTo>
                      <a:lnTo>
                        <a:pt x="251" y="137"/>
                      </a:lnTo>
                      <a:lnTo>
                        <a:pt x="275" y="149"/>
                      </a:lnTo>
                      <a:lnTo>
                        <a:pt x="301" y="160"/>
                      </a:lnTo>
                      <a:lnTo>
                        <a:pt x="326" y="171"/>
                      </a:lnTo>
                      <a:lnTo>
                        <a:pt x="351" y="182"/>
                      </a:lnTo>
                      <a:lnTo>
                        <a:pt x="376" y="193"/>
                      </a:lnTo>
                      <a:lnTo>
                        <a:pt x="401" y="202"/>
                      </a:lnTo>
                      <a:lnTo>
                        <a:pt x="426" y="212"/>
                      </a:lnTo>
                      <a:lnTo>
                        <a:pt x="452" y="221"/>
                      </a:lnTo>
                      <a:lnTo>
                        <a:pt x="476" y="229"/>
                      </a:lnTo>
                      <a:lnTo>
                        <a:pt x="500" y="237"/>
                      </a:lnTo>
                      <a:lnTo>
                        <a:pt x="526" y="245"/>
                      </a:lnTo>
                      <a:lnTo>
                        <a:pt x="550" y="252"/>
                      </a:lnTo>
                      <a:lnTo>
                        <a:pt x="576" y="259"/>
                      </a:lnTo>
                      <a:lnTo>
                        <a:pt x="601" y="266"/>
                      </a:lnTo>
                      <a:lnTo>
                        <a:pt x="626" y="271"/>
                      </a:lnTo>
                      <a:lnTo>
                        <a:pt x="651" y="278"/>
                      </a:lnTo>
                      <a:lnTo>
                        <a:pt x="676" y="283"/>
                      </a:lnTo>
                      <a:lnTo>
                        <a:pt x="701" y="287"/>
                      </a:lnTo>
                      <a:lnTo>
                        <a:pt x="727" y="293"/>
                      </a:lnTo>
                      <a:lnTo>
                        <a:pt x="751" y="297"/>
                      </a:lnTo>
                      <a:lnTo>
                        <a:pt x="777" y="301"/>
                      </a:lnTo>
                      <a:lnTo>
                        <a:pt x="801" y="305"/>
                      </a:lnTo>
                      <a:lnTo>
                        <a:pt x="827" y="309"/>
                      </a:lnTo>
                      <a:lnTo>
                        <a:pt x="851" y="312"/>
                      </a:lnTo>
                      <a:lnTo>
                        <a:pt x="877" y="316"/>
                      </a:lnTo>
                      <a:lnTo>
                        <a:pt x="901" y="319"/>
                      </a:lnTo>
                      <a:lnTo>
                        <a:pt x="927" y="321"/>
                      </a:lnTo>
                      <a:lnTo>
                        <a:pt x="951" y="324"/>
                      </a:lnTo>
                      <a:lnTo>
                        <a:pt x="977" y="327"/>
                      </a:lnTo>
                      <a:lnTo>
                        <a:pt x="1002" y="329"/>
                      </a:lnTo>
                      <a:lnTo>
                        <a:pt x="1027" y="331"/>
                      </a:lnTo>
                      <a:lnTo>
                        <a:pt x="1052" y="333"/>
                      </a:lnTo>
                      <a:lnTo>
                        <a:pt x="1077" y="335"/>
                      </a:lnTo>
                      <a:lnTo>
                        <a:pt x="1102" y="338"/>
                      </a:lnTo>
                      <a:lnTo>
                        <a:pt x="1128" y="339"/>
                      </a:lnTo>
                      <a:lnTo>
                        <a:pt x="1152" y="340"/>
                      </a:lnTo>
                      <a:lnTo>
                        <a:pt x="1178" y="343"/>
                      </a:lnTo>
                      <a:lnTo>
                        <a:pt x="1202" y="344"/>
                      </a:lnTo>
                      <a:lnTo>
                        <a:pt x="1228" y="346"/>
                      </a:lnTo>
                      <a:lnTo>
                        <a:pt x="1252" y="347"/>
                      </a:lnTo>
                      <a:lnTo>
                        <a:pt x="1278" y="348"/>
                      </a:lnTo>
                      <a:lnTo>
                        <a:pt x="1302" y="350"/>
                      </a:lnTo>
                      <a:lnTo>
                        <a:pt x="1328" y="351"/>
                      </a:lnTo>
                      <a:lnTo>
                        <a:pt x="1352" y="352"/>
                      </a:lnTo>
                      <a:lnTo>
                        <a:pt x="1377" y="354"/>
                      </a:lnTo>
                      <a:lnTo>
                        <a:pt x="1403" y="354"/>
                      </a:lnTo>
                      <a:lnTo>
                        <a:pt x="1427" y="355"/>
                      </a:lnTo>
                      <a:lnTo>
                        <a:pt x="1453" y="357"/>
                      </a:lnTo>
                      <a:lnTo>
                        <a:pt x="1477" y="358"/>
                      </a:lnTo>
                      <a:lnTo>
                        <a:pt x="1503" y="358"/>
                      </a:lnTo>
                      <a:lnTo>
                        <a:pt x="1527" y="359"/>
                      </a:lnTo>
                      <a:lnTo>
                        <a:pt x="1553" y="361"/>
                      </a:lnTo>
                      <a:lnTo>
                        <a:pt x="1577" y="361"/>
                      </a:lnTo>
                      <a:lnTo>
                        <a:pt x="1603" y="362"/>
                      </a:lnTo>
                      <a:lnTo>
                        <a:pt x="1628" y="362"/>
                      </a:lnTo>
                      <a:lnTo>
                        <a:pt x="1653" y="363"/>
                      </a:lnTo>
                      <a:lnTo>
                        <a:pt x="1678" y="363"/>
                      </a:lnTo>
                      <a:lnTo>
                        <a:pt x="1703" y="365"/>
                      </a:lnTo>
                      <a:lnTo>
                        <a:pt x="1728" y="365"/>
                      </a:lnTo>
                      <a:lnTo>
                        <a:pt x="1754" y="366"/>
                      </a:lnTo>
                      <a:lnTo>
                        <a:pt x="1778" y="366"/>
                      </a:lnTo>
                      <a:lnTo>
                        <a:pt x="1804" y="367"/>
                      </a:lnTo>
                      <a:lnTo>
                        <a:pt x="1828" y="367"/>
                      </a:lnTo>
                      <a:lnTo>
                        <a:pt x="1854" y="369"/>
                      </a:lnTo>
                      <a:lnTo>
                        <a:pt x="1878" y="369"/>
                      </a:lnTo>
                      <a:lnTo>
                        <a:pt x="1904" y="370"/>
                      </a:lnTo>
                      <a:lnTo>
                        <a:pt x="1928" y="370"/>
                      </a:lnTo>
                      <a:lnTo>
                        <a:pt x="1954" y="370"/>
                      </a:lnTo>
                      <a:lnTo>
                        <a:pt x="1978" y="371"/>
                      </a:lnTo>
                    </a:path>
                  </a:pathLst>
                </a:cu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38" name="Freeform 254">
                  <a:extLst>
                    <a:ext uri="{FF2B5EF4-FFF2-40B4-BE49-F238E27FC236}">
                      <a16:creationId xmlns:a16="http://schemas.microsoft.com/office/drawing/2014/main" id="{D51E1191-0DEF-4382-D461-3DE58404955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8845550" y="3113088"/>
                  <a:ext cx="3140075" cy="1663700"/>
                </a:xfrm>
                <a:custGeom>
                  <a:avLst/>
                  <a:gdLst>
                    <a:gd name="T0" fmla="*/ 1954 w 1978"/>
                    <a:gd name="T1" fmla="*/ 1032 h 1048"/>
                    <a:gd name="T2" fmla="*/ 1904 w 1978"/>
                    <a:gd name="T3" fmla="*/ 997 h 1048"/>
                    <a:gd name="T4" fmla="*/ 1854 w 1978"/>
                    <a:gd name="T5" fmla="*/ 962 h 1048"/>
                    <a:gd name="T6" fmla="*/ 1804 w 1978"/>
                    <a:gd name="T7" fmla="*/ 928 h 1048"/>
                    <a:gd name="T8" fmla="*/ 1754 w 1978"/>
                    <a:gd name="T9" fmla="*/ 893 h 1048"/>
                    <a:gd name="T10" fmla="*/ 1703 w 1978"/>
                    <a:gd name="T11" fmla="*/ 857 h 1048"/>
                    <a:gd name="T12" fmla="*/ 1653 w 1978"/>
                    <a:gd name="T13" fmla="*/ 823 h 1048"/>
                    <a:gd name="T14" fmla="*/ 1603 w 1978"/>
                    <a:gd name="T15" fmla="*/ 790 h 1048"/>
                    <a:gd name="T16" fmla="*/ 1553 w 1978"/>
                    <a:gd name="T17" fmla="*/ 754 h 1048"/>
                    <a:gd name="T18" fmla="*/ 1503 w 1978"/>
                    <a:gd name="T19" fmla="*/ 720 h 1048"/>
                    <a:gd name="T20" fmla="*/ 1453 w 1978"/>
                    <a:gd name="T21" fmla="*/ 687 h 1048"/>
                    <a:gd name="T22" fmla="*/ 1403 w 1978"/>
                    <a:gd name="T23" fmla="*/ 653 h 1048"/>
                    <a:gd name="T24" fmla="*/ 1352 w 1978"/>
                    <a:gd name="T25" fmla="*/ 619 h 1048"/>
                    <a:gd name="T26" fmla="*/ 1302 w 1978"/>
                    <a:gd name="T27" fmla="*/ 585 h 1048"/>
                    <a:gd name="T28" fmla="*/ 1252 w 1978"/>
                    <a:gd name="T29" fmla="*/ 552 h 1048"/>
                    <a:gd name="T30" fmla="*/ 1202 w 1978"/>
                    <a:gd name="T31" fmla="*/ 519 h 1048"/>
                    <a:gd name="T32" fmla="*/ 1152 w 1978"/>
                    <a:gd name="T33" fmla="*/ 486 h 1048"/>
                    <a:gd name="T34" fmla="*/ 1102 w 1978"/>
                    <a:gd name="T35" fmla="*/ 454 h 1048"/>
                    <a:gd name="T36" fmla="*/ 1052 w 1978"/>
                    <a:gd name="T37" fmla="*/ 422 h 1048"/>
                    <a:gd name="T38" fmla="*/ 1002 w 1978"/>
                    <a:gd name="T39" fmla="*/ 390 h 1048"/>
                    <a:gd name="T40" fmla="*/ 951 w 1978"/>
                    <a:gd name="T41" fmla="*/ 360 h 1048"/>
                    <a:gd name="T42" fmla="*/ 901 w 1978"/>
                    <a:gd name="T43" fmla="*/ 329 h 1048"/>
                    <a:gd name="T44" fmla="*/ 851 w 1978"/>
                    <a:gd name="T45" fmla="*/ 299 h 1048"/>
                    <a:gd name="T46" fmla="*/ 801 w 1978"/>
                    <a:gd name="T47" fmla="*/ 271 h 1048"/>
                    <a:gd name="T48" fmla="*/ 751 w 1978"/>
                    <a:gd name="T49" fmla="*/ 242 h 1048"/>
                    <a:gd name="T50" fmla="*/ 701 w 1978"/>
                    <a:gd name="T51" fmla="*/ 216 h 1048"/>
                    <a:gd name="T52" fmla="*/ 651 w 1978"/>
                    <a:gd name="T53" fmla="*/ 191 h 1048"/>
                    <a:gd name="T54" fmla="*/ 601 w 1978"/>
                    <a:gd name="T55" fmla="*/ 166 h 1048"/>
                    <a:gd name="T56" fmla="*/ 550 w 1978"/>
                    <a:gd name="T57" fmla="*/ 143 h 1048"/>
                    <a:gd name="T58" fmla="*/ 500 w 1978"/>
                    <a:gd name="T59" fmla="*/ 123 h 1048"/>
                    <a:gd name="T60" fmla="*/ 452 w 1978"/>
                    <a:gd name="T61" fmla="*/ 103 h 1048"/>
                    <a:gd name="T62" fmla="*/ 401 w 1978"/>
                    <a:gd name="T63" fmla="*/ 86 h 1048"/>
                    <a:gd name="T64" fmla="*/ 351 w 1978"/>
                    <a:gd name="T65" fmla="*/ 70 h 1048"/>
                    <a:gd name="T66" fmla="*/ 301 w 1978"/>
                    <a:gd name="T67" fmla="*/ 57 h 1048"/>
                    <a:gd name="T68" fmla="*/ 251 w 1978"/>
                    <a:gd name="T69" fmla="*/ 43 h 1048"/>
                    <a:gd name="T70" fmla="*/ 201 w 1978"/>
                    <a:gd name="T71" fmla="*/ 32 h 1048"/>
                    <a:gd name="T72" fmla="*/ 151 w 1978"/>
                    <a:gd name="T73" fmla="*/ 23 h 1048"/>
                    <a:gd name="T74" fmla="*/ 101 w 1978"/>
                    <a:gd name="T75" fmla="*/ 15 h 1048"/>
                    <a:gd name="T76" fmla="*/ 51 w 1978"/>
                    <a:gd name="T77" fmla="*/ 7 h 1048"/>
                    <a:gd name="T78" fmla="*/ 0 w 1978"/>
                    <a:gd name="T79" fmla="*/ 0 h 10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</a:cxnLst>
                  <a:rect l="0" t="0" r="r" b="b"/>
                  <a:pathLst>
                    <a:path w="1978" h="1048">
                      <a:moveTo>
                        <a:pt x="1978" y="1048"/>
                      </a:moveTo>
                      <a:lnTo>
                        <a:pt x="1954" y="1032"/>
                      </a:lnTo>
                      <a:lnTo>
                        <a:pt x="1928" y="1014"/>
                      </a:lnTo>
                      <a:lnTo>
                        <a:pt x="1904" y="997"/>
                      </a:lnTo>
                      <a:lnTo>
                        <a:pt x="1878" y="979"/>
                      </a:lnTo>
                      <a:lnTo>
                        <a:pt x="1854" y="962"/>
                      </a:lnTo>
                      <a:lnTo>
                        <a:pt x="1828" y="944"/>
                      </a:lnTo>
                      <a:lnTo>
                        <a:pt x="1804" y="928"/>
                      </a:lnTo>
                      <a:lnTo>
                        <a:pt x="1778" y="910"/>
                      </a:lnTo>
                      <a:lnTo>
                        <a:pt x="1754" y="893"/>
                      </a:lnTo>
                      <a:lnTo>
                        <a:pt x="1728" y="875"/>
                      </a:lnTo>
                      <a:lnTo>
                        <a:pt x="1703" y="857"/>
                      </a:lnTo>
                      <a:lnTo>
                        <a:pt x="1678" y="841"/>
                      </a:lnTo>
                      <a:lnTo>
                        <a:pt x="1653" y="823"/>
                      </a:lnTo>
                      <a:lnTo>
                        <a:pt x="1628" y="806"/>
                      </a:lnTo>
                      <a:lnTo>
                        <a:pt x="1603" y="790"/>
                      </a:lnTo>
                      <a:lnTo>
                        <a:pt x="1577" y="772"/>
                      </a:lnTo>
                      <a:lnTo>
                        <a:pt x="1553" y="754"/>
                      </a:lnTo>
                      <a:lnTo>
                        <a:pt x="1527" y="738"/>
                      </a:lnTo>
                      <a:lnTo>
                        <a:pt x="1503" y="720"/>
                      </a:lnTo>
                      <a:lnTo>
                        <a:pt x="1477" y="703"/>
                      </a:lnTo>
                      <a:lnTo>
                        <a:pt x="1453" y="687"/>
                      </a:lnTo>
                      <a:lnTo>
                        <a:pt x="1427" y="669"/>
                      </a:lnTo>
                      <a:lnTo>
                        <a:pt x="1403" y="653"/>
                      </a:lnTo>
                      <a:lnTo>
                        <a:pt x="1377" y="635"/>
                      </a:lnTo>
                      <a:lnTo>
                        <a:pt x="1352" y="619"/>
                      </a:lnTo>
                      <a:lnTo>
                        <a:pt x="1328" y="603"/>
                      </a:lnTo>
                      <a:lnTo>
                        <a:pt x="1302" y="585"/>
                      </a:lnTo>
                      <a:lnTo>
                        <a:pt x="1278" y="569"/>
                      </a:lnTo>
                      <a:lnTo>
                        <a:pt x="1252" y="552"/>
                      </a:lnTo>
                      <a:lnTo>
                        <a:pt x="1228" y="536"/>
                      </a:lnTo>
                      <a:lnTo>
                        <a:pt x="1202" y="519"/>
                      </a:lnTo>
                      <a:lnTo>
                        <a:pt x="1178" y="502"/>
                      </a:lnTo>
                      <a:lnTo>
                        <a:pt x="1152" y="486"/>
                      </a:lnTo>
                      <a:lnTo>
                        <a:pt x="1128" y="470"/>
                      </a:lnTo>
                      <a:lnTo>
                        <a:pt x="1102" y="454"/>
                      </a:lnTo>
                      <a:lnTo>
                        <a:pt x="1077" y="439"/>
                      </a:lnTo>
                      <a:lnTo>
                        <a:pt x="1052" y="422"/>
                      </a:lnTo>
                      <a:lnTo>
                        <a:pt x="1027" y="406"/>
                      </a:lnTo>
                      <a:lnTo>
                        <a:pt x="1002" y="390"/>
                      </a:lnTo>
                      <a:lnTo>
                        <a:pt x="977" y="375"/>
                      </a:lnTo>
                      <a:lnTo>
                        <a:pt x="951" y="360"/>
                      </a:lnTo>
                      <a:lnTo>
                        <a:pt x="927" y="344"/>
                      </a:lnTo>
                      <a:lnTo>
                        <a:pt x="901" y="329"/>
                      </a:lnTo>
                      <a:lnTo>
                        <a:pt x="877" y="314"/>
                      </a:lnTo>
                      <a:lnTo>
                        <a:pt x="851" y="299"/>
                      </a:lnTo>
                      <a:lnTo>
                        <a:pt x="827" y="286"/>
                      </a:lnTo>
                      <a:lnTo>
                        <a:pt x="801" y="271"/>
                      </a:lnTo>
                      <a:lnTo>
                        <a:pt x="777" y="257"/>
                      </a:lnTo>
                      <a:lnTo>
                        <a:pt x="751" y="242"/>
                      </a:lnTo>
                      <a:lnTo>
                        <a:pt x="727" y="229"/>
                      </a:lnTo>
                      <a:lnTo>
                        <a:pt x="701" y="216"/>
                      </a:lnTo>
                      <a:lnTo>
                        <a:pt x="676" y="203"/>
                      </a:lnTo>
                      <a:lnTo>
                        <a:pt x="651" y="191"/>
                      </a:lnTo>
                      <a:lnTo>
                        <a:pt x="626" y="179"/>
                      </a:lnTo>
                      <a:lnTo>
                        <a:pt x="601" y="166"/>
                      </a:lnTo>
                      <a:lnTo>
                        <a:pt x="576" y="154"/>
                      </a:lnTo>
                      <a:lnTo>
                        <a:pt x="550" y="143"/>
                      </a:lnTo>
                      <a:lnTo>
                        <a:pt x="526" y="132"/>
                      </a:lnTo>
                      <a:lnTo>
                        <a:pt x="500" y="123"/>
                      </a:lnTo>
                      <a:lnTo>
                        <a:pt x="476" y="112"/>
                      </a:lnTo>
                      <a:lnTo>
                        <a:pt x="452" y="103"/>
                      </a:lnTo>
                      <a:lnTo>
                        <a:pt x="426" y="95"/>
                      </a:lnTo>
                      <a:lnTo>
                        <a:pt x="401" y="86"/>
                      </a:lnTo>
                      <a:lnTo>
                        <a:pt x="376" y="78"/>
                      </a:lnTo>
                      <a:lnTo>
                        <a:pt x="351" y="70"/>
                      </a:lnTo>
                      <a:lnTo>
                        <a:pt x="326" y="63"/>
                      </a:lnTo>
                      <a:lnTo>
                        <a:pt x="301" y="57"/>
                      </a:lnTo>
                      <a:lnTo>
                        <a:pt x="275" y="50"/>
                      </a:lnTo>
                      <a:lnTo>
                        <a:pt x="251" y="43"/>
                      </a:lnTo>
                      <a:lnTo>
                        <a:pt x="225" y="38"/>
                      </a:lnTo>
                      <a:lnTo>
                        <a:pt x="201" y="32"/>
                      </a:lnTo>
                      <a:lnTo>
                        <a:pt x="175" y="28"/>
                      </a:lnTo>
                      <a:lnTo>
                        <a:pt x="151" y="23"/>
                      </a:lnTo>
                      <a:lnTo>
                        <a:pt x="125" y="19"/>
                      </a:lnTo>
                      <a:lnTo>
                        <a:pt x="101" y="15"/>
                      </a:lnTo>
                      <a:lnTo>
                        <a:pt x="75" y="11"/>
                      </a:lnTo>
                      <a:lnTo>
                        <a:pt x="51" y="7"/>
                      </a:lnTo>
                      <a:lnTo>
                        <a:pt x="25" y="4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39" name="Freeform 255">
                  <a:extLst>
                    <a:ext uri="{FF2B5EF4-FFF2-40B4-BE49-F238E27FC236}">
                      <a16:creationId xmlns:a16="http://schemas.microsoft.com/office/drawing/2014/main" id="{9489B7BD-5499-A297-9986-FD35D0B2FEC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8845550" y="2736850"/>
                  <a:ext cx="3140075" cy="1127125"/>
                </a:xfrm>
                <a:custGeom>
                  <a:avLst/>
                  <a:gdLst>
                    <a:gd name="T0" fmla="*/ 25 w 1978"/>
                    <a:gd name="T1" fmla="*/ 8 h 710"/>
                    <a:gd name="T2" fmla="*/ 75 w 1978"/>
                    <a:gd name="T3" fmla="*/ 27 h 710"/>
                    <a:gd name="T4" fmla="*/ 125 w 1978"/>
                    <a:gd name="T5" fmla="*/ 44 h 710"/>
                    <a:gd name="T6" fmla="*/ 175 w 1978"/>
                    <a:gd name="T7" fmla="*/ 62 h 710"/>
                    <a:gd name="T8" fmla="*/ 225 w 1978"/>
                    <a:gd name="T9" fmla="*/ 80 h 710"/>
                    <a:gd name="T10" fmla="*/ 275 w 1978"/>
                    <a:gd name="T11" fmla="*/ 99 h 710"/>
                    <a:gd name="T12" fmla="*/ 326 w 1978"/>
                    <a:gd name="T13" fmla="*/ 116 h 710"/>
                    <a:gd name="T14" fmla="*/ 376 w 1978"/>
                    <a:gd name="T15" fmla="*/ 134 h 710"/>
                    <a:gd name="T16" fmla="*/ 426 w 1978"/>
                    <a:gd name="T17" fmla="*/ 153 h 710"/>
                    <a:gd name="T18" fmla="*/ 476 w 1978"/>
                    <a:gd name="T19" fmla="*/ 170 h 710"/>
                    <a:gd name="T20" fmla="*/ 526 w 1978"/>
                    <a:gd name="T21" fmla="*/ 188 h 710"/>
                    <a:gd name="T22" fmla="*/ 576 w 1978"/>
                    <a:gd name="T23" fmla="*/ 206 h 710"/>
                    <a:gd name="T24" fmla="*/ 626 w 1978"/>
                    <a:gd name="T25" fmla="*/ 225 h 710"/>
                    <a:gd name="T26" fmla="*/ 676 w 1978"/>
                    <a:gd name="T27" fmla="*/ 242 h 710"/>
                    <a:gd name="T28" fmla="*/ 727 w 1978"/>
                    <a:gd name="T29" fmla="*/ 260 h 710"/>
                    <a:gd name="T30" fmla="*/ 777 w 1978"/>
                    <a:gd name="T31" fmla="*/ 277 h 710"/>
                    <a:gd name="T32" fmla="*/ 827 w 1978"/>
                    <a:gd name="T33" fmla="*/ 296 h 710"/>
                    <a:gd name="T34" fmla="*/ 877 w 1978"/>
                    <a:gd name="T35" fmla="*/ 314 h 710"/>
                    <a:gd name="T36" fmla="*/ 927 w 1978"/>
                    <a:gd name="T37" fmla="*/ 332 h 710"/>
                    <a:gd name="T38" fmla="*/ 977 w 1978"/>
                    <a:gd name="T39" fmla="*/ 349 h 710"/>
                    <a:gd name="T40" fmla="*/ 1027 w 1978"/>
                    <a:gd name="T41" fmla="*/ 368 h 710"/>
                    <a:gd name="T42" fmla="*/ 1077 w 1978"/>
                    <a:gd name="T43" fmla="*/ 386 h 710"/>
                    <a:gd name="T44" fmla="*/ 1128 w 1978"/>
                    <a:gd name="T45" fmla="*/ 403 h 710"/>
                    <a:gd name="T46" fmla="*/ 1178 w 1978"/>
                    <a:gd name="T47" fmla="*/ 421 h 710"/>
                    <a:gd name="T48" fmla="*/ 1228 w 1978"/>
                    <a:gd name="T49" fmla="*/ 440 h 710"/>
                    <a:gd name="T50" fmla="*/ 1278 w 1978"/>
                    <a:gd name="T51" fmla="*/ 458 h 710"/>
                    <a:gd name="T52" fmla="*/ 1328 w 1978"/>
                    <a:gd name="T53" fmla="*/ 475 h 710"/>
                    <a:gd name="T54" fmla="*/ 1377 w 1978"/>
                    <a:gd name="T55" fmla="*/ 493 h 710"/>
                    <a:gd name="T56" fmla="*/ 1427 w 1978"/>
                    <a:gd name="T57" fmla="*/ 512 h 710"/>
                    <a:gd name="T58" fmla="*/ 1477 w 1978"/>
                    <a:gd name="T59" fmla="*/ 529 h 710"/>
                    <a:gd name="T60" fmla="*/ 1527 w 1978"/>
                    <a:gd name="T61" fmla="*/ 547 h 710"/>
                    <a:gd name="T62" fmla="*/ 1577 w 1978"/>
                    <a:gd name="T63" fmla="*/ 566 h 710"/>
                    <a:gd name="T64" fmla="*/ 1628 w 1978"/>
                    <a:gd name="T65" fmla="*/ 584 h 710"/>
                    <a:gd name="T66" fmla="*/ 1678 w 1978"/>
                    <a:gd name="T67" fmla="*/ 601 h 710"/>
                    <a:gd name="T68" fmla="*/ 1728 w 1978"/>
                    <a:gd name="T69" fmla="*/ 619 h 710"/>
                    <a:gd name="T70" fmla="*/ 1778 w 1978"/>
                    <a:gd name="T71" fmla="*/ 638 h 710"/>
                    <a:gd name="T72" fmla="*/ 1828 w 1978"/>
                    <a:gd name="T73" fmla="*/ 655 h 710"/>
                    <a:gd name="T74" fmla="*/ 1878 w 1978"/>
                    <a:gd name="T75" fmla="*/ 673 h 710"/>
                    <a:gd name="T76" fmla="*/ 1928 w 1978"/>
                    <a:gd name="T77" fmla="*/ 691 h 710"/>
                    <a:gd name="T78" fmla="*/ 1978 w 1978"/>
                    <a:gd name="T79" fmla="*/ 710 h 71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</a:cxnLst>
                  <a:rect l="0" t="0" r="r" b="b"/>
                  <a:pathLst>
                    <a:path w="1978" h="710">
                      <a:moveTo>
                        <a:pt x="0" y="0"/>
                      </a:moveTo>
                      <a:lnTo>
                        <a:pt x="25" y="8"/>
                      </a:lnTo>
                      <a:lnTo>
                        <a:pt x="51" y="17"/>
                      </a:lnTo>
                      <a:lnTo>
                        <a:pt x="75" y="27"/>
                      </a:lnTo>
                      <a:lnTo>
                        <a:pt x="101" y="35"/>
                      </a:lnTo>
                      <a:lnTo>
                        <a:pt x="125" y="44"/>
                      </a:lnTo>
                      <a:lnTo>
                        <a:pt x="151" y="54"/>
                      </a:lnTo>
                      <a:lnTo>
                        <a:pt x="175" y="62"/>
                      </a:lnTo>
                      <a:lnTo>
                        <a:pt x="201" y="71"/>
                      </a:lnTo>
                      <a:lnTo>
                        <a:pt x="225" y="80"/>
                      </a:lnTo>
                      <a:lnTo>
                        <a:pt x="251" y="89"/>
                      </a:lnTo>
                      <a:lnTo>
                        <a:pt x="275" y="99"/>
                      </a:lnTo>
                      <a:lnTo>
                        <a:pt x="301" y="107"/>
                      </a:lnTo>
                      <a:lnTo>
                        <a:pt x="326" y="116"/>
                      </a:lnTo>
                      <a:lnTo>
                        <a:pt x="351" y="126"/>
                      </a:lnTo>
                      <a:lnTo>
                        <a:pt x="376" y="134"/>
                      </a:lnTo>
                      <a:lnTo>
                        <a:pt x="401" y="143"/>
                      </a:lnTo>
                      <a:lnTo>
                        <a:pt x="426" y="153"/>
                      </a:lnTo>
                      <a:lnTo>
                        <a:pt x="452" y="161"/>
                      </a:lnTo>
                      <a:lnTo>
                        <a:pt x="476" y="170"/>
                      </a:lnTo>
                      <a:lnTo>
                        <a:pt x="500" y="178"/>
                      </a:lnTo>
                      <a:lnTo>
                        <a:pt x="526" y="188"/>
                      </a:lnTo>
                      <a:lnTo>
                        <a:pt x="550" y="197"/>
                      </a:lnTo>
                      <a:lnTo>
                        <a:pt x="576" y="206"/>
                      </a:lnTo>
                      <a:lnTo>
                        <a:pt x="601" y="215"/>
                      </a:lnTo>
                      <a:lnTo>
                        <a:pt x="626" y="225"/>
                      </a:lnTo>
                      <a:lnTo>
                        <a:pt x="651" y="233"/>
                      </a:lnTo>
                      <a:lnTo>
                        <a:pt x="676" y="242"/>
                      </a:lnTo>
                      <a:lnTo>
                        <a:pt x="701" y="250"/>
                      </a:lnTo>
                      <a:lnTo>
                        <a:pt x="727" y="260"/>
                      </a:lnTo>
                      <a:lnTo>
                        <a:pt x="751" y="269"/>
                      </a:lnTo>
                      <a:lnTo>
                        <a:pt x="777" y="277"/>
                      </a:lnTo>
                      <a:lnTo>
                        <a:pt x="801" y="287"/>
                      </a:lnTo>
                      <a:lnTo>
                        <a:pt x="827" y="296"/>
                      </a:lnTo>
                      <a:lnTo>
                        <a:pt x="851" y="304"/>
                      </a:lnTo>
                      <a:lnTo>
                        <a:pt x="877" y="314"/>
                      </a:lnTo>
                      <a:lnTo>
                        <a:pt x="901" y="323"/>
                      </a:lnTo>
                      <a:lnTo>
                        <a:pt x="927" y="332"/>
                      </a:lnTo>
                      <a:lnTo>
                        <a:pt x="951" y="341"/>
                      </a:lnTo>
                      <a:lnTo>
                        <a:pt x="977" y="349"/>
                      </a:lnTo>
                      <a:lnTo>
                        <a:pt x="1002" y="359"/>
                      </a:lnTo>
                      <a:lnTo>
                        <a:pt x="1027" y="368"/>
                      </a:lnTo>
                      <a:lnTo>
                        <a:pt x="1052" y="376"/>
                      </a:lnTo>
                      <a:lnTo>
                        <a:pt x="1077" y="386"/>
                      </a:lnTo>
                      <a:lnTo>
                        <a:pt x="1102" y="395"/>
                      </a:lnTo>
                      <a:lnTo>
                        <a:pt x="1128" y="403"/>
                      </a:lnTo>
                      <a:lnTo>
                        <a:pt x="1152" y="413"/>
                      </a:lnTo>
                      <a:lnTo>
                        <a:pt x="1178" y="421"/>
                      </a:lnTo>
                      <a:lnTo>
                        <a:pt x="1202" y="430"/>
                      </a:lnTo>
                      <a:lnTo>
                        <a:pt x="1228" y="440"/>
                      </a:lnTo>
                      <a:lnTo>
                        <a:pt x="1252" y="448"/>
                      </a:lnTo>
                      <a:lnTo>
                        <a:pt x="1278" y="458"/>
                      </a:lnTo>
                      <a:lnTo>
                        <a:pt x="1302" y="467"/>
                      </a:lnTo>
                      <a:lnTo>
                        <a:pt x="1328" y="475"/>
                      </a:lnTo>
                      <a:lnTo>
                        <a:pt x="1352" y="485"/>
                      </a:lnTo>
                      <a:lnTo>
                        <a:pt x="1377" y="493"/>
                      </a:lnTo>
                      <a:lnTo>
                        <a:pt x="1403" y="502"/>
                      </a:lnTo>
                      <a:lnTo>
                        <a:pt x="1427" y="512"/>
                      </a:lnTo>
                      <a:lnTo>
                        <a:pt x="1453" y="520"/>
                      </a:lnTo>
                      <a:lnTo>
                        <a:pt x="1477" y="529"/>
                      </a:lnTo>
                      <a:lnTo>
                        <a:pt x="1503" y="539"/>
                      </a:lnTo>
                      <a:lnTo>
                        <a:pt x="1527" y="547"/>
                      </a:lnTo>
                      <a:lnTo>
                        <a:pt x="1553" y="556"/>
                      </a:lnTo>
                      <a:lnTo>
                        <a:pt x="1577" y="566"/>
                      </a:lnTo>
                      <a:lnTo>
                        <a:pt x="1603" y="574"/>
                      </a:lnTo>
                      <a:lnTo>
                        <a:pt x="1628" y="584"/>
                      </a:lnTo>
                      <a:lnTo>
                        <a:pt x="1653" y="592"/>
                      </a:lnTo>
                      <a:lnTo>
                        <a:pt x="1678" y="601"/>
                      </a:lnTo>
                      <a:lnTo>
                        <a:pt x="1703" y="611"/>
                      </a:lnTo>
                      <a:lnTo>
                        <a:pt x="1728" y="619"/>
                      </a:lnTo>
                      <a:lnTo>
                        <a:pt x="1754" y="628"/>
                      </a:lnTo>
                      <a:lnTo>
                        <a:pt x="1778" y="638"/>
                      </a:lnTo>
                      <a:lnTo>
                        <a:pt x="1804" y="646"/>
                      </a:lnTo>
                      <a:lnTo>
                        <a:pt x="1828" y="655"/>
                      </a:lnTo>
                      <a:lnTo>
                        <a:pt x="1854" y="663"/>
                      </a:lnTo>
                      <a:lnTo>
                        <a:pt x="1878" y="673"/>
                      </a:lnTo>
                      <a:lnTo>
                        <a:pt x="1904" y="682"/>
                      </a:lnTo>
                      <a:lnTo>
                        <a:pt x="1928" y="691"/>
                      </a:lnTo>
                      <a:lnTo>
                        <a:pt x="1954" y="700"/>
                      </a:lnTo>
                      <a:lnTo>
                        <a:pt x="1978" y="710"/>
                      </a:lnTo>
                    </a:path>
                  </a:pathLst>
                </a:custGeom>
                <a:noFill/>
                <a:ln w="0" cap="flat">
                  <a:solidFill>
                    <a:srgbClr val="3366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40" name="Rectangle 256">
                  <a:extLst>
                    <a:ext uri="{FF2B5EF4-FFF2-40B4-BE49-F238E27FC236}">
                      <a16:creationId xmlns:a16="http://schemas.microsoft.com/office/drawing/2014/main" id="{4A894D34-B177-CBB1-096B-82AC49CB8B0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574639" y="2590800"/>
                  <a:ext cx="814194" cy="5536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1100" b="1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R</a:t>
                  </a:r>
                  <a:r>
                    <a:rPr kumimoji="0" lang="en-US" altLang="hu-HU" sz="1100" b="1" i="0" u="none" strike="noStrike" cap="none" normalizeH="0" baseline="3000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2</a:t>
                  </a:r>
                  <a:r>
                    <a:rPr kumimoji="0" lang="en-US" altLang="hu-HU" sz="11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= 0.26</a:t>
                  </a:r>
                </a:p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n-US" altLang="hu-HU" sz="1100" b="1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p&lt;0.05</a:t>
                  </a:r>
                  <a:endParaRPr kumimoji="0" lang="en-US" altLang="hu-HU" sz="11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1" name="Line 257">
                  <a:extLst>
                    <a:ext uri="{FF2B5EF4-FFF2-40B4-BE49-F238E27FC236}">
                      <a16:creationId xmlns:a16="http://schemas.microsoft.com/office/drawing/2014/main" id="{6F694781-BDAD-B15D-372E-9DE2E0EEE0D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8688388" y="1746250"/>
                  <a:ext cx="0" cy="3176587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42" name="Rectangle 258">
                  <a:extLst>
                    <a:ext uri="{FF2B5EF4-FFF2-40B4-BE49-F238E27FC236}">
                      <a16:creationId xmlns:a16="http://schemas.microsoft.com/office/drawing/2014/main" id="{E8875380-9BB8-8479-A665-8BC324A4639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473339" y="4688329"/>
                  <a:ext cx="159732" cy="2013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50</a:t>
                  </a:r>
                  <a:endParaRPr kumimoji="0" lang="en-US" altLang="hu-HU" sz="14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3" name="Rectangle 259">
                  <a:extLst>
                    <a:ext uri="{FF2B5EF4-FFF2-40B4-BE49-F238E27FC236}">
                      <a16:creationId xmlns:a16="http://schemas.microsoft.com/office/drawing/2014/main" id="{0F97F57E-ABAC-C0C0-B11C-1422A182068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473339" y="3880293"/>
                  <a:ext cx="159732" cy="2013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55</a:t>
                  </a:r>
                  <a:endParaRPr kumimoji="0" lang="en-US" altLang="hu-HU" sz="14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4" name="Rectangle 260">
                  <a:extLst>
                    <a:ext uri="{FF2B5EF4-FFF2-40B4-BE49-F238E27FC236}">
                      <a16:creationId xmlns:a16="http://schemas.microsoft.com/office/drawing/2014/main" id="{B398FA47-19FD-F288-5DBE-AAE3DD6DBA2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473339" y="3070668"/>
                  <a:ext cx="159732" cy="2013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60</a:t>
                  </a:r>
                  <a:endParaRPr kumimoji="0" lang="en-US" altLang="hu-HU" sz="14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5" name="Rectangle 261">
                  <a:extLst>
                    <a:ext uri="{FF2B5EF4-FFF2-40B4-BE49-F238E27FC236}">
                      <a16:creationId xmlns:a16="http://schemas.microsoft.com/office/drawing/2014/main" id="{F53C95F0-2D1C-5E15-D378-2BF594B4976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473339" y="2262632"/>
                  <a:ext cx="159732" cy="2013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65</a:t>
                  </a:r>
                  <a:endParaRPr kumimoji="0" lang="en-US" altLang="hu-HU" sz="14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6" name="Line 262">
                  <a:extLst>
                    <a:ext uri="{FF2B5EF4-FFF2-40B4-BE49-F238E27FC236}">
                      <a16:creationId xmlns:a16="http://schemas.microsoft.com/office/drawing/2014/main" id="{14BA1D0E-94C5-FD86-CCDB-7E30122CDA4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8662988" y="4799013"/>
                  <a:ext cx="25400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47" name="Line 263">
                  <a:extLst>
                    <a:ext uri="{FF2B5EF4-FFF2-40B4-BE49-F238E27FC236}">
                      <a16:creationId xmlns:a16="http://schemas.microsoft.com/office/drawing/2014/main" id="{9823ADC6-3448-5559-AB6F-A71511B6FAB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8662988" y="3987800"/>
                  <a:ext cx="25400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48" name="Line 264">
                  <a:extLst>
                    <a:ext uri="{FF2B5EF4-FFF2-40B4-BE49-F238E27FC236}">
                      <a16:creationId xmlns:a16="http://schemas.microsoft.com/office/drawing/2014/main" id="{BE8CE753-D967-24AF-6CE7-4B28FA7D7DC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8662988" y="3179763"/>
                  <a:ext cx="25400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49" name="Line 265">
                  <a:extLst>
                    <a:ext uri="{FF2B5EF4-FFF2-40B4-BE49-F238E27FC236}">
                      <a16:creationId xmlns:a16="http://schemas.microsoft.com/office/drawing/2014/main" id="{D39B5421-BE09-2155-F874-41A3DCFECE6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8662988" y="2370138"/>
                  <a:ext cx="25400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50" name="Line 266">
                  <a:extLst>
                    <a:ext uri="{FF2B5EF4-FFF2-40B4-BE49-F238E27FC236}">
                      <a16:creationId xmlns:a16="http://schemas.microsoft.com/office/drawing/2014/main" id="{6CBE481A-C2B9-CCD7-29E6-163FF25A875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8688388" y="4922838"/>
                  <a:ext cx="3454400" cy="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51" name="Line 267">
                  <a:extLst>
                    <a:ext uri="{FF2B5EF4-FFF2-40B4-BE49-F238E27FC236}">
                      <a16:creationId xmlns:a16="http://schemas.microsoft.com/office/drawing/2014/main" id="{12480003-730A-7F55-A4BF-AACAFBEE5D3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8747125" y="4922838"/>
                  <a:ext cx="0" cy="23812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52" name="Line 268">
                  <a:extLst>
                    <a:ext uri="{FF2B5EF4-FFF2-40B4-BE49-F238E27FC236}">
                      <a16:creationId xmlns:a16="http://schemas.microsoft.com/office/drawing/2014/main" id="{642DAA2D-23FB-CA42-A3F1-C9F57BAB37D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9472613" y="4922838"/>
                  <a:ext cx="0" cy="23812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53" name="Line 269">
                  <a:extLst>
                    <a:ext uri="{FF2B5EF4-FFF2-40B4-BE49-F238E27FC236}">
                      <a16:creationId xmlns:a16="http://schemas.microsoft.com/office/drawing/2014/main" id="{D907BC91-8739-60E1-0F49-4DA9E73C2D4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10199688" y="4922838"/>
                  <a:ext cx="0" cy="23812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54" name="Line 270">
                  <a:extLst>
                    <a:ext uri="{FF2B5EF4-FFF2-40B4-BE49-F238E27FC236}">
                      <a16:creationId xmlns:a16="http://schemas.microsoft.com/office/drawing/2014/main" id="{51FEA1B7-791B-CA75-5B1B-2366731F5D4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10923588" y="4922838"/>
                  <a:ext cx="0" cy="23812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55" name="Line 271">
                  <a:extLst>
                    <a:ext uri="{FF2B5EF4-FFF2-40B4-BE49-F238E27FC236}">
                      <a16:creationId xmlns:a16="http://schemas.microsoft.com/office/drawing/2014/main" id="{B2C92BE2-F6FC-DBB5-A92D-8F6CF9A5F56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11649075" y="4922838"/>
                  <a:ext cx="0" cy="23812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56" name="Rectangle 272">
                  <a:extLst>
                    <a:ext uri="{FF2B5EF4-FFF2-40B4-BE49-F238E27FC236}">
                      <a16:creationId xmlns:a16="http://schemas.microsoft.com/office/drawing/2014/main" id="{771AB955-60D5-5847-5787-45AB859E1E7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638438" y="4933798"/>
                  <a:ext cx="239599" cy="2013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100</a:t>
                  </a:r>
                  <a:endParaRPr kumimoji="0" lang="en-US" altLang="hu-HU" sz="14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7" name="Rectangle 273">
                  <a:extLst>
                    <a:ext uri="{FF2B5EF4-FFF2-40B4-BE49-F238E27FC236}">
                      <a16:creationId xmlns:a16="http://schemas.microsoft.com/office/drawing/2014/main" id="{32BC6D71-E053-46C7-3904-88D9EC74C8C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365513" y="4933798"/>
                  <a:ext cx="239599" cy="2013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200</a:t>
                  </a:r>
                  <a:endParaRPr kumimoji="0" lang="en-US" altLang="hu-HU" sz="14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8" name="Rectangle 274">
                  <a:extLst>
                    <a:ext uri="{FF2B5EF4-FFF2-40B4-BE49-F238E27FC236}">
                      <a16:creationId xmlns:a16="http://schemas.microsoft.com/office/drawing/2014/main" id="{3D4825EF-984B-FB77-0D26-02E3ABE8568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089416" y="4933798"/>
                  <a:ext cx="239599" cy="2013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300</a:t>
                  </a:r>
                  <a:endParaRPr kumimoji="0" lang="en-US" altLang="hu-HU" sz="14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9" name="Rectangle 275">
                  <a:extLst>
                    <a:ext uri="{FF2B5EF4-FFF2-40B4-BE49-F238E27FC236}">
                      <a16:creationId xmlns:a16="http://schemas.microsoft.com/office/drawing/2014/main" id="{8D52C7A2-5265-7A02-4F11-34F5AA12A0D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816489" y="4933798"/>
                  <a:ext cx="239599" cy="2013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400</a:t>
                  </a:r>
                  <a:endParaRPr kumimoji="0" lang="en-US" altLang="hu-HU" sz="14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0" name="Rectangle 276">
                  <a:extLst>
                    <a:ext uri="{FF2B5EF4-FFF2-40B4-BE49-F238E27FC236}">
                      <a16:creationId xmlns:a16="http://schemas.microsoft.com/office/drawing/2014/main" id="{703FEB35-C072-F483-15A3-BD60BEC9D61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541978" y="4933798"/>
                  <a:ext cx="239599" cy="2013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500</a:t>
                  </a:r>
                  <a:endParaRPr kumimoji="0" lang="en-US" altLang="hu-HU" sz="14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1" name="Rectangle 279">
                  <a:extLst>
                    <a:ext uri="{FF2B5EF4-FFF2-40B4-BE49-F238E27FC236}">
                      <a16:creationId xmlns:a16="http://schemas.microsoft.com/office/drawing/2014/main" id="{F470BF3A-6344-D22A-DC2D-A0AD7E261A7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686800" y="1401763"/>
                  <a:ext cx="3505200" cy="35234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hu-HU" altLang="hu-HU" sz="1400" b="1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Moderate</a:t>
                  </a:r>
                  <a:r>
                    <a:rPr kumimoji="0" lang="hu-HU" altLang="hu-HU" sz="14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 COVID-19</a:t>
                  </a:r>
                  <a:endParaRPr kumimoji="0" lang="en-US" altLang="hu-HU" sz="11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</a:endParaRPr>
                </a:p>
              </p:txBody>
            </p:sp>
          </p:grpSp>
          <p:sp>
            <p:nvSpPr>
              <p:cNvPr id="78" name="Szövegdoboz 77">
                <a:extLst>
                  <a:ext uri="{FF2B5EF4-FFF2-40B4-BE49-F238E27FC236}">
                    <a16:creationId xmlns:a16="http://schemas.microsoft.com/office/drawing/2014/main" id="{E5EF86AA-1B32-C622-9CDA-DE061BDA32F4}"/>
                  </a:ext>
                </a:extLst>
              </p:cNvPr>
              <p:cNvSpPr txBox="1"/>
              <p:nvPr/>
            </p:nvSpPr>
            <p:spPr>
              <a:xfrm>
                <a:off x="1210775" y="4970880"/>
                <a:ext cx="3659836" cy="3850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oluble PD-1 level in serum (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g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/ml)</a:t>
                </a:r>
              </a:p>
            </p:txBody>
          </p:sp>
          <p:cxnSp>
            <p:nvCxnSpPr>
              <p:cNvPr id="79" name="Egyenes összekötő nyíllal 78">
                <a:extLst>
                  <a:ext uri="{FF2B5EF4-FFF2-40B4-BE49-F238E27FC236}">
                    <a16:creationId xmlns:a16="http://schemas.microsoft.com/office/drawing/2014/main" id="{C000284E-8158-8DB9-4335-6068C2A44FF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99096" y="5176894"/>
                <a:ext cx="6180105" cy="5258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80" name="Csoportba foglalás 79">
                <a:extLst>
                  <a:ext uri="{FF2B5EF4-FFF2-40B4-BE49-F238E27FC236}">
                    <a16:creationId xmlns:a16="http://schemas.microsoft.com/office/drawing/2014/main" id="{AE2F33F4-64AD-ADEA-33B6-DE470F89D590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950887" y="1401766"/>
                <a:ext cx="3303932" cy="3360035"/>
                <a:chOff x="343752" y="1401763"/>
                <a:chExt cx="3671036" cy="3733373"/>
              </a:xfrm>
            </p:grpSpPr>
            <p:sp>
              <p:nvSpPr>
                <p:cNvPr id="82" name="Oval 147">
                  <a:extLst>
                    <a:ext uri="{FF2B5EF4-FFF2-40B4-BE49-F238E27FC236}">
                      <a16:creationId xmlns:a16="http://schemas.microsoft.com/office/drawing/2014/main" id="{E280D1E3-0550-B8C9-C3CE-20AF9FB2A5F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95600" y="3908425"/>
                  <a:ext cx="63500" cy="65087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83" name="Oval 148">
                  <a:extLst>
                    <a:ext uri="{FF2B5EF4-FFF2-40B4-BE49-F238E27FC236}">
                      <a16:creationId xmlns:a16="http://schemas.microsoft.com/office/drawing/2014/main" id="{993D7043-0AF1-A5F0-8749-046FEED5FC8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111375" y="4125913"/>
                  <a:ext cx="65088" cy="63500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84" name="Oval 149">
                  <a:extLst>
                    <a:ext uri="{FF2B5EF4-FFF2-40B4-BE49-F238E27FC236}">
                      <a16:creationId xmlns:a16="http://schemas.microsoft.com/office/drawing/2014/main" id="{C1FA111F-789B-DE73-CFDF-61D9F7F5D4F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552575" y="3406775"/>
                  <a:ext cx="61913" cy="65087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85" name="Oval 150">
                  <a:extLst>
                    <a:ext uri="{FF2B5EF4-FFF2-40B4-BE49-F238E27FC236}">
                      <a16:creationId xmlns:a16="http://schemas.microsoft.com/office/drawing/2014/main" id="{DD306DDC-4C00-E1C6-94EA-09C20A94063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219325" y="3743325"/>
                  <a:ext cx="65088" cy="63500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86" name="Oval 151">
                  <a:extLst>
                    <a:ext uri="{FF2B5EF4-FFF2-40B4-BE49-F238E27FC236}">
                      <a16:creationId xmlns:a16="http://schemas.microsoft.com/office/drawing/2014/main" id="{2FEB8EF4-2834-ED1E-DDDB-07C7E2E5B27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473200" y="3714750"/>
                  <a:ext cx="61913" cy="65087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87" name="Oval 152">
                  <a:extLst>
                    <a:ext uri="{FF2B5EF4-FFF2-40B4-BE49-F238E27FC236}">
                      <a16:creationId xmlns:a16="http://schemas.microsoft.com/office/drawing/2014/main" id="{A9D79D17-0218-650E-CF0D-9D3F2E839CB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871663" y="2130425"/>
                  <a:ext cx="63500" cy="63500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88" name="Oval 153">
                  <a:extLst>
                    <a:ext uri="{FF2B5EF4-FFF2-40B4-BE49-F238E27FC236}">
                      <a16:creationId xmlns:a16="http://schemas.microsoft.com/office/drawing/2014/main" id="{6B012B11-B764-44CB-2AD4-14FB8BA042F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66775" y="3673475"/>
                  <a:ext cx="65088" cy="63500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89" name="Oval 154">
                  <a:extLst>
                    <a:ext uri="{FF2B5EF4-FFF2-40B4-BE49-F238E27FC236}">
                      <a16:creationId xmlns:a16="http://schemas.microsoft.com/office/drawing/2014/main" id="{DD309BA2-B8F2-9ED3-CCA8-DE56468925D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33675" y="2241550"/>
                  <a:ext cx="61913" cy="61912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90" name="Oval 155">
                  <a:extLst>
                    <a:ext uri="{FF2B5EF4-FFF2-40B4-BE49-F238E27FC236}">
                      <a16:creationId xmlns:a16="http://schemas.microsoft.com/office/drawing/2014/main" id="{22651E74-D11F-55FD-857E-CC37292C562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14675" y="4144963"/>
                  <a:ext cx="61913" cy="61912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91" name="Oval 156">
                  <a:extLst>
                    <a:ext uri="{FF2B5EF4-FFF2-40B4-BE49-F238E27FC236}">
                      <a16:creationId xmlns:a16="http://schemas.microsoft.com/office/drawing/2014/main" id="{A06F084F-5388-1E24-98CD-082767EFF38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825875" y="3900488"/>
                  <a:ext cx="65088" cy="61912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92" name="Oval 157">
                  <a:extLst>
                    <a:ext uri="{FF2B5EF4-FFF2-40B4-BE49-F238E27FC236}">
                      <a16:creationId xmlns:a16="http://schemas.microsoft.com/office/drawing/2014/main" id="{4F5EEA2F-945D-7727-7B70-780C3C6A60B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763713" y="1858963"/>
                  <a:ext cx="65088" cy="65087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93" name="Oval 158">
                  <a:extLst>
                    <a:ext uri="{FF2B5EF4-FFF2-40B4-BE49-F238E27FC236}">
                      <a16:creationId xmlns:a16="http://schemas.microsoft.com/office/drawing/2014/main" id="{5018E5E2-D9BB-9DCC-51F9-D2709C058D0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85800" y="3197225"/>
                  <a:ext cx="61913" cy="63500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94" name="Oval 159">
                  <a:extLst>
                    <a:ext uri="{FF2B5EF4-FFF2-40B4-BE49-F238E27FC236}">
                      <a16:creationId xmlns:a16="http://schemas.microsoft.com/office/drawing/2014/main" id="{656E88F1-40B5-4479-D1E1-5B9A08C89D7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41413" y="4352925"/>
                  <a:ext cx="65088" cy="65087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95" name="Oval 160">
                  <a:extLst>
                    <a:ext uri="{FF2B5EF4-FFF2-40B4-BE49-F238E27FC236}">
                      <a16:creationId xmlns:a16="http://schemas.microsoft.com/office/drawing/2014/main" id="{7C032A8B-2022-4C18-9E5E-2B18538C800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32163" y="4079875"/>
                  <a:ext cx="63500" cy="65087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96" name="Freeform 161">
                  <a:extLst>
                    <a:ext uri="{FF2B5EF4-FFF2-40B4-BE49-F238E27FC236}">
                      <a16:creationId xmlns:a16="http://schemas.microsoft.com/office/drawing/2014/main" id="{4553DC13-3276-9831-B577-A5B62DBDD88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715963" y="3278188"/>
                  <a:ext cx="3143250" cy="477837"/>
                </a:xfrm>
                <a:custGeom>
                  <a:avLst/>
                  <a:gdLst>
                    <a:gd name="T0" fmla="*/ 26 w 1980"/>
                    <a:gd name="T1" fmla="*/ 3 h 301"/>
                    <a:gd name="T2" fmla="*/ 76 w 1980"/>
                    <a:gd name="T3" fmla="*/ 11 h 301"/>
                    <a:gd name="T4" fmla="*/ 126 w 1980"/>
                    <a:gd name="T5" fmla="*/ 19 h 301"/>
                    <a:gd name="T6" fmla="*/ 176 w 1980"/>
                    <a:gd name="T7" fmla="*/ 26 h 301"/>
                    <a:gd name="T8" fmla="*/ 226 w 1980"/>
                    <a:gd name="T9" fmla="*/ 34 h 301"/>
                    <a:gd name="T10" fmla="*/ 277 w 1980"/>
                    <a:gd name="T11" fmla="*/ 41 h 301"/>
                    <a:gd name="T12" fmla="*/ 327 w 1980"/>
                    <a:gd name="T13" fmla="*/ 49 h 301"/>
                    <a:gd name="T14" fmla="*/ 377 w 1980"/>
                    <a:gd name="T15" fmla="*/ 57 h 301"/>
                    <a:gd name="T16" fmla="*/ 427 w 1980"/>
                    <a:gd name="T17" fmla="*/ 64 h 301"/>
                    <a:gd name="T18" fmla="*/ 477 w 1980"/>
                    <a:gd name="T19" fmla="*/ 72 h 301"/>
                    <a:gd name="T20" fmla="*/ 527 w 1980"/>
                    <a:gd name="T21" fmla="*/ 80 h 301"/>
                    <a:gd name="T22" fmla="*/ 577 w 1980"/>
                    <a:gd name="T23" fmla="*/ 87 h 301"/>
                    <a:gd name="T24" fmla="*/ 627 w 1980"/>
                    <a:gd name="T25" fmla="*/ 95 h 301"/>
                    <a:gd name="T26" fmla="*/ 678 w 1980"/>
                    <a:gd name="T27" fmla="*/ 103 h 301"/>
                    <a:gd name="T28" fmla="*/ 728 w 1980"/>
                    <a:gd name="T29" fmla="*/ 110 h 301"/>
                    <a:gd name="T30" fmla="*/ 776 w 1980"/>
                    <a:gd name="T31" fmla="*/ 118 h 301"/>
                    <a:gd name="T32" fmla="*/ 827 w 1980"/>
                    <a:gd name="T33" fmla="*/ 125 h 301"/>
                    <a:gd name="T34" fmla="*/ 877 w 1980"/>
                    <a:gd name="T35" fmla="*/ 133 h 301"/>
                    <a:gd name="T36" fmla="*/ 927 w 1980"/>
                    <a:gd name="T37" fmla="*/ 141 h 301"/>
                    <a:gd name="T38" fmla="*/ 977 w 1980"/>
                    <a:gd name="T39" fmla="*/ 148 h 301"/>
                    <a:gd name="T40" fmla="*/ 1027 w 1980"/>
                    <a:gd name="T41" fmla="*/ 156 h 301"/>
                    <a:gd name="T42" fmla="*/ 1077 w 1980"/>
                    <a:gd name="T43" fmla="*/ 164 h 301"/>
                    <a:gd name="T44" fmla="*/ 1127 w 1980"/>
                    <a:gd name="T45" fmla="*/ 171 h 301"/>
                    <a:gd name="T46" fmla="*/ 1177 w 1980"/>
                    <a:gd name="T47" fmla="*/ 179 h 301"/>
                    <a:gd name="T48" fmla="*/ 1228 w 1980"/>
                    <a:gd name="T49" fmla="*/ 186 h 301"/>
                    <a:gd name="T50" fmla="*/ 1278 w 1980"/>
                    <a:gd name="T51" fmla="*/ 194 h 301"/>
                    <a:gd name="T52" fmla="*/ 1328 w 1980"/>
                    <a:gd name="T53" fmla="*/ 202 h 301"/>
                    <a:gd name="T54" fmla="*/ 1378 w 1980"/>
                    <a:gd name="T55" fmla="*/ 209 h 301"/>
                    <a:gd name="T56" fmla="*/ 1428 w 1980"/>
                    <a:gd name="T57" fmla="*/ 217 h 301"/>
                    <a:gd name="T58" fmla="*/ 1478 w 1980"/>
                    <a:gd name="T59" fmla="*/ 225 h 301"/>
                    <a:gd name="T60" fmla="*/ 1528 w 1980"/>
                    <a:gd name="T61" fmla="*/ 232 h 301"/>
                    <a:gd name="T62" fmla="*/ 1579 w 1980"/>
                    <a:gd name="T63" fmla="*/ 240 h 301"/>
                    <a:gd name="T64" fmla="*/ 1629 w 1980"/>
                    <a:gd name="T65" fmla="*/ 247 h 301"/>
                    <a:gd name="T66" fmla="*/ 1679 w 1980"/>
                    <a:gd name="T67" fmla="*/ 255 h 301"/>
                    <a:gd name="T68" fmla="*/ 1729 w 1980"/>
                    <a:gd name="T69" fmla="*/ 263 h 301"/>
                    <a:gd name="T70" fmla="*/ 1779 w 1980"/>
                    <a:gd name="T71" fmla="*/ 270 h 301"/>
                    <a:gd name="T72" fmla="*/ 1829 w 1980"/>
                    <a:gd name="T73" fmla="*/ 278 h 301"/>
                    <a:gd name="T74" fmla="*/ 1879 w 1980"/>
                    <a:gd name="T75" fmla="*/ 286 h 301"/>
                    <a:gd name="T76" fmla="*/ 1929 w 1980"/>
                    <a:gd name="T77" fmla="*/ 293 h 301"/>
                    <a:gd name="T78" fmla="*/ 1980 w 1980"/>
                    <a:gd name="T79" fmla="*/ 301 h 30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</a:cxnLst>
                  <a:rect l="0" t="0" r="r" b="b"/>
                  <a:pathLst>
                    <a:path w="1980" h="301">
                      <a:moveTo>
                        <a:pt x="0" y="0"/>
                      </a:moveTo>
                      <a:lnTo>
                        <a:pt x="26" y="3"/>
                      </a:lnTo>
                      <a:lnTo>
                        <a:pt x="50" y="7"/>
                      </a:lnTo>
                      <a:lnTo>
                        <a:pt x="76" y="11"/>
                      </a:lnTo>
                      <a:lnTo>
                        <a:pt x="100" y="15"/>
                      </a:lnTo>
                      <a:lnTo>
                        <a:pt x="126" y="19"/>
                      </a:lnTo>
                      <a:lnTo>
                        <a:pt x="151" y="22"/>
                      </a:lnTo>
                      <a:lnTo>
                        <a:pt x="176" y="26"/>
                      </a:lnTo>
                      <a:lnTo>
                        <a:pt x="201" y="30"/>
                      </a:lnTo>
                      <a:lnTo>
                        <a:pt x="226" y="34"/>
                      </a:lnTo>
                      <a:lnTo>
                        <a:pt x="251" y="38"/>
                      </a:lnTo>
                      <a:lnTo>
                        <a:pt x="277" y="41"/>
                      </a:lnTo>
                      <a:lnTo>
                        <a:pt x="301" y="45"/>
                      </a:lnTo>
                      <a:lnTo>
                        <a:pt x="327" y="49"/>
                      </a:lnTo>
                      <a:lnTo>
                        <a:pt x="351" y="53"/>
                      </a:lnTo>
                      <a:lnTo>
                        <a:pt x="377" y="57"/>
                      </a:lnTo>
                      <a:lnTo>
                        <a:pt x="401" y="61"/>
                      </a:lnTo>
                      <a:lnTo>
                        <a:pt x="427" y="64"/>
                      </a:lnTo>
                      <a:lnTo>
                        <a:pt x="451" y="68"/>
                      </a:lnTo>
                      <a:lnTo>
                        <a:pt x="477" y="72"/>
                      </a:lnTo>
                      <a:lnTo>
                        <a:pt x="501" y="76"/>
                      </a:lnTo>
                      <a:lnTo>
                        <a:pt x="527" y="80"/>
                      </a:lnTo>
                      <a:lnTo>
                        <a:pt x="552" y="83"/>
                      </a:lnTo>
                      <a:lnTo>
                        <a:pt x="577" y="87"/>
                      </a:lnTo>
                      <a:lnTo>
                        <a:pt x="602" y="91"/>
                      </a:lnTo>
                      <a:lnTo>
                        <a:pt x="627" y="95"/>
                      </a:lnTo>
                      <a:lnTo>
                        <a:pt x="652" y="99"/>
                      </a:lnTo>
                      <a:lnTo>
                        <a:pt x="678" y="103"/>
                      </a:lnTo>
                      <a:lnTo>
                        <a:pt x="702" y="106"/>
                      </a:lnTo>
                      <a:lnTo>
                        <a:pt x="728" y="110"/>
                      </a:lnTo>
                      <a:lnTo>
                        <a:pt x="752" y="114"/>
                      </a:lnTo>
                      <a:lnTo>
                        <a:pt x="776" y="118"/>
                      </a:lnTo>
                      <a:lnTo>
                        <a:pt x="802" y="122"/>
                      </a:lnTo>
                      <a:lnTo>
                        <a:pt x="827" y="125"/>
                      </a:lnTo>
                      <a:lnTo>
                        <a:pt x="852" y="129"/>
                      </a:lnTo>
                      <a:lnTo>
                        <a:pt x="877" y="133"/>
                      </a:lnTo>
                      <a:lnTo>
                        <a:pt x="902" y="137"/>
                      </a:lnTo>
                      <a:lnTo>
                        <a:pt x="927" y="141"/>
                      </a:lnTo>
                      <a:lnTo>
                        <a:pt x="953" y="144"/>
                      </a:lnTo>
                      <a:lnTo>
                        <a:pt x="977" y="148"/>
                      </a:lnTo>
                      <a:lnTo>
                        <a:pt x="1003" y="152"/>
                      </a:lnTo>
                      <a:lnTo>
                        <a:pt x="1027" y="156"/>
                      </a:lnTo>
                      <a:lnTo>
                        <a:pt x="1053" y="160"/>
                      </a:lnTo>
                      <a:lnTo>
                        <a:pt x="1077" y="164"/>
                      </a:lnTo>
                      <a:lnTo>
                        <a:pt x="1103" y="167"/>
                      </a:lnTo>
                      <a:lnTo>
                        <a:pt x="1127" y="171"/>
                      </a:lnTo>
                      <a:lnTo>
                        <a:pt x="1153" y="175"/>
                      </a:lnTo>
                      <a:lnTo>
                        <a:pt x="1177" y="179"/>
                      </a:lnTo>
                      <a:lnTo>
                        <a:pt x="1203" y="183"/>
                      </a:lnTo>
                      <a:lnTo>
                        <a:pt x="1228" y="186"/>
                      </a:lnTo>
                      <a:lnTo>
                        <a:pt x="1253" y="190"/>
                      </a:lnTo>
                      <a:lnTo>
                        <a:pt x="1278" y="194"/>
                      </a:lnTo>
                      <a:lnTo>
                        <a:pt x="1303" y="198"/>
                      </a:lnTo>
                      <a:lnTo>
                        <a:pt x="1328" y="202"/>
                      </a:lnTo>
                      <a:lnTo>
                        <a:pt x="1354" y="206"/>
                      </a:lnTo>
                      <a:lnTo>
                        <a:pt x="1378" y="209"/>
                      </a:lnTo>
                      <a:lnTo>
                        <a:pt x="1404" y="213"/>
                      </a:lnTo>
                      <a:lnTo>
                        <a:pt x="1428" y="217"/>
                      </a:lnTo>
                      <a:lnTo>
                        <a:pt x="1454" y="221"/>
                      </a:lnTo>
                      <a:lnTo>
                        <a:pt x="1478" y="225"/>
                      </a:lnTo>
                      <a:lnTo>
                        <a:pt x="1504" y="228"/>
                      </a:lnTo>
                      <a:lnTo>
                        <a:pt x="1528" y="232"/>
                      </a:lnTo>
                      <a:lnTo>
                        <a:pt x="1554" y="236"/>
                      </a:lnTo>
                      <a:lnTo>
                        <a:pt x="1579" y="240"/>
                      </a:lnTo>
                      <a:lnTo>
                        <a:pt x="1604" y="244"/>
                      </a:lnTo>
                      <a:lnTo>
                        <a:pt x="1629" y="247"/>
                      </a:lnTo>
                      <a:lnTo>
                        <a:pt x="1653" y="251"/>
                      </a:lnTo>
                      <a:lnTo>
                        <a:pt x="1679" y="255"/>
                      </a:lnTo>
                      <a:lnTo>
                        <a:pt x="1703" y="259"/>
                      </a:lnTo>
                      <a:lnTo>
                        <a:pt x="1729" y="263"/>
                      </a:lnTo>
                      <a:lnTo>
                        <a:pt x="1753" y="267"/>
                      </a:lnTo>
                      <a:lnTo>
                        <a:pt x="1779" y="270"/>
                      </a:lnTo>
                      <a:lnTo>
                        <a:pt x="1803" y="274"/>
                      </a:lnTo>
                      <a:lnTo>
                        <a:pt x="1829" y="278"/>
                      </a:lnTo>
                      <a:lnTo>
                        <a:pt x="1854" y="282"/>
                      </a:lnTo>
                      <a:lnTo>
                        <a:pt x="1879" y="286"/>
                      </a:lnTo>
                      <a:lnTo>
                        <a:pt x="1904" y="289"/>
                      </a:lnTo>
                      <a:lnTo>
                        <a:pt x="1929" y="293"/>
                      </a:lnTo>
                      <a:lnTo>
                        <a:pt x="1954" y="297"/>
                      </a:lnTo>
                      <a:lnTo>
                        <a:pt x="1980" y="301"/>
                      </a:lnTo>
                    </a:path>
                  </a:pathLst>
                </a:custGeom>
                <a:noFill/>
                <a:ln w="365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97" name="Freeform 162">
                  <a:extLst>
                    <a:ext uri="{FF2B5EF4-FFF2-40B4-BE49-F238E27FC236}">
                      <a16:creationId xmlns:a16="http://schemas.microsoft.com/office/drawing/2014/main" id="{36A1F954-39EC-C613-99AC-2B81A119982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715963" y="2382838"/>
                  <a:ext cx="3143250" cy="2393950"/>
                </a:xfrm>
                <a:custGeom>
                  <a:avLst/>
                  <a:gdLst>
                    <a:gd name="T0" fmla="*/ 50 w 1980"/>
                    <a:gd name="T1" fmla="*/ 30 h 1508"/>
                    <a:gd name="T2" fmla="*/ 126 w 1980"/>
                    <a:gd name="T3" fmla="*/ 74 h 1508"/>
                    <a:gd name="T4" fmla="*/ 201 w 1980"/>
                    <a:gd name="T5" fmla="*/ 116 h 1508"/>
                    <a:gd name="T6" fmla="*/ 277 w 1980"/>
                    <a:gd name="T7" fmla="*/ 158 h 1508"/>
                    <a:gd name="T8" fmla="*/ 351 w 1980"/>
                    <a:gd name="T9" fmla="*/ 197 h 1508"/>
                    <a:gd name="T10" fmla="*/ 427 w 1980"/>
                    <a:gd name="T11" fmla="*/ 235 h 1508"/>
                    <a:gd name="T12" fmla="*/ 501 w 1980"/>
                    <a:gd name="T13" fmla="*/ 270 h 1508"/>
                    <a:gd name="T14" fmla="*/ 577 w 1980"/>
                    <a:gd name="T15" fmla="*/ 301 h 1508"/>
                    <a:gd name="T16" fmla="*/ 652 w 1980"/>
                    <a:gd name="T17" fmla="*/ 331 h 1508"/>
                    <a:gd name="T18" fmla="*/ 728 w 1980"/>
                    <a:gd name="T19" fmla="*/ 355 h 1508"/>
                    <a:gd name="T20" fmla="*/ 802 w 1980"/>
                    <a:gd name="T21" fmla="*/ 376 h 1508"/>
                    <a:gd name="T22" fmla="*/ 877 w 1980"/>
                    <a:gd name="T23" fmla="*/ 392 h 1508"/>
                    <a:gd name="T24" fmla="*/ 953 w 1980"/>
                    <a:gd name="T25" fmla="*/ 401 h 1508"/>
                    <a:gd name="T26" fmla="*/ 1027 w 1980"/>
                    <a:gd name="T27" fmla="*/ 407 h 1508"/>
                    <a:gd name="T28" fmla="*/ 1103 w 1980"/>
                    <a:gd name="T29" fmla="*/ 408 h 1508"/>
                    <a:gd name="T30" fmla="*/ 1177 w 1980"/>
                    <a:gd name="T31" fmla="*/ 404 h 1508"/>
                    <a:gd name="T32" fmla="*/ 1253 w 1980"/>
                    <a:gd name="T33" fmla="*/ 397 h 1508"/>
                    <a:gd name="T34" fmla="*/ 1328 w 1980"/>
                    <a:gd name="T35" fmla="*/ 387 h 1508"/>
                    <a:gd name="T36" fmla="*/ 1404 w 1980"/>
                    <a:gd name="T37" fmla="*/ 373 h 1508"/>
                    <a:gd name="T38" fmla="*/ 1478 w 1980"/>
                    <a:gd name="T39" fmla="*/ 358 h 1508"/>
                    <a:gd name="T40" fmla="*/ 1554 w 1980"/>
                    <a:gd name="T41" fmla="*/ 341 h 1508"/>
                    <a:gd name="T42" fmla="*/ 1629 w 1980"/>
                    <a:gd name="T43" fmla="*/ 322 h 1508"/>
                    <a:gd name="T44" fmla="*/ 1703 w 1980"/>
                    <a:gd name="T45" fmla="*/ 301 h 1508"/>
                    <a:gd name="T46" fmla="*/ 1779 w 1980"/>
                    <a:gd name="T47" fmla="*/ 281 h 1508"/>
                    <a:gd name="T48" fmla="*/ 1854 w 1980"/>
                    <a:gd name="T49" fmla="*/ 258 h 1508"/>
                    <a:gd name="T50" fmla="*/ 1929 w 1980"/>
                    <a:gd name="T51" fmla="*/ 236 h 1508"/>
                    <a:gd name="T52" fmla="*/ 1980 w 1980"/>
                    <a:gd name="T53" fmla="*/ 1508 h 1508"/>
                    <a:gd name="T54" fmla="*/ 1904 w 1980"/>
                    <a:gd name="T55" fmla="*/ 1464 h 1508"/>
                    <a:gd name="T56" fmla="*/ 1829 w 1980"/>
                    <a:gd name="T57" fmla="*/ 1418 h 1508"/>
                    <a:gd name="T58" fmla="*/ 1753 w 1980"/>
                    <a:gd name="T59" fmla="*/ 1373 h 1508"/>
                    <a:gd name="T60" fmla="*/ 1679 w 1980"/>
                    <a:gd name="T61" fmla="*/ 1329 h 1508"/>
                    <a:gd name="T62" fmla="*/ 1604 w 1980"/>
                    <a:gd name="T63" fmla="*/ 1287 h 1508"/>
                    <a:gd name="T64" fmla="*/ 1528 w 1980"/>
                    <a:gd name="T65" fmla="*/ 1245 h 1508"/>
                    <a:gd name="T66" fmla="*/ 1454 w 1980"/>
                    <a:gd name="T67" fmla="*/ 1206 h 1508"/>
                    <a:gd name="T68" fmla="*/ 1378 w 1980"/>
                    <a:gd name="T69" fmla="*/ 1168 h 1508"/>
                    <a:gd name="T70" fmla="*/ 1303 w 1980"/>
                    <a:gd name="T71" fmla="*/ 1133 h 1508"/>
                    <a:gd name="T72" fmla="*/ 1228 w 1980"/>
                    <a:gd name="T73" fmla="*/ 1101 h 1508"/>
                    <a:gd name="T74" fmla="*/ 1153 w 1980"/>
                    <a:gd name="T75" fmla="*/ 1072 h 1508"/>
                    <a:gd name="T76" fmla="*/ 1077 w 1980"/>
                    <a:gd name="T77" fmla="*/ 1046 h 1508"/>
                    <a:gd name="T78" fmla="*/ 1003 w 1980"/>
                    <a:gd name="T79" fmla="*/ 1026 h 1508"/>
                    <a:gd name="T80" fmla="*/ 927 w 1980"/>
                    <a:gd name="T81" fmla="*/ 1010 h 1508"/>
                    <a:gd name="T82" fmla="*/ 852 w 1980"/>
                    <a:gd name="T83" fmla="*/ 999 h 1508"/>
                    <a:gd name="T84" fmla="*/ 776 w 1980"/>
                    <a:gd name="T85" fmla="*/ 994 h 1508"/>
                    <a:gd name="T86" fmla="*/ 702 w 1980"/>
                    <a:gd name="T87" fmla="*/ 992 h 1508"/>
                    <a:gd name="T88" fmla="*/ 627 w 1980"/>
                    <a:gd name="T89" fmla="*/ 996 h 1508"/>
                    <a:gd name="T90" fmla="*/ 552 w 1980"/>
                    <a:gd name="T91" fmla="*/ 1003 h 1508"/>
                    <a:gd name="T92" fmla="*/ 477 w 1980"/>
                    <a:gd name="T93" fmla="*/ 1014 h 1508"/>
                    <a:gd name="T94" fmla="*/ 401 w 1980"/>
                    <a:gd name="T95" fmla="*/ 1027 h 1508"/>
                    <a:gd name="T96" fmla="*/ 327 w 1980"/>
                    <a:gd name="T97" fmla="*/ 1042 h 1508"/>
                    <a:gd name="T98" fmla="*/ 251 w 1980"/>
                    <a:gd name="T99" fmla="*/ 1060 h 1508"/>
                    <a:gd name="T100" fmla="*/ 176 w 1980"/>
                    <a:gd name="T101" fmla="*/ 1077 h 1508"/>
                    <a:gd name="T102" fmla="*/ 100 w 1980"/>
                    <a:gd name="T103" fmla="*/ 1098 h 1508"/>
                    <a:gd name="T104" fmla="*/ 26 w 1980"/>
                    <a:gd name="T105" fmla="*/ 1119 h 150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</a:cxnLst>
                  <a:rect l="0" t="0" r="r" b="b"/>
                  <a:pathLst>
                    <a:path w="1980" h="1508">
                      <a:moveTo>
                        <a:pt x="0" y="0"/>
                      </a:moveTo>
                      <a:lnTo>
                        <a:pt x="26" y="15"/>
                      </a:lnTo>
                      <a:lnTo>
                        <a:pt x="50" y="30"/>
                      </a:lnTo>
                      <a:lnTo>
                        <a:pt x="76" y="45"/>
                      </a:lnTo>
                      <a:lnTo>
                        <a:pt x="100" y="59"/>
                      </a:lnTo>
                      <a:lnTo>
                        <a:pt x="126" y="74"/>
                      </a:lnTo>
                      <a:lnTo>
                        <a:pt x="151" y="89"/>
                      </a:lnTo>
                      <a:lnTo>
                        <a:pt x="176" y="102"/>
                      </a:lnTo>
                      <a:lnTo>
                        <a:pt x="201" y="116"/>
                      </a:lnTo>
                      <a:lnTo>
                        <a:pt x="226" y="131"/>
                      </a:lnTo>
                      <a:lnTo>
                        <a:pt x="251" y="144"/>
                      </a:lnTo>
                      <a:lnTo>
                        <a:pt x="277" y="158"/>
                      </a:lnTo>
                      <a:lnTo>
                        <a:pt x="301" y="171"/>
                      </a:lnTo>
                      <a:lnTo>
                        <a:pt x="327" y="183"/>
                      </a:lnTo>
                      <a:lnTo>
                        <a:pt x="351" y="197"/>
                      </a:lnTo>
                      <a:lnTo>
                        <a:pt x="377" y="209"/>
                      </a:lnTo>
                      <a:lnTo>
                        <a:pt x="401" y="223"/>
                      </a:lnTo>
                      <a:lnTo>
                        <a:pt x="427" y="235"/>
                      </a:lnTo>
                      <a:lnTo>
                        <a:pt x="451" y="246"/>
                      </a:lnTo>
                      <a:lnTo>
                        <a:pt x="477" y="258"/>
                      </a:lnTo>
                      <a:lnTo>
                        <a:pt x="501" y="270"/>
                      </a:lnTo>
                      <a:lnTo>
                        <a:pt x="527" y="281"/>
                      </a:lnTo>
                      <a:lnTo>
                        <a:pt x="552" y="292"/>
                      </a:lnTo>
                      <a:lnTo>
                        <a:pt x="577" y="301"/>
                      </a:lnTo>
                      <a:lnTo>
                        <a:pt x="602" y="312"/>
                      </a:lnTo>
                      <a:lnTo>
                        <a:pt x="627" y="322"/>
                      </a:lnTo>
                      <a:lnTo>
                        <a:pt x="652" y="331"/>
                      </a:lnTo>
                      <a:lnTo>
                        <a:pt x="678" y="339"/>
                      </a:lnTo>
                      <a:lnTo>
                        <a:pt x="702" y="347"/>
                      </a:lnTo>
                      <a:lnTo>
                        <a:pt x="728" y="355"/>
                      </a:lnTo>
                      <a:lnTo>
                        <a:pt x="752" y="364"/>
                      </a:lnTo>
                      <a:lnTo>
                        <a:pt x="776" y="370"/>
                      </a:lnTo>
                      <a:lnTo>
                        <a:pt x="802" y="376"/>
                      </a:lnTo>
                      <a:lnTo>
                        <a:pt x="827" y="381"/>
                      </a:lnTo>
                      <a:lnTo>
                        <a:pt x="852" y="387"/>
                      </a:lnTo>
                      <a:lnTo>
                        <a:pt x="877" y="392"/>
                      </a:lnTo>
                      <a:lnTo>
                        <a:pt x="902" y="396"/>
                      </a:lnTo>
                      <a:lnTo>
                        <a:pt x="927" y="399"/>
                      </a:lnTo>
                      <a:lnTo>
                        <a:pt x="953" y="401"/>
                      </a:lnTo>
                      <a:lnTo>
                        <a:pt x="977" y="404"/>
                      </a:lnTo>
                      <a:lnTo>
                        <a:pt x="1003" y="406"/>
                      </a:lnTo>
                      <a:lnTo>
                        <a:pt x="1027" y="407"/>
                      </a:lnTo>
                      <a:lnTo>
                        <a:pt x="1053" y="408"/>
                      </a:lnTo>
                      <a:lnTo>
                        <a:pt x="1077" y="408"/>
                      </a:lnTo>
                      <a:lnTo>
                        <a:pt x="1103" y="408"/>
                      </a:lnTo>
                      <a:lnTo>
                        <a:pt x="1127" y="407"/>
                      </a:lnTo>
                      <a:lnTo>
                        <a:pt x="1153" y="406"/>
                      </a:lnTo>
                      <a:lnTo>
                        <a:pt x="1177" y="404"/>
                      </a:lnTo>
                      <a:lnTo>
                        <a:pt x="1203" y="403"/>
                      </a:lnTo>
                      <a:lnTo>
                        <a:pt x="1228" y="400"/>
                      </a:lnTo>
                      <a:lnTo>
                        <a:pt x="1253" y="397"/>
                      </a:lnTo>
                      <a:lnTo>
                        <a:pt x="1278" y="393"/>
                      </a:lnTo>
                      <a:lnTo>
                        <a:pt x="1303" y="391"/>
                      </a:lnTo>
                      <a:lnTo>
                        <a:pt x="1328" y="387"/>
                      </a:lnTo>
                      <a:lnTo>
                        <a:pt x="1354" y="383"/>
                      </a:lnTo>
                      <a:lnTo>
                        <a:pt x="1378" y="378"/>
                      </a:lnTo>
                      <a:lnTo>
                        <a:pt x="1404" y="373"/>
                      </a:lnTo>
                      <a:lnTo>
                        <a:pt x="1428" y="368"/>
                      </a:lnTo>
                      <a:lnTo>
                        <a:pt x="1454" y="364"/>
                      </a:lnTo>
                      <a:lnTo>
                        <a:pt x="1478" y="358"/>
                      </a:lnTo>
                      <a:lnTo>
                        <a:pt x="1504" y="353"/>
                      </a:lnTo>
                      <a:lnTo>
                        <a:pt x="1528" y="346"/>
                      </a:lnTo>
                      <a:lnTo>
                        <a:pt x="1554" y="341"/>
                      </a:lnTo>
                      <a:lnTo>
                        <a:pt x="1579" y="334"/>
                      </a:lnTo>
                      <a:lnTo>
                        <a:pt x="1604" y="328"/>
                      </a:lnTo>
                      <a:lnTo>
                        <a:pt x="1629" y="322"/>
                      </a:lnTo>
                      <a:lnTo>
                        <a:pt x="1653" y="315"/>
                      </a:lnTo>
                      <a:lnTo>
                        <a:pt x="1679" y="308"/>
                      </a:lnTo>
                      <a:lnTo>
                        <a:pt x="1703" y="301"/>
                      </a:lnTo>
                      <a:lnTo>
                        <a:pt x="1729" y="294"/>
                      </a:lnTo>
                      <a:lnTo>
                        <a:pt x="1753" y="288"/>
                      </a:lnTo>
                      <a:lnTo>
                        <a:pt x="1779" y="281"/>
                      </a:lnTo>
                      <a:lnTo>
                        <a:pt x="1803" y="273"/>
                      </a:lnTo>
                      <a:lnTo>
                        <a:pt x="1829" y="266"/>
                      </a:lnTo>
                      <a:lnTo>
                        <a:pt x="1854" y="258"/>
                      </a:lnTo>
                      <a:lnTo>
                        <a:pt x="1879" y="251"/>
                      </a:lnTo>
                      <a:lnTo>
                        <a:pt x="1904" y="243"/>
                      </a:lnTo>
                      <a:lnTo>
                        <a:pt x="1929" y="236"/>
                      </a:lnTo>
                      <a:lnTo>
                        <a:pt x="1954" y="228"/>
                      </a:lnTo>
                      <a:lnTo>
                        <a:pt x="1980" y="220"/>
                      </a:lnTo>
                      <a:lnTo>
                        <a:pt x="1980" y="1508"/>
                      </a:lnTo>
                      <a:lnTo>
                        <a:pt x="1954" y="1493"/>
                      </a:lnTo>
                      <a:lnTo>
                        <a:pt x="1929" y="1479"/>
                      </a:lnTo>
                      <a:lnTo>
                        <a:pt x="1904" y="1464"/>
                      </a:lnTo>
                      <a:lnTo>
                        <a:pt x="1879" y="1447"/>
                      </a:lnTo>
                      <a:lnTo>
                        <a:pt x="1854" y="1432"/>
                      </a:lnTo>
                      <a:lnTo>
                        <a:pt x="1829" y="1418"/>
                      </a:lnTo>
                      <a:lnTo>
                        <a:pt x="1803" y="1403"/>
                      </a:lnTo>
                      <a:lnTo>
                        <a:pt x="1779" y="1388"/>
                      </a:lnTo>
                      <a:lnTo>
                        <a:pt x="1753" y="1373"/>
                      </a:lnTo>
                      <a:lnTo>
                        <a:pt x="1729" y="1358"/>
                      </a:lnTo>
                      <a:lnTo>
                        <a:pt x="1703" y="1344"/>
                      </a:lnTo>
                      <a:lnTo>
                        <a:pt x="1679" y="1329"/>
                      </a:lnTo>
                      <a:lnTo>
                        <a:pt x="1653" y="1315"/>
                      </a:lnTo>
                      <a:lnTo>
                        <a:pt x="1629" y="1301"/>
                      </a:lnTo>
                      <a:lnTo>
                        <a:pt x="1604" y="1287"/>
                      </a:lnTo>
                      <a:lnTo>
                        <a:pt x="1579" y="1273"/>
                      </a:lnTo>
                      <a:lnTo>
                        <a:pt x="1554" y="1259"/>
                      </a:lnTo>
                      <a:lnTo>
                        <a:pt x="1528" y="1245"/>
                      </a:lnTo>
                      <a:lnTo>
                        <a:pt x="1504" y="1232"/>
                      </a:lnTo>
                      <a:lnTo>
                        <a:pt x="1478" y="1218"/>
                      </a:lnTo>
                      <a:lnTo>
                        <a:pt x="1454" y="1206"/>
                      </a:lnTo>
                      <a:lnTo>
                        <a:pt x="1428" y="1193"/>
                      </a:lnTo>
                      <a:lnTo>
                        <a:pt x="1404" y="1180"/>
                      </a:lnTo>
                      <a:lnTo>
                        <a:pt x="1378" y="1168"/>
                      </a:lnTo>
                      <a:lnTo>
                        <a:pt x="1354" y="1156"/>
                      </a:lnTo>
                      <a:lnTo>
                        <a:pt x="1328" y="1144"/>
                      </a:lnTo>
                      <a:lnTo>
                        <a:pt x="1303" y="1133"/>
                      </a:lnTo>
                      <a:lnTo>
                        <a:pt x="1278" y="1122"/>
                      </a:lnTo>
                      <a:lnTo>
                        <a:pt x="1253" y="1111"/>
                      </a:lnTo>
                      <a:lnTo>
                        <a:pt x="1228" y="1101"/>
                      </a:lnTo>
                      <a:lnTo>
                        <a:pt x="1203" y="1091"/>
                      </a:lnTo>
                      <a:lnTo>
                        <a:pt x="1177" y="1080"/>
                      </a:lnTo>
                      <a:lnTo>
                        <a:pt x="1153" y="1072"/>
                      </a:lnTo>
                      <a:lnTo>
                        <a:pt x="1127" y="1063"/>
                      </a:lnTo>
                      <a:lnTo>
                        <a:pt x="1103" y="1054"/>
                      </a:lnTo>
                      <a:lnTo>
                        <a:pt x="1077" y="1046"/>
                      </a:lnTo>
                      <a:lnTo>
                        <a:pt x="1053" y="1040"/>
                      </a:lnTo>
                      <a:lnTo>
                        <a:pt x="1027" y="1031"/>
                      </a:lnTo>
                      <a:lnTo>
                        <a:pt x="1003" y="1026"/>
                      </a:lnTo>
                      <a:lnTo>
                        <a:pt x="977" y="1019"/>
                      </a:lnTo>
                      <a:lnTo>
                        <a:pt x="953" y="1015"/>
                      </a:lnTo>
                      <a:lnTo>
                        <a:pt x="927" y="1010"/>
                      </a:lnTo>
                      <a:lnTo>
                        <a:pt x="902" y="1006"/>
                      </a:lnTo>
                      <a:lnTo>
                        <a:pt x="877" y="1002"/>
                      </a:lnTo>
                      <a:lnTo>
                        <a:pt x="852" y="999"/>
                      </a:lnTo>
                      <a:lnTo>
                        <a:pt x="827" y="996"/>
                      </a:lnTo>
                      <a:lnTo>
                        <a:pt x="802" y="995"/>
                      </a:lnTo>
                      <a:lnTo>
                        <a:pt x="776" y="994"/>
                      </a:lnTo>
                      <a:lnTo>
                        <a:pt x="752" y="992"/>
                      </a:lnTo>
                      <a:lnTo>
                        <a:pt x="728" y="992"/>
                      </a:lnTo>
                      <a:lnTo>
                        <a:pt x="702" y="992"/>
                      </a:lnTo>
                      <a:lnTo>
                        <a:pt x="678" y="994"/>
                      </a:lnTo>
                      <a:lnTo>
                        <a:pt x="652" y="995"/>
                      </a:lnTo>
                      <a:lnTo>
                        <a:pt x="627" y="996"/>
                      </a:lnTo>
                      <a:lnTo>
                        <a:pt x="602" y="998"/>
                      </a:lnTo>
                      <a:lnTo>
                        <a:pt x="577" y="1000"/>
                      </a:lnTo>
                      <a:lnTo>
                        <a:pt x="552" y="1003"/>
                      </a:lnTo>
                      <a:lnTo>
                        <a:pt x="527" y="1006"/>
                      </a:lnTo>
                      <a:lnTo>
                        <a:pt x="501" y="1010"/>
                      </a:lnTo>
                      <a:lnTo>
                        <a:pt x="477" y="1014"/>
                      </a:lnTo>
                      <a:lnTo>
                        <a:pt x="451" y="1018"/>
                      </a:lnTo>
                      <a:lnTo>
                        <a:pt x="427" y="1022"/>
                      </a:lnTo>
                      <a:lnTo>
                        <a:pt x="401" y="1027"/>
                      </a:lnTo>
                      <a:lnTo>
                        <a:pt x="377" y="1031"/>
                      </a:lnTo>
                      <a:lnTo>
                        <a:pt x="351" y="1037"/>
                      </a:lnTo>
                      <a:lnTo>
                        <a:pt x="327" y="1042"/>
                      </a:lnTo>
                      <a:lnTo>
                        <a:pt x="301" y="1048"/>
                      </a:lnTo>
                      <a:lnTo>
                        <a:pt x="277" y="1053"/>
                      </a:lnTo>
                      <a:lnTo>
                        <a:pt x="251" y="1060"/>
                      </a:lnTo>
                      <a:lnTo>
                        <a:pt x="226" y="1065"/>
                      </a:lnTo>
                      <a:lnTo>
                        <a:pt x="201" y="1072"/>
                      </a:lnTo>
                      <a:lnTo>
                        <a:pt x="176" y="1077"/>
                      </a:lnTo>
                      <a:lnTo>
                        <a:pt x="151" y="1084"/>
                      </a:lnTo>
                      <a:lnTo>
                        <a:pt x="126" y="1091"/>
                      </a:lnTo>
                      <a:lnTo>
                        <a:pt x="100" y="1098"/>
                      </a:lnTo>
                      <a:lnTo>
                        <a:pt x="76" y="1105"/>
                      </a:lnTo>
                      <a:lnTo>
                        <a:pt x="50" y="1113"/>
                      </a:lnTo>
                      <a:lnTo>
                        <a:pt x="26" y="1119"/>
                      </a:lnTo>
                      <a:lnTo>
                        <a:pt x="0" y="1126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98" name="Freeform 163">
                  <a:extLst>
                    <a:ext uri="{FF2B5EF4-FFF2-40B4-BE49-F238E27FC236}">
                      <a16:creationId xmlns:a16="http://schemas.microsoft.com/office/drawing/2014/main" id="{41325D51-0734-F1DF-B8DD-F72885E3251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715963" y="2382838"/>
                  <a:ext cx="3143250" cy="647700"/>
                </a:xfrm>
                <a:custGeom>
                  <a:avLst/>
                  <a:gdLst>
                    <a:gd name="T0" fmla="*/ 26 w 1980"/>
                    <a:gd name="T1" fmla="*/ 15 h 408"/>
                    <a:gd name="T2" fmla="*/ 76 w 1980"/>
                    <a:gd name="T3" fmla="*/ 45 h 408"/>
                    <a:gd name="T4" fmla="*/ 126 w 1980"/>
                    <a:gd name="T5" fmla="*/ 74 h 408"/>
                    <a:gd name="T6" fmla="*/ 176 w 1980"/>
                    <a:gd name="T7" fmla="*/ 102 h 408"/>
                    <a:gd name="T8" fmla="*/ 226 w 1980"/>
                    <a:gd name="T9" fmla="*/ 131 h 408"/>
                    <a:gd name="T10" fmla="*/ 277 w 1980"/>
                    <a:gd name="T11" fmla="*/ 158 h 408"/>
                    <a:gd name="T12" fmla="*/ 327 w 1980"/>
                    <a:gd name="T13" fmla="*/ 183 h 408"/>
                    <a:gd name="T14" fmla="*/ 377 w 1980"/>
                    <a:gd name="T15" fmla="*/ 209 h 408"/>
                    <a:gd name="T16" fmla="*/ 427 w 1980"/>
                    <a:gd name="T17" fmla="*/ 235 h 408"/>
                    <a:gd name="T18" fmla="*/ 477 w 1980"/>
                    <a:gd name="T19" fmla="*/ 258 h 408"/>
                    <a:gd name="T20" fmla="*/ 527 w 1980"/>
                    <a:gd name="T21" fmla="*/ 281 h 408"/>
                    <a:gd name="T22" fmla="*/ 577 w 1980"/>
                    <a:gd name="T23" fmla="*/ 301 h 408"/>
                    <a:gd name="T24" fmla="*/ 627 w 1980"/>
                    <a:gd name="T25" fmla="*/ 322 h 408"/>
                    <a:gd name="T26" fmla="*/ 678 w 1980"/>
                    <a:gd name="T27" fmla="*/ 339 h 408"/>
                    <a:gd name="T28" fmla="*/ 728 w 1980"/>
                    <a:gd name="T29" fmla="*/ 355 h 408"/>
                    <a:gd name="T30" fmla="*/ 776 w 1980"/>
                    <a:gd name="T31" fmla="*/ 370 h 408"/>
                    <a:gd name="T32" fmla="*/ 827 w 1980"/>
                    <a:gd name="T33" fmla="*/ 381 h 408"/>
                    <a:gd name="T34" fmla="*/ 877 w 1980"/>
                    <a:gd name="T35" fmla="*/ 392 h 408"/>
                    <a:gd name="T36" fmla="*/ 927 w 1980"/>
                    <a:gd name="T37" fmla="*/ 399 h 408"/>
                    <a:gd name="T38" fmla="*/ 977 w 1980"/>
                    <a:gd name="T39" fmla="*/ 404 h 408"/>
                    <a:gd name="T40" fmla="*/ 1027 w 1980"/>
                    <a:gd name="T41" fmla="*/ 407 h 408"/>
                    <a:gd name="T42" fmla="*/ 1077 w 1980"/>
                    <a:gd name="T43" fmla="*/ 408 h 408"/>
                    <a:gd name="T44" fmla="*/ 1127 w 1980"/>
                    <a:gd name="T45" fmla="*/ 407 h 408"/>
                    <a:gd name="T46" fmla="*/ 1177 w 1980"/>
                    <a:gd name="T47" fmla="*/ 404 h 408"/>
                    <a:gd name="T48" fmla="*/ 1228 w 1980"/>
                    <a:gd name="T49" fmla="*/ 400 h 408"/>
                    <a:gd name="T50" fmla="*/ 1278 w 1980"/>
                    <a:gd name="T51" fmla="*/ 393 h 408"/>
                    <a:gd name="T52" fmla="*/ 1328 w 1980"/>
                    <a:gd name="T53" fmla="*/ 387 h 408"/>
                    <a:gd name="T54" fmla="*/ 1378 w 1980"/>
                    <a:gd name="T55" fmla="*/ 378 h 408"/>
                    <a:gd name="T56" fmla="*/ 1428 w 1980"/>
                    <a:gd name="T57" fmla="*/ 368 h 408"/>
                    <a:gd name="T58" fmla="*/ 1478 w 1980"/>
                    <a:gd name="T59" fmla="*/ 358 h 408"/>
                    <a:gd name="T60" fmla="*/ 1528 w 1980"/>
                    <a:gd name="T61" fmla="*/ 346 h 408"/>
                    <a:gd name="T62" fmla="*/ 1579 w 1980"/>
                    <a:gd name="T63" fmla="*/ 334 h 408"/>
                    <a:gd name="T64" fmla="*/ 1629 w 1980"/>
                    <a:gd name="T65" fmla="*/ 322 h 408"/>
                    <a:gd name="T66" fmla="*/ 1679 w 1980"/>
                    <a:gd name="T67" fmla="*/ 308 h 408"/>
                    <a:gd name="T68" fmla="*/ 1729 w 1980"/>
                    <a:gd name="T69" fmla="*/ 294 h 408"/>
                    <a:gd name="T70" fmla="*/ 1779 w 1980"/>
                    <a:gd name="T71" fmla="*/ 281 h 408"/>
                    <a:gd name="T72" fmla="*/ 1829 w 1980"/>
                    <a:gd name="T73" fmla="*/ 266 h 408"/>
                    <a:gd name="T74" fmla="*/ 1879 w 1980"/>
                    <a:gd name="T75" fmla="*/ 251 h 408"/>
                    <a:gd name="T76" fmla="*/ 1929 w 1980"/>
                    <a:gd name="T77" fmla="*/ 236 h 408"/>
                    <a:gd name="T78" fmla="*/ 1980 w 1980"/>
                    <a:gd name="T79" fmla="*/ 220 h 40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</a:cxnLst>
                  <a:rect l="0" t="0" r="r" b="b"/>
                  <a:pathLst>
                    <a:path w="1980" h="408">
                      <a:moveTo>
                        <a:pt x="0" y="0"/>
                      </a:moveTo>
                      <a:lnTo>
                        <a:pt x="26" y="15"/>
                      </a:lnTo>
                      <a:lnTo>
                        <a:pt x="50" y="30"/>
                      </a:lnTo>
                      <a:lnTo>
                        <a:pt x="76" y="45"/>
                      </a:lnTo>
                      <a:lnTo>
                        <a:pt x="100" y="59"/>
                      </a:lnTo>
                      <a:lnTo>
                        <a:pt x="126" y="74"/>
                      </a:lnTo>
                      <a:lnTo>
                        <a:pt x="151" y="89"/>
                      </a:lnTo>
                      <a:lnTo>
                        <a:pt x="176" y="102"/>
                      </a:lnTo>
                      <a:lnTo>
                        <a:pt x="201" y="116"/>
                      </a:lnTo>
                      <a:lnTo>
                        <a:pt x="226" y="131"/>
                      </a:lnTo>
                      <a:lnTo>
                        <a:pt x="251" y="144"/>
                      </a:lnTo>
                      <a:lnTo>
                        <a:pt x="277" y="158"/>
                      </a:lnTo>
                      <a:lnTo>
                        <a:pt x="301" y="171"/>
                      </a:lnTo>
                      <a:lnTo>
                        <a:pt x="327" y="183"/>
                      </a:lnTo>
                      <a:lnTo>
                        <a:pt x="351" y="197"/>
                      </a:lnTo>
                      <a:lnTo>
                        <a:pt x="377" y="209"/>
                      </a:lnTo>
                      <a:lnTo>
                        <a:pt x="401" y="223"/>
                      </a:lnTo>
                      <a:lnTo>
                        <a:pt x="427" y="235"/>
                      </a:lnTo>
                      <a:lnTo>
                        <a:pt x="451" y="246"/>
                      </a:lnTo>
                      <a:lnTo>
                        <a:pt x="477" y="258"/>
                      </a:lnTo>
                      <a:lnTo>
                        <a:pt x="501" y="270"/>
                      </a:lnTo>
                      <a:lnTo>
                        <a:pt x="527" y="281"/>
                      </a:lnTo>
                      <a:lnTo>
                        <a:pt x="552" y="292"/>
                      </a:lnTo>
                      <a:lnTo>
                        <a:pt x="577" y="301"/>
                      </a:lnTo>
                      <a:lnTo>
                        <a:pt x="602" y="312"/>
                      </a:lnTo>
                      <a:lnTo>
                        <a:pt x="627" y="322"/>
                      </a:lnTo>
                      <a:lnTo>
                        <a:pt x="652" y="331"/>
                      </a:lnTo>
                      <a:lnTo>
                        <a:pt x="678" y="339"/>
                      </a:lnTo>
                      <a:lnTo>
                        <a:pt x="702" y="347"/>
                      </a:lnTo>
                      <a:lnTo>
                        <a:pt x="728" y="355"/>
                      </a:lnTo>
                      <a:lnTo>
                        <a:pt x="752" y="364"/>
                      </a:lnTo>
                      <a:lnTo>
                        <a:pt x="776" y="370"/>
                      </a:lnTo>
                      <a:lnTo>
                        <a:pt x="802" y="376"/>
                      </a:lnTo>
                      <a:lnTo>
                        <a:pt x="827" y="381"/>
                      </a:lnTo>
                      <a:lnTo>
                        <a:pt x="852" y="387"/>
                      </a:lnTo>
                      <a:lnTo>
                        <a:pt x="877" y="392"/>
                      </a:lnTo>
                      <a:lnTo>
                        <a:pt x="902" y="396"/>
                      </a:lnTo>
                      <a:lnTo>
                        <a:pt x="927" y="399"/>
                      </a:lnTo>
                      <a:lnTo>
                        <a:pt x="953" y="401"/>
                      </a:lnTo>
                      <a:lnTo>
                        <a:pt x="977" y="404"/>
                      </a:lnTo>
                      <a:lnTo>
                        <a:pt x="1003" y="406"/>
                      </a:lnTo>
                      <a:lnTo>
                        <a:pt x="1027" y="407"/>
                      </a:lnTo>
                      <a:lnTo>
                        <a:pt x="1053" y="408"/>
                      </a:lnTo>
                      <a:lnTo>
                        <a:pt x="1077" y="408"/>
                      </a:lnTo>
                      <a:lnTo>
                        <a:pt x="1103" y="408"/>
                      </a:lnTo>
                      <a:lnTo>
                        <a:pt x="1127" y="407"/>
                      </a:lnTo>
                      <a:lnTo>
                        <a:pt x="1153" y="406"/>
                      </a:lnTo>
                      <a:lnTo>
                        <a:pt x="1177" y="404"/>
                      </a:lnTo>
                      <a:lnTo>
                        <a:pt x="1203" y="403"/>
                      </a:lnTo>
                      <a:lnTo>
                        <a:pt x="1228" y="400"/>
                      </a:lnTo>
                      <a:lnTo>
                        <a:pt x="1253" y="397"/>
                      </a:lnTo>
                      <a:lnTo>
                        <a:pt x="1278" y="393"/>
                      </a:lnTo>
                      <a:lnTo>
                        <a:pt x="1303" y="391"/>
                      </a:lnTo>
                      <a:lnTo>
                        <a:pt x="1328" y="387"/>
                      </a:lnTo>
                      <a:lnTo>
                        <a:pt x="1354" y="383"/>
                      </a:lnTo>
                      <a:lnTo>
                        <a:pt x="1378" y="378"/>
                      </a:lnTo>
                      <a:lnTo>
                        <a:pt x="1404" y="373"/>
                      </a:lnTo>
                      <a:lnTo>
                        <a:pt x="1428" y="368"/>
                      </a:lnTo>
                      <a:lnTo>
                        <a:pt x="1454" y="364"/>
                      </a:lnTo>
                      <a:lnTo>
                        <a:pt x="1478" y="358"/>
                      </a:lnTo>
                      <a:lnTo>
                        <a:pt x="1504" y="353"/>
                      </a:lnTo>
                      <a:lnTo>
                        <a:pt x="1528" y="346"/>
                      </a:lnTo>
                      <a:lnTo>
                        <a:pt x="1554" y="341"/>
                      </a:lnTo>
                      <a:lnTo>
                        <a:pt x="1579" y="334"/>
                      </a:lnTo>
                      <a:lnTo>
                        <a:pt x="1604" y="328"/>
                      </a:lnTo>
                      <a:lnTo>
                        <a:pt x="1629" y="322"/>
                      </a:lnTo>
                      <a:lnTo>
                        <a:pt x="1653" y="315"/>
                      </a:lnTo>
                      <a:lnTo>
                        <a:pt x="1679" y="308"/>
                      </a:lnTo>
                      <a:lnTo>
                        <a:pt x="1703" y="301"/>
                      </a:lnTo>
                      <a:lnTo>
                        <a:pt x="1729" y="294"/>
                      </a:lnTo>
                      <a:lnTo>
                        <a:pt x="1753" y="288"/>
                      </a:lnTo>
                      <a:lnTo>
                        <a:pt x="1779" y="281"/>
                      </a:lnTo>
                      <a:lnTo>
                        <a:pt x="1803" y="273"/>
                      </a:lnTo>
                      <a:lnTo>
                        <a:pt x="1829" y="266"/>
                      </a:lnTo>
                      <a:lnTo>
                        <a:pt x="1854" y="258"/>
                      </a:lnTo>
                      <a:lnTo>
                        <a:pt x="1879" y="251"/>
                      </a:lnTo>
                      <a:lnTo>
                        <a:pt x="1904" y="243"/>
                      </a:lnTo>
                      <a:lnTo>
                        <a:pt x="1929" y="236"/>
                      </a:lnTo>
                      <a:lnTo>
                        <a:pt x="1954" y="228"/>
                      </a:lnTo>
                      <a:lnTo>
                        <a:pt x="1980" y="220"/>
                      </a:lnTo>
                    </a:path>
                  </a:pathLst>
                </a:cu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99" name="Freeform 164">
                  <a:extLst>
                    <a:ext uri="{FF2B5EF4-FFF2-40B4-BE49-F238E27FC236}">
                      <a16:creationId xmlns:a16="http://schemas.microsoft.com/office/drawing/2014/main" id="{41935F64-56F7-B453-642D-29C0954FD20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715963" y="3957638"/>
                  <a:ext cx="3143250" cy="819150"/>
                </a:xfrm>
                <a:custGeom>
                  <a:avLst/>
                  <a:gdLst>
                    <a:gd name="T0" fmla="*/ 1954 w 1980"/>
                    <a:gd name="T1" fmla="*/ 501 h 516"/>
                    <a:gd name="T2" fmla="*/ 1904 w 1980"/>
                    <a:gd name="T3" fmla="*/ 472 h 516"/>
                    <a:gd name="T4" fmla="*/ 1854 w 1980"/>
                    <a:gd name="T5" fmla="*/ 440 h 516"/>
                    <a:gd name="T6" fmla="*/ 1803 w 1980"/>
                    <a:gd name="T7" fmla="*/ 411 h 516"/>
                    <a:gd name="T8" fmla="*/ 1753 w 1980"/>
                    <a:gd name="T9" fmla="*/ 381 h 516"/>
                    <a:gd name="T10" fmla="*/ 1703 w 1980"/>
                    <a:gd name="T11" fmla="*/ 352 h 516"/>
                    <a:gd name="T12" fmla="*/ 1653 w 1980"/>
                    <a:gd name="T13" fmla="*/ 323 h 516"/>
                    <a:gd name="T14" fmla="*/ 1604 w 1980"/>
                    <a:gd name="T15" fmla="*/ 295 h 516"/>
                    <a:gd name="T16" fmla="*/ 1554 w 1980"/>
                    <a:gd name="T17" fmla="*/ 267 h 516"/>
                    <a:gd name="T18" fmla="*/ 1504 w 1980"/>
                    <a:gd name="T19" fmla="*/ 240 h 516"/>
                    <a:gd name="T20" fmla="*/ 1454 w 1980"/>
                    <a:gd name="T21" fmla="*/ 214 h 516"/>
                    <a:gd name="T22" fmla="*/ 1404 w 1980"/>
                    <a:gd name="T23" fmla="*/ 188 h 516"/>
                    <a:gd name="T24" fmla="*/ 1354 w 1980"/>
                    <a:gd name="T25" fmla="*/ 164 h 516"/>
                    <a:gd name="T26" fmla="*/ 1303 w 1980"/>
                    <a:gd name="T27" fmla="*/ 141 h 516"/>
                    <a:gd name="T28" fmla="*/ 1253 w 1980"/>
                    <a:gd name="T29" fmla="*/ 119 h 516"/>
                    <a:gd name="T30" fmla="*/ 1203 w 1980"/>
                    <a:gd name="T31" fmla="*/ 99 h 516"/>
                    <a:gd name="T32" fmla="*/ 1153 w 1980"/>
                    <a:gd name="T33" fmla="*/ 80 h 516"/>
                    <a:gd name="T34" fmla="*/ 1103 w 1980"/>
                    <a:gd name="T35" fmla="*/ 62 h 516"/>
                    <a:gd name="T36" fmla="*/ 1053 w 1980"/>
                    <a:gd name="T37" fmla="*/ 48 h 516"/>
                    <a:gd name="T38" fmla="*/ 1003 w 1980"/>
                    <a:gd name="T39" fmla="*/ 34 h 516"/>
                    <a:gd name="T40" fmla="*/ 953 w 1980"/>
                    <a:gd name="T41" fmla="*/ 23 h 516"/>
                    <a:gd name="T42" fmla="*/ 902 w 1980"/>
                    <a:gd name="T43" fmla="*/ 14 h 516"/>
                    <a:gd name="T44" fmla="*/ 852 w 1980"/>
                    <a:gd name="T45" fmla="*/ 7 h 516"/>
                    <a:gd name="T46" fmla="*/ 802 w 1980"/>
                    <a:gd name="T47" fmla="*/ 3 h 516"/>
                    <a:gd name="T48" fmla="*/ 752 w 1980"/>
                    <a:gd name="T49" fmla="*/ 0 h 516"/>
                    <a:gd name="T50" fmla="*/ 702 w 1980"/>
                    <a:gd name="T51" fmla="*/ 0 h 516"/>
                    <a:gd name="T52" fmla="*/ 652 w 1980"/>
                    <a:gd name="T53" fmla="*/ 3 h 516"/>
                    <a:gd name="T54" fmla="*/ 602 w 1980"/>
                    <a:gd name="T55" fmla="*/ 6 h 516"/>
                    <a:gd name="T56" fmla="*/ 552 w 1980"/>
                    <a:gd name="T57" fmla="*/ 11 h 516"/>
                    <a:gd name="T58" fmla="*/ 501 w 1980"/>
                    <a:gd name="T59" fmla="*/ 18 h 516"/>
                    <a:gd name="T60" fmla="*/ 451 w 1980"/>
                    <a:gd name="T61" fmla="*/ 26 h 516"/>
                    <a:gd name="T62" fmla="*/ 401 w 1980"/>
                    <a:gd name="T63" fmla="*/ 35 h 516"/>
                    <a:gd name="T64" fmla="*/ 351 w 1980"/>
                    <a:gd name="T65" fmla="*/ 45 h 516"/>
                    <a:gd name="T66" fmla="*/ 301 w 1980"/>
                    <a:gd name="T67" fmla="*/ 56 h 516"/>
                    <a:gd name="T68" fmla="*/ 251 w 1980"/>
                    <a:gd name="T69" fmla="*/ 68 h 516"/>
                    <a:gd name="T70" fmla="*/ 201 w 1980"/>
                    <a:gd name="T71" fmla="*/ 80 h 516"/>
                    <a:gd name="T72" fmla="*/ 151 w 1980"/>
                    <a:gd name="T73" fmla="*/ 92 h 516"/>
                    <a:gd name="T74" fmla="*/ 100 w 1980"/>
                    <a:gd name="T75" fmla="*/ 106 h 516"/>
                    <a:gd name="T76" fmla="*/ 50 w 1980"/>
                    <a:gd name="T77" fmla="*/ 121 h 516"/>
                    <a:gd name="T78" fmla="*/ 0 w 1980"/>
                    <a:gd name="T79" fmla="*/ 134 h 51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</a:cxnLst>
                  <a:rect l="0" t="0" r="r" b="b"/>
                  <a:pathLst>
                    <a:path w="1980" h="516">
                      <a:moveTo>
                        <a:pt x="1980" y="516"/>
                      </a:moveTo>
                      <a:lnTo>
                        <a:pt x="1954" y="501"/>
                      </a:lnTo>
                      <a:lnTo>
                        <a:pt x="1929" y="487"/>
                      </a:lnTo>
                      <a:lnTo>
                        <a:pt x="1904" y="472"/>
                      </a:lnTo>
                      <a:lnTo>
                        <a:pt x="1879" y="455"/>
                      </a:lnTo>
                      <a:lnTo>
                        <a:pt x="1854" y="440"/>
                      </a:lnTo>
                      <a:lnTo>
                        <a:pt x="1829" y="426"/>
                      </a:lnTo>
                      <a:lnTo>
                        <a:pt x="1803" y="411"/>
                      </a:lnTo>
                      <a:lnTo>
                        <a:pt x="1779" y="396"/>
                      </a:lnTo>
                      <a:lnTo>
                        <a:pt x="1753" y="381"/>
                      </a:lnTo>
                      <a:lnTo>
                        <a:pt x="1729" y="366"/>
                      </a:lnTo>
                      <a:lnTo>
                        <a:pt x="1703" y="352"/>
                      </a:lnTo>
                      <a:lnTo>
                        <a:pt x="1679" y="337"/>
                      </a:lnTo>
                      <a:lnTo>
                        <a:pt x="1653" y="323"/>
                      </a:lnTo>
                      <a:lnTo>
                        <a:pt x="1629" y="309"/>
                      </a:lnTo>
                      <a:lnTo>
                        <a:pt x="1604" y="295"/>
                      </a:lnTo>
                      <a:lnTo>
                        <a:pt x="1579" y="281"/>
                      </a:lnTo>
                      <a:lnTo>
                        <a:pt x="1554" y="267"/>
                      </a:lnTo>
                      <a:lnTo>
                        <a:pt x="1528" y="253"/>
                      </a:lnTo>
                      <a:lnTo>
                        <a:pt x="1504" y="240"/>
                      </a:lnTo>
                      <a:lnTo>
                        <a:pt x="1478" y="226"/>
                      </a:lnTo>
                      <a:lnTo>
                        <a:pt x="1454" y="214"/>
                      </a:lnTo>
                      <a:lnTo>
                        <a:pt x="1428" y="201"/>
                      </a:lnTo>
                      <a:lnTo>
                        <a:pt x="1404" y="188"/>
                      </a:lnTo>
                      <a:lnTo>
                        <a:pt x="1378" y="176"/>
                      </a:lnTo>
                      <a:lnTo>
                        <a:pt x="1354" y="164"/>
                      </a:lnTo>
                      <a:lnTo>
                        <a:pt x="1328" y="152"/>
                      </a:lnTo>
                      <a:lnTo>
                        <a:pt x="1303" y="141"/>
                      </a:lnTo>
                      <a:lnTo>
                        <a:pt x="1278" y="130"/>
                      </a:lnTo>
                      <a:lnTo>
                        <a:pt x="1253" y="119"/>
                      </a:lnTo>
                      <a:lnTo>
                        <a:pt x="1228" y="109"/>
                      </a:lnTo>
                      <a:lnTo>
                        <a:pt x="1203" y="99"/>
                      </a:lnTo>
                      <a:lnTo>
                        <a:pt x="1177" y="88"/>
                      </a:lnTo>
                      <a:lnTo>
                        <a:pt x="1153" y="80"/>
                      </a:lnTo>
                      <a:lnTo>
                        <a:pt x="1127" y="71"/>
                      </a:lnTo>
                      <a:lnTo>
                        <a:pt x="1103" y="62"/>
                      </a:lnTo>
                      <a:lnTo>
                        <a:pt x="1077" y="54"/>
                      </a:lnTo>
                      <a:lnTo>
                        <a:pt x="1053" y="48"/>
                      </a:lnTo>
                      <a:lnTo>
                        <a:pt x="1027" y="39"/>
                      </a:lnTo>
                      <a:lnTo>
                        <a:pt x="1003" y="34"/>
                      </a:lnTo>
                      <a:lnTo>
                        <a:pt x="977" y="27"/>
                      </a:lnTo>
                      <a:lnTo>
                        <a:pt x="953" y="23"/>
                      </a:lnTo>
                      <a:lnTo>
                        <a:pt x="927" y="18"/>
                      </a:lnTo>
                      <a:lnTo>
                        <a:pt x="902" y="14"/>
                      </a:lnTo>
                      <a:lnTo>
                        <a:pt x="877" y="10"/>
                      </a:lnTo>
                      <a:lnTo>
                        <a:pt x="852" y="7"/>
                      </a:lnTo>
                      <a:lnTo>
                        <a:pt x="827" y="4"/>
                      </a:lnTo>
                      <a:lnTo>
                        <a:pt x="802" y="3"/>
                      </a:lnTo>
                      <a:lnTo>
                        <a:pt x="776" y="2"/>
                      </a:lnTo>
                      <a:lnTo>
                        <a:pt x="752" y="0"/>
                      </a:lnTo>
                      <a:lnTo>
                        <a:pt x="728" y="0"/>
                      </a:lnTo>
                      <a:lnTo>
                        <a:pt x="702" y="0"/>
                      </a:lnTo>
                      <a:lnTo>
                        <a:pt x="678" y="2"/>
                      </a:lnTo>
                      <a:lnTo>
                        <a:pt x="652" y="3"/>
                      </a:lnTo>
                      <a:lnTo>
                        <a:pt x="627" y="4"/>
                      </a:lnTo>
                      <a:lnTo>
                        <a:pt x="602" y="6"/>
                      </a:lnTo>
                      <a:lnTo>
                        <a:pt x="577" y="8"/>
                      </a:lnTo>
                      <a:lnTo>
                        <a:pt x="552" y="11"/>
                      </a:lnTo>
                      <a:lnTo>
                        <a:pt x="527" y="14"/>
                      </a:lnTo>
                      <a:lnTo>
                        <a:pt x="501" y="18"/>
                      </a:lnTo>
                      <a:lnTo>
                        <a:pt x="477" y="22"/>
                      </a:lnTo>
                      <a:lnTo>
                        <a:pt x="451" y="26"/>
                      </a:lnTo>
                      <a:lnTo>
                        <a:pt x="427" y="30"/>
                      </a:lnTo>
                      <a:lnTo>
                        <a:pt x="401" y="35"/>
                      </a:lnTo>
                      <a:lnTo>
                        <a:pt x="377" y="39"/>
                      </a:lnTo>
                      <a:lnTo>
                        <a:pt x="351" y="45"/>
                      </a:lnTo>
                      <a:lnTo>
                        <a:pt x="327" y="50"/>
                      </a:lnTo>
                      <a:lnTo>
                        <a:pt x="301" y="56"/>
                      </a:lnTo>
                      <a:lnTo>
                        <a:pt x="277" y="61"/>
                      </a:lnTo>
                      <a:lnTo>
                        <a:pt x="251" y="68"/>
                      </a:lnTo>
                      <a:lnTo>
                        <a:pt x="226" y="73"/>
                      </a:lnTo>
                      <a:lnTo>
                        <a:pt x="201" y="80"/>
                      </a:lnTo>
                      <a:lnTo>
                        <a:pt x="176" y="85"/>
                      </a:lnTo>
                      <a:lnTo>
                        <a:pt x="151" y="92"/>
                      </a:lnTo>
                      <a:lnTo>
                        <a:pt x="126" y="99"/>
                      </a:lnTo>
                      <a:lnTo>
                        <a:pt x="100" y="106"/>
                      </a:lnTo>
                      <a:lnTo>
                        <a:pt x="76" y="113"/>
                      </a:lnTo>
                      <a:lnTo>
                        <a:pt x="50" y="121"/>
                      </a:lnTo>
                      <a:lnTo>
                        <a:pt x="26" y="127"/>
                      </a:lnTo>
                      <a:lnTo>
                        <a:pt x="0" y="134"/>
                      </a:lnTo>
                    </a:path>
                  </a:pathLst>
                </a:cu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00" name="Freeform 165">
                  <a:extLst>
                    <a:ext uri="{FF2B5EF4-FFF2-40B4-BE49-F238E27FC236}">
                      <a16:creationId xmlns:a16="http://schemas.microsoft.com/office/drawing/2014/main" id="{F016F24D-C7BC-4D3C-2337-995023835E4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715963" y="3278188"/>
                  <a:ext cx="3143250" cy="477837"/>
                </a:xfrm>
                <a:custGeom>
                  <a:avLst/>
                  <a:gdLst>
                    <a:gd name="T0" fmla="*/ 26 w 1980"/>
                    <a:gd name="T1" fmla="*/ 3 h 301"/>
                    <a:gd name="T2" fmla="*/ 76 w 1980"/>
                    <a:gd name="T3" fmla="*/ 11 h 301"/>
                    <a:gd name="T4" fmla="*/ 126 w 1980"/>
                    <a:gd name="T5" fmla="*/ 19 h 301"/>
                    <a:gd name="T6" fmla="*/ 176 w 1980"/>
                    <a:gd name="T7" fmla="*/ 26 h 301"/>
                    <a:gd name="T8" fmla="*/ 226 w 1980"/>
                    <a:gd name="T9" fmla="*/ 34 h 301"/>
                    <a:gd name="T10" fmla="*/ 277 w 1980"/>
                    <a:gd name="T11" fmla="*/ 41 h 301"/>
                    <a:gd name="T12" fmla="*/ 327 w 1980"/>
                    <a:gd name="T13" fmla="*/ 49 h 301"/>
                    <a:gd name="T14" fmla="*/ 377 w 1980"/>
                    <a:gd name="T15" fmla="*/ 57 h 301"/>
                    <a:gd name="T16" fmla="*/ 427 w 1980"/>
                    <a:gd name="T17" fmla="*/ 64 h 301"/>
                    <a:gd name="T18" fmla="*/ 477 w 1980"/>
                    <a:gd name="T19" fmla="*/ 72 h 301"/>
                    <a:gd name="T20" fmla="*/ 527 w 1980"/>
                    <a:gd name="T21" fmla="*/ 80 h 301"/>
                    <a:gd name="T22" fmla="*/ 577 w 1980"/>
                    <a:gd name="T23" fmla="*/ 87 h 301"/>
                    <a:gd name="T24" fmla="*/ 627 w 1980"/>
                    <a:gd name="T25" fmla="*/ 95 h 301"/>
                    <a:gd name="T26" fmla="*/ 678 w 1980"/>
                    <a:gd name="T27" fmla="*/ 103 h 301"/>
                    <a:gd name="T28" fmla="*/ 728 w 1980"/>
                    <a:gd name="T29" fmla="*/ 110 h 301"/>
                    <a:gd name="T30" fmla="*/ 776 w 1980"/>
                    <a:gd name="T31" fmla="*/ 118 h 301"/>
                    <a:gd name="T32" fmla="*/ 827 w 1980"/>
                    <a:gd name="T33" fmla="*/ 125 h 301"/>
                    <a:gd name="T34" fmla="*/ 877 w 1980"/>
                    <a:gd name="T35" fmla="*/ 133 h 301"/>
                    <a:gd name="T36" fmla="*/ 927 w 1980"/>
                    <a:gd name="T37" fmla="*/ 141 h 301"/>
                    <a:gd name="T38" fmla="*/ 977 w 1980"/>
                    <a:gd name="T39" fmla="*/ 148 h 301"/>
                    <a:gd name="T40" fmla="*/ 1027 w 1980"/>
                    <a:gd name="T41" fmla="*/ 156 h 301"/>
                    <a:gd name="T42" fmla="*/ 1077 w 1980"/>
                    <a:gd name="T43" fmla="*/ 164 h 301"/>
                    <a:gd name="T44" fmla="*/ 1127 w 1980"/>
                    <a:gd name="T45" fmla="*/ 171 h 301"/>
                    <a:gd name="T46" fmla="*/ 1177 w 1980"/>
                    <a:gd name="T47" fmla="*/ 179 h 301"/>
                    <a:gd name="T48" fmla="*/ 1228 w 1980"/>
                    <a:gd name="T49" fmla="*/ 186 h 301"/>
                    <a:gd name="T50" fmla="*/ 1278 w 1980"/>
                    <a:gd name="T51" fmla="*/ 194 h 301"/>
                    <a:gd name="T52" fmla="*/ 1328 w 1980"/>
                    <a:gd name="T53" fmla="*/ 202 h 301"/>
                    <a:gd name="T54" fmla="*/ 1378 w 1980"/>
                    <a:gd name="T55" fmla="*/ 209 h 301"/>
                    <a:gd name="T56" fmla="*/ 1428 w 1980"/>
                    <a:gd name="T57" fmla="*/ 217 h 301"/>
                    <a:gd name="T58" fmla="*/ 1478 w 1980"/>
                    <a:gd name="T59" fmla="*/ 225 h 301"/>
                    <a:gd name="T60" fmla="*/ 1528 w 1980"/>
                    <a:gd name="T61" fmla="*/ 232 h 301"/>
                    <a:gd name="T62" fmla="*/ 1579 w 1980"/>
                    <a:gd name="T63" fmla="*/ 240 h 301"/>
                    <a:gd name="T64" fmla="*/ 1629 w 1980"/>
                    <a:gd name="T65" fmla="*/ 247 h 301"/>
                    <a:gd name="T66" fmla="*/ 1679 w 1980"/>
                    <a:gd name="T67" fmla="*/ 255 h 301"/>
                    <a:gd name="T68" fmla="*/ 1729 w 1980"/>
                    <a:gd name="T69" fmla="*/ 263 h 301"/>
                    <a:gd name="T70" fmla="*/ 1779 w 1980"/>
                    <a:gd name="T71" fmla="*/ 270 h 301"/>
                    <a:gd name="T72" fmla="*/ 1829 w 1980"/>
                    <a:gd name="T73" fmla="*/ 278 h 301"/>
                    <a:gd name="T74" fmla="*/ 1879 w 1980"/>
                    <a:gd name="T75" fmla="*/ 286 h 301"/>
                    <a:gd name="T76" fmla="*/ 1929 w 1980"/>
                    <a:gd name="T77" fmla="*/ 293 h 301"/>
                    <a:gd name="T78" fmla="*/ 1980 w 1980"/>
                    <a:gd name="T79" fmla="*/ 301 h 30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</a:cxnLst>
                  <a:rect l="0" t="0" r="r" b="b"/>
                  <a:pathLst>
                    <a:path w="1980" h="301">
                      <a:moveTo>
                        <a:pt x="0" y="0"/>
                      </a:moveTo>
                      <a:lnTo>
                        <a:pt x="26" y="3"/>
                      </a:lnTo>
                      <a:lnTo>
                        <a:pt x="50" y="7"/>
                      </a:lnTo>
                      <a:lnTo>
                        <a:pt x="76" y="11"/>
                      </a:lnTo>
                      <a:lnTo>
                        <a:pt x="100" y="15"/>
                      </a:lnTo>
                      <a:lnTo>
                        <a:pt x="126" y="19"/>
                      </a:lnTo>
                      <a:lnTo>
                        <a:pt x="151" y="22"/>
                      </a:lnTo>
                      <a:lnTo>
                        <a:pt x="176" y="26"/>
                      </a:lnTo>
                      <a:lnTo>
                        <a:pt x="201" y="30"/>
                      </a:lnTo>
                      <a:lnTo>
                        <a:pt x="226" y="34"/>
                      </a:lnTo>
                      <a:lnTo>
                        <a:pt x="251" y="38"/>
                      </a:lnTo>
                      <a:lnTo>
                        <a:pt x="277" y="41"/>
                      </a:lnTo>
                      <a:lnTo>
                        <a:pt x="301" y="45"/>
                      </a:lnTo>
                      <a:lnTo>
                        <a:pt x="327" y="49"/>
                      </a:lnTo>
                      <a:lnTo>
                        <a:pt x="351" y="53"/>
                      </a:lnTo>
                      <a:lnTo>
                        <a:pt x="377" y="57"/>
                      </a:lnTo>
                      <a:lnTo>
                        <a:pt x="401" y="61"/>
                      </a:lnTo>
                      <a:lnTo>
                        <a:pt x="427" y="64"/>
                      </a:lnTo>
                      <a:lnTo>
                        <a:pt x="451" y="68"/>
                      </a:lnTo>
                      <a:lnTo>
                        <a:pt x="477" y="72"/>
                      </a:lnTo>
                      <a:lnTo>
                        <a:pt x="501" y="76"/>
                      </a:lnTo>
                      <a:lnTo>
                        <a:pt x="527" y="80"/>
                      </a:lnTo>
                      <a:lnTo>
                        <a:pt x="552" y="83"/>
                      </a:lnTo>
                      <a:lnTo>
                        <a:pt x="577" y="87"/>
                      </a:lnTo>
                      <a:lnTo>
                        <a:pt x="602" y="91"/>
                      </a:lnTo>
                      <a:lnTo>
                        <a:pt x="627" y="95"/>
                      </a:lnTo>
                      <a:lnTo>
                        <a:pt x="652" y="99"/>
                      </a:lnTo>
                      <a:lnTo>
                        <a:pt x="678" y="103"/>
                      </a:lnTo>
                      <a:lnTo>
                        <a:pt x="702" y="106"/>
                      </a:lnTo>
                      <a:lnTo>
                        <a:pt x="728" y="110"/>
                      </a:lnTo>
                      <a:lnTo>
                        <a:pt x="752" y="114"/>
                      </a:lnTo>
                      <a:lnTo>
                        <a:pt x="776" y="118"/>
                      </a:lnTo>
                      <a:lnTo>
                        <a:pt x="802" y="122"/>
                      </a:lnTo>
                      <a:lnTo>
                        <a:pt x="827" y="125"/>
                      </a:lnTo>
                      <a:lnTo>
                        <a:pt x="852" y="129"/>
                      </a:lnTo>
                      <a:lnTo>
                        <a:pt x="877" y="133"/>
                      </a:lnTo>
                      <a:lnTo>
                        <a:pt x="902" y="137"/>
                      </a:lnTo>
                      <a:lnTo>
                        <a:pt x="927" y="141"/>
                      </a:lnTo>
                      <a:lnTo>
                        <a:pt x="953" y="144"/>
                      </a:lnTo>
                      <a:lnTo>
                        <a:pt x="977" y="148"/>
                      </a:lnTo>
                      <a:lnTo>
                        <a:pt x="1003" y="152"/>
                      </a:lnTo>
                      <a:lnTo>
                        <a:pt x="1027" y="156"/>
                      </a:lnTo>
                      <a:lnTo>
                        <a:pt x="1053" y="160"/>
                      </a:lnTo>
                      <a:lnTo>
                        <a:pt x="1077" y="164"/>
                      </a:lnTo>
                      <a:lnTo>
                        <a:pt x="1103" y="167"/>
                      </a:lnTo>
                      <a:lnTo>
                        <a:pt x="1127" y="171"/>
                      </a:lnTo>
                      <a:lnTo>
                        <a:pt x="1153" y="175"/>
                      </a:lnTo>
                      <a:lnTo>
                        <a:pt x="1177" y="179"/>
                      </a:lnTo>
                      <a:lnTo>
                        <a:pt x="1203" y="183"/>
                      </a:lnTo>
                      <a:lnTo>
                        <a:pt x="1228" y="186"/>
                      </a:lnTo>
                      <a:lnTo>
                        <a:pt x="1253" y="190"/>
                      </a:lnTo>
                      <a:lnTo>
                        <a:pt x="1278" y="194"/>
                      </a:lnTo>
                      <a:lnTo>
                        <a:pt x="1303" y="198"/>
                      </a:lnTo>
                      <a:lnTo>
                        <a:pt x="1328" y="202"/>
                      </a:lnTo>
                      <a:lnTo>
                        <a:pt x="1354" y="206"/>
                      </a:lnTo>
                      <a:lnTo>
                        <a:pt x="1378" y="209"/>
                      </a:lnTo>
                      <a:lnTo>
                        <a:pt x="1404" y="213"/>
                      </a:lnTo>
                      <a:lnTo>
                        <a:pt x="1428" y="217"/>
                      </a:lnTo>
                      <a:lnTo>
                        <a:pt x="1454" y="221"/>
                      </a:lnTo>
                      <a:lnTo>
                        <a:pt x="1478" y="225"/>
                      </a:lnTo>
                      <a:lnTo>
                        <a:pt x="1504" y="228"/>
                      </a:lnTo>
                      <a:lnTo>
                        <a:pt x="1528" y="232"/>
                      </a:lnTo>
                      <a:lnTo>
                        <a:pt x="1554" y="236"/>
                      </a:lnTo>
                      <a:lnTo>
                        <a:pt x="1579" y="240"/>
                      </a:lnTo>
                      <a:lnTo>
                        <a:pt x="1604" y="244"/>
                      </a:lnTo>
                      <a:lnTo>
                        <a:pt x="1629" y="247"/>
                      </a:lnTo>
                      <a:lnTo>
                        <a:pt x="1653" y="251"/>
                      </a:lnTo>
                      <a:lnTo>
                        <a:pt x="1679" y="255"/>
                      </a:lnTo>
                      <a:lnTo>
                        <a:pt x="1703" y="259"/>
                      </a:lnTo>
                      <a:lnTo>
                        <a:pt x="1729" y="263"/>
                      </a:lnTo>
                      <a:lnTo>
                        <a:pt x="1753" y="267"/>
                      </a:lnTo>
                      <a:lnTo>
                        <a:pt x="1779" y="270"/>
                      </a:lnTo>
                      <a:lnTo>
                        <a:pt x="1803" y="274"/>
                      </a:lnTo>
                      <a:lnTo>
                        <a:pt x="1829" y="278"/>
                      </a:lnTo>
                      <a:lnTo>
                        <a:pt x="1854" y="282"/>
                      </a:lnTo>
                      <a:lnTo>
                        <a:pt x="1879" y="286"/>
                      </a:lnTo>
                      <a:lnTo>
                        <a:pt x="1904" y="289"/>
                      </a:lnTo>
                      <a:lnTo>
                        <a:pt x="1929" y="293"/>
                      </a:lnTo>
                      <a:lnTo>
                        <a:pt x="1954" y="297"/>
                      </a:lnTo>
                      <a:lnTo>
                        <a:pt x="1980" y="301"/>
                      </a:lnTo>
                    </a:path>
                  </a:pathLst>
                </a:custGeom>
                <a:noFill/>
                <a:ln w="0" cap="flat">
                  <a:solidFill>
                    <a:srgbClr val="3366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01" name="Rectangle 166">
                  <a:extLst>
                    <a:ext uri="{FF2B5EF4-FFF2-40B4-BE49-F238E27FC236}">
                      <a16:creationId xmlns:a16="http://schemas.microsoft.com/office/drawing/2014/main" id="{63A45738-CA5B-C740-60CE-E36441E23EE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11439" y="2863850"/>
                  <a:ext cx="814194" cy="5536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1100" b="0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R</a:t>
                  </a:r>
                  <a:r>
                    <a:rPr kumimoji="0" lang="en-US" altLang="hu-HU" sz="1100" b="0" i="0" u="none" strike="noStrike" cap="none" normalizeH="0" baseline="3000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2</a:t>
                  </a:r>
                  <a:r>
                    <a:rPr kumimoji="0" lang="en-US" altLang="hu-HU" sz="11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= 0.03</a:t>
                  </a:r>
                </a:p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n-US" altLang="hu-HU" sz="11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p=0.526</a:t>
                  </a:r>
                  <a:endParaRPr kumimoji="0" lang="en-US" altLang="hu-HU" sz="11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2" name="Line 167">
                  <a:extLst>
                    <a:ext uri="{FF2B5EF4-FFF2-40B4-BE49-F238E27FC236}">
                      <a16:creationId xmlns:a16="http://schemas.microsoft.com/office/drawing/2014/main" id="{C0AC9827-6419-ABAE-AA08-59A6D761D05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558800" y="1746250"/>
                  <a:ext cx="0" cy="3176587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03" name="Rectangle 168">
                  <a:extLst>
                    <a:ext uri="{FF2B5EF4-FFF2-40B4-BE49-F238E27FC236}">
                      <a16:creationId xmlns:a16="http://schemas.microsoft.com/office/drawing/2014/main" id="{9400C2A8-877F-BE7B-290C-F06A2F73C17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3752" y="3826319"/>
                  <a:ext cx="159732" cy="2013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55</a:t>
                  </a:r>
                  <a:endParaRPr kumimoji="0" lang="en-US" altLang="hu-HU" sz="14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4" name="Rectangle 169">
                  <a:extLst>
                    <a:ext uri="{FF2B5EF4-FFF2-40B4-BE49-F238E27FC236}">
                      <a16:creationId xmlns:a16="http://schemas.microsoft.com/office/drawing/2014/main" id="{B2295A07-0AEE-0B62-0D5D-B9B142D8C4E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3752" y="2837305"/>
                  <a:ext cx="159732" cy="2013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60</a:t>
                  </a:r>
                  <a:endParaRPr kumimoji="0" lang="en-US" altLang="hu-HU" sz="14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5" name="Rectangle 170">
                  <a:extLst>
                    <a:ext uri="{FF2B5EF4-FFF2-40B4-BE49-F238E27FC236}">
                      <a16:creationId xmlns:a16="http://schemas.microsoft.com/office/drawing/2014/main" id="{B4137E44-BCBA-A3EE-BA41-7F56325E569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3752" y="1846707"/>
                  <a:ext cx="159732" cy="2013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65</a:t>
                  </a:r>
                  <a:endParaRPr kumimoji="0" lang="en-US" altLang="hu-HU" sz="14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6" name="Line 171">
                  <a:extLst>
                    <a:ext uri="{FF2B5EF4-FFF2-40B4-BE49-F238E27FC236}">
                      <a16:creationId xmlns:a16="http://schemas.microsoft.com/office/drawing/2014/main" id="{6E28DCA6-9C55-0FBE-B4B8-D41D2AFE494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34988" y="3933825"/>
                  <a:ext cx="23813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07" name="Line 172">
                  <a:extLst>
                    <a:ext uri="{FF2B5EF4-FFF2-40B4-BE49-F238E27FC236}">
                      <a16:creationId xmlns:a16="http://schemas.microsoft.com/office/drawing/2014/main" id="{1015B484-378F-7B2C-0DCE-0F21069B3C4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34988" y="2944813"/>
                  <a:ext cx="23813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08" name="Line 173">
                  <a:extLst>
                    <a:ext uri="{FF2B5EF4-FFF2-40B4-BE49-F238E27FC236}">
                      <a16:creationId xmlns:a16="http://schemas.microsoft.com/office/drawing/2014/main" id="{AD80B1CD-92B3-3EA0-AD9D-FDB6A96E3AE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34988" y="1955800"/>
                  <a:ext cx="23813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09" name="Line 174">
                  <a:extLst>
                    <a:ext uri="{FF2B5EF4-FFF2-40B4-BE49-F238E27FC236}">
                      <a16:creationId xmlns:a16="http://schemas.microsoft.com/office/drawing/2014/main" id="{19EAC740-6EEE-3AB2-8E40-22A88712A30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58800" y="4922838"/>
                  <a:ext cx="3455988" cy="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10" name="Line 175">
                  <a:extLst>
                    <a:ext uri="{FF2B5EF4-FFF2-40B4-BE49-F238E27FC236}">
                      <a16:creationId xmlns:a16="http://schemas.microsoft.com/office/drawing/2014/main" id="{004A5B78-BFDF-266A-4AA4-C604204E818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635000" y="4922838"/>
                  <a:ext cx="0" cy="23812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11" name="Line 176">
                  <a:extLst>
                    <a:ext uri="{FF2B5EF4-FFF2-40B4-BE49-F238E27FC236}">
                      <a16:creationId xmlns:a16="http://schemas.microsoft.com/office/drawing/2014/main" id="{F3DC3338-7ED1-9A7D-7EEA-A1F95DF81F7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1611313" y="4922838"/>
                  <a:ext cx="0" cy="23812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12" name="Line 177">
                  <a:extLst>
                    <a:ext uri="{FF2B5EF4-FFF2-40B4-BE49-F238E27FC236}">
                      <a16:creationId xmlns:a16="http://schemas.microsoft.com/office/drawing/2014/main" id="{77E1EC32-3C03-147C-AA6E-7FB740DFA08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587625" y="4922838"/>
                  <a:ext cx="0" cy="23812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13" name="Line 178">
                  <a:extLst>
                    <a:ext uri="{FF2B5EF4-FFF2-40B4-BE49-F238E27FC236}">
                      <a16:creationId xmlns:a16="http://schemas.microsoft.com/office/drawing/2014/main" id="{A2751B6C-BD54-14FC-E76C-D3B1ADB25E1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563938" y="4922838"/>
                  <a:ext cx="0" cy="23812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14" name="Rectangle 179">
                  <a:extLst>
                    <a:ext uri="{FF2B5EF4-FFF2-40B4-BE49-F238E27FC236}">
                      <a16:creationId xmlns:a16="http://schemas.microsoft.com/office/drawing/2014/main" id="{EC5ED541-B247-2AAB-7F5E-272A958CFB0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24727" y="4933798"/>
                  <a:ext cx="239599" cy="2013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100</a:t>
                  </a:r>
                  <a:endParaRPr kumimoji="0" lang="en-US" altLang="hu-HU" sz="14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5" name="Rectangle 180">
                  <a:extLst>
                    <a:ext uri="{FF2B5EF4-FFF2-40B4-BE49-F238E27FC236}">
                      <a16:creationId xmlns:a16="http://schemas.microsoft.com/office/drawing/2014/main" id="{BB35D542-D651-5AA0-180F-9BB6C0DD4B3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501040" y="4933798"/>
                  <a:ext cx="239599" cy="2013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150</a:t>
                  </a:r>
                  <a:endParaRPr kumimoji="0" lang="en-US" altLang="hu-HU" sz="14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6" name="Rectangle 181">
                  <a:extLst>
                    <a:ext uri="{FF2B5EF4-FFF2-40B4-BE49-F238E27FC236}">
                      <a16:creationId xmlns:a16="http://schemas.microsoft.com/office/drawing/2014/main" id="{E3BEFD6E-1B86-D453-58E9-120894D757B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77354" y="4933798"/>
                  <a:ext cx="239599" cy="2013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200</a:t>
                  </a:r>
                  <a:endParaRPr kumimoji="0" lang="en-US" altLang="hu-HU" sz="14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7" name="Rectangle 182">
                  <a:extLst>
                    <a:ext uri="{FF2B5EF4-FFF2-40B4-BE49-F238E27FC236}">
                      <a16:creationId xmlns:a16="http://schemas.microsoft.com/office/drawing/2014/main" id="{7AD452B5-3282-97F0-C687-C24AEB16E75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55254" y="4933798"/>
                  <a:ext cx="239599" cy="2013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250</a:t>
                  </a:r>
                  <a:endParaRPr kumimoji="0" lang="en-US" altLang="hu-HU" sz="14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8" name="Rectangle 185">
                  <a:extLst>
                    <a:ext uri="{FF2B5EF4-FFF2-40B4-BE49-F238E27FC236}">
                      <a16:creationId xmlns:a16="http://schemas.microsoft.com/office/drawing/2014/main" id="{607307F8-6179-5107-991A-F15B5F8C66F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58800" y="1401763"/>
                  <a:ext cx="3441700" cy="35234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hu-HU" altLang="hu-HU" sz="1400" b="1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Healthy</a:t>
                  </a:r>
                  <a:r>
                    <a:rPr kumimoji="0" lang="hu-HU" altLang="hu-HU" sz="14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 </a:t>
                  </a:r>
                  <a:r>
                    <a:rPr kumimoji="0" lang="hu-HU" altLang="hu-HU" sz="1400" b="1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controls</a:t>
                  </a:r>
                  <a:endParaRPr kumimoji="0" lang="en-US" altLang="hu-HU" sz="11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</a:endParaRPr>
                </a:p>
              </p:txBody>
            </p:sp>
          </p:grpSp>
          <p:sp>
            <p:nvSpPr>
              <p:cNvPr id="81" name="Szövegdoboz 80">
                <a:extLst>
                  <a:ext uri="{FF2B5EF4-FFF2-40B4-BE49-F238E27FC236}">
                    <a16:creationId xmlns:a16="http://schemas.microsoft.com/office/drawing/2014/main" id="{01892A85-5BD9-95BA-E036-673AC0FC804C}"/>
                  </a:ext>
                </a:extLst>
              </p:cNvPr>
              <p:cNvSpPr txBox="1"/>
              <p:nvPr/>
            </p:nvSpPr>
            <p:spPr>
              <a:xfrm rot="16200000">
                <a:off x="-778456" y="2929579"/>
                <a:ext cx="2858929" cy="53670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PD-1 expression by CD8+ T cells (%)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5673001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Csoportba foglalás 1">
            <a:extLst>
              <a:ext uri="{FF2B5EF4-FFF2-40B4-BE49-F238E27FC236}">
                <a16:creationId xmlns:a16="http://schemas.microsoft.com/office/drawing/2014/main" id="{A94972F4-0268-42D8-8CCE-C3E7B56020D4}"/>
              </a:ext>
            </a:extLst>
          </p:cNvPr>
          <p:cNvGrpSpPr/>
          <p:nvPr/>
        </p:nvGrpSpPr>
        <p:grpSpPr>
          <a:xfrm>
            <a:off x="-16935" y="66133"/>
            <a:ext cx="7595718" cy="4167715"/>
            <a:chOff x="-16935" y="66133"/>
            <a:chExt cx="7595718" cy="4167715"/>
          </a:xfrm>
        </p:grpSpPr>
        <p:grpSp>
          <p:nvGrpSpPr>
            <p:cNvPr id="149" name="Csoportba foglalás 148">
              <a:extLst>
                <a:ext uri="{FF2B5EF4-FFF2-40B4-BE49-F238E27FC236}">
                  <a16:creationId xmlns:a16="http://schemas.microsoft.com/office/drawing/2014/main" id="{6EBEF3D5-20EF-53B9-B64E-6E367551E134}"/>
                </a:ext>
              </a:extLst>
            </p:cNvPr>
            <p:cNvGrpSpPr/>
            <p:nvPr/>
          </p:nvGrpSpPr>
          <p:grpSpPr>
            <a:xfrm>
              <a:off x="253826" y="1509704"/>
              <a:ext cx="7324957" cy="2724144"/>
              <a:chOff x="1232769" y="1963995"/>
              <a:chExt cx="9106222" cy="3848945"/>
            </a:xfrm>
          </p:grpSpPr>
          <p:grpSp>
            <p:nvGrpSpPr>
              <p:cNvPr id="4" name="Csoportba foglalás 3">
                <a:extLst>
                  <a:ext uri="{FF2B5EF4-FFF2-40B4-BE49-F238E27FC236}">
                    <a16:creationId xmlns:a16="http://schemas.microsoft.com/office/drawing/2014/main" id="{9CC5F0A2-56C5-FD2D-0235-F3864FA2B634}"/>
                  </a:ext>
                </a:extLst>
              </p:cNvPr>
              <p:cNvGrpSpPr/>
              <p:nvPr/>
            </p:nvGrpSpPr>
            <p:grpSpPr>
              <a:xfrm>
                <a:off x="6533725" y="1963995"/>
                <a:ext cx="3805266" cy="3284345"/>
                <a:chOff x="1693138" y="1333500"/>
                <a:chExt cx="3663088" cy="3725333"/>
              </a:xfrm>
            </p:grpSpPr>
            <p:sp>
              <p:nvSpPr>
                <p:cNvPr id="5" name="Oval 55">
                  <a:extLst>
                    <a:ext uri="{FF2B5EF4-FFF2-40B4-BE49-F238E27FC236}">
                      <a16:creationId xmlns:a16="http://schemas.microsoft.com/office/drawing/2014/main" id="{7752CA19-CD20-39D9-CD9E-4E1AA94647F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705225" y="3736975"/>
                  <a:ext cx="61913" cy="61912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6" name="Oval 56">
                  <a:extLst>
                    <a:ext uri="{FF2B5EF4-FFF2-40B4-BE49-F238E27FC236}">
                      <a16:creationId xmlns:a16="http://schemas.microsoft.com/office/drawing/2014/main" id="{DA2C0D3E-5059-B036-9460-D06555F5964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57450" y="2928937"/>
                  <a:ext cx="63500" cy="61912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7" name="Oval 57">
                  <a:extLst>
                    <a:ext uri="{FF2B5EF4-FFF2-40B4-BE49-F238E27FC236}">
                      <a16:creationId xmlns:a16="http://schemas.microsoft.com/office/drawing/2014/main" id="{FAA72811-C56F-54F3-CF81-A50136DB8B3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05188" y="3228975"/>
                  <a:ext cx="65088" cy="65087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8" name="Oval 58">
                  <a:extLst>
                    <a:ext uri="{FF2B5EF4-FFF2-40B4-BE49-F238E27FC236}">
                      <a16:creationId xmlns:a16="http://schemas.microsoft.com/office/drawing/2014/main" id="{B4E0580F-1C0F-A1D8-DBA0-E99492DB8CE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730750" y="1917700"/>
                  <a:ext cx="63500" cy="63500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9" name="Oval 59">
                  <a:extLst>
                    <a:ext uri="{FF2B5EF4-FFF2-40B4-BE49-F238E27FC236}">
                      <a16:creationId xmlns:a16="http://schemas.microsoft.com/office/drawing/2014/main" id="{946390AD-8B8D-998E-179F-021E6AD8414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168775" y="3251200"/>
                  <a:ext cx="65088" cy="63500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0" name="Oval 60">
                  <a:extLst>
                    <a:ext uri="{FF2B5EF4-FFF2-40B4-BE49-F238E27FC236}">
                      <a16:creationId xmlns:a16="http://schemas.microsoft.com/office/drawing/2014/main" id="{5298A690-7D45-43ED-AAD1-51CA06FB1A9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144713" y="4302125"/>
                  <a:ext cx="65088" cy="65087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1" name="Oval 61">
                  <a:extLst>
                    <a:ext uri="{FF2B5EF4-FFF2-40B4-BE49-F238E27FC236}">
                      <a16:creationId xmlns:a16="http://schemas.microsoft.com/office/drawing/2014/main" id="{D3222929-6F99-3033-17A8-2FBE364C481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068513" y="3803650"/>
                  <a:ext cx="61913" cy="65087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2" name="Oval 62">
                  <a:extLst>
                    <a:ext uri="{FF2B5EF4-FFF2-40B4-BE49-F238E27FC236}">
                      <a16:creationId xmlns:a16="http://schemas.microsoft.com/office/drawing/2014/main" id="{BDB31B3D-3025-25AD-1FE6-ED4BE8A319B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55900" y="3300412"/>
                  <a:ext cx="61913" cy="61912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3" name="Oval 63">
                  <a:extLst>
                    <a:ext uri="{FF2B5EF4-FFF2-40B4-BE49-F238E27FC236}">
                      <a16:creationId xmlns:a16="http://schemas.microsoft.com/office/drawing/2014/main" id="{3A3BDC40-6080-222E-A2B8-BBA3B8AC264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024063" y="4678362"/>
                  <a:ext cx="65088" cy="63500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4" name="Oval 64">
                  <a:extLst>
                    <a:ext uri="{FF2B5EF4-FFF2-40B4-BE49-F238E27FC236}">
                      <a16:creationId xmlns:a16="http://schemas.microsoft.com/office/drawing/2014/main" id="{26472E10-0178-B3C3-FDFF-60DF19C4289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67313" y="3248025"/>
                  <a:ext cx="61913" cy="65087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5" name="Oval 65">
                  <a:extLst>
                    <a:ext uri="{FF2B5EF4-FFF2-40B4-BE49-F238E27FC236}">
                      <a16:creationId xmlns:a16="http://schemas.microsoft.com/office/drawing/2014/main" id="{D71700C6-3507-9C0E-99AD-BA8B9331F0C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366963" y="3875087"/>
                  <a:ext cx="61913" cy="63500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6" name="Freeform 66">
                  <a:extLst>
                    <a:ext uri="{FF2B5EF4-FFF2-40B4-BE49-F238E27FC236}">
                      <a16:creationId xmlns:a16="http://schemas.microsoft.com/office/drawing/2014/main" id="{AC4E8A1C-EBCF-B2EF-CE43-9688EA821F3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057400" y="2652712"/>
                  <a:ext cx="3140075" cy="1357312"/>
                </a:xfrm>
                <a:custGeom>
                  <a:avLst/>
                  <a:gdLst>
                    <a:gd name="T0" fmla="*/ 26 w 1978"/>
                    <a:gd name="T1" fmla="*/ 844 h 855"/>
                    <a:gd name="T2" fmla="*/ 76 w 1978"/>
                    <a:gd name="T3" fmla="*/ 823 h 855"/>
                    <a:gd name="T4" fmla="*/ 126 w 1978"/>
                    <a:gd name="T5" fmla="*/ 801 h 855"/>
                    <a:gd name="T6" fmla="*/ 175 w 1978"/>
                    <a:gd name="T7" fmla="*/ 779 h 855"/>
                    <a:gd name="T8" fmla="*/ 225 w 1978"/>
                    <a:gd name="T9" fmla="*/ 757 h 855"/>
                    <a:gd name="T10" fmla="*/ 275 w 1978"/>
                    <a:gd name="T11" fmla="*/ 736 h 855"/>
                    <a:gd name="T12" fmla="*/ 325 w 1978"/>
                    <a:gd name="T13" fmla="*/ 714 h 855"/>
                    <a:gd name="T14" fmla="*/ 375 w 1978"/>
                    <a:gd name="T15" fmla="*/ 692 h 855"/>
                    <a:gd name="T16" fmla="*/ 425 w 1978"/>
                    <a:gd name="T17" fmla="*/ 671 h 855"/>
                    <a:gd name="T18" fmla="*/ 475 w 1978"/>
                    <a:gd name="T19" fmla="*/ 649 h 855"/>
                    <a:gd name="T20" fmla="*/ 525 w 1978"/>
                    <a:gd name="T21" fmla="*/ 627 h 855"/>
                    <a:gd name="T22" fmla="*/ 576 w 1978"/>
                    <a:gd name="T23" fmla="*/ 606 h 855"/>
                    <a:gd name="T24" fmla="*/ 626 w 1978"/>
                    <a:gd name="T25" fmla="*/ 585 h 855"/>
                    <a:gd name="T26" fmla="*/ 676 w 1978"/>
                    <a:gd name="T27" fmla="*/ 564 h 855"/>
                    <a:gd name="T28" fmla="*/ 726 w 1978"/>
                    <a:gd name="T29" fmla="*/ 542 h 855"/>
                    <a:gd name="T30" fmla="*/ 776 w 1978"/>
                    <a:gd name="T31" fmla="*/ 520 h 855"/>
                    <a:gd name="T32" fmla="*/ 826 w 1978"/>
                    <a:gd name="T33" fmla="*/ 499 h 855"/>
                    <a:gd name="T34" fmla="*/ 876 w 1978"/>
                    <a:gd name="T35" fmla="*/ 477 h 855"/>
                    <a:gd name="T36" fmla="*/ 926 w 1978"/>
                    <a:gd name="T37" fmla="*/ 455 h 855"/>
                    <a:gd name="T38" fmla="*/ 977 w 1978"/>
                    <a:gd name="T39" fmla="*/ 434 h 855"/>
                    <a:gd name="T40" fmla="*/ 1027 w 1978"/>
                    <a:gd name="T41" fmla="*/ 412 h 855"/>
                    <a:gd name="T42" fmla="*/ 1077 w 1978"/>
                    <a:gd name="T43" fmla="*/ 390 h 855"/>
                    <a:gd name="T44" fmla="*/ 1127 w 1978"/>
                    <a:gd name="T45" fmla="*/ 369 h 855"/>
                    <a:gd name="T46" fmla="*/ 1177 w 1978"/>
                    <a:gd name="T47" fmla="*/ 347 h 855"/>
                    <a:gd name="T48" fmla="*/ 1227 w 1978"/>
                    <a:gd name="T49" fmla="*/ 325 h 855"/>
                    <a:gd name="T50" fmla="*/ 1277 w 1978"/>
                    <a:gd name="T51" fmla="*/ 304 h 855"/>
                    <a:gd name="T52" fmla="*/ 1327 w 1978"/>
                    <a:gd name="T53" fmla="*/ 282 h 855"/>
                    <a:gd name="T54" fmla="*/ 1378 w 1978"/>
                    <a:gd name="T55" fmla="*/ 260 h 855"/>
                    <a:gd name="T56" fmla="*/ 1428 w 1978"/>
                    <a:gd name="T57" fmla="*/ 239 h 855"/>
                    <a:gd name="T58" fmla="*/ 1478 w 1978"/>
                    <a:gd name="T59" fmla="*/ 217 h 855"/>
                    <a:gd name="T60" fmla="*/ 1528 w 1978"/>
                    <a:gd name="T61" fmla="*/ 195 h 855"/>
                    <a:gd name="T62" fmla="*/ 1578 w 1978"/>
                    <a:gd name="T63" fmla="*/ 174 h 855"/>
                    <a:gd name="T64" fmla="*/ 1628 w 1978"/>
                    <a:gd name="T65" fmla="*/ 152 h 855"/>
                    <a:gd name="T66" fmla="*/ 1678 w 1978"/>
                    <a:gd name="T67" fmla="*/ 130 h 855"/>
                    <a:gd name="T68" fmla="*/ 1729 w 1978"/>
                    <a:gd name="T69" fmla="*/ 109 h 855"/>
                    <a:gd name="T70" fmla="*/ 1779 w 1978"/>
                    <a:gd name="T71" fmla="*/ 87 h 855"/>
                    <a:gd name="T72" fmla="*/ 1829 w 1978"/>
                    <a:gd name="T73" fmla="*/ 65 h 855"/>
                    <a:gd name="T74" fmla="*/ 1879 w 1978"/>
                    <a:gd name="T75" fmla="*/ 44 h 855"/>
                    <a:gd name="T76" fmla="*/ 1929 w 1978"/>
                    <a:gd name="T77" fmla="*/ 22 h 855"/>
                    <a:gd name="T78" fmla="*/ 1978 w 1978"/>
                    <a:gd name="T79" fmla="*/ 0 h 85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</a:cxnLst>
                  <a:rect l="0" t="0" r="r" b="b"/>
                  <a:pathLst>
                    <a:path w="1978" h="855">
                      <a:moveTo>
                        <a:pt x="0" y="855"/>
                      </a:moveTo>
                      <a:lnTo>
                        <a:pt x="26" y="844"/>
                      </a:lnTo>
                      <a:lnTo>
                        <a:pt x="50" y="833"/>
                      </a:lnTo>
                      <a:lnTo>
                        <a:pt x="76" y="823"/>
                      </a:lnTo>
                      <a:lnTo>
                        <a:pt x="100" y="812"/>
                      </a:lnTo>
                      <a:lnTo>
                        <a:pt x="126" y="801"/>
                      </a:lnTo>
                      <a:lnTo>
                        <a:pt x="150" y="790"/>
                      </a:lnTo>
                      <a:lnTo>
                        <a:pt x="175" y="779"/>
                      </a:lnTo>
                      <a:lnTo>
                        <a:pt x="200" y="768"/>
                      </a:lnTo>
                      <a:lnTo>
                        <a:pt x="225" y="757"/>
                      </a:lnTo>
                      <a:lnTo>
                        <a:pt x="250" y="747"/>
                      </a:lnTo>
                      <a:lnTo>
                        <a:pt x="275" y="736"/>
                      </a:lnTo>
                      <a:lnTo>
                        <a:pt x="301" y="725"/>
                      </a:lnTo>
                      <a:lnTo>
                        <a:pt x="325" y="714"/>
                      </a:lnTo>
                      <a:lnTo>
                        <a:pt x="351" y="703"/>
                      </a:lnTo>
                      <a:lnTo>
                        <a:pt x="375" y="692"/>
                      </a:lnTo>
                      <a:lnTo>
                        <a:pt x="401" y="682"/>
                      </a:lnTo>
                      <a:lnTo>
                        <a:pt x="425" y="671"/>
                      </a:lnTo>
                      <a:lnTo>
                        <a:pt x="451" y="660"/>
                      </a:lnTo>
                      <a:lnTo>
                        <a:pt x="475" y="649"/>
                      </a:lnTo>
                      <a:lnTo>
                        <a:pt x="501" y="638"/>
                      </a:lnTo>
                      <a:lnTo>
                        <a:pt x="525" y="627"/>
                      </a:lnTo>
                      <a:lnTo>
                        <a:pt x="551" y="617"/>
                      </a:lnTo>
                      <a:lnTo>
                        <a:pt x="576" y="606"/>
                      </a:lnTo>
                      <a:lnTo>
                        <a:pt x="601" y="596"/>
                      </a:lnTo>
                      <a:lnTo>
                        <a:pt x="626" y="585"/>
                      </a:lnTo>
                      <a:lnTo>
                        <a:pt x="651" y="575"/>
                      </a:lnTo>
                      <a:lnTo>
                        <a:pt x="676" y="564"/>
                      </a:lnTo>
                      <a:lnTo>
                        <a:pt x="702" y="553"/>
                      </a:lnTo>
                      <a:lnTo>
                        <a:pt x="726" y="542"/>
                      </a:lnTo>
                      <a:lnTo>
                        <a:pt x="752" y="531"/>
                      </a:lnTo>
                      <a:lnTo>
                        <a:pt x="776" y="520"/>
                      </a:lnTo>
                      <a:lnTo>
                        <a:pt x="802" y="510"/>
                      </a:lnTo>
                      <a:lnTo>
                        <a:pt x="826" y="499"/>
                      </a:lnTo>
                      <a:lnTo>
                        <a:pt x="852" y="488"/>
                      </a:lnTo>
                      <a:lnTo>
                        <a:pt x="876" y="477"/>
                      </a:lnTo>
                      <a:lnTo>
                        <a:pt x="902" y="466"/>
                      </a:lnTo>
                      <a:lnTo>
                        <a:pt x="926" y="455"/>
                      </a:lnTo>
                      <a:lnTo>
                        <a:pt x="952" y="445"/>
                      </a:lnTo>
                      <a:lnTo>
                        <a:pt x="977" y="434"/>
                      </a:lnTo>
                      <a:lnTo>
                        <a:pt x="1002" y="423"/>
                      </a:lnTo>
                      <a:lnTo>
                        <a:pt x="1027" y="412"/>
                      </a:lnTo>
                      <a:lnTo>
                        <a:pt x="1052" y="401"/>
                      </a:lnTo>
                      <a:lnTo>
                        <a:pt x="1077" y="390"/>
                      </a:lnTo>
                      <a:lnTo>
                        <a:pt x="1101" y="379"/>
                      </a:lnTo>
                      <a:lnTo>
                        <a:pt x="1127" y="369"/>
                      </a:lnTo>
                      <a:lnTo>
                        <a:pt x="1151" y="358"/>
                      </a:lnTo>
                      <a:lnTo>
                        <a:pt x="1177" y="347"/>
                      </a:lnTo>
                      <a:lnTo>
                        <a:pt x="1201" y="336"/>
                      </a:lnTo>
                      <a:lnTo>
                        <a:pt x="1227" y="325"/>
                      </a:lnTo>
                      <a:lnTo>
                        <a:pt x="1252" y="314"/>
                      </a:lnTo>
                      <a:lnTo>
                        <a:pt x="1277" y="304"/>
                      </a:lnTo>
                      <a:lnTo>
                        <a:pt x="1302" y="293"/>
                      </a:lnTo>
                      <a:lnTo>
                        <a:pt x="1327" y="282"/>
                      </a:lnTo>
                      <a:lnTo>
                        <a:pt x="1352" y="271"/>
                      </a:lnTo>
                      <a:lnTo>
                        <a:pt x="1378" y="260"/>
                      </a:lnTo>
                      <a:lnTo>
                        <a:pt x="1402" y="249"/>
                      </a:lnTo>
                      <a:lnTo>
                        <a:pt x="1428" y="239"/>
                      </a:lnTo>
                      <a:lnTo>
                        <a:pt x="1452" y="228"/>
                      </a:lnTo>
                      <a:lnTo>
                        <a:pt x="1478" y="217"/>
                      </a:lnTo>
                      <a:lnTo>
                        <a:pt x="1502" y="206"/>
                      </a:lnTo>
                      <a:lnTo>
                        <a:pt x="1528" y="195"/>
                      </a:lnTo>
                      <a:lnTo>
                        <a:pt x="1552" y="184"/>
                      </a:lnTo>
                      <a:lnTo>
                        <a:pt x="1578" y="174"/>
                      </a:lnTo>
                      <a:lnTo>
                        <a:pt x="1603" y="163"/>
                      </a:lnTo>
                      <a:lnTo>
                        <a:pt x="1628" y="152"/>
                      </a:lnTo>
                      <a:lnTo>
                        <a:pt x="1653" y="141"/>
                      </a:lnTo>
                      <a:lnTo>
                        <a:pt x="1678" y="130"/>
                      </a:lnTo>
                      <a:lnTo>
                        <a:pt x="1703" y="119"/>
                      </a:lnTo>
                      <a:lnTo>
                        <a:pt x="1729" y="109"/>
                      </a:lnTo>
                      <a:lnTo>
                        <a:pt x="1753" y="98"/>
                      </a:lnTo>
                      <a:lnTo>
                        <a:pt x="1779" y="87"/>
                      </a:lnTo>
                      <a:lnTo>
                        <a:pt x="1803" y="76"/>
                      </a:lnTo>
                      <a:lnTo>
                        <a:pt x="1829" y="65"/>
                      </a:lnTo>
                      <a:lnTo>
                        <a:pt x="1853" y="54"/>
                      </a:lnTo>
                      <a:lnTo>
                        <a:pt x="1879" y="44"/>
                      </a:lnTo>
                      <a:lnTo>
                        <a:pt x="1903" y="33"/>
                      </a:lnTo>
                      <a:lnTo>
                        <a:pt x="1929" y="22"/>
                      </a:lnTo>
                      <a:lnTo>
                        <a:pt x="1953" y="11"/>
                      </a:lnTo>
                      <a:lnTo>
                        <a:pt x="1978" y="0"/>
                      </a:lnTo>
                    </a:path>
                  </a:pathLst>
                </a:custGeom>
                <a:noFill/>
                <a:ln w="365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7" name="Freeform 67">
                  <a:extLst>
                    <a:ext uri="{FF2B5EF4-FFF2-40B4-BE49-F238E27FC236}">
                      <a16:creationId xmlns:a16="http://schemas.microsoft.com/office/drawing/2014/main" id="{23A287C2-B4C2-4ED8-FBAB-7C49D4CCBB3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057400" y="1822450"/>
                  <a:ext cx="3140075" cy="2768600"/>
                </a:xfrm>
                <a:custGeom>
                  <a:avLst/>
                  <a:gdLst>
                    <a:gd name="T0" fmla="*/ 50 w 1978"/>
                    <a:gd name="T1" fmla="*/ 1004 h 1744"/>
                    <a:gd name="T2" fmla="*/ 126 w 1978"/>
                    <a:gd name="T3" fmla="*/ 991 h 1744"/>
                    <a:gd name="T4" fmla="*/ 200 w 1978"/>
                    <a:gd name="T5" fmla="*/ 976 h 1744"/>
                    <a:gd name="T6" fmla="*/ 275 w 1978"/>
                    <a:gd name="T7" fmla="*/ 959 h 1744"/>
                    <a:gd name="T8" fmla="*/ 351 w 1978"/>
                    <a:gd name="T9" fmla="*/ 942 h 1744"/>
                    <a:gd name="T10" fmla="*/ 425 w 1978"/>
                    <a:gd name="T11" fmla="*/ 921 h 1744"/>
                    <a:gd name="T12" fmla="*/ 501 w 1978"/>
                    <a:gd name="T13" fmla="*/ 900 h 1744"/>
                    <a:gd name="T14" fmla="*/ 576 w 1978"/>
                    <a:gd name="T15" fmla="*/ 874 h 1744"/>
                    <a:gd name="T16" fmla="*/ 651 w 1978"/>
                    <a:gd name="T17" fmla="*/ 847 h 1744"/>
                    <a:gd name="T18" fmla="*/ 726 w 1978"/>
                    <a:gd name="T19" fmla="*/ 816 h 1744"/>
                    <a:gd name="T20" fmla="*/ 802 w 1978"/>
                    <a:gd name="T21" fmla="*/ 782 h 1744"/>
                    <a:gd name="T22" fmla="*/ 876 w 1978"/>
                    <a:gd name="T23" fmla="*/ 745 h 1744"/>
                    <a:gd name="T24" fmla="*/ 952 w 1978"/>
                    <a:gd name="T25" fmla="*/ 705 h 1744"/>
                    <a:gd name="T26" fmla="*/ 1027 w 1978"/>
                    <a:gd name="T27" fmla="*/ 663 h 1744"/>
                    <a:gd name="T28" fmla="*/ 1101 w 1978"/>
                    <a:gd name="T29" fmla="*/ 618 h 1744"/>
                    <a:gd name="T30" fmla="*/ 1177 w 1978"/>
                    <a:gd name="T31" fmla="*/ 571 h 1744"/>
                    <a:gd name="T32" fmla="*/ 1252 w 1978"/>
                    <a:gd name="T33" fmla="*/ 522 h 1744"/>
                    <a:gd name="T34" fmla="*/ 1327 w 1978"/>
                    <a:gd name="T35" fmla="*/ 472 h 1744"/>
                    <a:gd name="T36" fmla="*/ 1402 w 1978"/>
                    <a:gd name="T37" fmla="*/ 420 h 1744"/>
                    <a:gd name="T38" fmla="*/ 1478 w 1978"/>
                    <a:gd name="T39" fmla="*/ 369 h 1744"/>
                    <a:gd name="T40" fmla="*/ 1552 w 1978"/>
                    <a:gd name="T41" fmla="*/ 315 h 1744"/>
                    <a:gd name="T42" fmla="*/ 1628 w 1978"/>
                    <a:gd name="T43" fmla="*/ 260 h 1744"/>
                    <a:gd name="T44" fmla="*/ 1703 w 1978"/>
                    <a:gd name="T45" fmla="*/ 206 h 1744"/>
                    <a:gd name="T46" fmla="*/ 1779 w 1978"/>
                    <a:gd name="T47" fmla="*/ 151 h 1744"/>
                    <a:gd name="T48" fmla="*/ 1853 w 1978"/>
                    <a:gd name="T49" fmla="*/ 94 h 1744"/>
                    <a:gd name="T50" fmla="*/ 1929 w 1978"/>
                    <a:gd name="T51" fmla="*/ 38 h 1744"/>
                    <a:gd name="T52" fmla="*/ 1978 w 1978"/>
                    <a:gd name="T53" fmla="*/ 1047 h 1744"/>
                    <a:gd name="T54" fmla="*/ 1903 w 1978"/>
                    <a:gd name="T55" fmla="*/ 1056 h 1744"/>
                    <a:gd name="T56" fmla="*/ 1829 w 1978"/>
                    <a:gd name="T57" fmla="*/ 1064 h 1744"/>
                    <a:gd name="T58" fmla="*/ 1753 w 1978"/>
                    <a:gd name="T59" fmla="*/ 1073 h 1744"/>
                    <a:gd name="T60" fmla="*/ 1678 w 1978"/>
                    <a:gd name="T61" fmla="*/ 1083 h 1744"/>
                    <a:gd name="T62" fmla="*/ 1603 w 1978"/>
                    <a:gd name="T63" fmla="*/ 1094 h 1744"/>
                    <a:gd name="T64" fmla="*/ 1528 w 1978"/>
                    <a:gd name="T65" fmla="*/ 1104 h 1744"/>
                    <a:gd name="T66" fmla="*/ 1452 w 1978"/>
                    <a:gd name="T67" fmla="*/ 1115 h 1744"/>
                    <a:gd name="T68" fmla="*/ 1378 w 1978"/>
                    <a:gd name="T69" fmla="*/ 1129 h 1744"/>
                    <a:gd name="T70" fmla="*/ 1302 w 1978"/>
                    <a:gd name="T71" fmla="*/ 1142 h 1744"/>
                    <a:gd name="T72" fmla="*/ 1227 w 1978"/>
                    <a:gd name="T73" fmla="*/ 1157 h 1744"/>
                    <a:gd name="T74" fmla="*/ 1151 w 1978"/>
                    <a:gd name="T75" fmla="*/ 1175 h 1744"/>
                    <a:gd name="T76" fmla="*/ 1077 w 1978"/>
                    <a:gd name="T77" fmla="*/ 1194 h 1744"/>
                    <a:gd name="T78" fmla="*/ 1002 w 1978"/>
                    <a:gd name="T79" fmla="*/ 1214 h 1744"/>
                    <a:gd name="T80" fmla="*/ 926 w 1978"/>
                    <a:gd name="T81" fmla="*/ 1237 h 1744"/>
                    <a:gd name="T82" fmla="*/ 852 w 1978"/>
                    <a:gd name="T83" fmla="*/ 1263 h 1744"/>
                    <a:gd name="T84" fmla="*/ 776 w 1978"/>
                    <a:gd name="T85" fmla="*/ 1293 h 1744"/>
                    <a:gd name="T86" fmla="*/ 702 w 1978"/>
                    <a:gd name="T87" fmla="*/ 1324 h 1744"/>
                    <a:gd name="T88" fmla="*/ 626 w 1978"/>
                    <a:gd name="T89" fmla="*/ 1359 h 1744"/>
                    <a:gd name="T90" fmla="*/ 551 w 1978"/>
                    <a:gd name="T91" fmla="*/ 1397 h 1744"/>
                    <a:gd name="T92" fmla="*/ 475 w 1978"/>
                    <a:gd name="T93" fmla="*/ 1439 h 1744"/>
                    <a:gd name="T94" fmla="*/ 401 w 1978"/>
                    <a:gd name="T95" fmla="*/ 1482 h 1744"/>
                    <a:gd name="T96" fmla="*/ 325 w 1978"/>
                    <a:gd name="T97" fmla="*/ 1527 h 1744"/>
                    <a:gd name="T98" fmla="*/ 250 w 1978"/>
                    <a:gd name="T99" fmla="*/ 1574 h 1744"/>
                    <a:gd name="T100" fmla="*/ 175 w 1978"/>
                    <a:gd name="T101" fmla="*/ 1625 h 1744"/>
                    <a:gd name="T102" fmla="*/ 100 w 1978"/>
                    <a:gd name="T103" fmla="*/ 1675 h 1744"/>
                    <a:gd name="T104" fmla="*/ 26 w 1978"/>
                    <a:gd name="T105" fmla="*/ 1726 h 174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</a:cxnLst>
                  <a:rect l="0" t="0" r="r" b="b"/>
                  <a:pathLst>
                    <a:path w="1978" h="1744">
                      <a:moveTo>
                        <a:pt x="0" y="1012"/>
                      </a:moveTo>
                      <a:lnTo>
                        <a:pt x="26" y="1008"/>
                      </a:lnTo>
                      <a:lnTo>
                        <a:pt x="50" y="1004"/>
                      </a:lnTo>
                      <a:lnTo>
                        <a:pt x="76" y="1000"/>
                      </a:lnTo>
                      <a:lnTo>
                        <a:pt x="100" y="995"/>
                      </a:lnTo>
                      <a:lnTo>
                        <a:pt x="126" y="991"/>
                      </a:lnTo>
                      <a:lnTo>
                        <a:pt x="150" y="986"/>
                      </a:lnTo>
                      <a:lnTo>
                        <a:pt x="175" y="981"/>
                      </a:lnTo>
                      <a:lnTo>
                        <a:pt x="200" y="976"/>
                      </a:lnTo>
                      <a:lnTo>
                        <a:pt x="225" y="970"/>
                      </a:lnTo>
                      <a:lnTo>
                        <a:pt x="250" y="965"/>
                      </a:lnTo>
                      <a:lnTo>
                        <a:pt x="275" y="959"/>
                      </a:lnTo>
                      <a:lnTo>
                        <a:pt x="301" y="954"/>
                      </a:lnTo>
                      <a:lnTo>
                        <a:pt x="325" y="949"/>
                      </a:lnTo>
                      <a:lnTo>
                        <a:pt x="351" y="942"/>
                      </a:lnTo>
                      <a:lnTo>
                        <a:pt x="375" y="935"/>
                      </a:lnTo>
                      <a:lnTo>
                        <a:pt x="401" y="928"/>
                      </a:lnTo>
                      <a:lnTo>
                        <a:pt x="425" y="921"/>
                      </a:lnTo>
                      <a:lnTo>
                        <a:pt x="451" y="915"/>
                      </a:lnTo>
                      <a:lnTo>
                        <a:pt x="475" y="907"/>
                      </a:lnTo>
                      <a:lnTo>
                        <a:pt x="501" y="900"/>
                      </a:lnTo>
                      <a:lnTo>
                        <a:pt x="525" y="892"/>
                      </a:lnTo>
                      <a:lnTo>
                        <a:pt x="551" y="884"/>
                      </a:lnTo>
                      <a:lnTo>
                        <a:pt x="576" y="874"/>
                      </a:lnTo>
                      <a:lnTo>
                        <a:pt x="601" y="866"/>
                      </a:lnTo>
                      <a:lnTo>
                        <a:pt x="626" y="856"/>
                      </a:lnTo>
                      <a:lnTo>
                        <a:pt x="651" y="847"/>
                      </a:lnTo>
                      <a:lnTo>
                        <a:pt x="676" y="836"/>
                      </a:lnTo>
                      <a:lnTo>
                        <a:pt x="702" y="827"/>
                      </a:lnTo>
                      <a:lnTo>
                        <a:pt x="726" y="816"/>
                      </a:lnTo>
                      <a:lnTo>
                        <a:pt x="752" y="805"/>
                      </a:lnTo>
                      <a:lnTo>
                        <a:pt x="776" y="793"/>
                      </a:lnTo>
                      <a:lnTo>
                        <a:pt x="802" y="782"/>
                      </a:lnTo>
                      <a:lnTo>
                        <a:pt x="826" y="770"/>
                      </a:lnTo>
                      <a:lnTo>
                        <a:pt x="852" y="758"/>
                      </a:lnTo>
                      <a:lnTo>
                        <a:pt x="876" y="745"/>
                      </a:lnTo>
                      <a:lnTo>
                        <a:pt x="902" y="732"/>
                      </a:lnTo>
                      <a:lnTo>
                        <a:pt x="926" y="718"/>
                      </a:lnTo>
                      <a:lnTo>
                        <a:pt x="952" y="705"/>
                      </a:lnTo>
                      <a:lnTo>
                        <a:pt x="977" y="691"/>
                      </a:lnTo>
                      <a:lnTo>
                        <a:pt x="1002" y="676"/>
                      </a:lnTo>
                      <a:lnTo>
                        <a:pt x="1027" y="663"/>
                      </a:lnTo>
                      <a:lnTo>
                        <a:pt x="1052" y="648"/>
                      </a:lnTo>
                      <a:lnTo>
                        <a:pt x="1077" y="633"/>
                      </a:lnTo>
                      <a:lnTo>
                        <a:pt x="1101" y="618"/>
                      </a:lnTo>
                      <a:lnTo>
                        <a:pt x="1127" y="602"/>
                      </a:lnTo>
                      <a:lnTo>
                        <a:pt x="1151" y="587"/>
                      </a:lnTo>
                      <a:lnTo>
                        <a:pt x="1177" y="571"/>
                      </a:lnTo>
                      <a:lnTo>
                        <a:pt x="1201" y="554"/>
                      </a:lnTo>
                      <a:lnTo>
                        <a:pt x="1227" y="538"/>
                      </a:lnTo>
                      <a:lnTo>
                        <a:pt x="1252" y="522"/>
                      </a:lnTo>
                      <a:lnTo>
                        <a:pt x="1277" y="506"/>
                      </a:lnTo>
                      <a:lnTo>
                        <a:pt x="1302" y="489"/>
                      </a:lnTo>
                      <a:lnTo>
                        <a:pt x="1327" y="472"/>
                      </a:lnTo>
                      <a:lnTo>
                        <a:pt x="1352" y="455"/>
                      </a:lnTo>
                      <a:lnTo>
                        <a:pt x="1378" y="438"/>
                      </a:lnTo>
                      <a:lnTo>
                        <a:pt x="1402" y="420"/>
                      </a:lnTo>
                      <a:lnTo>
                        <a:pt x="1428" y="404"/>
                      </a:lnTo>
                      <a:lnTo>
                        <a:pt x="1452" y="386"/>
                      </a:lnTo>
                      <a:lnTo>
                        <a:pt x="1478" y="369"/>
                      </a:lnTo>
                      <a:lnTo>
                        <a:pt x="1502" y="351"/>
                      </a:lnTo>
                      <a:lnTo>
                        <a:pt x="1528" y="332"/>
                      </a:lnTo>
                      <a:lnTo>
                        <a:pt x="1552" y="315"/>
                      </a:lnTo>
                      <a:lnTo>
                        <a:pt x="1578" y="297"/>
                      </a:lnTo>
                      <a:lnTo>
                        <a:pt x="1603" y="278"/>
                      </a:lnTo>
                      <a:lnTo>
                        <a:pt x="1628" y="260"/>
                      </a:lnTo>
                      <a:lnTo>
                        <a:pt x="1653" y="243"/>
                      </a:lnTo>
                      <a:lnTo>
                        <a:pt x="1678" y="224"/>
                      </a:lnTo>
                      <a:lnTo>
                        <a:pt x="1703" y="206"/>
                      </a:lnTo>
                      <a:lnTo>
                        <a:pt x="1729" y="187"/>
                      </a:lnTo>
                      <a:lnTo>
                        <a:pt x="1753" y="168"/>
                      </a:lnTo>
                      <a:lnTo>
                        <a:pt x="1779" y="151"/>
                      </a:lnTo>
                      <a:lnTo>
                        <a:pt x="1803" y="132"/>
                      </a:lnTo>
                      <a:lnTo>
                        <a:pt x="1829" y="113"/>
                      </a:lnTo>
                      <a:lnTo>
                        <a:pt x="1853" y="94"/>
                      </a:lnTo>
                      <a:lnTo>
                        <a:pt x="1879" y="75"/>
                      </a:lnTo>
                      <a:lnTo>
                        <a:pt x="1903" y="57"/>
                      </a:lnTo>
                      <a:lnTo>
                        <a:pt x="1929" y="38"/>
                      </a:lnTo>
                      <a:lnTo>
                        <a:pt x="1953" y="19"/>
                      </a:lnTo>
                      <a:lnTo>
                        <a:pt x="1978" y="0"/>
                      </a:lnTo>
                      <a:lnTo>
                        <a:pt x="1978" y="1047"/>
                      </a:lnTo>
                      <a:lnTo>
                        <a:pt x="1953" y="1050"/>
                      </a:lnTo>
                      <a:lnTo>
                        <a:pt x="1929" y="1053"/>
                      </a:lnTo>
                      <a:lnTo>
                        <a:pt x="1903" y="1056"/>
                      </a:lnTo>
                      <a:lnTo>
                        <a:pt x="1879" y="1058"/>
                      </a:lnTo>
                      <a:lnTo>
                        <a:pt x="1853" y="1061"/>
                      </a:lnTo>
                      <a:lnTo>
                        <a:pt x="1829" y="1064"/>
                      </a:lnTo>
                      <a:lnTo>
                        <a:pt x="1803" y="1066"/>
                      </a:lnTo>
                      <a:lnTo>
                        <a:pt x="1779" y="1070"/>
                      </a:lnTo>
                      <a:lnTo>
                        <a:pt x="1753" y="1073"/>
                      </a:lnTo>
                      <a:lnTo>
                        <a:pt x="1729" y="1076"/>
                      </a:lnTo>
                      <a:lnTo>
                        <a:pt x="1703" y="1080"/>
                      </a:lnTo>
                      <a:lnTo>
                        <a:pt x="1678" y="1083"/>
                      </a:lnTo>
                      <a:lnTo>
                        <a:pt x="1653" y="1087"/>
                      </a:lnTo>
                      <a:lnTo>
                        <a:pt x="1628" y="1089"/>
                      </a:lnTo>
                      <a:lnTo>
                        <a:pt x="1603" y="1094"/>
                      </a:lnTo>
                      <a:lnTo>
                        <a:pt x="1578" y="1096"/>
                      </a:lnTo>
                      <a:lnTo>
                        <a:pt x="1552" y="1100"/>
                      </a:lnTo>
                      <a:lnTo>
                        <a:pt x="1528" y="1104"/>
                      </a:lnTo>
                      <a:lnTo>
                        <a:pt x="1502" y="1107"/>
                      </a:lnTo>
                      <a:lnTo>
                        <a:pt x="1478" y="1111"/>
                      </a:lnTo>
                      <a:lnTo>
                        <a:pt x="1452" y="1115"/>
                      </a:lnTo>
                      <a:lnTo>
                        <a:pt x="1428" y="1119"/>
                      </a:lnTo>
                      <a:lnTo>
                        <a:pt x="1402" y="1125"/>
                      </a:lnTo>
                      <a:lnTo>
                        <a:pt x="1378" y="1129"/>
                      </a:lnTo>
                      <a:lnTo>
                        <a:pt x="1352" y="1133"/>
                      </a:lnTo>
                      <a:lnTo>
                        <a:pt x="1327" y="1137"/>
                      </a:lnTo>
                      <a:lnTo>
                        <a:pt x="1302" y="1142"/>
                      </a:lnTo>
                      <a:lnTo>
                        <a:pt x="1277" y="1148"/>
                      </a:lnTo>
                      <a:lnTo>
                        <a:pt x="1252" y="1152"/>
                      </a:lnTo>
                      <a:lnTo>
                        <a:pt x="1227" y="1157"/>
                      </a:lnTo>
                      <a:lnTo>
                        <a:pt x="1201" y="1163"/>
                      </a:lnTo>
                      <a:lnTo>
                        <a:pt x="1177" y="1168"/>
                      </a:lnTo>
                      <a:lnTo>
                        <a:pt x="1151" y="1175"/>
                      </a:lnTo>
                      <a:lnTo>
                        <a:pt x="1127" y="1180"/>
                      </a:lnTo>
                      <a:lnTo>
                        <a:pt x="1101" y="1187"/>
                      </a:lnTo>
                      <a:lnTo>
                        <a:pt x="1077" y="1194"/>
                      </a:lnTo>
                      <a:lnTo>
                        <a:pt x="1052" y="1199"/>
                      </a:lnTo>
                      <a:lnTo>
                        <a:pt x="1027" y="1207"/>
                      </a:lnTo>
                      <a:lnTo>
                        <a:pt x="1002" y="1214"/>
                      </a:lnTo>
                      <a:lnTo>
                        <a:pt x="977" y="1221"/>
                      </a:lnTo>
                      <a:lnTo>
                        <a:pt x="952" y="1229"/>
                      </a:lnTo>
                      <a:lnTo>
                        <a:pt x="926" y="1237"/>
                      </a:lnTo>
                      <a:lnTo>
                        <a:pt x="902" y="1245"/>
                      </a:lnTo>
                      <a:lnTo>
                        <a:pt x="876" y="1255"/>
                      </a:lnTo>
                      <a:lnTo>
                        <a:pt x="852" y="1263"/>
                      </a:lnTo>
                      <a:lnTo>
                        <a:pt x="826" y="1272"/>
                      </a:lnTo>
                      <a:lnTo>
                        <a:pt x="802" y="1282"/>
                      </a:lnTo>
                      <a:lnTo>
                        <a:pt x="776" y="1293"/>
                      </a:lnTo>
                      <a:lnTo>
                        <a:pt x="752" y="1302"/>
                      </a:lnTo>
                      <a:lnTo>
                        <a:pt x="726" y="1313"/>
                      </a:lnTo>
                      <a:lnTo>
                        <a:pt x="702" y="1324"/>
                      </a:lnTo>
                      <a:lnTo>
                        <a:pt x="676" y="1336"/>
                      </a:lnTo>
                      <a:lnTo>
                        <a:pt x="651" y="1347"/>
                      </a:lnTo>
                      <a:lnTo>
                        <a:pt x="626" y="1359"/>
                      </a:lnTo>
                      <a:lnTo>
                        <a:pt x="601" y="1371"/>
                      </a:lnTo>
                      <a:lnTo>
                        <a:pt x="576" y="1385"/>
                      </a:lnTo>
                      <a:lnTo>
                        <a:pt x="551" y="1397"/>
                      </a:lnTo>
                      <a:lnTo>
                        <a:pt x="525" y="1411"/>
                      </a:lnTo>
                      <a:lnTo>
                        <a:pt x="501" y="1424"/>
                      </a:lnTo>
                      <a:lnTo>
                        <a:pt x="475" y="1439"/>
                      </a:lnTo>
                      <a:lnTo>
                        <a:pt x="451" y="1453"/>
                      </a:lnTo>
                      <a:lnTo>
                        <a:pt x="425" y="1467"/>
                      </a:lnTo>
                      <a:lnTo>
                        <a:pt x="401" y="1482"/>
                      </a:lnTo>
                      <a:lnTo>
                        <a:pt x="375" y="1497"/>
                      </a:lnTo>
                      <a:lnTo>
                        <a:pt x="351" y="1512"/>
                      </a:lnTo>
                      <a:lnTo>
                        <a:pt x="325" y="1527"/>
                      </a:lnTo>
                      <a:lnTo>
                        <a:pt x="301" y="1543"/>
                      </a:lnTo>
                      <a:lnTo>
                        <a:pt x="275" y="1558"/>
                      </a:lnTo>
                      <a:lnTo>
                        <a:pt x="250" y="1574"/>
                      </a:lnTo>
                      <a:lnTo>
                        <a:pt x="225" y="1591"/>
                      </a:lnTo>
                      <a:lnTo>
                        <a:pt x="200" y="1607"/>
                      </a:lnTo>
                      <a:lnTo>
                        <a:pt x="175" y="1625"/>
                      </a:lnTo>
                      <a:lnTo>
                        <a:pt x="150" y="1641"/>
                      </a:lnTo>
                      <a:lnTo>
                        <a:pt x="126" y="1657"/>
                      </a:lnTo>
                      <a:lnTo>
                        <a:pt x="100" y="1675"/>
                      </a:lnTo>
                      <a:lnTo>
                        <a:pt x="76" y="1692"/>
                      </a:lnTo>
                      <a:lnTo>
                        <a:pt x="50" y="1709"/>
                      </a:lnTo>
                      <a:lnTo>
                        <a:pt x="26" y="1726"/>
                      </a:lnTo>
                      <a:lnTo>
                        <a:pt x="0" y="1744"/>
                      </a:lnTo>
                      <a:lnTo>
                        <a:pt x="0" y="1012"/>
                      </a:lnTo>
                      <a:close/>
                    </a:path>
                  </a:pathLst>
                </a:cu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8" name="Freeform 68">
                  <a:extLst>
                    <a:ext uri="{FF2B5EF4-FFF2-40B4-BE49-F238E27FC236}">
                      <a16:creationId xmlns:a16="http://schemas.microsoft.com/office/drawing/2014/main" id="{DE179B14-0AE6-C531-5AF3-B664245F8FB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057400" y="1822450"/>
                  <a:ext cx="3140075" cy="1606550"/>
                </a:xfrm>
                <a:custGeom>
                  <a:avLst/>
                  <a:gdLst>
                    <a:gd name="T0" fmla="*/ 26 w 1978"/>
                    <a:gd name="T1" fmla="*/ 1008 h 1012"/>
                    <a:gd name="T2" fmla="*/ 76 w 1978"/>
                    <a:gd name="T3" fmla="*/ 1000 h 1012"/>
                    <a:gd name="T4" fmla="*/ 126 w 1978"/>
                    <a:gd name="T5" fmla="*/ 991 h 1012"/>
                    <a:gd name="T6" fmla="*/ 175 w 1978"/>
                    <a:gd name="T7" fmla="*/ 981 h 1012"/>
                    <a:gd name="T8" fmla="*/ 225 w 1978"/>
                    <a:gd name="T9" fmla="*/ 970 h 1012"/>
                    <a:gd name="T10" fmla="*/ 275 w 1978"/>
                    <a:gd name="T11" fmla="*/ 959 h 1012"/>
                    <a:gd name="T12" fmla="*/ 325 w 1978"/>
                    <a:gd name="T13" fmla="*/ 949 h 1012"/>
                    <a:gd name="T14" fmla="*/ 375 w 1978"/>
                    <a:gd name="T15" fmla="*/ 935 h 1012"/>
                    <a:gd name="T16" fmla="*/ 425 w 1978"/>
                    <a:gd name="T17" fmla="*/ 921 h 1012"/>
                    <a:gd name="T18" fmla="*/ 475 w 1978"/>
                    <a:gd name="T19" fmla="*/ 907 h 1012"/>
                    <a:gd name="T20" fmla="*/ 525 w 1978"/>
                    <a:gd name="T21" fmla="*/ 892 h 1012"/>
                    <a:gd name="T22" fmla="*/ 576 w 1978"/>
                    <a:gd name="T23" fmla="*/ 874 h 1012"/>
                    <a:gd name="T24" fmla="*/ 626 w 1978"/>
                    <a:gd name="T25" fmla="*/ 856 h 1012"/>
                    <a:gd name="T26" fmla="*/ 676 w 1978"/>
                    <a:gd name="T27" fmla="*/ 836 h 1012"/>
                    <a:gd name="T28" fmla="*/ 726 w 1978"/>
                    <a:gd name="T29" fmla="*/ 816 h 1012"/>
                    <a:gd name="T30" fmla="*/ 776 w 1978"/>
                    <a:gd name="T31" fmla="*/ 793 h 1012"/>
                    <a:gd name="T32" fmla="*/ 826 w 1978"/>
                    <a:gd name="T33" fmla="*/ 770 h 1012"/>
                    <a:gd name="T34" fmla="*/ 876 w 1978"/>
                    <a:gd name="T35" fmla="*/ 745 h 1012"/>
                    <a:gd name="T36" fmla="*/ 926 w 1978"/>
                    <a:gd name="T37" fmla="*/ 718 h 1012"/>
                    <a:gd name="T38" fmla="*/ 977 w 1978"/>
                    <a:gd name="T39" fmla="*/ 691 h 1012"/>
                    <a:gd name="T40" fmla="*/ 1027 w 1978"/>
                    <a:gd name="T41" fmla="*/ 663 h 1012"/>
                    <a:gd name="T42" fmla="*/ 1077 w 1978"/>
                    <a:gd name="T43" fmla="*/ 633 h 1012"/>
                    <a:gd name="T44" fmla="*/ 1127 w 1978"/>
                    <a:gd name="T45" fmla="*/ 602 h 1012"/>
                    <a:gd name="T46" fmla="*/ 1177 w 1978"/>
                    <a:gd name="T47" fmla="*/ 571 h 1012"/>
                    <a:gd name="T48" fmla="*/ 1227 w 1978"/>
                    <a:gd name="T49" fmla="*/ 538 h 1012"/>
                    <a:gd name="T50" fmla="*/ 1277 w 1978"/>
                    <a:gd name="T51" fmla="*/ 506 h 1012"/>
                    <a:gd name="T52" fmla="*/ 1327 w 1978"/>
                    <a:gd name="T53" fmla="*/ 472 h 1012"/>
                    <a:gd name="T54" fmla="*/ 1378 w 1978"/>
                    <a:gd name="T55" fmla="*/ 438 h 1012"/>
                    <a:gd name="T56" fmla="*/ 1428 w 1978"/>
                    <a:gd name="T57" fmla="*/ 404 h 1012"/>
                    <a:gd name="T58" fmla="*/ 1478 w 1978"/>
                    <a:gd name="T59" fmla="*/ 369 h 1012"/>
                    <a:gd name="T60" fmla="*/ 1528 w 1978"/>
                    <a:gd name="T61" fmla="*/ 332 h 1012"/>
                    <a:gd name="T62" fmla="*/ 1578 w 1978"/>
                    <a:gd name="T63" fmla="*/ 297 h 1012"/>
                    <a:gd name="T64" fmla="*/ 1628 w 1978"/>
                    <a:gd name="T65" fmla="*/ 260 h 1012"/>
                    <a:gd name="T66" fmla="*/ 1678 w 1978"/>
                    <a:gd name="T67" fmla="*/ 224 h 1012"/>
                    <a:gd name="T68" fmla="*/ 1729 w 1978"/>
                    <a:gd name="T69" fmla="*/ 187 h 1012"/>
                    <a:gd name="T70" fmla="*/ 1779 w 1978"/>
                    <a:gd name="T71" fmla="*/ 151 h 1012"/>
                    <a:gd name="T72" fmla="*/ 1829 w 1978"/>
                    <a:gd name="T73" fmla="*/ 113 h 1012"/>
                    <a:gd name="T74" fmla="*/ 1879 w 1978"/>
                    <a:gd name="T75" fmla="*/ 75 h 1012"/>
                    <a:gd name="T76" fmla="*/ 1929 w 1978"/>
                    <a:gd name="T77" fmla="*/ 38 h 1012"/>
                    <a:gd name="T78" fmla="*/ 1978 w 1978"/>
                    <a:gd name="T79" fmla="*/ 0 h 101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</a:cxnLst>
                  <a:rect l="0" t="0" r="r" b="b"/>
                  <a:pathLst>
                    <a:path w="1978" h="1012">
                      <a:moveTo>
                        <a:pt x="0" y="1012"/>
                      </a:moveTo>
                      <a:lnTo>
                        <a:pt x="26" y="1008"/>
                      </a:lnTo>
                      <a:lnTo>
                        <a:pt x="50" y="1004"/>
                      </a:lnTo>
                      <a:lnTo>
                        <a:pt x="76" y="1000"/>
                      </a:lnTo>
                      <a:lnTo>
                        <a:pt x="100" y="995"/>
                      </a:lnTo>
                      <a:lnTo>
                        <a:pt x="126" y="991"/>
                      </a:lnTo>
                      <a:lnTo>
                        <a:pt x="150" y="986"/>
                      </a:lnTo>
                      <a:lnTo>
                        <a:pt x="175" y="981"/>
                      </a:lnTo>
                      <a:lnTo>
                        <a:pt x="200" y="976"/>
                      </a:lnTo>
                      <a:lnTo>
                        <a:pt x="225" y="970"/>
                      </a:lnTo>
                      <a:lnTo>
                        <a:pt x="250" y="965"/>
                      </a:lnTo>
                      <a:lnTo>
                        <a:pt x="275" y="959"/>
                      </a:lnTo>
                      <a:lnTo>
                        <a:pt x="301" y="954"/>
                      </a:lnTo>
                      <a:lnTo>
                        <a:pt x="325" y="949"/>
                      </a:lnTo>
                      <a:lnTo>
                        <a:pt x="351" y="942"/>
                      </a:lnTo>
                      <a:lnTo>
                        <a:pt x="375" y="935"/>
                      </a:lnTo>
                      <a:lnTo>
                        <a:pt x="401" y="928"/>
                      </a:lnTo>
                      <a:lnTo>
                        <a:pt x="425" y="921"/>
                      </a:lnTo>
                      <a:lnTo>
                        <a:pt x="451" y="915"/>
                      </a:lnTo>
                      <a:lnTo>
                        <a:pt x="475" y="907"/>
                      </a:lnTo>
                      <a:lnTo>
                        <a:pt x="501" y="900"/>
                      </a:lnTo>
                      <a:lnTo>
                        <a:pt x="525" y="892"/>
                      </a:lnTo>
                      <a:lnTo>
                        <a:pt x="551" y="884"/>
                      </a:lnTo>
                      <a:lnTo>
                        <a:pt x="576" y="874"/>
                      </a:lnTo>
                      <a:lnTo>
                        <a:pt x="601" y="866"/>
                      </a:lnTo>
                      <a:lnTo>
                        <a:pt x="626" y="856"/>
                      </a:lnTo>
                      <a:lnTo>
                        <a:pt x="651" y="847"/>
                      </a:lnTo>
                      <a:lnTo>
                        <a:pt x="676" y="836"/>
                      </a:lnTo>
                      <a:lnTo>
                        <a:pt x="702" y="827"/>
                      </a:lnTo>
                      <a:lnTo>
                        <a:pt x="726" y="816"/>
                      </a:lnTo>
                      <a:lnTo>
                        <a:pt x="752" y="805"/>
                      </a:lnTo>
                      <a:lnTo>
                        <a:pt x="776" y="793"/>
                      </a:lnTo>
                      <a:lnTo>
                        <a:pt x="802" y="782"/>
                      </a:lnTo>
                      <a:lnTo>
                        <a:pt x="826" y="770"/>
                      </a:lnTo>
                      <a:lnTo>
                        <a:pt x="852" y="758"/>
                      </a:lnTo>
                      <a:lnTo>
                        <a:pt x="876" y="745"/>
                      </a:lnTo>
                      <a:lnTo>
                        <a:pt x="902" y="732"/>
                      </a:lnTo>
                      <a:lnTo>
                        <a:pt x="926" y="718"/>
                      </a:lnTo>
                      <a:lnTo>
                        <a:pt x="952" y="705"/>
                      </a:lnTo>
                      <a:lnTo>
                        <a:pt x="977" y="691"/>
                      </a:lnTo>
                      <a:lnTo>
                        <a:pt x="1002" y="676"/>
                      </a:lnTo>
                      <a:lnTo>
                        <a:pt x="1027" y="663"/>
                      </a:lnTo>
                      <a:lnTo>
                        <a:pt x="1052" y="648"/>
                      </a:lnTo>
                      <a:lnTo>
                        <a:pt x="1077" y="633"/>
                      </a:lnTo>
                      <a:lnTo>
                        <a:pt x="1101" y="618"/>
                      </a:lnTo>
                      <a:lnTo>
                        <a:pt x="1127" y="602"/>
                      </a:lnTo>
                      <a:lnTo>
                        <a:pt x="1151" y="587"/>
                      </a:lnTo>
                      <a:lnTo>
                        <a:pt x="1177" y="571"/>
                      </a:lnTo>
                      <a:lnTo>
                        <a:pt x="1201" y="554"/>
                      </a:lnTo>
                      <a:lnTo>
                        <a:pt x="1227" y="538"/>
                      </a:lnTo>
                      <a:lnTo>
                        <a:pt x="1252" y="522"/>
                      </a:lnTo>
                      <a:lnTo>
                        <a:pt x="1277" y="506"/>
                      </a:lnTo>
                      <a:lnTo>
                        <a:pt x="1302" y="489"/>
                      </a:lnTo>
                      <a:lnTo>
                        <a:pt x="1327" y="472"/>
                      </a:lnTo>
                      <a:lnTo>
                        <a:pt x="1352" y="455"/>
                      </a:lnTo>
                      <a:lnTo>
                        <a:pt x="1378" y="438"/>
                      </a:lnTo>
                      <a:lnTo>
                        <a:pt x="1402" y="420"/>
                      </a:lnTo>
                      <a:lnTo>
                        <a:pt x="1428" y="404"/>
                      </a:lnTo>
                      <a:lnTo>
                        <a:pt x="1452" y="386"/>
                      </a:lnTo>
                      <a:lnTo>
                        <a:pt x="1478" y="369"/>
                      </a:lnTo>
                      <a:lnTo>
                        <a:pt x="1502" y="351"/>
                      </a:lnTo>
                      <a:lnTo>
                        <a:pt x="1528" y="332"/>
                      </a:lnTo>
                      <a:lnTo>
                        <a:pt x="1552" y="315"/>
                      </a:lnTo>
                      <a:lnTo>
                        <a:pt x="1578" y="297"/>
                      </a:lnTo>
                      <a:lnTo>
                        <a:pt x="1603" y="278"/>
                      </a:lnTo>
                      <a:lnTo>
                        <a:pt x="1628" y="260"/>
                      </a:lnTo>
                      <a:lnTo>
                        <a:pt x="1653" y="243"/>
                      </a:lnTo>
                      <a:lnTo>
                        <a:pt x="1678" y="224"/>
                      </a:lnTo>
                      <a:lnTo>
                        <a:pt x="1703" y="206"/>
                      </a:lnTo>
                      <a:lnTo>
                        <a:pt x="1729" y="187"/>
                      </a:lnTo>
                      <a:lnTo>
                        <a:pt x="1753" y="168"/>
                      </a:lnTo>
                      <a:lnTo>
                        <a:pt x="1779" y="151"/>
                      </a:lnTo>
                      <a:lnTo>
                        <a:pt x="1803" y="132"/>
                      </a:lnTo>
                      <a:lnTo>
                        <a:pt x="1829" y="113"/>
                      </a:lnTo>
                      <a:lnTo>
                        <a:pt x="1853" y="94"/>
                      </a:lnTo>
                      <a:lnTo>
                        <a:pt x="1879" y="75"/>
                      </a:lnTo>
                      <a:lnTo>
                        <a:pt x="1903" y="57"/>
                      </a:lnTo>
                      <a:lnTo>
                        <a:pt x="1929" y="38"/>
                      </a:lnTo>
                      <a:lnTo>
                        <a:pt x="1953" y="19"/>
                      </a:lnTo>
                      <a:lnTo>
                        <a:pt x="1978" y="0"/>
                      </a:lnTo>
                    </a:path>
                  </a:pathLst>
                </a:cu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9" name="Freeform 69">
                  <a:extLst>
                    <a:ext uri="{FF2B5EF4-FFF2-40B4-BE49-F238E27FC236}">
                      <a16:creationId xmlns:a16="http://schemas.microsoft.com/office/drawing/2014/main" id="{F73DE64F-4952-A64A-BBEF-0F7C11284B1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057400" y="3484562"/>
                  <a:ext cx="3140075" cy="1106487"/>
                </a:xfrm>
                <a:custGeom>
                  <a:avLst/>
                  <a:gdLst>
                    <a:gd name="T0" fmla="*/ 1953 w 1978"/>
                    <a:gd name="T1" fmla="*/ 3 h 697"/>
                    <a:gd name="T2" fmla="*/ 1903 w 1978"/>
                    <a:gd name="T3" fmla="*/ 9 h 697"/>
                    <a:gd name="T4" fmla="*/ 1853 w 1978"/>
                    <a:gd name="T5" fmla="*/ 14 h 697"/>
                    <a:gd name="T6" fmla="*/ 1803 w 1978"/>
                    <a:gd name="T7" fmla="*/ 19 h 697"/>
                    <a:gd name="T8" fmla="*/ 1753 w 1978"/>
                    <a:gd name="T9" fmla="*/ 26 h 697"/>
                    <a:gd name="T10" fmla="*/ 1703 w 1978"/>
                    <a:gd name="T11" fmla="*/ 33 h 697"/>
                    <a:gd name="T12" fmla="*/ 1653 w 1978"/>
                    <a:gd name="T13" fmla="*/ 40 h 697"/>
                    <a:gd name="T14" fmla="*/ 1603 w 1978"/>
                    <a:gd name="T15" fmla="*/ 47 h 697"/>
                    <a:gd name="T16" fmla="*/ 1552 w 1978"/>
                    <a:gd name="T17" fmla="*/ 53 h 697"/>
                    <a:gd name="T18" fmla="*/ 1502 w 1978"/>
                    <a:gd name="T19" fmla="*/ 60 h 697"/>
                    <a:gd name="T20" fmla="*/ 1452 w 1978"/>
                    <a:gd name="T21" fmla="*/ 68 h 697"/>
                    <a:gd name="T22" fmla="*/ 1402 w 1978"/>
                    <a:gd name="T23" fmla="*/ 78 h 697"/>
                    <a:gd name="T24" fmla="*/ 1352 w 1978"/>
                    <a:gd name="T25" fmla="*/ 86 h 697"/>
                    <a:gd name="T26" fmla="*/ 1302 w 1978"/>
                    <a:gd name="T27" fmla="*/ 95 h 697"/>
                    <a:gd name="T28" fmla="*/ 1252 w 1978"/>
                    <a:gd name="T29" fmla="*/ 105 h 697"/>
                    <a:gd name="T30" fmla="*/ 1201 w 1978"/>
                    <a:gd name="T31" fmla="*/ 116 h 697"/>
                    <a:gd name="T32" fmla="*/ 1151 w 1978"/>
                    <a:gd name="T33" fmla="*/ 128 h 697"/>
                    <a:gd name="T34" fmla="*/ 1101 w 1978"/>
                    <a:gd name="T35" fmla="*/ 140 h 697"/>
                    <a:gd name="T36" fmla="*/ 1052 w 1978"/>
                    <a:gd name="T37" fmla="*/ 152 h 697"/>
                    <a:gd name="T38" fmla="*/ 1002 w 1978"/>
                    <a:gd name="T39" fmla="*/ 167 h 697"/>
                    <a:gd name="T40" fmla="*/ 952 w 1978"/>
                    <a:gd name="T41" fmla="*/ 182 h 697"/>
                    <a:gd name="T42" fmla="*/ 902 w 1978"/>
                    <a:gd name="T43" fmla="*/ 198 h 697"/>
                    <a:gd name="T44" fmla="*/ 852 w 1978"/>
                    <a:gd name="T45" fmla="*/ 216 h 697"/>
                    <a:gd name="T46" fmla="*/ 802 w 1978"/>
                    <a:gd name="T47" fmla="*/ 235 h 697"/>
                    <a:gd name="T48" fmla="*/ 752 w 1978"/>
                    <a:gd name="T49" fmla="*/ 255 h 697"/>
                    <a:gd name="T50" fmla="*/ 702 w 1978"/>
                    <a:gd name="T51" fmla="*/ 277 h 697"/>
                    <a:gd name="T52" fmla="*/ 651 w 1978"/>
                    <a:gd name="T53" fmla="*/ 300 h 697"/>
                    <a:gd name="T54" fmla="*/ 601 w 1978"/>
                    <a:gd name="T55" fmla="*/ 324 h 697"/>
                    <a:gd name="T56" fmla="*/ 551 w 1978"/>
                    <a:gd name="T57" fmla="*/ 350 h 697"/>
                    <a:gd name="T58" fmla="*/ 501 w 1978"/>
                    <a:gd name="T59" fmla="*/ 377 h 697"/>
                    <a:gd name="T60" fmla="*/ 451 w 1978"/>
                    <a:gd name="T61" fmla="*/ 406 h 697"/>
                    <a:gd name="T62" fmla="*/ 401 w 1978"/>
                    <a:gd name="T63" fmla="*/ 435 h 697"/>
                    <a:gd name="T64" fmla="*/ 351 w 1978"/>
                    <a:gd name="T65" fmla="*/ 465 h 697"/>
                    <a:gd name="T66" fmla="*/ 301 w 1978"/>
                    <a:gd name="T67" fmla="*/ 496 h 697"/>
                    <a:gd name="T68" fmla="*/ 250 w 1978"/>
                    <a:gd name="T69" fmla="*/ 527 h 697"/>
                    <a:gd name="T70" fmla="*/ 200 w 1978"/>
                    <a:gd name="T71" fmla="*/ 560 h 697"/>
                    <a:gd name="T72" fmla="*/ 150 w 1978"/>
                    <a:gd name="T73" fmla="*/ 594 h 697"/>
                    <a:gd name="T74" fmla="*/ 100 w 1978"/>
                    <a:gd name="T75" fmla="*/ 628 h 697"/>
                    <a:gd name="T76" fmla="*/ 50 w 1978"/>
                    <a:gd name="T77" fmla="*/ 662 h 697"/>
                    <a:gd name="T78" fmla="*/ 0 w 1978"/>
                    <a:gd name="T79" fmla="*/ 697 h 69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</a:cxnLst>
                  <a:rect l="0" t="0" r="r" b="b"/>
                  <a:pathLst>
                    <a:path w="1978" h="697">
                      <a:moveTo>
                        <a:pt x="1978" y="0"/>
                      </a:moveTo>
                      <a:lnTo>
                        <a:pt x="1953" y="3"/>
                      </a:lnTo>
                      <a:lnTo>
                        <a:pt x="1929" y="6"/>
                      </a:lnTo>
                      <a:lnTo>
                        <a:pt x="1903" y="9"/>
                      </a:lnTo>
                      <a:lnTo>
                        <a:pt x="1879" y="11"/>
                      </a:lnTo>
                      <a:lnTo>
                        <a:pt x="1853" y="14"/>
                      </a:lnTo>
                      <a:lnTo>
                        <a:pt x="1829" y="17"/>
                      </a:lnTo>
                      <a:lnTo>
                        <a:pt x="1803" y="19"/>
                      </a:lnTo>
                      <a:lnTo>
                        <a:pt x="1779" y="23"/>
                      </a:lnTo>
                      <a:lnTo>
                        <a:pt x="1753" y="26"/>
                      </a:lnTo>
                      <a:lnTo>
                        <a:pt x="1729" y="29"/>
                      </a:lnTo>
                      <a:lnTo>
                        <a:pt x="1703" y="33"/>
                      </a:lnTo>
                      <a:lnTo>
                        <a:pt x="1678" y="36"/>
                      </a:lnTo>
                      <a:lnTo>
                        <a:pt x="1653" y="40"/>
                      </a:lnTo>
                      <a:lnTo>
                        <a:pt x="1628" y="42"/>
                      </a:lnTo>
                      <a:lnTo>
                        <a:pt x="1603" y="47"/>
                      </a:lnTo>
                      <a:lnTo>
                        <a:pt x="1578" y="49"/>
                      </a:lnTo>
                      <a:lnTo>
                        <a:pt x="1552" y="53"/>
                      </a:lnTo>
                      <a:lnTo>
                        <a:pt x="1528" y="57"/>
                      </a:lnTo>
                      <a:lnTo>
                        <a:pt x="1502" y="60"/>
                      </a:lnTo>
                      <a:lnTo>
                        <a:pt x="1478" y="64"/>
                      </a:lnTo>
                      <a:lnTo>
                        <a:pt x="1452" y="68"/>
                      </a:lnTo>
                      <a:lnTo>
                        <a:pt x="1428" y="72"/>
                      </a:lnTo>
                      <a:lnTo>
                        <a:pt x="1402" y="78"/>
                      </a:lnTo>
                      <a:lnTo>
                        <a:pt x="1378" y="82"/>
                      </a:lnTo>
                      <a:lnTo>
                        <a:pt x="1352" y="86"/>
                      </a:lnTo>
                      <a:lnTo>
                        <a:pt x="1327" y="90"/>
                      </a:lnTo>
                      <a:lnTo>
                        <a:pt x="1302" y="95"/>
                      </a:lnTo>
                      <a:lnTo>
                        <a:pt x="1277" y="101"/>
                      </a:lnTo>
                      <a:lnTo>
                        <a:pt x="1252" y="105"/>
                      </a:lnTo>
                      <a:lnTo>
                        <a:pt x="1227" y="110"/>
                      </a:lnTo>
                      <a:lnTo>
                        <a:pt x="1201" y="116"/>
                      </a:lnTo>
                      <a:lnTo>
                        <a:pt x="1177" y="121"/>
                      </a:lnTo>
                      <a:lnTo>
                        <a:pt x="1151" y="128"/>
                      </a:lnTo>
                      <a:lnTo>
                        <a:pt x="1127" y="133"/>
                      </a:lnTo>
                      <a:lnTo>
                        <a:pt x="1101" y="140"/>
                      </a:lnTo>
                      <a:lnTo>
                        <a:pt x="1077" y="147"/>
                      </a:lnTo>
                      <a:lnTo>
                        <a:pt x="1052" y="152"/>
                      </a:lnTo>
                      <a:lnTo>
                        <a:pt x="1027" y="160"/>
                      </a:lnTo>
                      <a:lnTo>
                        <a:pt x="1002" y="167"/>
                      </a:lnTo>
                      <a:lnTo>
                        <a:pt x="977" y="174"/>
                      </a:lnTo>
                      <a:lnTo>
                        <a:pt x="952" y="182"/>
                      </a:lnTo>
                      <a:lnTo>
                        <a:pt x="926" y="190"/>
                      </a:lnTo>
                      <a:lnTo>
                        <a:pt x="902" y="198"/>
                      </a:lnTo>
                      <a:lnTo>
                        <a:pt x="876" y="208"/>
                      </a:lnTo>
                      <a:lnTo>
                        <a:pt x="852" y="216"/>
                      </a:lnTo>
                      <a:lnTo>
                        <a:pt x="826" y="225"/>
                      </a:lnTo>
                      <a:lnTo>
                        <a:pt x="802" y="235"/>
                      </a:lnTo>
                      <a:lnTo>
                        <a:pt x="776" y="246"/>
                      </a:lnTo>
                      <a:lnTo>
                        <a:pt x="752" y="255"/>
                      </a:lnTo>
                      <a:lnTo>
                        <a:pt x="726" y="266"/>
                      </a:lnTo>
                      <a:lnTo>
                        <a:pt x="702" y="277"/>
                      </a:lnTo>
                      <a:lnTo>
                        <a:pt x="676" y="289"/>
                      </a:lnTo>
                      <a:lnTo>
                        <a:pt x="651" y="300"/>
                      </a:lnTo>
                      <a:lnTo>
                        <a:pt x="626" y="312"/>
                      </a:lnTo>
                      <a:lnTo>
                        <a:pt x="601" y="324"/>
                      </a:lnTo>
                      <a:lnTo>
                        <a:pt x="576" y="338"/>
                      </a:lnTo>
                      <a:lnTo>
                        <a:pt x="551" y="350"/>
                      </a:lnTo>
                      <a:lnTo>
                        <a:pt x="525" y="364"/>
                      </a:lnTo>
                      <a:lnTo>
                        <a:pt x="501" y="377"/>
                      </a:lnTo>
                      <a:lnTo>
                        <a:pt x="475" y="392"/>
                      </a:lnTo>
                      <a:lnTo>
                        <a:pt x="451" y="406"/>
                      </a:lnTo>
                      <a:lnTo>
                        <a:pt x="425" y="420"/>
                      </a:lnTo>
                      <a:lnTo>
                        <a:pt x="401" y="435"/>
                      </a:lnTo>
                      <a:lnTo>
                        <a:pt x="375" y="450"/>
                      </a:lnTo>
                      <a:lnTo>
                        <a:pt x="351" y="465"/>
                      </a:lnTo>
                      <a:lnTo>
                        <a:pt x="325" y="480"/>
                      </a:lnTo>
                      <a:lnTo>
                        <a:pt x="301" y="496"/>
                      </a:lnTo>
                      <a:lnTo>
                        <a:pt x="275" y="511"/>
                      </a:lnTo>
                      <a:lnTo>
                        <a:pt x="250" y="527"/>
                      </a:lnTo>
                      <a:lnTo>
                        <a:pt x="225" y="544"/>
                      </a:lnTo>
                      <a:lnTo>
                        <a:pt x="200" y="560"/>
                      </a:lnTo>
                      <a:lnTo>
                        <a:pt x="175" y="578"/>
                      </a:lnTo>
                      <a:lnTo>
                        <a:pt x="150" y="594"/>
                      </a:lnTo>
                      <a:lnTo>
                        <a:pt x="126" y="610"/>
                      </a:lnTo>
                      <a:lnTo>
                        <a:pt x="100" y="628"/>
                      </a:lnTo>
                      <a:lnTo>
                        <a:pt x="76" y="645"/>
                      </a:lnTo>
                      <a:lnTo>
                        <a:pt x="50" y="662"/>
                      </a:lnTo>
                      <a:lnTo>
                        <a:pt x="26" y="679"/>
                      </a:lnTo>
                      <a:lnTo>
                        <a:pt x="0" y="697"/>
                      </a:lnTo>
                    </a:path>
                  </a:pathLst>
                </a:cu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20" name="Freeform 70">
                  <a:extLst>
                    <a:ext uri="{FF2B5EF4-FFF2-40B4-BE49-F238E27FC236}">
                      <a16:creationId xmlns:a16="http://schemas.microsoft.com/office/drawing/2014/main" id="{5E360036-F772-30BB-FD99-C87506E1B67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057400" y="2652712"/>
                  <a:ext cx="3140075" cy="1357312"/>
                </a:xfrm>
                <a:custGeom>
                  <a:avLst/>
                  <a:gdLst>
                    <a:gd name="T0" fmla="*/ 26 w 1978"/>
                    <a:gd name="T1" fmla="*/ 844 h 855"/>
                    <a:gd name="T2" fmla="*/ 76 w 1978"/>
                    <a:gd name="T3" fmla="*/ 823 h 855"/>
                    <a:gd name="T4" fmla="*/ 126 w 1978"/>
                    <a:gd name="T5" fmla="*/ 801 h 855"/>
                    <a:gd name="T6" fmla="*/ 175 w 1978"/>
                    <a:gd name="T7" fmla="*/ 779 h 855"/>
                    <a:gd name="T8" fmla="*/ 225 w 1978"/>
                    <a:gd name="T9" fmla="*/ 757 h 855"/>
                    <a:gd name="T10" fmla="*/ 275 w 1978"/>
                    <a:gd name="T11" fmla="*/ 736 h 855"/>
                    <a:gd name="T12" fmla="*/ 325 w 1978"/>
                    <a:gd name="T13" fmla="*/ 714 h 855"/>
                    <a:gd name="T14" fmla="*/ 375 w 1978"/>
                    <a:gd name="T15" fmla="*/ 692 h 855"/>
                    <a:gd name="T16" fmla="*/ 425 w 1978"/>
                    <a:gd name="T17" fmla="*/ 671 h 855"/>
                    <a:gd name="T18" fmla="*/ 475 w 1978"/>
                    <a:gd name="T19" fmla="*/ 649 h 855"/>
                    <a:gd name="T20" fmla="*/ 525 w 1978"/>
                    <a:gd name="T21" fmla="*/ 627 h 855"/>
                    <a:gd name="T22" fmla="*/ 576 w 1978"/>
                    <a:gd name="T23" fmla="*/ 606 h 855"/>
                    <a:gd name="T24" fmla="*/ 626 w 1978"/>
                    <a:gd name="T25" fmla="*/ 585 h 855"/>
                    <a:gd name="T26" fmla="*/ 676 w 1978"/>
                    <a:gd name="T27" fmla="*/ 564 h 855"/>
                    <a:gd name="T28" fmla="*/ 726 w 1978"/>
                    <a:gd name="T29" fmla="*/ 542 h 855"/>
                    <a:gd name="T30" fmla="*/ 776 w 1978"/>
                    <a:gd name="T31" fmla="*/ 520 h 855"/>
                    <a:gd name="T32" fmla="*/ 826 w 1978"/>
                    <a:gd name="T33" fmla="*/ 499 h 855"/>
                    <a:gd name="T34" fmla="*/ 876 w 1978"/>
                    <a:gd name="T35" fmla="*/ 477 h 855"/>
                    <a:gd name="T36" fmla="*/ 926 w 1978"/>
                    <a:gd name="T37" fmla="*/ 455 h 855"/>
                    <a:gd name="T38" fmla="*/ 977 w 1978"/>
                    <a:gd name="T39" fmla="*/ 434 h 855"/>
                    <a:gd name="T40" fmla="*/ 1027 w 1978"/>
                    <a:gd name="T41" fmla="*/ 412 h 855"/>
                    <a:gd name="T42" fmla="*/ 1077 w 1978"/>
                    <a:gd name="T43" fmla="*/ 390 h 855"/>
                    <a:gd name="T44" fmla="*/ 1127 w 1978"/>
                    <a:gd name="T45" fmla="*/ 369 h 855"/>
                    <a:gd name="T46" fmla="*/ 1177 w 1978"/>
                    <a:gd name="T47" fmla="*/ 347 h 855"/>
                    <a:gd name="T48" fmla="*/ 1227 w 1978"/>
                    <a:gd name="T49" fmla="*/ 325 h 855"/>
                    <a:gd name="T50" fmla="*/ 1277 w 1978"/>
                    <a:gd name="T51" fmla="*/ 304 h 855"/>
                    <a:gd name="T52" fmla="*/ 1327 w 1978"/>
                    <a:gd name="T53" fmla="*/ 282 h 855"/>
                    <a:gd name="T54" fmla="*/ 1378 w 1978"/>
                    <a:gd name="T55" fmla="*/ 260 h 855"/>
                    <a:gd name="T56" fmla="*/ 1428 w 1978"/>
                    <a:gd name="T57" fmla="*/ 239 h 855"/>
                    <a:gd name="T58" fmla="*/ 1478 w 1978"/>
                    <a:gd name="T59" fmla="*/ 217 h 855"/>
                    <a:gd name="T60" fmla="*/ 1528 w 1978"/>
                    <a:gd name="T61" fmla="*/ 195 h 855"/>
                    <a:gd name="T62" fmla="*/ 1578 w 1978"/>
                    <a:gd name="T63" fmla="*/ 174 h 855"/>
                    <a:gd name="T64" fmla="*/ 1628 w 1978"/>
                    <a:gd name="T65" fmla="*/ 152 h 855"/>
                    <a:gd name="T66" fmla="*/ 1678 w 1978"/>
                    <a:gd name="T67" fmla="*/ 130 h 855"/>
                    <a:gd name="T68" fmla="*/ 1729 w 1978"/>
                    <a:gd name="T69" fmla="*/ 109 h 855"/>
                    <a:gd name="T70" fmla="*/ 1779 w 1978"/>
                    <a:gd name="T71" fmla="*/ 87 h 855"/>
                    <a:gd name="T72" fmla="*/ 1829 w 1978"/>
                    <a:gd name="T73" fmla="*/ 65 h 855"/>
                    <a:gd name="T74" fmla="*/ 1879 w 1978"/>
                    <a:gd name="T75" fmla="*/ 44 h 855"/>
                    <a:gd name="T76" fmla="*/ 1929 w 1978"/>
                    <a:gd name="T77" fmla="*/ 22 h 855"/>
                    <a:gd name="T78" fmla="*/ 1978 w 1978"/>
                    <a:gd name="T79" fmla="*/ 0 h 85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</a:cxnLst>
                  <a:rect l="0" t="0" r="r" b="b"/>
                  <a:pathLst>
                    <a:path w="1978" h="855">
                      <a:moveTo>
                        <a:pt x="0" y="855"/>
                      </a:moveTo>
                      <a:lnTo>
                        <a:pt x="26" y="844"/>
                      </a:lnTo>
                      <a:lnTo>
                        <a:pt x="50" y="833"/>
                      </a:lnTo>
                      <a:lnTo>
                        <a:pt x="76" y="823"/>
                      </a:lnTo>
                      <a:lnTo>
                        <a:pt x="100" y="812"/>
                      </a:lnTo>
                      <a:lnTo>
                        <a:pt x="126" y="801"/>
                      </a:lnTo>
                      <a:lnTo>
                        <a:pt x="150" y="790"/>
                      </a:lnTo>
                      <a:lnTo>
                        <a:pt x="175" y="779"/>
                      </a:lnTo>
                      <a:lnTo>
                        <a:pt x="200" y="768"/>
                      </a:lnTo>
                      <a:lnTo>
                        <a:pt x="225" y="757"/>
                      </a:lnTo>
                      <a:lnTo>
                        <a:pt x="250" y="747"/>
                      </a:lnTo>
                      <a:lnTo>
                        <a:pt x="275" y="736"/>
                      </a:lnTo>
                      <a:lnTo>
                        <a:pt x="301" y="725"/>
                      </a:lnTo>
                      <a:lnTo>
                        <a:pt x="325" y="714"/>
                      </a:lnTo>
                      <a:lnTo>
                        <a:pt x="351" y="703"/>
                      </a:lnTo>
                      <a:lnTo>
                        <a:pt x="375" y="692"/>
                      </a:lnTo>
                      <a:lnTo>
                        <a:pt x="401" y="682"/>
                      </a:lnTo>
                      <a:lnTo>
                        <a:pt x="425" y="671"/>
                      </a:lnTo>
                      <a:lnTo>
                        <a:pt x="451" y="660"/>
                      </a:lnTo>
                      <a:lnTo>
                        <a:pt x="475" y="649"/>
                      </a:lnTo>
                      <a:lnTo>
                        <a:pt x="501" y="638"/>
                      </a:lnTo>
                      <a:lnTo>
                        <a:pt x="525" y="627"/>
                      </a:lnTo>
                      <a:lnTo>
                        <a:pt x="551" y="617"/>
                      </a:lnTo>
                      <a:lnTo>
                        <a:pt x="576" y="606"/>
                      </a:lnTo>
                      <a:lnTo>
                        <a:pt x="601" y="596"/>
                      </a:lnTo>
                      <a:lnTo>
                        <a:pt x="626" y="585"/>
                      </a:lnTo>
                      <a:lnTo>
                        <a:pt x="651" y="575"/>
                      </a:lnTo>
                      <a:lnTo>
                        <a:pt x="676" y="564"/>
                      </a:lnTo>
                      <a:lnTo>
                        <a:pt x="702" y="553"/>
                      </a:lnTo>
                      <a:lnTo>
                        <a:pt x="726" y="542"/>
                      </a:lnTo>
                      <a:lnTo>
                        <a:pt x="752" y="531"/>
                      </a:lnTo>
                      <a:lnTo>
                        <a:pt x="776" y="520"/>
                      </a:lnTo>
                      <a:lnTo>
                        <a:pt x="802" y="510"/>
                      </a:lnTo>
                      <a:lnTo>
                        <a:pt x="826" y="499"/>
                      </a:lnTo>
                      <a:lnTo>
                        <a:pt x="852" y="488"/>
                      </a:lnTo>
                      <a:lnTo>
                        <a:pt x="876" y="477"/>
                      </a:lnTo>
                      <a:lnTo>
                        <a:pt x="902" y="466"/>
                      </a:lnTo>
                      <a:lnTo>
                        <a:pt x="926" y="455"/>
                      </a:lnTo>
                      <a:lnTo>
                        <a:pt x="952" y="445"/>
                      </a:lnTo>
                      <a:lnTo>
                        <a:pt x="977" y="434"/>
                      </a:lnTo>
                      <a:lnTo>
                        <a:pt x="1002" y="423"/>
                      </a:lnTo>
                      <a:lnTo>
                        <a:pt x="1027" y="412"/>
                      </a:lnTo>
                      <a:lnTo>
                        <a:pt x="1052" y="401"/>
                      </a:lnTo>
                      <a:lnTo>
                        <a:pt x="1077" y="390"/>
                      </a:lnTo>
                      <a:lnTo>
                        <a:pt x="1101" y="379"/>
                      </a:lnTo>
                      <a:lnTo>
                        <a:pt x="1127" y="369"/>
                      </a:lnTo>
                      <a:lnTo>
                        <a:pt x="1151" y="358"/>
                      </a:lnTo>
                      <a:lnTo>
                        <a:pt x="1177" y="347"/>
                      </a:lnTo>
                      <a:lnTo>
                        <a:pt x="1201" y="336"/>
                      </a:lnTo>
                      <a:lnTo>
                        <a:pt x="1227" y="325"/>
                      </a:lnTo>
                      <a:lnTo>
                        <a:pt x="1252" y="314"/>
                      </a:lnTo>
                      <a:lnTo>
                        <a:pt x="1277" y="304"/>
                      </a:lnTo>
                      <a:lnTo>
                        <a:pt x="1302" y="293"/>
                      </a:lnTo>
                      <a:lnTo>
                        <a:pt x="1327" y="282"/>
                      </a:lnTo>
                      <a:lnTo>
                        <a:pt x="1352" y="271"/>
                      </a:lnTo>
                      <a:lnTo>
                        <a:pt x="1378" y="260"/>
                      </a:lnTo>
                      <a:lnTo>
                        <a:pt x="1402" y="249"/>
                      </a:lnTo>
                      <a:lnTo>
                        <a:pt x="1428" y="239"/>
                      </a:lnTo>
                      <a:lnTo>
                        <a:pt x="1452" y="228"/>
                      </a:lnTo>
                      <a:lnTo>
                        <a:pt x="1478" y="217"/>
                      </a:lnTo>
                      <a:lnTo>
                        <a:pt x="1502" y="206"/>
                      </a:lnTo>
                      <a:lnTo>
                        <a:pt x="1528" y="195"/>
                      </a:lnTo>
                      <a:lnTo>
                        <a:pt x="1552" y="184"/>
                      </a:lnTo>
                      <a:lnTo>
                        <a:pt x="1578" y="174"/>
                      </a:lnTo>
                      <a:lnTo>
                        <a:pt x="1603" y="163"/>
                      </a:lnTo>
                      <a:lnTo>
                        <a:pt x="1628" y="152"/>
                      </a:lnTo>
                      <a:lnTo>
                        <a:pt x="1653" y="141"/>
                      </a:lnTo>
                      <a:lnTo>
                        <a:pt x="1678" y="130"/>
                      </a:lnTo>
                      <a:lnTo>
                        <a:pt x="1703" y="119"/>
                      </a:lnTo>
                      <a:lnTo>
                        <a:pt x="1729" y="109"/>
                      </a:lnTo>
                      <a:lnTo>
                        <a:pt x="1753" y="98"/>
                      </a:lnTo>
                      <a:lnTo>
                        <a:pt x="1779" y="87"/>
                      </a:lnTo>
                      <a:lnTo>
                        <a:pt x="1803" y="76"/>
                      </a:lnTo>
                      <a:lnTo>
                        <a:pt x="1829" y="65"/>
                      </a:lnTo>
                      <a:lnTo>
                        <a:pt x="1853" y="54"/>
                      </a:lnTo>
                      <a:lnTo>
                        <a:pt x="1879" y="44"/>
                      </a:lnTo>
                      <a:lnTo>
                        <a:pt x="1903" y="33"/>
                      </a:lnTo>
                      <a:lnTo>
                        <a:pt x="1929" y="22"/>
                      </a:lnTo>
                      <a:lnTo>
                        <a:pt x="1953" y="11"/>
                      </a:lnTo>
                      <a:lnTo>
                        <a:pt x="1978" y="0"/>
                      </a:lnTo>
                    </a:path>
                  </a:pathLst>
                </a:custGeom>
                <a:noFill/>
                <a:ln w="0" cap="flat">
                  <a:solidFill>
                    <a:srgbClr val="3366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21" name="Rectangle 71">
                  <a:extLst>
                    <a:ext uri="{FF2B5EF4-FFF2-40B4-BE49-F238E27FC236}">
                      <a16:creationId xmlns:a16="http://schemas.microsoft.com/office/drawing/2014/main" id="{708406A5-710D-3D05-87A5-957301C1C90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36977" y="2491254"/>
                  <a:ext cx="799957" cy="81385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1100" b="1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R</a:t>
                  </a:r>
                  <a:r>
                    <a:rPr kumimoji="0" lang="en-US" altLang="hu-HU" sz="1100" b="1" i="0" u="none" strike="noStrike" cap="none" normalizeH="0" baseline="3000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2</a:t>
                  </a:r>
                  <a:r>
                    <a:rPr kumimoji="0" lang="en-US" altLang="hu-HU" sz="11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=0.4416</a:t>
                  </a:r>
                </a:p>
                <a:p>
                  <a:r>
                    <a:rPr lang="en-US" altLang="hu-HU" sz="1100" b="1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p&lt;0.03</a:t>
                  </a:r>
                  <a:endParaRPr kumimoji="0" lang="en-US" altLang="hu-HU" sz="11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endParaRPr kumimoji="0" lang="en-US" altLang="hu-HU" sz="11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" name="Line 72">
                  <a:extLst>
                    <a:ext uri="{FF2B5EF4-FFF2-40B4-BE49-F238E27FC236}">
                      <a16:creationId xmlns:a16="http://schemas.microsoft.com/office/drawing/2014/main" id="{F68CAB7F-C172-380D-050F-5E5EF1EB652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1900238" y="1677987"/>
                  <a:ext cx="0" cy="3176587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23" name="Rectangle 73">
                  <a:extLst>
                    <a:ext uri="{FF2B5EF4-FFF2-40B4-BE49-F238E27FC236}">
                      <a16:creationId xmlns:a16="http://schemas.microsoft.com/office/drawing/2014/main" id="{2E91A9A0-0A3A-FEA9-294C-33314402E22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693138" y="4229338"/>
                  <a:ext cx="138122" cy="1972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i="0" u="none" strike="noStrike" cap="none" normalizeH="0" baseline="0" dirty="0">
                      <a:ln>
                        <a:noFill/>
                      </a:ln>
                      <a:solidFill>
                        <a:srgbClr val="4D4D4D"/>
                      </a:solidFill>
                      <a:effectLst/>
                      <a:cs typeface="Arial" panose="020B0604020202020204" pitchFamily="34" charset="0"/>
                    </a:rPr>
                    <a:t>25</a:t>
                  </a:r>
                  <a:endParaRPr kumimoji="0" lang="en-US" altLang="hu-HU" sz="140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" name="Rectangle 74">
                  <a:extLst>
                    <a:ext uri="{FF2B5EF4-FFF2-40B4-BE49-F238E27FC236}">
                      <a16:creationId xmlns:a16="http://schemas.microsoft.com/office/drawing/2014/main" id="{B6119E5C-E3FE-8576-A163-11BBA9CDFD4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693138" y="3610212"/>
                  <a:ext cx="138122" cy="1972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i="0" u="none" strike="noStrike" cap="none" normalizeH="0" baseline="0" dirty="0">
                      <a:ln>
                        <a:noFill/>
                      </a:ln>
                      <a:solidFill>
                        <a:srgbClr val="4D4D4D"/>
                      </a:solidFill>
                      <a:effectLst/>
                      <a:cs typeface="Arial" panose="020B0604020202020204" pitchFamily="34" charset="0"/>
                    </a:rPr>
                    <a:t>30</a:t>
                  </a:r>
                  <a:endParaRPr kumimoji="0" lang="en-US" altLang="hu-HU" sz="140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" name="Rectangle 75">
                  <a:extLst>
                    <a:ext uri="{FF2B5EF4-FFF2-40B4-BE49-F238E27FC236}">
                      <a16:creationId xmlns:a16="http://schemas.microsoft.com/office/drawing/2014/main" id="{23DE59AB-659B-EA15-2D8D-9AC4559D152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693138" y="2992677"/>
                  <a:ext cx="138122" cy="1972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i="0" u="none" strike="noStrike" cap="none" normalizeH="0" baseline="0" dirty="0">
                      <a:ln>
                        <a:noFill/>
                      </a:ln>
                      <a:solidFill>
                        <a:srgbClr val="4D4D4D"/>
                      </a:solidFill>
                      <a:effectLst/>
                      <a:cs typeface="Arial" panose="020B0604020202020204" pitchFamily="34" charset="0"/>
                    </a:rPr>
                    <a:t>35</a:t>
                  </a:r>
                  <a:endParaRPr kumimoji="0" lang="en-US" altLang="hu-HU" sz="140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" name="Rectangle 76">
                  <a:extLst>
                    <a:ext uri="{FF2B5EF4-FFF2-40B4-BE49-F238E27FC236}">
                      <a16:creationId xmlns:a16="http://schemas.microsoft.com/office/drawing/2014/main" id="{249435CC-D919-CBAD-F0A0-3F2CFDE71E8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693138" y="2375136"/>
                  <a:ext cx="138122" cy="1972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i="0" u="none" strike="noStrike" cap="none" normalizeH="0" baseline="0" dirty="0">
                      <a:ln>
                        <a:noFill/>
                      </a:ln>
                      <a:solidFill>
                        <a:srgbClr val="4D4D4D"/>
                      </a:solidFill>
                      <a:effectLst/>
                      <a:cs typeface="Arial" panose="020B0604020202020204" pitchFamily="34" charset="0"/>
                    </a:rPr>
                    <a:t>40</a:t>
                  </a:r>
                  <a:endParaRPr kumimoji="0" lang="en-US" altLang="hu-HU" sz="140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Rectangle 77">
                  <a:extLst>
                    <a:ext uri="{FF2B5EF4-FFF2-40B4-BE49-F238E27FC236}">
                      <a16:creationId xmlns:a16="http://schemas.microsoft.com/office/drawing/2014/main" id="{766B3AC8-91C1-98D1-B7F5-5BC4063E00E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693138" y="1756012"/>
                  <a:ext cx="138122" cy="1972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i="0" u="none" strike="noStrike" cap="none" normalizeH="0" baseline="0" dirty="0">
                      <a:ln>
                        <a:noFill/>
                      </a:ln>
                      <a:solidFill>
                        <a:srgbClr val="4D4D4D"/>
                      </a:solidFill>
                      <a:effectLst/>
                      <a:cs typeface="Arial" panose="020B0604020202020204" pitchFamily="34" charset="0"/>
                    </a:rPr>
                    <a:t>45</a:t>
                  </a:r>
                  <a:endParaRPr kumimoji="0" lang="en-US" altLang="hu-HU" sz="80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Line 78">
                  <a:extLst>
                    <a:ext uri="{FF2B5EF4-FFF2-40B4-BE49-F238E27FC236}">
                      <a16:creationId xmlns:a16="http://schemas.microsoft.com/office/drawing/2014/main" id="{7B12CDDE-415E-81C5-FD2F-C925CBAAB02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876425" y="4341812"/>
                  <a:ext cx="23813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29" name="Line 79">
                  <a:extLst>
                    <a:ext uri="{FF2B5EF4-FFF2-40B4-BE49-F238E27FC236}">
                      <a16:creationId xmlns:a16="http://schemas.microsoft.com/office/drawing/2014/main" id="{34596B22-FE31-C35A-EDDC-8E0CB9CB685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876425" y="3724275"/>
                  <a:ext cx="23813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0" name="Line 80">
                  <a:extLst>
                    <a:ext uri="{FF2B5EF4-FFF2-40B4-BE49-F238E27FC236}">
                      <a16:creationId xmlns:a16="http://schemas.microsoft.com/office/drawing/2014/main" id="{7F71921C-946D-35C7-CBC5-A939BFD5479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876425" y="3105150"/>
                  <a:ext cx="23813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1" name="Line 81">
                  <a:extLst>
                    <a:ext uri="{FF2B5EF4-FFF2-40B4-BE49-F238E27FC236}">
                      <a16:creationId xmlns:a16="http://schemas.microsoft.com/office/drawing/2014/main" id="{24C8E7C4-C36A-34AD-74F9-B95E18CD1FB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876425" y="2487612"/>
                  <a:ext cx="23813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2" name="Line 82">
                  <a:extLst>
                    <a:ext uri="{FF2B5EF4-FFF2-40B4-BE49-F238E27FC236}">
                      <a16:creationId xmlns:a16="http://schemas.microsoft.com/office/drawing/2014/main" id="{8599B626-80C8-F662-BBBD-B979AE89F23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876425" y="1870075"/>
                  <a:ext cx="23813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3" name="Line 83">
                  <a:extLst>
                    <a:ext uri="{FF2B5EF4-FFF2-40B4-BE49-F238E27FC236}">
                      <a16:creationId xmlns:a16="http://schemas.microsoft.com/office/drawing/2014/main" id="{6C394D75-13F6-6E7A-0C00-07D172675F8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900238" y="4854575"/>
                  <a:ext cx="3455988" cy="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4" name="Line 84">
                  <a:extLst>
                    <a:ext uri="{FF2B5EF4-FFF2-40B4-BE49-F238E27FC236}">
                      <a16:creationId xmlns:a16="http://schemas.microsoft.com/office/drawing/2014/main" id="{829C9561-908B-6EC0-B1CD-946A27EC560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536825" y="4854575"/>
                  <a:ext cx="0" cy="23812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5" name="Line 85">
                  <a:extLst>
                    <a:ext uri="{FF2B5EF4-FFF2-40B4-BE49-F238E27FC236}">
                      <a16:creationId xmlns:a16="http://schemas.microsoft.com/office/drawing/2014/main" id="{5C3C7C6D-E626-E20E-6D2E-B554BD014A1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390900" y="4854575"/>
                  <a:ext cx="0" cy="23812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6" name="Line 86">
                  <a:extLst>
                    <a:ext uri="{FF2B5EF4-FFF2-40B4-BE49-F238E27FC236}">
                      <a16:creationId xmlns:a16="http://schemas.microsoft.com/office/drawing/2014/main" id="{6648AB03-AABE-4FE3-BA2A-2C83347F630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244975" y="4854575"/>
                  <a:ext cx="0" cy="23812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7" name="Line 87">
                  <a:extLst>
                    <a:ext uri="{FF2B5EF4-FFF2-40B4-BE49-F238E27FC236}">
                      <a16:creationId xmlns:a16="http://schemas.microsoft.com/office/drawing/2014/main" id="{98F3474A-C998-4BB5-4D23-473AC87E5EE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5097463" y="4854575"/>
                  <a:ext cx="0" cy="23812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8" name="Rectangle 88">
                  <a:extLst>
                    <a:ext uri="{FF2B5EF4-FFF2-40B4-BE49-F238E27FC236}">
                      <a16:creationId xmlns:a16="http://schemas.microsoft.com/office/drawing/2014/main" id="{8FC37C8B-3948-4B9E-D1EF-64C553BBD72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360175" y="4861534"/>
                  <a:ext cx="345305" cy="1972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i="0" u="none" strike="noStrike" cap="none" normalizeH="0" baseline="0" dirty="0">
                      <a:ln>
                        <a:noFill/>
                      </a:ln>
                      <a:solidFill>
                        <a:srgbClr val="4D4D4D"/>
                      </a:solidFill>
                      <a:effectLst/>
                      <a:cs typeface="Arial" panose="020B0604020202020204" pitchFamily="34" charset="0"/>
                    </a:rPr>
                    <a:t>40000</a:t>
                  </a:r>
                  <a:endParaRPr kumimoji="0" lang="en-US" altLang="hu-HU" sz="140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" name="Rectangle 89">
                  <a:extLst>
                    <a:ext uri="{FF2B5EF4-FFF2-40B4-BE49-F238E27FC236}">
                      <a16:creationId xmlns:a16="http://schemas.microsoft.com/office/drawing/2014/main" id="{426A8AD4-27F0-F77C-F86D-3FBC16FCC6D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12663" y="4861534"/>
                  <a:ext cx="345305" cy="1972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i="0" u="none" strike="noStrike" cap="none" normalizeH="0" baseline="0" dirty="0">
                      <a:ln>
                        <a:noFill/>
                      </a:ln>
                      <a:solidFill>
                        <a:srgbClr val="4D4D4D"/>
                      </a:solidFill>
                      <a:effectLst/>
                      <a:cs typeface="Arial" panose="020B0604020202020204" pitchFamily="34" charset="0"/>
                    </a:rPr>
                    <a:t>60000</a:t>
                  </a:r>
                  <a:endParaRPr kumimoji="0" lang="en-US" altLang="hu-HU" sz="140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" name="Rectangle 90">
                  <a:extLst>
                    <a:ext uri="{FF2B5EF4-FFF2-40B4-BE49-F238E27FC236}">
                      <a16:creationId xmlns:a16="http://schemas.microsoft.com/office/drawing/2014/main" id="{98A5176A-1C75-F027-D81E-8B8727B7F05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066738" y="4861534"/>
                  <a:ext cx="345305" cy="1972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i="0" u="none" strike="noStrike" cap="none" normalizeH="0" baseline="0" dirty="0">
                      <a:ln>
                        <a:noFill/>
                      </a:ln>
                      <a:solidFill>
                        <a:srgbClr val="4D4D4D"/>
                      </a:solidFill>
                      <a:effectLst/>
                      <a:cs typeface="Arial" panose="020B0604020202020204" pitchFamily="34" charset="0"/>
                    </a:rPr>
                    <a:t>80000</a:t>
                  </a:r>
                  <a:endParaRPr kumimoji="0" lang="en-US" altLang="hu-HU" sz="140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1" name="Rectangle 91">
                  <a:extLst>
                    <a:ext uri="{FF2B5EF4-FFF2-40B4-BE49-F238E27FC236}">
                      <a16:creationId xmlns:a16="http://schemas.microsoft.com/office/drawing/2014/main" id="{5980192D-4BC1-997A-E9E8-6133A891EEE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876075" y="4861534"/>
                  <a:ext cx="414366" cy="1972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i="0" u="none" strike="noStrike" cap="none" normalizeH="0" baseline="0" dirty="0">
                      <a:ln>
                        <a:noFill/>
                      </a:ln>
                      <a:solidFill>
                        <a:srgbClr val="4D4D4D"/>
                      </a:solidFill>
                      <a:effectLst/>
                      <a:cs typeface="Arial" panose="020B0604020202020204" pitchFamily="34" charset="0"/>
                    </a:rPr>
                    <a:t>100000</a:t>
                  </a:r>
                  <a:endParaRPr kumimoji="0" lang="en-US" altLang="hu-HU" sz="140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2" name="Rectangle 94">
                  <a:extLst>
                    <a:ext uri="{FF2B5EF4-FFF2-40B4-BE49-F238E27FC236}">
                      <a16:creationId xmlns:a16="http://schemas.microsoft.com/office/drawing/2014/main" id="{6DA9AF4B-40D2-EF5E-496F-E13962F4B0B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900237" y="1333500"/>
                  <a:ext cx="3455987" cy="34527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14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Deceased</a:t>
                  </a:r>
                  <a:endParaRPr kumimoji="0" lang="en-US" altLang="hu-HU" sz="11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</a:endParaRPr>
                </a:p>
              </p:txBody>
            </p:sp>
          </p:grpSp>
          <p:grpSp>
            <p:nvGrpSpPr>
              <p:cNvPr id="43" name="Csoportba foglalás 42">
                <a:extLst>
                  <a:ext uri="{FF2B5EF4-FFF2-40B4-BE49-F238E27FC236}">
                    <a16:creationId xmlns:a16="http://schemas.microsoft.com/office/drawing/2014/main" id="{E28D9C51-9FA1-B94F-50B4-52E1C435867E}"/>
                  </a:ext>
                </a:extLst>
              </p:cNvPr>
              <p:cNvGrpSpPr/>
              <p:nvPr/>
            </p:nvGrpSpPr>
            <p:grpSpPr>
              <a:xfrm>
                <a:off x="1911985" y="1990725"/>
                <a:ext cx="3801967" cy="3284344"/>
                <a:chOff x="5758725" y="1333500"/>
                <a:chExt cx="3659913" cy="3725333"/>
              </a:xfrm>
            </p:grpSpPr>
            <p:sp>
              <p:nvSpPr>
                <p:cNvPr id="44" name="Oval 97">
                  <a:extLst>
                    <a:ext uri="{FF2B5EF4-FFF2-40B4-BE49-F238E27FC236}">
                      <a16:creationId xmlns:a16="http://schemas.microsoft.com/office/drawing/2014/main" id="{DD1F8FE0-271C-F481-884C-DE324C1A75D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861175" y="3384550"/>
                  <a:ext cx="65088" cy="63500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45" name="Oval 98">
                  <a:extLst>
                    <a:ext uri="{FF2B5EF4-FFF2-40B4-BE49-F238E27FC236}">
                      <a16:creationId xmlns:a16="http://schemas.microsoft.com/office/drawing/2014/main" id="{BD260DA0-EC8D-6E95-DBB9-9FC152BF3CA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227888" y="3662362"/>
                  <a:ext cx="63500" cy="63500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46" name="Oval 99">
                  <a:extLst>
                    <a:ext uri="{FF2B5EF4-FFF2-40B4-BE49-F238E27FC236}">
                      <a16:creationId xmlns:a16="http://schemas.microsoft.com/office/drawing/2014/main" id="{B0F090B7-26FA-A091-4756-1273AFA925B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445500" y="4191000"/>
                  <a:ext cx="61913" cy="63500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47" name="Oval 100">
                  <a:extLst>
                    <a:ext uri="{FF2B5EF4-FFF2-40B4-BE49-F238E27FC236}">
                      <a16:creationId xmlns:a16="http://schemas.microsoft.com/office/drawing/2014/main" id="{20AD9E53-2DC7-B081-133B-9302F4B789E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229725" y="2595562"/>
                  <a:ext cx="65088" cy="63500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48" name="Oval 101">
                  <a:extLst>
                    <a:ext uri="{FF2B5EF4-FFF2-40B4-BE49-F238E27FC236}">
                      <a16:creationId xmlns:a16="http://schemas.microsoft.com/office/drawing/2014/main" id="{D5724865-015D-0DA5-1E00-D9FC21CE83E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239125" y="3201987"/>
                  <a:ext cx="63500" cy="61912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49" name="Oval 102">
                  <a:extLst>
                    <a:ext uri="{FF2B5EF4-FFF2-40B4-BE49-F238E27FC236}">
                      <a16:creationId xmlns:a16="http://schemas.microsoft.com/office/drawing/2014/main" id="{8F59F401-987A-3BAF-DB99-BF216C5FEFD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089650" y="3111500"/>
                  <a:ext cx="65088" cy="63500"/>
                </a:xfrm>
                <a:prstGeom prst="ellipse">
                  <a:avLst/>
                </a:prstGeom>
                <a:solidFill>
                  <a:srgbClr val="000000"/>
                </a:solidFill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50" name="Freeform 103">
                  <a:extLst>
                    <a:ext uri="{FF2B5EF4-FFF2-40B4-BE49-F238E27FC236}">
                      <a16:creationId xmlns:a16="http://schemas.microsoft.com/office/drawing/2014/main" id="{95BA79ED-9A09-64FD-AD76-3AEB71778C0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121400" y="3295650"/>
                  <a:ext cx="3140075" cy="188912"/>
                </a:xfrm>
                <a:custGeom>
                  <a:avLst/>
                  <a:gdLst>
                    <a:gd name="T0" fmla="*/ 25 w 1978"/>
                    <a:gd name="T1" fmla="*/ 118 h 119"/>
                    <a:gd name="T2" fmla="*/ 75 w 1978"/>
                    <a:gd name="T3" fmla="*/ 114 h 119"/>
                    <a:gd name="T4" fmla="*/ 125 w 1978"/>
                    <a:gd name="T5" fmla="*/ 111 h 119"/>
                    <a:gd name="T6" fmla="*/ 175 w 1978"/>
                    <a:gd name="T7" fmla="*/ 109 h 119"/>
                    <a:gd name="T8" fmla="*/ 225 w 1978"/>
                    <a:gd name="T9" fmla="*/ 106 h 119"/>
                    <a:gd name="T10" fmla="*/ 275 w 1978"/>
                    <a:gd name="T11" fmla="*/ 103 h 119"/>
                    <a:gd name="T12" fmla="*/ 326 w 1978"/>
                    <a:gd name="T13" fmla="*/ 99 h 119"/>
                    <a:gd name="T14" fmla="*/ 376 w 1978"/>
                    <a:gd name="T15" fmla="*/ 96 h 119"/>
                    <a:gd name="T16" fmla="*/ 426 w 1978"/>
                    <a:gd name="T17" fmla="*/ 94 h 119"/>
                    <a:gd name="T18" fmla="*/ 476 w 1978"/>
                    <a:gd name="T19" fmla="*/ 91 h 119"/>
                    <a:gd name="T20" fmla="*/ 526 w 1978"/>
                    <a:gd name="T21" fmla="*/ 88 h 119"/>
                    <a:gd name="T22" fmla="*/ 576 w 1978"/>
                    <a:gd name="T23" fmla="*/ 84 h 119"/>
                    <a:gd name="T24" fmla="*/ 626 w 1978"/>
                    <a:gd name="T25" fmla="*/ 82 h 119"/>
                    <a:gd name="T26" fmla="*/ 676 w 1978"/>
                    <a:gd name="T27" fmla="*/ 79 h 119"/>
                    <a:gd name="T28" fmla="*/ 727 w 1978"/>
                    <a:gd name="T29" fmla="*/ 76 h 119"/>
                    <a:gd name="T30" fmla="*/ 777 w 1978"/>
                    <a:gd name="T31" fmla="*/ 72 h 119"/>
                    <a:gd name="T32" fmla="*/ 827 w 1978"/>
                    <a:gd name="T33" fmla="*/ 69 h 119"/>
                    <a:gd name="T34" fmla="*/ 877 w 1978"/>
                    <a:gd name="T35" fmla="*/ 67 h 119"/>
                    <a:gd name="T36" fmla="*/ 927 w 1978"/>
                    <a:gd name="T37" fmla="*/ 64 h 119"/>
                    <a:gd name="T38" fmla="*/ 977 w 1978"/>
                    <a:gd name="T39" fmla="*/ 61 h 119"/>
                    <a:gd name="T40" fmla="*/ 1027 w 1978"/>
                    <a:gd name="T41" fmla="*/ 57 h 119"/>
                    <a:gd name="T42" fmla="*/ 1077 w 1978"/>
                    <a:gd name="T43" fmla="*/ 54 h 119"/>
                    <a:gd name="T44" fmla="*/ 1128 w 1978"/>
                    <a:gd name="T45" fmla="*/ 52 h 119"/>
                    <a:gd name="T46" fmla="*/ 1178 w 1978"/>
                    <a:gd name="T47" fmla="*/ 49 h 119"/>
                    <a:gd name="T48" fmla="*/ 1228 w 1978"/>
                    <a:gd name="T49" fmla="*/ 46 h 119"/>
                    <a:gd name="T50" fmla="*/ 1278 w 1978"/>
                    <a:gd name="T51" fmla="*/ 42 h 119"/>
                    <a:gd name="T52" fmla="*/ 1328 w 1978"/>
                    <a:gd name="T53" fmla="*/ 40 h 119"/>
                    <a:gd name="T54" fmla="*/ 1377 w 1978"/>
                    <a:gd name="T55" fmla="*/ 37 h 119"/>
                    <a:gd name="T56" fmla="*/ 1427 w 1978"/>
                    <a:gd name="T57" fmla="*/ 34 h 119"/>
                    <a:gd name="T58" fmla="*/ 1477 w 1978"/>
                    <a:gd name="T59" fmla="*/ 30 h 119"/>
                    <a:gd name="T60" fmla="*/ 1527 w 1978"/>
                    <a:gd name="T61" fmla="*/ 27 h 119"/>
                    <a:gd name="T62" fmla="*/ 1577 w 1978"/>
                    <a:gd name="T63" fmla="*/ 25 h 119"/>
                    <a:gd name="T64" fmla="*/ 1628 w 1978"/>
                    <a:gd name="T65" fmla="*/ 22 h 119"/>
                    <a:gd name="T66" fmla="*/ 1678 w 1978"/>
                    <a:gd name="T67" fmla="*/ 19 h 119"/>
                    <a:gd name="T68" fmla="*/ 1728 w 1978"/>
                    <a:gd name="T69" fmla="*/ 15 h 119"/>
                    <a:gd name="T70" fmla="*/ 1778 w 1978"/>
                    <a:gd name="T71" fmla="*/ 12 h 119"/>
                    <a:gd name="T72" fmla="*/ 1828 w 1978"/>
                    <a:gd name="T73" fmla="*/ 10 h 119"/>
                    <a:gd name="T74" fmla="*/ 1878 w 1978"/>
                    <a:gd name="T75" fmla="*/ 7 h 119"/>
                    <a:gd name="T76" fmla="*/ 1928 w 1978"/>
                    <a:gd name="T77" fmla="*/ 4 h 119"/>
                    <a:gd name="T78" fmla="*/ 1978 w 1978"/>
                    <a:gd name="T79" fmla="*/ 0 h 11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</a:cxnLst>
                  <a:rect l="0" t="0" r="r" b="b"/>
                  <a:pathLst>
                    <a:path w="1978" h="119">
                      <a:moveTo>
                        <a:pt x="0" y="119"/>
                      </a:moveTo>
                      <a:lnTo>
                        <a:pt x="25" y="118"/>
                      </a:lnTo>
                      <a:lnTo>
                        <a:pt x="51" y="117"/>
                      </a:lnTo>
                      <a:lnTo>
                        <a:pt x="75" y="114"/>
                      </a:lnTo>
                      <a:lnTo>
                        <a:pt x="101" y="113"/>
                      </a:lnTo>
                      <a:lnTo>
                        <a:pt x="125" y="111"/>
                      </a:lnTo>
                      <a:lnTo>
                        <a:pt x="151" y="110"/>
                      </a:lnTo>
                      <a:lnTo>
                        <a:pt x="175" y="109"/>
                      </a:lnTo>
                      <a:lnTo>
                        <a:pt x="201" y="107"/>
                      </a:lnTo>
                      <a:lnTo>
                        <a:pt x="225" y="106"/>
                      </a:lnTo>
                      <a:lnTo>
                        <a:pt x="251" y="105"/>
                      </a:lnTo>
                      <a:lnTo>
                        <a:pt x="275" y="103"/>
                      </a:lnTo>
                      <a:lnTo>
                        <a:pt x="301" y="100"/>
                      </a:lnTo>
                      <a:lnTo>
                        <a:pt x="326" y="99"/>
                      </a:lnTo>
                      <a:lnTo>
                        <a:pt x="351" y="98"/>
                      </a:lnTo>
                      <a:lnTo>
                        <a:pt x="376" y="96"/>
                      </a:lnTo>
                      <a:lnTo>
                        <a:pt x="401" y="95"/>
                      </a:lnTo>
                      <a:lnTo>
                        <a:pt x="426" y="94"/>
                      </a:lnTo>
                      <a:lnTo>
                        <a:pt x="452" y="92"/>
                      </a:lnTo>
                      <a:lnTo>
                        <a:pt x="476" y="91"/>
                      </a:lnTo>
                      <a:lnTo>
                        <a:pt x="500" y="90"/>
                      </a:lnTo>
                      <a:lnTo>
                        <a:pt x="526" y="88"/>
                      </a:lnTo>
                      <a:lnTo>
                        <a:pt x="550" y="86"/>
                      </a:lnTo>
                      <a:lnTo>
                        <a:pt x="576" y="84"/>
                      </a:lnTo>
                      <a:lnTo>
                        <a:pt x="601" y="83"/>
                      </a:lnTo>
                      <a:lnTo>
                        <a:pt x="626" y="82"/>
                      </a:lnTo>
                      <a:lnTo>
                        <a:pt x="651" y="80"/>
                      </a:lnTo>
                      <a:lnTo>
                        <a:pt x="676" y="79"/>
                      </a:lnTo>
                      <a:lnTo>
                        <a:pt x="701" y="77"/>
                      </a:lnTo>
                      <a:lnTo>
                        <a:pt x="727" y="76"/>
                      </a:lnTo>
                      <a:lnTo>
                        <a:pt x="751" y="75"/>
                      </a:lnTo>
                      <a:lnTo>
                        <a:pt x="777" y="72"/>
                      </a:lnTo>
                      <a:lnTo>
                        <a:pt x="801" y="71"/>
                      </a:lnTo>
                      <a:lnTo>
                        <a:pt x="827" y="69"/>
                      </a:lnTo>
                      <a:lnTo>
                        <a:pt x="851" y="68"/>
                      </a:lnTo>
                      <a:lnTo>
                        <a:pt x="877" y="67"/>
                      </a:lnTo>
                      <a:lnTo>
                        <a:pt x="901" y="65"/>
                      </a:lnTo>
                      <a:lnTo>
                        <a:pt x="927" y="64"/>
                      </a:lnTo>
                      <a:lnTo>
                        <a:pt x="951" y="63"/>
                      </a:lnTo>
                      <a:lnTo>
                        <a:pt x="977" y="61"/>
                      </a:lnTo>
                      <a:lnTo>
                        <a:pt x="1002" y="58"/>
                      </a:lnTo>
                      <a:lnTo>
                        <a:pt x="1027" y="57"/>
                      </a:lnTo>
                      <a:lnTo>
                        <a:pt x="1052" y="56"/>
                      </a:lnTo>
                      <a:lnTo>
                        <a:pt x="1077" y="54"/>
                      </a:lnTo>
                      <a:lnTo>
                        <a:pt x="1102" y="53"/>
                      </a:lnTo>
                      <a:lnTo>
                        <a:pt x="1128" y="52"/>
                      </a:lnTo>
                      <a:lnTo>
                        <a:pt x="1152" y="50"/>
                      </a:lnTo>
                      <a:lnTo>
                        <a:pt x="1178" y="49"/>
                      </a:lnTo>
                      <a:lnTo>
                        <a:pt x="1202" y="48"/>
                      </a:lnTo>
                      <a:lnTo>
                        <a:pt x="1228" y="46"/>
                      </a:lnTo>
                      <a:lnTo>
                        <a:pt x="1252" y="44"/>
                      </a:lnTo>
                      <a:lnTo>
                        <a:pt x="1278" y="42"/>
                      </a:lnTo>
                      <a:lnTo>
                        <a:pt x="1302" y="41"/>
                      </a:lnTo>
                      <a:lnTo>
                        <a:pt x="1328" y="40"/>
                      </a:lnTo>
                      <a:lnTo>
                        <a:pt x="1352" y="38"/>
                      </a:lnTo>
                      <a:lnTo>
                        <a:pt x="1377" y="37"/>
                      </a:lnTo>
                      <a:lnTo>
                        <a:pt x="1403" y="35"/>
                      </a:lnTo>
                      <a:lnTo>
                        <a:pt x="1427" y="34"/>
                      </a:lnTo>
                      <a:lnTo>
                        <a:pt x="1453" y="33"/>
                      </a:lnTo>
                      <a:lnTo>
                        <a:pt x="1477" y="30"/>
                      </a:lnTo>
                      <a:lnTo>
                        <a:pt x="1503" y="29"/>
                      </a:lnTo>
                      <a:lnTo>
                        <a:pt x="1527" y="27"/>
                      </a:lnTo>
                      <a:lnTo>
                        <a:pt x="1553" y="26"/>
                      </a:lnTo>
                      <a:lnTo>
                        <a:pt x="1577" y="25"/>
                      </a:lnTo>
                      <a:lnTo>
                        <a:pt x="1603" y="23"/>
                      </a:lnTo>
                      <a:lnTo>
                        <a:pt x="1628" y="22"/>
                      </a:lnTo>
                      <a:lnTo>
                        <a:pt x="1653" y="21"/>
                      </a:lnTo>
                      <a:lnTo>
                        <a:pt x="1678" y="19"/>
                      </a:lnTo>
                      <a:lnTo>
                        <a:pt x="1703" y="18"/>
                      </a:lnTo>
                      <a:lnTo>
                        <a:pt x="1728" y="15"/>
                      </a:lnTo>
                      <a:lnTo>
                        <a:pt x="1754" y="14"/>
                      </a:lnTo>
                      <a:lnTo>
                        <a:pt x="1778" y="12"/>
                      </a:lnTo>
                      <a:lnTo>
                        <a:pt x="1804" y="11"/>
                      </a:lnTo>
                      <a:lnTo>
                        <a:pt x="1828" y="10"/>
                      </a:lnTo>
                      <a:lnTo>
                        <a:pt x="1854" y="8"/>
                      </a:lnTo>
                      <a:lnTo>
                        <a:pt x="1878" y="7"/>
                      </a:lnTo>
                      <a:lnTo>
                        <a:pt x="1904" y="6"/>
                      </a:lnTo>
                      <a:lnTo>
                        <a:pt x="1928" y="4"/>
                      </a:lnTo>
                      <a:lnTo>
                        <a:pt x="1954" y="2"/>
                      </a:lnTo>
                      <a:lnTo>
                        <a:pt x="1978" y="0"/>
                      </a:lnTo>
                    </a:path>
                  </a:pathLst>
                </a:custGeom>
                <a:noFill/>
                <a:ln w="365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51" name="Freeform 104">
                  <a:extLst>
                    <a:ext uri="{FF2B5EF4-FFF2-40B4-BE49-F238E27FC236}">
                      <a16:creationId xmlns:a16="http://schemas.microsoft.com/office/drawing/2014/main" id="{9793AED5-A8D5-32F5-E571-FEEAA64D2F1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121400" y="2095500"/>
                  <a:ext cx="3140075" cy="2613025"/>
                </a:xfrm>
                <a:custGeom>
                  <a:avLst/>
                  <a:gdLst>
                    <a:gd name="T0" fmla="*/ 51 w 1978"/>
                    <a:gd name="T1" fmla="*/ 126 h 1646"/>
                    <a:gd name="T2" fmla="*/ 125 w 1978"/>
                    <a:gd name="T3" fmla="*/ 162 h 1646"/>
                    <a:gd name="T4" fmla="*/ 201 w 1978"/>
                    <a:gd name="T5" fmla="*/ 194 h 1646"/>
                    <a:gd name="T6" fmla="*/ 275 w 1978"/>
                    <a:gd name="T7" fmla="*/ 227 h 1646"/>
                    <a:gd name="T8" fmla="*/ 351 w 1978"/>
                    <a:gd name="T9" fmla="*/ 256 h 1646"/>
                    <a:gd name="T10" fmla="*/ 426 w 1978"/>
                    <a:gd name="T11" fmla="*/ 285 h 1646"/>
                    <a:gd name="T12" fmla="*/ 500 w 1978"/>
                    <a:gd name="T13" fmla="*/ 311 h 1646"/>
                    <a:gd name="T14" fmla="*/ 576 w 1978"/>
                    <a:gd name="T15" fmla="*/ 334 h 1646"/>
                    <a:gd name="T16" fmla="*/ 651 w 1978"/>
                    <a:gd name="T17" fmla="*/ 354 h 1646"/>
                    <a:gd name="T18" fmla="*/ 727 w 1978"/>
                    <a:gd name="T19" fmla="*/ 370 h 1646"/>
                    <a:gd name="T20" fmla="*/ 801 w 1978"/>
                    <a:gd name="T21" fmla="*/ 381 h 1646"/>
                    <a:gd name="T22" fmla="*/ 877 w 1978"/>
                    <a:gd name="T23" fmla="*/ 388 h 1646"/>
                    <a:gd name="T24" fmla="*/ 951 w 1978"/>
                    <a:gd name="T25" fmla="*/ 390 h 1646"/>
                    <a:gd name="T26" fmla="*/ 1027 w 1978"/>
                    <a:gd name="T27" fmla="*/ 386 h 1646"/>
                    <a:gd name="T28" fmla="*/ 1102 w 1978"/>
                    <a:gd name="T29" fmla="*/ 378 h 1646"/>
                    <a:gd name="T30" fmla="*/ 1178 w 1978"/>
                    <a:gd name="T31" fmla="*/ 363 h 1646"/>
                    <a:gd name="T32" fmla="*/ 1252 w 1978"/>
                    <a:gd name="T33" fmla="*/ 344 h 1646"/>
                    <a:gd name="T34" fmla="*/ 1328 w 1978"/>
                    <a:gd name="T35" fmla="*/ 321 h 1646"/>
                    <a:gd name="T36" fmla="*/ 1403 w 1978"/>
                    <a:gd name="T37" fmla="*/ 294 h 1646"/>
                    <a:gd name="T38" fmla="*/ 1477 w 1978"/>
                    <a:gd name="T39" fmla="*/ 263 h 1646"/>
                    <a:gd name="T40" fmla="*/ 1553 w 1978"/>
                    <a:gd name="T41" fmla="*/ 229 h 1646"/>
                    <a:gd name="T42" fmla="*/ 1628 w 1978"/>
                    <a:gd name="T43" fmla="*/ 193 h 1646"/>
                    <a:gd name="T44" fmla="*/ 1703 w 1978"/>
                    <a:gd name="T45" fmla="*/ 155 h 1646"/>
                    <a:gd name="T46" fmla="*/ 1778 w 1978"/>
                    <a:gd name="T47" fmla="*/ 114 h 1646"/>
                    <a:gd name="T48" fmla="*/ 1854 w 1978"/>
                    <a:gd name="T49" fmla="*/ 72 h 1646"/>
                    <a:gd name="T50" fmla="*/ 1928 w 1978"/>
                    <a:gd name="T51" fmla="*/ 29 h 1646"/>
                    <a:gd name="T52" fmla="*/ 1978 w 1978"/>
                    <a:gd name="T53" fmla="*/ 1514 h 1646"/>
                    <a:gd name="T54" fmla="*/ 1904 w 1978"/>
                    <a:gd name="T55" fmla="*/ 1478 h 1646"/>
                    <a:gd name="T56" fmla="*/ 1828 w 1978"/>
                    <a:gd name="T57" fmla="*/ 1446 h 1646"/>
                    <a:gd name="T58" fmla="*/ 1754 w 1978"/>
                    <a:gd name="T59" fmla="*/ 1413 h 1646"/>
                    <a:gd name="T60" fmla="*/ 1678 w 1978"/>
                    <a:gd name="T61" fmla="*/ 1382 h 1646"/>
                    <a:gd name="T62" fmla="*/ 1603 w 1978"/>
                    <a:gd name="T63" fmla="*/ 1354 h 1646"/>
                    <a:gd name="T64" fmla="*/ 1527 w 1978"/>
                    <a:gd name="T65" fmla="*/ 1327 h 1646"/>
                    <a:gd name="T66" fmla="*/ 1453 w 1978"/>
                    <a:gd name="T67" fmla="*/ 1304 h 1646"/>
                    <a:gd name="T68" fmla="*/ 1377 w 1978"/>
                    <a:gd name="T69" fmla="*/ 1282 h 1646"/>
                    <a:gd name="T70" fmla="*/ 1302 w 1978"/>
                    <a:gd name="T71" fmla="*/ 1266 h 1646"/>
                    <a:gd name="T72" fmla="*/ 1228 w 1978"/>
                    <a:gd name="T73" fmla="*/ 1252 h 1646"/>
                    <a:gd name="T74" fmla="*/ 1152 w 1978"/>
                    <a:gd name="T75" fmla="*/ 1244 h 1646"/>
                    <a:gd name="T76" fmla="*/ 1077 w 1978"/>
                    <a:gd name="T77" fmla="*/ 1240 h 1646"/>
                    <a:gd name="T78" fmla="*/ 1002 w 1978"/>
                    <a:gd name="T79" fmla="*/ 1241 h 1646"/>
                    <a:gd name="T80" fmla="*/ 927 w 1978"/>
                    <a:gd name="T81" fmla="*/ 1249 h 1646"/>
                    <a:gd name="T82" fmla="*/ 851 w 1978"/>
                    <a:gd name="T83" fmla="*/ 1262 h 1646"/>
                    <a:gd name="T84" fmla="*/ 777 w 1978"/>
                    <a:gd name="T85" fmla="*/ 1279 h 1646"/>
                    <a:gd name="T86" fmla="*/ 701 w 1978"/>
                    <a:gd name="T87" fmla="*/ 1302 h 1646"/>
                    <a:gd name="T88" fmla="*/ 626 w 1978"/>
                    <a:gd name="T89" fmla="*/ 1328 h 1646"/>
                    <a:gd name="T90" fmla="*/ 550 w 1978"/>
                    <a:gd name="T91" fmla="*/ 1358 h 1646"/>
                    <a:gd name="T92" fmla="*/ 476 w 1978"/>
                    <a:gd name="T93" fmla="*/ 1392 h 1646"/>
                    <a:gd name="T94" fmla="*/ 401 w 1978"/>
                    <a:gd name="T95" fmla="*/ 1427 h 1646"/>
                    <a:gd name="T96" fmla="*/ 326 w 1978"/>
                    <a:gd name="T97" fmla="*/ 1465 h 1646"/>
                    <a:gd name="T98" fmla="*/ 251 w 1978"/>
                    <a:gd name="T99" fmla="*/ 1504 h 1646"/>
                    <a:gd name="T100" fmla="*/ 175 w 1978"/>
                    <a:gd name="T101" fmla="*/ 1546 h 1646"/>
                    <a:gd name="T102" fmla="*/ 101 w 1978"/>
                    <a:gd name="T103" fmla="*/ 1588 h 1646"/>
                    <a:gd name="T104" fmla="*/ 25 w 1978"/>
                    <a:gd name="T105" fmla="*/ 1633 h 16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</a:cxnLst>
                  <a:rect l="0" t="0" r="r" b="b"/>
                  <a:pathLst>
                    <a:path w="1978" h="1646">
                      <a:moveTo>
                        <a:pt x="0" y="103"/>
                      </a:moveTo>
                      <a:lnTo>
                        <a:pt x="25" y="115"/>
                      </a:lnTo>
                      <a:lnTo>
                        <a:pt x="51" y="126"/>
                      </a:lnTo>
                      <a:lnTo>
                        <a:pt x="75" y="138"/>
                      </a:lnTo>
                      <a:lnTo>
                        <a:pt x="101" y="151"/>
                      </a:lnTo>
                      <a:lnTo>
                        <a:pt x="125" y="162"/>
                      </a:lnTo>
                      <a:lnTo>
                        <a:pt x="151" y="172"/>
                      </a:lnTo>
                      <a:lnTo>
                        <a:pt x="175" y="183"/>
                      </a:lnTo>
                      <a:lnTo>
                        <a:pt x="201" y="194"/>
                      </a:lnTo>
                      <a:lnTo>
                        <a:pt x="225" y="205"/>
                      </a:lnTo>
                      <a:lnTo>
                        <a:pt x="251" y="216"/>
                      </a:lnTo>
                      <a:lnTo>
                        <a:pt x="275" y="227"/>
                      </a:lnTo>
                      <a:lnTo>
                        <a:pt x="301" y="236"/>
                      </a:lnTo>
                      <a:lnTo>
                        <a:pt x="326" y="247"/>
                      </a:lnTo>
                      <a:lnTo>
                        <a:pt x="351" y="256"/>
                      </a:lnTo>
                      <a:lnTo>
                        <a:pt x="376" y="266"/>
                      </a:lnTo>
                      <a:lnTo>
                        <a:pt x="401" y="275"/>
                      </a:lnTo>
                      <a:lnTo>
                        <a:pt x="426" y="285"/>
                      </a:lnTo>
                      <a:lnTo>
                        <a:pt x="452" y="294"/>
                      </a:lnTo>
                      <a:lnTo>
                        <a:pt x="476" y="302"/>
                      </a:lnTo>
                      <a:lnTo>
                        <a:pt x="500" y="311"/>
                      </a:lnTo>
                      <a:lnTo>
                        <a:pt x="526" y="319"/>
                      </a:lnTo>
                      <a:lnTo>
                        <a:pt x="550" y="327"/>
                      </a:lnTo>
                      <a:lnTo>
                        <a:pt x="576" y="334"/>
                      </a:lnTo>
                      <a:lnTo>
                        <a:pt x="601" y="340"/>
                      </a:lnTo>
                      <a:lnTo>
                        <a:pt x="626" y="347"/>
                      </a:lnTo>
                      <a:lnTo>
                        <a:pt x="651" y="354"/>
                      </a:lnTo>
                      <a:lnTo>
                        <a:pt x="676" y="359"/>
                      </a:lnTo>
                      <a:lnTo>
                        <a:pt x="701" y="365"/>
                      </a:lnTo>
                      <a:lnTo>
                        <a:pt x="727" y="370"/>
                      </a:lnTo>
                      <a:lnTo>
                        <a:pt x="751" y="374"/>
                      </a:lnTo>
                      <a:lnTo>
                        <a:pt x="777" y="378"/>
                      </a:lnTo>
                      <a:lnTo>
                        <a:pt x="801" y="381"/>
                      </a:lnTo>
                      <a:lnTo>
                        <a:pt x="827" y="384"/>
                      </a:lnTo>
                      <a:lnTo>
                        <a:pt x="851" y="386"/>
                      </a:lnTo>
                      <a:lnTo>
                        <a:pt x="877" y="388"/>
                      </a:lnTo>
                      <a:lnTo>
                        <a:pt x="901" y="389"/>
                      </a:lnTo>
                      <a:lnTo>
                        <a:pt x="927" y="390"/>
                      </a:lnTo>
                      <a:lnTo>
                        <a:pt x="951" y="390"/>
                      </a:lnTo>
                      <a:lnTo>
                        <a:pt x="977" y="389"/>
                      </a:lnTo>
                      <a:lnTo>
                        <a:pt x="1002" y="389"/>
                      </a:lnTo>
                      <a:lnTo>
                        <a:pt x="1027" y="386"/>
                      </a:lnTo>
                      <a:lnTo>
                        <a:pt x="1052" y="384"/>
                      </a:lnTo>
                      <a:lnTo>
                        <a:pt x="1077" y="381"/>
                      </a:lnTo>
                      <a:lnTo>
                        <a:pt x="1102" y="378"/>
                      </a:lnTo>
                      <a:lnTo>
                        <a:pt x="1128" y="374"/>
                      </a:lnTo>
                      <a:lnTo>
                        <a:pt x="1152" y="369"/>
                      </a:lnTo>
                      <a:lnTo>
                        <a:pt x="1178" y="363"/>
                      </a:lnTo>
                      <a:lnTo>
                        <a:pt x="1202" y="358"/>
                      </a:lnTo>
                      <a:lnTo>
                        <a:pt x="1228" y="351"/>
                      </a:lnTo>
                      <a:lnTo>
                        <a:pt x="1252" y="344"/>
                      </a:lnTo>
                      <a:lnTo>
                        <a:pt x="1278" y="338"/>
                      </a:lnTo>
                      <a:lnTo>
                        <a:pt x="1302" y="329"/>
                      </a:lnTo>
                      <a:lnTo>
                        <a:pt x="1328" y="321"/>
                      </a:lnTo>
                      <a:lnTo>
                        <a:pt x="1352" y="312"/>
                      </a:lnTo>
                      <a:lnTo>
                        <a:pt x="1377" y="304"/>
                      </a:lnTo>
                      <a:lnTo>
                        <a:pt x="1403" y="294"/>
                      </a:lnTo>
                      <a:lnTo>
                        <a:pt x="1427" y="283"/>
                      </a:lnTo>
                      <a:lnTo>
                        <a:pt x="1453" y="274"/>
                      </a:lnTo>
                      <a:lnTo>
                        <a:pt x="1477" y="263"/>
                      </a:lnTo>
                      <a:lnTo>
                        <a:pt x="1503" y="252"/>
                      </a:lnTo>
                      <a:lnTo>
                        <a:pt x="1527" y="240"/>
                      </a:lnTo>
                      <a:lnTo>
                        <a:pt x="1553" y="229"/>
                      </a:lnTo>
                      <a:lnTo>
                        <a:pt x="1577" y="217"/>
                      </a:lnTo>
                      <a:lnTo>
                        <a:pt x="1603" y="205"/>
                      </a:lnTo>
                      <a:lnTo>
                        <a:pt x="1628" y="193"/>
                      </a:lnTo>
                      <a:lnTo>
                        <a:pt x="1653" y="180"/>
                      </a:lnTo>
                      <a:lnTo>
                        <a:pt x="1678" y="167"/>
                      </a:lnTo>
                      <a:lnTo>
                        <a:pt x="1703" y="155"/>
                      </a:lnTo>
                      <a:lnTo>
                        <a:pt x="1728" y="141"/>
                      </a:lnTo>
                      <a:lnTo>
                        <a:pt x="1754" y="128"/>
                      </a:lnTo>
                      <a:lnTo>
                        <a:pt x="1778" y="114"/>
                      </a:lnTo>
                      <a:lnTo>
                        <a:pt x="1804" y="101"/>
                      </a:lnTo>
                      <a:lnTo>
                        <a:pt x="1828" y="86"/>
                      </a:lnTo>
                      <a:lnTo>
                        <a:pt x="1854" y="72"/>
                      </a:lnTo>
                      <a:lnTo>
                        <a:pt x="1878" y="59"/>
                      </a:lnTo>
                      <a:lnTo>
                        <a:pt x="1904" y="44"/>
                      </a:lnTo>
                      <a:lnTo>
                        <a:pt x="1928" y="29"/>
                      </a:lnTo>
                      <a:lnTo>
                        <a:pt x="1954" y="15"/>
                      </a:lnTo>
                      <a:lnTo>
                        <a:pt x="1978" y="0"/>
                      </a:lnTo>
                      <a:lnTo>
                        <a:pt x="1978" y="1514"/>
                      </a:lnTo>
                      <a:lnTo>
                        <a:pt x="1954" y="1501"/>
                      </a:lnTo>
                      <a:lnTo>
                        <a:pt x="1928" y="1491"/>
                      </a:lnTo>
                      <a:lnTo>
                        <a:pt x="1904" y="1478"/>
                      </a:lnTo>
                      <a:lnTo>
                        <a:pt x="1878" y="1467"/>
                      </a:lnTo>
                      <a:lnTo>
                        <a:pt x="1854" y="1457"/>
                      </a:lnTo>
                      <a:lnTo>
                        <a:pt x="1828" y="1446"/>
                      </a:lnTo>
                      <a:lnTo>
                        <a:pt x="1804" y="1434"/>
                      </a:lnTo>
                      <a:lnTo>
                        <a:pt x="1778" y="1424"/>
                      </a:lnTo>
                      <a:lnTo>
                        <a:pt x="1754" y="1413"/>
                      </a:lnTo>
                      <a:lnTo>
                        <a:pt x="1728" y="1402"/>
                      </a:lnTo>
                      <a:lnTo>
                        <a:pt x="1703" y="1392"/>
                      </a:lnTo>
                      <a:lnTo>
                        <a:pt x="1678" y="1382"/>
                      </a:lnTo>
                      <a:lnTo>
                        <a:pt x="1653" y="1373"/>
                      </a:lnTo>
                      <a:lnTo>
                        <a:pt x="1628" y="1363"/>
                      </a:lnTo>
                      <a:lnTo>
                        <a:pt x="1603" y="1354"/>
                      </a:lnTo>
                      <a:lnTo>
                        <a:pt x="1577" y="1344"/>
                      </a:lnTo>
                      <a:lnTo>
                        <a:pt x="1553" y="1336"/>
                      </a:lnTo>
                      <a:lnTo>
                        <a:pt x="1527" y="1327"/>
                      </a:lnTo>
                      <a:lnTo>
                        <a:pt x="1503" y="1318"/>
                      </a:lnTo>
                      <a:lnTo>
                        <a:pt x="1477" y="1310"/>
                      </a:lnTo>
                      <a:lnTo>
                        <a:pt x="1453" y="1304"/>
                      </a:lnTo>
                      <a:lnTo>
                        <a:pt x="1427" y="1295"/>
                      </a:lnTo>
                      <a:lnTo>
                        <a:pt x="1403" y="1289"/>
                      </a:lnTo>
                      <a:lnTo>
                        <a:pt x="1377" y="1282"/>
                      </a:lnTo>
                      <a:lnTo>
                        <a:pt x="1352" y="1276"/>
                      </a:lnTo>
                      <a:lnTo>
                        <a:pt x="1328" y="1270"/>
                      </a:lnTo>
                      <a:lnTo>
                        <a:pt x="1302" y="1266"/>
                      </a:lnTo>
                      <a:lnTo>
                        <a:pt x="1278" y="1260"/>
                      </a:lnTo>
                      <a:lnTo>
                        <a:pt x="1252" y="1256"/>
                      </a:lnTo>
                      <a:lnTo>
                        <a:pt x="1228" y="1252"/>
                      </a:lnTo>
                      <a:lnTo>
                        <a:pt x="1202" y="1248"/>
                      </a:lnTo>
                      <a:lnTo>
                        <a:pt x="1178" y="1245"/>
                      </a:lnTo>
                      <a:lnTo>
                        <a:pt x="1152" y="1244"/>
                      </a:lnTo>
                      <a:lnTo>
                        <a:pt x="1128" y="1241"/>
                      </a:lnTo>
                      <a:lnTo>
                        <a:pt x="1102" y="1241"/>
                      </a:lnTo>
                      <a:lnTo>
                        <a:pt x="1077" y="1240"/>
                      </a:lnTo>
                      <a:lnTo>
                        <a:pt x="1052" y="1240"/>
                      </a:lnTo>
                      <a:lnTo>
                        <a:pt x="1027" y="1241"/>
                      </a:lnTo>
                      <a:lnTo>
                        <a:pt x="1002" y="1241"/>
                      </a:lnTo>
                      <a:lnTo>
                        <a:pt x="977" y="1244"/>
                      </a:lnTo>
                      <a:lnTo>
                        <a:pt x="951" y="1247"/>
                      </a:lnTo>
                      <a:lnTo>
                        <a:pt x="927" y="1249"/>
                      </a:lnTo>
                      <a:lnTo>
                        <a:pt x="901" y="1253"/>
                      </a:lnTo>
                      <a:lnTo>
                        <a:pt x="877" y="1257"/>
                      </a:lnTo>
                      <a:lnTo>
                        <a:pt x="851" y="1262"/>
                      </a:lnTo>
                      <a:lnTo>
                        <a:pt x="827" y="1267"/>
                      </a:lnTo>
                      <a:lnTo>
                        <a:pt x="801" y="1274"/>
                      </a:lnTo>
                      <a:lnTo>
                        <a:pt x="777" y="1279"/>
                      </a:lnTo>
                      <a:lnTo>
                        <a:pt x="751" y="1286"/>
                      </a:lnTo>
                      <a:lnTo>
                        <a:pt x="727" y="1294"/>
                      </a:lnTo>
                      <a:lnTo>
                        <a:pt x="701" y="1302"/>
                      </a:lnTo>
                      <a:lnTo>
                        <a:pt x="676" y="1310"/>
                      </a:lnTo>
                      <a:lnTo>
                        <a:pt x="651" y="1318"/>
                      </a:lnTo>
                      <a:lnTo>
                        <a:pt x="626" y="1328"/>
                      </a:lnTo>
                      <a:lnTo>
                        <a:pt x="601" y="1337"/>
                      </a:lnTo>
                      <a:lnTo>
                        <a:pt x="576" y="1348"/>
                      </a:lnTo>
                      <a:lnTo>
                        <a:pt x="550" y="1358"/>
                      </a:lnTo>
                      <a:lnTo>
                        <a:pt x="526" y="1369"/>
                      </a:lnTo>
                      <a:lnTo>
                        <a:pt x="500" y="1379"/>
                      </a:lnTo>
                      <a:lnTo>
                        <a:pt x="476" y="1392"/>
                      </a:lnTo>
                      <a:lnTo>
                        <a:pt x="452" y="1402"/>
                      </a:lnTo>
                      <a:lnTo>
                        <a:pt x="426" y="1415"/>
                      </a:lnTo>
                      <a:lnTo>
                        <a:pt x="401" y="1427"/>
                      </a:lnTo>
                      <a:lnTo>
                        <a:pt x="376" y="1439"/>
                      </a:lnTo>
                      <a:lnTo>
                        <a:pt x="351" y="1451"/>
                      </a:lnTo>
                      <a:lnTo>
                        <a:pt x="326" y="1465"/>
                      </a:lnTo>
                      <a:lnTo>
                        <a:pt x="301" y="1478"/>
                      </a:lnTo>
                      <a:lnTo>
                        <a:pt x="275" y="1491"/>
                      </a:lnTo>
                      <a:lnTo>
                        <a:pt x="251" y="1504"/>
                      </a:lnTo>
                      <a:lnTo>
                        <a:pt x="225" y="1518"/>
                      </a:lnTo>
                      <a:lnTo>
                        <a:pt x="201" y="1531"/>
                      </a:lnTo>
                      <a:lnTo>
                        <a:pt x="175" y="1546"/>
                      </a:lnTo>
                      <a:lnTo>
                        <a:pt x="151" y="1560"/>
                      </a:lnTo>
                      <a:lnTo>
                        <a:pt x="125" y="1575"/>
                      </a:lnTo>
                      <a:lnTo>
                        <a:pt x="101" y="1588"/>
                      </a:lnTo>
                      <a:lnTo>
                        <a:pt x="75" y="1603"/>
                      </a:lnTo>
                      <a:lnTo>
                        <a:pt x="51" y="1618"/>
                      </a:lnTo>
                      <a:lnTo>
                        <a:pt x="25" y="1633"/>
                      </a:lnTo>
                      <a:lnTo>
                        <a:pt x="0" y="1646"/>
                      </a:lnTo>
                      <a:lnTo>
                        <a:pt x="0" y="103"/>
                      </a:lnTo>
                      <a:close/>
                    </a:path>
                  </a:pathLst>
                </a:cu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52" name="Freeform 105">
                  <a:extLst>
                    <a:ext uri="{FF2B5EF4-FFF2-40B4-BE49-F238E27FC236}">
                      <a16:creationId xmlns:a16="http://schemas.microsoft.com/office/drawing/2014/main" id="{98D8EB02-17C1-18B6-A9B0-8E7C87C0729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121400" y="2095500"/>
                  <a:ext cx="3140075" cy="619125"/>
                </a:xfrm>
                <a:custGeom>
                  <a:avLst/>
                  <a:gdLst>
                    <a:gd name="T0" fmla="*/ 25 w 1978"/>
                    <a:gd name="T1" fmla="*/ 115 h 390"/>
                    <a:gd name="T2" fmla="*/ 75 w 1978"/>
                    <a:gd name="T3" fmla="*/ 138 h 390"/>
                    <a:gd name="T4" fmla="*/ 125 w 1978"/>
                    <a:gd name="T5" fmla="*/ 162 h 390"/>
                    <a:gd name="T6" fmla="*/ 175 w 1978"/>
                    <a:gd name="T7" fmla="*/ 183 h 390"/>
                    <a:gd name="T8" fmla="*/ 225 w 1978"/>
                    <a:gd name="T9" fmla="*/ 205 h 390"/>
                    <a:gd name="T10" fmla="*/ 275 w 1978"/>
                    <a:gd name="T11" fmla="*/ 227 h 390"/>
                    <a:gd name="T12" fmla="*/ 326 w 1978"/>
                    <a:gd name="T13" fmla="*/ 247 h 390"/>
                    <a:gd name="T14" fmla="*/ 376 w 1978"/>
                    <a:gd name="T15" fmla="*/ 266 h 390"/>
                    <a:gd name="T16" fmla="*/ 426 w 1978"/>
                    <a:gd name="T17" fmla="*/ 285 h 390"/>
                    <a:gd name="T18" fmla="*/ 476 w 1978"/>
                    <a:gd name="T19" fmla="*/ 302 h 390"/>
                    <a:gd name="T20" fmla="*/ 526 w 1978"/>
                    <a:gd name="T21" fmla="*/ 319 h 390"/>
                    <a:gd name="T22" fmla="*/ 576 w 1978"/>
                    <a:gd name="T23" fmla="*/ 334 h 390"/>
                    <a:gd name="T24" fmla="*/ 626 w 1978"/>
                    <a:gd name="T25" fmla="*/ 347 h 390"/>
                    <a:gd name="T26" fmla="*/ 676 w 1978"/>
                    <a:gd name="T27" fmla="*/ 359 h 390"/>
                    <a:gd name="T28" fmla="*/ 727 w 1978"/>
                    <a:gd name="T29" fmla="*/ 370 h 390"/>
                    <a:gd name="T30" fmla="*/ 777 w 1978"/>
                    <a:gd name="T31" fmla="*/ 378 h 390"/>
                    <a:gd name="T32" fmla="*/ 827 w 1978"/>
                    <a:gd name="T33" fmla="*/ 384 h 390"/>
                    <a:gd name="T34" fmla="*/ 877 w 1978"/>
                    <a:gd name="T35" fmla="*/ 388 h 390"/>
                    <a:gd name="T36" fmla="*/ 927 w 1978"/>
                    <a:gd name="T37" fmla="*/ 390 h 390"/>
                    <a:gd name="T38" fmla="*/ 977 w 1978"/>
                    <a:gd name="T39" fmla="*/ 389 h 390"/>
                    <a:gd name="T40" fmla="*/ 1027 w 1978"/>
                    <a:gd name="T41" fmla="*/ 386 h 390"/>
                    <a:gd name="T42" fmla="*/ 1077 w 1978"/>
                    <a:gd name="T43" fmla="*/ 381 h 390"/>
                    <a:gd name="T44" fmla="*/ 1128 w 1978"/>
                    <a:gd name="T45" fmla="*/ 374 h 390"/>
                    <a:gd name="T46" fmla="*/ 1178 w 1978"/>
                    <a:gd name="T47" fmla="*/ 363 h 390"/>
                    <a:gd name="T48" fmla="*/ 1228 w 1978"/>
                    <a:gd name="T49" fmla="*/ 351 h 390"/>
                    <a:gd name="T50" fmla="*/ 1278 w 1978"/>
                    <a:gd name="T51" fmla="*/ 338 h 390"/>
                    <a:gd name="T52" fmla="*/ 1328 w 1978"/>
                    <a:gd name="T53" fmla="*/ 321 h 390"/>
                    <a:gd name="T54" fmla="*/ 1377 w 1978"/>
                    <a:gd name="T55" fmla="*/ 304 h 390"/>
                    <a:gd name="T56" fmla="*/ 1427 w 1978"/>
                    <a:gd name="T57" fmla="*/ 283 h 390"/>
                    <a:gd name="T58" fmla="*/ 1477 w 1978"/>
                    <a:gd name="T59" fmla="*/ 263 h 390"/>
                    <a:gd name="T60" fmla="*/ 1527 w 1978"/>
                    <a:gd name="T61" fmla="*/ 240 h 390"/>
                    <a:gd name="T62" fmla="*/ 1577 w 1978"/>
                    <a:gd name="T63" fmla="*/ 217 h 390"/>
                    <a:gd name="T64" fmla="*/ 1628 w 1978"/>
                    <a:gd name="T65" fmla="*/ 193 h 390"/>
                    <a:gd name="T66" fmla="*/ 1678 w 1978"/>
                    <a:gd name="T67" fmla="*/ 167 h 390"/>
                    <a:gd name="T68" fmla="*/ 1728 w 1978"/>
                    <a:gd name="T69" fmla="*/ 141 h 390"/>
                    <a:gd name="T70" fmla="*/ 1778 w 1978"/>
                    <a:gd name="T71" fmla="*/ 114 h 390"/>
                    <a:gd name="T72" fmla="*/ 1828 w 1978"/>
                    <a:gd name="T73" fmla="*/ 86 h 390"/>
                    <a:gd name="T74" fmla="*/ 1878 w 1978"/>
                    <a:gd name="T75" fmla="*/ 59 h 390"/>
                    <a:gd name="T76" fmla="*/ 1928 w 1978"/>
                    <a:gd name="T77" fmla="*/ 29 h 390"/>
                    <a:gd name="T78" fmla="*/ 1978 w 1978"/>
                    <a:gd name="T79" fmla="*/ 0 h 39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</a:cxnLst>
                  <a:rect l="0" t="0" r="r" b="b"/>
                  <a:pathLst>
                    <a:path w="1978" h="390">
                      <a:moveTo>
                        <a:pt x="0" y="103"/>
                      </a:moveTo>
                      <a:lnTo>
                        <a:pt x="25" y="115"/>
                      </a:lnTo>
                      <a:lnTo>
                        <a:pt x="51" y="126"/>
                      </a:lnTo>
                      <a:lnTo>
                        <a:pt x="75" y="138"/>
                      </a:lnTo>
                      <a:lnTo>
                        <a:pt x="101" y="151"/>
                      </a:lnTo>
                      <a:lnTo>
                        <a:pt x="125" y="162"/>
                      </a:lnTo>
                      <a:lnTo>
                        <a:pt x="151" y="172"/>
                      </a:lnTo>
                      <a:lnTo>
                        <a:pt x="175" y="183"/>
                      </a:lnTo>
                      <a:lnTo>
                        <a:pt x="201" y="194"/>
                      </a:lnTo>
                      <a:lnTo>
                        <a:pt x="225" y="205"/>
                      </a:lnTo>
                      <a:lnTo>
                        <a:pt x="251" y="216"/>
                      </a:lnTo>
                      <a:lnTo>
                        <a:pt x="275" y="227"/>
                      </a:lnTo>
                      <a:lnTo>
                        <a:pt x="301" y="236"/>
                      </a:lnTo>
                      <a:lnTo>
                        <a:pt x="326" y="247"/>
                      </a:lnTo>
                      <a:lnTo>
                        <a:pt x="351" y="256"/>
                      </a:lnTo>
                      <a:lnTo>
                        <a:pt x="376" y="266"/>
                      </a:lnTo>
                      <a:lnTo>
                        <a:pt x="401" y="275"/>
                      </a:lnTo>
                      <a:lnTo>
                        <a:pt x="426" y="285"/>
                      </a:lnTo>
                      <a:lnTo>
                        <a:pt x="452" y="294"/>
                      </a:lnTo>
                      <a:lnTo>
                        <a:pt x="476" y="302"/>
                      </a:lnTo>
                      <a:lnTo>
                        <a:pt x="500" y="311"/>
                      </a:lnTo>
                      <a:lnTo>
                        <a:pt x="526" y="319"/>
                      </a:lnTo>
                      <a:lnTo>
                        <a:pt x="550" y="327"/>
                      </a:lnTo>
                      <a:lnTo>
                        <a:pt x="576" y="334"/>
                      </a:lnTo>
                      <a:lnTo>
                        <a:pt x="601" y="340"/>
                      </a:lnTo>
                      <a:lnTo>
                        <a:pt x="626" y="347"/>
                      </a:lnTo>
                      <a:lnTo>
                        <a:pt x="651" y="354"/>
                      </a:lnTo>
                      <a:lnTo>
                        <a:pt x="676" y="359"/>
                      </a:lnTo>
                      <a:lnTo>
                        <a:pt x="701" y="365"/>
                      </a:lnTo>
                      <a:lnTo>
                        <a:pt x="727" y="370"/>
                      </a:lnTo>
                      <a:lnTo>
                        <a:pt x="751" y="374"/>
                      </a:lnTo>
                      <a:lnTo>
                        <a:pt x="777" y="378"/>
                      </a:lnTo>
                      <a:lnTo>
                        <a:pt x="801" y="381"/>
                      </a:lnTo>
                      <a:lnTo>
                        <a:pt x="827" y="384"/>
                      </a:lnTo>
                      <a:lnTo>
                        <a:pt x="851" y="386"/>
                      </a:lnTo>
                      <a:lnTo>
                        <a:pt x="877" y="388"/>
                      </a:lnTo>
                      <a:lnTo>
                        <a:pt x="901" y="389"/>
                      </a:lnTo>
                      <a:lnTo>
                        <a:pt x="927" y="390"/>
                      </a:lnTo>
                      <a:lnTo>
                        <a:pt x="951" y="390"/>
                      </a:lnTo>
                      <a:lnTo>
                        <a:pt x="977" y="389"/>
                      </a:lnTo>
                      <a:lnTo>
                        <a:pt x="1002" y="389"/>
                      </a:lnTo>
                      <a:lnTo>
                        <a:pt x="1027" y="386"/>
                      </a:lnTo>
                      <a:lnTo>
                        <a:pt x="1052" y="384"/>
                      </a:lnTo>
                      <a:lnTo>
                        <a:pt x="1077" y="381"/>
                      </a:lnTo>
                      <a:lnTo>
                        <a:pt x="1102" y="378"/>
                      </a:lnTo>
                      <a:lnTo>
                        <a:pt x="1128" y="374"/>
                      </a:lnTo>
                      <a:lnTo>
                        <a:pt x="1152" y="369"/>
                      </a:lnTo>
                      <a:lnTo>
                        <a:pt x="1178" y="363"/>
                      </a:lnTo>
                      <a:lnTo>
                        <a:pt x="1202" y="358"/>
                      </a:lnTo>
                      <a:lnTo>
                        <a:pt x="1228" y="351"/>
                      </a:lnTo>
                      <a:lnTo>
                        <a:pt x="1252" y="344"/>
                      </a:lnTo>
                      <a:lnTo>
                        <a:pt x="1278" y="338"/>
                      </a:lnTo>
                      <a:lnTo>
                        <a:pt x="1302" y="329"/>
                      </a:lnTo>
                      <a:lnTo>
                        <a:pt x="1328" y="321"/>
                      </a:lnTo>
                      <a:lnTo>
                        <a:pt x="1352" y="312"/>
                      </a:lnTo>
                      <a:lnTo>
                        <a:pt x="1377" y="304"/>
                      </a:lnTo>
                      <a:lnTo>
                        <a:pt x="1403" y="294"/>
                      </a:lnTo>
                      <a:lnTo>
                        <a:pt x="1427" y="283"/>
                      </a:lnTo>
                      <a:lnTo>
                        <a:pt x="1453" y="274"/>
                      </a:lnTo>
                      <a:lnTo>
                        <a:pt x="1477" y="263"/>
                      </a:lnTo>
                      <a:lnTo>
                        <a:pt x="1503" y="252"/>
                      </a:lnTo>
                      <a:lnTo>
                        <a:pt x="1527" y="240"/>
                      </a:lnTo>
                      <a:lnTo>
                        <a:pt x="1553" y="229"/>
                      </a:lnTo>
                      <a:lnTo>
                        <a:pt x="1577" y="217"/>
                      </a:lnTo>
                      <a:lnTo>
                        <a:pt x="1603" y="205"/>
                      </a:lnTo>
                      <a:lnTo>
                        <a:pt x="1628" y="193"/>
                      </a:lnTo>
                      <a:lnTo>
                        <a:pt x="1653" y="180"/>
                      </a:lnTo>
                      <a:lnTo>
                        <a:pt x="1678" y="167"/>
                      </a:lnTo>
                      <a:lnTo>
                        <a:pt x="1703" y="155"/>
                      </a:lnTo>
                      <a:lnTo>
                        <a:pt x="1728" y="141"/>
                      </a:lnTo>
                      <a:lnTo>
                        <a:pt x="1754" y="128"/>
                      </a:lnTo>
                      <a:lnTo>
                        <a:pt x="1778" y="114"/>
                      </a:lnTo>
                      <a:lnTo>
                        <a:pt x="1804" y="101"/>
                      </a:lnTo>
                      <a:lnTo>
                        <a:pt x="1828" y="86"/>
                      </a:lnTo>
                      <a:lnTo>
                        <a:pt x="1854" y="72"/>
                      </a:lnTo>
                      <a:lnTo>
                        <a:pt x="1878" y="59"/>
                      </a:lnTo>
                      <a:lnTo>
                        <a:pt x="1904" y="44"/>
                      </a:lnTo>
                      <a:lnTo>
                        <a:pt x="1928" y="29"/>
                      </a:lnTo>
                      <a:lnTo>
                        <a:pt x="1954" y="15"/>
                      </a:lnTo>
                      <a:lnTo>
                        <a:pt x="1978" y="0"/>
                      </a:lnTo>
                    </a:path>
                  </a:pathLst>
                </a:cu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53" name="Freeform 106">
                  <a:extLst>
                    <a:ext uri="{FF2B5EF4-FFF2-40B4-BE49-F238E27FC236}">
                      <a16:creationId xmlns:a16="http://schemas.microsoft.com/office/drawing/2014/main" id="{54FCA397-094D-EA80-0E8D-2BA1AE6DC85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121400" y="4064000"/>
                  <a:ext cx="3140075" cy="644525"/>
                </a:xfrm>
                <a:custGeom>
                  <a:avLst/>
                  <a:gdLst>
                    <a:gd name="T0" fmla="*/ 1954 w 1978"/>
                    <a:gd name="T1" fmla="*/ 261 h 406"/>
                    <a:gd name="T2" fmla="*/ 1904 w 1978"/>
                    <a:gd name="T3" fmla="*/ 238 h 406"/>
                    <a:gd name="T4" fmla="*/ 1854 w 1978"/>
                    <a:gd name="T5" fmla="*/ 217 h 406"/>
                    <a:gd name="T6" fmla="*/ 1804 w 1978"/>
                    <a:gd name="T7" fmla="*/ 194 h 406"/>
                    <a:gd name="T8" fmla="*/ 1754 w 1978"/>
                    <a:gd name="T9" fmla="*/ 173 h 406"/>
                    <a:gd name="T10" fmla="*/ 1703 w 1978"/>
                    <a:gd name="T11" fmla="*/ 152 h 406"/>
                    <a:gd name="T12" fmla="*/ 1653 w 1978"/>
                    <a:gd name="T13" fmla="*/ 133 h 406"/>
                    <a:gd name="T14" fmla="*/ 1603 w 1978"/>
                    <a:gd name="T15" fmla="*/ 114 h 406"/>
                    <a:gd name="T16" fmla="*/ 1553 w 1978"/>
                    <a:gd name="T17" fmla="*/ 96 h 406"/>
                    <a:gd name="T18" fmla="*/ 1503 w 1978"/>
                    <a:gd name="T19" fmla="*/ 78 h 406"/>
                    <a:gd name="T20" fmla="*/ 1453 w 1978"/>
                    <a:gd name="T21" fmla="*/ 64 h 406"/>
                    <a:gd name="T22" fmla="*/ 1403 w 1978"/>
                    <a:gd name="T23" fmla="*/ 49 h 406"/>
                    <a:gd name="T24" fmla="*/ 1352 w 1978"/>
                    <a:gd name="T25" fmla="*/ 36 h 406"/>
                    <a:gd name="T26" fmla="*/ 1302 w 1978"/>
                    <a:gd name="T27" fmla="*/ 26 h 406"/>
                    <a:gd name="T28" fmla="*/ 1252 w 1978"/>
                    <a:gd name="T29" fmla="*/ 16 h 406"/>
                    <a:gd name="T30" fmla="*/ 1202 w 1978"/>
                    <a:gd name="T31" fmla="*/ 8 h 406"/>
                    <a:gd name="T32" fmla="*/ 1152 w 1978"/>
                    <a:gd name="T33" fmla="*/ 4 h 406"/>
                    <a:gd name="T34" fmla="*/ 1102 w 1978"/>
                    <a:gd name="T35" fmla="*/ 1 h 406"/>
                    <a:gd name="T36" fmla="*/ 1052 w 1978"/>
                    <a:gd name="T37" fmla="*/ 0 h 406"/>
                    <a:gd name="T38" fmla="*/ 1002 w 1978"/>
                    <a:gd name="T39" fmla="*/ 1 h 406"/>
                    <a:gd name="T40" fmla="*/ 951 w 1978"/>
                    <a:gd name="T41" fmla="*/ 7 h 406"/>
                    <a:gd name="T42" fmla="*/ 901 w 1978"/>
                    <a:gd name="T43" fmla="*/ 13 h 406"/>
                    <a:gd name="T44" fmla="*/ 851 w 1978"/>
                    <a:gd name="T45" fmla="*/ 22 h 406"/>
                    <a:gd name="T46" fmla="*/ 801 w 1978"/>
                    <a:gd name="T47" fmla="*/ 34 h 406"/>
                    <a:gd name="T48" fmla="*/ 751 w 1978"/>
                    <a:gd name="T49" fmla="*/ 46 h 406"/>
                    <a:gd name="T50" fmla="*/ 701 w 1978"/>
                    <a:gd name="T51" fmla="*/ 62 h 406"/>
                    <a:gd name="T52" fmla="*/ 651 w 1978"/>
                    <a:gd name="T53" fmla="*/ 78 h 406"/>
                    <a:gd name="T54" fmla="*/ 601 w 1978"/>
                    <a:gd name="T55" fmla="*/ 97 h 406"/>
                    <a:gd name="T56" fmla="*/ 550 w 1978"/>
                    <a:gd name="T57" fmla="*/ 118 h 406"/>
                    <a:gd name="T58" fmla="*/ 500 w 1978"/>
                    <a:gd name="T59" fmla="*/ 139 h 406"/>
                    <a:gd name="T60" fmla="*/ 452 w 1978"/>
                    <a:gd name="T61" fmla="*/ 162 h 406"/>
                    <a:gd name="T62" fmla="*/ 401 w 1978"/>
                    <a:gd name="T63" fmla="*/ 187 h 406"/>
                    <a:gd name="T64" fmla="*/ 351 w 1978"/>
                    <a:gd name="T65" fmla="*/ 211 h 406"/>
                    <a:gd name="T66" fmla="*/ 301 w 1978"/>
                    <a:gd name="T67" fmla="*/ 238 h 406"/>
                    <a:gd name="T68" fmla="*/ 251 w 1978"/>
                    <a:gd name="T69" fmla="*/ 264 h 406"/>
                    <a:gd name="T70" fmla="*/ 201 w 1978"/>
                    <a:gd name="T71" fmla="*/ 291 h 406"/>
                    <a:gd name="T72" fmla="*/ 151 w 1978"/>
                    <a:gd name="T73" fmla="*/ 320 h 406"/>
                    <a:gd name="T74" fmla="*/ 101 w 1978"/>
                    <a:gd name="T75" fmla="*/ 348 h 406"/>
                    <a:gd name="T76" fmla="*/ 51 w 1978"/>
                    <a:gd name="T77" fmla="*/ 378 h 406"/>
                    <a:gd name="T78" fmla="*/ 0 w 1978"/>
                    <a:gd name="T79" fmla="*/ 406 h 40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</a:cxnLst>
                  <a:rect l="0" t="0" r="r" b="b"/>
                  <a:pathLst>
                    <a:path w="1978" h="406">
                      <a:moveTo>
                        <a:pt x="1978" y="274"/>
                      </a:moveTo>
                      <a:lnTo>
                        <a:pt x="1954" y="261"/>
                      </a:lnTo>
                      <a:lnTo>
                        <a:pt x="1928" y="251"/>
                      </a:lnTo>
                      <a:lnTo>
                        <a:pt x="1904" y="238"/>
                      </a:lnTo>
                      <a:lnTo>
                        <a:pt x="1878" y="227"/>
                      </a:lnTo>
                      <a:lnTo>
                        <a:pt x="1854" y="217"/>
                      </a:lnTo>
                      <a:lnTo>
                        <a:pt x="1828" y="206"/>
                      </a:lnTo>
                      <a:lnTo>
                        <a:pt x="1804" y="194"/>
                      </a:lnTo>
                      <a:lnTo>
                        <a:pt x="1778" y="184"/>
                      </a:lnTo>
                      <a:lnTo>
                        <a:pt x="1754" y="173"/>
                      </a:lnTo>
                      <a:lnTo>
                        <a:pt x="1728" y="162"/>
                      </a:lnTo>
                      <a:lnTo>
                        <a:pt x="1703" y="152"/>
                      </a:lnTo>
                      <a:lnTo>
                        <a:pt x="1678" y="142"/>
                      </a:lnTo>
                      <a:lnTo>
                        <a:pt x="1653" y="133"/>
                      </a:lnTo>
                      <a:lnTo>
                        <a:pt x="1628" y="123"/>
                      </a:lnTo>
                      <a:lnTo>
                        <a:pt x="1603" y="114"/>
                      </a:lnTo>
                      <a:lnTo>
                        <a:pt x="1577" y="104"/>
                      </a:lnTo>
                      <a:lnTo>
                        <a:pt x="1553" y="96"/>
                      </a:lnTo>
                      <a:lnTo>
                        <a:pt x="1527" y="87"/>
                      </a:lnTo>
                      <a:lnTo>
                        <a:pt x="1503" y="78"/>
                      </a:lnTo>
                      <a:lnTo>
                        <a:pt x="1477" y="70"/>
                      </a:lnTo>
                      <a:lnTo>
                        <a:pt x="1453" y="64"/>
                      </a:lnTo>
                      <a:lnTo>
                        <a:pt x="1427" y="55"/>
                      </a:lnTo>
                      <a:lnTo>
                        <a:pt x="1403" y="49"/>
                      </a:lnTo>
                      <a:lnTo>
                        <a:pt x="1377" y="42"/>
                      </a:lnTo>
                      <a:lnTo>
                        <a:pt x="1352" y="36"/>
                      </a:lnTo>
                      <a:lnTo>
                        <a:pt x="1328" y="30"/>
                      </a:lnTo>
                      <a:lnTo>
                        <a:pt x="1302" y="26"/>
                      </a:lnTo>
                      <a:lnTo>
                        <a:pt x="1278" y="20"/>
                      </a:lnTo>
                      <a:lnTo>
                        <a:pt x="1252" y="16"/>
                      </a:lnTo>
                      <a:lnTo>
                        <a:pt x="1228" y="12"/>
                      </a:lnTo>
                      <a:lnTo>
                        <a:pt x="1202" y="8"/>
                      </a:lnTo>
                      <a:lnTo>
                        <a:pt x="1178" y="5"/>
                      </a:lnTo>
                      <a:lnTo>
                        <a:pt x="1152" y="4"/>
                      </a:lnTo>
                      <a:lnTo>
                        <a:pt x="1128" y="1"/>
                      </a:lnTo>
                      <a:lnTo>
                        <a:pt x="1102" y="1"/>
                      </a:lnTo>
                      <a:lnTo>
                        <a:pt x="1077" y="0"/>
                      </a:lnTo>
                      <a:lnTo>
                        <a:pt x="1052" y="0"/>
                      </a:lnTo>
                      <a:lnTo>
                        <a:pt x="1027" y="1"/>
                      </a:lnTo>
                      <a:lnTo>
                        <a:pt x="1002" y="1"/>
                      </a:lnTo>
                      <a:lnTo>
                        <a:pt x="977" y="4"/>
                      </a:lnTo>
                      <a:lnTo>
                        <a:pt x="951" y="7"/>
                      </a:lnTo>
                      <a:lnTo>
                        <a:pt x="927" y="9"/>
                      </a:lnTo>
                      <a:lnTo>
                        <a:pt x="901" y="13"/>
                      </a:lnTo>
                      <a:lnTo>
                        <a:pt x="877" y="17"/>
                      </a:lnTo>
                      <a:lnTo>
                        <a:pt x="851" y="22"/>
                      </a:lnTo>
                      <a:lnTo>
                        <a:pt x="827" y="27"/>
                      </a:lnTo>
                      <a:lnTo>
                        <a:pt x="801" y="34"/>
                      </a:lnTo>
                      <a:lnTo>
                        <a:pt x="777" y="39"/>
                      </a:lnTo>
                      <a:lnTo>
                        <a:pt x="751" y="46"/>
                      </a:lnTo>
                      <a:lnTo>
                        <a:pt x="727" y="54"/>
                      </a:lnTo>
                      <a:lnTo>
                        <a:pt x="701" y="62"/>
                      </a:lnTo>
                      <a:lnTo>
                        <a:pt x="676" y="70"/>
                      </a:lnTo>
                      <a:lnTo>
                        <a:pt x="651" y="78"/>
                      </a:lnTo>
                      <a:lnTo>
                        <a:pt x="626" y="88"/>
                      </a:lnTo>
                      <a:lnTo>
                        <a:pt x="601" y="97"/>
                      </a:lnTo>
                      <a:lnTo>
                        <a:pt x="576" y="108"/>
                      </a:lnTo>
                      <a:lnTo>
                        <a:pt x="550" y="118"/>
                      </a:lnTo>
                      <a:lnTo>
                        <a:pt x="526" y="129"/>
                      </a:lnTo>
                      <a:lnTo>
                        <a:pt x="500" y="139"/>
                      </a:lnTo>
                      <a:lnTo>
                        <a:pt x="476" y="152"/>
                      </a:lnTo>
                      <a:lnTo>
                        <a:pt x="452" y="162"/>
                      </a:lnTo>
                      <a:lnTo>
                        <a:pt x="426" y="175"/>
                      </a:lnTo>
                      <a:lnTo>
                        <a:pt x="401" y="187"/>
                      </a:lnTo>
                      <a:lnTo>
                        <a:pt x="376" y="199"/>
                      </a:lnTo>
                      <a:lnTo>
                        <a:pt x="351" y="211"/>
                      </a:lnTo>
                      <a:lnTo>
                        <a:pt x="326" y="225"/>
                      </a:lnTo>
                      <a:lnTo>
                        <a:pt x="301" y="238"/>
                      </a:lnTo>
                      <a:lnTo>
                        <a:pt x="275" y="251"/>
                      </a:lnTo>
                      <a:lnTo>
                        <a:pt x="251" y="264"/>
                      </a:lnTo>
                      <a:lnTo>
                        <a:pt x="225" y="278"/>
                      </a:lnTo>
                      <a:lnTo>
                        <a:pt x="201" y="291"/>
                      </a:lnTo>
                      <a:lnTo>
                        <a:pt x="175" y="306"/>
                      </a:lnTo>
                      <a:lnTo>
                        <a:pt x="151" y="320"/>
                      </a:lnTo>
                      <a:lnTo>
                        <a:pt x="125" y="335"/>
                      </a:lnTo>
                      <a:lnTo>
                        <a:pt x="101" y="348"/>
                      </a:lnTo>
                      <a:lnTo>
                        <a:pt x="75" y="363"/>
                      </a:lnTo>
                      <a:lnTo>
                        <a:pt x="51" y="378"/>
                      </a:lnTo>
                      <a:lnTo>
                        <a:pt x="25" y="393"/>
                      </a:lnTo>
                      <a:lnTo>
                        <a:pt x="0" y="406"/>
                      </a:lnTo>
                    </a:path>
                  </a:pathLst>
                </a:cu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54" name="Freeform 107">
                  <a:extLst>
                    <a:ext uri="{FF2B5EF4-FFF2-40B4-BE49-F238E27FC236}">
                      <a16:creationId xmlns:a16="http://schemas.microsoft.com/office/drawing/2014/main" id="{47301F0F-FDF2-EA1F-3B81-CBA4C7842DD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121400" y="3295650"/>
                  <a:ext cx="3140075" cy="188912"/>
                </a:xfrm>
                <a:custGeom>
                  <a:avLst/>
                  <a:gdLst>
                    <a:gd name="T0" fmla="*/ 25 w 1978"/>
                    <a:gd name="T1" fmla="*/ 118 h 119"/>
                    <a:gd name="T2" fmla="*/ 75 w 1978"/>
                    <a:gd name="T3" fmla="*/ 114 h 119"/>
                    <a:gd name="T4" fmla="*/ 125 w 1978"/>
                    <a:gd name="T5" fmla="*/ 111 h 119"/>
                    <a:gd name="T6" fmla="*/ 175 w 1978"/>
                    <a:gd name="T7" fmla="*/ 109 h 119"/>
                    <a:gd name="T8" fmla="*/ 225 w 1978"/>
                    <a:gd name="T9" fmla="*/ 106 h 119"/>
                    <a:gd name="T10" fmla="*/ 275 w 1978"/>
                    <a:gd name="T11" fmla="*/ 103 h 119"/>
                    <a:gd name="T12" fmla="*/ 326 w 1978"/>
                    <a:gd name="T13" fmla="*/ 99 h 119"/>
                    <a:gd name="T14" fmla="*/ 376 w 1978"/>
                    <a:gd name="T15" fmla="*/ 96 h 119"/>
                    <a:gd name="T16" fmla="*/ 426 w 1978"/>
                    <a:gd name="T17" fmla="*/ 94 h 119"/>
                    <a:gd name="T18" fmla="*/ 476 w 1978"/>
                    <a:gd name="T19" fmla="*/ 91 h 119"/>
                    <a:gd name="T20" fmla="*/ 526 w 1978"/>
                    <a:gd name="T21" fmla="*/ 88 h 119"/>
                    <a:gd name="T22" fmla="*/ 576 w 1978"/>
                    <a:gd name="T23" fmla="*/ 84 h 119"/>
                    <a:gd name="T24" fmla="*/ 626 w 1978"/>
                    <a:gd name="T25" fmla="*/ 82 h 119"/>
                    <a:gd name="T26" fmla="*/ 676 w 1978"/>
                    <a:gd name="T27" fmla="*/ 79 h 119"/>
                    <a:gd name="T28" fmla="*/ 727 w 1978"/>
                    <a:gd name="T29" fmla="*/ 76 h 119"/>
                    <a:gd name="T30" fmla="*/ 777 w 1978"/>
                    <a:gd name="T31" fmla="*/ 72 h 119"/>
                    <a:gd name="T32" fmla="*/ 827 w 1978"/>
                    <a:gd name="T33" fmla="*/ 69 h 119"/>
                    <a:gd name="T34" fmla="*/ 877 w 1978"/>
                    <a:gd name="T35" fmla="*/ 67 h 119"/>
                    <a:gd name="T36" fmla="*/ 927 w 1978"/>
                    <a:gd name="T37" fmla="*/ 64 h 119"/>
                    <a:gd name="T38" fmla="*/ 977 w 1978"/>
                    <a:gd name="T39" fmla="*/ 61 h 119"/>
                    <a:gd name="T40" fmla="*/ 1027 w 1978"/>
                    <a:gd name="T41" fmla="*/ 57 h 119"/>
                    <a:gd name="T42" fmla="*/ 1077 w 1978"/>
                    <a:gd name="T43" fmla="*/ 54 h 119"/>
                    <a:gd name="T44" fmla="*/ 1128 w 1978"/>
                    <a:gd name="T45" fmla="*/ 52 h 119"/>
                    <a:gd name="T46" fmla="*/ 1178 w 1978"/>
                    <a:gd name="T47" fmla="*/ 49 h 119"/>
                    <a:gd name="T48" fmla="*/ 1228 w 1978"/>
                    <a:gd name="T49" fmla="*/ 46 h 119"/>
                    <a:gd name="T50" fmla="*/ 1278 w 1978"/>
                    <a:gd name="T51" fmla="*/ 42 h 119"/>
                    <a:gd name="T52" fmla="*/ 1328 w 1978"/>
                    <a:gd name="T53" fmla="*/ 40 h 119"/>
                    <a:gd name="T54" fmla="*/ 1377 w 1978"/>
                    <a:gd name="T55" fmla="*/ 37 h 119"/>
                    <a:gd name="T56" fmla="*/ 1427 w 1978"/>
                    <a:gd name="T57" fmla="*/ 34 h 119"/>
                    <a:gd name="T58" fmla="*/ 1477 w 1978"/>
                    <a:gd name="T59" fmla="*/ 30 h 119"/>
                    <a:gd name="T60" fmla="*/ 1527 w 1978"/>
                    <a:gd name="T61" fmla="*/ 27 h 119"/>
                    <a:gd name="T62" fmla="*/ 1577 w 1978"/>
                    <a:gd name="T63" fmla="*/ 25 h 119"/>
                    <a:gd name="T64" fmla="*/ 1628 w 1978"/>
                    <a:gd name="T65" fmla="*/ 22 h 119"/>
                    <a:gd name="T66" fmla="*/ 1678 w 1978"/>
                    <a:gd name="T67" fmla="*/ 19 h 119"/>
                    <a:gd name="T68" fmla="*/ 1728 w 1978"/>
                    <a:gd name="T69" fmla="*/ 15 h 119"/>
                    <a:gd name="T70" fmla="*/ 1778 w 1978"/>
                    <a:gd name="T71" fmla="*/ 12 h 119"/>
                    <a:gd name="T72" fmla="*/ 1828 w 1978"/>
                    <a:gd name="T73" fmla="*/ 10 h 119"/>
                    <a:gd name="T74" fmla="*/ 1878 w 1978"/>
                    <a:gd name="T75" fmla="*/ 7 h 119"/>
                    <a:gd name="T76" fmla="*/ 1928 w 1978"/>
                    <a:gd name="T77" fmla="*/ 4 h 119"/>
                    <a:gd name="T78" fmla="*/ 1978 w 1978"/>
                    <a:gd name="T79" fmla="*/ 0 h 11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</a:cxnLst>
                  <a:rect l="0" t="0" r="r" b="b"/>
                  <a:pathLst>
                    <a:path w="1978" h="119">
                      <a:moveTo>
                        <a:pt x="0" y="119"/>
                      </a:moveTo>
                      <a:lnTo>
                        <a:pt x="25" y="118"/>
                      </a:lnTo>
                      <a:lnTo>
                        <a:pt x="51" y="117"/>
                      </a:lnTo>
                      <a:lnTo>
                        <a:pt x="75" y="114"/>
                      </a:lnTo>
                      <a:lnTo>
                        <a:pt x="101" y="113"/>
                      </a:lnTo>
                      <a:lnTo>
                        <a:pt x="125" y="111"/>
                      </a:lnTo>
                      <a:lnTo>
                        <a:pt x="151" y="110"/>
                      </a:lnTo>
                      <a:lnTo>
                        <a:pt x="175" y="109"/>
                      </a:lnTo>
                      <a:lnTo>
                        <a:pt x="201" y="107"/>
                      </a:lnTo>
                      <a:lnTo>
                        <a:pt x="225" y="106"/>
                      </a:lnTo>
                      <a:lnTo>
                        <a:pt x="251" y="105"/>
                      </a:lnTo>
                      <a:lnTo>
                        <a:pt x="275" y="103"/>
                      </a:lnTo>
                      <a:lnTo>
                        <a:pt x="301" y="100"/>
                      </a:lnTo>
                      <a:lnTo>
                        <a:pt x="326" y="99"/>
                      </a:lnTo>
                      <a:lnTo>
                        <a:pt x="351" y="98"/>
                      </a:lnTo>
                      <a:lnTo>
                        <a:pt x="376" y="96"/>
                      </a:lnTo>
                      <a:lnTo>
                        <a:pt x="401" y="95"/>
                      </a:lnTo>
                      <a:lnTo>
                        <a:pt x="426" y="94"/>
                      </a:lnTo>
                      <a:lnTo>
                        <a:pt x="452" y="92"/>
                      </a:lnTo>
                      <a:lnTo>
                        <a:pt x="476" y="91"/>
                      </a:lnTo>
                      <a:lnTo>
                        <a:pt x="500" y="90"/>
                      </a:lnTo>
                      <a:lnTo>
                        <a:pt x="526" y="88"/>
                      </a:lnTo>
                      <a:lnTo>
                        <a:pt x="550" y="86"/>
                      </a:lnTo>
                      <a:lnTo>
                        <a:pt x="576" y="84"/>
                      </a:lnTo>
                      <a:lnTo>
                        <a:pt x="601" y="83"/>
                      </a:lnTo>
                      <a:lnTo>
                        <a:pt x="626" y="82"/>
                      </a:lnTo>
                      <a:lnTo>
                        <a:pt x="651" y="80"/>
                      </a:lnTo>
                      <a:lnTo>
                        <a:pt x="676" y="79"/>
                      </a:lnTo>
                      <a:lnTo>
                        <a:pt x="701" y="77"/>
                      </a:lnTo>
                      <a:lnTo>
                        <a:pt x="727" y="76"/>
                      </a:lnTo>
                      <a:lnTo>
                        <a:pt x="751" y="75"/>
                      </a:lnTo>
                      <a:lnTo>
                        <a:pt x="777" y="72"/>
                      </a:lnTo>
                      <a:lnTo>
                        <a:pt x="801" y="71"/>
                      </a:lnTo>
                      <a:lnTo>
                        <a:pt x="827" y="69"/>
                      </a:lnTo>
                      <a:lnTo>
                        <a:pt x="851" y="68"/>
                      </a:lnTo>
                      <a:lnTo>
                        <a:pt x="877" y="67"/>
                      </a:lnTo>
                      <a:lnTo>
                        <a:pt x="901" y="65"/>
                      </a:lnTo>
                      <a:lnTo>
                        <a:pt x="927" y="64"/>
                      </a:lnTo>
                      <a:lnTo>
                        <a:pt x="951" y="63"/>
                      </a:lnTo>
                      <a:lnTo>
                        <a:pt x="977" y="61"/>
                      </a:lnTo>
                      <a:lnTo>
                        <a:pt x="1002" y="58"/>
                      </a:lnTo>
                      <a:lnTo>
                        <a:pt x="1027" y="57"/>
                      </a:lnTo>
                      <a:lnTo>
                        <a:pt x="1052" y="56"/>
                      </a:lnTo>
                      <a:lnTo>
                        <a:pt x="1077" y="54"/>
                      </a:lnTo>
                      <a:lnTo>
                        <a:pt x="1102" y="53"/>
                      </a:lnTo>
                      <a:lnTo>
                        <a:pt x="1128" y="52"/>
                      </a:lnTo>
                      <a:lnTo>
                        <a:pt x="1152" y="50"/>
                      </a:lnTo>
                      <a:lnTo>
                        <a:pt x="1178" y="49"/>
                      </a:lnTo>
                      <a:lnTo>
                        <a:pt x="1202" y="48"/>
                      </a:lnTo>
                      <a:lnTo>
                        <a:pt x="1228" y="46"/>
                      </a:lnTo>
                      <a:lnTo>
                        <a:pt x="1252" y="44"/>
                      </a:lnTo>
                      <a:lnTo>
                        <a:pt x="1278" y="42"/>
                      </a:lnTo>
                      <a:lnTo>
                        <a:pt x="1302" y="41"/>
                      </a:lnTo>
                      <a:lnTo>
                        <a:pt x="1328" y="40"/>
                      </a:lnTo>
                      <a:lnTo>
                        <a:pt x="1352" y="38"/>
                      </a:lnTo>
                      <a:lnTo>
                        <a:pt x="1377" y="37"/>
                      </a:lnTo>
                      <a:lnTo>
                        <a:pt x="1403" y="35"/>
                      </a:lnTo>
                      <a:lnTo>
                        <a:pt x="1427" y="34"/>
                      </a:lnTo>
                      <a:lnTo>
                        <a:pt x="1453" y="33"/>
                      </a:lnTo>
                      <a:lnTo>
                        <a:pt x="1477" y="30"/>
                      </a:lnTo>
                      <a:lnTo>
                        <a:pt x="1503" y="29"/>
                      </a:lnTo>
                      <a:lnTo>
                        <a:pt x="1527" y="27"/>
                      </a:lnTo>
                      <a:lnTo>
                        <a:pt x="1553" y="26"/>
                      </a:lnTo>
                      <a:lnTo>
                        <a:pt x="1577" y="25"/>
                      </a:lnTo>
                      <a:lnTo>
                        <a:pt x="1603" y="23"/>
                      </a:lnTo>
                      <a:lnTo>
                        <a:pt x="1628" y="22"/>
                      </a:lnTo>
                      <a:lnTo>
                        <a:pt x="1653" y="21"/>
                      </a:lnTo>
                      <a:lnTo>
                        <a:pt x="1678" y="19"/>
                      </a:lnTo>
                      <a:lnTo>
                        <a:pt x="1703" y="18"/>
                      </a:lnTo>
                      <a:lnTo>
                        <a:pt x="1728" y="15"/>
                      </a:lnTo>
                      <a:lnTo>
                        <a:pt x="1754" y="14"/>
                      </a:lnTo>
                      <a:lnTo>
                        <a:pt x="1778" y="12"/>
                      </a:lnTo>
                      <a:lnTo>
                        <a:pt x="1804" y="11"/>
                      </a:lnTo>
                      <a:lnTo>
                        <a:pt x="1828" y="10"/>
                      </a:lnTo>
                      <a:lnTo>
                        <a:pt x="1854" y="8"/>
                      </a:lnTo>
                      <a:lnTo>
                        <a:pt x="1878" y="7"/>
                      </a:lnTo>
                      <a:lnTo>
                        <a:pt x="1904" y="6"/>
                      </a:lnTo>
                      <a:lnTo>
                        <a:pt x="1928" y="4"/>
                      </a:lnTo>
                      <a:lnTo>
                        <a:pt x="1954" y="2"/>
                      </a:lnTo>
                      <a:lnTo>
                        <a:pt x="1978" y="0"/>
                      </a:lnTo>
                    </a:path>
                  </a:pathLst>
                </a:custGeom>
                <a:noFill/>
                <a:ln w="0" cap="flat">
                  <a:solidFill>
                    <a:srgbClr val="3366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55" name="Rectangle 108">
                  <a:extLst>
                    <a:ext uri="{FF2B5EF4-FFF2-40B4-BE49-F238E27FC236}">
                      <a16:creationId xmlns:a16="http://schemas.microsoft.com/office/drawing/2014/main" id="{558D3759-E80E-4979-6E50-0C9380CC594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114602" y="2692181"/>
                  <a:ext cx="705956" cy="81385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1100" b="0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R</a:t>
                  </a:r>
                  <a:r>
                    <a:rPr kumimoji="0" lang="en-US" altLang="hu-HU" sz="1100" b="0" i="0" u="none" strike="noStrike" cap="none" normalizeH="0" baseline="3000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2</a:t>
                  </a:r>
                  <a:r>
                    <a:rPr kumimoji="0" lang="en-US" altLang="hu-HU" sz="11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&lt;0.001</a:t>
                  </a:r>
                </a:p>
                <a:p>
                  <a:r>
                    <a:rPr lang="en-US" altLang="hu-HU" sz="11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P=0.896</a:t>
                  </a:r>
                  <a:endParaRPr kumimoji="0" lang="en-US" altLang="hu-HU" sz="110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endParaRPr kumimoji="0" lang="en-US" altLang="hu-HU" sz="11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" name="Line 109">
                  <a:extLst>
                    <a:ext uri="{FF2B5EF4-FFF2-40B4-BE49-F238E27FC236}">
                      <a16:creationId xmlns:a16="http://schemas.microsoft.com/office/drawing/2014/main" id="{61B09BFD-71A3-DCA2-ADAE-AC92CA6988F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5964238" y="1677987"/>
                  <a:ext cx="0" cy="3176587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57" name="Rectangle 110">
                  <a:extLst>
                    <a:ext uri="{FF2B5EF4-FFF2-40B4-BE49-F238E27FC236}">
                      <a16:creationId xmlns:a16="http://schemas.microsoft.com/office/drawing/2014/main" id="{5A61EF65-72E1-12CE-CCFC-0EE564CD6A6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758725" y="4434130"/>
                  <a:ext cx="138122" cy="1972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solidFill>
                        <a:srgbClr val="4D4D4D"/>
                      </a:solidFill>
                      <a:effectLst/>
                      <a:cs typeface="Arial" panose="020B0604020202020204" pitchFamily="34" charset="0"/>
                    </a:rPr>
                    <a:t>20</a:t>
                  </a:r>
                  <a:endParaRPr kumimoji="0" lang="en-US" altLang="hu-HU" sz="14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8" name="Rectangle 111">
                  <a:extLst>
                    <a:ext uri="{FF2B5EF4-FFF2-40B4-BE49-F238E27FC236}">
                      <a16:creationId xmlns:a16="http://schemas.microsoft.com/office/drawing/2014/main" id="{163BE375-11CB-B32E-2772-8E191609E9D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758725" y="3815001"/>
                  <a:ext cx="138122" cy="1972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solidFill>
                        <a:srgbClr val="4D4D4D"/>
                      </a:solidFill>
                      <a:effectLst/>
                      <a:cs typeface="Arial" panose="020B0604020202020204" pitchFamily="34" charset="0"/>
                    </a:rPr>
                    <a:t>25</a:t>
                  </a:r>
                  <a:endParaRPr kumimoji="0" lang="en-US" altLang="hu-HU" sz="14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9" name="Rectangle 112">
                  <a:extLst>
                    <a:ext uri="{FF2B5EF4-FFF2-40B4-BE49-F238E27FC236}">
                      <a16:creationId xmlns:a16="http://schemas.microsoft.com/office/drawing/2014/main" id="{89B01BB0-37CD-154C-48F7-BC8A7AAECE0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758725" y="3194286"/>
                  <a:ext cx="138122" cy="1972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solidFill>
                        <a:srgbClr val="4D4D4D"/>
                      </a:solidFill>
                      <a:effectLst/>
                      <a:cs typeface="Arial" panose="020B0604020202020204" pitchFamily="34" charset="0"/>
                    </a:rPr>
                    <a:t>30</a:t>
                  </a:r>
                  <a:endParaRPr kumimoji="0" lang="en-US" altLang="hu-HU" sz="14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0" name="Rectangle 113">
                  <a:extLst>
                    <a:ext uri="{FF2B5EF4-FFF2-40B4-BE49-F238E27FC236}">
                      <a16:creationId xmlns:a16="http://schemas.microsoft.com/office/drawing/2014/main" id="{AD646F26-4E40-8CC4-CBC1-139A5DDE656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758725" y="2575163"/>
                  <a:ext cx="138122" cy="1972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solidFill>
                        <a:srgbClr val="4D4D4D"/>
                      </a:solidFill>
                      <a:effectLst/>
                      <a:cs typeface="Arial" panose="020B0604020202020204" pitchFamily="34" charset="0"/>
                    </a:rPr>
                    <a:t>35</a:t>
                  </a:r>
                  <a:endParaRPr kumimoji="0" lang="en-US" altLang="hu-HU" sz="14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1" name="Rectangle 114">
                  <a:extLst>
                    <a:ext uri="{FF2B5EF4-FFF2-40B4-BE49-F238E27FC236}">
                      <a16:creationId xmlns:a16="http://schemas.microsoft.com/office/drawing/2014/main" id="{2082A77A-7ADF-E5FD-8458-A37EC45A22C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758725" y="1956037"/>
                  <a:ext cx="138122" cy="1972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solidFill>
                        <a:srgbClr val="4D4D4D"/>
                      </a:solidFill>
                      <a:effectLst/>
                      <a:cs typeface="Arial" panose="020B0604020202020204" pitchFamily="34" charset="0"/>
                    </a:rPr>
                    <a:t>40</a:t>
                  </a:r>
                  <a:endParaRPr kumimoji="0" lang="en-US" altLang="hu-HU" sz="14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2" name="Line 115">
                  <a:extLst>
                    <a:ext uri="{FF2B5EF4-FFF2-40B4-BE49-F238E27FC236}">
                      <a16:creationId xmlns:a16="http://schemas.microsoft.com/office/drawing/2014/main" id="{E091467D-F1CE-049C-5218-9362431F0C2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938838" y="4548187"/>
                  <a:ext cx="25400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63" name="Line 116">
                  <a:extLst>
                    <a:ext uri="{FF2B5EF4-FFF2-40B4-BE49-F238E27FC236}">
                      <a16:creationId xmlns:a16="http://schemas.microsoft.com/office/drawing/2014/main" id="{C725FF4E-EA6D-F7CF-DF36-05338E1F961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938838" y="3929062"/>
                  <a:ext cx="25400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64" name="Line 117">
                  <a:extLst>
                    <a:ext uri="{FF2B5EF4-FFF2-40B4-BE49-F238E27FC236}">
                      <a16:creationId xmlns:a16="http://schemas.microsoft.com/office/drawing/2014/main" id="{7664ABBC-A2C0-EE73-ECA2-B7EE07EB332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938838" y="3308350"/>
                  <a:ext cx="25400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65" name="Line 118">
                  <a:extLst>
                    <a:ext uri="{FF2B5EF4-FFF2-40B4-BE49-F238E27FC236}">
                      <a16:creationId xmlns:a16="http://schemas.microsoft.com/office/drawing/2014/main" id="{04B04DA1-5EB6-2F93-3B6E-1D4AD3511BA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938838" y="2689225"/>
                  <a:ext cx="25400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66" name="Line 119">
                  <a:extLst>
                    <a:ext uri="{FF2B5EF4-FFF2-40B4-BE49-F238E27FC236}">
                      <a16:creationId xmlns:a16="http://schemas.microsoft.com/office/drawing/2014/main" id="{4DC24AA0-B189-683B-682E-0633F83951D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938838" y="2070100"/>
                  <a:ext cx="25400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67" name="Line 120">
                  <a:extLst>
                    <a:ext uri="{FF2B5EF4-FFF2-40B4-BE49-F238E27FC236}">
                      <a16:creationId xmlns:a16="http://schemas.microsoft.com/office/drawing/2014/main" id="{D2DCA159-2836-2B89-746E-63BDD0F0BFA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964238" y="4854575"/>
                  <a:ext cx="3454400" cy="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68" name="Line 121">
                  <a:extLst>
                    <a:ext uri="{FF2B5EF4-FFF2-40B4-BE49-F238E27FC236}">
                      <a16:creationId xmlns:a16="http://schemas.microsoft.com/office/drawing/2014/main" id="{38D3DEA0-727E-F518-7FA2-05A93254616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6840538" y="4854575"/>
                  <a:ext cx="0" cy="23812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69" name="Line 122">
                  <a:extLst>
                    <a:ext uri="{FF2B5EF4-FFF2-40B4-BE49-F238E27FC236}">
                      <a16:creationId xmlns:a16="http://schemas.microsoft.com/office/drawing/2014/main" id="{65B47310-9879-5010-CCAE-1AF4F098154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7785100" y="4854575"/>
                  <a:ext cx="0" cy="23812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70" name="Line 123">
                  <a:extLst>
                    <a:ext uri="{FF2B5EF4-FFF2-40B4-BE49-F238E27FC236}">
                      <a16:creationId xmlns:a16="http://schemas.microsoft.com/office/drawing/2014/main" id="{ABD8A870-192D-CD97-096E-5BED986FADB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8731250" y="4854575"/>
                  <a:ext cx="0" cy="23812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71" name="Rectangle 124">
                  <a:extLst>
                    <a:ext uri="{FF2B5EF4-FFF2-40B4-BE49-F238E27FC236}">
                      <a16:creationId xmlns:a16="http://schemas.microsoft.com/office/drawing/2014/main" id="{BC846A5B-4053-87A0-0F6F-93B02FEF89E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663889" y="4861534"/>
                  <a:ext cx="345305" cy="1972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solidFill>
                        <a:srgbClr val="4D4D4D"/>
                      </a:solidFill>
                      <a:effectLst/>
                      <a:latin typeface="Helvetica" panose="020B0604020202020204" pitchFamily="34" charset="0"/>
                    </a:rPr>
                    <a:t>20000</a:t>
                  </a:r>
                  <a:endParaRPr kumimoji="0" lang="en-US" altLang="hu-HU" sz="14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</a:endParaRPr>
                </a:p>
              </p:txBody>
            </p:sp>
            <p:sp>
              <p:nvSpPr>
                <p:cNvPr id="72" name="Rectangle 125">
                  <a:extLst>
                    <a:ext uri="{FF2B5EF4-FFF2-40B4-BE49-F238E27FC236}">
                      <a16:creationId xmlns:a16="http://schemas.microsoft.com/office/drawing/2014/main" id="{32D9CF05-A69D-D6EA-1B7C-A5A47616605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10038" y="4861534"/>
                  <a:ext cx="345305" cy="1972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solidFill>
                        <a:srgbClr val="4D4D4D"/>
                      </a:solidFill>
                      <a:effectLst/>
                      <a:latin typeface="Helvetica" panose="020B0604020202020204" pitchFamily="34" charset="0"/>
                    </a:rPr>
                    <a:t>30000</a:t>
                  </a:r>
                  <a:endParaRPr kumimoji="0" lang="en-US" altLang="hu-HU" sz="14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</a:endParaRPr>
                </a:p>
              </p:txBody>
            </p:sp>
            <p:sp>
              <p:nvSpPr>
                <p:cNvPr id="73" name="Rectangle 126">
                  <a:extLst>
                    <a:ext uri="{FF2B5EF4-FFF2-40B4-BE49-F238E27FC236}">
                      <a16:creationId xmlns:a16="http://schemas.microsoft.com/office/drawing/2014/main" id="{94D09E86-FA2E-4F06-EAC5-C17B9ED53B6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553013" y="4861534"/>
                  <a:ext cx="345305" cy="1972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solidFill>
                        <a:srgbClr val="4D4D4D"/>
                      </a:solidFill>
                      <a:effectLst/>
                      <a:latin typeface="Helvetica" panose="020B0604020202020204" pitchFamily="34" charset="0"/>
                    </a:rPr>
                    <a:t>40000</a:t>
                  </a:r>
                  <a:endParaRPr kumimoji="0" lang="en-US" altLang="hu-HU" sz="14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</a:endParaRPr>
                </a:p>
              </p:txBody>
            </p:sp>
            <p:sp>
              <p:nvSpPr>
                <p:cNvPr id="74" name="Rectangle 129">
                  <a:extLst>
                    <a:ext uri="{FF2B5EF4-FFF2-40B4-BE49-F238E27FC236}">
                      <a16:creationId xmlns:a16="http://schemas.microsoft.com/office/drawing/2014/main" id="{6DBAD87D-4BB4-E1F4-8CA4-DC01551C31E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962650" y="1333500"/>
                  <a:ext cx="3378195" cy="34527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14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Helvetica" panose="020B0604020202020204" pitchFamily="34" charset="0"/>
                    </a:rPr>
                    <a:t>Survived</a:t>
                  </a:r>
                  <a:endParaRPr kumimoji="0" lang="en-US" altLang="hu-HU" sz="11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</a:endParaRPr>
                </a:p>
              </p:txBody>
            </p:sp>
          </p:grpSp>
          <p:sp>
            <p:nvSpPr>
              <p:cNvPr id="75" name="Szövegdoboz 74">
                <a:extLst>
                  <a:ext uri="{FF2B5EF4-FFF2-40B4-BE49-F238E27FC236}">
                    <a16:creationId xmlns:a16="http://schemas.microsoft.com/office/drawing/2014/main" id="{B24E7C1A-292A-65D9-451F-1C4D2F6471E7}"/>
                  </a:ext>
                </a:extLst>
              </p:cNvPr>
              <p:cNvSpPr txBox="1"/>
              <p:nvPr/>
            </p:nvSpPr>
            <p:spPr>
              <a:xfrm>
                <a:off x="2054110" y="5443311"/>
                <a:ext cx="3659836" cy="36962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oluble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D155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level in serum (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g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/ml)</a:t>
                </a:r>
              </a:p>
            </p:txBody>
          </p:sp>
          <p:cxnSp>
            <p:nvCxnSpPr>
              <p:cNvPr id="76" name="Egyenes összekötő nyíllal 75">
                <a:extLst>
                  <a:ext uri="{FF2B5EF4-FFF2-40B4-BE49-F238E27FC236}">
                    <a16:creationId xmlns:a16="http://schemas.microsoft.com/office/drawing/2014/main" id="{636E3575-42C0-86E8-18A2-BFD381DD3F8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250137" y="5605375"/>
                <a:ext cx="4221095" cy="5257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7" name="Szövegdoboz 76">
                <a:extLst>
                  <a:ext uri="{FF2B5EF4-FFF2-40B4-BE49-F238E27FC236}">
                    <a16:creationId xmlns:a16="http://schemas.microsoft.com/office/drawing/2014/main" id="{9F16E128-DA00-877D-07FF-FDCED30B3E97}"/>
                  </a:ext>
                </a:extLst>
              </p:cNvPr>
              <p:cNvSpPr txBox="1"/>
              <p:nvPr/>
            </p:nvSpPr>
            <p:spPr>
              <a:xfrm rot="16200000">
                <a:off x="-17071" y="3501022"/>
                <a:ext cx="3035349" cy="53566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D155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expression by non-classical monocytes (%)</a:t>
                </a:r>
              </a:p>
            </p:txBody>
          </p:sp>
        </p:grpSp>
        <p:sp>
          <p:nvSpPr>
            <p:cNvPr id="150" name="Szövegdoboz 149">
              <a:extLst>
                <a:ext uri="{FF2B5EF4-FFF2-40B4-BE49-F238E27FC236}">
                  <a16:creationId xmlns:a16="http://schemas.microsoft.com/office/drawing/2014/main" id="{8ED9E538-F0E6-8AFB-F406-BF251B9A365F}"/>
                </a:ext>
              </a:extLst>
            </p:cNvPr>
            <p:cNvSpPr txBox="1"/>
            <p:nvPr/>
          </p:nvSpPr>
          <p:spPr>
            <a:xfrm>
              <a:off x="-16935" y="66133"/>
              <a:ext cx="331167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3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041493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Csoportba foglalás 1">
            <a:extLst>
              <a:ext uri="{FF2B5EF4-FFF2-40B4-BE49-F238E27FC236}">
                <a16:creationId xmlns:a16="http://schemas.microsoft.com/office/drawing/2014/main" id="{56E1210A-C308-4441-920B-FE00AB4FFC6E}"/>
              </a:ext>
            </a:extLst>
          </p:cNvPr>
          <p:cNvGrpSpPr/>
          <p:nvPr/>
        </p:nvGrpSpPr>
        <p:grpSpPr>
          <a:xfrm>
            <a:off x="-16935" y="66133"/>
            <a:ext cx="9693648" cy="4145376"/>
            <a:chOff x="-16935" y="66133"/>
            <a:chExt cx="9693648" cy="4145376"/>
          </a:xfrm>
        </p:grpSpPr>
        <p:grpSp>
          <p:nvGrpSpPr>
            <p:cNvPr id="4" name="Csoportba foglalás 3">
              <a:extLst>
                <a:ext uri="{FF2B5EF4-FFF2-40B4-BE49-F238E27FC236}">
                  <a16:creationId xmlns:a16="http://schemas.microsoft.com/office/drawing/2014/main" id="{358F4A5B-211C-4A8D-DE30-998AE52DACB3}"/>
                </a:ext>
              </a:extLst>
            </p:cNvPr>
            <p:cNvGrpSpPr/>
            <p:nvPr/>
          </p:nvGrpSpPr>
          <p:grpSpPr>
            <a:xfrm>
              <a:off x="564178" y="979781"/>
              <a:ext cx="3280789" cy="3231728"/>
              <a:chOff x="4148711" y="3566763"/>
              <a:chExt cx="3280789" cy="3231728"/>
            </a:xfrm>
          </p:grpSpPr>
          <p:sp>
            <p:nvSpPr>
              <p:cNvPr id="5" name="Oval 738">
                <a:extLst>
                  <a:ext uri="{FF2B5EF4-FFF2-40B4-BE49-F238E27FC236}">
                    <a16:creationId xmlns:a16="http://schemas.microsoft.com/office/drawing/2014/main" id="{E4DAA042-021D-0B6E-5D40-FE000760AD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19650" y="5899150"/>
                <a:ext cx="28575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6" name="Oval 739">
                <a:extLst>
                  <a:ext uri="{FF2B5EF4-FFF2-40B4-BE49-F238E27FC236}">
                    <a16:creationId xmlns:a16="http://schemas.microsoft.com/office/drawing/2014/main" id="{5190CA98-1BF6-763C-087B-E6CEECD81D9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19650" y="5192713"/>
                <a:ext cx="28575" cy="28575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7" name="Oval 740">
                <a:extLst>
                  <a:ext uri="{FF2B5EF4-FFF2-40B4-BE49-F238E27FC236}">
                    <a16:creationId xmlns:a16="http://schemas.microsoft.com/office/drawing/2014/main" id="{7F1755C6-3A0A-E44A-0EA8-AFEBFAD04E0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3150" y="5537200"/>
                <a:ext cx="26987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8" name="Oval 741">
                <a:extLst>
                  <a:ext uri="{FF2B5EF4-FFF2-40B4-BE49-F238E27FC236}">
                    <a16:creationId xmlns:a16="http://schemas.microsoft.com/office/drawing/2014/main" id="{BA154538-3786-8749-CE57-FD32671D13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19650" y="4470400"/>
                <a:ext cx="28575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9" name="Oval 742">
                <a:extLst>
                  <a:ext uri="{FF2B5EF4-FFF2-40B4-BE49-F238E27FC236}">
                    <a16:creationId xmlns:a16="http://schemas.microsoft.com/office/drawing/2014/main" id="{672C65D5-9C35-290A-FD6E-578FA4E449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3150" y="4868863"/>
                <a:ext cx="26987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0" name="Oval 743">
                <a:extLst>
                  <a:ext uri="{FF2B5EF4-FFF2-40B4-BE49-F238E27FC236}">
                    <a16:creationId xmlns:a16="http://schemas.microsoft.com/office/drawing/2014/main" id="{C7512F7F-B0AE-F256-D6A3-E35A9BAE82B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19650" y="5424488"/>
                <a:ext cx="28575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1" name="Oval 744">
                <a:extLst>
                  <a:ext uri="{FF2B5EF4-FFF2-40B4-BE49-F238E27FC236}">
                    <a16:creationId xmlns:a16="http://schemas.microsoft.com/office/drawing/2014/main" id="{6EC62CA2-379A-0805-31A6-BD0242242F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57738" y="5621338"/>
                <a:ext cx="26987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2" name="Oval 745">
                <a:extLst>
                  <a:ext uri="{FF2B5EF4-FFF2-40B4-BE49-F238E27FC236}">
                    <a16:creationId xmlns:a16="http://schemas.microsoft.com/office/drawing/2014/main" id="{DE0B2E30-A1CD-0C0B-81C4-EB4C3E1A96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3150" y="6162675"/>
                <a:ext cx="26987" cy="28575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3" name="Oval 746">
                <a:extLst>
                  <a:ext uri="{FF2B5EF4-FFF2-40B4-BE49-F238E27FC236}">
                    <a16:creationId xmlns:a16="http://schemas.microsoft.com/office/drawing/2014/main" id="{E9F31005-599D-4F0D-9EF4-638BAF1B05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19650" y="6138863"/>
                <a:ext cx="28575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4" name="Oval 747">
                <a:extLst>
                  <a:ext uri="{FF2B5EF4-FFF2-40B4-BE49-F238E27FC236}">
                    <a16:creationId xmlns:a16="http://schemas.microsoft.com/office/drawing/2014/main" id="{996E1ACD-BB1B-3987-4246-420D9CBD6B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57738" y="6227763"/>
                <a:ext cx="26987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5" name="Oval 748">
                <a:extLst>
                  <a:ext uri="{FF2B5EF4-FFF2-40B4-BE49-F238E27FC236}">
                    <a16:creationId xmlns:a16="http://schemas.microsoft.com/office/drawing/2014/main" id="{E8DFE6F1-6EBB-8AD6-3522-E87062EC96C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57738" y="4886325"/>
                <a:ext cx="26987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6" name="Oval 749">
                <a:extLst>
                  <a:ext uri="{FF2B5EF4-FFF2-40B4-BE49-F238E27FC236}">
                    <a16:creationId xmlns:a16="http://schemas.microsoft.com/office/drawing/2014/main" id="{0DFF2DE6-11D2-B999-D4C8-1E9C9B2743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94238" y="5387975"/>
                <a:ext cx="28575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7" name="Oval 750">
                <a:extLst>
                  <a:ext uri="{FF2B5EF4-FFF2-40B4-BE49-F238E27FC236}">
                    <a16:creationId xmlns:a16="http://schemas.microsoft.com/office/drawing/2014/main" id="{7F2B58B7-5EF8-E44C-0281-44A15D03E6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46650" y="5459413"/>
                <a:ext cx="26987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8" name="Oval 751">
                <a:extLst>
                  <a:ext uri="{FF2B5EF4-FFF2-40B4-BE49-F238E27FC236}">
                    <a16:creationId xmlns:a16="http://schemas.microsoft.com/office/drawing/2014/main" id="{AE595175-7C88-639A-FACE-89E045CC3B6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19650" y="4605338"/>
                <a:ext cx="28575" cy="28575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9" name="Freeform 752">
                <a:extLst>
                  <a:ext uri="{FF2B5EF4-FFF2-40B4-BE49-F238E27FC236}">
                    <a16:creationId xmlns:a16="http://schemas.microsoft.com/office/drawing/2014/main" id="{6FFAEF9E-BE04-C5C9-E6B2-039765D7469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645025" y="4900613"/>
                <a:ext cx="377825" cy="1011237"/>
              </a:xfrm>
              <a:custGeom>
                <a:avLst/>
                <a:gdLst>
                  <a:gd name="T0" fmla="*/ 0 w 238"/>
                  <a:gd name="T1" fmla="*/ 637 h 637"/>
                  <a:gd name="T2" fmla="*/ 238 w 238"/>
                  <a:gd name="T3" fmla="*/ 637 h 637"/>
                  <a:gd name="T4" fmla="*/ 238 w 238"/>
                  <a:gd name="T5" fmla="*/ 637 h 637"/>
                  <a:gd name="T6" fmla="*/ 238 w 238"/>
                  <a:gd name="T7" fmla="*/ 350 h 637"/>
                  <a:gd name="T8" fmla="*/ 238 w 238"/>
                  <a:gd name="T9" fmla="*/ 0 h 637"/>
                  <a:gd name="T10" fmla="*/ 238 w 238"/>
                  <a:gd name="T11" fmla="*/ 0 h 637"/>
                  <a:gd name="T12" fmla="*/ 0 w 238"/>
                  <a:gd name="T13" fmla="*/ 0 h 637"/>
                  <a:gd name="T14" fmla="*/ 0 w 238"/>
                  <a:gd name="T15" fmla="*/ 0 h 637"/>
                  <a:gd name="T16" fmla="*/ 0 w 238"/>
                  <a:gd name="T17" fmla="*/ 350 h 637"/>
                  <a:gd name="T18" fmla="*/ 0 w 238"/>
                  <a:gd name="T19" fmla="*/ 637 h 6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238" h="637">
                    <a:moveTo>
                      <a:pt x="0" y="637"/>
                    </a:moveTo>
                    <a:lnTo>
                      <a:pt x="238" y="637"/>
                    </a:lnTo>
                    <a:lnTo>
                      <a:pt x="238" y="637"/>
                    </a:lnTo>
                    <a:lnTo>
                      <a:pt x="238" y="350"/>
                    </a:lnTo>
                    <a:lnTo>
                      <a:pt x="238" y="0"/>
                    </a:lnTo>
                    <a:lnTo>
                      <a:pt x="238" y="0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0" y="350"/>
                    </a:lnTo>
                    <a:lnTo>
                      <a:pt x="0" y="637"/>
                    </a:lnTo>
                  </a:path>
                </a:pathLst>
              </a:cu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0" name="Line 753">
                <a:extLst>
                  <a:ext uri="{FF2B5EF4-FFF2-40B4-BE49-F238E27FC236}">
                    <a16:creationId xmlns:a16="http://schemas.microsoft.com/office/drawing/2014/main" id="{60C102C5-5C0E-BB32-4631-57E8A332B2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645025" y="5911850"/>
                <a:ext cx="0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1" name="Line 754">
                <a:extLst>
                  <a:ext uri="{FF2B5EF4-FFF2-40B4-BE49-F238E27FC236}">
                    <a16:creationId xmlns:a16="http://schemas.microsoft.com/office/drawing/2014/main" id="{7A06CC59-B65E-D450-8021-516596FB36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645025" y="5456238"/>
                <a:ext cx="377825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2" name="Line 755">
                <a:extLst>
                  <a:ext uri="{FF2B5EF4-FFF2-40B4-BE49-F238E27FC236}">
                    <a16:creationId xmlns:a16="http://schemas.microsoft.com/office/drawing/2014/main" id="{C2176FEC-3876-9F4F-4E9A-62C6F7D763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33938" y="4900613"/>
                <a:ext cx="0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3" name="Line 756">
                <a:extLst>
                  <a:ext uri="{FF2B5EF4-FFF2-40B4-BE49-F238E27FC236}">
                    <a16:creationId xmlns:a16="http://schemas.microsoft.com/office/drawing/2014/main" id="{701B173F-08FE-67D4-BF9D-C2D8A7731F9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33938" y="5911850"/>
                <a:ext cx="0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4" name="Line 757">
                <a:extLst>
                  <a:ext uri="{FF2B5EF4-FFF2-40B4-BE49-F238E27FC236}">
                    <a16:creationId xmlns:a16="http://schemas.microsoft.com/office/drawing/2014/main" id="{02D292DA-440B-BB90-8C5C-0B0D3AF0C2D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833938" y="4483100"/>
                <a:ext cx="0" cy="417512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5" name="Line 758">
                <a:extLst>
                  <a:ext uri="{FF2B5EF4-FFF2-40B4-BE49-F238E27FC236}">
                    <a16:creationId xmlns:a16="http://schemas.microsoft.com/office/drawing/2014/main" id="{FDD73F83-D8A5-AB75-73A4-B57F1C43DE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33938" y="5911850"/>
                <a:ext cx="0" cy="328612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6" name="Line 759">
                <a:extLst>
                  <a:ext uri="{FF2B5EF4-FFF2-40B4-BE49-F238E27FC236}">
                    <a16:creationId xmlns:a16="http://schemas.microsoft.com/office/drawing/2014/main" id="{F76DDBE5-7314-6D03-2D66-B645699F4A5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810125" y="4483100"/>
                <a:ext cx="47625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7" name="Line 760">
                <a:extLst>
                  <a:ext uri="{FF2B5EF4-FFF2-40B4-BE49-F238E27FC236}">
                    <a16:creationId xmlns:a16="http://schemas.microsoft.com/office/drawing/2014/main" id="{48FA0BD6-E524-5266-0DA7-A6216C5419E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810125" y="6240463"/>
                <a:ext cx="47625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8" name="Rectangle 761">
                <a:extLst>
                  <a:ext uri="{FF2B5EF4-FFF2-40B4-BE49-F238E27FC236}">
                    <a16:creationId xmlns:a16="http://schemas.microsoft.com/office/drawing/2014/main" id="{873FD860-43ED-240F-DF2A-2FF98334CE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22825" y="5421313"/>
                <a:ext cx="23812" cy="23812"/>
              </a:xfrm>
              <a:prstGeom prst="rect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9" name="Oval 765">
                <a:extLst>
                  <a:ext uri="{FF2B5EF4-FFF2-40B4-BE49-F238E27FC236}">
                    <a16:creationId xmlns:a16="http://schemas.microsoft.com/office/drawing/2014/main" id="{69E81D8C-8E5F-88D8-C5D1-4791EF9A309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01285" y="5037138"/>
                <a:ext cx="26987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30" name="Freeform 776">
                <a:extLst>
                  <a:ext uri="{FF2B5EF4-FFF2-40B4-BE49-F238E27FC236}">
                    <a16:creationId xmlns:a16="http://schemas.microsoft.com/office/drawing/2014/main" id="{333B0390-7B3A-1DD6-8F9C-1D843BD23BB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026660" y="5870575"/>
                <a:ext cx="376237" cy="368300"/>
              </a:xfrm>
              <a:custGeom>
                <a:avLst/>
                <a:gdLst>
                  <a:gd name="T0" fmla="*/ 0 w 237"/>
                  <a:gd name="T1" fmla="*/ 232 h 232"/>
                  <a:gd name="T2" fmla="*/ 237 w 237"/>
                  <a:gd name="T3" fmla="*/ 232 h 232"/>
                  <a:gd name="T4" fmla="*/ 237 w 237"/>
                  <a:gd name="T5" fmla="*/ 232 h 232"/>
                  <a:gd name="T6" fmla="*/ 237 w 237"/>
                  <a:gd name="T7" fmla="*/ 136 h 232"/>
                  <a:gd name="T8" fmla="*/ 237 w 237"/>
                  <a:gd name="T9" fmla="*/ 0 h 232"/>
                  <a:gd name="T10" fmla="*/ 237 w 237"/>
                  <a:gd name="T11" fmla="*/ 0 h 232"/>
                  <a:gd name="T12" fmla="*/ 0 w 237"/>
                  <a:gd name="T13" fmla="*/ 0 h 232"/>
                  <a:gd name="T14" fmla="*/ 0 w 237"/>
                  <a:gd name="T15" fmla="*/ 0 h 232"/>
                  <a:gd name="T16" fmla="*/ 0 w 237"/>
                  <a:gd name="T17" fmla="*/ 136 h 232"/>
                  <a:gd name="T18" fmla="*/ 0 w 237"/>
                  <a:gd name="T19" fmla="*/ 232 h 2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237" h="232">
                    <a:moveTo>
                      <a:pt x="0" y="232"/>
                    </a:moveTo>
                    <a:lnTo>
                      <a:pt x="237" y="232"/>
                    </a:lnTo>
                    <a:lnTo>
                      <a:pt x="237" y="232"/>
                    </a:lnTo>
                    <a:lnTo>
                      <a:pt x="237" y="136"/>
                    </a:lnTo>
                    <a:lnTo>
                      <a:pt x="237" y="0"/>
                    </a:lnTo>
                    <a:lnTo>
                      <a:pt x="237" y="0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0" y="136"/>
                    </a:lnTo>
                    <a:lnTo>
                      <a:pt x="0" y="232"/>
                    </a:lnTo>
                  </a:path>
                </a:pathLst>
              </a:custGeom>
              <a:pattFill prst="pct25">
                <a:fgClr>
                  <a:schemeClr val="tx1"/>
                </a:fgClr>
                <a:bgClr>
                  <a:schemeClr val="bg1"/>
                </a:bgClr>
              </a:pattFill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31" name="Rectangle 896">
                <a:extLst>
                  <a:ext uri="{FF2B5EF4-FFF2-40B4-BE49-F238E27FC236}">
                    <a16:creationId xmlns:a16="http://schemas.microsoft.com/office/drawing/2014/main" id="{4C76B4B5-FAA1-21F4-5BD3-8A7FE9C49D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70400" y="6300788"/>
                <a:ext cx="5770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hu-HU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en-US" altLang="hu-HU" sz="2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" name="Rectangle 897">
                <a:extLst>
                  <a:ext uri="{FF2B5EF4-FFF2-40B4-BE49-F238E27FC236}">
                    <a16:creationId xmlns:a16="http://schemas.microsoft.com/office/drawing/2014/main" id="{4AD2FE07-5DD6-8279-F906-23047762014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19600" y="5886450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hu-HU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</a:t>
                </a:r>
                <a:endParaRPr kumimoji="0" lang="en-US" altLang="hu-HU" sz="2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3" name="Rectangle 898">
                <a:extLst>
                  <a:ext uri="{FF2B5EF4-FFF2-40B4-BE49-F238E27FC236}">
                    <a16:creationId xmlns:a16="http://schemas.microsoft.com/office/drawing/2014/main" id="{23E721F2-81A1-F404-8EB4-C64AE3BC6B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19600" y="5470525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hu-HU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0</a:t>
                </a:r>
                <a:endParaRPr kumimoji="0" lang="en-US" altLang="hu-HU" sz="2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4" name="Rectangle 899">
                <a:extLst>
                  <a:ext uri="{FF2B5EF4-FFF2-40B4-BE49-F238E27FC236}">
                    <a16:creationId xmlns:a16="http://schemas.microsoft.com/office/drawing/2014/main" id="{72B6BA64-4E7D-B7EC-195F-35CA7118E4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19600" y="5056188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hu-HU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0</a:t>
                </a:r>
                <a:endParaRPr kumimoji="0" lang="en-US" altLang="hu-HU" sz="2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5" name="Rectangle 900">
                <a:extLst>
                  <a:ext uri="{FF2B5EF4-FFF2-40B4-BE49-F238E27FC236}">
                    <a16:creationId xmlns:a16="http://schemas.microsoft.com/office/drawing/2014/main" id="{9F11EDD2-1C7F-A82B-123E-74EDE6A3012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19600" y="4640263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hu-HU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0</a:t>
                </a:r>
                <a:endParaRPr kumimoji="0" lang="en-US" altLang="hu-HU" sz="2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6" name="Rectangle 901">
                <a:extLst>
                  <a:ext uri="{FF2B5EF4-FFF2-40B4-BE49-F238E27FC236}">
                    <a16:creationId xmlns:a16="http://schemas.microsoft.com/office/drawing/2014/main" id="{430B6DDE-C560-A96C-B605-E666A97C31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68800" y="4224338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hu-HU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0</a:t>
                </a:r>
                <a:endParaRPr kumimoji="0" lang="en-US" altLang="hu-HU" sz="2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7" name="Line 902">
                <a:extLst>
                  <a:ext uri="{FF2B5EF4-FFF2-40B4-BE49-F238E27FC236}">
                    <a16:creationId xmlns:a16="http://schemas.microsoft.com/office/drawing/2014/main" id="{0443DC85-5859-5AC1-A2DF-11A00027043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33938" y="6361113"/>
                <a:ext cx="0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38" name="Line 908">
                <a:extLst>
                  <a:ext uri="{FF2B5EF4-FFF2-40B4-BE49-F238E27FC236}">
                    <a16:creationId xmlns:a16="http://schemas.microsoft.com/office/drawing/2014/main" id="{0CA80D78-9910-5C77-6D46-3F491719DEE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98988" y="6361113"/>
                <a:ext cx="2830512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39" name="Line 909">
                <a:extLst>
                  <a:ext uri="{FF2B5EF4-FFF2-40B4-BE49-F238E27FC236}">
                    <a16:creationId xmlns:a16="http://schemas.microsoft.com/office/drawing/2014/main" id="{D565D5A5-75D1-BF1A-EC2A-562E42E0525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56125" y="6361113"/>
                <a:ext cx="42862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40" name="Line 910">
                <a:extLst>
                  <a:ext uri="{FF2B5EF4-FFF2-40B4-BE49-F238E27FC236}">
                    <a16:creationId xmlns:a16="http://schemas.microsoft.com/office/drawing/2014/main" id="{1D8C9407-C909-9672-C251-74C98D3191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56125" y="5945188"/>
                <a:ext cx="42862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41" name="Line 911">
                <a:extLst>
                  <a:ext uri="{FF2B5EF4-FFF2-40B4-BE49-F238E27FC236}">
                    <a16:creationId xmlns:a16="http://schemas.microsoft.com/office/drawing/2014/main" id="{C85374BA-AB87-05DA-A7FC-FCFAE9B629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56125" y="5530850"/>
                <a:ext cx="42862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42" name="Line 912">
                <a:extLst>
                  <a:ext uri="{FF2B5EF4-FFF2-40B4-BE49-F238E27FC236}">
                    <a16:creationId xmlns:a16="http://schemas.microsoft.com/office/drawing/2014/main" id="{E09DD22F-A7C1-DAA0-D46C-099AA4B13C5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56125" y="5114925"/>
                <a:ext cx="42862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43" name="Line 913">
                <a:extLst>
                  <a:ext uri="{FF2B5EF4-FFF2-40B4-BE49-F238E27FC236}">
                    <a16:creationId xmlns:a16="http://schemas.microsoft.com/office/drawing/2014/main" id="{D6AEB38A-F0E2-9D1B-2FA4-6F515677DE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56125" y="4699000"/>
                <a:ext cx="42862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44" name="Line 914">
                <a:extLst>
                  <a:ext uri="{FF2B5EF4-FFF2-40B4-BE49-F238E27FC236}">
                    <a16:creationId xmlns:a16="http://schemas.microsoft.com/office/drawing/2014/main" id="{241B0DFB-0F8E-FEDA-33FB-5D3BBA9D85C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56125" y="4284663"/>
                <a:ext cx="42862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45" name="Line 915">
                <a:extLst>
                  <a:ext uri="{FF2B5EF4-FFF2-40B4-BE49-F238E27FC236}">
                    <a16:creationId xmlns:a16="http://schemas.microsoft.com/office/drawing/2014/main" id="{E4AF3974-8969-3AB0-708C-C3DEA742A53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598988" y="4284663"/>
                <a:ext cx="0" cy="207645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46" name="Rectangle 916">
                <a:extLst>
                  <a:ext uri="{FF2B5EF4-FFF2-40B4-BE49-F238E27FC236}">
                    <a16:creationId xmlns:a16="http://schemas.microsoft.com/office/drawing/2014/main" id="{902B0A86-BE48-0196-E10D-2AFF488EB9E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3069163" y="5214618"/>
                <a:ext cx="232837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hu-HU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D69</a:t>
                </a:r>
                <a:r>
                  <a:rPr kumimoji="0" lang="en-US" altLang="hu-HU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expression by NKdim cells (%)</a:t>
                </a:r>
                <a:endParaRPr kumimoji="0" lang="en-US" altLang="hu-HU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7" name="Oval 762">
                <a:extLst>
                  <a:ext uri="{FF2B5EF4-FFF2-40B4-BE49-F238E27FC236}">
                    <a16:creationId xmlns:a16="http://schemas.microsoft.com/office/drawing/2014/main" id="{EC0C48A0-5306-384A-DE0C-5B1068902E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37798" y="6262688"/>
                <a:ext cx="28575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48" name="Oval 763">
                <a:extLst>
                  <a:ext uri="{FF2B5EF4-FFF2-40B4-BE49-F238E27FC236}">
                    <a16:creationId xmlns:a16="http://schemas.microsoft.com/office/drawing/2014/main" id="{2B10D1F4-6DFA-C02B-44E5-C3DD456C4E1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01285" y="5973763"/>
                <a:ext cx="26987" cy="28575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49" name="Oval 764">
                <a:extLst>
                  <a:ext uri="{FF2B5EF4-FFF2-40B4-BE49-F238E27FC236}">
                    <a16:creationId xmlns:a16="http://schemas.microsoft.com/office/drawing/2014/main" id="{37FA0C35-8898-E101-DA3E-81F5E6164C4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25085" y="6119813"/>
                <a:ext cx="28575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50" name="Oval 766">
                <a:extLst>
                  <a:ext uri="{FF2B5EF4-FFF2-40B4-BE49-F238E27FC236}">
                    <a16:creationId xmlns:a16="http://schemas.microsoft.com/office/drawing/2014/main" id="{D9DA5CB9-D32F-FBE5-DE6E-38C8DA6B8A6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37798" y="5653088"/>
                <a:ext cx="28575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51" name="Oval 767">
                <a:extLst>
                  <a:ext uri="{FF2B5EF4-FFF2-40B4-BE49-F238E27FC236}">
                    <a16:creationId xmlns:a16="http://schemas.microsoft.com/office/drawing/2014/main" id="{A3693175-C5F4-6EAB-B0EC-2613066F43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37798" y="5856288"/>
                <a:ext cx="28575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52" name="Oval 768">
                <a:extLst>
                  <a:ext uri="{FF2B5EF4-FFF2-40B4-BE49-F238E27FC236}">
                    <a16:creationId xmlns:a16="http://schemas.microsoft.com/office/drawing/2014/main" id="{FCB0710C-255C-A5B4-95E0-7A16875747E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75898" y="6081713"/>
                <a:ext cx="26987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53" name="Oval 769">
                <a:extLst>
                  <a:ext uri="{FF2B5EF4-FFF2-40B4-BE49-F238E27FC236}">
                    <a16:creationId xmlns:a16="http://schemas.microsoft.com/office/drawing/2014/main" id="{350E6B34-B033-54B8-FE63-C1294D107B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63185" y="6224588"/>
                <a:ext cx="26987" cy="28575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54" name="Oval 770">
                <a:extLst>
                  <a:ext uri="{FF2B5EF4-FFF2-40B4-BE49-F238E27FC236}">
                    <a16:creationId xmlns:a16="http://schemas.microsoft.com/office/drawing/2014/main" id="{08CE27B0-5BAA-8E63-7FBB-114A46CCA36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13998" y="6264275"/>
                <a:ext cx="26987" cy="28575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55" name="Oval 771">
                <a:extLst>
                  <a:ext uri="{FF2B5EF4-FFF2-40B4-BE49-F238E27FC236}">
                    <a16:creationId xmlns:a16="http://schemas.microsoft.com/office/drawing/2014/main" id="{A6F875AD-C78F-B250-DD76-71C7C72232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86985" y="6311900"/>
                <a:ext cx="28575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56" name="Oval 772">
                <a:extLst>
                  <a:ext uri="{FF2B5EF4-FFF2-40B4-BE49-F238E27FC236}">
                    <a16:creationId xmlns:a16="http://schemas.microsoft.com/office/drawing/2014/main" id="{8446E777-0643-E0DE-CEC7-F581C6FF5F3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50473" y="6115050"/>
                <a:ext cx="26987" cy="28575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57" name="Oval 773">
                <a:extLst>
                  <a:ext uri="{FF2B5EF4-FFF2-40B4-BE49-F238E27FC236}">
                    <a16:creationId xmlns:a16="http://schemas.microsoft.com/office/drawing/2014/main" id="{273A7240-91A7-84CB-CECC-D054D1088C7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63185" y="5878513"/>
                <a:ext cx="26987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58" name="Oval 774">
                <a:extLst>
                  <a:ext uri="{FF2B5EF4-FFF2-40B4-BE49-F238E27FC236}">
                    <a16:creationId xmlns:a16="http://schemas.microsoft.com/office/drawing/2014/main" id="{D6585E63-E8F1-9FCE-66F1-876D239439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52098" y="6065838"/>
                <a:ext cx="26987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59" name="Oval 775">
                <a:extLst>
                  <a:ext uri="{FF2B5EF4-FFF2-40B4-BE49-F238E27FC236}">
                    <a16:creationId xmlns:a16="http://schemas.microsoft.com/office/drawing/2014/main" id="{1A0415D0-94D4-C1FC-CAEB-AA66C4A307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63185" y="5614988"/>
                <a:ext cx="26987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60" name="Line 777">
                <a:extLst>
                  <a:ext uri="{FF2B5EF4-FFF2-40B4-BE49-F238E27FC236}">
                    <a16:creationId xmlns:a16="http://schemas.microsoft.com/office/drawing/2014/main" id="{B3F199BA-642A-9BBE-B170-58F8C8B15A8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026660" y="6238875"/>
                <a:ext cx="0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61" name="Line 778">
                <a:extLst>
                  <a:ext uri="{FF2B5EF4-FFF2-40B4-BE49-F238E27FC236}">
                    <a16:creationId xmlns:a16="http://schemas.microsoft.com/office/drawing/2014/main" id="{28F29115-BC86-B4CE-3245-F71CBDF57D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026660" y="6086475"/>
                <a:ext cx="376237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62" name="Line 779">
                <a:extLst>
                  <a:ext uri="{FF2B5EF4-FFF2-40B4-BE49-F238E27FC236}">
                    <a16:creationId xmlns:a16="http://schemas.microsoft.com/office/drawing/2014/main" id="{84002189-E0AE-E497-0981-0B5BAC228C2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15573" y="5870575"/>
                <a:ext cx="0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63" name="Line 780">
                <a:extLst>
                  <a:ext uri="{FF2B5EF4-FFF2-40B4-BE49-F238E27FC236}">
                    <a16:creationId xmlns:a16="http://schemas.microsoft.com/office/drawing/2014/main" id="{100F8948-1A64-0D4E-7BA9-0C4C5986F2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15573" y="6238875"/>
                <a:ext cx="0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64" name="Line 781">
                <a:extLst>
                  <a:ext uri="{FF2B5EF4-FFF2-40B4-BE49-F238E27FC236}">
                    <a16:creationId xmlns:a16="http://schemas.microsoft.com/office/drawing/2014/main" id="{A66E9BB9-3DE0-7B88-BE24-B7D86A3E676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15573" y="5627688"/>
                <a:ext cx="0" cy="242887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65" name="Line 782">
                <a:extLst>
                  <a:ext uri="{FF2B5EF4-FFF2-40B4-BE49-F238E27FC236}">
                    <a16:creationId xmlns:a16="http://schemas.microsoft.com/office/drawing/2014/main" id="{CE5449E8-A347-0E93-38B3-7592662B480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15573" y="6238875"/>
                <a:ext cx="0" cy="87312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66" name="Line 783">
                <a:extLst>
                  <a:ext uri="{FF2B5EF4-FFF2-40B4-BE49-F238E27FC236}">
                    <a16:creationId xmlns:a16="http://schemas.microsoft.com/office/drawing/2014/main" id="{44A66D71-9F77-293C-32FE-FAB897310A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191760" y="5627688"/>
                <a:ext cx="46037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67" name="Line 784">
                <a:extLst>
                  <a:ext uri="{FF2B5EF4-FFF2-40B4-BE49-F238E27FC236}">
                    <a16:creationId xmlns:a16="http://schemas.microsoft.com/office/drawing/2014/main" id="{CBF1B26E-6143-B4D8-4838-617E74127ED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191760" y="6326188"/>
                <a:ext cx="46037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68" name="Rectangle 785">
                <a:extLst>
                  <a:ext uri="{FF2B5EF4-FFF2-40B4-BE49-F238E27FC236}">
                    <a16:creationId xmlns:a16="http://schemas.microsoft.com/office/drawing/2014/main" id="{A8B0D9FB-4CA1-A81E-8398-3F4B03ABD0C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02873" y="5962650"/>
                <a:ext cx="23812" cy="23812"/>
              </a:xfrm>
              <a:prstGeom prst="rect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69" name="Line 804">
                <a:extLst>
                  <a:ext uri="{FF2B5EF4-FFF2-40B4-BE49-F238E27FC236}">
                    <a16:creationId xmlns:a16="http://schemas.microsoft.com/office/drawing/2014/main" id="{D1C33532-DAFF-AD2E-6FE9-2A37B3F963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98148" y="5102225"/>
                <a:ext cx="0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70" name="Line 903">
                <a:extLst>
                  <a:ext uri="{FF2B5EF4-FFF2-40B4-BE49-F238E27FC236}">
                    <a16:creationId xmlns:a16="http://schemas.microsoft.com/office/drawing/2014/main" id="{6D3C1650-D59C-BCD6-3505-160573027B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15573" y="6361113"/>
                <a:ext cx="0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71" name="Szövegdoboz 70">
                <a:extLst>
                  <a:ext uri="{FF2B5EF4-FFF2-40B4-BE49-F238E27FC236}">
                    <a16:creationId xmlns:a16="http://schemas.microsoft.com/office/drawing/2014/main" id="{2DF2F3AA-51DA-0D9B-DB41-81E9C9667D7F}"/>
                  </a:ext>
                </a:extLst>
              </p:cNvPr>
              <p:cNvSpPr txBox="1"/>
              <p:nvPr/>
            </p:nvSpPr>
            <p:spPr>
              <a:xfrm>
                <a:off x="4521184" y="6360687"/>
                <a:ext cx="1027484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Healthy control</a:t>
                </a:r>
                <a:r>
                  <a:rPr lang="hu-HU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Szövegdoboz 71">
                <a:extLst>
                  <a:ext uri="{FF2B5EF4-FFF2-40B4-BE49-F238E27FC236}">
                    <a16:creationId xmlns:a16="http://schemas.microsoft.com/office/drawing/2014/main" id="{569996E7-26E3-EFC2-14E3-114EB2C665BD}"/>
                  </a:ext>
                </a:extLst>
              </p:cNvPr>
              <p:cNvSpPr txBox="1"/>
              <p:nvPr/>
            </p:nvSpPr>
            <p:spPr>
              <a:xfrm>
                <a:off x="6379558" y="6355414"/>
                <a:ext cx="1027484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hu-HU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evere</a:t>
                </a:r>
                <a:endParaRPr lang="hu-HU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hu-HU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OVID-19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Line 175">
                <a:extLst>
                  <a:ext uri="{FF2B5EF4-FFF2-40B4-BE49-F238E27FC236}">
                    <a16:creationId xmlns:a16="http://schemas.microsoft.com/office/drawing/2014/main" id="{FA2DE6DB-C050-4D6D-D039-9F99A811609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22504" y="4357314"/>
                <a:ext cx="382275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74" name="Szövegdoboz 73">
                <a:extLst>
                  <a:ext uri="{FF2B5EF4-FFF2-40B4-BE49-F238E27FC236}">
                    <a16:creationId xmlns:a16="http://schemas.microsoft.com/office/drawing/2014/main" id="{9EF84C5F-2463-C694-79A7-1106E9D2070E}"/>
                  </a:ext>
                </a:extLst>
              </p:cNvPr>
              <p:cNvSpPr txBox="1"/>
              <p:nvPr/>
            </p:nvSpPr>
            <p:spPr>
              <a:xfrm>
                <a:off x="4765675" y="4160837"/>
                <a:ext cx="47783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*</a:t>
                </a:r>
              </a:p>
            </p:txBody>
          </p:sp>
          <p:grpSp>
            <p:nvGrpSpPr>
              <p:cNvPr id="75" name="Csoportba foglalás 74">
                <a:extLst>
                  <a:ext uri="{FF2B5EF4-FFF2-40B4-BE49-F238E27FC236}">
                    <a16:creationId xmlns:a16="http://schemas.microsoft.com/office/drawing/2014/main" id="{632EB033-4CAA-BCF4-C442-FBD8B3D69BD7}"/>
                  </a:ext>
                </a:extLst>
              </p:cNvPr>
              <p:cNvGrpSpPr/>
              <p:nvPr/>
            </p:nvGrpSpPr>
            <p:grpSpPr>
              <a:xfrm>
                <a:off x="6521451" y="4129293"/>
                <a:ext cx="754072" cy="2244519"/>
                <a:chOff x="5589588" y="4129293"/>
                <a:chExt cx="754072" cy="2244519"/>
              </a:xfrm>
            </p:grpSpPr>
            <p:sp>
              <p:nvSpPr>
                <p:cNvPr id="144" name="Oval 787">
                  <a:extLst>
                    <a:ext uri="{FF2B5EF4-FFF2-40B4-BE49-F238E27FC236}">
                      <a16:creationId xmlns:a16="http://schemas.microsoft.com/office/drawing/2014/main" id="{DA744978-8D89-814D-1823-8CF1FAF6252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764213" y="4738688"/>
                  <a:ext cx="26987" cy="28575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45" name="Oval 788">
                  <a:extLst>
                    <a:ext uri="{FF2B5EF4-FFF2-40B4-BE49-F238E27FC236}">
                      <a16:creationId xmlns:a16="http://schemas.microsoft.com/office/drawing/2014/main" id="{32BFD796-50F5-3B9B-F385-2B7155A770F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764213" y="5003800"/>
                  <a:ext cx="26987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46" name="Oval 789">
                  <a:extLst>
                    <a:ext uri="{FF2B5EF4-FFF2-40B4-BE49-F238E27FC236}">
                      <a16:creationId xmlns:a16="http://schemas.microsoft.com/office/drawing/2014/main" id="{F09221C3-801F-90C0-F40C-F5715220AF9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710238" y="4938713"/>
                  <a:ext cx="26987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47" name="Oval 790">
                  <a:extLst>
                    <a:ext uri="{FF2B5EF4-FFF2-40B4-BE49-F238E27FC236}">
                      <a16:creationId xmlns:a16="http://schemas.microsoft.com/office/drawing/2014/main" id="{C47C00BA-3664-630B-BFF2-B3349AAAC9C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791200" y="4654550"/>
                  <a:ext cx="26987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48" name="Oval 791">
                  <a:extLst>
                    <a:ext uri="{FF2B5EF4-FFF2-40B4-BE49-F238E27FC236}">
                      <a16:creationId xmlns:a16="http://schemas.microsoft.com/office/drawing/2014/main" id="{F6F4C9CC-C48B-A3BF-6B44-82029407BE9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791200" y="4362450"/>
                  <a:ext cx="26987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49" name="Oval 793">
                  <a:extLst>
                    <a:ext uri="{FF2B5EF4-FFF2-40B4-BE49-F238E27FC236}">
                      <a16:creationId xmlns:a16="http://schemas.microsoft.com/office/drawing/2014/main" id="{7587432B-CEE3-289A-EBCD-73B8FA60EE0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818188" y="4926013"/>
                  <a:ext cx="26987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50" name="Oval 794">
                  <a:extLst>
                    <a:ext uri="{FF2B5EF4-FFF2-40B4-BE49-F238E27FC236}">
                      <a16:creationId xmlns:a16="http://schemas.microsoft.com/office/drawing/2014/main" id="{ECBC81BD-00DC-C245-6551-749BBF125A9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710238" y="4724400"/>
                  <a:ext cx="26987" cy="28575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51" name="Oval 795">
                  <a:extLst>
                    <a:ext uri="{FF2B5EF4-FFF2-40B4-BE49-F238E27FC236}">
                      <a16:creationId xmlns:a16="http://schemas.microsoft.com/office/drawing/2014/main" id="{34C24F10-CD11-9A92-4C85-59E88F5D25D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656263" y="4930775"/>
                  <a:ext cx="26987" cy="28575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52" name="Oval 796">
                  <a:extLst>
                    <a:ext uri="{FF2B5EF4-FFF2-40B4-BE49-F238E27FC236}">
                      <a16:creationId xmlns:a16="http://schemas.microsoft.com/office/drawing/2014/main" id="{61FD7675-5BEF-BF8F-9B27-CD74EFFBC55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818188" y="4713288"/>
                  <a:ext cx="26987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53" name="Oval 797">
                  <a:extLst>
                    <a:ext uri="{FF2B5EF4-FFF2-40B4-BE49-F238E27FC236}">
                      <a16:creationId xmlns:a16="http://schemas.microsoft.com/office/drawing/2014/main" id="{40A5546C-F73C-9DBB-DCD1-8E1DABECA6A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872163" y="4926013"/>
                  <a:ext cx="26987" cy="28575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54" name="Oval 799">
                  <a:extLst>
                    <a:ext uri="{FF2B5EF4-FFF2-40B4-BE49-F238E27FC236}">
                      <a16:creationId xmlns:a16="http://schemas.microsoft.com/office/drawing/2014/main" id="{03D34D6E-C18A-0F87-694C-7D0D72B66A8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737225" y="4495800"/>
                  <a:ext cx="26987" cy="28575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55" name="Oval 800">
                  <a:extLst>
                    <a:ext uri="{FF2B5EF4-FFF2-40B4-BE49-F238E27FC236}">
                      <a16:creationId xmlns:a16="http://schemas.microsoft.com/office/drawing/2014/main" id="{5282DC51-FFF2-E21B-DBBC-764FC6B9990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926138" y="5087938"/>
                  <a:ext cx="26987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56" name="Oval 801">
                  <a:extLst>
                    <a:ext uri="{FF2B5EF4-FFF2-40B4-BE49-F238E27FC236}">
                      <a16:creationId xmlns:a16="http://schemas.microsoft.com/office/drawing/2014/main" id="{77E27052-EBD1-2090-BF61-0DC17D0136E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737225" y="4419600"/>
                  <a:ext cx="26987" cy="28575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57" name="Freeform 803">
                  <a:extLst>
                    <a:ext uri="{FF2B5EF4-FFF2-40B4-BE49-F238E27FC236}">
                      <a16:creationId xmlns:a16="http://schemas.microsoft.com/office/drawing/2014/main" id="{4D14D7AF-5200-783E-BEE7-03E8ED8071E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589588" y="4727575"/>
                  <a:ext cx="377825" cy="374650"/>
                </a:xfrm>
                <a:custGeom>
                  <a:avLst/>
                  <a:gdLst>
                    <a:gd name="T0" fmla="*/ 0 w 238"/>
                    <a:gd name="T1" fmla="*/ 236 h 236"/>
                    <a:gd name="T2" fmla="*/ 238 w 238"/>
                    <a:gd name="T3" fmla="*/ 236 h 236"/>
                    <a:gd name="T4" fmla="*/ 238 w 238"/>
                    <a:gd name="T5" fmla="*/ 236 h 236"/>
                    <a:gd name="T6" fmla="*/ 238 w 238"/>
                    <a:gd name="T7" fmla="*/ 134 h 236"/>
                    <a:gd name="T8" fmla="*/ 238 w 238"/>
                    <a:gd name="T9" fmla="*/ 0 h 236"/>
                    <a:gd name="T10" fmla="*/ 238 w 238"/>
                    <a:gd name="T11" fmla="*/ 0 h 236"/>
                    <a:gd name="T12" fmla="*/ 0 w 238"/>
                    <a:gd name="T13" fmla="*/ 0 h 236"/>
                    <a:gd name="T14" fmla="*/ 0 w 238"/>
                    <a:gd name="T15" fmla="*/ 0 h 236"/>
                    <a:gd name="T16" fmla="*/ 0 w 238"/>
                    <a:gd name="T17" fmla="*/ 134 h 236"/>
                    <a:gd name="T18" fmla="*/ 0 w 238"/>
                    <a:gd name="T19" fmla="*/ 236 h 2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238" h="236">
                      <a:moveTo>
                        <a:pt x="0" y="236"/>
                      </a:moveTo>
                      <a:lnTo>
                        <a:pt x="238" y="236"/>
                      </a:lnTo>
                      <a:lnTo>
                        <a:pt x="238" y="236"/>
                      </a:lnTo>
                      <a:lnTo>
                        <a:pt x="238" y="134"/>
                      </a:lnTo>
                      <a:lnTo>
                        <a:pt x="238" y="0"/>
                      </a:lnTo>
                      <a:lnTo>
                        <a:pt x="238" y="0"/>
                      </a:ln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0" y="134"/>
                      </a:lnTo>
                      <a:lnTo>
                        <a:pt x="0" y="236"/>
                      </a:lnTo>
                    </a:path>
                  </a:pathLst>
                </a:cu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58" name="Line 805">
                  <a:extLst>
                    <a:ext uri="{FF2B5EF4-FFF2-40B4-BE49-F238E27FC236}">
                      <a16:creationId xmlns:a16="http://schemas.microsoft.com/office/drawing/2014/main" id="{DAA6798E-394F-0A31-4521-155ABA6FC42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5589588" y="4940300"/>
                  <a:ext cx="377825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59" name="Line 806">
                  <a:extLst>
                    <a:ext uri="{FF2B5EF4-FFF2-40B4-BE49-F238E27FC236}">
                      <a16:creationId xmlns:a16="http://schemas.microsoft.com/office/drawing/2014/main" id="{0CC16210-CD34-F1BC-51DD-4574E885F15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778500" y="4727575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60" name="Line 808">
                  <a:extLst>
                    <a:ext uri="{FF2B5EF4-FFF2-40B4-BE49-F238E27FC236}">
                      <a16:creationId xmlns:a16="http://schemas.microsoft.com/office/drawing/2014/main" id="{6469ECF4-DC78-A986-BBC5-E7B7E430E2D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5778500" y="4376738"/>
                  <a:ext cx="0" cy="350837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61" name="Line 810">
                  <a:extLst>
                    <a:ext uri="{FF2B5EF4-FFF2-40B4-BE49-F238E27FC236}">
                      <a16:creationId xmlns:a16="http://schemas.microsoft.com/office/drawing/2014/main" id="{BF58B4A1-4D71-13AD-8092-DF269CC9FCA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5754688" y="4376738"/>
                  <a:ext cx="47625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62" name="Rectangle 812">
                  <a:extLst>
                    <a:ext uri="{FF2B5EF4-FFF2-40B4-BE49-F238E27FC236}">
                      <a16:creationId xmlns:a16="http://schemas.microsoft.com/office/drawing/2014/main" id="{9B8722ED-EB9A-6BF7-53C1-C2990D7AB8A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765800" y="4919663"/>
                  <a:ext cx="23812" cy="23812"/>
                </a:xfrm>
                <a:prstGeom prst="rect">
                  <a:avLst/>
                </a:prstGeom>
                <a:noFill/>
                <a:ln w="1588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63" name="Oval 826">
                  <a:extLst>
                    <a:ext uri="{FF2B5EF4-FFF2-40B4-BE49-F238E27FC236}">
                      <a16:creationId xmlns:a16="http://schemas.microsoft.com/office/drawing/2014/main" id="{22DE317E-BDAA-4BA4-C0FB-E7D3C877213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140460" y="4578350"/>
                  <a:ext cx="26987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64" name="Oval 828">
                  <a:extLst>
                    <a:ext uri="{FF2B5EF4-FFF2-40B4-BE49-F238E27FC236}">
                      <a16:creationId xmlns:a16="http://schemas.microsoft.com/office/drawing/2014/main" id="{585BE5CD-6F05-85EF-4042-8ECF131EAF8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140460" y="5041900"/>
                  <a:ext cx="26987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65" name="Freeform 830">
                  <a:extLst>
                    <a:ext uri="{FF2B5EF4-FFF2-40B4-BE49-F238E27FC236}">
                      <a16:creationId xmlns:a16="http://schemas.microsoft.com/office/drawing/2014/main" id="{05A52B13-0D07-F5F9-B3FF-19C11C81A97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965835" y="5446713"/>
                  <a:ext cx="377825" cy="387350"/>
                </a:xfrm>
                <a:custGeom>
                  <a:avLst/>
                  <a:gdLst>
                    <a:gd name="T0" fmla="*/ 0 w 238"/>
                    <a:gd name="T1" fmla="*/ 244 h 244"/>
                    <a:gd name="T2" fmla="*/ 238 w 238"/>
                    <a:gd name="T3" fmla="*/ 244 h 244"/>
                    <a:gd name="T4" fmla="*/ 238 w 238"/>
                    <a:gd name="T5" fmla="*/ 244 h 244"/>
                    <a:gd name="T6" fmla="*/ 238 w 238"/>
                    <a:gd name="T7" fmla="*/ 112 h 244"/>
                    <a:gd name="T8" fmla="*/ 238 w 238"/>
                    <a:gd name="T9" fmla="*/ 0 h 244"/>
                    <a:gd name="T10" fmla="*/ 238 w 238"/>
                    <a:gd name="T11" fmla="*/ 0 h 244"/>
                    <a:gd name="T12" fmla="*/ 0 w 238"/>
                    <a:gd name="T13" fmla="*/ 0 h 244"/>
                    <a:gd name="T14" fmla="*/ 0 w 238"/>
                    <a:gd name="T15" fmla="*/ 0 h 244"/>
                    <a:gd name="T16" fmla="*/ 0 w 238"/>
                    <a:gd name="T17" fmla="*/ 112 h 244"/>
                    <a:gd name="T18" fmla="*/ 0 w 238"/>
                    <a:gd name="T19" fmla="*/ 244 h 24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238" h="244">
                      <a:moveTo>
                        <a:pt x="0" y="244"/>
                      </a:moveTo>
                      <a:lnTo>
                        <a:pt x="238" y="244"/>
                      </a:lnTo>
                      <a:lnTo>
                        <a:pt x="238" y="244"/>
                      </a:lnTo>
                      <a:lnTo>
                        <a:pt x="238" y="112"/>
                      </a:lnTo>
                      <a:lnTo>
                        <a:pt x="238" y="0"/>
                      </a:lnTo>
                      <a:lnTo>
                        <a:pt x="238" y="0"/>
                      </a:ln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0" y="112"/>
                      </a:lnTo>
                      <a:lnTo>
                        <a:pt x="0" y="244"/>
                      </a:lnTo>
                    </a:path>
                  </a:pathLst>
                </a:custGeom>
                <a:pattFill prst="pct25">
                  <a:fgClr>
                    <a:srgbClr val="FF0000"/>
                  </a:fgClr>
                  <a:bgClr>
                    <a:schemeClr val="bg1"/>
                  </a:bgClr>
                </a:pattFill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66" name="Line 835">
                  <a:extLst>
                    <a:ext uri="{FF2B5EF4-FFF2-40B4-BE49-F238E27FC236}">
                      <a16:creationId xmlns:a16="http://schemas.microsoft.com/office/drawing/2014/main" id="{7089AE34-E3CF-7D3F-074E-1C55DD002C7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6154748" y="5056188"/>
                  <a:ext cx="0" cy="390525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67" name="Line 837">
                  <a:extLst>
                    <a:ext uri="{FF2B5EF4-FFF2-40B4-BE49-F238E27FC236}">
                      <a16:creationId xmlns:a16="http://schemas.microsoft.com/office/drawing/2014/main" id="{5732D093-355C-9980-7D63-D398168DAA8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6130935" y="5056188"/>
                  <a:ext cx="47625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68" name="Oval 786">
                  <a:extLst>
                    <a:ext uri="{FF2B5EF4-FFF2-40B4-BE49-F238E27FC236}">
                      <a16:creationId xmlns:a16="http://schemas.microsoft.com/office/drawing/2014/main" id="{77EFCCF8-FBAE-6136-6878-C1D7B09A1E4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791200" y="5375275"/>
                  <a:ext cx="26987" cy="28575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69" name="Oval 792">
                  <a:extLst>
                    <a:ext uri="{FF2B5EF4-FFF2-40B4-BE49-F238E27FC236}">
                      <a16:creationId xmlns:a16="http://schemas.microsoft.com/office/drawing/2014/main" id="{2A5FBF0E-2F66-0656-741E-BC1ED62113D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737225" y="5353050"/>
                  <a:ext cx="26987" cy="28575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70" name="Oval 798">
                  <a:extLst>
                    <a:ext uri="{FF2B5EF4-FFF2-40B4-BE49-F238E27FC236}">
                      <a16:creationId xmlns:a16="http://schemas.microsoft.com/office/drawing/2014/main" id="{7BEAFA68-6852-B822-6182-F33B87F6332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602288" y="5100638"/>
                  <a:ext cx="26987" cy="28575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71" name="Oval 802">
                  <a:extLst>
                    <a:ext uri="{FF2B5EF4-FFF2-40B4-BE49-F238E27FC236}">
                      <a16:creationId xmlns:a16="http://schemas.microsoft.com/office/drawing/2014/main" id="{2A77563A-F0C2-B538-040D-0E2F0083947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764213" y="5856288"/>
                  <a:ext cx="26987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72" name="Line 807">
                  <a:extLst>
                    <a:ext uri="{FF2B5EF4-FFF2-40B4-BE49-F238E27FC236}">
                      <a16:creationId xmlns:a16="http://schemas.microsoft.com/office/drawing/2014/main" id="{7438FBF9-68D9-08AF-B5FD-93880C52751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778500" y="5102225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73" name="Line 809">
                  <a:extLst>
                    <a:ext uri="{FF2B5EF4-FFF2-40B4-BE49-F238E27FC236}">
                      <a16:creationId xmlns:a16="http://schemas.microsoft.com/office/drawing/2014/main" id="{56824B1C-D74F-548B-53E6-C94C34C2610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778500" y="5102225"/>
                  <a:ext cx="0" cy="287337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74" name="Line 811">
                  <a:extLst>
                    <a:ext uri="{FF2B5EF4-FFF2-40B4-BE49-F238E27FC236}">
                      <a16:creationId xmlns:a16="http://schemas.microsoft.com/office/drawing/2014/main" id="{69B11B7F-1505-D130-2489-8209587F539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5754688" y="5389563"/>
                  <a:ext cx="47625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75" name="Oval 813">
                  <a:extLst>
                    <a:ext uri="{FF2B5EF4-FFF2-40B4-BE49-F238E27FC236}">
                      <a16:creationId xmlns:a16="http://schemas.microsoft.com/office/drawing/2014/main" id="{6F15AE25-A0B2-6301-6ED7-4A7281977E3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172210" y="5592763"/>
                  <a:ext cx="26987" cy="28575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76" name="Oval 814">
                  <a:extLst>
                    <a:ext uri="{FF2B5EF4-FFF2-40B4-BE49-F238E27FC236}">
                      <a16:creationId xmlns:a16="http://schemas.microsoft.com/office/drawing/2014/main" id="{0CD214BD-4771-508F-5523-20EB55F1416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172210" y="5786438"/>
                  <a:ext cx="26987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77" name="Oval 815">
                  <a:extLst>
                    <a:ext uri="{FF2B5EF4-FFF2-40B4-BE49-F238E27FC236}">
                      <a16:creationId xmlns:a16="http://schemas.microsoft.com/office/drawing/2014/main" id="{A0309825-D38C-B644-0460-D1FB610D4BE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108710" y="5819775"/>
                  <a:ext cx="28575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78" name="Oval 816">
                  <a:extLst>
                    <a:ext uri="{FF2B5EF4-FFF2-40B4-BE49-F238E27FC236}">
                      <a16:creationId xmlns:a16="http://schemas.microsoft.com/office/drawing/2014/main" id="{0CE642A4-C139-E5D2-998D-654EEE2FD42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108710" y="5575300"/>
                  <a:ext cx="28575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79" name="Oval 817">
                  <a:extLst>
                    <a:ext uri="{FF2B5EF4-FFF2-40B4-BE49-F238E27FC236}">
                      <a16:creationId xmlns:a16="http://schemas.microsoft.com/office/drawing/2014/main" id="{A3E614E6-4941-18FC-58A4-D6C475E8BFF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234123" y="5534025"/>
                  <a:ext cx="28575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80" name="Oval 818">
                  <a:extLst>
                    <a:ext uri="{FF2B5EF4-FFF2-40B4-BE49-F238E27FC236}">
                      <a16:creationId xmlns:a16="http://schemas.microsoft.com/office/drawing/2014/main" id="{DD2BADCA-9549-0236-59FF-983367A41FA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172210" y="5308600"/>
                  <a:ext cx="26987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81" name="Oval 819">
                  <a:extLst>
                    <a:ext uri="{FF2B5EF4-FFF2-40B4-BE49-F238E27FC236}">
                      <a16:creationId xmlns:a16="http://schemas.microsoft.com/office/drawing/2014/main" id="{11D5AF7B-A9A4-8385-9B36-83132C52352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045210" y="5611813"/>
                  <a:ext cx="28575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82" name="Oval 820">
                  <a:extLst>
                    <a:ext uri="{FF2B5EF4-FFF2-40B4-BE49-F238E27FC236}">
                      <a16:creationId xmlns:a16="http://schemas.microsoft.com/office/drawing/2014/main" id="{8EA9E61A-11AC-0119-3284-904883B1981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297623" y="5662613"/>
                  <a:ext cx="26987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83" name="Oval 821">
                  <a:extLst>
                    <a:ext uri="{FF2B5EF4-FFF2-40B4-BE49-F238E27FC236}">
                      <a16:creationId xmlns:a16="http://schemas.microsoft.com/office/drawing/2014/main" id="{0FEA2D9C-DD68-CFF4-FF00-AD10E2648C6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108710" y="5148263"/>
                  <a:ext cx="28575" cy="28575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84" name="Oval 822">
                  <a:extLst>
                    <a:ext uri="{FF2B5EF4-FFF2-40B4-BE49-F238E27FC236}">
                      <a16:creationId xmlns:a16="http://schemas.microsoft.com/office/drawing/2014/main" id="{FED6E84B-B1BC-506A-E59D-9E21E80DC98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234123" y="5932488"/>
                  <a:ext cx="28575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85" name="Oval 823">
                  <a:extLst>
                    <a:ext uri="{FF2B5EF4-FFF2-40B4-BE49-F238E27FC236}">
                      <a16:creationId xmlns:a16="http://schemas.microsoft.com/office/drawing/2014/main" id="{0BE62F93-C851-F061-C30B-5A30AD017A2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140460" y="5981700"/>
                  <a:ext cx="26987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86" name="Oval 824">
                  <a:extLst>
                    <a:ext uri="{FF2B5EF4-FFF2-40B4-BE49-F238E27FC236}">
                      <a16:creationId xmlns:a16="http://schemas.microsoft.com/office/drawing/2014/main" id="{85C825FB-C523-C540-FBCA-7BE6714D6F0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983298" y="5721350"/>
                  <a:ext cx="26987" cy="28575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87" name="Oval 825">
                  <a:extLst>
                    <a:ext uri="{FF2B5EF4-FFF2-40B4-BE49-F238E27FC236}">
                      <a16:creationId xmlns:a16="http://schemas.microsoft.com/office/drawing/2014/main" id="{F17C573C-4ED4-23F8-14EF-404D7130423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140460" y="6346825"/>
                  <a:ext cx="26987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88" name="Oval 827">
                  <a:extLst>
                    <a:ext uri="{FF2B5EF4-FFF2-40B4-BE49-F238E27FC236}">
                      <a16:creationId xmlns:a16="http://schemas.microsoft.com/office/drawing/2014/main" id="{4E01630E-8F07-9E76-2690-F4A451B3827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140460" y="5432425"/>
                  <a:ext cx="26987" cy="28575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89" name="Oval 829">
                  <a:extLst>
                    <a:ext uri="{FF2B5EF4-FFF2-40B4-BE49-F238E27FC236}">
                      <a16:creationId xmlns:a16="http://schemas.microsoft.com/office/drawing/2014/main" id="{8D85609F-D560-4BCF-8D45-15C93DF1F11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045210" y="5876925"/>
                  <a:ext cx="28575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90" name="Line 831">
                  <a:extLst>
                    <a:ext uri="{FF2B5EF4-FFF2-40B4-BE49-F238E27FC236}">
                      <a16:creationId xmlns:a16="http://schemas.microsoft.com/office/drawing/2014/main" id="{DD699730-5299-BD90-C589-737AF170546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965835" y="5834063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91" name="Line 832">
                  <a:extLst>
                    <a:ext uri="{FF2B5EF4-FFF2-40B4-BE49-F238E27FC236}">
                      <a16:creationId xmlns:a16="http://schemas.microsoft.com/office/drawing/2014/main" id="{0AC4176D-816C-D5B1-5029-69117B3A9EF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5965835" y="5624513"/>
                  <a:ext cx="377825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92" name="Line 833">
                  <a:extLst>
                    <a:ext uri="{FF2B5EF4-FFF2-40B4-BE49-F238E27FC236}">
                      <a16:creationId xmlns:a16="http://schemas.microsoft.com/office/drawing/2014/main" id="{FCFA0715-D5DC-A7D5-81DB-07746222F09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154748" y="5446713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93" name="Line 834">
                  <a:extLst>
                    <a:ext uri="{FF2B5EF4-FFF2-40B4-BE49-F238E27FC236}">
                      <a16:creationId xmlns:a16="http://schemas.microsoft.com/office/drawing/2014/main" id="{3868D7F1-29DB-789A-D51E-548A478FB83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154748" y="5834063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94" name="Line 836">
                  <a:extLst>
                    <a:ext uri="{FF2B5EF4-FFF2-40B4-BE49-F238E27FC236}">
                      <a16:creationId xmlns:a16="http://schemas.microsoft.com/office/drawing/2014/main" id="{EF0545E2-C6A0-ABFB-3EE3-0F143A9DE3D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154748" y="5834063"/>
                  <a:ext cx="0" cy="52705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95" name="Line 838">
                  <a:extLst>
                    <a:ext uri="{FF2B5EF4-FFF2-40B4-BE49-F238E27FC236}">
                      <a16:creationId xmlns:a16="http://schemas.microsoft.com/office/drawing/2014/main" id="{A08891BE-D0F2-D192-B342-1D7EEFC75CE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6130935" y="6361113"/>
                  <a:ext cx="47625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96" name="Rectangle 839">
                  <a:extLst>
                    <a:ext uri="{FF2B5EF4-FFF2-40B4-BE49-F238E27FC236}">
                      <a16:creationId xmlns:a16="http://schemas.microsoft.com/office/drawing/2014/main" id="{CEE51633-5DEE-3274-451E-29B05C32CF9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142048" y="5586413"/>
                  <a:ext cx="23812" cy="23812"/>
                </a:xfrm>
                <a:prstGeom prst="rect">
                  <a:avLst/>
                </a:prstGeom>
                <a:noFill/>
                <a:ln w="1588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97" name="Line 904">
                  <a:extLst>
                    <a:ext uri="{FF2B5EF4-FFF2-40B4-BE49-F238E27FC236}">
                      <a16:creationId xmlns:a16="http://schemas.microsoft.com/office/drawing/2014/main" id="{9D31BC97-3B17-3ADD-D52C-DECB651F0B0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778500" y="6361113"/>
                  <a:ext cx="0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98" name="Line 905">
                  <a:extLst>
                    <a:ext uri="{FF2B5EF4-FFF2-40B4-BE49-F238E27FC236}">
                      <a16:creationId xmlns:a16="http://schemas.microsoft.com/office/drawing/2014/main" id="{85AB2CBE-5423-3858-DCD7-3D33CAF907C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154748" y="6361113"/>
                  <a:ext cx="0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99" name="Line 175">
                  <a:extLst>
                    <a:ext uri="{FF2B5EF4-FFF2-40B4-BE49-F238E27FC236}">
                      <a16:creationId xmlns:a16="http://schemas.microsoft.com/office/drawing/2014/main" id="{C8F5CFDC-BC70-57D0-226E-D1F7A3964E2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784803" y="4321969"/>
                  <a:ext cx="382275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200" name="Szövegdoboz 199">
                  <a:extLst>
                    <a:ext uri="{FF2B5EF4-FFF2-40B4-BE49-F238E27FC236}">
                      <a16:creationId xmlns:a16="http://schemas.microsoft.com/office/drawing/2014/main" id="{1123E42B-D3D0-CE82-4129-1DDB71CEE3A1}"/>
                    </a:ext>
                  </a:extLst>
                </p:cNvPr>
                <p:cNvSpPr txBox="1"/>
                <p:nvPr/>
              </p:nvSpPr>
              <p:spPr>
                <a:xfrm>
                  <a:off x="5742795" y="4129293"/>
                  <a:ext cx="47783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/>
                    <a:t>**</a:t>
                  </a:r>
                </a:p>
              </p:txBody>
            </p:sp>
          </p:grpSp>
          <p:grpSp>
            <p:nvGrpSpPr>
              <p:cNvPr id="76" name="Csoportba foglalás 75">
                <a:extLst>
                  <a:ext uri="{FF2B5EF4-FFF2-40B4-BE49-F238E27FC236}">
                    <a16:creationId xmlns:a16="http://schemas.microsoft.com/office/drawing/2014/main" id="{5F0264BA-58F9-0E41-E27B-F7AACC805AA6}"/>
                  </a:ext>
                </a:extLst>
              </p:cNvPr>
              <p:cNvGrpSpPr/>
              <p:nvPr/>
            </p:nvGrpSpPr>
            <p:grpSpPr>
              <a:xfrm>
                <a:off x="5456693" y="4115758"/>
                <a:ext cx="1027484" cy="2682733"/>
                <a:chOff x="6403796" y="4109408"/>
                <a:chExt cx="1027484" cy="2682733"/>
              </a:xfrm>
            </p:grpSpPr>
            <p:sp>
              <p:nvSpPr>
                <p:cNvPr id="83" name="Oval 841">
                  <a:extLst>
                    <a:ext uri="{FF2B5EF4-FFF2-40B4-BE49-F238E27FC236}">
                      <a16:creationId xmlns:a16="http://schemas.microsoft.com/office/drawing/2014/main" id="{42306172-B814-770E-4D51-13B14E858CD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707188" y="4905375"/>
                  <a:ext cx="28575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84" name="Oval 842">
                  <a:extLst>
                    <a:ext uri="{FF2B5EF4-FFF2-40B4-BE49-F238E27FC236}">
                      <a16:creationId xmlns:a16="http://schemas.microsoft.com/office/drawing/2014/main" id="{10761D06-05DB-B141-0EB0-6E7141D181F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707188" y="4837113"/>
                  <a:ext cx="28575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85" name="Oval 843">
                  <a:extLst>
                    <a:ext uri="{FF2B5EF4-FFF2-40B4-BE49-F238E27FC236}">
                      <a16:creationId xmlns:a16="http://schemas.microsoft.com/office/drawing/2014/main" id="{F15E19EC-3598-7ABE-00D8-492380FE3E7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745288" y="4419600"/>
                  <a:ext cx="26987" cy="28575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86" name="Oval 844">
                  <a:extLst>
                    <a:ext uri="{FF2B5EF4-FFF2-40B4-BE49-F238E27FC236}">
                      <a16:creationId xmlns:a16="http://schemas.microsoft.com/office/drawing/2014/main" id="{59220F24-C6CA-32F1-CA02-F91C9796007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670675" y="4398963"/>
                  <a:ext cx="26987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87" name="Oval 845">
                  <a:extLst>
                    <a:ext uri="{FF2B5EF4-FFF2-40B4-BE49-F238E27FC236}">
                      <a16:creationId xmlns:a16="http://schemas.microsoft.com/office/drawing/2014/main" id="{6526B0F1-58AC-9C27-860A-2C9A90224B4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707188" y="4659313"/>
                  <a:ext cx="28575" cy="28575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88" name="Oval 846">
                  <a:extLst>
                    <a:ext uri="{FF2B5EF4-FFF2-40B4-BE49-F238E27FC236}">
                      <a16:creationId xmlns:a16="http://schemas.microsoft.com/office/drawing/2014/main" id="{0A26A77D-D420-47E7-04A4-86BEC1B03A7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632575" y="4824413"/>
                  <a:ext cx="26987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89" name="Oval 847">
                  <a:extLst>
                    <a:ext uri="{FF2B5EF4-FFF2-40B4-BE49-F238E27FC236}">
                      <a16:creationId xmlns:a16="http://schemas.microsoft.com/office/drawing/2014/main" id="{FE0233FD-2C65-9452-E33A-A706FAE7ED4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781800" y="4840288"/>
                  <a:ext cx="28575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90" name="Oval 849">
                  <a:extLst>
                    <a:ext uri="{FF2B5EF4-FFF2-40B4-BE49-F238E27FC236}">
                      <a16:creationId xmlns:a16="http://schemas.microsoft.com/office/drawing/2014/main" id="{9037CC9F-EB32-D49B-1E01-824B666E4D6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632575" y="4975225"/>
                  <a:ext cx="26987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91" name="Oval 851">
                  <a:extLst>
                    <a:ext uri="{FF2B5EF4-FFF2-40B4-BE49-F238E27FC236}">
                      <a16:creationId xmlns:a16="http://schemas.microsoft.com/office/drawing/2014/main" id="{5A747B48-8276-3E5A-1BC4-C11E9F73D44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781800" y="4902200"/>
                  <a:ext cx="28575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92" name="Oval 852">
                  <a:extLst>
                    <a:ext uri="{FF2B5EF4-FFF2-40B4-BE49-F238E27FC236}">
                      <a16:creationId xmlns:a16="http://schemas.microsoft.com/office/drawing/2014/main" id="{1820B5A4-4311-C77B-E4EA-E979BC0BDEC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556375" y="4746625"/>
                  <a:ext cx="26987" cy="28575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93" name="Oval 853">
                  <a:extLst>
                    <a:ext uri="{FF2B5EF4-FFF2-40B4-BE49-F238E27FC236}">
                      <a16:creationId xmlns:a16="http://schemas.microsoft.com/office/drawing/2014/main" id="{D4F7FF23-7F44-CA7D-8D45-0C4F2CB7F55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632575" y="4641850"/>
                  <a:ext cx="26987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94" name="Oval 854">
                  <a:extLst>
                    <a:ext uri="{FF2B5EF4-FFF2-40B4-BE49-F238E27FC236}">
                      <a16:creationId xmlns:a16="http://schemas.microsoft.com/office/drawing/2014/main" id="{2F515270-3B68-5294-6D8D-712DE99E298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858000" y="4757738"/>
                  <a:ext cx="26987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95" name="Oval 856">
                  <a:extLst>
                    <a:ext uri="{FF2B5EF4-FFF2-40B4-BE49-F238E27FC236}">
                      <a16:creationId xmlns:a16="http://schemas.microsoft.com/office/drawing/2014/main" id="{E0C3BEF9-14A5-B717-2A9E-736811514E8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781800" y="4602163"/>
                  <a:ext cx="28575" cy="28575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96" name="Freeform 858">
                  <a:extLst>
                    <a:ext uri="{FF2B5EF4-FFF2-40B4-BE49-F238E27FC236}">
                      <a16:creationId xmlns:a16="http://schemas.microsoft.com/office/drawing/2014/main" id="{DD28CBF1-65A8-CD22-455E-4896E51A4DB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532563" y="4673600"/>
                  <a:ext cx="377825" cy="549275"/>
                </a:xfrm>
                <a:custGeom>
                  <a:avLst/>
                  <a:gdLst>
                    <a:gd name="T0" fmla="*/ 0 w 238"/>
                    <a:gd name="T1" fmla="*/ 346 h 346"/>
                    <a:gd name="T2" fmla="*/ 238 w 238"/>
                    <a:gd name="T3" fmla="*/ 346 h 346"/>
                    <a:gd name="T4" fmla="*/ 238 w 238"/>
                    <a:gd name="T5" fmla="*/ 346 h 346"/>
                    <a:gd name="T6" fmla="*/ 238 w 238"/>
                    <a:gd name="T7" fmla="*/ 113 h 346"/>
                    <a:gd name="T8" fmla="*/ 238 w 238"/>
                    <a:gd name="T9" fmla="*/ 0 h 346"/>
                    <a:gd name="T10" fmla="*/ 238 w 238"/>
                    <a:gd name="T11" fmla="*/ 0 h 346"/>
                    <a:gd name="T12" fmla="*/ 0 w 238"/>
                    <a:gd name="T13" fmla="*/ 0 h 346"/>
                    <a:gd name="T14" fmla="*/ 0 w 238"/>
                    <a:gd name="T15" fmla="*/ 0 h 346"/>
                    <a:gd name="T16" fmla="*/ 0 w 238"/>
                    <a:gd name="T17" fmla="*/ 113 h 346"/>
                    <a:gd name="T18" fmla="*/ 0 w 238"/>
                    <a:gd name="T19" fmla="*/ 346 h 3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238" h="346">
                      <a:moveTo>
                        <a:pt x="0" y="346"/>
                      </a:moveTo>
                      <a:lnTo>
                        <a:pt x="238" y="346"/>
                      </a:lnTo>
                      <a:lnTo>
                        <a:pt x="238" y="346"/>
                      </a:lnTo>
                      <a:lnTo>
                        <a:pt x="238" y="113"/>
                      </a:lnTo>
                      <a:lnTo>
                        <a:pt x="238" y="0"/>
                      </a:lnTo>
                      <a:lnTo>
                        <a:pt x="238" y="0"/>
                      </a:ln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0" y="113"/>
                      </a:lnTo>
                      <a:lnTo>
                        <a:pt x="0" y="346"/>
                      </a:lnTo>
                    </a:path>
                  </a:pathLst>
                </a:cu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97" name="Line 860">
                  <a:extLst>
                    <a:ext uri="{FF2B5EF4-FFF2-40B4-BE49-F238E27FC236}">
                      <a16:creationId xmlns:a16="http://schemas.microsoft.com/office/drawing/2014/main" id="{DFCF4DCB-DF85-DA4F-7231-B044069F55F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6532563" y="4852988"/>
                  <a:ext cx="377825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98" name="Line 861">
                  <a:extLst>
                    <a:ext uri="{FF2B5EF4-FFF2-40B4-BE49-F238E27FC236}">
                      <a16:creationId xmlns:a16="http://schemas.microsoft.com/office/drawing/2014/main" id="{0EE6E29B-286E-C3B9-36A0-3C8004D3704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721475" y="4673600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99" name="Line 863">
                  <a:extLst>
                    <a:ext uri="{FF2B5EF4-FFF2-40B4-BE49-F238E27FC236}">
                      <a16:creationId xmlns:a16="http://schemas.microsoft.com/office/drawing/2014/main" id="{51679781-2369-5AC4-057F-2F805E285CC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6721475" y="4411663"/>
                  <a:ext cx="0" cy="261937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00" name="Line 865">
                  <a:extLst>
                    <a:ext uri="{FF2B5EF4-FFF2-40B4-BE49-F238E27FC236}">
                      <a16:creationId xmlns:a16="http://schemas.microsoft.com/office/drawing/2014/main" id="{F6D68474-7B31-9D2F-D33F-5E18843582B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6697663" y="4411663"/>
                  <a:ext cx="47625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01" name="Rectangle 867">
                  <a:extLst>
                    <a:ext uri="{FF2B5EF4-FFF2-40B4-BE49-F238E27FC236}">
                      <a16:creationId xmlns:a16="http://schemas.microsoft.com/office/drawing/2014/main" id="{F67FD3A3-DAB0-D6DE-4BD8-65F3D71FECA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708775" y="4962525"/>
                  <a:ext cx="23812" cy="23812"/>
                </a:xfrm>
                <a:prstGeom prst="rect">
                  <a:avLst/>
                </a:prstGeom>
                <a:noFill/>
                <a:ln w="1588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02" name="Oval 869">
                  <a:extLst>
                    <a:ext uri="{FF2B5EF4-FFF2-40B4-BE49-F238E27FC236}">
                      <a16:creationId xmlns:a16="http://schemas.microsoft.com/office/drawing/2014/main" id="{9A4706CC-F69E-F5F5-0BCC-6A5922FD1C1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083435" y="5038725"/>
                  <a:ext cx="28575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03" name="Oval 871">
                  <a:extLst>
                    <a:ext uri="{FF2B5EF4-FFF2-40B4-BE49-F238E27FC236}">
                      <a16:creationId xmlns:a16="http://schemas.microsoft.com/office/drawing/2014/main" id="{993FFFF4-BA78-4232-BA29-AF4346256AD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121535" y="4889500"/>
                  <a:ext cx="26987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04" name="Oval 872">
                  <a:extLst>
                    <a:ext uri="{FF2B5EF4-FFF2-40B4-BE49-F238E27FC236}">
                      <a16:creationId xmlns:a16="http://schemas.microsoft.com/office/drawing/2014/main" id="{0D744BB2-7458-58EE-7B65-1C7B0E99672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046923" y="4784725"/>
                  <a:ext cx="26987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05" name="Freeform 886">
                  <a:extLst>
                    <a:ext uri="{FF2B5EF4-FFF2-40B4-BE49-F238E27FC236}">
                      <a16:creationId xmlns:a16="http://schemas.microsoft.com/office/drawing/2014/main" id="{C3E53565-F6C3-2697-10C4-7D2430E2666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908810" y="5130800"/>
                  <a:ext cx="377825" cy="601662"/>
                </a:xfrm>
                <a:custGeom>
                  <a:avLst/>
                  <a:gdLst>
                    <a:gd name="T0" fmla="*/ 0 w 238"/>
                    <a:gd name="T1" fmla="*/ 379 h 379"/>
                    <a:gd name="T2" fmla="*/ 238 w 238"/>
                    <a:gd name="T3" fmla="*/ 379 h 379"/>
                    <a:gd name="T4" fmla="*/ 238 w 238"/>
                    <a:gd name="T5" fmla="*/ 379 h 379"/>
                    <a:gd name="T6" fmla="*/ 238 w 238"/>
                    <a:gd name="T7" fmla="*/ 273 h 379"/>
                    <a:gd name="T8" fmla="*/ 238 w 238"/>
                    <a:gd name="T9" fmla="*/ 0 h 379"/>
                    <a:gd name="T10" fmla="*/ 238 w 238"/>
                    <a:gd name="T11" fmla="*/ 0 h 379"/>
                    <a:gd name="T12" fmla="*/ 0 w 238"/>
                    <a:gd name="T13" fmla="*/ 0 h 379"/>
                    <a:gd name="T14" fmla="*/ 0 w 238"/>
                    <a:gd name="T15" fmla="*/ 0 h 379"/>
                    <a:gd name="T16" fmla="*/ 0 w 238"/>
                    <a:gd name="T17" fmla="*/ 273 h 379"/>
                    <a:gd name="T18" fmla="*/ 0 w 238"/>
                    <a:gd name="T19" fmla="*/ 379 h 37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238" h="379">
                      <a:moveTo>
                        <a:pt x="0" y="379"/>
                      </a:moveTo>
                      <a:lnTo>
                        <a:pt x="238" y="379"/>
                      </a:lnTo>
                      <a:lnTo>
                        <a:pt x="238" y="379"/>
                      </a:lnTo>
                      <a:lnTo>
                        <a:pt x="238" y="273"/>
                      </a:lnTo>
                      <a:lnTo>
                        <a:pt x="238" y="0"/>
                      </a:lnTo>
                      <a:lnTo>
                        <a:pt x="238" y="0"/>
                      </a:ln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0" y="273"/>
                      </a:lnTo>
                      <a:lnTo>
                        <a:pt x="0" y="379"/>
                      </a:lnTo>
                    </a:path>
                  </a:pathLst>
                </a:custGeom>
                <a:pattFill prst="pct50">
                  <a:fgClr>
                    <a:schemeClr val="accent1"/>
                  </a:fgClr>
                  <a:bgClr>
                    <a:schemeClr val="bg1"/>
                  </a:bgClr>
                </a:pattFill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06" name="Line 891">
                  <a:extLst>
                    <a:ext uri="{FF2B5EF4-FFF2-40B4-BE49-F238E27FC236}">
                      <a16:creationId xmlns:a16="http://schemas.microsoft.com/office/drawing/2014/main" id="{A01CCF1A-08B0-B912-5DFB-A433417075D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7097723" y="4799013"/>
                  <a:ext cx="0" cy="331787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07" name="Line 893">
                  <a:extLst>
                    <a:ext uri="{FF2B5EF4-FFF2-40B4-BE49-F238E27FC236}">
                      <a16:creationId xmlns:a16="http://schemas.microsoft.com/office/drawing/2014/main" id="{C9B8CDD0-EB32-7068-EE23-070EEAF4506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7073910" y="4799013"/>
                  <a:ext cx="47625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08" name="Oval 840">
                  <a:extLst>
                    <a:ext uri="{FF2B5EF4-FFF2-40B4-BE49-F238E27FC236}">
                      <a16:creationId xmlns:a16="http://schemas.microsoft.com/office/drawing/2014/main" id="{1EA5A800-64EC-59F0-AD67-AE1630C69B9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707188" y="5208588"/>
                  <a:ext cx="28575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09" name="Oval 848">
                  <a:extLst>
                    <a:ext uri="{FF2B5EF4-FFF2-40B4-BE49-F238E27FC236}">
                      <a16:creationId xmlns:a16="http://schemas.microsoft.com/office/drawing/2014/main" id="{3374FF15-DFB1-D9FA-7094-274F8742198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707188" y="5935663"/>
                  <a:ext cx="28575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10" name="Oval 850">
                  <a:extLst>
                    <a:ext uri="{FF2B5EF4-FFF2-40B4-BE49-F238E27FC236}">
                      <a16:creationId xmlns:a16="http://schemas.microsoft.com/office/drawing/2014/main" id="{B4C8692F-3BFF-1ABC-78FF-E791919A6A6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707188" y="5324475"/>
                  <a:ext cx="28575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11" name="Oval 855">
                  <a:extLst>
                    <a:ext uri="{FF2B5EF4-FFF2-40B4-BE49-F238E27FC236}">
                      <a16:creationId xmlns:a16="http://schemas.microsoft.com/office/drawing/2014/main" id="{3536093E-8C1C-478B-3B29-CEFAB568705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707188" y="5572125"/>
                  <a:ext cx="28575" cy="28575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12" name="Oval 857">
                  <a:extLst>
                    <a:ext uri="{FF2B5EF4-FFF2-40B4-BE49-F238E27FC236}">
                      <a16:creationId xmlns:a16="http://schemas.microsoft.com/office/drawing/2014/main" id="{5BE0EC36-3A58-E62F-2587-CF968A6A554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707188" y="5741988"/>
                  <a:ext cx="28575" cy="28575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13" name="Line 859">
                  <a:extLst>
                    <a:ext uri="{FF2B5EF4-FFF2-40B4-BE49-F238E27FC236}">
                      <a16:creationId xmlns:a16="http://schemas.microsoft.com/office/drawing/2014/main" id="{7DBE1386-4F2D-E38C-95D9-C715A452638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532563" y="5222875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14" name="Line 862">
                  <a:extLst>
                    <a:ext uri="{FF2B5EF4-FFF2-40B4-BE49-F238E27FC236}">
                      <a16:creationId xmlns:a16="http://schemas.microsoft.com/office/drawing/2014/main" id="{33701D91-C870-3497-A99A-826D74250BE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721475" y="5222875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15" name="Line 864">
                  <a:extLst>
                    <a:ext uri="{FF2B5EF4-FFF2-40B4-BE49-F238E27FC236}">
                      <a16:creationId xmlns:a16="http://schemas.microsoft.com/office/drawing/2014/main" id="{5C40E680-24EA-3923-943E-CDCADD1F6AB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721475" y="5222875"/>
                  <a:ext cx="0" cy="727075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16" name="Line 866">
                  <a:extLst>
                    <a:ext uri="{FF2B5EF4-FFF2-40B4-BE49-F238E27FC236}">
                      <a16:creationId xmlns:a16="http://schemas.microsoft.com/office/drawing/2014/main" id="{B0EE108C-6EF6-9932-800D-83762B7707A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6697663" y="5949950"/>
                  <a:ext cx="47625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17" name="Oval 868">
                  <a:extLst>
                    <a:ext uri="{FF2B5EF4-FFF2-40B4-BE49-F238E27FC236}">
                      <a16:creationId xmlns:a16="http://schemas.microsoft.com/office/drawing/2014/main" id="{20D49C8B-5C6E-245A-7A9C-5863F89B869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121535" y="5116513"/>
                  <a:ext cx="26987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18" name="Oval 870">
                  <a:extLst>
                    <a:ext uri="{FF2B5EF4-FFF2-40B4-BE49-F238E27FC236}">
                      <a16:creationId xmlns:a16="http://schemas.microsoft.com/office/drawing/2014/main" id="{D2857ACD-2B3B-89E6-259D-6590C057389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121535" y="5842000"/>
                  <a:ext cx="26987" cy="28575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19" name="Oval 873">
                  <a:extLst>
                    <a:ext uri="{FF2B5EF4-FFF2-40B4-BE49-F238E27FC236}">
                      <a16:creationId xmlns:a16="http://schemas.microsoft.com/office/drawing/2014/main" id="{E143C43D-6842-6506-AA2B-831E591EE0A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046923" y="5275263"/>
                  <a:ext cx="26987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20" name="Oval 874">
                  <a:extLst>
                    <a:ext uri="{FF2B5EF4-FFF2-40B4-BE49-F238E27FC236}">
                      <a16:creationId xmlns:a16="http://schemas.microsoft.com/office/drawing/2014/main" id="{747980D3-EE60-1198-16EB-14E0D9665E5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197735" y="5116513"/>
                  <a:ext cx="26987" cy="28575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21" name="Oval 875">
                  <a:extLst>
                    <a:ext uri="{FF2B5EF4-FFF2-40B4-BE49-F238E27FC236}">
                      <a16:creationId xmlns:a16="http://schemas.microsoft.com/office/drawing/2014/main" id="{0B82A5F5-33E8-6D36-0E53-0CB20A6B4E5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121535" y="5465763"/>
                  <a:ext cx="26987" cy="28575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22" name="Oval 876">
                  <a:extLst>
                    <a:ext uri="{FF2B5EF4-FFF2-40B4-BE49-F238E27FC236}">
                      <a16:creationId xmlns:a16="http://schemas.microsoft.com/office/drawing/2014/main" id="{1C3669B5-AE93-D96D-59B9-D9337F6267E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083435" y="6146800"/>
                  <a:ext cx="28575" cy="28575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23" name="Oval 877">
                  <a:extLst>
                    <a:ext uri="{FF2B5EF4-FFF2-40B4-BE49-F238E27FC236}">
                      <a16:creationId xmlns:a16="http://schemas.microsoft.com/office/drawing/2014/main" id="{EE37E1CB-4675-5390-1C84-DA92A961A4D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046923" y="5811838"/>
                  <a:ext cx="26987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24" name="Oval 878">
                  <a:extLst>
                    <a:ext uri="{FF2B5EF4-FFF2-40B4-BE49-F238E27FC236}">
                      <a16:creationId xmlns:a16="http://schemas.microsoft.com/office/drawing/2014/main" id="{821ADD74-23A6-2380-CA35-DEA2444AB9F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083435" y="5718175"/>
                  <a:ext cx="28575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25" name="Oval 879">
                  <a:extLst>
                    <a:ext uri="{FF2B5EF4-FFF2-40B4-BE49-F238E27FC236}">
                      <a16:creationId xmlns:a16="http://schemas.microsoft.com/office/drawing/2014/main" id="{D1AA67F8-2CB9-CD6F-686B-DA6877F8D2C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008823" y="5643563"/>
                  <a:ext cx="26987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26" name="Oval 880">
                  <a:extLst>
                    <a:ext uri="{FF2B5EF4-FFF2-40B4-BE49-F238E27FC236}">
                      <a16:creationId xmlns:a16="http://schemas.microsoft.com/office/drawing/2014/main" id="{9E5EBB7E-3BCA-D410-95F1-DEF5275402B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159635" y="5583238"/>
                  <a:ext cx="26987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27" name="Oval 881">
                  <a:extLst>
                    <a:ext uri="{FF2B5EF4-FFF2-40B4-BE49-F238E27FC236}">
                      <a16:creationId xmlns:a16="http://schemas.microsoft.com/office/drawing/2014/main" id="{16C18C56-DEB2-34D4-45E7-3BD8716F603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970723" y="5270500"/>
                  <a:ext cx="26987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28" name="Oval 882">
                  <a:extLst>
                    <a:ext uri="{FF2B5EF4-FFF2-40B4-BE49-F238E27FC236}">
                      <a16:creationId xmlns:a16="http://schemas.microsoft.com/office/drawing/2014/main" id="{A0BE1762-16CA-5E28-068B-3192139FCA9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932623" y="5681663"/>
                  <a:ext cx="26987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29" name="Oval 883">
                  <a:extLst>
                    <a:ext uri="{FF2B5EF4-FFF2-40B4-BE49-F238E27FC236}">
                      <a16:creationId xmlns:a16="http://schemas.microsoft.com/office/drawing/2014/main" id="{62990295-54C2-C115-5E92-ADB7BE7C977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234248" y="5659438"/>
                  <a:ext cx="28575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30" name="Oval 884">
                  <a:extLst>
                    <a:ext uri="{FF2B5EF4-FFF2-40B4-BE49-F238E27FC236}">
                      <a16:creationId xmlns:a16="http://schemas.microsoft.com/office/drawing/2014/main" id="{6DC5CF6E-9A1D-C995-A368-83607A20C3B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046923" y="5516563"/>
                  <a:ext cx="26987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31" name="Oval 885">
                  <a:extLst>
                    <a:ext uri="{FF2B5EF4-FFF2-40B4-BE49-F238E27FC236}">
                      <a16:creationId xmlns:a16="http://schemas.microsoft.com/office/drawing/2014/main" id="{2D24DA7C-00E5-8135-508C-5D5707820CD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083435" y="6081713"/>
                  <a:ext cx="28575" cy="28575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32" name="Line 887">
                  <a:extLst>
                    <a:ext uri="{FF2B5EF4-FFF2-40B4-BE49-F238E27FC236}">
                      <a16:creationId xmlns:a16="http://schemas.microsoft.com/office/drawing/2014/main" id="{7718ABBC-E83E-B3A1-1C24-A2F72ABC356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908810" y="5732463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33" name="Line 888">
                  <a:extLst>
                    <a:ext uri="{FF2B5EF4-FFF2-40B4-BE49-F238E27FC236}">
                      <a16:creationId xmlns:a16="http://schemas.microsoft.com/office/drawing/2014/main" id="{9C41456F-7CA3-75CC-F20E-752BEBEBC24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6908810" y="5564188"/>
                  <a:ext cx="377825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34" name="Line 889">
                  <a:extLst>
                    <a:ext uri="{FF2B5EF4-FFF2-40B4-BE49-F238E27FC236}">
                      <a16:creationId xmlns:a16="http://schemas.microsoft.com/office/drawing/2014/main" id="{D9F5E7CE-7B2D-5936-DA18-1A3A75D9427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097723" y="5130800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35" name="Line 890">
                  <a:extLst>
                    <a:ext uri="{FF2B5EF4-FFF2-40B4-BE49-F238E27FC236}">
                      <a16:creationId xmlns:a16="http://schemas.microsoft.com/office/drawing/2014/main" id="{2C8BC114-E1E2-DDF1-82FE-7347FE2D2F9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097723" y="5732463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36" name="Line 892">
                  <a:extLst>
                    <a:ext uri="{FF2B5EF4-FFF2-40B4-BE49-F238E27FC236}">
                      <a16:creationId xmlns:a16="http://schemas.microsoft.com/office/drawing/2014/main" id="{C571C351-09AF-55CA-B018-2E283DBE588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097723" y="5732463"/>
                  <a:ext cx="0" cy="428625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37" name="Line 894">
                  <a:extLst>
                    <a:ext uri="{FF2B5EF4-FFF2-40B4-BE49-F238E27FC236}">
                      <a16:creationId xmlns:a16="http://schemas.microsoft.com/office/drawing/2014/main" id="{269F013D-86D9-1DC9-7FA3-76725434261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7073910" y="6161088"/>
                  <a:ext cx="47625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38" name="Rectangle 895">
                  <a:extLst>
                    <a:ext uri="{FF2B5EF4-FFF2-40B4-BE49-F238E27FC236}">
                      <a16:creationId xmlns:a16="http://schemas.microsoft.com/office/drawing/2014/main" id="{C356786F-C1C7-1AC4-F994-F61A32ECFC2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085023" y="5481638"/>
                  <a:ext cx="23812" cy="23812"/>
                </a:xfrm>
                <a:prstGeom prst="rect">
                  <a:avLst/>
                </a:prstGeom>
                <a:noFill/>
                <a:ln w="1588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39" name="Line 906">
                  <a:extLst>
                    <a:ext uri="{FF2B5EF4-FFF2-40B4-BE49-F238E27FC236}">
                      <a16:creationId xmlns:a16="http://schemas.microsoft.com/office/drawing/2014/main" id="{913674DF-B3DE-C80A-7AA4-C6C26FD5CE1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721475" y="6361113"/>
                  <a:ext cx="0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40" name="Line 907">
                  <a:extLst>
                    <a:ext uri="{FF2B5EF4-FFF2-40B4-BE49-F238E27FC236}">
                      <a16:creationId xmlns:a16="http://schemas.microsoft.com/office/drawing/2014/main" id="{F82D2734-99CA-BFE0-204D-CB3845016D1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192963" y="6361113"/>
                  <a:ext cx="0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41" name="Szövegdoboz 140">
                  <a:extLst>
                    <a:ext uri="{FF2B5EF4-FFF2-40B4-BE49-F238E27FC236}">
                      <a16:creationId xmlns:a16="http://schemas.microsoft.com/office/drawing/2014/main" id="{5906D5BF-6D2B-CDBB-B1B8-C0255393AEC1}"/>
                    </a:ext>
                  </a:extLst>
                </p:cNvPr>
                <p:cNvSpPr txBox="1"/>
                <p:nvPr/>
              </p:nvSpPr>
              <p:spPr>
                <a:xfrm>
                  <a:off x="6403796" y="6361254"/>
                  <a:ext cx="1027484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hu-HU" sz="11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Moderate</a:t>
                  </a:r>
                  <a:endParaRPr lang="hu-HU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r>
                    <a:rPr lang="hu-HU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VID-19</a:t>
                  </a:r>
                  <a:endParaRPr 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2" name="Line 175">
                  <a:extLst>
                    <a:ext uri="{FF2B5EF4-FFF2-40B4-BE49-F238E27FC236}">
                      <a16:creationId xmlns:a16="http://schemas.microsoft.com/office/drawing/2014/main" id="{35F5C5B6-6A10-95D4-8BCE-78A718123F2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728958" y="4311882"/>
                  <a:ext cx="382275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43" name="Szövegdoboz 142">
                  <a:extLst>
                    <a:ext uri="{FF2B5EF4-FFF2-40B4-BE49-F238E27FC236}">
                      <a16:creationId xmlns:a16="http://schemas.microsoft.com/office/drawing/2014/main" id="{974624B9-9B39-5CF4-806B-F454BFADD156}"/>
                    </a:ext>
                  </a:extLst>
                </p:cNvPr>
                <p:cNvSpPr txBox="1"/>
                <p:nvPr/>
              </p:nvSpPr>
              <p:spPr>
                <a:xfrm>
                  <a:off x="6679310" y="4109408"/>
                  <a:ext cx="47783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/>
                    <a:t>**</a:t>
                  </a:r>
                </a:p>
              </p:txBody>
            </p:sp>
          </p:grpSp>
          <p:sp>
            <p:nvSpPr>
              <p:cNvPr id="77" name="Line 175">
                <a:extLst>
                  <a:ext uri="{FF2B5EF4-FFF2-40B4-BE49-F238E27FC236}">
                    <a16:creationId xmlns:a16="http://schemas.microsoft.com/office/drawing/2014/main" id="{94951FCA-F0B7-6DEB-6007-D2D4EB0AA68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42668" y="3785510"/>
                <a:ext cx="1893600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78" name="Szövegdoboz 77">
                <a:extLst>
                  <a:ext uri="{FF2B5EF4-FFF2-40B4-BE49-F238E27FC236}">
                    <a16:creationId xmlns:a16="http://schemas.microsoft.com/office/drawing/2014/main" id="{D5B033DA-C926-9732-F088-546F424C5076}"/>
                  </a:ext>
                </a:extLst>
              </p:cNvPr>
              <p:cNvSpPr txBox="1"/>
              <p:nvPr/>
            </p:nvSpPr>
            <p:spPr>
              <a:xfrm>
                <a:off x="4831555" y="3566763"/>
                <a:ext cx="191293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**</a:t>
                </a:r>
              </a:p>
            </p:txBody>
          </p:sp>
          <p:sp>
            <p:nvSpPr>
              <p:cNvPr id="79" name="Line 175">
                <a:extLst>
                  <a:ext uri="{FF2B5EF4-FFF2-40B4-BE49-F238E27FC236}">
                    <a16:creationId xmlns:a16="http://schemas.microsoft.com/office/drawing/2014/main" id="{5209BD24-D36A-2E44-1749-6E272C6A09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22409" y="3960026"/>
                <a:ext cx="936000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80" name="Szövegdoboz 79">
                <a:extLst>
                  <a:ext uri="{FF2B5EF4-FFF2-40B4-BE49-F238E27FC236}">
                    <a16:creationId xmlns:a16="http://schemas.microsoft.com/office/drawing/2014/main" id="{3B453AE6-CA73-7F4C-0940-C4201EEA4E97}"/>
                  </a:ext>
                </a:extLst>
              </p:cNvPr>
              <p:cNvSpPr txBox="1"/>
              <p:nvPr/>
            </p:nvSpPr>
            <p:spPr>
              <a:xfrm>
                <a:off x="5246221" y="3771129"/>
                <a:ext cx="89957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*</a:t>
                </a:r>
              </a:p>
            </p:txBody>
          </p:sp>
          <p:sp>
            <p:nvSpPr>
              <p:cNvPr id="81" name="Line 175">
                <a:extLst>
                  <a:ext uri="{FF2B5EF4-FFF2-40B4-BE49-F238E27FC236}">
                    <a16:creationId xmlns:a16="http://schemas.microsoft.com/office/drawing/2014/main" id="{051D565F-9167-62EB-BFF3-6515109090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17549" y="4172262"/>
                <a:ext cx="936000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82" name="Szövegdoboz 81">
                <a:extLst>
                  <a:ext uri="{FF2B5EF4-FFF2-40B4-BE49-F238E27FC236}">
                    <a16:creationId xmlns:a16="http://schemas.microsoft.com/office/drawing/2014/main" id="{DAAFF569-1B39-5D5B-2D20-735B4B633934}"/>
                  </a:ext>
                </a:extLst>
              </p:cNvPr>
              <p:cNvSpPr txBox="1"/>
              <p:nvPr/>
            </p:nvSpPr>
            <p:spPr>
              <a:xfrm>
                <a:off x="4841361" y="3973840"/>
                <a:ext cx="89957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**</a:t>
                </a:r>
              </a:p>
            </p:txBody>
          </p:sp>
        </p:grpSp>
        <p:sp>
          <p:nvSpPr>
            <p:cNvPr id="211" name="Szövegdoboz 210">
              <a:extLst>
                <a:ext uri="{FF2B5EF4-FFF2-40B4-BE49-F238E27FC236}">
                  <a16:creationId xmlns:a16="http://schemas.microsoft.com/office/drawing/2014/main" id="{4B8E2779-95C3-390A-70A3-FBC9431AD8B1}"/>
                </a:ext>
              </a:extLst>
            </p:cNvPr>
            <p:cNvSpPr txBox="1"/>
            <p:nvPr/>
          </p:nvSpPr>
          <p:spPr>
            <a:xfrm>
              <a:off x="-16935" y="66133"/>
              <a:ext cx="331167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4.</a:t>
              </a:r>
            </a:p>
          </p:txBody>
        </p:sp>
        <p:grpSp>
          <p:nvGrpSpPr>
            <p:cNvPr id="212" name="Csoportba foglalás 211">
              <a:extLst>
                <a:ext uri="{FF2B5EF4-FFF2-40B4-BE49-F238E27FC236}">
                  <a16:creationId xmlns:a16="http://schemas.microsoft.com/office/drawing/2014/main" id="{F7B7B6E3-E700-A26C-B679-1FA7F78C3B61}"/>
                </a:ext>
              </a:extLst>
            </p:cNvPr>
            <p:cNvGrpSpPr/>
            <p:nvPr/>
          </p:nvGrpSpPr>
          <p:grpSpPr>
            <a:xfrm>
              <a:off x="4569142" y="1325554"/>
              <a:ext cx="3413772" cy="2873765"/>
              <a:chOff x="7833666" y="3918031"/>
              <a:chExt cx="3413772" cy="2873765"/>
            </a:xfrm>
          </p:grpSpPr>
          <p:sp>
            <p:nvSpPr>
              <p:cNvPr id="213" name="Oval 920">
                <a:extLst>
                  <a:ext uri="{FF2B5EF4-FFF2-40B4-BE49-F238E27FC236}">
                    <a16:creationId xmlns:a16="http://schemas.microsoft.com/office/drawing/2014/main" id="{333980B3-C8AE-6AF7-38D9-50808DE180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37588" y="5507038"/>
                <a:ext cx="28575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14" name="Oval 921">
                <a:extLst>
                  <a:ext uri="{FF2B5EF4-FFF2-40B4-BE49-F238E27FC236}">
                    <a16:creationId xmlns:a16="http://schemas.microsoft.com/office/drawing/2014/main" id="{1B0F2131-2173-3D02-35AC-590224FEAF6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75688" y="4962525"/>
                <a:ext cx="28575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15" name="Oval 922">
                <a:extLst>
                  <a:ext uri="{FF2B5EF4-FFF2-40B4-BE49-F238E27FC236}">
                    <a16:creationId xmlns:a16="http://schemas.microsoft.com/office/drawing/2014/main" id="{9B4DA370-EE9D-B9A0-EC51-377D1BC17F7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37588" y="4872038"/>
                <a:ext cx="28575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16" name="Oval 923">
                <a:extLst>
                  <a:ext uri="{FF2B5EF4-FFF2-40B4-BE49-F238E27FC236}">
                    <a16:creationId xmlns:a16="http://schemas.microsoft.com/office/drawing/2014/main" id="{F4E29727-9CA4-249B-E6BB-9F835CFBC3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37588" y="4294188"/>
                <a:ext cx="28575" cy="28575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17" name="Oval 924">
                <a:extLst>
                  <a:ext uri="{FF2B5EF4-FFF2-40B4-BE49-F238E27FC236}">
                    <a16:creationId xmlns:a16="http://schemas.microsoft.com/office/drawing/2014/main" id="{BE093F6B-6B71-48AC-7F8B-C66BA7F521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62975" y="4371975"/>
                <a:ext cx="26988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18" name="Oval 925">
                <a:extLst>
                  <a:ext uri="{FF2B5EF4-FFF2-40B4-BE49-F238E27FC236}">
                    <a16:creationId xmlns:a16="http://schemas.microsoft.com/office/drawing/2014/main" id="{0048A146-181F-4F0A-6727-769D4BE864C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01075" y="4913313"/>
                <a:ext cx="26988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19" name="Oval 926">
                <a:extLst>
                  <a:ext uri="{FF2B5EF4-FFF2-40B4-BE49-F238E27FC236}">
                    <a16:creationId xmlns:a16="http://schemas.microsoft.com/office/drawing/2014/main" id="{7691B3B9-4E6E-131F-C2CA-0978C3FB38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713788" y="4414838"/>
                <a:ext cx="26988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20" name="Oval 927">
                <a:extLst>
                  <a:ext uri="{FF2B5EF4-FFF2-40B4-BE49-F238E27FC236}">
                    <a16:creationId xmlns:a16="http://schemas.microsoft.com/office/drawing/2014/main" id="{AC1983FE-1542-96A5-15A8-844A5C84A26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62975" y="4840288"/>
                <a:ext cx="26988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21" name="Oval 928">
                <a:extLst>
                  <a:ext uri="{FF2B5EF4-FFF2-40B4-BE49-F238E27FC236}">
                    <a16:creationId xmlns:a16="http://schemas.microsoft.com/office/drawing/2014/main" id="{9D409DEB-3A17-B7C3-959D-9BCD022AD5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37588" y="4518025"/>
                <a:ext cx="28575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22" name="Oval 929">
                <a:extLst>
                  <a:ext uri="{FF2B5EF4-FFF2-40B4-BE49-F238E27FC236}">
                    <a16:creationId xmlns:a16="http://schemas.microsoft.com/office/drawing/2014/main" id="{3B01F3D8-80F8-F39C-DC51-1029B6EEC2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713788" y="4779963"/>
                <a:ext cx="26988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23" name="Oval 930">
                <a:extLst>
                  <a:ext uri="{FF2B5EF4-FFF2-40B4-BE49-F238E27FC236}">
                    <a16:creationId xmlns:a16="http://schemas.microsoft.com/office/drawing/2014/main" id="{29484A3C-44DA-328A-B089-E212664531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486775" y="4891088"/>
                <a:ext cx="28575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24" name="Oval 931">
                <a:extLst>
                  <a:ext uri="{FF2B5EF4-FFF2-40B4-BE49-F238E27FC236}">
                    <a16:creationId xmlns:a16="http://schemas.microsoft.com/office/drawing/2014/main" id="{7DC3AA44-FFE5-CC33-65F3-7D6B9671576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486775" y="4364038"/>
                <a:ext cx="28575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25" name="Oval 932">
                <a:extLst>
                  <a:ext uri="{FF2B5EF4-FFF2-40B4-BE49-F238E27FC236}">
                    <a16:creationId xmlns:a16="http://schemas.microsoft.com/office/drawing/2014/main" id="{25AB554C-875D-07DD-18A4-35C710F8F2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789988" y="4838700"/>
                <a:ext cx="26988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26" name="Oval 933">
                <a:extLst>
                  <a:ext uri="{FF2B5EF4-FFF2-40B4-BE49-F238E27FC236}">
                    <a16:creationId xmlns:a16="http://schemas.microsoft.com/office/drawing/2014/main" id="{0A5C3156-CBA5-B67B-D1D6-0CC366B2681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789988" y="4324350"/>
                <a:ext cx="26988" cy="28575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27" name="Freeform 934">
                <a:extLst>
                  <a:ext uri="{FF2B5EF4-FFF2-40B4-BE49-F238E27FC236}">
                    <a16:creationId xmlns:a16="http://schemas.microsoft.com/office/drawing/2014/main" id="{78A0C7B6-DCCD-EA96-64C9-06361C8A1F4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462963" y="4386263"/>
                <a:ext cx="377825" cy="519112"/>
              </a:xfrm>
              <a:custGeom>
                <a:avLst/>
                <a:gdLst>
                  <a:gd name="T0" fmla="*/ 0 w 238"/>
                  <a:gd name="T1" fmla="*/ 327 h 327"/>
                  <a:gd name="T2" fmla="*/ 238 w 238"/>
                  <a:gd name="T3" fmla="*/ 327 h 327"/>
                  <a:gd name="T4" fmla="*/ 238 w 238"/>
                  <a:gd name="T5" fmla="*/ 327 h 327"/>
                  <a:gd name="T6" fmla="*/ 238 w 238"/>
                  <a:gd name="T7" fmla="*/ 275 h 327"/>
                  <a:gd name="T8" fmla="*/ 238 w 238"/>
                  <a:gd name="T9" fmla="*/ 0 h 327"/>
                  <a:gd name="T10" fmla="*/ 238 w 238"/>
                  <a:gd name="T11" fmla="*/ 0 h 327"/>
                  <a:gd name="T12" fmla="*/ 0 w 238"/>
                  <a:gd name="T13" fmla="*/ 0 h 327"/>
                  <a:gd name="T14" fmla="*/ 0 w 238"/>
                  <a:gd name="T15" fmla="*/ 0 h 327"/>
                  <a:gd name="T16" fmla="*/ 0 w 238"/>
                  <a:gd name="T17" fmla="*/ 275 h 327"/>
                  <a:gd name="T18" fmla="*/ 0 w 238"/>
                  <a:gd name="T19" fmla="*/ 327 h 3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238" h="327">
                    <a:moveTo>
                      <a:pt x="0" y="327"/>
                    </a:moveTo>
                    <a:lnTo>
                      <a:pt x="238" y="327"/>
                    </a:lnTo>
                    <a:lnTo>
                      <a:pt x="238" y="327"/>
                    </a:lnTo>
                    <a:lnTo>
                      <a:pt x="238" y="275"/>
                    </a:lnTo>
                    <a:lnTo>
                      <a:pt x="238" y="0"/>
                    </a:lnTo>
                    <a:lnTo>
                      <a:pt x="238" y="0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0" y="275"/>
                    </a:lnTo>
                    <a:lnTo>
                      <a:pt x="0" y="327"/>
                    </a:lnTo>
                  </a:path>
                </a:pathLst>
              </a:cu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28" name="Line 935">
                <a:extLst>
                  <a:ext uri="{FF2B5EF4-FFF2-40B4-BE49-F238E27FC236}">
                    <a16:creationId xmlns:a16="http://schemas.microsoft.com/office/drawing/2014/main" id="{24F753A6-63D6-D09B-E374-566DCACAA4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462963" y="4905375"/>
                <a:ext cx="0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29" name="Line 936">
                <a:extLst>
                  <a:ext uri="{FF2B5EF4-FFF2-40B4-BE49-F238E27FC236}">
                    <a16:creationId xmlns:a16="http://schemas.microsoft.com/office/drawing/2014/main" id="{23FB5971-3F8D-98ED-FD08-A52F26333D8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8462963" y="4822825"/>
                <a:ext cx="377825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30" name="Line 937">
                <a:extLst>
                  <a:ext uri="{FF2B5EF4-FFF2-40B4-BE49-F238E27FC236}">
                    <a16:creationId xmlns:a16="http://schemas.microsoft.com/office/drawing/2014/main" id="{4768EB99-7737-1580-5722-5BAFB7750BE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651875" y="4386263"/>
                <a:ext cx="0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31" name="Line 938">
                <a:extLst>
                  <a:ext uri="{FF2B5EF4-FFF2-40B4-BE49-F238E27FC236}">
                    <a16:creationId xmlns:a16="http://schemas.microsoft.com/office/drawing/2014/main" id="{415BDC68-FDE0-BF3E-5030-E80DB742BE0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651875" y="4905375"/>
                <a:ext cx="0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32" name="Line 939">
                <a:extLst>
                  <a:ext uri="{FF2B5EF4-FFF2-40B4-BE49-F238E27FC236}">
                    <a16:creationId xmlns:a16="http://schemas.microsoft.com/office/drawing/2014/main" id="{82E6E5A5-47F8-3094-EFB2-EA794A7249C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651875" y="4308475"/>
                <a:ext cx="0" cy="77787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33" name="Line 940">
                <a:extLst>
                  <a:ext uri="{FF2B5EF4-FFF2-40B4-BE49-F238E27FC236}">
                    <a16:creationId xmlns:a16="http://schemas.microsoft.com/office/drawing/2014/main" id="{F25DC6B6-00BB-AB3C-D573-318FA6693AE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651875" y="4905375"/>
                <a:ext cx="0" cy="614362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34" name="Line 941">
                <a:extLst>
                  <a:ext uri="{FF2B5EF4-FFF2-40B4-BE49-F238E27FC236}">
                    <a16:creationId xmlns:a16="http://schemas.microsoft.com/office/drawing/2014/main" id="{BD6BA7D8-7B9C-8A3C-2A37-341B5667A2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8628063" y="4308475"/>
                <a:ext cx="47625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35" name="Line 942">
                <a:extLst>
                  <a:ext uri="{FF2B5EF4-FFF2-40B4-BE49-F238E27FC236}">
                    <a16:creationId xmlns:a16="http://schemas.microsoft.com/office/drawing/2014/main" id="{6984875A-AF96-8F68-F0BC-B8C8F542CE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8628063" y="5519738"/>
                <a:ext cx="47625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36" name="Rectangle 943">
                <a:extLst>
                  <a:ext uri="{FF2B5EF4-FFF2-40B4-BE49-F238E27FC236}">
                    <a16:creationId xmlns:a16="http://schemas.microsoft.com/office/drawing/2014/main" id="{174A5D5A-BAFD-AB95-9FFE-3003C846F7F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40763" y="4708525"/>
                <a:ext cx="23813" cy="23812"/>
              </a:xfrm>
              <a:prstGeom prst="rect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37" name="Oval 945">
                <a:extLst>
                  <a:ext uri="{FF2B5EF4-FFF2-40B4-BE49-F238E27FC236}">
                    <a16:creationId xmlns:a16="http://schemas.microsoft.com/office/drawing/2014/main" id="{C078DF75-C2ED-3AA9-7F9E-591273E20F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017796" y="6030913"/>
                <a:ext cx="26988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38" name="Oval 946">
                <a:extLst>
                  <a:ext uri="{FF2B5EF4-FFF2-40B4-BE49-F238E27FC236}">
                    <a16:creationId xmlns:a16="http://schemas.microsoft.com/office/drawing/2014/main" id="{7469B08D-7BF5-26C4-EE09-A5F792AE383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017796" y="6242050"/>
                <a:ext cx="26988" cy="28575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39" name="Freeform 958">
                <a:extLst>
                  <a:ext uri="{FF2B5EF4-FFF2-40B4-BE49-F238E27FC236}">
                    <a16:creationId xmlns:a16="http://schemas.microsoft.com/office/drawing/2014/main" id="{B0A8FF16-4AC9-5C4D-1DCD-F2023CF3BAB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843171" y="4672013"/>
                <a:ext cx="376238" cy="1031875"/>
              </a:xfrm>
              <a:custGeom>
                <a:avLst/>
                <a:gdLst>
                  <a:gd name="T0" fmla="*/ 0 w 237"/>
                  <a:gd name="T1" fmla="*/ 650 h 650"/>
                  <a:gd name="T2" fmla="*/ 237 w 237"/>
                  <a:gd name="T3" fmla="*/ 650 h 650"/>
                  <a:gd name="T4" fmla="*/ 237 w 237"/>
                  <a:gd name="T5" fmla="*/ 650 h 650"/>
                  <a:gd name="T6" fmla="*/ 237 w 237"/>
                  <a:gd name="T7" fmla="*/ 333 h 650"/>
                  <a:gd name="T8" fmla="*/ 237 w 237"/>
                  <a:gd name="T9" fmla="*/ 0 h 650"/>
                  <a:gd name="T10" fmla="*/ 237 w 237"/>
                  <a:gd name="T11" fmla="*/ 0 h 650"/>
                  <a:gd name="T12" fmla="*/ 0 w 237"/>
                  <a:gd name="T13" fmla="*/ 0 h 650"/>
                  <a:gd name="T14" fmla="*/ 0 w 237"/>
                  <a:gd name="T15" fmla="*/ 0 h 650"/>
                  <a:gd name="T16" fmla="*/ 0 w 237"/>
                  <a:gd name="T17" fmla="*/ 333 h 650"/>
                  <a:gd name="T18" fmla="*/ 0 w 237"/>
                  <a:gd name="T19" fmla="*/ 650 h 6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237" h="650">
                    <a:moveTo>
                      <a:pt x="0" y="650"/>
                    </a:moveTo>
                    <a:lnTo>
                      <a:pt x="237" y="650"/>
                    </a:lnTo>
                    <a:lnTo>
                      <a:pt x="237" y="650"/>
                    </a:lnTo>
                    <a:lnTo>
                      <a:pt x="237" y="333"/>
                    </a:lnTo>
                    <a:lnTo>
                      <a:pt x="237" y="0"/>
                    </a:lnTo>
                    <a:lnTo>
                      <a:pt x="237" y="0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0" y="333"/>
                    </a:lnTo>
                    <a:lnTo>
                      <a:pt x="0" y="650"/>
                    </a:lnTo>
                  </a:path>
                </a:pathLst>
              </a:custGeom>
              <a:pattFill prst="pct25">
                <a:fgClr>
                  <a:schemeClr val="tx1"/>
                </a:fgClr>
                <a:bgClr>
                  <a:schemeClr val="bg1"/>
                </a:bgClr>
              </a:pattFill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40" name="Line 964">
                <a:extLst>
                  <a:ext uri="{FF2B5EF4-FFF2-40B4-BE49-F238E27FC236}">
                    <a16:creationId xmlns:a16="http://schemas.microsoft.com/office/drawing/2014/main" id="{5F5DBD93-DEBA-5441-1A72-59A99F062B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032083" y="5703888"/>
                <a:ext cx="0" cy="55245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41" name="Line 966">
                <a:extLst>
                  <a:ext uri="{FF2B5EF4-FFF2-40B4-BE49-F238E27FC236}">
                    <a16:creationId xmlns:a16="http://schemas.microsoft.com/office/drawing/2014/main" id="{7160E616-FE77-EC07-E64F-BD84F928F8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9008271" y="6256338"/>
                <a:ext cx="46038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42" name="Rectangle 1070">
                <a:extLst>
                  <a:ext uri="{FF2B5EF4-FFF2-40B4-BE49-F238E27FC236}">
                    <a16:creationId xmlns:a16="http://schemas.microsoft.com/office/drawing/2014/main" id="{11099796-5067-B9CE-F6A3-2328D24B056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288338" y="6300788"/>
                <a:ext cx="5770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hu-HU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en-US" altLang="hu-HU" sz="2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3" name="Rectangle 1071">
                <a:extLst>
                  <a:ext uri="{FF2B5EF4-FFF2-40B4-BE49-F238E27FC236}">
                    <a16:creationId xmlns:a16="http://schemas.microsoft.com/office/drawing/2014/main" id="{74804DE2-81FF-46E5-F725-3354E56D51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237538" y="5886450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hu-HU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</a:t>
                </a:r>
                <a:endParaRPr kumimoji="0" lang="en-US" altLang="hu-HU" sz="2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4" name="Rectangle 1072">
                <a:extLst>
                  <a:ext uri="{FF2B5EF4-FFF2-40B4-BE49-F238E27FC236}">
                    <a16:creationId xmlns:a16="http://schemas.microsoft.com/office/drawing/2014/main" id="{0F503645-9638-1FF5-B58B-23A6F6D53B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237538" y="5470525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hu-HU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0</a:t>
                </a:r>
                <a:endParaRPr kumimoji="0" lang="en-US" altLang="hu-HU" sz="2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5" name="Rectangle 1073">
                <a:extLst>
                  <a:ext uri="{FF2B5EF4-FFF2-40B4-BE49-F238E27FC236}">
                    <a16:creationId xmlns:a16="http://schemas.microsoft.com/office/drawing/2014/main" id="{88FB8F47-D593-CF77-AC65-DD9194AE621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237538" y="5056188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hu-HU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0</a:t>
                </a:r>
                <a:endParaRPr kumimoji="0" lang="en-US" altLang="hu-HU" sz="2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6" name="Rectangle 1074">
                <a:extLst>
                  <a:ext uri="{FF2B5EF4-FFF2-40B4-BE49-F238E27FC236}">
                    <a16:creationId xmlns:a16="http://schemas.microsoft.com/office/drawing/2014/main" id="{3AF2C85D-8352-B615-3E32-5FDDECFBF2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237538" y="4640263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hu-HU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0</a:t>
                </a:r>
                <a:endParaRPr kumimoji="0" lang="en-US" altLang="hu-HU" sz="2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7" name="Rectangle 1075">
                <a:extLst>
                  <a:ext uri="{FF2B5EF4-FFF2-40B4-BE49-F238E27FC236}">
                    <a16:creationId xmlns:a16="http://schemas.microsoft.com/office/drawing/2014/main" id="{F3ABD93E-D63C-37CC-6645-ECF1045FFB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86738" y="4224338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hu-HU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0</a:t>
                </a:r>
                <a:endParaRPr kumimoji="0" lang="en-US" altLang="hu-HU" sz="2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8" name="Line 1076">
                <a:extLst>
                  <a:ext uri="{FF2B5EF4-FFF2-40B4-BE49-F238E27FC236}">
                    <a16:creationId xmlns:a16="http://schemas.microsoft.com/office/drawing/2014/main" id="{66815580-F91F-1617-53D1-CF722326F8D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651875" y="6361113"/>
                <a:ext cx="0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49" name="Line 1077">
                <a:extLst>
                  <a:ext uri="{FF2B5EF4-FFF2-40B4-BE49-F238E27FC236}">
                    <a16:creationId xmlns:a16="http://schemas.microsoft.com/office/drawing/2014/main" id="{9FE70DC0-A7C8-304D-4720-4F76D0235F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032083" y="6361113"/>
                <a:ext cx="0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50" name="Line 1082">
                <a:extLst>
                  <a:ext uri="{FF2B5EF4-FFF2-40B4-BE49-F238E27FC236}">
                    <a16:creationId xmlns:a16="http://schemas.microsoft.com/office/drawing/2014/main" id="{7AEE2A79-428F-07A1-55BC-8A7AA2D199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416925" y="6361113"/>
                <a:ext cx="2830513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51" name="Line 1083">
                <a:extLst>
                  <a:ext uri="{FF2B5EF4-FFF2-40B4-BE49-F238E27FC236}">
                    <a16:creationId xmlns:a16="http://schemas.microsoft.com/office/drawing/2014/main" id="{1DE016FA-76ED-B672-2DBD-302012825F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374063" y="6361113"/>
                <a:ext cx="42863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52" name="Line 1084">
                <a:extLst>
                  <a:ext uri="{FF2B5EF4-FFF2-40B4-BE49-F238E27FC236}">
                    <a16:creationId xmlns:a16="http://schemas.microsoft.com/office/drawing/2014/main" id="{AAA2DC09-37C1-00B1-DFC3-26393DC57D8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374063" y="5945188"/>
                <a:ext cx="42863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53" name="Line 1085">
                <a:extLst>
                  <a:ext uri="{FF2B5EF4-FFF2-40B4-BE49-F238E27FC236}">
                    <a16:creationId xmlns:a16="http://schemas.microsoft.com/office/drawing/2014/main" id="{02280BE0-47C5-CCFA-C55E-E2F478F011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374063" y="5530850"/>
                <a:ext cx="42863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54" name="Line 1086">
                <a:extLst>
                  <a:ext uri="{FF2B5EF4-FFF2-40B4-BE49-F238E27FC236}">
                    <a16:creationId xmlns:a16="http://schemas.microsoft.com/office/drawing/2014/main" id="{D8A4E752-C87A-0E88-EBE1-946E0637520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374063" y="5114925"/>
                <a:ext cx="42863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55" name="Line 1087">
                <a:extLst>
                  <a:ext uri="{FF2B5EF4-FFF2-40B4-BE49-F238E27FC236}">
                    <a16:creationId xmlns:a16="http://schemas.microsoft.com/office/drawing/2014/main" id="{108CBFAD-7F69-FC2E-3377-0C61A34BD3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374063" y="4699000"/>
                <a:ext cx="42863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56" name="Line 1088">
                <a:extLst>
                  <a:ext uri="{FF2B5EF4-FFF2-40B4-BE49-F238E27FC236}">
                    <a16:creationId xmlns:a16="http://schemas.microsoft.com/office/drawing/2014/main" id="{64EDAE35-2D89-5365-FE60-B46F738487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374063" y="4284663"/>
                <a:ext cx="42863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57" name="Line 1089">
                <a:extLst>
                  <a:ext uri="{FF2B5EF4-FFF2-40B4-BE49-F238E27FC236}">
                    <a16:creationId xmlns:a16="http://schemas.microsoft.com/office/drawing/2014/main" id="{736E3AD3-4A33-2057-33F7-82D9660F74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416925" y="4284663"/>
                <a:ext cx="0" cy="207645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58" name="Rectangle 1090">
                <a:extLst>
                  <a:ext uri="{FF2B5EF4-FFF2-40B4-BE49-F238E27FC236}">
                    <a16:creationId xmlns:a16="http://schemas.microsoft.com/office/drawing/2014/main" id="{FAD07B6C-8E89-6501-E7CF-40D62DB0740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6973386" y="5154467"/>
                <a:ext cx="2059114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hu-HU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D69</a:t>
                </a:r>
                <a:r>
                  <a:rPr kumimoji="0" lang="en-US" altLang="hu-HU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expression by NKbright cells (%)</a:t>
                </a:r>
                <a:endParaRPr kumimoji="0" lang="en-US" altLang="hu-HU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9" name="Oval 944">
                <a:extLst>
                  <a:ext uri="{FF2B5EF4-FFF2-40B4-BE49-F238E27FC236}">
                    <a16:creationId xmlns:a16="http://schemas.microsoft.com/office/drawing/2014/main" id="{23D940FD-0D1C-DA12-42D3-446B7C6048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017796" y="5797550"/>
                <a:ext cx="26988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60" name="Oval 947">
                <a:extLst>
                  <a:ext uri="{FF2B5EF4-FFF2-40B4-BE49-F238E27FC236}">
                    <a16:creationId xmlns:a16="http://schemas.microsoft.com/office/drawing/2014/main" id="{81B6FF82-B143-E91A-3C27-3E981F1AC2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063833" y="4489450"/>
                <a:ext cx="28575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61" name="Oval 948">
                <a:extLst>
                  <a:ext uri="{FF2B5EF4-FFF2-40B4-BE49-F238E27FC236}">
                    <a16:creationId xmlns:a16="http://schemas.microsoft.com/office/drawing/2014/main" id="{1BAEA5D6-8420-A354-DB59-8A49E9040E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063833" y="4424363"/>
                <a:ext cx="28575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62" name="Oval 949">
                <a:extLst>
                  <a:ext uri="{FF2B5EF4-FFF2-40B4-BE49-F238E27FC236}">
                    <a16:creationId xmlns:a16="http://schemas.microsoft.com/office/drawing/2014/main" id="{D76634A2-4FB1-1F6F-AA25-CE6C00A888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063833" y="5175250"/>
                <a:ext cx="28575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63" name="Oval 950">
                <a:extLst>
                  <a:ext uri="{FF2B5EF4-FFF2-40B4-BE49-F238E27FC236}">
                    <a16:creationId xmlns:a16="http://schemas.microsoft.com/office/drawing/2014/main" id="{1B396184-5D83-D43F-A48D-BA05E3804BA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017796" y="4724400"/>
                <a:ext cx="26988" cy="28575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64" name="Oval 951">
                <a:extLst>
                  <a:ext uri="{FF2B5EF4-FFF2-40B4-BE49-F238E27FC236}">
                    <a16:creationId xmlns:a16="http://schemas.microsoft.com/office/drawing/2014/main" id="{EB00AE8B-334C-FB8E-5EB4-50DA1648F7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970171" y="5116513"/>
                <a:ext cx="26988" cy="28575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65" name="Oval 952">
                <a:extLst>
                  <a:ext uri="{FF2B5EF4-FFF2-40B4-BE49-F238E27FC236}">
                    <a16:creationId xmlns:a16="http://schemas.microsoft.com/office/drawing/2014/main" id="{80C28AEA-5454-498E-13FE-71E2668CDD5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159083" y="5199063"/>
                <a:ext cx="26988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66" name="Oval 953">
                <a:extLst>
                  <a:ext uri="{FF2B5EF4-FFF2-40B4-BE49-F238E27FC236}">
                    <a16:creationId xmlns:a16="http://schemas.microsoft.com/office/drawing/2014/main" id="{0E731B21-589F-D301-9EE3-60B5BB8EEE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063833" y="5689600"/>
                <a:ext cx="28575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67" name="Oval 954">
                <a:extLst>
                  <a:ext uri="{FF2B5EF4-FFF2-40B4-BE49-F238E27FC236}">
                    <a16:creationId xmlns:a16="http://schemas.microsoft.com/office/drawing/2014/main" id="{D9A8C3F3-D2C8-532B-225C-6521258F955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970171" y="5537200"/>
                <a:ext cx="26988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68" name="Oval 955">
                <a:extLst>
                  <a:ext uri="{FF2B5EF4-FFF2-40B4-BE49-F238E27FC236}">
                    <a16:creationId xmlns:a16="http://schemas.microsoft.com/office/drawing/2014/main" id="{602CA0C0-4862-7835-3ED6-BFEC89FA93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970171" y="4657725"/>
                <a:ext cx="26988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69" name="Oval 956">
                <a:extLst>
                  <a:ext uri="{FF2B5EF4-FFF2-40B4-BE49-F238E27FC236}">
                    <a16:creationId xmlns:a16="http://schemas.microsoft.com/office/drawing/2014/main" id="{BA09BF78-AC23-D22C-1783-4374EB3BEEF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874921" y="5226050"/>
                <a:ext cx="28575" cy="28575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70" name="Oval 957">
                <a:extLst>
                  <a:ext uri="{FF2B5EF4-FFF2-40B4-BE49-F238E27FC236}">
                    <a16:creationId xmlns:a16="http://schemas.microsoft.com/office/drawing/2014/main" id="{2A63FA23-7319-E990-CBC4-17F4C3F7697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970171" y="4445000"/>
                <a:ext cx="26988" cy="26987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71" name="Line 959">
                <a:extLst>
                  <a:ext uri="{FF2B5EF4-FFF2-40B4-BE49-F238E27FC236}">
                    <a16:creationId xmlns:a16="http://schemas.microsoft.com/office/drawing/2014/main" id="{DE8B1EAC-B37D-FB0C-2BD3-77A684CAB16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843171" y="5703888"/>
                <a:ext cx="0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72" name="Line 960">
                <a:extLst>
                  <a:ext uri="{FF2B5EF4-FFF2-40B4-BE49-F238E27FC236}">
                    <a16:creationId xmlns:a16="http://schemas.microsoft.com/office/drawing/2014/main" id="{22B10CAB-89DD-A4D5-3860-B21132B8DE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8843171" y="5200650"/>
                <a:ext cx="376238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73" name="Line 961">
                <a:extLst>
                  <a:ext uri="{FF2B5EF4-FFF2-40B4-BE49-F238E27FC236}">
                    <a16:creationId xmlns:a16="http://schemas.microsoft.com/office/drawing/2014/main" id="{98BA17F7-7539-6BFD-0FE2-12D6DEE82E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032083" y="4672013"/>
                <a:ext cx="0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74" name="Line 962">
                <a:extLst>
                  <a:ext uri="{FF2B5EF4-FFF2-40B4-BE49-F238E27FC236}">
                    <a16:creationId xmlns:a16="http://schemas.microsoft.com/office/drawing/2014/main" id="{5ACE7A25-97D7-337E-62E4-56B0255815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032083" y="5703888"/>
                <a:ext cx="0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75" name="Line 963">
                <a:extLst>
                  <a:ext uri="{FF2B5EF4-FFF2-40B4-BE49-F238E27FC236}">
                    <a16:creationId xmlns:a16="http://schemas.microsoft.com/office/drawing/2014/main" id="{5622E51F-5D60-9421-88BC-6BE8C46EDD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9032083" y="4438650"/>
                <a:ext cx="0" cy="233362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76" name="Line 965">
                <a:extLst>
                  <a:ext uri="{FF2B5EF4-FFF2-40B4-BE49-F238E27FC236}">
                    <a16:creationId xmlns:a16="http://schemas.microsoft.com/office/drawing/2014/main" id="{C385A965-39B1-7B7B-D9F5-AD4DF58DEAB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9008271" y="4438650"/>
                <a:ext cx="46038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77" name="Rectangle 967">
                <a:extLst>
                  <a:ext uri="{FF2B5EF4-FFF2-40B4-BE49-F238E27FC236}">
                    <a16:creationId xmlns:a16="http://schemas.microsoft.com/office/drawing/2014/main" id="{6285F1BE-E644-7021-2B30-B00FFBF8705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019383" y="5199063"/>
                <a:ext cx="23813" cy="23812"/>
              </a:xfrm>
              <a:prstGeom prst="rect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78" name="Szövegdoboz 277">
                <a:extLst>
                  <a:ext uri="{FF2B5EF4-FFF2-40B4-BE49-F238E27FC236}">
                    <a16:creationId xmlns:a16="http://schemas.microsoft.com/office/drawing/2014/main" id="{96C69015-4F84-DB1C-6B4D-578D9117F5F5}"/>
                  </a:ext>
                </a:extLst>
              </p:cNvPr>
              <p:cNvSpPr txBox="1"/>
              <p:nvPr/>
            </p:nvSpPr>
            <p:spPr>
              <a:xfrm>
                <a:off x="8322260" y="6360342"/>
                <a:ext cx="1027484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Healthy control</a:t>
                </a:r>
                <a:r>
                  <a:rPr lang="hu-HU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9" name="Line 175">
                <a:extLst>
                  <a:ext uri="{FF2B5EF4-FFF2-40B4-BE49-F238E27FC236}">
                    <a16:creationId xmlns:a16="http://schemas.microsoft.com/office/drawing/2014/main" id="{BD3DD85B-8CC5-A3A0-1730-CC85B71E157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659818" y="4168327"/>
                <a:ext cx="382275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80" name="Szövegdoboz 279">
                <a:extLst>
                  <a:ext uri="{FF2B5EF4-FFF2-40B4-BE49-F238E27FC236}">
                    <a16:creationId xmlns:a16="http://schemas.microsoft.com/office/drawing/2014/main" id="{8C9036A8-F2FF-8BA4-31C7-01B27AAC5799}"/>
                  </a:ext>
                </a:extLst>
              </p:cNvPr>
              <p:cNvSpPr txBox="1"/>
              <p:nvPr/>
            </p:nvSpPr>
            <p:spPr>
              <a:xfrm>
                <a:off x="8602989" y="3933750"/>
                <a:ext cx="47783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*</a:t>
                </a:r>
              </a:p>
            </p:txBody>
          </p:sp>
          <p:grpSp>
            <p:nvGrpSpPr>
              <p:cNvPr id="281" name="Csoportba foglalás 280">
                <a:extLst>
                  <a:ext uri="{FF2B5EF4-FFF2-40B4-BE49-F238E27FC236}">
                    <a16:creationId xmlns:a16="http://schemas.microsoft.com/office/drawing/2014/main" id="{C85BFA8A-4369-E48E-D3EB-011CA4222CC4}"/>
                  </a:ext>
                </a:extLst>
              </p:cNvPr>
              <p:cNvGrpSpPr/>
              <p:nvPr/>
            </p:nvGrpSpPr>
            <p:grpSpPr>
              <a:xfrm>
                <a:off x="10208622" y="3969945"/>
                <a:ext cx="1027484" cy="2821840"/>
                <a:chOff x="9263709" y="3969945"/>
                <a:chExt cx="1027484" cy="2821840"/>
              </a:xfrm>
            </p:grpSpPr>
            <p:sp>
              <p:nvSpPr>
                <p:cNvPr id="344" name="Oval 968">
                  <a:extLst>
                    <a:ext uri="{FF2B5EF4-FFF2-40B4-BE49-F238E27FC236}">
                      <a16:creationId xmlns:a16="http://schemas.microsoft.com/office/drawing/2014/main" id="{391F2037-1EDA-B4BD-FB24-9BF26EBE4FB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575800" y="4962525"/>
                  <a:ext cx="26988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45" name="Oval 969">
                  <a:extLst>
                    <a:ext uri="{FF2B5EF4-FFF2-40B4-BE49-F238E27FC236}">
                      <a16:creationId xmlns:a16="http://schemas.microsoft.com/office/drawing/2014/main" id="{B34D25A4-6FB2-D5DF-2B39-6305EAFDA1F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575800" y="4732338"/>
                  <a:ext cx="26988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46" name="Oval 970">
                  <a:extLst>
                    <a:ext uri="{FF2B5EF4-FFF2-40B4-BE49-F238E27FC236}">
                      <a16:creationId xmlns:a16="http://schemas.microsoft.com/office/drawing/2014/main" id="{2C70094C-16EA-6A55-55E3-66DE0552E63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575800" y="4368800"/>
                  <a:ext cx="26988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47" name="Oval 971">
                  <a:extLst>
                    <a:ext uri="{FF2B5EF4-FFF2-40B4-BE49-F238E27FC236}">
                      <a16:creationId xmlns:a16="http://schemas.microsoft.com/office/drawing/2014/main" id="{45EA4412-038B-A685-539B-66E5870FFFD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613900" y="4270375"/>
                  <a:ext cx="26988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48" name="Oval 972">
                  <a:extLst>
                    <a:ext uri="{FF2B5EF4-FFF2-40B4-BE49-F238E27FC236}">
                      <a16:creationId xmlns:a16="http://schemas.microsoft.com/office/drawing/2014/main" id="{0CC67041-4D82-CE6F-98B2-88F5454BD9E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613900" y="4500563"/>
                  <a:ext cx="26988" cy="28575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49" name="Oval 973">
                  <a:extLst>
                    <a:ext uri="{FF2B5EF4-FFF2-40B4-BE49-F238E27FC236}">
                      <a16:creationId xmlns:a16="http://schemas.microsoft.com/office/drawing/2014/main" id="{DD667E56-BC60-1EC1-7330-4D64CB8B9FE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537700" y="4622800"/>
                  <a:ext cx="26988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50" name="Oval 974">
                  <a:extLst>
                    <a:ext uri="{FF2B5EF4-FFF2-40B4-BE49-F238E27FC236}">
                      <a16:creationId xmlns:a16="http://schemas.microsoft.com/office/drawing/2014/main" id="{6C5FF75F-272F-952E-0425-5CE59C81581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688513" y="4532313"/>
                  <a:ext cx="28575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51" name="Oval 976">
                  <a:extLst>
                    <a:ext uri="{FF2B5EF4-FFF2-40B4-BE49-F238E27FC236}">
                      <a16:creationId xmlns:a16="http://schemas.microsoft.com/office/drawing/2014/main" id="{2E798062-2806-BE40-FB71-175F9F00989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499600" y="4430713"/>
                  <a:ext cx="28575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52" name="Oval 977">
                  <a:extLst>
                    <a:ext uri="{FF2B5EF4-FFF2-40B4-BE49-F238E27FC236}">
                      <a16:creationId xmlns:a16="http://schemas.microsoft.com/office/drawing/2014/main" id="{637077EF-0DFF-52D1-3E10-7B8FE6CECAE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537700" y="4270375"/>
                  <a:ext cx="26988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53" name="Oval 978">
                  <a:extLst>
                    <a:ext uri="{FF2B5EF4-FFF2-40B4-BE49-F238E27FC236}">
                      <a16:creationId xmlns:a16="http://schemas.microsoft.com/office/drawing/2014/main" id="{D00F48E6-68E0-C20A-7EF9-118D3D28D84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650413" y="4425950"/>
                  <a:ext cx="28575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54" name="Oval 980">
                  <a:extLst>
                    <a:ext uri="{FF2B5EF4-FFF2-40B4-BE49-F238E27FC236}">
                      <a16:creationId xmlns:a16="http://schemas.microsoft.com/office/drawing/2014/main" id="{949DC083-A007-99E3-D9BB-F7255A9097A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726613" y="4478338"/>
                  <a:ext cx="26988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55" name="Freeform 981">
                  <a:extLst>
                    <a:ext uri="{FF2B5EF4-FFF2-40B4-BE49-F238E27FC236}">
                      <a16:creationId xmlns:a16="http://schemas.microsoft.com/office/drawing/2014/main" id="{816CEE7B-6AE7-3FDE-1826-A66695954E3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9401175" y="4383088"/>
                  <a:ext cx="377825" cy="163512"/>
                </a:xfrm>
                <a:custGeom>
                  <a:avLst/>
                  <a:gdLst>
                    <a:gd name="T0" fmla="*/ 0 w 238"/>
                    <a:gd name="T1" fmla="*/ 103 h 103"/>
                    <a:gd name="T2" fmla="*/ 238 w 238"/>
                    <a:gd name="T3" fmla="*/ 103 h 103"/>
                    <a:gd name="T4" fmla="*/ 238 w 238"/>
                    <a:gd name="T5" fmla="*/ 103 h 103"/>
                    <a:gd name="T6" fmla="*/ 238 w 238"/>
                    <a:gd name="T7" fmla="*/ 69 h 103"/>
                    <a:gd name="T8" fmla="*/ 238 w 238"/>
                    <a:gd name="T9" fmla="*/ 0 h 103"/>
                    <a:gd name="T10" fmla="*/ 238 w 238"/>
                    <a:gd name="T11" fmla="*/ 0 h 103"/>
                    <a:gd name="T12" fmla="*/ 0 w 238"/>
                    <a:gd name="T13" fmla="*/ 0 h 103"/>
                    <a:gd name="T14" fmla="*/ 0 w 238"/>
                    <a:gd name="T15" fmla="*/ 0 h 103"/>
                    <a:gd name="T16" fmla="*/ 0 w 238"/>
                    <a:gd name="T17" fmla="*/ 69 h 103"/>
                    <a:gd name="T18" fmla="*/ 0 w 238"/>
                    <a:gd name="T19" fmla="*/ 103 h 10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238" h="103">
                      <a:moveTo>
                        <a:pt x="0" y="103"/>
                      </a:moveTo>
                      <a:lnTo>
                        <a:pt x="238" y="103"/>
                      </a:lnTo>
                      <a:lnTo>
                        <a:pt x="238" y="103"/>
                      </a:lnTo>
                      <a:lnTo>
                        <a:pt x="238" y="69"/>
                      </a:lnTo>
                      <a:lnTo>
                        <a:pt x="238" y="0"/>
                      </a:lnTo>
                      <a:lnTo>
                        <a:pt x="238" y="0"/>
                      </a:ln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0" y="69"/>
                      </a:lnTo>
                      <a:lnTo>
                        <a:pt x="0" y="103"/>
                      </a:lnTo>
                    </a:path>
                  </a:pathLst>
                </a:cu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56" name="Line 983">
                  <a:extLst>
                    <a:ext uri="{FF2B5EF4-FFF2-40B4-BE49-F238E27FC236}">
                      <a16:creationId xmlns:a16="http://schemas.microsoft.com/office/drawing/2014/main" id="{3D68105F-E454-6F6B-D1DE-EEFF453DBF8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9401175" y="4492625"/>
                  <a:ext cx="377825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57" name="Line 984">
                  <a:extLst>
                    <a:ext uri="{FF2B5EF4-FFF2-40B4-BE49-F238E27FC236}">
                      <a16:creationId xmlns:a16="http://schemas.microsoft.com/office/drawing/2014/main" id="{3AEB00B9-E008-1FC4-0F91-2005C1F9F8A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9590088" y="4383088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58" name="Line 985">
                  <a:extLst>
                    <a:ext uri="{FF2B5EF4-FFF2-40B4-BE49-F238E27FC236}">
                      <a16:creationId xmlns:a16="http://schemas.microsoft.com/office/drawing/2014/main" id="{15C8320F-E8D5-2CF4-4C77-84C6C1DBFD4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9590088" y="4546600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59" name="Line 986">
                  <a:extLst>
                    <a:ext uri="{FF2B5EF4-FFF2-40B4-BE49-F238E27FC236}">
                      <a16:creationId xmlns:a16="http://schemas.microsoft.com/office/drawing/2014/main" id="{E62F0260-B087-BF41-122C-BCFBF1654D9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9590088" y="4284663"/>
                  <a:ext cx="0" cy="98425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60" name="Line 987">
                  <a:extLst>
                    <a:ext uri="{FF2B5EF4-FFF2-40B4-BE49-F238E27FC236}">
                      <a16:creationId xmlns:a16="http://schemas.microsoft.com/office/drawing/2014/main" id="{EF66A7E4-D8AF-C12B-85DF-6224408D424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9590088" y="4546600"/>
                  <a:ext cx="0" cy="200025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61" name="Line 988">
                  <a:extLst>
                    <a:ext uri="{FF2B5EF4-FFF2-40B4-BE49-F238E27FC236}">
                      <a16:creationId xmlns:a16="http://schemas.microsoft.com/office/drawing/2014/main" id="{23E71A89-35B5-F815-60EF-6F16822CA57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9566275" y="4284663"/>
                  <a:ext cx="47625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62" name="Line 989">
                  <a:extLst>
                    <a:ext uri="{FF2B5EF4-FFF2-40B4-BE49-F238E27FC236}">
                      <a16:creationId xmlns:a16="http://schemas.microsoft.com/office/drawing/2014/main" id="{9252E37E-E980-1BC0-43AE-986301779ED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9566275" y="4746625"/>
                  <a:ext cx="47625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63" name="Rectangle 990">
                  <a:extLst>
                    <a:ext uri="{FF2B5EF4-FFF2-40B4-BE49-F238E27FC236}">
                      <a16:creationId xmlns:a16="http://schemas.microsoft.com/office/drawing/2014/main" id="{FF99294A-B216-73CE-39F2-0BB70FD074F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577388" y="4495800"/>
                  <a:ext cx="23813" cy="23812"/>
                </a:xfrm>
                <a:prstGeom prst="rect">
                  <a:avLst/>
                </a:prstGeom>
                <a:noFill/>
                <a:ln w="1588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64" name="Oval 996">
                  <a:extLst>
                    <a:ext uri="{FF2B5EF4-FFF2-40B4-BE49-F238E27FC236}">
                      <a16:creationId xmlns:a16="http://schemas.microsoft.com/office/drawing/2014/main" id="{3FFBB3C6-BC41-36D3-95EE-B3D81C8EB28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999673" y="5654675"/>
                  <a:ext cx="26988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65" name="Oval 999">
                  <a:extLst>
                    <a:ext uri="{FF2B5EF4-FFF2-40B4-BE49-F238E27FC236}">
                      <a16:creationId xmlns:a16="http://schemas.microsoft.com/office/drawing/2014/main" id="{7AFEBB42-AEA1-9EC7-6A11-790B84661FD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904423" y="5654675"/>
                  <a:ext cx="28575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66" name="Oval 1000">
                  <a:extLst>
                    <a:ext uri="{FF2B5EF4-FFF2-40B4-BE49-F238E27FC236}">
                      <a16:creationId xmlns:a16="http://schemas.microsoft.com/office/drawing/2014/main" id="{253BDFE5-6664-6AA5-7EBA-600E7621AD4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952048" y="4456113"/>
                  <a:ext cx="26988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67" name="Oval 1003">
                  <a:extLst>
                    <a:ext uri="{FF2B5EF4-FFF2-40B4-BE49-F238E27FC236}">
                      <a16:creationId xmlns:a16="http://schemas.microsoft.com/office/drawing/2014/main" id="{55E39D8C-A641-7182-89ED-C3374453C15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952048" y="4270375"/>
                  <a:ext cx="26988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68" name="Freeform 1004">
                  <a:extLst>
                    <a:ext uri="{FF2B5EF4-FFF2-40B4-BE49-F238E27FC236}">
                      <a16:creationId xmlns:a16="http://schemas.microsoft.com/office/drawing/2014/main" id="{99F2F281-99A5-ED60-FFF3-7536F9E8692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9777423" y="4824413"/>
                  <a:ext cx="377825" cy="482600"/>
                </a:xfrm>
                <a:custGeom>
                  <a:avLst/>
                  <a:gdLst>
                    <a:gd name="T0" fmla="*/ 0 w 238"/>
                    <a:gd name="T1" fmla="*/ 304 h 304"/>
                    <a:gd name="T2" fmla="*/ 238 w 238"/>
                    <a:gd name="T3" fmla="*/ 304 h 304"/>
                    <a:gd name="T4" fmla="*/ 238 w 238"/>
                    <a:gd name="T5" fmla="*/ 304 h 304"/>
                    <a:gd name="T6" fmla="*/ 238 w 238"/>
                    <a:gd name="T7" fmla="*/ 183 h 304"/>
                    <a:gd name="T8" fmla="*/ 238 w 238"/>
                    <a:gd name="T9" fmla="*/ 0 h 304"/>
                    <a:gd name="T10" fmla="*/ 238 w 238"/>
                    <a:gd name="T11" fmla="*/ 0 h 304"/>
                    <a:gd name="T12" fmla="*/ 0 w 238"/>
                    <a:gd name="T13" fmla="*/ 0 h 304"/>
                    <a:gd name="T14" fmla="*/ 0 w 238"/>
                    <a:gd name="T15" fmla="*/ 0 h 304"/>
                    <a:gd name="T16" fmla="*/ 0 w 238"/>
                    <a:gd name="T17" fmla="*/ 183 h 304"/>
                    <a:gd name="T18" fmla="*/ 0 w 238"/>
                    <a:gd name="T19" fmla="*/ 304 h 30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238" h="304">
                      <a:moveTo>
                        <a:pt x="0" y="304"/>
                      </a:moveTo>
                      <a:lnTo>
                        <a:pt x="238" y="304"/>
                      </a:lnTo>
                      <a:lnTo>
                        <a:pt x="238" y="304"/>
                      </a:lnTo>
                      <a:lnTo>
                        <a:pt x="238" y="183"/>
                      </a:lnTo>
                      <a:lnTo>
                        <a:pt x="238" y="0"/>
                      </a:lnTo>
                      <a:lnTo>
                        <a:pt x="238" y="0"/>
                      </a:ln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0" y="183"/>
                      </a:lnTo>
                      <a:lnTo>
                        <a:pt x="0" y="304"/>
                      </a:lnTo>
                    </a:path>
                  </a:pathLst>
                </a:custGeom>
                <a:pattFill prst="pct25">
                  <a:fgClr>
                    <a:srgbClr val="FF0000"/>
                  </a:fgClr>
                  <a:bgClr>
                    <a:schemeClr val="bg1"/>
                  </a:bgClr>
                </a:pattFill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69" name="Line 1009">
                  <a:extLst>
                    <a:ext uri="{FF2B5EF4-FFF2-40B4-BE49-F238E27FC236}">
                      <a16:creationId xmlns:a16="http://schemas.microsoft.com/office/drawing/2014/main" id="{59FCFFB8-E781-B368-69A5-0A12D878741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9966335" y="4284663"/>
                  <a:ext cx="0" cy="53975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70" name="Line 1010">
                  <a:extLst>
                    <a:ext uri="{FF2B5EF4-FFF2-40B4-BE49-F238E27FC236}">
                      <a16:creationId xmlns:a16="http://schemas.microsoft.com/office/drawing/2014/main" id="{6F2396B2-1B49-03A3-A80F-5E140D1905C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9966335" y="5307013"/>
                  <a:ext cx="0" cy="36195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71" name="Line 1011">
                  <a:extLst>
                    <a:ext uri="{FF2B5EF4-FFF2-40B4-BE49-F238E27FC236}">
                      <a16:creationId xmlns:a16="http://schemas.microsoft.com/office/drawing/2014/main" id="{2BE16184-671A-4333-258D-5D13F7969F9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9942523" y="4284663"/>
                  <a:ext cx="47625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72" name="Line 1012">
                  <a:extLst>
                    <a:ext uri="{FF2B5EF4-FFF2-40B4-BE49-F238E27FC236}">
                      <a16:creationId xmlns:a16="http://schemas.microsoft.com/office/drawing/2014/main" id="{9590218A-8E4B-4218-8DF5-89F6C4BBA3A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9942523" y="5668963"/>
                  <a:ext cx="47625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73" name="Line 1078">
                  <a:extLst>
                    <a:ext uri="{FF2B5EF4-FFF2-40B4-BE49-F238E27FC236}">
                      <a16:creationId xmlns:a16="http://schemas.microsoft.com/office/drawing/2014/main" id="{176DB09A-4827-3522-A6CB-D2EEDF7C5A4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9596438" y="6361113"/>
                  <a:ext cx="0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74" name="Line 1079">
                  <a:extLst>
                    <a:ext uri="{FF2B5EF4-FFF2-40B4-BE49-F238E27FC236}">
                      <a16:creationId xmlns:a16="http://schemas.microsoft.com/office/drawing/2014/main" id="{AD407F89-150E-255C-439F-30284CC1EDF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0067925" y="6361113"/>
                  <a:ext cx="0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75" name="Oval 975">
                  <a:extLst>
                    <a:ext uri="{FF2B5EF4-FFF2-40B4-BE49-F238E27FC236}">
                      <a16:creationId xmlns:a16="http://schemas.microsoft.com/office/drawing/2014/main" id="{F10793FF-441F-F6C4-A388-15FEDC327E7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463088" y="4524375"/>
                  <a:ext cx="26988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76" name="Oval 979">
                  <a:extLst>
                    <a:ext uri="{FF2B5EF4-FFF2-40B4-BE49-F238E27FC236}">
                      <a16:creationId xmlns:a16="http://schemas.microsoft.com/office/drawing/2014/main" id="{60C8FC3D-4E88-127F-175D-1B4560079F6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424988" y="4297363"/>
                  <a:ext cx="26988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77" name="Line 982">
                  <a:extLst>
                    <a:ext uri="{FF2B5EF4-FFF2-40B4-BE49-F238E27FC236}">
                      <a16:creationId xmlns:a16="http://schemas.microsoft.com/office/drawing/2014/main" id="{51CA0F19-BC05-46AD-08B2-5522CCA2F0F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9401175" y="4546600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78" name="Oval 991">
                  <a:extLst>
                    <a:ext uri="{FF2B5EF4-FFF2-40B4-BE49-F238E27FC236}">
                      <a16:creationId xmlns:a16="http://schemas.microsoft.com/office/drawing/2014/main" id="{538E3CD6-B637-8B33-A4E6-C5EA15C7616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952048" y="5373688"/>
                  <a:ext cx="26988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79" name="Oval 992">
                  <a:extLst>
                    <a:ext uri="{FF2B5EF4-FFF2-40B4-BE49-F238E27FC236}">
                      <a16:creationId xmlns:a16="http://schemas.microsoft.com/office/drawing/2014/main" id="{FBF6A620-CBFD-FAF7-C4F0-8E5165D37D1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999673" y="5294313"/>
                  <a:ext cx="26988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80" name="Oval 993">
                  <a:extLst>
                    <a:ext uri="{FF2B5EF4-FFF2-40B4-BE49-F238E27FC236}">
                      <a16:creationId xmlns:a16="http://schemas.microsoft.com/office/drawing/2014/main" id="{56A9D937-895D-BC77-4CCF-D4AF09D553B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999673" y="5029200"/>
                  <a:ext cx="26988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81" name="Oval 994">
                  <a:extLst>
                    <a:ext uri="{FF2B5EF4-FFF2-40B4-BE49-F238E27FC236}">
                      <a16:creationId xmlns:a16="http://schemas.microsoft.com/office/drawing/2014/main" id="{F0714918-D5EE-BB52-BDE3-55071DB5A15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904423" y="5100638"/>
                  <a:ext cx="28575" cy="28575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82" name="Oval 995">
                  <a:extLst>
                    <a:ext uri="{FF2B5EF4-FFF2-40B4-BE49-F238E27FC236}">
                      <a16:creationId xmlns:a16="http://schemas.microsoft.com/office/drawing/2014/main" id="{E962F5FC-C544-1B20-5ADD-FCF2D3D45C6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093335" y="5100638"/>
                  <a:ext cx="26988" cy="28575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83" name="Oval 997">
                  <a:extLst>
                    <a:ext uri="{FF2B5EF4-FFF2-40B4-BE49-F238E27FC236}">
                      <a16:creationId xmlns:a16="http://schemas.microsoft.com/office/drawing/2014/main" id="{89F09983-0769-6878-30F9-3772E283336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810760" y="4921250"/>
                  <a:ext cx="26988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84" name="Oval 998">
                  <a:extLst>
                    <a:ext uri="{FF2B5EF4-FFF2-40B4-BE49-F238E27FC236}">
                      <a16:creationId xmlns:a16="http://schemas.microsoft.com/office/drawing/2014/main" id="{08F443D2-622F-8BAE-E3DD-067DA191C84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904423" y="5251450"/>
                  <a:ext cx="28575" cy="28575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85" name="Oval 1001">
                  <a:extLst>
                    <a:ext uri="{FF2B5EF4-FFF2-40B4-BE49-F238E27FC236}">
                      <a16:creationId xmlns:a16="http://schemas.microsoft.com/office/drawing/2014/main" id="{F18B21BB-AB96-E630-0B44-8BE309546FB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999673" y="4795838"/>
                  <a:ext cx="26988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86" name="Oval 1002">
                  <a:extLst>
                    <a:ext uri="{FF2B5EF4-FFF2-40B4-BE49-F238E27FC236}">
                      <a16:creationId xmlns:a16="http://schemas.microsoft.com/office/drawing/2014/main" id="{1F893B22-1B17-A1CB-8B23-7AF535823CA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904423" y="4811713"/>
                  <a:ext cx="28575" cy="26987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87" name="Line 1005">
                  <a:extLst>
                    <a:ext uri="{FF2B5EF4-FFF2-40B4-BE49-F238E27FC236}">
                      <a16:creationId xmlns:a16="http://schemas.microsoft.com/office/drawing/2014/main" id="{F5CAF522-223A-2C75-4F01-07A74DC0B3C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9777423" y="5307013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88" name="Line 1006">
                  <a:extLst>
                    <a:ext uri="{FF2B5EF4-FFF2-40B4-BE49-F238E27FC236}">
                      <a16:creationId xmlns:a16="http://schemas.microsoft.com/office/drawing/2014/main" id="{6CF88DBC-B19C-CE2D-1DD7-D2BD6B7BC8E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9777423" y="5114925"/>
                  <a:ext cx="377825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89" name="Line 1007">
                  <a:extLst>
                    <a:ext uri="{FF2B5EF4-FFF2-40B4-BE49-F238E27FC236}">
                      <a16:creationId xmlns:a16="http://schemas.microsoft.com/office/drawing/2014/main" id="{3330F543-1A53-3713-CB8D-4B7F4FD733D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9966335" y="4824413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90" name="Line 1008">
                  <a:extLst>
                    <a:ext uri="{FF2B5EF4-FFF2-40B4-BE49-F238E27FC236}">
                      <a16:creationId xmlns:a16="http://schemas.microsoft.com/office/drawing/2014/main" id="{B43F5DBB-69D4-0405-B49B-FA1C819D21F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9966335" y="5307013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91" name="Rectangle 1013">
                  <a:extLst>
                    <a:ext uri="{FF2B5EF4-FFF2-40B4-BE49-F238E27FC236}">
                      <a16:creationId xmlns:a16="http://schemas.microsoft.com/office/drawing/2014/main" id="{5DB23378-2EB2-FD82-6618-87F1A3630C7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953635" y="5056188"/>
                  <a:ext cx="23813" cy="23812"/>
                </a:xfrm>
                <a:prstGeom prst="rect">
                  <a:avLst/>
                </a:prstGeom>
                <a:noFill/>
                <a:ln w="1588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92" name="Szövegdoboz 391">
                  <a:extLst>
                    <a:ext uri="{FF2B5EF4-FFF2-40B4-BE49-F238E27FC236}">
                      <a16:creationId xmlns:a16="http://schemas.microsoft.com/office/drawing/2014/main" id="{C4F7E0A6-535F-1D6D-AD4F-EF1D970E7A0D}"/>
                    </a:ext>
                  </a:extLst>
                </p:cNvPr>
                <p:cNvSpPr txBox="1"/>
                <p:nvPr/>
              </p:nvSpPr>
              <p:spPr>
                <a:xfrm>
                  <a:off x="9263709" y="6360898"/>
                  <a:ext cx="1027484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hu-HU" sz="11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evere</a:t>
                  </a:r>
                  <a:endParaRPr lang="hu-HU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r>
                    <a:rPr lang="hu-HU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VID-19</a:t>
                  </a:r>
                  <a:endParaRPr 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3" name="Line 175">
                  <a:extLst>
                    <a:ext uri="{FF2B5EF4-FFF2-40B4-BE49-F238E27FC236}">
                      <a16:creationId xmlns:a16="http://schemas.microsoft.com/office/drawing/2014/main" id="{E6E05627-7F15-3B44-827E-664BCCC57B9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9611458" y="4194371"/>
                  <a:ext cx="382275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94" name="Szövegdoboz 393">
                  <a:extLst>
                    <a:ext uri="{FF2B5EF4-FFF2-40B4-BE49-F238E27FC236}">
                      <a16:creationId xmlns:a16="http://schemas.microsoft.com/office/drawing/2014/main" id="{BA679EA2-C451-7116-A716-413A90890AB3}"/>
                    </a:ext>
                  </a:extLst>
                </p:cNvPr>
                <p:cNvSpPr txBox="1"/>
                <p:nvPr/>
              </p:nvSpPr>
              <p:spPr>
                <a:xfrm>
                  <a:off x="9569450" y="3969945"/>
                  <a:ext cx="47783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/>
                    <a:t>**</a:t>
                  </a:r>
                </a:p>
              </p:txBody>
            </p:sp>
          </p:grpSp>
          <p:grpSp>
            <p:nvGrpSpPr>
              <p:cNvPr id="282" name="Csoportba foglalás 281">
                <a:extLst>
                  <a:ext uri="{FF2B5EF4-FFF2-40B4-BE49-F238E27FC236}">
                    <a16:creationId xmlns:a16="http://schemas.microsoft.com/office/drawing/2014/main" id="{FE12DB83-3B4B-4DAD-3EB6-5439FF411078}"/>
                  </a:ext>
                </a:extLst>
              </p:cNvPr>
              <p:cNvGrpSpPr/>
              <p:nvPr/>
            </p:nvGrpSpPr>
            <p:grpSpPr>
              <a:xfrm>
                <a:off x="9275009" y="3918031"/>
                <a:ext cx="1027484" cy="2873765"/>
                <a:chOff x="10206872" y="3918031"/>
                <a:chExt cx="1027484" cy="2873765"/>
              </a:xfrm>
            </p:grpSpPr>
            <p:sp>
              <p:nvSpPr>
                <p:cNvPr id="283" name="Oval 1014">
                  <a:extLst>
                    <a:ext uri="{FF2B5EF4-FFF2-40B4-BE49-F238E27FC236}">
                      <a16:creationId xmlns:a16="http://schemas.microsoft.com/office/drawing/2014/main" id="{EE1D0B41-A4DA-C98D-AE31-C1D14D05B01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533063" y="4594225"/>
                  <a:ext cx="28575" cy="28575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284" name="Oval 1015">
                  <a:extLst>
                    <a:ext uri="{FF2B5EF4-FFF2-40B4-BE49-F238E27FC236}">
                      <a16:creationId xmlns:a16="http://schemas.microsoft.com/office/drawing/2014/main" id="{8B7D0B9B-FA10-E6EE-B7B2-8010F9AF6F5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491788" y="4616450"/>
                  <a:ext cx="26988" cy="28575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285" name="Oval 1016">
                  <a:extLst>
                    <a:ext uri="{FF2B5EF4-FFF2-40B4-BE49-F238E27FC236}">
                      <a16:creationId xmlns:a16="http://schemas.microsoft.com/office/drawing/2014/main" id="{56FA45A7-7B29-583D-6FED-A75FC723129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512425" y="4848225"/>
                  <a:ext cx="28575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286" name="Oval 1017">
                  <a:extLst>
                    <a:ext uri="{FF2B5EF4-FFF2-40B4-BE49-F238E27FC236}">
                      <a16:creationId xmlns:a16="http://schemas.microsoft.com/office/drawing/2014/main" id="{60C0DE56-7CF8-B59B-4939-2677EE01C93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512425" y="4297363"/>
                  <a:ext cx="28575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287" name="Oval 1018">
                  <a:extLst>
                    <a:ext uri="{FF2B5EF4-FFF2-40B4-BE49-F238E27FC236}">
                      <a16:creationId xmlns:a16="http://schemas.microsoft.com/office/drawing/2014/main" id="{74838A8E-A65A-BCED-B59E-A21275F65DF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471150" y="4344988"/>
                  <a:ext cx="26988" cy="28575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288" name="Oval 1019">
                  <a:extLst>
                    <a:ext uri="{FF2B5EF4-FFF2-40B4-BE49-F238E27FC236}">
                      <a16:creationId xmlns:a16="http://schemas.microsoft.com/office/drawing/2014/main" id="{AF2DE7BD-6412-7E34-20B6-A00CD712CF9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553700" y="4365625"/>
                  <a:ext cx="28575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289" name="Oval 1020">
                  <a:extLst>
                    <a:ext uri="{FF2B5EF4-FFF2-40B4-BE49-F238E27FC236}">
                      <a16:creationId xmlns:a16="http://schemas.microsoft.com/office/drawing/2014/main" id="{8BE83331-6047-4EF8-78BC-61B6762A7CA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428288" y="4406900"/>
                  <a:ext cx="28575" cy="28575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290" name="Oval 1021">
                  <a:extLst>
                    <a:ext uri="{FF2B5EF4-FFF2-40B4-BE49-F238E27FC236}">
                      <a16:creationId xmlns:a16="http://schemas.microsoft.com/office/drawing/2014/main" id="{7CA5169B-F07F-CAB6-C3F1-079ACD4AC85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533063" y="4270375"/>
                  <a:ext cx="28575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291" name="Oval 1022">
                  <a:extLst>
                    <a:ext uri="{FF2B5EF4-FFF2-40B4-BE49-F238E27FC236}">
                      <a16:creationId xmlns:a16="http://schemas.microsoft.com/office/drawing/2014/main" id="{43A97288-B0C1-70D8-9D7E-DC3F3DD7097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575925" y="4679950"/>
                  <a:ext cx="26988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292" name="Oval 1023">
                  <a:extLst>
                    <a:ext uri="{FF2B5EF4-FFF2-40B4-BE49-F238E27FC236}">
                      <a16:creationId xmlns:a16="http://schemas.microsoft.com/office/drawing/2014/main" id="{9F40254D-E929-5D03-1074-B980F212EA7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448925" y="4670425"/>
                  <a:ext cx="28575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293" name="Oval 1024">
                  <a:extLst>
                    <a:ext uri="{FF2B5EF4-FFF2-40B4-BE49-F238E27FC236}">
                      <a16:creationId xmlns:a16="http://schemas.microsoft.com/office/drawing/2014/main" id="{5A99A767-A463-47DF-3728-513C14EC5D7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617200" y="4651375"/>
                  <a:ext cx="28575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294" name="Oval 1025">
                  <a:extLst>
                    <a:ext uri="{FF2B5EF4-FFF2-40B4-BE49-F238E27FC236}">
                      <a16:creationId xmlns:a16="http://schemas.microsoft.com/office/drawing/2014/main" id="{96517D70-1F65-C1C8-62E7-2C88A0CF050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596563" y="4367213"/>
                  <a:ext cx="26988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295" name="Oval 1026">
                  <a:extLst>
                    <a:ext uri="{FF2B5EF4-FFF2-40B4-BE49-F238E27FC236}">
                      <a16:creationId xmlns:a16="http://schemas.microsoft.com/office/drawing/2014/main" id="{086D9154-0235-1F7B-A00F-E923339159E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387013" y="4362450"/>
                  <a:ext cx="26988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296" name="Oval 1027">
                  <a:extLst>
                    <a:ext uri="{FF2B5EF4-FFF2-40B4-BE49-F238E27FC236}">
                      <a16:creationId xmlns:a16="http://schemas.microsoft.com/office/drawing/2014/main" id="{615851D8-4C01-6BC7-F650-6A9D8C16196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637838" y="4465638"/>
                  <a:ext cx="28575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297" name="Oval 1028">
                  <a:extLst>
                    <a:ext uri="{FF2B5EF4-FFF2-40B4-BE49-F238E27FC236}">
                      <a16:creationId xmlns:a16="http://schemas.microsoft.com/office/drawing/2014/main" id="{AEC5C237-EADE-2499-9A4C-4F5C4A3AA68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344150" y="4367213"/>
                  <a:ext cx="28575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298" name="Oval 1029">
                  <a:extLst>
                    <a:ext uri="{FF2B5EF4-FFF2-40B4-BE49-F238E27FC236}">
                      <a16:creationId xmlns:a16="http://schemas.microsoft.com/office/drawing/2014/main" id="{52527862-0A92-C1E9-535F-02CDF18DE19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491788" y="4270375"/>
                  <a:ext cx="26988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299" name="Oval 1030">
                  <a:extLst>
                    <a:ext uri="{FF2B5EF4-FFF2-40B4-BE49-F238E27FC236}">
                      <a16:creationId xmlns:a16="http://schemas.microsoft.com/office/drawing/2014/main" id="{7337ADC7-9EC8-D637-09CC-B5C5EEC1CB3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680700" y="4321175"/>
                  <a:ext cx="26988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00" name="Oval 1031">
                  <a:extLst>
                    <a:ext uri="{FF2B5EF4-FFF2-40B4-BE49-F238E27FC236}">
                      <a16:creationId xmlns:a16="http://schemas.microsoft.com/office/drawing/2014/main" id="{95A7C81C-EB64-44B4-0126-4A2A212324A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407650" y="4548188"/>
                  <a:ext cx="26988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01" name="Freeform 1032">
                  <a:extLst>
                    <a:ext uri="{FF2B5EF4-FFF2-40B4-BE49-F238E27FC236}">
                      <a16:creationId xmlns:a16="http://schemas.microsoft.com/office/drawing/2014/main" id="{193AEFF9-320C-57FD-38C6-8FDE97CF281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0337800" y="4359275"/>
                  <a:ext cx="377825" cy="271462"/>
                </a:xfrm>
                <a:custGeom>
                  <a:avLst/>
                  <a:gdLst>
                    <a:gd name="T0" fmla="*/ 0 w 238"/>
                    <a:gd name="T1" fmla="*/ 171 h 171"/>
                    <a:gd name="T2" fmla="*/ 238 w 238"/>
                    <a:gd name="T3" fmla="*/ 171 h 171"/>
                    <a:gd name="T4" fmla="*/ 238 w 238"/>
                    <a:gd name="T5" fmla="*/ 171 h 171"/>
                    <a:gd name="T6" fmla="*/ 238 w 238"/>
                    <a:gd name="T7" fmla="*/ 27 h 171"/>
                    <a:gd name="T8" fmla="*/ 238 w 238"/>
                    <a:gd name="T9" fmla="*/ 0 h 171"/>
                    <a:gd name="T10" fmla="*/ 238 w 238"/>
                    <a:gd name="T11" fmla="*/ 0 h 171"/>
                    <a:gd name="T12" fmla="*/ 0 w 238"/>
                    <a:gd name="T13" fmla="*/ 0 h 171"/>
                    <a:gd name="T14" fmla="*/ 0 w 238"/>
                    <a:gd name="T15" fmla="*/ 0 h 171"/>
                    <a:gd name="T16" fmla="*/ 0 w 238"/>
                    <a:gd name="T17" fmla="*/ 27 h 171"/>
                    <a:gd name="T18" fmla="*/ 0 w 238"/>
                    <a:gd name="T19" fmla="*/ 171 h 17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238" h="171">
                      <a:moveTo>
                        <a:pt x="0" y="171"/>
                      </a:moveTo>
                      <a:lnTo>
                        <a:pt x="238" y="171"/>
                      </a:lnTo>
                      <a:lnTo>
                        <a:pt x="238" y="171"/>
                      </a:lnTo>
                      <a:lnTo>
                        <a:pt x="238" y="27"/>
                      </a:lnTo>
                      <a:lnTo>
                        <a:pt x="238" y="0"/>
                      </a:lnTo>
                      <a:lnTo>
                        <a:pt x="238" y="0"/>
                      </a:ln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0" y="27"/>
                      </a:lnTo>
                      <a:lnTo>
                        <a:pt x="0" y="171"/>
                      </a:lnTo>
                    </a:path>
                  </a:pathLst>
                </a:cu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02" name="Line 1033">
                  <a:extLst>
                    <a:ext uri="{FF2B5EF4-FFF2-40B4-BE49-F238E27FC236}">
                      <a16:creationId xmlns:a16="http://schemas.microsoft.com/office/drawing/2014/main" id="{050EB840-BC43-E434-B156-ADB3BD529C7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0337800" y="4630738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03" name="Line 1034">
                  <a:extLst>
                    <a:ext uri="{FF2B5EF4-FFF2-40B4-BE49-F238E27FC236}">
                      <a16:creationId xmlns:a16="http://schemas.microsoft.com/office/drawing/2014/main" id="{5CE0338F-0908-4E18-6C66-84448C7601D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0337800" y="4402138"/>
                  <a:ext cx="377825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04" name="Line 1035">
                  <a:extLst>
                    <a:ext uri="{FF2B5EF4-FFF2-40B4-BE49-F238E27FC236}">
                      <a16:creationId xmlns:a16="http://schemas.microsoft.com/office/drawing/2014/main" id="{0A820A46-B080-1E28-FDDF-01EC10C3644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0526713" y="4359275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05" name="Line 1036">
                  <a:extLst>
                    <a:ext uri="{FF2B5EF4-FFF2-40B4-BE49-F238E27FC236}">
                      <a16:creationId xmlns:a16="http://schemas.microsoft.com/office/drawing/2014/main" id="{559F0222-2817-7827-7ADA-6569B9FC399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0526713" y="4630738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06" name="Line 1037">
                  <a:extLst>
                    <a:ext uri="{FF2B5EF4-FFF2-40B4-BE49-F238E27FC236}">
                      <a16:creationId xmlns:a16="http://schemas.microsoft.com/office/drawing/2014/main" id="{A857CD36-5AB9-BB35-0026-0A727764192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10526713" y="4284663"/>
                  <a:ext cx="0" cy="74612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07" name="Line 1038">
                  <a:extLst>
                    <a:ext uri="{FF2B5EF4-FFF2-40B4-BE49-F238E27FC236}">
                      <a16:creationId xmlns:a16="http://schemas.microsoft.com/office/drawing/2014/main" id="{1CB2F665-46E1-A327-9AA9-518647B24AD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0526713" y="4630738"/>
                  <a:ext cx="0" cy="230187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08" name="Line 1039">
                  <a:extLst>
                    <a:ext uri="{FF2B5EF4-FFF2-40B4-BE49-F238E27FC236}">
                      <a16:creationId xmlns:a16="http://schemas.microsoft.com/office/drawing/2014/main" id="{43529F9B-3761-2E40-EBD9-76548301FED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0502900" y="4284663"/>
                  <a:ext cx="47625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09" name="Line 1040">
                  <a:extLst>
                    <a:ext uri="{FF2B5EF4-FFF2-40B4-BE49-F238E27FC236}">
                      <a16:creationId xmlns:a16="http://schemas.microsoft.com/office/drawing/2014/main" id="{A0102FFA-A711-16D4-9E81-AA47D961967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0502900" y="4860925"/>
                  <a:ext cx="47625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10" name="Rectangle 1041">
                  <a:extLst>
                    <a:ext uri="{FF2B5EF4-FFF2-40B4-BE49-F238E27FC236}">
                      <a16:creationId xmlns:a16="http://schemas.microsoft.com/office/drawing/2014/main" id="{F5EB5B62-12A5-D7E6-BBDB-E66B12A8A9E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514013" y="4470400"/>
                  <a:ext cx="23813" cy="23812"/>
                </a:xfrm>
                <a:prstGeom prst="rect">
                  <a:avLst/>
                </a:prstGeom>
                <a:noFill/>
                <a:ln w="1588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11" name="Oval 1045">
                  <a:extLst>
                    <a:ext uri="{FF2B5EF4-FFF2-40B4-BE49-F238E27FC236}">
                      <a16:creationId xmlns:a16="http://schemas.microsoft.com/office/drawing/2014/main" id="{CF7962BF-7A7A-03DB-6242-19E5AC87153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888673" y="4606925"/>
                  <a:ext cx="28575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12" name="Oval 1046">
                  <a:extLst>
                    <a:ext uri="{FF2B5EF4-FFF2-40B4-BE49-F238E27FC236}">
                      <a16:creationId xmlns:a16="http://schemas.microsoft.com/office/drawing/2014/main" id="{2152C583-1254-1F30-AA6A-D9A5330950B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814060" y="4616450"/>
                  <a:ext cx="26988" cy="28575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13" name="Oval 1047">
                  <a:extLst>
                    <a:ext uri="{FF2B5EF4-FFF2-40B4-BE49-F238E27FC236}">
                      <a16:creationId xmlns:a16="http://schemas.microsoft.com/office/drawing/2014/main" id="{68B19AF0-C5C0-3EA3-F94A-B95024810AE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888673" y="5654675"/>
                  <a:ext cx="28575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14" name="Oval 1053">
                  <a:extLst>
                    <a:ext uri="{FF2B5EF4-FFF2-40B4-BE49-F238E27FC236}">
                      <a16:creationId xmlns:a16="http://schemas.microsoft.com/office/drawing/2014/main" id="{A795A2E7-B538-94F8-2423-AE1DB6CB6C9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814060" y="5580063"/>
                  <a:ext cx="26988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15" name="Oval 1054">
                  <a:extLst>
                    <a:ext uri="{FF2B5EF4-FFF2-40B4-BE49-F238E27FC236}">
                      <a16:creationId xmlns:a16="http://schemas.microsoft.com/office/drawing/2014/main" id="{C654D25A-7814-85E5-72C6-F4B342A2CB2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964873" y="5724525"/>
                  <a:ext cx="26988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16" name="Oval 1057">
                  <a:extLst>
                    <a:ext uri="{FF2B5EF4-FFF2-40B4-BE49-F238E27FC236}">
                      <a16:creationId xmlns:a16="http://schemas.microsoft.com/office/drawing/2014/main" id="{DEAC152C-EE3B-FA6D-3310-B81118380DA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964873" y="4589463"/>
                  <a:ext cx="26988" cy="28575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17" name="Oval 1058">
                  <a:extLst>
                    <a:ext uri="{FF2B5EF4-FFF2-40B4-BE49-F238E27FC236}">
                      <a16:creationId xmlns:a16="http://schemas.microsoft.com/office/drawing/2014/main" id="{92322FA9-A09A-A97B-F0B6-29D93DB69D3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888673" y="4270375"/>
                  <a:ext cx="28575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18" name="Freeform 1060">
                  <a:extLst>
                    <a:ext uri="{FF2B5EF4-FFF2-40B4-BE49-F238E27FC236}">
                      <a16:creationId xmlns:a16="http://schemas.microsoft.com/office/drawing/2014/main" id="{5B29C26F-5D62-011E-99EE-68C99F70322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0714048" y="4841875"/>
                  <a:ext cx="377825" cy="574675"/>
                </a:xfrm>
                <a:custGeom>
                  <a:avLst/>
                  <a:gdLst>
                    <a:gd name="T0" fmla="*/ 0 w 238"/>
                    <a:gd name="T1" fmla="*/ 362 h 362"/>
                    <a:gd name="T2" fmla="*/ 238 w 238"/>
                    <a:gd name="T3" fmla="*/ 362 h 362"/>
                    <a:gd name="T4" fmla="*/ 238 w 238"/>
                    <a:gd name="T5" fmla="*/ 362 h 362"/>
                    <a:gd name="T6" fmla="*/ 238 w 238"/>
                    <a:gd name="T7" fmla="*/ 127 h 362"/>
                    <a:gd name="T8" fmla="*/ 238 w 238"/>
                    <a:gd name="T9" fmla="*/ 0 h 362"/>
                    <a:gd name="T10" fmla="*/ 238 w 238"/>
                    <a:gd name="T11" fmla="*/ 0 h 362"/>
                    <a:gd name="T12" fmla="*/ 0 w 238"/>
                    <a:gd name="T13" fmla="*/ 0 h 362"/>
                    <a:gd name="T14" fmla="*/ 0 w 238"/>
                    <a:gd name="T15" fmla="*/ 0 h 362"/>
                    <a:gd name="T16" fmla="*/ 0 w 238"/>
                    <a:gd name="T17" fmla="*/ 127 h 362"/>
                    <a:gd name="T18" fmla="*/ 0 w 238"/>
                    <a:gd name="T19" fmla="*/ 362 h 36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238" h="362">
                      <a:moveTo>
                        <a:pt x="0" y="362"/>
                      </a:moveTo>
                      <a:lnTo>
                        <a:pt x="238" y="362"/>
                      </a:lnTo>
                      <a:lnTo>
                        <a:pt x="238" y="362"/>
                      </a:lnTo>
                      <a:lnTo>
                        <a:pt x="238" y="127"/>
                      </a:lnTo>
                      <a:lnTo>
                        <a:pt x="238" y="0"/>
                      </a:lnTo>
                      <a:lnTo>
                        <a:pt x="238" y="0"/>
                      </a:ln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0" y="127"/>
                      </a:lnTo>
                      <a:lnTo>
                        <a:pt x="0" y="362"/>
                      </a:lnTo>
                    </a:path>
                  </a:pathLst>
                </a:custGeom>
                <a:pattFill prst="pct50">
                  <a:fgClr>
                    <a:schemeClr val="accent1"/>
                  </a:fgClr>
                  <a:bgClr>
                    <a:schemeClr val="bg1"/>
                  </a:bgClr>
                </a:pattFill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19" name="Line 1065">
                  <a:extLst>
                    <a:ext uri="{FF2B5EF4-FFF2-40B4-BE49-F238E27FC236}">
                      <a16:creationId xmlns:a16="http://schemas.microsoft.com/office/drawing/2014/main" id="{6612EB70-C34E-C17E-D6FB-C0584FF66F3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10902960" y="4284663"/>
                  <a:ext cx="0" cy="557212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20" name="Line 1066">
                  <a:extLst>
                    <a:ext uri="{FF2B5EF4-FFF2-40B4-BE49-F238E27FC236}">
                      <a16:creationId xmlns:a16="http://schemas.microsoft.com/office/drawing/2014/main" id="{D8087252-2357-A898-7F92-3C5B40399BA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0902960" y="5416550"/>
                  <a:ext cx="0" cy="320675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21" name="Line 1067">
                  <a:extLst>
                    <a:ext uri="{FF2B5EF4-FFF2-40B4-BE49-F238E27FC236}">
                      <a16:creationId xmlns:a16="http://schemas.microsoft.com/office/drawing/2014/main" id="{A22A692C-170A-0CE4-E0B2-C99A4309A6E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0879148" y="4284663"/>
                  <a:ext cx="47625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22" name="Line 1068">
                  <a:extLst>
                    <a:ext uri="{FF2B5EF4-FFF2-40B4-BE49-F238E27FC236}">
                      <a16:creationId xmlns:a16="http://schemas.microsoft.com/office/drawing/2014/main" id="{DB764701-BABE-10E3-F0BF-4566F5D34C9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0879148" y="5737225"/>
                  <a:ext cx="47625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23" name="Line 1080">
                  <a:extLst>
                    <a:ext uri="{FF2B5EF4-FFF2-40B4-BE49-F238E27FC236}">
                      <a16:creationId xmlns:a16="http://schemas.microsoft.com/office/drawing/2014/main" id="{FC919F32-EF4F-A40E-7F6C-A83F3B1DFCE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0539413" y="6361113"/>
                  <a:ext cx="0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24" name="Line 1081">
                  <a:extLst>
                    <a:ext uri="{FF2B5EF4-FFF2-40B4-BE49-F238E27FC236}">
                      <a16:creationId xmlns:a16="http://schemas.microsoft.com/office/drawing/2014/main" id="{A086D138-E14A-1967-6097-36C626DA9D5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1010900" y="6361113"/>
                  <a:ext cx="0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25" name="Oval 1042">
                  <a:extLst>
                    <a:ext uri="{FF2B5EF4-FFF2-40B4-BE49-F238E27FC236}">
                      <a16:creationId xmlns:a16="http://schemas.microsoft.com/office/drawing/2014/main" id="{7C6CB7F1-32BC-5892-5938-A9342EC5BE9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926773" y="4827588"/>
                  <a:ext cx="26988" cy="28575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26" name="Oval 1043">
                  <a:extLst>
                    <a:ext uri="{FF2B5EF4-FFF2-40B4-BE49-F238E27FC236}">
                      <a16:creationId xmlns:a16="http://schemas.microsoft.com/office/drawing/2014/main" id="{F3C25FC9-7C63-305A-BB7A-18E8B8B264D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926773" y="5178425"/>
                  <a:ext cx="26988" cy="28575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27" name="Oval 1044">
                  <a:extLst>
                    <a:ext uri="{FF2B5EF4-FFF2-40B4-BE49-F238E27FC236}">
                      <a16:creationId xmlns:a16="http://schemas.microsoft.com/office/drawing/2014/main" id="{0E8D1BCE-7F64-17BD-03EE-E555B377985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888673" y="4989513"/>
                  <a:ext cx="28575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28" name="Oval 1048">
                  <a:extLst>
                    <a:ext uri="{FF2B5EF4-FFF2-40B4-BE49-F238E27FC236}">
                      <a16:creationId xmlns:a16="http://schemas.microsoft.com/office/drawing/2014/main" id="{122EA62F-3694-0D48-1B6E-E84C75858A1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814060" y="4910138"/>
                  <a:ext cx="26988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29" name="Oval 1049">
                  <a:extLst>
                    <a:ext uri="{FF2B5EF4-FFF2-40B4-BE49-F238E27FC236}">
                      <a16:creationId xmlns:a16="http://schemas.microsoft.com/office/drawing/2014/main" id="{5D7A3FC9-3948-0002-7C9C-F1FB6D13FA4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964873" y="5026025"/>
                  <a:ext cx="26988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30" name="Oval 1050">
                  <a:extLst>
                    <a:ext uri="{FF2B5EF4-FFF2-40B4-BE49-F238E27FC236}">
                      <a16:creationId xmlns:a16="http://schemas.microsoft.com/office/drawing/2014/main" id="{C83C2AFE-21EC-6AE5-D9F5-98094095225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926773" y="5437188"/>
                  <a:ext cx="26988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31" name="Oval 1051">
                  <a:extLst>
                    <a:ext uri="{FF2B5EF4-FFF2-40B4-BE49-F238E27FC236}">
                      <a16:creationId xmlns:a16="http://schemas.microsoft.com/office/drawing/2014/main" id="{8664D651-0B1C-6109-907F-FEA8F7B852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852160" y="5308600"/>
                  <a:ext cx="26988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32" name="Oval 1052">
                  <a:extLst>
                    <a:ext uri="{FF2B5EF4-FFF2-40B4-BE49-F238E27FC236}">
                      <a16:creationId xmlns:a16="http://schemas.microsoft.com/office/drawing/2014/main" id="{74BE2DA4-2119-AB06-68B4-7C6061C5D5B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737860" y="5033963"/>
                  <a:ext cx="26988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33" name="Oval 1055">
                  <a:extLst>
                    <a:ext uri="{FF2B5EF4-FFF2-40B4-BE49-F238E27FC236}">
                      <a16:creationId xmlns:a16="http://schemas.microsoft.com/office/drawing/2014/main" id="{59131113-C48D-9138-1F25-DF59775878D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852160" y="5403850"/>
                  <a:ext cx="26988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34" name="Oval 1056">
                  <a:extLst>
                    <a:ext uri="{FF2B5EF4-FFF2-40B4-BE49-F238E27FC236}">
                      <a16:creationId xmlns:a16="http://schemas.microsoft.com/office/drawing/2014/main" id="{12988983-238C-68DC-29A4-648884DB6FC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852160" y="4837113"/>
                  <a:ext cx="26988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35" name="Oval 1059">
                  <a:extLst>
                    <a:ext uri="{FF2B5EF4-FFF2-40B4-BE49-F238E27FC236}">
                      <a16:creationId xmlns:a16="http://schemas.microsoft.com/office/drawing/2014/main" id="{61A884CD-8BCB-06E1-4BB0-69768316309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039485" y="5035550"/>
                  <a:ext cx="28575" cy="26987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36" name="Line 1061">
                  <a:extLst>
                    <a:ext uri="{FF2B5EF4-FFF2-40B4-BE49-F238E27FC236}">
                      <a16:creationId xmlns:a16="http://schemas.microsoft.com/office/drawing/2014/main" id="{8D277C5A-A2DA-7095-5981-A72ED8863C9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0714048" y="5416550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37" name="Line 1062">
                  <a:extLst>
                    <a:ext uri="{FF2B5EF4-FFF2-40B4-BE49-F238E27FC236}">
                      <a16:creationId xmlns:a16="http://schemas.microsoft.com/office/drawing/2014/main" id="{2750D159-7489-B200-D112-D87AF74B366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0714048" y="5043488"/>
                  <a:ext cx="377825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38" name="Line 1063">
                  <a:extLst>
                    <a:ext uri="{FF2B5EF4-FFF2-40B4-BE49-F238E27FC236}">
                      <a16:creationId xmlns:a16="http://schemas.microsoft.com/office/drawing/2014/main" id="{0F964F2E-CBEC-AF0A-8370-B1C73F9C859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0902960" y="4841875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39" name="Line 1064">
                  <a:extLst>
                    <a:ext uri="{FF2B5EF4-FFF2-40B4-BE49-F238E27FC236}">
                      <a16:creationId xmlns:a16="http://schemas.microsoft.com/office/drawing/2014/main" id="{7ADB15BD-60DF-635E-23AC-41D6D6DAE67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0902960" y="5416550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40" name="Rectangle 1069">
                  <a:extLst>
                    <a:ext uri="{FF2B5EF4-FFF2-40B4-BE49-F238E27FC236}">
                      <a16:creationId xmlns:a16="http://schemas.microsoft.com/office/drawing/2014/main" id="{A219D0DE-20A8-3770-E75B-CC42AC0176B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890260" y="5059363"/>
                  <a:ext cx="23813" cy="23812"/>
                </a:xfrm>
                <a:prstGeom prst="rect">
                  <a:avLst/>
                </a:prstGeom>
                <a:noFill/>
                <a:ln w="1588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41" name="Szövegdoboz 340">
                  <a:extLst>
                    <a:ext uri="{FF2B5EF4-FFF2-40B4-BE49-F238E27FC236}">
                      <a16:creationId xmlns:a16="http://schemas.microsoft.com/office/drawing/2014/main" id="{744C2868-BFC8-0152-A1DB-23B1D41704D4}"/>
                    </a:ext>
                  </a:extLst>
                </p:cNvPr>
                <p:cNvSpPr txBox="1"/>
                <p:nvPr/>
              </p:nvSpPr>
              <p:spPr>
                <a:xfrm>
                  <a:off x="10206872" y="6360909"/>
                  <a:ext cx="1027484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hu-HU" sz="11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Moderate</a:t>
                  </a:r>
                  <a:endParaRPr lang="hu-HU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r>
                    <a:rPr lang="hu-HU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VID-19</a:t>
                  </a:r>
                  <a:endParaRPr 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2" name="Line 175">
                  <a:extLst>
                    <a:ext uri="{FF2B5EF4-FFF2-40B4-BE49-F238E27FC236}">
                      <a16:creationId xmlns:a16="http://schemas.microsoft.com/office/drawing/2014/main" id="{EE15ABCA-1934-63BB-01A4-200BD42F570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0538418" y="4139555"/>
                  <a:ext cx="382275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43" name="Szövegdoboz 342">
                  <a:extLst>
                    <a:ext uri="{FF2B5EF4-FFF2-40B4-BE49-F238E27FC236}">
                      <a16:creationId xmlns:a16="http://schemas.microsoft.com/office/drawing/2014/main" id="{3E6032BC-DC0B-5412-FEBC-58A8E3C5E3F0}"/>
                    </a:ext>
                  </a:extLst>
                </p:cNvPr>
                <p:cNvSpPr txBox="1"/>
                <p:nvPr/>
              </p:nvSpPr>
              <p:spPr>
                <a:xfrm>
                  <a:off x="10488770" y="3918031"/>
                  <a:ext cx="47783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/>
                    <a:t>**</a:t>
                  </a:r>
                </a:p>
              </p:txBody>
            </p:sp>
          </p:grpSp>
        </p:grpSp>
        <p:sp>
          <p:nvSpPr>
            <p:cNvPr id="395" name="Szövegdoboz 394">
              <a:extLst>
                <a:ext uri="{FF2B5EF4-FFF2-40B4-BE49-F238E27FC236}">
                  <a16:creationId xmlns:a16="http://schemas.microsoft.com/office/drawing/2014/main" id="{68F1C2CE-C274-28CE-FFFF-480875CDA629}"/>
                </a:ext>
              </a:extLst>
            </p:cNvPr>
            <p:cNvSpPr txBox="1"/>
            <p:nvPr/>
          </p:nvSpPr>
          <p:spPr>
            <a:xfrm>
              <a:off x="4347167" y="1206241"/>
              <a:ext cx="102748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pSp>
          <p:nvGrpSpPr>
            <p:cNvPr id="405" name="Csoportba foglalás 404">
              <a:extLst>
                <a:ext uri="{FF2B5EF4-FFF2-40B4-BE49-F238E27FC236}">
                  <a16:creationId xmlns:a16="http://schemas.microsoft.com/office/drawing/2014/main" id="{DC96313C-4D5D-A41C-AB60-B3EDCD3150D6}"/>
                </a:ext>
              </a:extLst>
            </p:cNvPr>
            <p:cNvGrpSpPr/>
            <p:nvPr/>
          </p:nvGrpSpPr>
          <p:grpSpPr>
            <a:xfrm>
              <a:off x="8324236" y="2188984"/>
              <a:ext cx="1352477" cy="540256"/>
              <a:chOff x="7775273" y="2190113"/>
              <a:chExt cx="1352477" cy="540256"/>
            </a:xfrm>
          </p:grpSpPr>
          <p:sp>
            <p:nvSpPr>
              <p:cNvPr id="406" name="Szövegdoboz 405">
                <a:extLst>
                  <a:ext uri="{FF2B5EF4-FFF2-40B4-BE49-F238E27FC236}">
                    <a16:creationId xmlns:a16="http://schemas.microsoft.com/office/drawing/2014/main" id="{16D15E8D-405E-2A88-4B2C-7B53AFFF8ACA}"/>
                  </a:ext>
                </a:extLst>
              </p:cNvPr>
              <p:cNvSpPr txBox="1"/>
              <p:nvPr/>
            </p:nvSpPr>
            <p:spPr>
              <a:xfrm>
                <a:off x="8231281" y="2190113"/>
                <a:ext cx="89170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D107a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+</a:t>
                </a:r>
              </a:p>
            </p:txBody>
          </p:sp>
          <p:sp>
            <p:nvSpPr>
              <p:cNvPr id="407" name="Freeform 153">
                <a:extLst>
                  <a:ext uri="{FF2B5EF4-FFF2-40B4-BE49-F238E27FC236}">
                    <a16:creationId xmlns:a16="http://schemas.microsoft.com/office/drawing/2014/main" id="{DCBD5CE5-8742-DA02-9AD4-03DC9F3A61A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775273" y="2269105"/>
                <a:ext cx="135872" cy="127784"/>
              </a:xfrm>
              <a:custGeom>
                <a:avLst/>
                <a:gdLst>
                  <a:gd name="T0" fmla="*/ 0 w 238"/>
                  <a:gd name="T1" fmla="*/ 424 h 424"/>
                  <a:gd name="T2" fmla="*/ 238 w 238"/>
                  <a:gd name="T3" fmla="*/ 424 h 424"/>
                  <a:gd name="T4" fmla="*/ 238 w 238"/>
                  <a:gd name="T5" fmla="*/ 424 h 424"/>
                  <a:gd name="T6" fmla="*/ 238 w 238"/>
                  <a:gd name="T7" fmla="*/ 287 h 424"/>
                  <a:gd name="T8" fmla="*/ 238 w 238"/>
                  <a:gd name="T9" fmla="*/ 0 h 424"/>
                  <a:gd name="T10" fmla="*/ 238 w 238"/>
                  <a:gd name="T11" fmla="*/ 0 h 424"/>
                  <a:gd name="T12" fmla="*/ 0 w 238"/>
                  <a:gd name="T13" fmla="*/ 0 h 424"/>
                  <a:gd name="T14" fmla="*/ 0 w 238"/>
                  <a:gd name="T15" fmla="*/ 0 h 424"/>
                  <a:gd name="T16" fmla="*/ 0 w 238"/>
                  <a:gd name="T17" fmla="*/ 287 h 424"/>
                  <a:gd name="T18" fmla="*/ 0 w 238"/>
                  <a:gd name="T19" fmla="*/ 424 h 4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238" h="424">
                    <a:moveTo>
                      <a:pt x="0" y="424"/>
                    </a:moveTo>
                    <a:lnTo>
                      <a:pt x="238" y="424"/>
                    </a:lnTo>
                    <a:lnTo>
                      <a:pt x="238" y="424"/>
                    </a:lnTo>
                    <a:lnTo>
                      <a:pt x="238" y="287"/>
                    </a:lnTo>
                    <a:lnTo>
                      <a:pt x="238" y="0"/>
                    </a:lnTo>
                    <a:lnTo>
                      <a:pt x="238" y="0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0" y="287"/>
                    </a:lnTo>
                    <a:lnTo>
                      <a:pt x="0" y="424"/>
                    </a:lnTo>
                  </a:path>
                </a:pathLst>
              </a:custGeom>
              <a:noFill/>
              <a:ln w="4763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408" name="Freeform 153">
                <a:extLst>
                  <a:ext uri="{FF2B5EF4-FFF2-40B4-BE49-F238E27FC236}">
                    <a16:creationId xmlns:a16="http://schemas.microsoft.com/office/drawing/2014/main" id="{E0184C0D-C851-9783-EB32-CDFC526FB7B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958672" y="2268744"/>
                <a:ext cx="135872" cy="127784"/>
              </a:xfrm>
              <a:custGeom>
                <a:avLst/>
                <a:gdLst>
                  <a:gd name="T0" fmla="*/ 0 w 238"/>
                  <a:gd name="T1" fmla="*/ 424 h 424"/>
                  <a:gd name="T2" fmla="*/ 238 w 238"/>
                  <a:gd name="T3" fmla="*/ 424 h 424"/>
                  <a:gd name="T4" fmla="*/ 238 w 238"/>
                  <a:gd name="T5" fmla="*/ 424 h 424"/>
                  <a:gd name="T6" fmla="*/ 238 w 238"/>
                  <a:gd name="T7" fmla="*/ 287 h 424"/>
                  <a:gd name="T8" fmla="*/ 238 w 238"/>
                  <a:gd name="T9" fmla="*/ 0 h 424"/>
                  <a:gd name="T10" fmla="*/ 238 w 238"/>
                  <a:gd name="T11" fmla="*/ 0 h 424"/>
                  <a:gd name="T12" fmla="*/ 0 w 238"/>
                  <a:gd name="T13" fmla="*/ 0 h 424"/>
                  <a:gd name="T14" fmla="*/ 0 w 238"/>
                  <a:gd name="T15" fmla="*/ 0 h 424"/>
                  <a:gd name="T16" fmla="*/ 0 w 238"/>
                  <a:gd name="T17" fmla="*/ 287 h 424"/>
                  <a:gd name="T18" fmla="*/ 0 w 238"/>
                  <a:gd name="T19" fmla="*/ 424 h 4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238" h="424">
                    <a:moveTo>
                      <a:pt x="0" y="424"/>
                    </a:moveTo>
                    <a:lnTo>
                      <a:pt x="238" y="424"/>
                    </a:lnTo>
                    <a:lnTo>
                      <a:pt x="238" y="424"/>
                    </a:lnTo>
                    <a:lnTo>
                      <a:pt x="238" y="287"/>
                    </a:lnTo>
                    <a:lnTo>
                      <a:pt x="238" y="0"/>
                    </a:lnTo>
                    <a:lnTo>
                      <a:pt x="238" y="0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0" y="287"/>
                    </a:lnTo>
                    <a:lnTo>
                      <a:pt x="0" y="424"/>
                    </a:lnTo>
                  </a:path>
                </a:pathLst>
              </a:cu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409" name="Freeform 153">
                <a:extLst>
                  <a:ext uri="{FF2B5EF4-FFF2-40B4-BE49-F238E27FC236}">
                    <a16:creationId xmlns:a16="http://schemas.microsoft.com/office/drawing/2014/main" id="{C3EC2EBE-5D27-00B7-32CF-295F56F68F5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142070" y="2269752"/>
                <a:ext cx="135872" cy="127784"/>
              </a:xfrm>
              <a:custGeom>
                <a:avLst/>
                <a:gdLst>
                  <a:gd name="T0" fmla="*/ 0 w 238"/>
                  <a:gd name="T1" fmla="*/ 424 h 424"/>
                  <a:gd name="T2" fmla="*/ 238 w 238"/>
                  <a:gd name="T3" fmla="*/ 424 h 424"/>
                  <a:gd name="T4" fmla="*/ 238 w 238"/>
                  <a:gd name="T5" fmla="*/ 424 h 424"/>
                  <a:gd name="T6" fmla="*/ 238 w 238"/>
                  <a:gd name="T7" fmla="*/ 287 h 424"/>
                  <a:gd name="T8" fmla="*/ 238 w 238"/>
                  <a:gd name="T9" fmla="*/ 0 h 424"/>
                  <a:gd name="T10" fmla="*/ 238 w 238"/>
                  <a:gd name="T11" fmla="*/ 0 h 424"/>
                  <a:gd name="T12" fmla="*/ 0 w 238"/>
                  <a:gd name="T13" fmla="*/ 0 h 424"/>
                  <a:gd name="T14" fmla="*/ 0 w 238"/>
                  <a:gd name="T15" fmla="*/ 0 h 424"/>
                  <a:gd name="T16" fmla="*/ 0 w 238"/>
                  <a:gd name="T17" fmla="*/ 287 h 424"/>
                  <a:gd name="T18" fmla="*/ 0 w 238"/>
                  <a:gd name="T19" fmla="*/ 424 h 4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238" h="424">
                    <a:moveTo>
                      <a:pt x="0" y="424"/>
                    </a:moveTo>
                    <a:lnTo>
                      <a:pt x="238" y="424"/>
                    </a:lnTo>
                    <a:lnTo>
                      <a:pt x="238" y="424"/>
                    </a:lnTo>
                    <a:lnTo>
                      <a:pt x="238" y="287"/>
                    </a:lnTo>
                    <a:lnTo>
                      <a:pt x="238" y="0"/>
                    </a:lnTo>
                    <a:lnTo>
                      <a:pt x="238" y="0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0" y="287"/>
                    </a:lnTo>
                    <a:lnTo>
                      <a:pt x="0" y="424"/>
                    </a:lnTo>
                  </a:path>
                </a:pathLst>
              </a:cu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410" name="Freeform 153">
                <a:extLst>
                  <a:ext uri="{FF2B5EF4-FFF2-40B4-BE49-F238E27FC236}">
                    <a16:creationId xmlns:a16="http://schemas.microsoft.com/office/drawing/2014/main" id="{95CEC60C-5C2C-4040-BB01-1F2A01DA0B7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776358" y="2526268"/>
                <a:ext cx="135872" cy="131858"/>
              </a:xfrm>
              <a:custGeom>
                <a:avLst/>
                <a:gdLst>
                  <a:gd name="T0" fmla="*/ 0 w 238"/>
                  <a:gd name="T1" fmla="*/ 424 h 424"/>
                  <a:gd name="T2" fmla="*/ 238 w 238"/>
                  <a:gd name="T3" fmla="*/ 424 h 424"/>
                  <a:gd name="T4" fmla="*/ 238 w 238"/>
                  <a:gd name="T5" fmla="*/ 424 h 424"/>
                  <a:gd name="T6" fmla="*/ 238 w 238"/>
                  <a:gd name="T7" fmla="*/ 287 h 424"/>
                  <a:gd name="T8" fmla="*/ 238 w 238"/>
                  <a:gd name="T9" fmla="*/ 0 h 424"/>
                  <a:gd name="T10" fmla="*/ 238 w 238"/>
                  <a:gd name="T11" fmla="*/ 0 h 424"/>
                  <a:gd name="T12" fmla="*/ 0 w 238"/>
                  <a:gd name="T13" fmla="*/ 0 h 424"/>
                  <a:gd name="T14" fmla="*/ 0 w 238"/>
                  <a:gd name="T15" fmla="*/ 0 h 424"/>
                  <a:gd name="T16" fmla="*/ 0 w 238"/>
                  <a:gd name="T17" fmla="*/ 287 h 424"/>
                  <a:gd name="T18" fmla="*/ 0 w 238"/>
                  <a:gd name="T19" fmla="*/ 424 h 4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238" h="424">
                    <a:moveTo>
                      <a:pt x="0" y="424"/>
                    </a:moveTo>
                    <a:lnTo>
                      <a:pt x="238" y="424"/>
                    </a:lnTo>
                    <a:lnTo>
                      <a:pt x="238" y="424"/>
                    </a:lnTo>
                    <a:lnTo>
                      <a:pt x="238" y="287"/>
                    </a:lnTo>
                    <a:lnTo>
                      <a:pt x="238" y="0"/>
                    </a:lnTo>
                    <a:lnTo>
                      <a:pt x="238" y="0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0" y="287"/>
                    </a:lnTo>
                    <a:lnTo>
                      <a:pt x="0" y="424"/>
                    </a:lnTo>
                  </a:path>
                </a:pathLst>
              </a:custGeom>
              <a:pattFill prst="pct25">
                <a:fgClr>
                  <a:schemeClr val="tx1"/>
                </a:fgClr>
                <a:bgClr>
                  <a:schemeClr val="bg1"/>
                </a:bgClr>
              </a:pattFill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411" name="Freeform 153">
                <a:extLst>
                  <a:ext uri="{FF2B5EF4-FFF2-40B4-BE49-F238E27FC236}">
                    <a16:creationId xmlns:a16="http://schemas.microsoft.com/office/drawing/2014/main" id="{CA8031C2-C15B-2376-DC98-BA5DDA08198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959757" y="2525906"/>
                <a:ext cx="135872" cy="131858"/>
              </a:xfrm>
              <a:custGeom>
                <a:avLst/>
                <a:gdLst>
                  <a:gd name="T0" fmla="*/ 0 w 238"/>
                  <a:gd name="T1" fmla="*/ 424 h 424"/>
                  <a:gd name="T2" fmla="*/ 238 w 238"/>
                  <a:gd name="T3" fmla="*/ 424 h 424"/>
                  <a:gd name="T4" fmla="*/ 238 w 238"/>
                  <a:gd name="T5" fmla="*/ 424 h 424"/>
                  <a:gd name="T6" fmla="*/ 238 w 238"/>
                  <a:gd name="T7" fmla="*/ 287 h 424"/>
                  <a:gd name="T8" fmla="*/ 238 w 238"/>
                  <a:gd name="T9" fmla="*/ 0 h 424"/>
                  <a:gd name="T10" fmla="*/ 238 w 238"/>
                  <a:gd name="T11" fmla="*/ 0 h 424"/>
                  <a:gd name="T12" fmla="*/ 0 w 238"/>
                  <a:gd name="T13" fmla="*/ 0 h 424"/>
                  <a:gd name="T14" fmla="*/ 0 w 238"/>
                  <a:gd name="T15" fmla="*/ 0 h 424"/>
                  <a:gd name="T16" fmla="*/ 0 w 238"/>
                  <a:gd name="T17" fmla="*/ 287 h 424"/>
                  <a:gd name="T18" fmla="*/ 0 w 238"/>
                  <a:gd name="T19" fmla="*/ 424 h 4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238" h="424">
                    <a:moveTo>
                      <a:pt x="0" y="424"/>
                    </a:moveTo>
                    <a:lnTo>
                      <a:pt x="238" y="424"/>
                    </a:lnTo>
                    <a:lnTo>
                      <a:pt x="238" y="424"/>
                    </a:lnTo>
                    <a:lnTo>
                      <a:pt x="238" y="287"/>
                    </a:lnTo>
                    <a:lnTo>
                      <a:pt x="238" y="0"/>
                    </a:lnTo>
                    <a:lnTo>
                      <a:pt x="238" y="0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0" y="287"/>
                    </a:lnTo>
                    <a:lnTo>
                      <a:pt x="0" y="424"/>
                    </a:lnTo>
                  </a:path>
                </a:pathLst>
              </a:custGeom>
              <a:pattFill prst="pct25">
                <a:fgClr>
                  <a:srgbClr val="FF0000"/>
                </a:fgClr>
                <a:bgClr>
                  <a:schemeClr val="bg1"/>
                </a:bgClr>
              </a:pattFill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412" name="Freeform 153">
                <a:extLst>
                  <a:ext uri="{FF2B5EF4-FFF2-40B4-BE49-F238E27FC236}">
                    <a16:creationId xmlns:a16="http://schemas.microsoft.com/office/drawing/2014/main" id="{A7DC6500-27FD-BCAC-C978-1C89D6E440B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143156" y="2526916"/>
                <a:ext cx="135872" cy="131858"/>
              </a:xfrm>
              <a:custGeom>
                <a:avLst/>
                <a:gdLst>
                  <a:gd name="T0" fmla="*/ 0 w 238"/>
                  <a:gd name="T1" fmla="*/ 424 h 424"/>
                  <a:gd name="T2" fmla="*/ 238 w 238"/>
                  <a:gd name="T3" fmla="*/ 424 h 424"/>
                  <a:gd name="T4" fmla="*/ 238 w 238"/>
                  <a:gd name="T5" fmla="*/ 424 h 424"/>
                  <a:gd name="T6" fmla="*/ 238 w 238"/>
                  <a:gd name="T7" fmla="*/ 287 h 424"/>
                  <a:gd name="T8" fmla="*/ 238 w 238"/>
                  <a:gd name="T9" fmla="*/ 0 h 424"/>
                  <a:gd name="T10" fmla="*/ 238 w 238"/>
                  <a:gd name="T11" fmla="*/ 0 h 424"/>
                  <a:gd name="T12" fmla="*/ 0 w 238"/>
                  <a:gd name="T13" fmla="*/ 0 h 424"/>
                  <a:gd name="T14" fmla="*/ 0 w 238"/>
                  <a:gd name="T15" fmla="*/ 0 h 424"/>
                  <a:gd name="T16" fmla="*/ 0 w 238"/>
                  <a:gd name="T17" fmla="*/ 287 h 424"/>
                  <a:gd name="T18" fmla="*/ 0 w 238"/>
                  <a:gd name="T19" fmla="*/ 424 h 4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238" h="424">
                    <a:moveTo>
                      <a:pt x="0" y="424"/>
                    </a:moveTo>
                    <a:lnTo>
                      <a:pt x="238" y="424"/>
                    </a:lnTo>
                    <a:lnTo>
                      <a:pt x="238" y="424"/>
                    </a:lnTo>
                    <a:lnTo>
                      <a:pt x="238" y="287"/>
                    </a:lnTo>
                    <a:lnTo>
                      <a:pt x="238" y="0"/>
                    </a:lnTo>
                    <a:lnTo>
                      <a:pt x="238" y="0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0" y="287"/>
                    </a:lnTo>
                    <a:lnTo>
                      <a:pt x="0" y="424"/>
                    </a:lnTo>
                  </a:path>
                </a:pathLst>
              </a:custGeom>
              <a:pattFill prst="pct50">
                <a:fgClr>
                  <a:schemeClr val="accent1"/>
                </a:fgClr>
                <a:bgClr>
                  <a:schemeClr val="bg1"/>
                </a:bgClr>
              </a:pattFill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413" name="Szövegdoboz 412">
                <a:extLst>
                  <a:ext uri="{FF2B5EF4-FFF2-40B4-BE49-F238E27FC236}">
                    <a16:creationId xmlns:a16="http://schemas.microsoft.com/office/drawing/2014/main" id="{D903D7B8-DD64-62CE-9468-9358F0AF2252}"/>
                  </a:ext>
                </a:extLst>
              </p:cNvPr>
              <p:cNvSpPr txBox="1"/>
              <p:nvPr/>
            </p:nvSpPr>
            <p:spPr>
              <a:xfrm>
                <a:off x="8230118" y="2453370"/>
                <a:ext cx="8976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D107a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</p:grpSp>
        <p:sp>
          <p:nvSpPr>
            <p:cNvPr id="414" name="Szövegdoboz 413">
              <a:extLst>
                <a:ext uri="{FF2B5EF4-FFF2-40B4-BE49-F238E27FC236}">
                  <a16:creationId xmlns:a16="http://schemas.microsoft.com/office/drawing/2014/main" id="{84649B57-15AE-991D-073F-AAEA0C95A2FF}"/>
                </a:ext>
              </a:extLst>
            </p:cNvPr>
            <p:cNvSpPr txBox="1"/>
            <p:nvPr/>
          </p:nvSpPr>
          <p:spPr>
            <a:xfrm>
              <a:off x="214411" y="1186271"/>
              <a:ext cx="102748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5105947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Csoportba foglalás 1">
            <a:extLst>
              <a:ext uri="{FF2B5EF4-FFF2-40B4-BE49-F238E27FC236}">
                <a16:creationId xmlns:a16="http://schemas.microsoft.com/office/drawing/2014/main" id="{408AECE6-3834-4545-9D31-07E8B14C9AAC}"/>
              </a:ext>
            </a:extLst>
          </p:cNvPr>
          <p:cNvGrpSpPr/>
          <p:nvPr/>
        </p:nvGrpSpPr>
        <p:grpSpPr>
          <a:xfrm>
            <a:off x="-16935" y="66133"/>
            <a:ext cx="7179359" cy="4168922"/>
            <a:chOff x="-16935" y="66133"/>
            <a:chExt cx="7179359" cy="4168922"/>
          </a:xfrm>
        </p:grpSpPr>
        <p:sp>
          <p:nvSpPr>
            <p:cNvPr id="4" name="Szövegdoboz 3">
              <a:extLst>
                <a:ext uri="{FF2B5EF4-FFF2-40B4-BE49-F238E27FC236}">
                  <a16:creationId xmlns:a16="http://schemas.microsoft.com/office/drawing/2014/main" id="{6BC0ECAC-11A1-90EA-9E3F-89B245EA271A}"/>
                </a:ext>
              </a:extLst>
            </p:cNvPr>
            <p:cNvSpPr txBox="1"/>
            <p:nvPr/>
          </p:nvSpPr>
          <p:spPr>
            <a:xfrm>
              <a:off x="-16935" y="66133"/>
              <a:ext cx="331167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5.</a:t>
              </a:r>
            </a:p>
          </p:txBody>
        </p:sp>
        <p:grpSp>
          <p:nvGrpSpPr>
            <p:cNvPr id="5" name="Csoportba foglalás 4">
              <a:extLst>
                <a:ext uri="{FF2B5EF4-FFF2-40B4-BE49-F238E27FC236}">
                  <a16:creationId xmlns:a16="http://schemas.microsoft.com/office/drawing/2014/main" id="{53E807D0-19F9-8C2E-2635-B6A2233ACC1D}"/>
                </a:ext>
              </a:extLst>
            </p:cNvPr>
            <p:cNvGrpSpPr/>
            <p:nvPr/>
          </p:nvGrpSpPr>
          <p:grpSpPr>
            <a:xfrm>
              <a:off x="391110" y="1559899"/>
              <a:ext cx="6771314" cy="2675156"/>
              <a:chOff x="624882" y="2180323"/>
              <a:chExt cx="8466751" cy="3650935"/>
            </a:xfrm>
          </p:grpSpPr>
          <p:grpSp>
            <p:nvGrpSpPr>
              <p:cNvPr id="6" name="Csoportba foglalás 5">
                <a:extLst>
                  <a:ext uri="{FF2B5EF4-FFF2-40B4-BE49-F238E27FC236}">
                    <a16:creationId xmlns:a16="http://schemas.microsoft.com/office/drawing/2014/main" id="{6F106BFF-C295-3B24-517D-50FCB3E4891B}"/>
                  </a:ext>
                </a:extLst>
              </p:cNvPr>
              <p:cNvGrpSpPr/>
              <p:nvPr/>
            </p:nvGrpSpPr>
            <p:grpSpPr>
              <a:xfrm>
                <a:off x="5312134" y="2186633"/>
                <a:ext cx="3779499" cy="3163628"/>
                <a:chOff x="1190659" y="2115589"/>
                <a:chExt cx="4862478" cy="3163628"/>
              </a:xfrm>
            </p:grpSpPr>
            <p:sp>
              <p:nvSpPr>
                <p:cNvPr id="44" name="Oval 80">
                  <a:extLst>
                    <a:ext uri="{FF2B5EF4-FFF2-40B4-BE49-F238E27FC236}">
                      <a16:creationId xmlns:a16="http://schemas.microsoft.com/office/drawing/2014/main" id="{08311285-9F4F-6A4D-9374-AE89AC389FB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46525" y="4501602"/>
                  <a:ext cx="53975" cy="52388"/>
                </a:xfrm>
                <a:prstGeom prst="ellipse">
                  <a:avLst/>
                </a:prstGeom>
                <a:solidFill>
                  <a:srgbClr val="000000"/>
                </a:solidFill>
                <a:ln w="317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45" name="Oval 81">
                  <a:extLst>
                    <a:ext uri="{FF2B5EF4-FFF2-40B4-BE49-F238E27FC236}">
                      <a16:creationId xmlns:a16="http://schemas.microsoft.com/office/drawing/2014/main" id="{47769B92-91DD-56FC-4616-230F598AC86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40225" y="3815802"/>
                  <a:ext cx="53975" cy="53975"/>
                </a:xfrm>
                <a:prstGeom prst="ellipse">
                  <a:avLst/>
                </a:prstGeom>
                <a:solidFill>
                  <a:srgbClr val="000000"/>
                </a:solidFill>
                <a:ln w="317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46" name="Oval 82">
                  <a:extLst>
                    <a:ext uri="{FF2B5EF4-FFF2-40B4-BE49-F238E27FC236}">
                      <a16:creationId xmlns:a16="http://schemas.microsoft.com/office/drawing/2014/main" id="{4C7F0032-0C50-38C9-E1B3-7679E728673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914525" y="4512714"/>
                  <a:ext cx="55562" cy="52388"/>
                </a:xfrm>
                <a:prstGeom prst="ellipse">
                  <a:avLst/>
                </a:prstGeom>
                <a:solidFill>
                  <a:srgbClr val="000000"/>
                </a:solidFill>
                <a:ln w="317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47" name="Oval 83">
                  <a:extLst>
                    <a:ext uri="{FF2B5EF4-FFF2-40B4-BE49-F238E27FC236}">
                      <a16:creationId xmlns:a16="http://schemas.microsoft.com/office/drawing/2014/main" id="{7EEE612A-175B-5933-8343-852C784578B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606550" y="4219027"/>
                  <a:ext cx="52387" cy="53975"/>
                </a:xfrm>
                <a:prstGeom prst="ellipse">
                  <a:avLst/>
                </a:prstGeom>
                <a:solidFill>
                  <a:srgbClr val="000000"/>
                </a:solidFill>
                <a:ln w="317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48" name="Oval 84">
                  <a:extLst>
                    <a:ext uri="{FF2B5EF4-FFF2-40B4-BE49-F238E27FC236}">
                      <a16:creationId xmlns:a16="http://schemas.microsoft.com/office/drawing/2014/main" id="{FEF7709C-7B8A-DD1E-06B4-91AA9A0EE5B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631950" y="3361777"/>
                  <a:ext cx="52387" cy="55563"/>
                </a:xfrm>
                <a:prstGeom prst="ellipse">
                  <a:avLst/>
                </a:prstGeom>
                <a:solidFill>
                  <a:srgbClr val="000000"/>
                </a:solidFill>
                <a:ln w="317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49" name="Oval 85">
                  <a:extLst>
                    <a:ext uri="{FF2B5EF4-FFF2-40B4-BE49-F238E27FC236}">
                      <a16:creationId xmlns:a16="http://schemas.microsoft.com/office/drawing/2014/main" id="{F4CD55F1-3441-AEE2-8834-305601EB792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287587" y="2801389"/>
                  <a:ext cx="53975" cy="53975"/>
                </a:xfrm>
                <a:prstGeom prst="ellipse">
                  <a:avLst/>
                </a:prstGeom>
                <a:solidFill>
                  <a:srgbClr val="000000"/>
                </a:solidFill>
                <a:ln w="317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50" name="Oval 86">
                  <a:extLst>
                    <a:ext uri="{FF2B5EF4-FFF2-40B4-BE49-F238E27FC236}">
                      <a16:creationId xmlns:a16="http://schemas.microsoft.com/office/drawing/2014/main" id="{A8E8B635-7BB2-BBFB-1704-5536D676848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665287" y="3647527"/>
                  <a:ext cx="52387" cy="53975"/>
                </a:xfrm>
                <a:prstGeom prst="ellipse">
                  <a:avLst/>
                </a:prstGeom>
                <a:solidFill>
                  <a:srgbClr val="000000"/>
                </a:solidFill>
                <a:ln w="317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51" name="Oval 87">
                  <a:extLst>
                    <a:ext uri="{FF2B5EF4-FFF2-40B4-BE49-F238E27FC236}">
                      <a16:creationId xmlns:a16="http://schemas.microsoft.com/office/drawing/2014/main" id="{E6691B71-84A2-47AA-9213-38CCC46DB5F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82887" y="4438102"/>
                  <a:ext cx="53975" cy="52388"/>
                </a:xfrm>
                <a:prstGeom prst="ellipse">
                  <a:avLst/>
                </a:prstGeom>
                <a:solidFill>
                  <a:srgbClr val="000000"/>
                </a:solidFill>
                <a:ln w="317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52" name="Oval 88">
                  <a:extLst>
                    <a:ext uri="{FF2B5EF4-FFF2-40B4-BE49-F238E27FC236}">
                      <a16:creationId xmlns:a16="http://schemas.microsoft.com/office/drawing/2014/main" id="{17EDF4A5-E622-D783-CCA1-59F589FF7F1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03500" y="4550814"/>
                  <a:ext cx="53975" cy="53975"/>
                </a:xfrm>
                <a:prstGeom prst="ellipse">
                  <a:avLst/>
                </a:prstGeom>
                <a:solidFill>
                  <a:srgbClr val="000000"/>
                </a:solidFill>
                <a:ln w="317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53" name="Oval 89">
                  <a:extLst>
                    <a:ext uri="{FF2B5EF4-FFF2-40B4-BE49-F238E27FC236}">
                      <a16:creationId xmlns:a16="http://schemas.microsoft.com/office/drawing/2014/main" id="{A57B607C-D965-F0BE-3E28-F7899AB0F09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816600" y="3461789"/>
                  <a:ext cx="53975" cy="53975"/>
                </a:xfrm>
                <a:prstGeom prst="ellipse">
                  <a:avLst/>
                </a:prstGeom>
                <a:solidFill>
                  <a:srgbClr val="000000"/>
                </a:solidFill>
                <a:ln w="317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54" name="Oval 90">
                  <a:extLst>
                    <a:ext uri="{FF2B5EF4-FFF2-40B4-BE49-F238E27FC236}">
                      <a16:creationId xmlns:a16="http://schemas.microsoft.com/office/drawing/2014/main" id="{917D0206-D1F1-9DAF-FB90-2C579BE0B9C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87687" y="2736302"/>
                  <a:ext cx="53975" cy="52388"/>
                </a:xfrm>
                <a:prstGeom prst="ellipse">
                  <a:avLst/>
                </a:prstGeom>
                <a:solidFill>
                  <a:srgbClr val="000000"/>
                </a:solidFill>
                <a:ln w="317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55" name="Freeform 91">
                  <a:extLst>
                    <a:ext uri="{FF2B5EF4-FFF2-40B4-BE49-F238E27FC236}">
                      <a16:creationId xmlns:a16="http://schemas.microsoft.com/office/drawing/2014/main" id="{3AD8007C-DC09-E744-692B-47825D8C327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631950" y="3750714"/>
                  <a:ext cx="4211637" cy="141288"/>
                </a:xfrm>
                <a:custGeom>
                  <a:avLst/>
                  <a:gdLst>
                    <a:gd name="T0" fmla="*/ 34 w 2653"/>
                    <a:gd name="T1" fmla="*/ 88 h 89"/>
                    <a:gd name="T2" fmla="*/ 101 w 2653"/>
                    <a:gd name="T3" fmla="*/ 86 h 89"/>
                    <a:gd name="T4" fmla="*/ 168 w 2653"/>
                    <a:gd name="T5" fmla="*/ 83 h 89"/>
                    <a:gd name="T6" fmla="*/ 236 w 2653"/>
                    <a:gd name="T7" fmla="*/ 81 h 89"/>
                    <a:gd name="T8" fmla="*/ 303 w 2653"/>
                    <a:gd name="T9" fmla="*/ 79 h 89"/>
                    <a:gd name="T10" fmla="*/ 369 w 2653"/>
                    <a:gd name="T11" fmla="*/ 77 h 89"/>
                    <a:gd name="T12" fmla="*/ 437 w 2653"/>
                    <a:gd name="T13" fmla="*/ 74 h 89"/>
                    <a:gd name="T14" fmla="*/ 504 w 2653"/>
                    <a:gd name="T15" fmla="*/ 72 h 89"/>
                    <a:gd name="T16" fmla="*/ 571 w 2653"/>
                    <a:gd name="T17" fmla="*/ 70 h 89"/>
                    <a:gd name="T18" fmla="*/ 638 w 2653"/>
                    <a:gd name="T19" fmla="*/ 67 h 89"/>
                    <a:gd name="T20" fmla="*/ 705 w 2653"/>
                    <a:gd name="T21" fmla="*/ 65 h 89"/>
                    <a:gd name="T22" fmla="*/ 773 w 2653"/>
                    <a:gd name="T23" fmla="*/ 63 h 89"/>
                    <a:gd name="T24" fmla="*/ 839 w 2653"/>
                    <a:gd name="T25" fmla="*/ 61 h 89"/>
                    <a:gd name="T26" fmla="*/ 907 w 2653"/>
                    <a:gd name="T27" fmla="*/ 58 h 89"/>
                    <a:gd name="T28" fmla="*/ 974 w 2653"/>
                    <a:gd name="T29" fmla="*/ 56 h 89"/>
                    <a:gd name="T30" fmla="*/ 1041 w 2653"/>
                    <a:gd name="T31" fmla="*/ 54 h 89"/>
                    <a:gd name="T32" fmla="*/ 1108 w 2653"/>
                    <a:gd name="T33" fmla="*/ 51 h 89"/>
                    <a:gd name="T34" fmla="*/ 1175 w 2653"/>
                    <a:gd name="T35" fmla="*/ 49 h 89"/>
                    <a:gd name="T36" fmla="*/ 1243 w 2653"/>
                    <a:gd name="T37" fmla="*/ 47 h 89"/>
                    <a:gd name="T38" fmla="*/ 1309 w 2653"/>
                    <a:gd name="T39" fmla="*/ 45 h 89"/>
                    <a:gd name="T40" fmla="*/ 1377 w 2653"/>
                    <a:gd name="T41" fmla="*/ 42 h 89"/>
                    <a:gd name="T42" fmla="*/ 1444 w 2653"/>
                    <a:gd name="T43" fmla="*/ 40 h 89"/>
                    <a:gd name="T44" fmla="*/ 1512 w 2653"/>
                    <a:gd name="T45" fmla="*/ 39 h 89"/>
                    <a:gd name="T46" fmla="*/ 1578 w 2653"/>
                    <a:gd name="T47" fmla="*/ 37 h 89"/>
                    <a:gd name="T48" fmla="*/ 1645 w 2653"/>
                    <a:gd name="T49" fmla="*/ 34 h 89"/>
                    <a:gd name="T50" fmla="*/ 1713 w 2653"/>
                    <a:gd name="T51" fmla="*/ 32 h 89"/>
                    <a:gd name="T52" fmla="*/ 1779 w 2653"/>
                    <a:gd name="T53" fmla="*/ 30 h 89"/>
                    <a:gd name="T54" fmla="*/ 1847 w 2653"/>
                    <a:gd name="T55" fmla="*/ 27 h 89"/>
                    <a:gd name="T56" fmla="*/ 1914 w 2653"/>
                    <a:gd name="T57" fmla="*/ 25 h 89"/>
                    <a:gd name="T58" fmla="*/ 1982 w 2653"/>
                    <a:gd name="T59" fmla="*/ 23 h 89"/>
                    <a:gd name="T60" fmla="*/ 2048 w 2653"/>
                    <a:gd name="T61" fmla="*/ 20 h 89"/>
                    <a:gd name="T62" fmla="*/ 2115 w 2653"/>
                    <a:gd name="T63" fmla="*/ 18 h 89"/>
                    <a:gd name="T64" fmla="*/ 2183 w 2653"/>
                    <a:gd name="T65" fmla="*/ 16 h 89"/>
                    <a:gd name="T66" fmla="*/ 2249 w 2653"/>
                    <a:gd name="T67" fmla="*/ 14 h 89"/>
                    <a:gd name="T68" fmla="*/ 2317 w 2653"/>
                    <a:gd name="T69" fmla="*/ 11 h 89"/>
                    <a:gd name="T70" fmla="*/ 2384 w 2653"/>
                    <a:gd name="T71" fmla="*/ 9 h 89"/>
                    <a:gd name="T72" fmla="*/ 2452 w 2653"/>
                    <a:gd name="T73" fmla="*/ 7 h 89"/>
                    <a:gd name="T74" fmla="*/ 2518 w 2653"/>
                    <a:gd name="T75" fmla="*/ 4 h 89"/>
                    <a:gd name="T76" fmla="*/ 2585 w 2653"/>
                    <a:gd name="T77" fmla="*/ 2 h 89"/>
                    <a:gd name="T78" fmla="*/ 2653 w 2653"/>
                    <a:gd name="T79" fmla="*/ 0 h 8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</a:cxnLst>
                  <a:rect l="0" t="0" r="r" b="b"/>
                  <a:pathLst>
                    <a:path w="2653" h="89">
                      <a:moveTo>
                        <a:pt x="0" y="89"/>
                      </a:moveTo>
                      <a:lnTo>
                        <a:pt x="34" y="88"/>
                      </a:lnTo>
                      <a:lnTo>
                        <a:pt x="67" y="87"/>
                      </a:lnTo>
                      <a:lnTo>
                        <a:pt x="101" y="86"/>
                      </a:lnTo>
                      <a:lnTo>
                        <a:pt x="135" y="85"/>
                      </a:lnTo>
                      <a:lnTo>
                        <a:pt x="168" y="83"/>
                      </a:lnTo>
                      <a:lnTo>
                        <a:pt x="202" y="82"/>
                      </a:lnTo>
                      <a:lnTo>
                        <a:pt x="236" y="81"/>
                      </a:lnTo>
                      <a:lnTo>
                        <a:pt x="269" y="80"/>
                      </a:lnTo>
                      <a:lnTo>
                        <a:pt x="303" y="79"/>
                      </a:lnTo>
                      <a:lnTo>
                        <a:pt x="336" y="78"/>
                      </a:lnTo>
                      <a:lnTo>
                        <a:pt x="369" y="77"/>
                      </a:lnTo>
                      <a:lnTo>
                        <a:pt x="404" y="75"/>
                      </a:lnTo>
                      <a:lnTo>
                        <a:pt x="437" y="74"/>
                      </a:lnTo>
                      <a:lnTo>
                        <a:pt x="470" y="73"/>
                      </a:lnTo>
                      <a:lnTo>
                        <a:pt x="504" y="72"/>
                      </a:lnTo>
                      <a:lnTo>
                        <a:pt x="537" y="71"/>
                      </a:lnTo>
                      <a:lnTo>
                        <a:pt x="571" y="70"/>
                      </a:lnTo>
                      <a:lnTo>
                        <a:pt x="605" y="69"/>
                      </a:lnTo>
                      <a:lnTo>
                        <a:pt x="638" y="67"/>
                      </a:lnTo>
                      <a:lnTo>
                        <a:pt x="672" y="66"/>
                      </a:lnTo>
                      <a:lnTo>
                        <a:pt x="705" y="65"/>
                      </a:lnTo>
                      <a:lnTo>
                        <a:pt x="739" y="64"/>
                      </a:lnTo>
                      <a:lnTo>
                        <a:pt x="773" y="63"/>
                      </a:lnTo>
                      <a:lnTo>
                        <a:pt x="806" y="62"/>
                      </a:lnTo>
                      <a:lnTo>
                        <a:pt x="839" y="61"/>
                      </a:lnTo>
                      <a:lnTo>
                        <a:pt x="874" y="59"/>
                      </a:lnTo>
                      <a:lnTo>
                        <a:pt x="907" y="58"/>
                      </a:lnTo>
                      <a:lnTo>
                        <a:pt x="940" y="57"/>
                      </a:lnTo>
                      <a:lnTo>
                        <a:pt x="974" y="56"/>
                      </a:lnTo>
                      <a:lnTo>
                        <a:pt x="1007" y="55"/>
                      </a:lnTo>
                      <a:lnTo>
                        <a:pt x="1041" y="54"/>
                      </a:lnTo>
                      <a:lnTo>
                        <a:pt x="1075" y="53"/>
                      </a:lnTo>
                      <a:lnTo>
                        <a:pt x="1108" y="51"/>
                      </a:lnTo>
                      <a:lnTo>
                        <a:pt x="1142" y="50"/>
                      </a:lnTo>
                      <a:lnTo>
                        <a:pt x="1175" y="49"/>
                      </a:lnTo>
                      <a:lnTo>
                        <a:pt x="1209" y="48"/>
                      </a:lnTo>
                      <a:lnTo>
                        <a:pt x="1243" y="47"/>
                      </a:lnTo>
                      <a:lnTo>
                        <a:pt x="1276" y="46"/>
                      </a:lnTo>
                      <a:lnTo>
                        <a:pt x="1309" y="45"/>
                      </a:lnTo>
                      <a:lnTo>
                        <a:pt x="1344" y="43"/>
                      </a:lnTo>
                      <a:lnTo>
                        <a:pt x="1377" y="42"/>
                      </a:lnTo>
                      <a:lnTo>
                        <a:pt x="1410" y="41"/>
                      </a:lnTo>
                      <a:lnTo>
                        <a:pt x="1444" y="40"/>
                      </a:lnTo>
                      <a:lnTo>
                        <a:pt x="1477" y="40"/>
                      </a:lnTo>
                      <a:lnTo>
                        <a:pt x="1512" y="39"/>
                      </a:lnTo>
                      <a:lnTo>
                        <a:pt x="1545" y="38"/>
                      </a:lnTo>
                      <a:lnTo>
                        <a:pt x="1578" y="37"/>
                      </a:lnTo>
                      <a:lnTo>
                        <a:pt x="1612" y="35"/>
                      </a:lnTo>
                      <a:lnTo>
                        <a:pt x="1645" y="34"/>
                      </a:lnTo>
                      <a:lnTo>
                        <a:pt x="1679" y="33"/>
                      </a:lnTo>
                      <a:lnTo>
                        <a:pt x="1713" y="32"/>
                      </a:lnTo>
                      <a:lnTo>
                        <a:pt x="1746" y="31"/>
                      </a:lnTo>
                      <a:lnTo>
                        <a:pt x="1779" y="30"/>
                      </a:lnTo>
                      <a:lnTo>
                        <a:pt x="1814" y="28"/>
                      </a:lnTo>
                      <a:lnTo>
                        <a:pt x="1847" y="27"/>
                      </a:lnTo>
                      <a:lnTo>
                        <a:pt x="1880" y="26"/>
                      </a:lnTo>
                      <a:lnTo>
                        <a:pt x="1914" y="25"/>
                      </a:lnTo>
                      <a:lnTo>
                        <a:pt x="1947" y="24"/>
                      </a:lnTo>
                      <a:lnTo>
                        <a:pt x="1982" y="23"/>
                      </a:lnTo>
                      <a:lnTo>
                        <a:pt x="2015" y="22"/>
                      </a:lnTo>
                      <a:lnTo>
                        <a:pt x="2048" y="20"/>
                      </a:lnTo>
                      <a:lnTo>
                        <a:pt x="2082" y="19"/>
                      </a:lnTo>
                      <a:lnTo>
                        <a:pt x="2115" y="18"/>
                      </a:lnTo>
                      <a:lnTo>
                        <a:pt x="2149" y="17"/>
                      </a:lnTo>
                      <a:lnTo>
                        <a:pt x="2183" y="16"/>
                      </a:lnTo>
                      <a:lnTo>
                        <a:pt x="2216" y="15"/>
                      </a:lnTo>
                      <a:lnTo>
                        <a:pt x="2249" y="14"/>
                      </a:lnTo>
                      <a:lnTo>
                        <a:pt x="2283" y="12"/>
                      </a:lnTo>
                      <a:lnTo>
                        <a:pt x="2317" y="11"/>
                      </a:lnTo>
                      <a:lnTo>
                        <a:pt x="2350" y="10"/>
                      </a:lnTo>
                      <a:lnTo>
                        <a:pt x="2384" y="9"/>
                      </a:lnTo>
                      <a:lnTo>
                        <a:pt x="2417" y="8"/>
                      </a:lnTo>
                      <a:lnTo>
                        <a:pt x="2452" y="7"/>
                      </a:lnTo>
                      <a:lnTo>
                        <a:pt x="2485" y="6"/>
                      </a:lnTo>
                      <a:lnTo>
                        <a:pt x="2518" y="4"/>
                      </a:lnTo>
                      <a:lnTo>
                        <a:pt x="2552" y="3"/>
                      </a:lnTo>
                      <a:lnTo>
                        <a:pt x="2585" y="2"/>
                      </a:lnTo>
                      <a:lnTo>
                        <a:pt x="2619" y="1"/>
                      </a:lnTo>
                      <a:lnTo>
                        <a:pt x="2653" y="0"/>
                      </a:lnTo>
                    </a:path>
                  </a:pathLst>
                </a:custGeom>
                <a:noFill/>
                <a:ln w="3016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56" name="Freeform 92">
                  <a:extLst>
                    <a:ext uri="{FF2B5EF4-FFF2-40B4-BE49-F238E27FC236}">
                      <a16:creationId xmlns:a16="http://schemas.microsoft.com/office/drawing/2014/main" id="{D7D5D2C6-E632-F8D3-5B6A-D2C53782EA0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631950" y="2531514"/>
                  <a:ext cx="4211637" cy="2436813"/>
                </a:xfrm>
                <a:custGeom>
                  <a:avLst/>
                  <a:gdLst>
                    <a:gd name="T0" fmla="*/ 67 w 2653"/>
                    <a:gd name="T1" fmla="*/ 440 h 1535"/>
                    <a:gd name="T2" fmla="*/ 168 w 2653"/>
                    <a:gd name="T3" fmla="*/ 461 h 1535"/>
                    <a:gd name="T4" fmla="*/ 269 w 2653"/>
                    <a:gd name="T5" fmla="*/ 480 h 1535"/>
                    <a:gd name="T6" fmla="*/ 369 w 2653"/>
                    <a:gd name="T7" fmla="*/ 497 h 1535"/>
                    <a:gd name="T8" fmla="*/ 470 w 2653"/>
                    <a:gd name="T9" fmla="*/ 510 h 1535"/>
                    <a:gd name="T10" fmla="*/ 571 w 2653"/>
                    <a:gd name="T11" fmla="*/ 519 h 1535"/>
                    <a:gd name="T12" fmla="*/ 672 w 2653"/>
                    <a:gd name="T13" fmla="*/ 524 h 1535"/>
                    <a:gd name="T14" fmla="*/ 773 w 2653"/>
                    <a:gd name="T15" fmla="*/ 524 h 1535"/>
                    <a:gd name="T16" fmla="*/ 874 w 2653"/>
                    <a:gd name="T17" fmla="*/ 520 h 1535"/>
                    <a:gd name="T18" fmla="*/ 974 w 2653"/>
                    <a:gd name="T19" fmla="*/ 511 h 1535"/>
                    <a:gd name="T20" fmla="*/ 1075 w 2653"/>
                    <a:gd name="T21" fmla="*/ 498 h 1535"/>
                    <a:gd name="T22" fmla="*/ 1175 w 2653"/>
                    <a:gd name="T23" fmla="*/ 480 h 1535"/>
                    <a:gd name="T24" fmla="*/ 1276 w 2653"/>
                    <a:gd name="T25" fmla="*/ 459 h 1535"/>
                    <a:gd name="T26" fmla="*/ 1377 w 2653"/>
                    <a:gd name="T27" fmla="*/ 434 h 1535"/>
                    <a:gd name="T28" fmla="*/ 1477 w 2653"/>
                    <a:gd name="T29" fmla="*/ 408 h 1535"/>
                    <a:gd name="T30" fmla="*/ 1578 w 2653"/>
                    <a:gd name="T31" fmla="*/ 378 h 1535"/>
                    <a:gd name="T32" fmla="*/ 1679 w 2653"/>
                    <a:gd name="T33" fmla="*/ 348 h 1535"/>
                    <a:gd name="T34" fmla="*/ 1779 w 2653"/>
                    <a:gd name="T35" fmla="*/ 315 h 1535"/>
                    <a:gd name="T36" fmla="*/ 1880 w 2653"/>
                    <a:gd name="T37" fmla="*/ 282 h 1535"/>
                    <a:gd name="T38" fmla="*/ 1982 w 2653"/>
                    <a:gd name="T39" fmla="*/ 248 h 1535"/>
                    <a:gd name="T40" fmla="*/ 2082 w 2653"/>
                    <a:gd name="T41" fmla="*/ 212 h 1535"/>
                    <a:gd name="T42" fmla="*/ 2183 w 2653"/>
                    <a:gd name="T43" fmla="*/ 176 h 1535"/>
                    <a:gd name="T44" fmla="*/ 2283 w 2653"/>
                    <a:gd name="T45" fmla="*/ 139 h 1535"/>
                    <a:gd name="T46" fmla="*/ 2384 w 2653"/>
                    <a:gd name="T47" fmla="*/ 101 h 1535"/>
                    <a:gd name="T48" fmla="*/ 2485 w 2653"/>
                    <a:gd name="T49" fmla="*/ 64 h 1535"/>
                    <a:gd name="T50" fmla="*/ 2585 w 2653"/>
                    <a:gd name="T51" fmla="*/ 26 h 1535"/>
                    <a:gd name="T52" fmla="*/ 2653 w 2653"/>
                    <a:gd name="T53" fmla="*/ 1535 h 1535"/>
                    <a:gd name="T54" fmla="*/ 2552 w 2653"/>
                    <a:gd name="T55" fmla="*/ 1504 h 1535"/>
                    <a:gd name="T56" fmla="*/ 2452 w 2653"/>
                    <a:gd name="T57" fmla="*/ 1472 h 1535"/>
                    <a:gd name="T58" fmla="*/ 2350 w 2653"/>
                    <a:gd name="T59" fmla="*/ 1441 h 1535"/>
                    <a:gd name="T60" fmla="*/ 2249 w 2653"/>
                    <a:gd name="T61" fmla="*/ 1412 h 1535"/>
                    <a:gd name="T62" fmla="*/ 2149 w 2653"/>
                    <a:gd name="T63" fmla="*/ 1382 h 1535"/>
                    <a:gd name="T64" fmla="*/ 2048 w 2653"/>
                    <a:gd name="T65" fmla="*/ 1352 h 1535"/>
                    <a:gd name="T66" fmla="*/ 1947 w 2653"/>
                    <a:gd name="T67" fmla="*/ 1325 h 1535"/>
                    <a:gd name="T68" fmla="*/ 1847 w 2653"/>
                    <a:gd name="T69" fmla="*/ 1296 h 1535"/>
                    <a:gd name="T70" fmla="*/ 1746 w 2653"/>
                    <a:gd name="T71" fmla="*/ 1270 h 1535"/>
                    <a:gd name="T72" fmla="*/ 1645 w 2653"/>
                    <a:gd name="T73" fmla="*/ 1245 h 1535"/>
                    <a:gd name="T74" fmla="*/ 1545 w 2653"/>
                    <a:gd name="T75" fmla="*/ 1222 h 1535"/>
                    <a:gd name="T76" fmla="*/ 1444 w 2653"/>
                    <a:gd name="T77" fmla="*/ 1200 h 1535"/>
                    <a:gd name="T78" fmla="*/ 1344 w 2653"/>
                    <a:gd name="T79" fmla="*/ 1181 h 1535"/>
                    <a:gd name="T80" fmla="*/ 1243 w 2653"/>
                    <a:gd name="T81" fmla="*/ 1165 h 1535"/>
                    <a:gd name="T82" fmla="*/ 1142 w 2653"/>
                    <a:gd name="T83" fmla="*/ 1151 h 1535"/>
                    <a:gd name="T84" fmla="*/ 1041 w 2653"/>
                    <a:gd name="T85" fmla="*/ 1142 h 1535"/>
                    <a:gd name="T86" fmla="*/ 940 w 2653"/>
                    <a:gd name="T87" fmla="*/ 1136 h 1535"/>
                    <a:gd name="T88" fmla="*/ 839 w 2653"/>
                    <a:gd name="T89" fmla="*/ 1136 h 1535"/>
                    <a:gd name="T90" fmla="*/ 739 w 2653"/>
                    <a:gd name="T91" fmla="*/ 1139 h 1535"/>
                    <a:gd name="T92" fmla="*/ 638 w 2653"/>
                    <a:gd name="T93" fmla="*/ 1149 h 1535"/>
                    <a:gd name="T94" fmla="*/ 537 w 2653"/>
                    <a:gd name="T95" fmla="*/ 1161 h 1535"/>
                    <a:gd name="T96" fmla="*/ 437 w 2653"/>
                    <a:gd name="T97" fmla="*/ 1180 h 1535"/>
                    <a:gd name="T98" fmla="*/ 336 w 2653"/>
                    <a:gd name="T99" fmla="*/ 1200 h 1535"/>
                    <a:gd name="T100" fmla="*/ 236 w 2653"/>
                    <a:gd name="T101" fmla="*/ 1224 h 1535"/>
                    <a:gd name="T102" fmla="*/ 135 w 2653"/>
                    <a:gd name="T103" fmla="*/ 1252 h 1535"/>
                    <a:gd name="T104" fmla="*/ 34 w 2653"/>
                    <a:gd name="T105" fmla="*/ 1280 h 153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</a:cxnLst>
                  <a:rect l="0" t="0" r="r" b="b"/>
                  <a:pathLst>
                    <a:path w="2653" h="1535">
                      <a:moveTo>
                        <a:pt x="0" y="424"/>
                      </a:moveTo>
                      <a:lnTo>
                        <a:pt x="34" y="432"/>
                      </a:lnTo>
                      <a:lnTo>
                        <a:pt x="67" y="440"/>
                      </a:lnTo>
                      <a:lnTo>
                        <a:pt x="101" y="447"/>
                      </a:lnTo>
                      <a:lnTo>
                        <a:pt x="135" y="455"/>
                      </a:lnTo>
                      <a:lnTo>
                        <a:pt x="168" y="461"/>
                      </a:lnTo>
                      <a:lnTo>
                        <a:pt x="202" y="468"/>
                      </a:lnTo>
                      <a:lnTo>
                        <a:pt x="236" y="474"/>
                      </a:lnTo>
                      <a:lnTo>
                        <a:pt x="269" y="480"/>
                      </a:lnTo>
                      <a:lnTo>
                        <a:pt x="303" y="486"/>
                      </a:lnTo>
                      <a:lnTo>
                        <a:pt x="336" y="491"/>
                      </a:lnTo>
                      <a:lnTo>
                        <a:pt x="369" y="497"/>
                      </a:lnTo>
                      <a:lnTo>
                        <a:pt x="404" y="502"/>
                      </a:lnTo>
                      <a:lnTo>
                        <a:pt x="437" y="506"/>
                      </a:lnTo>
                      <a:lnTo>
                        <a:pt x="470" y="510"/>
                      </a:lnTo>
                      <a:lnTo>
                        <a:pt x="504" y="513"/>
                      </a:lnTo>
                      <a:lnTo>
                        <a:pt x="537" y="516"/>
                      </a:lnTo>
                      <a:lnTo>
                        <a:pt x="571" y="519"/>
                      </a:lnTo>
                      <a:lnTo>
                        <a:pt x="605" y="521"/>
                      </a:lnTo>
                      <a:lnTo>
                        <a:pt x="638" y="523"/>
                      </a:lnTo>
                      <a:lnTo>
                        <a:pt x="672" y="524"/>
                      </a:lnTo>
                      <a:lnTo>
                        <a:pt x="705" y="524"/>
                      </a:lnTo>
                      <a:lnTo>
                        <a:pt x="739" y="524"/>
                      </a:lnTo>
                      <a:lnTo>
                        <a:pt x="773" y="524"/>
                      </a:lnTo>
                      <a:lnTo>
                        <a:pt x="806" y="523"/>
                      </a:lnTo>
                      <a:lnTo>
                        <a:pt x="839" y="522"/>
                      </a:lnTo>
                      <a:lnTo>
                        <a:pt x="874" y="520"/>
                      </a:lnTo>
                      <a:lnTo>
                        <a:pt x="907" y="518"/>
                      </a:lnTo>
                      <a:lnTo>
                        <a:pt x="940" y="514"/>
                      </a:lnTo>
                      <a:lnTo>
                        <a:pt x="974" y="511"/>
                      </a:lnTo>
                      <a:lnTo>
                        <a:pt x="1007" y="507"/>
                      </a:lnTo>
                      <a:lnTo>
                        <a:pt x="1041" y="503"/>
                      </a:lnTo>
                      <a:lnTo>
                        <a:pt x="1075" y="498"/>
                      </a:lnTo>
                      <a:lnTo>
                        <a:pt x="1108" y="492"/>
                      </a:lnTo>
                      <a:lnTo>
                        <a:pt x="1142" y="487"/>
                      </a:lnTo>
                      <a:lnTo>
                        <a:pt x="1175" y="480"/>
                      </a:lnTo>
                      <a:lnTo>
                        <a:pt x="1209" y="473"/>
                      </a:lnTo>
                      <a:lnTo>
                        <a:pt x="1243" y="466"/>
                      </a:lnTo>
                      <a:lnTo>
                        <a:pt x="1276" y="459"/>
                      </a:lnTo>
                      <a:lnTo>
                        <a:pt x="1309" y="451"/>
                      </a:lnTo>
                      <a:lnTo>
                        <a:pt x="1344" y="443"/>
                      </a:lnTo>
                      <a:lnTo>
                        <a:pt x="1377" y="434"/>
                      </a:lnTo>
                      <a:lnTo>
                        <a:pt x="1410" y="426"/>
                      </a:lnTo>
                      <a:lnTo>
                        <a:pt x="1444" y="417"/>
                      </a:lnTo>
                      <a:lnTo>
                        <a:pt x="1477" y="408"/>
                      </a:lnTo>
                      <a:lnTo>
                        <a:pt x="1512" y="399"/>
                      </a:lnTo>
                      <a:lnTo>
                        <a:pt x="1545" y="388"/>
                      </a:lnTo>
                      <a:lnTo>
                        <a:pt x="1578" y="378"/>
                      </a:lnTo>
                      <a:lnTo>
                        <a:pt x="1612" y="369"/>
                      </a:lnTo>
                      <a:lnTo>
                        <a:pt x="1645" y="359"/>
                      </a:lnTo>
                      <a:lnTo>
                        <a:pt x="1679" y="348"/>
                      </a:lnTo>
                      <a:lnTo>
                        <a:pt x="1713" y="337"/>
                      </a:lnTo>
                      <a:lnTo>
                        <a:pt x="1746" y="327"/>
                      </a:lnTo>
                      <a:lnTo>
                        <a:pt x="1779" y="315"/>
                      </a:lnTo>
                      <a:lnTo>
                        <a:pt x="1814" y="305"/>
                      </a:lnTo>
                      <a:lnTo>
                        <a:pt x="1847" y="293"/>
                      </a:lnTo>
                      <a:lnTo>
                        <a:pt x="1880" y="282"/>
                      </a:lnTo>
                      <a:lnTo>
                        <a:pt x="1914" y="271"/>
                      </a:lnTo>
                      <a:lnTo>
                        <a:pt x="1947" y="259"/>
                      </a:lnTo>
                      <a:lnTo>
                        <a:pt x="1982" y="248"/>
                      </a:lnTo>
                      <a:lnTo>
                        <a:pt x="2015" y="235"/>
                      </a:lnTo>
                      <a:lnTo>
                        <a:pt x="2048" y="224"/>
                      </a:lnTo>
                      <a:lnTo>
                        <a:pt x="2082" y="212"/>
                      </a:lnTo>
                      <a:lnTo>
                        <a:pt x="2115" y="200"/>
                      </a:lnTo>
                      <a:lnTo>
                        <a:pt x="2149" y="188"/>
                      </a:lnTo>
                      <a:lnTo>
                        <a:pt x="2183" y="176"/>
                      </a:lnTo>
                      <a:lnTo>
                        <a:pt x="2216" y="163"/>
                      </a:lnTo>
                      <a:lnTo>
                        <a:pt x="2249" y="152"/>
                      </a:lnTo>
                      <a:lnTo>
                        <a:pt x="2283" y="139"/>
                      </a:lnTo>
                      <a:lnTo>
                        <a:pt x="2317" y="127"/>
                      </a:lnTo>
                      <a:lnTo>
                        <a:pt x="2350" y="114"/>
                      </a:lnTo>
                      <a:lnTo>
                        <a:pt x="2384" y="101"/>
                      </a:lnTo>
                      <a:lnTo>
                        <a:pt x="2417" y="89"/>
                      </a:lnTo>
                      <a:lnTo>
                        <a:pt x="2452" y="76"/>
                      </a:lnTo>
                      <a:lnTo>
                        <a:pt x="2485" y="64"/>
                      </a:lnTo>
                      <a:lnTo>
                        <a:pt x="2518" y="51"/>
                      </a:lnTo>
                      <a:lnTo>
                        <a:pt x="2552" y="38"/>
                      </a:lnTo>
                      <a:lnTo>
                        <a:pt x="2585" y="26"/>
                      </a:lnTo>
                      <a:lnTo>
                        <a:pt x="2619" y="13"/>
                      </a:lnTo>
                      <a:lnTo>
                        <a:pt x="2653" y="0"/>
                      </a:lnTo>
                      <a:lnTo>
                        <a:pt x="2653" y="1535"/>
                      </a:lnTo>
                      <a:lnTo>
                        <a:pt x="2619" y="1525"/>
                      </a:lnTo>
                      <a:lnTo>
                        <a:pt x="2585" y="1515"/>
                      </a:lnTo>
                      <a:lnTo>
                        <a:pt x="2552" y="1504"/>
                      </a:lnTo>
                      <a:lnTo>
                        <a:pt x="2518" y="1494"/>
                      </a:lnTo>
                      <a:lnTo>
                        <a:pt x="2485" y="1484"/>
                      </a:lnTo>
                      <a:lnTo>
                        <a:pt x="2452" y="1472"/>
                      </a:lnTo>
                      <a:lnTo>
                        <a:pt x="2417" y="1462"/>
                      </a:lnTo>
                      <a:lnTo>
                        <a:pt x="2384" y="1452"/>
                      </a:lnTo>
                      <a:lnTo>
                        <a:pt x="2350" y="1441"/>
                      </a:lnTo>
                      <a:lnTo>
                        <a:pt x="2317" y="1432"/>
                      </a:lnTo>
                      <a:lnTo>
                        <a:pt x="2283" y="1422"/>
                      </a:lnTo>
                      <a:lnTo>
                        <a:pt x="2249" y="1412"/>
                      </a:lnTo>
                      <a:lnTo>
                        <a:pt x="2216" y="1401"/>
                      </a:lnTo>
                      <a:lnTo>
                        <a:pt x="2183" y="1391"/>
                      </a:lnTo>
                      <a:lnTo>
                        <a:pt x="2149" y="1382"/>
                      </a:lnTo>
                      <a:lnTo>
                        <a:pt x="2115" y="1372"/>
                      </a:lnTo>
                      <a:lnTo>
                        <a:pt x="2082" y="1362"/>
                      </a:lnTo>
                      <a:lnTo>
                        <a:pt x="2048" y="1352"/>
                      </a:lnTo>
                      <a:lnTo>
                        <a:pt x="2015" y="1343"/>
                      </a:lnTo>
                      <a:lnTo>
                        <a:pt x="1982" y="1334"/>
                      </a:lnTo>
                      <a:lnTo>
                        <a:pt x="1947" y="1325"/>
                      </a:lnTo>
                      <a:lnTo>
                        <a:pt x="1914" y="1314"/>
                      </a:lnTo>
                      <a:lnTo>
                        <a:pt x="1880" y="1305"/>
                      </a:lnTo>
                      <a:lnTo>
                        <a:pt x="1847" y="1296"/>
                      </a:lnTo>
                      <a:lnTo>
                        <a:pt x="1814" y="1288"/>
                      </a:lnTo>
                      <a:lnTo>
                        <a:pt x="1779" y="1279"/>
                      </a:lnTo>
                      <a:lnTo>
                        <a:pt x="1746" y="1270"/>
                      </a:lnTo>
                      <a:lnTo>
                        <a:pt x="1713" y="1262"/>
                      </a:lnTo>
                      <a:lnTo>
                        <a:pt x="1679" y="1254"/>
                      </a:lnTo>
                      <a:lnTo>
                        <a:pt x="1645" y="1245"/>
                      </a:lnTo>
                      <a:lnTo>
                        <a:pt x="1612" y="1237"/>
                      </a:lnTo>
                      <a:lnTo>
                        <a:pt x="1578" y="1230"/>
                      </a:lnTo>
                      <a:lnTo>
                        <a:pt x="1545" y="1222"/>
                      </a:lnTo>
                      <a:lnTo>
                        <a:pt x="1512" y="1214"/>
                      </a:lnTo>
                      <a:lnTo>
                        <a:pt x="1477" y="1207"/>
                      </a:lnTo>
                      <a:lnTo>
                        <a:pt x="1444" y="1200"/>
                      </a:lnTo>
                      <a:lnTo>
                        <a:pt x="1410" y="1193"/>
                      </a:lnTo>
                      <a:lnTo>
                        <a:pt x="1377" y="1188"/>
                      </a:lnTo>
                      <a:lnTo>
                        <a:pt x="1344" y="1181"/>
                      </a:lnTo>
                      <a:lnTo>
                        <a:pt x="1309" y="1175"/>
                      </a:lnTo>
                      <a:lnTo>
                        <a:pt x="1276" y="1169"/>
                      </a:lnTo>
                      <a:lnTo>
                        <a:pt x="1243" y="1165"/>
                      </a:lnTo>
                      <a:lnTo>
                        <a:pt x="1209" y="1160"/>
                      </a:lnTo>
                      <a:lnTo>
                        <a:pt x="1175" y="1156"/>
                      </a:lnTo>
                      <a:lnTo>
                        <a:pt x="1142" y="1151"/>
                      </a:lnTo>
                      <a:lnTo>
                        <a:pt x="1108" y="1148"/>
                      </a:lnTo>
                      <a:lnTo>
                        <a:pt x="1075" y="1144"/>
                      </a:lnTo>
                      <a:lnTo>
                        <a:pt x="1041" y="1142"/>
                      </a:lnTo>
                      <a:lnTo>
                        <a:pt x="1007" y="1139"/>
                      </a:lnTo>
                      <a:lnTo>
                        <a:pt x="974" y="1137"/>
                      </a:lnTo>
                      <a:lnTo>
                        <a:pt x="940" y="1136"/>
                      </a:lnTo>
                      <a:lnTo>
                        <a:pt x="907" y="1136"/>
                      </a:lnTo>
                      <a:lnTo>
                        <a:pt x="874" y="1135"/>
                      </a:lnTo>
                      <a:lnTo>
                        <a:pt x="839" y="1136"/>
                      </a:lnTo>
                      <a:lnTo>
                        <a:pt x="806" y="1136"/>
                      </a:lnTo>
                      <a:lnTo>
                        <a:pt x="773" y="1138"/>
                      </a:lnTo>
                      <a:lnTo>
                        <a:pt x="739" y="1139"/>
                      </a:lnTo>
                      <a:lnTo>
                        <a:pt x="705" y="1142"/>
                      </a:lnTo>
                      <a:lnTo>
                        <a:pt x="672" y="1145"/>
                      </a:lnTo>
                      <a:lnTo>
                        <a:pt x="638" y="1149"/>
                      </a:lnTo>
                      <a:lnTo>
                        <a:pt x="605" y="1152"/>
                      </a:lnTo>
                      <a:lnTo>
                        <a:pt x="571" y="1157"/>
                      </a:lnTo>
                      <a:lnTo>
                        <a:pt x="537" y="1161"/>
                      </a:lnTo>
                      <a:lnTo>
                        <a:pt x="504" y="1167"/>
                      </a:lnTo>
                      <a:lnTo>
                        <a:pt x="470" y="1173"/>
                      </a:lnTo>
                      <a:lnTo>
                        <a:pt x="437" y="1180"/>
                      </a:lnTo>
                      <a:lnTo>
                        <a:pt x="404" y="1185"/>
                      </a:lnTo>
                      <a:lnTo>
                        <a:pt x="369" y="1193"/>
                      </a:lnTo>
                      <a:lnTo>
                        <a:pt x="336" y="1200"/>
                      </a:lnTo>
                      <a:lnTo>
                        <a:pt x="303" y="1208"/>
                      </a:lnTo>
                      <a:lnTo>
                        <a:pt x="269" y="1216"/>
                      </a:lnTo>
                      <a:lnTo>
                        <a:pt x="236" y="1224"/>
                      </a:lnTo>
                      <a:lnTo>
                        <a:pt x="202" y="1233"/>
                      </a:lnTo>
                      <a:lnTo>
                        <a:pt x="168" y="1241"/>
                      </a:lnTo>
                      <a:lnTo>
                        <a:pt x="135" y="1252"/>
                      </a:lnTo>
                      <a:lnTo>
                        <a:pt x="101" y="1261"/>
                      </a:lnTo>
                      <a:lnTo>
                        <a:pt x="67" y="1270"/>
                      </a:lnTo>
                      <a:lnTo>
                        <a:pt x="34" y="1280"/>
                      </a:lnTo>
                      <a:lnTo>
                        <a:pt x="0" y="1290"/>
                      </a:lnTo>
                      <a:lnTo>
                        <a:pt x="0" y="424"/>
                      </a:lnTo>
                      <a:close/>
                    </a:path>
                  </a:pathLst>
                </a:cu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57" name="Freeform 93">
                  <a:extLst>
                    <a:ext uri="{FF2B5EF4-FFF2-40B4-BE49-F238E27FC236}">
                      <a16:creationId xmlns:a16="http://schemas.microsoft.com/office/drawing/2014/main" id="{9659BE46-201C-9787-4D9E-46B6594C230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631950" y="2531514"/>
                  <a:ext cx="4211637" cy="831850"/>
                </a:xfrm>
                <a:custGeom>
                  <a:avLst/>
                  <a:gdLst>
                    <a:gd name="T0" fmla="*/ 34 w 2653"/>
                    <a:gd name="T1" fmla="*/ 432 h 524"/>
                    <a:gd name="T2" fmla="*/ 101 w 2653"/>
                    <a:gd name="T3" fmla="*/ 447 h 524"/>
                    <a:gd name="T4" fmla="*/ 168 w 2653"/>
                    <a:gd name="T5" fmla="*/ 461 h 524"/>
                    <a:gd name="T6" fmla="*/ 236 w 2653"/>
                    <a:gd name="T7" fmla="*/ 474 h 524"/>
                    <a:gd name="T8" fmla="*/ 303 w 2653"/>
                    <a:gd name="T9" fmla="*/ 486 h 524"/>
                    <a:gd name="T10" fmla="*/ 369 w 2653"/>
                    <a:gd name="T11" fmla="*/ 497 h 524"/>
                    <a:gd name="T12" fmla="*/ 437 w 2653"/>
                    <a:gd name="T13" fmla="*/ 506 h 524"/>
                    <a:gd name="T14" fmla="*/ 504 w 2653"/>
                    <a:gd name="T15" fmla="*/ 513 h 524"/>
                    <a:gd name="T16" fmla="*/ 571 w 2653"/>
                    <a:gd name="T17" fmla="*/ 519 h 524"/>
                    <a:gd name="T18" fmla="*/ 638 w 2653"/>
                    <a:gd name="T19" fmla="*/ 523 h 524"/>
                    <a:gd name="T20" fmla="*/ 705 w 2653"/>
                    <a:gd name="T21" fmla="*/ 524 h 524"/>
                    <a:gd name="T22" fmla="*/ 773 w 2653"/>
                    <a:gd name="T23" fmla="*/ 524 h 524"/>
                    <a:gd name="T24" fmla="*/ 839 w 2653"/>
                    <a:gd name="T25" fmla="*/ 522 h 524"/>
                    <a:gd name="T26" fmla="*/ 907 w 2653"/>
                    <a:gd name="T27" fmla="*/ 518 h 524"/>
                    <a:gd name="T28" fmla="*/ 974 w 2653"/>
                    <a:gd name="T29" fmla="*/ 511 h 524"/>
                    <a:gd name="T30" fmla="*/ 1041 w 2653"/>
                    <a:gd name="T31" fmla="*/ 503 h 524"/>
                    <a:gd name="T32" fmla="*/ 1108 w 2653"/>
                    <a:gd name="T33" fmla="*/ 492 h 524"/>
                    <a:gd name="T34" fmla="*/ 1175 w 2653"/>
                    <a:gd name="T35" fmla="*/ 480 h 524"/>
                    <a:gd name="T36" fmla="*/ 1243 w 2653"/>
                    <a:gd name="T37" fmla="*/ 466 h 524"/>
                    <a:gd name="T38" fmla="*/ 1309 w 2653"/>
                    <a:gd name="T39" fmla="*/ 451 h 524"/>
                    <a:gd name="T40" fmla="*/ 1377 w 2653"/>
                    <a:gd name="T41" fmla="*/ 434 h 524"/>
                    <a:gd name="T42" fmla="*/ 1444 w 2653"/>
                    <a:gd name="T43" fmla="*/ 417 h 524"/>
                    <a:gd name="T44" fmla="*/ 1512 w 2653"/>
                    <a:gd name="T45" fmla="*/ 399 h 524"/>
                    <a:gd name="T46" fmla="*/ 1578 w 2653"/>
                    <a:gd name="T47" fmla="*/ 378 h 524"/>
                    <a:gd name="T48" fmla="*/ 1645 w 2653"/>
                    <a:gd name="T49" fmla="*/ 359 h 524"/>
                    <a:gd name="T50" fmla="*/ 1713 w 2653"/>
                    <a:gd name="T51" fmla="*/ 337 h 524"/>
                    <a:gd name="T52" fmla="*/ 1779 w 2653"/>
                    <a:gd name="T53" fmla="*/ 315 h 524"/>
                    <a:gd name="T54" fmla="*/ 1847 w 2653"/>
                    <a:gd name="T55" fmla="*/ 293 h 524"/>
                    <a:gd name="T56" fmla="*/ 1914 w 2653"/>
                    <a:gd name="T57" fmla="*/ 271 h 524"/>
                    <a:gd name="T58" fmla="*/ 1982 w 2653"/>
                    <a:gd name="T59" fmla="*/ 248 h 524"/>
                    <a:gd name="T60" fmla="*/ 2048 w 2653"/>
                    <a:gd name="T61" fmla="*/ 224 h 524"/>
                    <a:gd name="T62" fmla="*/ 2115 w 2653"/>
                    <a:gd name="T63" fmla="*/ 200 h 524"/>
                    <a:gd name="T64" fmla="*/ 2183 w 2653"/>
                    <a:gd name="T65" fmla="*/ 176 h 524"/>
                    <a:gd name="T66" fmla="*/ 2249 w 2653"/>
                    <a:gd name="T67" fmla="*/ 152 h 524"/>
                    <a:gd name="T68" fmla="*/ 2317 w 2653"/>
                    <a:gd name="T69" fmla="*/ 127 h 524"/>
                    <a:gd name="T70" fmla="*/ 2384 w 2653"/>
                    <a:gd name="T71" fmla="*/ 101 h 524"/>
                    <a:gd name="T72" fmla="*/ 2452 w 2653"/>
                    <a:gd name="T73" fmla="*/ 76 h 524"/>
                    <a:gd name="T74" fmla="*/ 2518 w 2653"/>
                    <a:gd name="T75" fmla="*/ 51 h 524"/>
                    <a:gd name="T76" fmla="*/ 2585 w 2653"/>
                    <a:gd name="T77" fmla="*/ 26 h 524"/>
                    <a:gd name="T78" fmla="*/ 2653 w 2653"/>
                    <a:gd name="T79" fmla="*/ 0 h 52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</a:cxnLst>
                  <a:rect l="0" t="0" r="r" b="b"/>
                  <a:pathLst>
                    <a:path w="2653" h="524">
                      <a:moveTo>
                        <a:pt x="0" y="424"/>
                      </a:moveTo>
                      <a:lnTo>
                        <a:pt x="34" y="432"/>
                      </a:lnTo>
                      <a:lnTo>
                        <a:pt x="67" y="440"/>
                      </a:lnTo>
                      <a:lnTo>
                        <a:pt x="101" y="447"/>
                      </a:lnTo>
                      <a:lnTo>
                        <a:pt x="135" y="455"/>
                      </a:lnTo>
                      <a:lnTo>
                        <a:pt x="168" y="461"/>
                      </a:lnTo>
                      <a:lnTo>
                        <a:pt x="202" y="468"/>
                      </a:lnTo>
                      <a:lnTo>
                        <a:pt x="236" y="474"/>
                      </a:lnTo>
                      <a:lnTo>
                        <a:pt x="269" y="480"/>
                      </a:lnTo>
                      <a:lnTo>
                        <a:pt x="303" y="486"/>
                      </a:lnTo>
                      <a:lnTo>
                        <a:pt x="336" y="491"/>
                      </a:lnTo>
                      <a:lnTo>
                        <a:pt x="369" y="497"/>
                      </a:lnTo>
                      <a:lnTo>
                        <a:pt x="404" y="502"/>
                      </a:lnTo>
                      <a:lnTo>
                        <a:pt x="437" y="506"/>
                      </a:lnTo>
                      <a:lnTo>
                        <a:pt x="470" y="510"/>
                      </a:lnTo>
                      <a:lnTo>
                        <a:pt x="504" y="513"/>
                      </a:lnTo>
                      <a:lnTo>
                        <a:pt x="537" y="516"/>
                      </a:lnTo>
                      <a:lnTo>
                        <a:pt x="571" y="519"/>
                      </a:lnTo>
                      <a:lnTo>
                        <a:pt x="605" y="521"/>
                      </a:lnTo>
                      <a:lnTo>
                        <a:pt x="638" y="523"/>
                      </a:lnTo>
                      <a:lnTo>
                        <a:pt x="672" y="524"/>
                      </a:lnTo>
                      <a:lnTo>
                        <a:pt x="705" y="524"/>
                      </a:lnTo>
                      <a:lnTo>
                        <a:pt x="739" y="524"/>
                      </a:lnTo>
                      <a:lnTo>
                        <a:pt x="773" y="524"/>
                      </a:lnTo>
                      <a:lnTo>
                        <a:pt x="806" y="523"/>
                      </a:lnTo>
                      <a:lnTo>
                        <a:pt x="839" y="522"/>
                      </a:lnTo>
                      <a:lnTo>
                        <a:pt x="874" y="520"/>
                      </a:lnTo>
                      <a:lnTo>
                        <a:pt x="907" y="518"/>
                      </a:lnTo>
                      <a:lnTo>
                        <a:pt x="940" y="514"/>
                      </a:lnTo>
                      <a:lnTo>
                        <a:pt x="974" y="511"/>
                      </a:lnTo>
                      <a:lnTo>
                        <a:pt x="1007" y="507"/>
                      </a:lnTo>
                      <a:lnTo>
                        <a:pt x="1041" y="503"/>
                      </a:lnTo>
                      <a:lnTo>
                        <a:pt x="1075" y="498"/>
                      </a:lnTo>
                      <a:lnTo>
                        <a:pt x="1108" y="492"/>
                      </a:lnTo>
                      <a:lnTo>
                        <a:pt x="1142" y="487"/>
                      </a:lnTo>
                      <a:lnTo>
                        <a:pt x="1175" y="480"/>
                      </a:lnTo>
                      <a:lnTo>
                        <a:pt x="1209" y="473"/>
                      </a:lnTo>
                      <a:lnTo>
                        <a:pt x="1243" y="466"/>
                      </a:lnTo>
                      <a:lnTo>
                        <a:pt x="1276" y="459"/>
                      </a:lnTo>
                      <a:lnTo>
                        <a:pt x="1309" y="451"/>
                      </a:lnTo>
                      <a:lnTo>
                        <a:pt x="1344" y="443"/>
                      </a:lnTo>
                      <a:lnTo>
                        <a:pt x="1377" y="434"/>
                      </a:lnTo>
                      <a:lnTo>
                        <a:pt x="1410" y="426"/>
                      </a:lnTo>
                      <a:lnTo>
                        <a:pt x="1444" y="417"/>
                      </a:lnTo>
                      <a:lnTo>
                        <a:pt x="1477" y="408"/>
                      </a:lnTo>
                      <a:lnTo>
                        <a:pt x="1512" y="399"/>
                      </a:lnTo>
                      <a:lnTo>
                        <a:pt x="1545" y="388"/>
                      </a:lnTo>
                      <a:lnTo>
                        <a:pt x="1578" y="378"/>
                      </a:lnTo>
                      <a:lnTo>
                        <a:pt x="1612" y="369"/>
                      </a:lnTo>
                      <a:lnTo>
                        <a:pt x="1645" y="359"/>
                      </a:lnTo>
                      <a:lnTo>
                        <a:pt x="1679" y="348"/>
                      </a:lnTo>
                      <a:lnTo>
                        <a:pt x="1713" y="337"/>
                      </a:lnTo>
                      <a:lnTo>
                        <a:pt x="1746" y="327"/>
                      </a:lnTo>
                      <a:lnTo>
                        <a:pt x="1779" y="315"/>
                      </a:lnTo>
                      <a:lnTo>
                        <a:pt x="1814" y="305"/>
                      </a:lnTo>
                      <a:lnTo>
                        <a:pt x="1847" y="293"/>
                      </a:lnTo>
                      <a:lnTo>
                        <a:pt x="1880" y="282"/>
                      </a:lnTo>
                      <a:lnTo>
                        <a:pt x="1914" y="271"/>
                      </a:lnTo>
                      <a:lnTo>
                        <a:pt x="1947" y="259"/>
                      </a:lnTo>
                      <a:lnTo>
                        <a:pt x="1982" y="248"/>
                      </a:lnTo>
                      <a:lnTo>
                        <a:pt x="2015" y="235"/>
                      </a:lnTo>
                      <a:lnTo>
                        <a:pt x="2048" y="224"/>
                      </a:lnTo>
                      <a:lnTo>
                        <a:pt x="2082" y="212"/>
                      </a:lnTo>
                      <a:lnTo>
                        <a:pt x="2115" y="200"/>
                      </a:lnTo>
                      <a:lnTo>
                        <a:pt x="2149" y="188"/>
                      </a:lnTo>
                      <a:lnTo>
                        <a:pt x="2183" y="176"/>
                      </a:lnTo>
                      <a:lnTo>
                        <a:pt x="2216" y="163"/>
                      </a:lnTo>
                      <a:lnTo>
                        <a:pt x="2249" y="152"/>
                      </a:lnTo>
                      <a:lnTo>
                        <a:pt x="2283" y="139"/>
                      </a:lnTo>
                      <a:lnTo>
                        <a:pt x="2317" y="127"/>
                      </a:lnTo>
                      <a:lnTo>
                        <a:pt x="2350" y="114"/>
                      </a:lnTo>
                      <a:lnTo>
                        <a:pt x="2384" y="101"/>
                      </a:lnTo>
                      <a:lnTo>
                        <a:pt x="2417" y="89"/>
                      </a:lnTo>
                      <a:lnTo>
                        <a:pt x="2452" y="76"/>
                      </a:lnTo>
                      <a:lnTo>
                        <a:pt x="2485" y="64"/>
                      </a:lnTo>
                      <a:lnTo>
                        <a:pt x="2518" y="51"/>
                      </a:lnTo>
                      <a:lnTo>
                        <a:pt x="2552" y="38"/>
                      </a:lnTo>
                      <a:lnTo>
                        <a:pt x="2585" y="26"/>
                      </a:lnTo>
                      <a:lnTo>
                        <a:pt x="2619" y="13"/>
                      </a:lnTo>
                      <a:lnTo>
                        <a:pt x="2653" y="0"/>
                      </a:lnTo>
                    </a:path>
                  </a:pathLst>
                </a:cu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58" name="Freeform 94">
                  <a:extLst>
                    <a:ext uri="{FF2B5EF4-FFF2-40B4-BE49-F238E27FC236}">
                      <a16:creationId xmlns:a16="http://schemas.microsoft.com/office/drawing/2014/main" id="{7AEFC21D-B6C8-4B46-9145-BF576CBB66F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631950" y="4333327"/>
                  <a:ext cx="4211637" cy="635000"/>
                </a:xfrm>
                <a:custGeom>
                  <a:avLst/>
                  <a:gdLst>
                    <a:gd name="T0" fmla="*/ 2619 w 2653"/>
                    <a:gd name="T1" fmla="*/ 390 h 400"/>
                    <a:gd name="T2" fmla="*/ 2552 w 2653"/>
                    <a:gd name="T3" fmla="*/ 369 h 400"/>
                    <a:gd name="T4" fmla="*/ 2485 w 2653"/>
                    <a:gd name="T5" fmla="*/ 349 h 400"/>
                    <a:gd name="T6" fmla="*/ 2417 w 2653"/>
                    <a:gd name="T7" fmla="*/ 327 h 400"/>
                    <a:gd name="T8" fmla="*/ 2350 w 2653"/>
                    <a:gd name="T9" fmla="*/ 306 h 400"/>
                    <a:gd name="T10" fmla="*/ 2283 w 2653"/>
                    <a:gd name="T11" fmla="*/ 287 h 400"/>
                    <a:gd name="T12" fmla="*/ 2216 w 2653"/>
                    <a:gd name="T13" fmla="*/ 266 h 400"/>
                    <a:gd name="T14" fmla="*/ 2149 w 2653"/>
                    <a:gd name="T15" fmla="*/ 247 h 400"/>
                    <a:gd name="T16" fmla="*/ 2082 w 2653"/>
                    <a:gd name="T17" fmla="*/ 227 h 400"/>
                    <a:gd name="T18" fmla="*/ 2015 w 2653"/>
                    <a:gd name="T19" fmla="*/ 208 h 400"/>
                    <a:gd name="T20" fmla="*/ 1947 w 2653"/>
                    <a:gd name="T21" fmla="*/ 190 h 400"/>
                    <a:gd name="T22" fmla="*/ 1880 w 2653"/>
                    <a:gd name="T23" fmla="*/ 170 h 400"/>
                    <a:gd name="T24" fmla="*/ 1814 w 2653"/>
                    <a:gd name="T25" fmla="*/ 153 h 400"/>
                    <a:gd name="T26" fmla="*/ 1746 w 2653"/>
                    <a:gd name="T27" fmla="*/ 135 h 400"/>
                    <a:gd name="T28" fmla="*/ 1679 w 2653"/>
                    <a:gd name="T29" fmla="*/ 119 h 400"/>
                    <a:gd name="T30" fmla="*/ 1612 w 2653"/>
                    <a:gd name="T31" fmla="*/ 102 h 400"/>
                    <a:gd name="T32" fmla="*/ 1545 w 2653"/>
                    <a:gd name="T33" fmla="*/ 87 h 400"/>
                    <a:gd name="T34" fmla="*/ 1477 w 2653"/>
                    <a:gd name="T35" fmla="*/ 72 h 400"/>
                    <a:gd name="T36" fmla="*/ 1410 w 2653"/>
                    <a:gd name="T37" fmla="*/ 58 h 400"/>
                    <a:gd name="T38" fmla="*/ 1344 w 2653"/>
                    <a:gd name="T39" fmla="*/ 46 h 400"/>
                    <a:gd name="T40" fmla="*/ 1276 w 2653"/>
                    <a:gd name="T41" fmla="*/ 34 h 400"/>
                    <a:gd name="T42" fmla="*/ 1209 w 2653"/>
                    <a:gd name="T43" fmla="*/ 25 h 400"/>
                    <a:gd name="T44" fmla="*/ 1142 w 2653"/>
                    <a:gd name="T45" fmla="*/ 16 h 400"/>
                    <a:gd name="T46" fmla="*/ 1075 w 2653"/>
                    <a:gd name="T47" fmla="*/ 9 h 400"/>
                    <a:gd name="T48" fmla="*/ 1007 w 2653"/>
                    <a:gd name="T49" fmla="*/ 4 h 400"/>
                    <a:gd name="T50" fmla="*/ 940 w 2653"/>
                    <a:gd name="T51" fmla="*/ 1 h 400"/>
                    <a:gd name="T52" fmla="*/ 874 w 2653"/>
                    <a:gd name="T53" fmla="*/ 0 h 400"/>
                    <a:gd name="T54" fmla="*/ 806 w 2653"/>
                    <a:gd name="T55" fmla="*/ 1 h 400"/>
                    <a:gd name="T56" fmla="*/ 739 w 2653"/>
                    <a:gd name="T57" fmla="*/ 4 h 400"/>
                    <a:gd name="T58" fmla="*/ 672 w 2653"/>
                    <a:gd name="T59" fmla="*/ 10 h 400"/>
                    <a:gd name="T60" fmla="*/ 605 w 2653"/>
                    <a:gd name="T61" fmla="*/ 17 h 400"/>
                    <a:gd name="T62" fmla="*/ 537 w 2653"/>
                    <a:gd name="T63" fmla="*/ 26 h 400"/>
                    <a:gd name="T64" fmla="*/ 470 w 2653"/>
                    <a:gd name="T65" fmla="*/ 38 h 400"/>
                    <a:gd name="T66" fmla="*/ 404 w 2653"/>
                    <a:gd name="T67" fmla="*/ 50 h 400"/>
                    <a:gd name="T68" fmla="*/ 336 w 2653"/>
                    <a:gd name="T69" fmla="*/ 65 h 400"/>
                    <a:gd name="T70" fmla="*/ 269 w 2653"/>
                    <a:gd name="T71" fmla="*/ 81 h 400"/>
                    <a:gd name="T72" fmla="*/ 202 w 2653"/>
                    <a:gd name="T73" fmla="*/ 98 h 400"/>
                    <a:gd name="T74" fmla="*/ 135 w 2653"/>
                    <a:gd name="T75" fmla="*/ 117 h 400"/>
                    <a:gd name="T76" fmla="*/ 67 w 2653"/>
                    <a:gd name="T77" fmla="*/ 135 h 400"/>
                    <a:gd name="T78" fmla="*/ 0 w 2653"/>
                    <a:gd name="T79" fmla="*/ 155 h 40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</a:cxnLst>
                  <a:rect l="0" t="0" r="r" b="b"/>
                  <a:pathLst>
                    <a:path w="2653" h="400">
                      <a:moveTo>
                        <a:pt x="2653" y="400"/>
                      </a:moveTo>
                      <a:lnTo>
                        <a:pt x="2619" y="390"/>
                      </a:lnTo>
                      <a:lnTo>
                        <a:pt x="2585" y="380"/>
                      </a:lnTo>
                      <a:lnTo>
                        <a:pt x="2552" y="369"/>
                      </a:lnTo>
                      <a:lnTo>
                        <a:pt x="2518" y="359"/>
                      </a:lnTo>
                      <a:lnTo>
                        <a:pt x="2485" y="349"/>
                      </a:lnTo>
                      <a:lnTo>
                        <a:pt x="2452" y="337"/>
                      </a:lnTo>
                      <a:lnTo>
                        <a:pt x="2417" y="327"/>
                      </a:lnTo>
                      <a:lnTo>
                        <a:pt x="2384" y="317"/>
                      </a:lnTo>
                      <a:lnTo>
                        <a:pt x="2350" y="306"/>
                      </a:lnTo>
                      <a:lnTo>
                        <a:pt x="2317" y="297"/>
                      </a:lnTo>
                      <a:lnTo>
                        <a:pt x="2283" y="287"/>
                      </a:lnTo>
                      <a:lnTo>
                        <a:pt x="2249" y="277"/>
                      </a:lnTo>
                      <a:lnTo>
                        <a:pt x="2216" y="266"/>
                      </a:lnTo>
                      <a:lnTo>
                        <a:pt x="2183" y="256"/>
                      </a:lnTo>
                      <a:lnTo>
                        <a:pt x="2149" y="247"/>
                      </a:lnTo>
                      <a:lnTo>
                        <a:pt x="2115" y="237"/>
                      </a:lnTo>
                      <a:lnTo>
                        <a:pt x="2082" y="227"/>
                      </a:lnTo>
                      <a:lnTo>
                        <a:pt x="2048" y="217"/>
                      </a:lnTo>
                      <a:lnTo>
                        <a:pt x="2015" y="208"/>
                      </a:lnTo>
                      <a:lnTo>
                        <a:pt x="1982" y="199"/>
                      </a:lnTo>
                      <a:lnTo>
                        <a:pt x="1947" y="190"/>
                      </a:lnTo>
                      <a:lnTo>
                        <a:pt x="1914" y="179"/>
                      </a:lnTo>
                      <a:lnTo>
                        <a:pt x="1880" y="170"/>
                      </a:lnTo>
                      <a:lnTo>
                        <a:pt x="1847" y="161"/>
                      </a:lnTo>
                      <a:lnTo>
                        <a:pt x="1814" y="153"/>
                      </a:lnTo>
                      <a:lnTo>
                        <a:pt x="1779" y="144"/>
                      </a:lnTo>
                      <a:lnTo>
                        <a:pt x="1746" y="135"/>
                      </a:lnTo>
                      <a:lnTo>
                        <a:pt x="1713" y="127"/>
                      </a:lnTo>
                      <a:lnTo>
                        <a:pt x="1679" y="119"/>
                      </a:lnTo>
                      <a:lnTo>
                        <a:pt x="1645" y="110"/>
                      </a:lnTo>
                      <a:lnTo>
                        <a:pt x="1612" y="102"/>
                      </a:lnTo>
                      <a:lnTo>
                        <a:pt x="1578" y="95"/>
                      </a:lnTo>
                      <a:lnTo>
                        <a:pt x="1545" y="87"/>
                      </a:lnTo>
                      <a:lnTo>
                        <a:pt x="1512" y="79"/>
                      </a:lnTo>
                      <a:lnTo>
                        <a:pt x="1477" y="72"/>
                      </a:lnTo>
                      <a:lnTo>
                        <a:pt x="1444" y="65"/>
                      </a:lnTo>
                      <a:lnTo>
                        <a:pt x="1410" y="58"/>
                      </a:lnTo>
                      <a:lnTo>
                        <a:pt x="1377" y="53"/>
                      </a:lnTo>
                      <a:lnTo>
                        <a:pt x="1344" y="46"/>
                      </a:lnTo>
                      <a:lnTo>
                        <a:pt x="1309" y="40"/>
                      </a:lnTo>
                      <a:lnTo>
                        <a:pt x="1276" y="34"/>
                      </a:lnTo>
                      <a:lnTo>
                        <a:pt x="1243" y="30"/>
                      </a:lnTo>
                      <a:lnTo>
                        <a:pt x="1209" y="25"/>
                      </a:lnTo>
                      <a:lnTo>
                        <a:pt x="1175" y="21"/>
                      </a:lnTo>
                      <a:lnTo>
                        <a:pt x="1142" y="16"/>
                      </a:lnTo>
                      <a:lnTo>
                        <a:pt x="1108" y="13"/>
                      </a:lnTo>
                      <a:lnTo>
                        <a:pt x="1075" y="9"/>
                      </a:lnTo>
                      <a:lnTo>
                        <a:pt x="1041" y="7"/>
                      </a:lnTo>
                      <a:lnTo>
                        <a:pt x="1007" y="4"/>
                      </a:lnTo>
                      <a:lnTo>
                        <a:pt x="974" y="2"/>
                      </a:lnTo>
                      <a:lnTo>
                        <a:pt x="940" y="1"/>
                      </a:lnTo>
                      <a:lnTo>
                        <a:pt x="907" y="1"/>
                      </a:lnTo>
                      <a:lnTo>
                        <a:pt x="874" y="0"/>
                      </a:lnTo>
                      <a:lnTo>
                        <a:pt x="839" y="1"/>
                      </a:lnTo>
                      <a:lnTo>
                        <a:pt x="806" y="1"/>
                      </a:lnTo>
                      <a:lnTo>
                        <a:pt x="773" y="3"/>
                      </a:lnTo>
                      <a:lnTo>
                        <a:pt x="739" y="4"/>
                      </a:lnTo>
                      <a:lnTo>
                        <a:pt x="705" y="7"/>
                      </a:lnTo>
                      <a:lnTo>
                        <a:pt x="672" y="10"/>
                      </a:lnTo>
                      <a:lnTo>
                        <a:pt x="638" y="14"/>
                      </a:lnTo>
                      <a:lnTo>
                        <a:pt x="605" y="17"/>
                      </a:lnTo>
                      <a:lnTo>
                        <a:pt x="571" y="22"/>
                      </a:lnTo>
                      <a:lnTo>
                        <a:pt x="537" y="26"/>
                      </a:lnTo>
                      <a:lnTo>
                        <a:pt x="504" y="32"/>
                      </a:lnTo>
                      <a:lnTo>
                        <a:pt x="470" y="38"/>
                      </a:lnTo>
                      <a:lnTo>
                        <a:pt x="437" y="45"/>
                      </a:lnTo>
                      <a:lnTo>
                        <a:pt x="404" y="50"/>
                      </a:lnTo>
                      <a:lnTo>
                        <a:pt x="369" y="58"/>
                      </a:lnTo>
                      <a:lnTo>
                        <a:pt x="336" y="65"/>
                      </a:lnTo>
                      <a:lnTo>
                        <a:pt x="303" y="73"/>
                      </a:lnTo>
                      <a:lnTo>
                        <a:pt x="269" y="81"/>
                      </a:lnTo>
                      <a:lnTo>
                        <a:pt x="236" y="89"/>
                      </a:lnTo>
                      <a:lnTo>
                        <a:pt x="202" y="98"/>
                      </a:lnTo>
                      <a:lnTo>
                        <a:pt x="168" y="106"/>
                      </a:lnTo>
                      <a:lnTo>
                        <a:pt x="135" y="117"/>
                      </a:lnTo>
                      <a:lnTo>
                        <a:pt x="101" y="126"/>
                      </a:lnTo>
                      <a:lnTo>
                        <a:pt x="67" y="135"/>
                      </a:lnTo>
                      <a:lnTo>
                        <a:pt x="34" y="145"/>
                      </a:lnTo>
                      <a:lnTo>
                        <a:pt x="0" y="155"/>
                      </a:lnTo>
                    </a:path>
                  </a:pathLst>
                </a:cu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59" name="Freeform 95">
                  <a:extLst>
                    <a:ext uri="{FF2B5EF4-FFF2-40B4-BE49-F238E27FC236}">
                      <a16:creationId xmlns:a16="http://schemas.microsoft.com/office/drawing/2014/main" id="{C6DBE5D9-C2C8-49D2-5AE0-0B39320E3FC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631950" y="3750714"/>
                  <a:ext cx="4211637" cy="141288"/>
                </a:xfrm>
                <a:custGeom>
                  <a:avLst/>
                  <a:gdLst>
                    <a:gd name="T0" fmla="*/ 34 w 2653"/>
                    <a:gd name="T1" fmla="*/ 88 h 89"/>
                    <a:gd name="T2" fmla="*/ 101 w 2653"/>
                    <a:gd name="T3" fmla="*/ 86 h 89"/>
                    <a:gd name="T4" fmla="*/ 168 w 2653"/>
                    <a:gd name="T5" fmla="*/ 83 h 89"/>
                    <a:gd name="T6" fmla="*/ 236 w 2653"/>
                    <a:gd name="T7" fmla="*/ 81 h 89"/>
                    <a:gd name="T8" fmla="*/ 303 w 2653"/>
                    <a:gd name="T9" fmla="*/ 79 h 89"/>
                    <a:gd name="T10" fmla="*/ 369 w 2653"/>
                    <a:gd name="T11" fmla="*/ 77 h 89"/>
                    <a:gd name="T12" fmla="*/ 437 w 2653"/>
                    <a:gd name="T13" fmla="*/ 74 h 89"/>
                    <a:gd name="T14" fmla="*/ 504 w 2653"/>
                    <a:gd name="T15" fmla="*/ 72 h 89"/>
                    <a:gd name="T16" fmla="*/ 571 w 2653"/>
                    <a:gd name="T17" fmla="*/ 70 h 89"/>
                    <a:gd name="T18" fmla="*/ 638 w 2653"/>
                    <a:gd name="T19" fmla="*/ 67 h 89"/>
                    <a:gd name="T20" fmla="*/ 705 w 2653"/>
                    <a:gd name="T21" fmla="*/ 65 h 89"/>
                    <a:gd name="T22" fmla="*/ 773 w 2653"/>
                    <a:gd name="T23" fmla="*/ 63 h 89"/>
                    <a:gd name="T24" fmla="*/ 839 w 2653"/>
                    <a:gd name="T25" fmla="*/ 61 h 89"/>
                    <a:gd name="T26" fmla="*/ 907 w 2653"/>
                    <a:gd name="T27" fmla="*/ 58 h 89"/>
                    <a:gd name="T28" fmla="*/ 974 w 2653"/>
                    <a:gd name="T29" fmla="*/ 56 h 89"/>
                    <a:gd name="T30" fmla="*/ 1041 w 2653"/>
                    <a:gd name="T31" fmla="*/ 54 h 89"/>
                    <a:gd name="T32" fmla="*/ 1108 w 2653"/>
                    <a:gd name="T33" fmla="*/ 51 h 89"/>
                    <a:gd name="T34" fmla="*/ 1175 w 2653"/>
                    <a:gd name="T35" fmla="*/ 49 h 89"/>
                    <a:gd name="T36" fmla="*/ 1243 w 2653"/>
                    <a:gd name="T37" fmla="*/ 47 h 89"/>
                    <a:gd name="T38" fmla="*/ 1309 w 2653"/>
                    <a:gd name="T39" fmla="*/ 45 h 89"/>
                    <a:gd name="T40" fmla="*/ 1377 w 2653"/>
                    <a:gd name="T41" fmla="*/ 42 h 89"/>
                    <a:gd name="T42" fmla="*/ 1444 w 2653"/>
                    <a:gd name="T43" fmla="*/ 40 h 89"/>
                    <a:gd name="T44" fmla="*/ 1512 w 2653"/>
                    <a:gd name="T45" fmla="*/ 39 h 89"/>
                    <a:gd name="T46" fmla="*/ 1578 w 2653"/>
                    <a:gd name="T47" fmla="*/ 37 h 89"/>
                    <a:gd name="T48" fmla="*/ 1645 w 2653"/>
                    <a:gd name="T49" fmla="*/ 34 h 89"/>
                    <a:gd name="T50" fmla="*/ 1713 w 2653"/>
                    <a:gd name="T51" fmla="*/ 32 h 89"/>
                    <a:gd name="T52" fmla="*/ 1779 w 2653"/>
                    <a:gd name="T53" fmla="*/ 30 h 89"/>
                    <a:gd name="T54" fmla="*/ 1847 w 2653"/>
                    <a:gd name="T55" fmla="*/ 27 h 89"/>
                    <a:gd name="T56" fmla="*/ 1914 w 2653"/>
                    <a:gd name="T57" fmla="*/ 25 h 89"/>
                    <a:gd name="T58" fmla="*/ 1982 w 2653"/>
                    <a:gd name="T59" fmla="*/ 23 h 89"/>
                    <a:gd name="T60" fmla="*/ 2048 w 2653"/>
                    <a:gd name="T61" fmla="*/ 20 h 89"/>
                    <a:gd name="T62" fmla="*/ 2115 w 2653"/>
                    <a:gd name="T63" fmla="*/ 18 h 89"/>
                    <a:gd name="T64" fmla="*/ 2183 w 2653"/>
                    <a:gd name="T65" fmla="*/ 16 h 89"/>
                    <a:gd name="T66" fmla="*/ 2249 w 2653"/>
                    <a:gd name="T67" fmla="*/ 14 h 89"/>
                    <a:gd name="T68" fmla="*/ 2317 w 2653"/>
                    <a:gd name="T69" fmla="*/ 11 h 89"/>
                    <a:gd name="T70" fmla="*/ 2384 w 2653"/>
                    <a:gd name="T71" fmla="*/ 9 h 89"/>
                    <a:gd name="T72" fmla="*/ 2452 w 2653"/>
                    <a:gd name="T73" fmla="*/ 7 h 89"/>
                    <a:gd name="T74" fmla="*/ 2518 w 2653"/>
                    <a:gd name="T75" fmla="*/ 4 h 89"/>
                    <a:gd name="T76" fmla="*/ 2585 w 2653"/>
                    <a:gd name="T77" fmla="*/ 2 h 89"/>
                    <a:gd name="T78" fmla="*/ 2653 w 2653"/>
                    <a:gd name="T79" fmla="*/ 0 h 8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</a:cxnLst>
                  <a:rect l="0" t="0" r="r" b="b"/>
                  <a:pathLst>
                    <a:path w="2653" h="89">
                      <a:moveTo>
                        <a:pt x="0" y="89"/>
                      </a:moveTo>
                      <a:lnTo>
                        <a:pt x="34" y="88"/>
                      </a:lnTo>
                      <a:lnTo>
                        <a:pt x="67" y="87"/>
                      </a:lnTo>
                      <a:lnTo>
                        <a:pt x="101" y="86"/>
                      </a:lnTo>
                      <a:lnTo>
                        <a:pt x="135" y="85"/>
                      </a:lnTo>
                      <a:lnTo>
                        <a:pt x="168" y="83"/>
                      </a:lnTo>
                      <a:lnTo>
                        <a:pt x="202" y="82"/>
                      </a:lnTo>
                      <a:lnTo>
                        <a:pt x="236" y="81"/>
                      </a:lnTo>
                      <a:lnTo>
                        <a:pt x="269" y="80"/>
                      </a:lnTo>
                      <a:lnTo>
                        <a:pt x="303" y="79"/>
                      </a:lnTo>
                      <a:lnTo>
                        <a:pt x="336" y="78"/>
                      </a:lnTo>
                      <a:lnTo>
                        <a:pt x="369" y="77"/>
                      </a:lnTo>
                      <a:lnTo>
                        <a:pt x="404" y="75"/>
                      </a:lnTo>
                      <a:lnTo>
                        <a:pt x="437" y="74"/>
                      </a:lnTo>
                      <a:lnTo>
                        <a:pt x="470" y="73"/>
                      </a:lnTo>
                      <a:lnTo>
                        <a:pt x="504" y="72"/>
                      </a:lnTo>
                      <a:lnTo>
                        <a:pt x="537" y="71"/>
                      </a:lnTo>
                      <a:lnTo>
                        <a:pt x="571" y="70"/>
                      </a:lnTo>
                      <a:lnTo>
                        <a:pt x="605" y="69"/>
                      </a:lnTo>
                      <a:lnTo>
                        <a:pt x="638" y="67"/>
                      </a:lnTo>
                      <a:lnTo>
                        <a:pt x="672" y="66"/>
                      </a:lnTo>
                      <a:lnTo>
                        <a:pt x="705" y="65"/>
                      </a:lnTo>
                      <a:lnTo>
                        <a:pt x="739" y="64"/>
                      </a:lnTo>
                      <a:lnTo>
                        <a:pt x="773" y="63"/>
                      </a:lnTo>
                      <a:lnTo>
                        <a:pt x="806" y="62"/>
                      </a:lnTo>
                      <a:lnTo>
                        <a:pt x="839" y="61"/>
                      </a:lnTo>
                      <a:lnTo>
                        <a:pt x="874" y="59"/>
                      </a:lnTo>
                      <a:lnTo>
                        <a:pt x="907" y="58"/>
                      </a:lnTo>
                      <a:lnTo>
                        <a:pt x="940" y="57"/>
                      </a:lnTo>
                      <a:lnTo>
                        <a:pt x="974" y="56"/>
                      </a:lnTo>
                      <a:lnTo>
                        <a:pt x="1007" y="55"/>
                      </a:lnTo>
                      <a:lnTo>
                        <a:pt x="1041" y="54"/>
                      </a:lnTo>
                      <a:lnTo>
                        <a:pt x="1075" y="53"/>
                      </a:lnTo>
                      <a:lnTo>
                        <a:pt x="1108" y="51"/>
                      </a:lnTo>
                      <a:lnTo>
                        <a:pt x="1142" y="50"/>
                      </a:lnTo>
                      <a:lnTo>
                        <a:pt x="1175" y="49"/>
                      </a:lnTo>
                      <a:lnTo>
                        <a:pt x="1209" y="48"/>
                      </a:lnTo>
                      <a:lnTo>
                        <a:pt x="1243" y="47"/>
                      </a:lnTo>
                      <a:lnTo>
                        <a:pt x="1276" y="46"/>
                      </a:lnTo>
                      <a:lnTo>
                        <a:pt x="1309" y="45"/>
                      </a:lnTo>
                      <a:lnTo>
                        <a:pt x="1344" y="43"/>
                      </a:lnTo>
                      <a:lnTo>
                        <a:pt x="1377" y="42"/>
                      </a:lnTo>
                      <a:lnTo>
                        <a:pt x="1410" y="41"/>
                      </a:lnTo>
                      <a:lnTo>
                        <a:pt x="1444" y="40"/>
                      </a:lnTo>
                      <a:lnTo>
                        <a:pt x="1477" y="40"/>
                      </a:lnTo>
                      <a:lnTo>
                        <a:pt x="1512" y="39"/>
                      </a:lnTo>
                      <a:lnTo>
                        <a:pt x="1545" y="38"/>
                      </a:lnTo>
                      <a:lnTo>
                        <a:pt x="1578" y="37"/>
                      </a:lnTo>
                      <a:lnTo>
                        <a:pt x="1612" y="35"/>
                      </a:lnTo>
                      <a:lnTo>
                        <a:pt x="1645" y="34"/>
                      </a:lnTo>
                      <a:lnTo>
                        <a:pt x="1679" y="33"/>
                      </a:lnTo>
                      <a:lnTo>
                        <a:pt x="1713" y="32"/>
                      </a:lnTo>
                      <a:lnTo>
                        <a:pt x="1746" y="31"/>
                      </a:lnTo>
                      <a:lnTo>
                        <a:pt x="1779" y="30"/>
                      </a:lnTo>
                      <a:lnTo>
                        <a:pt x="1814" y="28"/>
                      </a:lnTo>
                      <a:lnTo>
                        <a:pt x="1847" y="27"/>
                      </a:lnTo>
                      <a:lnTo>
                        <a:pt x="1880" y="26"/>
                      </a:lnTo>
                      <a:lnTo>
                        <a:pt x="1914" y="25"/>
                      </a:lnTo>
                      <a:lnTo>
                        <a:pt x="1947" y="24"/>
                      </a:lnTo>
                      <a:lnTo>
                        <a:pt x="1982" y="23"/>
                      </a:lnTo>
                      <a:lnTo>
                        <a:pt x="2015" y="22"/>
                      </a:lnTo>
                      <a:lnTo>
                        <a:pt x="2048" y="20"/>
                      </a:lnTo>
                      <a:lnTo>
                        <a:pt x="2082" y="19"/>
                      </a:lnTo>
                      <a:lnTo>
                        <a:pt x="2115" y="18"/>
                      </a:lnTo>
                      <a:lnTo>
                        <a:pt x="2149" y="17"/>
                      </a:lnTo>
                      <a:lnTo>
                        <a:pt x="2183" y="16"/>
                      </a:lnTo>
                      <a:lnTo>
                        <a:pt x="2216" y="15"/>
                      </a:lnTo>
                      <a:lnTo>
                        <a:pt x="2249" y="14"/>
                      </a:lnTo>
                      <a:lnTo>
                        <a:pt x="2283" y="12"/>
                      </a:lnTo>
                      <a:lnTo>
                        <a:pt x="2317" y="11"/>
                      </a:lnTo>
                      <a:lnTo>
                        <a:pt x="2350" y="10"/>
                      </a:lnTo>
                      <a:lnTo>
                        <a:pt x="2384" y="9"/>
                      </a:lnTo>
                      <a:lnTo>
                        <a:pt x="2417" y="8"/>
                      </a:lnTo>
                      <a:lnTo>
                        <a:pt x="2452" y="7"/>
                      </a:lnTo>
                      <a:lnTo>
                        <a:pt x="2485" y="6"/>
                      </a:lnTo>
                      <a:lnTo>
                        <a:pt x="2518" y="4"/>
                      </a:lnTo>
                      <a:lnTo>
                        <a:pt x="2552" y="3"/>
                      </a:lnTo>
                      <a:lnTo>
                        <a:pt x="2585" y="2"/>
                      </a:lnTo>
                      <a:lnTo>
                        <a:pt x="2619" y="1"/>
                      </a:lnTo>
                      <a:lnTo>
                        <a:pt x="2653" y="0"/>
                      </a:lnTo>
                    </a:path>
                  </a:pathLst>
                </a:custGeom>
                <a:noFill/>
                <a:ln w="0" cap="flat">
                  <a:solidFill>
                    <a:srgbClr val="3366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60" name="Rectangle 96">
                  <a:extLst>
                    <a:ext uri="{FF2B5EF4-FFF2-40B4-BE49-F238E27FC236}">
                      <a16:creationId xmlns:a16="http://schemas.microsoft.com/office/drawing/2014/main" id="{22D5A6F3-DB25-DCFC-1AA8-796EC39B30E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85058" y="3150860"/>
                  <a:ext cx="948963" cy="69306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1100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R</a:t>
                  </a:r>
                  <a:r>
                    <a:rPr kumimoji="0" lang="en-US" altLang="hu-HU" sz="1100" i="0" u="none" strike="noStrike" cap="none" normalizeH="0" baseline="3000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2</a:t>
                  </a:r>
                  <a:r>
                    <a:rPr kumimoji="0" lang="en-US" altLang="hu-HU" sz="110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&lt;0.001</a:t>
                  </a:r>
                </a:p>
                <a:p>
                  <a:r>
                    <a:rPr lang="en-US" altLang="hu-HU" sz="11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P=0.787</a:t>
                  </a:r>
                  <a:endParaRPr kumimoji="0" lang="en-US" altLang="hu-HU" sz="110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endParaRPr kumimoji="0" lang="en-US" altLang="hu-HU" sz="110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1" name="Line 97">
                  <a:extLst>
                    <a:ext uri="{FF2B5EF4-FFF2-40B4-BE49-F238E27FC236}">
                      <a16:creationId xmlns:a16="http://schemas.microsoft.com/office/drawing/2014/main" id="{CBA11A5B-A655-F727-9743-3EE14391809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1420812" y="2409277"/>
                  <a:ext cx="0" cy="2682875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62" name="Rectangle 98">
                  <a:extLst>
                    <a:ext uri="{FF2B5EF4-FFF2-40B4-BE49-F238E27FC236}">
                      <a16:creationId xmlns:a16="http://schemas.microsoft.com/office/drawing/2014/main" id="{085716E8-33CB-03E2-7BD6-5E7AC752598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54160" y="4918507"/>
                  <a:ext cx="92833" cy="1680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63" name="Rectangle 99">
                  <a:extLst>
                    <a:ext uri="{FF2B5EF4-FFF2-40B4-BE49-F238E27FC236}">
                      <a16:creationId xmlns:a16="http://schemas.microsoft.com/office/drawing/2014/main" id="{386C78A0-42B1-CBE8-CE9C-457FB63101E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90659" y="4229531"/>
                  <a:ext cx="185666" cy="1680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20</a:t>
                  </a:r>
                </a:p>
              </p:txBody>
            </p:sp>
            <p:sp>
              <p:nvSpPr>
                <p:cNvPr id="64" name="Rectangle 100">
                  <a:extLst>
                    <a:ext uri="{FF2B5EF4-FFF2-40B4-BE49-F238E27FC236}">
                      <a16:creationId xmlns:a16="http://schemas.microsoft.com/office/drawing/2014/main" id="{C26648DA-647D-6BEB-7F58-2F20972164C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90659" y="3538968"/>
                  <a:ext cx="185666" cy="1680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40</a:t>
                  </a:r>
                </a:p>
              </p:txBody>
            </p:sp>
            <p:sp>
              <p:nvSpPr>
                <p:cNvPr id="65" name="Rectangle 101">
                  <a:extLst>
                    <a:ext uri="{FF2B5EF4-FFF2-40B4-BE49-F238E27FC236}">
                      <a16:creationId xmlns:a16="http://schemas.microsoft.com/office/drawing/2014/main" id="{189057CF-6DE4-472F-5038-1419B40752B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90659" y="2849993"/>
                  <a:ext cx="185666" cy="1680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60</a:t>
                  </a:r>
                </a:p>
              </p:txBody>
            </p:sp>
            <p:sp>
              <p:nvSpPr>
                <p:cNvPr id="66" name="Line 102">
                  <a:extLst>
                    <a:ext uri="{FF2B5EF4-FFF2-40B4-BE49-F238E27FC236}">
                      <a16:creationId xmlns:a16="http://schemas.microsoft.com/office/drawing/2014/main" id="{2E45E1D6-04BA-96EB-6ACE-AF787D352AD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401762" y="5022302"/>
                  <a:ext cx="19050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67" name="Line 103">
                  <a:extLst>
                    <a:ext uri="{FF2B5EF4-FFF2-40B4-BE49-F238E27FC236}">
                      <a16:creationId xmlns:a16="http://schemas.microsoft.com/office/drawing/2014/main" id="{04921978-9A90-3DEF-17EE-E9EDFD8C798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401762" y="4333327"/>
                  <a:ext cx="19050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68" name="Line 104">
                  <a:extLst>
                    <a:ext uri="{FF2B5EF4-FFF2-40B4-BE49-F238E27FC236}">
                      <a16:creationId xmlns:a16="http://schemas.microsoft.com/office/drawing/2014/main" id="{E9FD36A4-912A-9DE2-B7F2-4EA8B68B60C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401762" y="3641177"/>
                  <a:ext cx="19050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69" name="Line 105">
                  <a:extLst>
                    <a:ext uri="{FF2B5EF4-FFF2-40B4-BE49-F238E27FC236}">
                      <a16:creationId xmlns:a16="http://schemas.microsoft.com/office/drawing/2014/main" id="{64A850DC-4148-FEC8-716D-D1A78F6BE65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401762" y="2952202"/>
                  <a:ext cx="19050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70" name="Line 106">
                  <a:extLst>
                    <a:ext uri="{FF2B5EF4-FFF2-40B4-BE49-F238E27FC236}">
                      <a16:creationId xmlns:a16="http://schemas.microsoft.com/office/drawing/2014/main" id="{FD7DEBA7-6F49-579A-4F7E-9D95A892A0F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420812" y="5092152"/>
                  <a:ext cx="4632325" cy="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71" name="Line 107">
                  <a:extLst>
                    <a:ext uri="{FF2B5EF4-FFF2-40B4-BE49-F238E27FC236}">
                      <a16:creationId xmlns:a16="http://schemas.microsoft.com/office/drawing/2014/main" id="{FDDEADBA-AD2A-73C5-9B70-B21CA547BC8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584450" y="5092152"/>
                  <a:ext cx="0" cy="1905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72" name="Line 108">
                  <a:extLst>
                    <a:ext uri="{FF2B5EF4-FFF2-40B4-BE49-F238E27FC236}">
                      <a16:creationId xmlns:a16="http://schemas.microsoft.com/office/drawing/2014/main" id="{41D540B6-C3FD-9E12-BA05-8490210FEAC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457700" y="5092152"/>
                  <a:ext cx="0" cy="1905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73" name="Rectangle 109">
                  <a:extLst>
                    <a:ext uri="{FF2B5EF4-FFF2-40B4-BE49-F238E27FC236}">
                      <a16:creationId xmlns:a16="http://schemas.microsoft.com/office/drawing/2014/main" id="{CBD2E794-D139-7312-1A69-0F6CC52711B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14587" y="5111201"/>
                  <a:ext cx="371333" cy="1680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5000</a:t>
                  </a:r>
                </a:p>
              </p:txBody>
            </p:sp>
            <p:sp>
              <p:nvSpPr>
                <p:cNvPr id="74" name="Rectangle 110">
                  <a:extLst>
                    <a:ext uri="{FF2B5EF4-FFF2-40B4-BE49-F238E27FC236}">
                      <a16:creationId xmlns:a16="http://schemas.microsoft.com/office/drawing/2014/main" id="{88FFD98E-49EB-8D77-5929-F7EBAE39125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257675" y="5111201"/>
                  <a:ext cx="464168" cy="1680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10000</a:t>
                  </a:r>
                </a:p>
              </p:txBody>
            </p:sp>
            <p:sp>
              <p:nvSpPr>
                <p:cNvPr id="75" name="Rectangle 113">
                  <a:extLst>
                    <a:ext uri="{FF2B5EF4-FFF2-40B4-BE49-F238E27FC236}">
                      <a16:creationId xmlns:a16="http://schemas.microsoft.com/office/drawing/2014/main" id="{8B39EE2E-048E-0AF4-7D15-37DCAEB047C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420811" y="2115589"/>
                  <a:ext cx="4632324" cy="29402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14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Deceased</a:t>
                  </a:r>
                  <a:endParaRPr kumimoji="0" lang="en-US" altLang="hu-HU" sz="14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7" name="Csoportba foglalás 6">
                <a:extLst>
                  <a:ext uri="{FF2B5EF4-FFF2-40B4-BE49-F238E27FC236}">
                    <a16:creationId xmlns:a16="http://schemas.microsoft.com/office/drawing/2014/main" id="{396B93B7-91BF-06B0-2ABF-1283E2EC5518}"/>
                  </a:ext>
                </a:extLst>
              </p:cNvPr>
              <p:cNvGrpSpPr/>
              <p:nvPr/>
            </p:nvGrpSpPr>
            <p:grpSpPr>
              <a:xfrm>
                <a:off x="1149076" y="2180323"/>
                <a:ext cx="3863809" cy="3163629"/>
                <a:chOff x="6325145" y="2115589"/>
                <a:chExt cx="4970945" cy="3163629"/>
              </a:xfrm>
            </p:grpSpPr>
            <p:sp>
              <p:nvSpPr>
                <p:cNvPr id="11" name="Oval 116">
                  <a:extLst>
                    <a:ext uri="{FF2B5EF4-FFF2-40B4-BE49-F238E27FC236}">
                      <a16:creationId xmlns:a16="http://schemas.microsoft.com/office/drawing/2014/main" id="{97BC789A-E776-747E-BFB1-2971141F542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734550" y="3172864"/>
                  <a:ext cx="55562" cy="55563"/>
                </a:xfrm>
                <a:prstGeom prst="ellipse">
                  <a:avLst/>
                </a:prstGeom>
                <a:solidFill>
                  <a:srgbClr val="000000"/>
                </a:solidFill>
                <a:ln w="317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2" name="Oval 117">
                  <a:extLst>
                    <a:ext uri="{FF2B5EF4-FFF2-40B4-BE49-F238E27FC236}">
                      <a16:creationId xmlns:a16="http://schemas.microsoft.com/office/drawing/2014/main" id="{FF2F01E3-85EC-213E-A183-4D3DC0C9350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947025" y="3971377"/>
                  <a:ext cx="53975" cy="55563"/>
                </a:xfrm>
                <a:prstGeom prst="ellipse">
                  <a:avLst/>
                </a:prstGeom>
                <a:solidFill>
                  <a:srgbClr val="000000"/>
                </a:solidFill>
                <a:ln w="317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3" name="Oval 118">
                  <a:extLst>
                    <a:ext uri="{FF2B5EF4-FFF2-40B4-BE49-F238E27FC236}">
                      <a16:creationId xmlns:a16="http://schemas.microsoft.com/office/drawing/2014/main" id="{43966959-1B6B-9C22-715B-08119928184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089775" y="4676227"/>
                  <a:ext cx="55562" cy="53975"/>
                </a:xfrm>
                <a:prstGeom prst="ellipse">
                  <a:avLst/>
                </a:prstGeom>
                <a:solidFill>
                  <a:srgbClr val="000000"/>
                </a:solidFill>
                <a:ln w="317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4" name="Oval 119">
                  <a:extLst>
                    <a:ext uri="{FF2B5EF4-FFF2-40B4-BE49-F238E27FC236}">
                      <a16:creationId xmlns:a16="http://schemas.microsoft.com/office/drawing/2014/main" id="{D3CCACEA-4AB5-2142-BCAE-A786A722DE7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751637" y="4409527"/>
                  <a:ext cx="53975" cy="52388"/>
                </a:xfrm>
                <a:prstGeom prst="ellipse">
                  <a:avLst/>
                </a:prstGeom>
                <a:solidFill>
                  <a:srgbClr val="000000"/>
                </a:solidFill>
                <a:ln w="317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5" name="Oval 120">
                  <a:extLst>
                    <a:ext uri="{FF2B5EF4-FFF2-40B4-BE49-F238E27FC236}">
                      <a16:creationId xmlns:a16="http://schemas.microsoft.com/office/drawing/2014/main" id="{AB1BCB44-ED52-00CC-B535-2D71B86E5C4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960100" y="3230014"/>
                  <a:ext cx="55562" cy="53975"/>
                </a:xfrm>
                <a:prstGeom prst="ellipse">
                  <a:avLst/>
                </a:prstGeom>
                <a:solidFill>
                  <a:srgbClr val="000000"/>
                </a:solidFill>
                <a:ln w="317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6" name="Oval 121">
                  <a:extLst>
                    <a:ext uri="{FF2B5EF4-FFF2-40B4-BE49-F238E27FC236}">
                      <a16:creationId xmlns:a16="http://schemas.microsoft.com/office/drawing/2014/main" id="{076890DA-E54C-3C7D-DE44-41AD39D7021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648700" y="3888827"/>
                  <a:ext cx="52387" cy="53975"/>
                </a:xfrm>
                <a:prstGeom prst="ellipse">
                  <a:avLst/>
                </a:prstGeom>
                <a:solidFill>
                  <a:srgbClr val="000000"/>
                </a:solidFill>
                <a:ln w="317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7" name="Freeform 122">
                  <a:extLst>
                    <a:ext uri="{FF2B5EF4-FFF2-40B4-BE49-F238E27FC236}">
                      <a16:creationId xmlns:a16="http://schemas.microsoft.com/office/drawing/2014/main" id="{57CDF3BF-E89C-ECF7-56D6-D8ACC832035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778625" y="3058564"/>
                  <a:ext cx="4208462" cy="1485900"/>
                </a:xfrm>
                <a:custGeom>
                  <a:avLst/>
                  <a:gdLst>
                    <a:gd name="T0" fmla="*/ 33 w 2651"/>
                    <a:gd name="T1" fmla="*/ 924 h 936"/>
                    <a:gd name="T2" fmla="*/ 100 w 2651"/>
                    <a:gd name="T3" fmla="*/ 900 h 936"/>
                    <a:gd name="T4" fmla="*/ 168 w 2651"/>
                    <a:gd name="T5" fmla="*/ 876 h 936"/>
                    <a:gd name="T6" fmla="*/ 234 w 2651"/>
                    <a:gd name="T7" fmla="*/ 852 h 936"/>
                    <a:gd name="T8" fmla="*/ 302 w 2651"/>
                    <a:gd name="T9" fmla="*/ 829 h 936"/>
                    <a:gd name="T10" fmla="*/ 369 w 2651"/>
                    <a:gd name="T11" fmla="*/ 805 h 936"/>
                    <a:gd name="T12" fmla="*/ 437 w 2651"/>
                    <a:gd name="T13" fmla="*/ 781 h 936"/>
                    <a:gd name="T14" fmla="*/ 503 w 2651"/>
                    <a:gd name="T15" fmla="*/ 758 h 936"/>
                    <a:gd name="T16" fmla="*/ 570 w 2651"/>
                    <a:gd name="T17" fmla="*/ 734 h 936"/>
                    <a:gd name="T18" fmla="*/ 638 w 2651"/>
                    <a:gd name="T19" fmla="*/ 710 h 936"/>
                    <a:gd name="T20" fmla="*/ 704 w 2651"/>
                    <a:gd name="T21" fmla="*/ 686 h 936"/>
                    <a:gd name="T22" fmla="*/ 772 w 2651"/>
                    <a:gd name="T23" fmla="*/ 663 h 936"/>
                    <a:gd name="T24" fmla="*/ 839 w 2651"/>
                    <a:gd name="T25" fmla="*/ 639 h 936"/>
                    <a:gd name="T26" fmla="*/ 907 w 2651"/>
                    <a:gd name="T27" fmla="*/ 615 h 936"/>
                    <a:gd name="T28" fmla="*/ 973 w 2651"/>
                    <a:gd name="T29" fmla="*/ 591 h 936"/>
                    <a:gd name="T30" fmla="*/ 1040 w 2651"/>
                    <a:gd name="T31" fmla="*/ 569 h 936"/>
                    <a:gd name="T32" fmla="*/ 1108 w 2651"/>
                    <a:gd name="T33" fmla="*/ 545 h 936"/>
                    <a:gd name="T34" fmla="*/ 1174 w 2651"/>
                    <a:gd name="T35" fmla="*/ 521 h 936"/>
                    <a:gd name="T36" fmla="*/ 1242 w 2651"/>
                    <a:gd name="T37" fmla="*/ 498 h 936"/>
                    <a:gd name="T38" fmla="*/ 1309 w 2651"/>
                    <a:gd name="T39" fmla="*/ 474 h 936"/>
                    <a:gd name="T40" fmla="*/ 1376 w 2651"/>
                    <a:gd name="T41" fmla="*/ 450 h 936"/>
                    <a:gd name="T42" fmla="*/ 1443 w 2651"/>
                    <a:gd name="T43" fmla="*/ 426 h 936"/>
                    <a:gd name="T44" fmla="*/ 1510 w 2651"/>
                    <a:gd name="T45" fmla="*/ 403 h 936"/>
                    <a:gd name="T46" fmla="*/ 1578 w 2651"/>
                    <a:gd name="T47" fmla="*/ 379 h 936"/>
                    <a:gd name="T48" fmla="*/ 1644 w 2651"/>
                    <a:gd name="T49" fmla="*/ 355 h 936"/>
                    <a:gd name="T50" fmla="*/ 1712 w 2651"/>
                    <a:gd name="T51" fmla="*/ 332 h 936"/>
                    <a:gd name="T52" fmla="*/ 1779 w 2651"/>
                    <a:gd name="T53" fmla="*/ 308 h 936"/>
                    <a:gd name="T54" fmla="*/ 1846 w 2651"/>
                    <a:gd name="T55" fmla="*/ 284 h 936"/>
                    <a:gd name="T56" fmla="*/ 1913 w 2651"/>
                    <a:gd name="T57" fmla="*/ 260 h 936"/>
                    <a:gd name="T58" fmla="*/ 1980 w 2651"/>
                    <a:gd name="T59" fmla="*/ 237 h 936"/>
                    <a:gd name="T60" fmla="*/ 2048 w 2651"/>
                    <a:gd name="T61" fmla="*/ 213 h 936"/>
                    <a:gd name="T62" fmla="*/ 2114 w 2651"/>
                    <a:gd name="T63" fmla="*/ 189 h 936"/>
                    <a:gd name="T64" fmla="*/ 2181 w 2651"/>
                    <a:gd name="T65" fmla="*/ 166 h 936"/>
                    <a:gd name="T66" fmla="*/ 2249 w 2651"/>
                    <a:gd name="T67" fmla="*/ 142 h 936"/>
                    <a:gd name="T68" fmla="*/ 2316 w 2651"/>
                    <a:gd name="T69" fmla="*/ 118 h 936"/>
                    <a:gd name="T70" fmla="*/ 2383 w 2651"/>
                    <a:gd name="T71" fmla="*/ 94 h 936"/>
                    <a:gd name="T72" fmla="*/ 2450 w 2651"/>
                    <a:gd name="T73" fmla="*/ 71 h 936"/>
                    <a:gd name="T74" fmla="*/ 2518 w 2651"/>
                    <a:gd name="T75" fmla="*/ 47 h 936"/>
                    <a:gd name="T76" fmla="*/ 2584 w 2651"/>
                    <a:gd name="T77" fmla="*/ 23 h 936"/>
                    <a:gd name="T78" fmla="*/ 2651 w 2651"/>
                    <a:gd name="T79" fmla="*/ 0 h 9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</a:cxnLst>
                  <a:rect l="0" t="0" r="r" b="b"/>
                  <a:pathLst>
                    <a:path w="2651" h="936">
                      <a:moveTo>
                        <a:pt x="0" y="936"/>
                      </a:moveTo>
                      <a:lnTo>
                        <a:pt x="33" y="924"/>
                      </a:lnTo>
                      <a:lnTo>
                        <a:pt x="67" y="912"/>
                      </a:lnTo>
                      <a:lnTo>
                        <a:pt x="100" y="900"/>
                      </a:lnTo>
                      <a:lnTo>
                        <a:pt x="134" y="888"/>
                      </a:lnTo>
                      <a:lnTo>
                        <a:pt x="168" y="876"/>
                      </a:lnTo>
                      <a:lnTo>
                        <a:pt x="201" y="865"/>
                      </a:lnTo>
                      <a:lnTo>
                        <a:pt x="234" y="852"/>
                      </a:lnTo>
                      <a:lnTo>
                        <a:pt x="268" y="841"/>
                      </a:lnTo>
                      <a:lnTo>
                        <a:pt x="302" y="829"/>
                      </a:lnTo>
                      <a:lnTo>
                        <a:pt x="335" y="817"/>
                      </a:lnTo>
                      <a:lnTo>
                        <a:pt x="369" y="805"/>
                      </a:lnTo>
                      <a:lnTo>
                        <a:pt x="402" y="794"/>
                      </a:lnTo>
                      <a:lnTo>
                        <a:pt x="437" y="781"/>
                      </a:lnTo>
                      <a:lnTo>
                        <a:pt x="470" y="770"/>
                      </a:lnTo>
                      <a:lnTo>
                        <a:pt x="503" y="758"/>
                      </a:lnTo>
                      <a:lnTo>
                        <a:pt x="537" y="746"/>
                      </a:lnTo>
                      <a:lnTo>
                        <a:pt x="570" y="734"/>
                      </a:lnTo>
                      <a:lnTo>
                        <a:pt x="603" y="722"/>
                      </a:lnTo>
                      <a:lnTo>
                        <a:pt x="638" y="710"/>
                      </a:lnTo>
                      <a:lnTo>
                        <a:pt x="671" y="699"/>
                      </a:lnTo>
                      <a:lnTo>
                        <a:pt x="704" y="686"/>
                      </a:lnTo>
                      <a:lnTo>
                        <a:pt x="738" y="675"/>
                      </a:lnTo>
                      <a:lnTo>
                        <a:pt x="772" y="663"/>
                      </a:lnTo>
                      <a:lnTo>
                        <a:pt x="805" y="651"/>
                      </a:lnTo>
                      <a:lnTo>
                        <a:pt x="839" y="639"/>
                      </a:lnTo>
                      <a:lnTo>
                        <a:pt x="872" y="628"/>
                      </a:lnTo>
                      <a:lnTo>
                        <a:pt x="907" y="615"/>
                      </a:lnTo>
                      <a:lnTo>
                        <a:pt x="940" y="604"/>
                      </a:lnTo>
                      <a:lnTo>
                        <a:pt x="973" y="591"/>
                      </a:lnTo>
                      <a:lnTo>
                        <a:pt x="1007" y="580"/>
                      </a:lnTo>
                      <a:lnTo>
                        <a:pt x="1040" y="569"/>
                      </a:lnTo>
                      <a:lnTo>
                        <a:pt x="1073" y="556"/>
                      </a:lnTo>
                      <a:lnTo>
                        <a:pt x="1108" y="545"/>
                      </a:lnTo>
                      <a:lnTo>
                        <a:pt x="1141" y="533"/>
                      </a:lnTo>
                      <a:lnTo>
                        <a:pt x="1174" y="521"/>
                      </a:lnTo>
                      <a:lnTo>
                        <a:pt x="1208" y="509"/>
                      </a:lnTo>
                      <a:lnTo>
                        <a:pt x="1242" y="498"/>
                      </a:lnTo>
                      <a:lnTo>
                        <a:pt x="1275" y="485"/>
                      </a:lnTo>
                      <a:lnTo>
                        <a:pt x="1309" y="474"/>
                      </a:lnTo>
                      <a:lnTo>
                        <a:pt x="1342" y="462"/>
                      </a:lnTo>
                      <a:lnTo>
                        <a:pt x="1376" y="450"/>
                      </a:lnTo>
                      <a:lnTo>
                        <a:pt x="1410" y="438"/>
                      </a:lnTo>
                      <a:lnTo>
                        <a:pt x="1443" y="426"/>
                      </a:lnTo>
                      <a:lnTo>
                        <a:pt x="1477" y="414"/>
                      </a:lnTo>
                      <a:lnTo>
                        <a:pt x="1510" y="403"/>
                      </a:lnTo>
                      <a:lnTo>
                        <a:pt x="1543" y="390"/>
                      </a:lnTo>
                      <a:lnTo>
                        <a:pt x="1578" y="379"/>
                      </a:lnTo>
                      <a:lnTo>
                        <a:pt x="1611" y="367"/>
                      </a:lnTo>
                      <a:lnTo>
                        <a:pt x="1644" y="355"/>
                      </a:lnTo>
                      <a:lnTo>
                        <a:pt x="1678" y="343"/>
                      </a:lnTo>
                      <a:lnTo>
                        <a:pt x="1712" y="332"/>
                      </a:lnTo>
                      <a:lnTo>
                        <a:pt x="1746" y="319"/>
                      </a:lnTo>
                      <a:lnTo>
                        <a:pt x="1779" y="308"/>
                      </a:lnTo>
                      <a:lnTo>
                        <a:pt x="1812" y="295"/>
                      </a:lnTo>
                      <a:lnTo>
                        <a:pt x="1846" y="284"/>
                      </a:lnTo>
                      <a:lnTo>
                        <a:pt x="1880" y="272"/>
                      </a:lnTo>
                      <a:lnTo>
                        <a:pt x="1913" y="260"/>
                      </a:lnTo>
                      <a:lnTo>
                        <a:pt x="1947" y="248"/>
                      </a:lnTo>
                      <a:lnTo>
                        <a:pt x="1980" y="237"/>
                      </a:lnTo>
                      <a:lnTo>
                        <a:pt x="2013" y="224"/>
                      </a:lnTo>
                      <a:lnTo>
                        <a:pt x="2048" y="213"/>
                      </a:lnTo>
                      <a:lnTo>
                        <a:pt x="2081" y="202"/>
                      </a:lnTo>
                      <a:lnTo>
                        <a:pt x="2114" y="189"/>
                      </a:lnTo>
                      <a:lnTo>
                        <a:pt x="2148" y="178"/>
                      </a:lnTo>
                      <a:lnTo>
                        <a:pt x="2181" y="166"/>
                      </a:lnTo>
                      <a:lnTo>
                        <a:pt x="2216" y="154"/>
                      </a:lnTo>
                      <a:lnTo>
                        <a:pt x="2249" y="142"/>
                      </a:lnTo>
                      <a:lnTo>
                        <a:pt x="2282" y="129"/>
                      </a:lnTo>
                      <a:lnTo>
                        <a:pt x="2316" y="118"/>
                      </a:lnTo>
                      <a:lnTo>
                        <a:pt x="2350" y="107"/>
                      </a:lnTo>
                      <a:lnTo>
                        <a:pt x="2383" y="94"/>
                      </a:lnTo>
                      <a:lnTo>
                        <a:pt x="2417" y="83"/>
                      </a:lnTo>
                      <a:lnTo>
                        <a:pt x="2450" y="71"/>
                      </a:lnTo>
                      <a:lnTo>
                        <a:pt x="2483" y="59"/>
                      </a:lnTo>
                      <a:lnTo>
                        <a:pt x="2518" y="47"/>
                      </a:lnTo>
                      <a:lnTo>
                        <a:pt x="2551" y="36"/>
                      </a:lnTo>
                      <a:lnTo>
                        <a:pt x="2584" y="23"/>
                      </a:lnTo>
                      <a:lnTo>
                        <a:pt x="2618" y="12"/>
                      </a:lnTo>
                      <a:lnTo>
                        <a:pt x="2651" y="0"/>
                      </a:lnTo>
                    </a:path>
                  </a:pathLst>
                </a:custGeom>
                <a:noFill/>
                <a:ln w="3016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8" name="Freeform 123">
                  <a:extLst>
                    <a:ext uri="{FF2B5EF4-FFF2-40B4-BE49-F238E27FC236}">
                      <a16:creationId xmlns:a16="http://schemas.microsoft.com/office/drawing/2014/main" id="{C6674A83-7138-4404-260D-AAA8A3E0C72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778625" y="2531514"/>
                  <a:ext cx="4208462" cy="2436813"/>
                </a:xfrm>
                <a:custGeom>
                  <a:avLst/>
                  <a:gdLst>
                    <a:gd name="T0" fmla="*/ 67 w 2651"/>
                    <a:gd name="T1" fmla="*/ 985 h 1535"/>
                    <a:gd name="T2" fmla="*/ 168 w 2651"/>
                    <a:gd name="T3" fmla="*/ 963 h 1535"/>
                    <a:gd name="T4" fmla="*/ 268 w 2651"/>
                    <a:gd name="T5" fmla="*/ 941 h 1535"/>
                    <a:gd name="T6" fmla="*/ 369 w 2651"/>
                    <a:gd name="T7" fmla="*/ 918 h 1535"/>
                    <a:gd name="T8" fmla="*/ 470 w 2651"/>
                    <a:gd name="T9" fmla="*/ 893 h 1535"/>
                    <a:gd name="T10" fmla="*/ 570 w 2651"/>
                    <a:gd name="T11" fmla="*/ 867 h 1535"/>
                    <a:gd name="T12" fmla="*/ 671 w 2651"/>
                    <a:gd name="T13" fmla="*/ 841 h 1535"/>
                    <a:gd name="T14" fmla="*/ 772 w 2651"/>
                    <a:gd name="T15" fmla="*/ 813 h 1535"/>
                    <a:gd name="T16" fmla="*/ 872 w 2651"/>
                    <a:gd name="T17" fmla="*/ 783 h 1535"/>
                    <a:gd name="T18" fmla="*/ 973 w 2651"/>
                    <a:gd name="T19" fmla="*/ 751 h 1535"/>
                    <a:gd name="T20" fmla="*/ 1073 w 2651"/>
                    <a:gd name="T21" fmla="*/ 718 h 1535"/>
                    <a:gd name="T22" fmla="*/ 1174 w 2651"/>
                    <a:gd name="T23" fmla="*/ 681 h 1535"/>
                    <a:gd name="T24" fmla="*/ 1275 w 2651"/>
                    <a:gd name="T25" fmla="*/ 643 h 1535"/>
                    <a:gd name="T26" fmla="*/ 1376 w 2651"/>
                    <a:gd name="T27" fmla="*/ 604 h 1535"/>
                    <a:gd name="T28" fmla="*/ 1477 w 2651"/>
                    <a:gd name="T29" fmla="*/ 562 h 1535"/>
                    <a:gd name="T30" fmla="*/ 1578 w 2651"/>
                    <a:gd name="T31" fmla="*/ 520 h 1535"/>
                    <a:gd name="T32" fmla="*/ 1678 w 2651"/>
                    <a:gd name="T33" fmla="*/ 475 h 1535"/>
                    <a:gd name="T34" fmla="*/ 1779 w 2651"/>
                    <a:gd name="T35" fmla="*/ 429 h 1535"/>
                    <a:gd name="T36" fmla="*/ 1880 w 2651"/>
                    <a:gd name="T37" fmla="*/ 383 h 1535"/>
                    <a:gd name="T38" fmla="*/ 1980 w 2651"/>
                    <a:gd name="T39" fmla="*/ 335 h 1535"/>
                    <a:gd name="T40" fmla="*/ 2081 w 2651"/>
                    <a:gd name="T41" fmla="*/ 285 h 1535"/>
                    <a:gd name="T42" fmla="*/ 2181 w 2651"/>
                    <a:gd name="T43" fmla="*/ 236 h 1535"/>
                    <a:gd name="T44" fmla="*/ 2282 w 2651"/>
                    <a:gd name="T45" fmla="*/ 186 h 1535"/>
                    <a:gd name="T46" fmla="*/ 2383 w 2651"/>
                    <a:gd name="T47" fmla="*/ 136 h 1535"/>
                    <a:gd name="T48" fmla="*/ 2483 w 2651"/>
                    <a:gd name="T49" fmla="*/ 85 h 1535"/>
                    <a:gd name="T50" fmla="*/ 2584 w 2651"/>
                    <a:gd name="T51" fmla="*/ 34 h 1535"/>
                    <a:gd name="T52" fmla="*/ 2651 w 2651"/>
                    <a:gd name="T53" fmla="*/ 664 h 1535"/>
                    <a:gd name="T54" fmla="*/ 2551 w 2651"/>
                    <a:gd name="T55" fmla="*/ 683 h 1535"/>
                    <a:gd name="T56" fmla="*/ 2450 w 2651"/>
                    <a:gd name="T57" fmla="*/ 703 h 1535"/>
                    <a:gd name="T58" fmla="*/ 2350 w 2651"/>
                    <a:gd name="T59" fmla="*/ 723 h 1535"/>
                    <a:gd name="T60" fmla="*/ 2249 w 2651"/>
                    <a:gd name="T61" fmla="*/ 745 h 1535"/>
                    <a:gd name="T62" fmla="*/ 2148 w 2651"/>
                    <a:gd name="T63" fmla="*/ 766 h 1535"/>
                    <a:gd name="T64" fmla="*/ 2048 w 2651"/>
                    <a:gd name="T65" fmla="*/ 787 h 1535"/>
                    <a:gd name="T66" fmla="*/ 1947 w 2651"/>
                    <a:gd name="T67" fmla="*/ 810 h 1535"/>
                    <a:gd name="T68" fmla="*/ 1846 w 2651"/>
                    <a:gd name="T69" fmla="*/ 834 h 1535"/>
                    <a:gd name="T70" fmla="*/ 1746 w 2651"/>
                    <a:gd name="T71" fmla="*/ 858 h 1535"/>
                    <a:gd name="T72" fmla="*/ 1644 w 2651"/>
                    <a:gd name="T73" fmla="*/ 885 h 1535"/>
                    <a:gd name="T74" fmla="*/ 1543 w 2651"/>
                    <a:gd name="T75" fmla="*/ 911 h 1535"/>
                    <a:gd name="T76" fmla="*/ 1443 w 2651"/>
                    <a:gd name="T77" fmla="*/ 939 h 1535"/>
                    <a:gd name="T78" fmla="*/ 1342 w 2651"/>
                    <a:gd name="T79" fmla="*/ 970 h 1535"/>
                    <a:gd name="T80" fmla="*/ 1242 w 2651"/>
                    <a:gd name="T81" fmla="*/ 1002 h 1535"/>
                    <a:gd name="T82" fmla="*/ 1141 w 2651"/>
                    <a:gd name="T83" fmla="*/ 1035 h 1535"/>
                    <a:gd name="T84" fmla="*/ 1040 w 2651"/>
                    <a:gd name="T85" fmla="*/ 1072 h 1535"/>
                    <a:gd name="T86" fmla="*/ 940 w 2651"/>
                    <a:gd name="T87" fmla="*/ 1110 h 1535"/>
                    <a:gd name="T88" fmla="*/ 839 w 2651"/>
                    <a:gd name="T89" fmla="*/ 1150 h 1535"/>
                    <a:gd name="T90" fmla="*/ 738 w 2651"/>
                    <a:gd name="T91" fmla="*/ 1192 h 1535"/>
                    <a:gd name="T92" fmla="*/ 638 w 2651"/>
                    <a:gd name="T93" fmla="*/ 1236 h 1535"/>
                    <a:gd name="T94" fmla="*/ 537 w 2651"/>
                    <a:gd name="T95" fmla="*/ 1280 h 1535"/>
                    <a:gd name="T96" fmla="*/ 437 w 2651"/>
                    <a:gd name="T97" fmla="*/ 1326 h 1535"/>
                    <a:gd name="T98" fmla="*/ 335 w 2651"/>
                    <a:gd name="T99" fmla="*/ 1373 h 1535"/>
                    <a:gd name="T100" fmla="*/ 234 w 2651"/>
                    <a:gd name="T101" fmla="*/ 1421 h 1535"/>
                    <a:gd name="T102" fmla="*/ 134 w 2651"/>
                    <a:gd name="T103" fmla="*/ 1470 h 1535"/>
                    <a:gd name="T104" fmla="*/ 33 w 2651"/>
                    <a:gd name="T105" fmla="*/ 1519 h 153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</a:cxnLst>
                  <a:rect l="0" t="0" r="r" b="b"/>
                  <a:pathLst>
                    <a:path w="2651" h="1535">
                      <a:moveTo>
                        <a:pt x="0" y="999"/>
                      </a:moveTo>
                      <a:lnTo>
                        <a:pt x="33" y="992"/>
                      </a:lnTo>
                      <a:lnTo>
                        <a:pt x="67" y="985"/>
                      </a:lnTo>
                      <a:lnTo>
                        <a:pt x="100" y="978"/>
                      </a:lnTo>
                      <a:lnTo>
                        <a:pt x="134" y="970"/>
                      </a:lnTo>
                      <a:lnTo>
                        <a:pt x="168" y="963"/>
                      </a:lnTo>
                      <a:lnTo>
                        <a:pt x="201" y="955"/>
                      </a:lnTo>
                      <a:lnTo>
                        <a:pt x="234" y="949"/>
                      </a:lnTo>
                      <a:lnTo>
                        <a:pt x="268" y="941"/>
                      </a:lnTo>
                      <a:lnTo>
                        <a:pt x="302" y="933"/>
                      </a:lnTo>
                      <a:lnTo>
                        <a:pt x="335" y="925"/>
                      </a:lnTo>
                      <a:lnTo>
                        <a:pt x="369" y="918"/>
                      </a:lnTo>
                      <a:lnTo>
                        <a:pt x="402" y="910"/>
                      </a:lnTo>
                      <a:lnTo>
                        <a:pt x="437" y="901"/>
                      </a:lnTo>
                      <a:lnTo>
                        <a:pt x="470" y="893"/>
                      </a:lnTo>
                      <a:lnTo>
                        <a:pt x="503" y="885"/>
                      </a:lnTo>
                      <a:lnTo>
                        <a:pt x="537" y="877"/>
                      </a:lnTo>
                      <a:lnTo>
                        <a:pt x="570" y="867"/>
                      </a:lnTo>
                      <a:lnTo>
                        <a:pt x="603" y="858"/>
                      </a:lnTo>
                      <a:lnTo>
                        <a:pt x="638" y="850"/>
                      </a:lnTo>
                      <a:lnTo>
                        <a:pt x="671" y="841"/>
                      </a:lnTo>
                      <a:lnTo>
                        <a:pt x="704" y="832"/>
                      </a:lnTo>
                      <a:lnTo>
                        <a:pt x="738" y="822"/>
                      </a:lnTo>
                      <a:lnTo>
                        <a:pt x="772" y="813"/>
                      </a:lnTo>
                      <a:lnTo>
                        <a:pt x="805" y="802"/>
                      </a:lnTo>
                      <a:lnTo>
                        <a:pt x="839" y="793"/>
                      </a:lnTo>
                      <a:lnTo>
                        <a:pt x="872" y="783"/>
                      </a:lnTo>
                      <a:lnTo>
                        <a:pt x="907" y="772"/>
                      </a:lnTo>
                      <a:lnTo>
                        <a:pt x="940" y="761"/>
                      </a:lnTo>
                      <a:lnTo>
                        <a:pt x="973" y="751"/>
                      </a:lnTo>
                      <a:lnTo>
                        <a:pt x="1007" y="739"/>
                      </a:lnTo>
                      <a:lnTo>
                        <a:pt x="1040" y="729"/>
                      </a:lnTo>
                      <a:lnTo>
                        <a:pt x="1073" y="718"/>
                      </a:lnTo>
                      <a:lnTo>
                        <a:pt x="1108" y="705"/>
                      </a:lnTo>
                      <a:lnTo>
                        <a:pt x="1141" y="694"/>
                      </a:lnTo>
                      <a:lnTo>
                        <a:pt x="1174" y="681"/>
                      </a:lnTo>
                      <a:lnTo>
                        <a:pt x="1208" y="668"/>
                      </a:lnTo>
                      <a:lnTo>
                        <a:pt x="1242" y="656"/>
                      </a:lnTo>
                      <a:lnTo>
                        <a:pt x="1275" y="643"/>
                      </a:lnTo>
                      <a:lnTo>
                        <a:pt x="1309" y="631"/>
                      </a:lnTo>
                      <a:lnTo>
                        <a:pt x="1342" y="617"/>
                      </a:lnTo>
                      <a:lnTo>
                        <a:pt x="1376" y="604"/>
                      </a:lnTo>
                      <a:lnTo>
                        <a:pt x="1410" y="591"/>
                      </a:lnTo>
                      <a:lnTo>
                        <a:pt x="1443" y="577"/>
                      </a:lnTo>
                      <a:lnTo>
                        <a:pt x="1477" y="562"/>
                      </a:lnTo>
                      <a:lnTo>
                        <a:pt x="1510" y="548"/>
                      </a:lnTo>
                      <a:lnTo>
                        <a:pt x="1543" y="534"/>
                      </a:lnTo>
                      <a:lnTo>
                        <a:pt x="1578" y="520"/>
                      </a:lnTo>
                      <a:lnTo>
                        <a:pt x="1611" y="505"/>
                      </a:lnTo>
                      <a:lnTo>
                        <a:pt x="1644" y="490"/>
                      </a:lnTo>
                      <a:lnTo>
                        <a:pt x="1678" y="475"/>
                      </a:lnTo>
                      <a:lnTo>
                        <a:pt x="1712" y="459"/>
                      </a:lnTo>
                      <a:lnTo>
                        <a:pt x="1746" y="444"/>
                      </a:lnTo>
                      <a:lnTo>
                        <a:pt x="1779" y="429"/>
                      </a:lnTo>
                      <a:lnTo>
                        <a:pt x="1812" y="413"/>
                      </a:lnTo>
                      <a:lnTo>
                        <a:pt x="1846" y="397"/>
                      </a:lnTo>
                      <a:lnTo>
                        <a:pt x="1880" y="383"/>
                      </a:lnTo>
                      <a:lnTo>
                        <a:pt x="1913" y="367"/>
                      </a:lnTo>
                      <a:lnTo>
                        <a:pt x="1947" y="351"/>
                      </a:lnTo>
                      <a:lnTo>
                        <a:pt x="1980" y="335"/>
                      </a:lnTo>
                      <a:lnTo>
                        <a:pt x="2013" y="319"/>
                      </a:lnTo>
                      <a:lnTo>
                        <a:pt x="2048" y="301"/>
                      </a:lnTo>
                      <a:lnTo>
                        <a:pt x="2081" y="285"/>
                      </a:lnTo>
                      <a:lnTo>
                        <a:pt x="2114" y="269"/>
                      </a:lnTo>
                      <a:lnTo>
                        <a:pt x="2148" y="253"/>
                      </a:lnTo>
                      <a:lnTo>
                        <a:pt x="2181" y="236"/>
                      </a:lnTo>
                      <a:lnTo>
                        <a:pt x="2216" y="220"/>
                      </a:lnTo>
                      <a:lnTo>
                        <a:pt x="2249" y="203"/>
                      </a:lnTo>
                      <a:lnTo>
                        <a:pt x="2282" y="186"/>
                      </a:lnTo>
                      <a:lnTo>
                        <a:pt x="2316" y="170"/>
                      </a:lnTo>
                      <a:lnTo>
                        <a:pt x="2350" y="153"/>
                      </a:lnTo>
                      <a:lnTo>
                        <a:pt x="2383" y="136"/>
                      </a:lnTo>
                      <a:lnTo>
                        <a:pt x="2417" y="120"/>
                      </a:lnTo>
                      <a:lnTo>
                        <a:pt x="2450" y="102"/>
                      </a:lnTo>
                      <a:lnTo>
                        <a:pt x="2483" y="85"/>
                      </a:lnTo>
                      <a:lnTo>
                        <a:pt x="2518" y="68"/>
                      </a:lnTo>
                      <a:lnTo>
                        <a:pt x="2551" y="51"/>
                      </a:lnTo>
                      <a:lnTo>
                        <a:pt x="2584" y="34"/>
                      </a:lnTo>
                      <a:lnTo>
                        <a:pt x="2618" y="17"/>
                      </a:lnTo>
                      <a:lnTo>
                        <a:pt x="2651" y="0"/>
                      </a:lnTo>
                      <a:lnTo>
                        <a:pt x="2651" y="664"/>
                      </a:lnTo>
                      <a:lnTo>
                        <a:pt x="2618" y="670"/>
                      </a:lnTo>
                      <a:lnTo>
                        <a:pt x="2584" y="676"/>
                      </a:lnTo>
                      <a:lnTo>
                        <a:pt x="2551" y="683"/>
                      </a:lnTo>
                      <a:lnTo>
                        <a:pt x="2518" y="690"/>
                      </a:lnTo>
                      <a:lnTo>
                        <a:pt x="2483" y="697"/>
                      </a:lnTo>
                      <a:lnTo>
                        <a:pt x="2450" y="703"/>
                      </a:lnTo>
                      <a:lnTo>
                        <a:pt x="2417" y="710"/>
                      </a:lnTo>
                      <a:lnTo>
                        <a:pt x="2383" y="716"/>
                      </a:lnTo>
                      <a:lnTo>
                        <a:pt x="2350" y="723"/>
                      </a:lnTo>
                      <a:lnTo>
                        <a:pt x="2316" y="730"/>
                      </a:lnTo>
                      <a:lnTo>
                        <a:pt x="2282" y="737"/>
                      </a:lnTo>
                      <a:lnTo>
                        <a:pt x="2249" y="745"/>
                      </a:lnTo>
                      <a:lnTo>
                        <a:pt x="2216" y="752"/>
                      </a:lnTo>
                      <a:lnTo>
                        <a:pt x="2181" y="759"/>
                      </a:lnTo>
                      <a:lnTo>
                        <a:pt x="2148" y="766"/>
                      </a:lnTo>
                      <a:lnTo>
                        <a:pt x="2114" y="774"/>
                      </a:lnTo>
                      <a:lnTo>
                        <a:pt x="2081" y="780"/>
                      </a:lnTo>
                      <a:lnTo>
                        <a:pt x="2048" y="787"/>
                      </a:lnTo>
                      <a:lnTo>
                        <a:pt x="2013" y="795"/>
                      </a:lnTo>
                      <a:lnTo>
                        <a:pt x="1980" y="803"/>
                      </a:lnTo>
                      <a:lnTo>
                        <a:pt x="1947" y="810"/>
                      </a:lnTo>
                      <a:lnTo>
                        <a:pt x="1913" y="818"/>
                      </a:lnTo>
                      <a:lnTo>
                        <a:pt x="1880" y="826"/>
                      </a:lnTo>
                      <a:lnTo>
                        <a:pt x="1846" y="834"/>
                      </a:lnTo>
                      <a:lnTo>
                        <a:pt x="1812" y="842"/>
                      </a:lnTo>
                      <a:lnTo>
                        <a:pt x="1779" y="850"/>
                      </a:lnTo>
                      <a:lnTo>
                        <a:pt x="1746" y="858"/>
                      </a:lnTo>
                      <a:lnTo>
                        <a:pt x="1712" y="867"/>
                      </a:lnTo>
                      <a:lnTo>
                        <a:pt x="1678" y="875"/>
                      </a:lnTo>
                      <a:lnTo>
                        <a:pt x="1644" y="885"/>
                      </a:lnTo>
                      <a:lnTo>
                        <a:pt x="1611" y="894"/>
                      </a:lnTo>
                      <a:lnTo>
                        <a:pt x="1578" y="902"/>
                      </a:lnTo>
                      <a:lnTo>
                        <a:pt x="1543" y="911"/>
                      </a:lnTo>
                      <a:lnTo>
                        <a:pt x="1510" y="921"/>
                      </a:lnTo>
                      <a:lnTo>
                        <a:pt x="1477" y="930"/>
                      </a:lnTo>
                      <a:lnTo>
                        <a:pt x="1443" y="939"/>
                      </a:lnTo>
                      <a:lnTo>
                        <a:pt x="1410" y="950"/>
                      </a:lnTo>
                      <a:lnTo>
                        <a:pt x="1376" y="960"/>
                      </a:lnTo>
                      <a:lnTo>
                        <a:pt x="1342" y="970"/>
                      </a:lnTo>
                      <a:lnTo>
                        <a:pt x="1309" y="981"/>
                      </a:lnTo>
                      <a:lnTo>
                        <a:pt x="1275" y="991"/>
                      </a:lnTo>
                      <a:lnTo>
                        <a:pt x="1242" y="1002"/>
                      </a:lnTo>
                      <a:lnTo>
                        <a:pt x="1208" y="1013"/>
                      </a:lnTo>
                      <a:lnTo>
                        <a:pt x="1174" y="1024"/>
                      </a:lnTo>
                      <a:lnTo>
                        <a:pt x="1141" y="1035"/>
                      </a:lnTo>
                      <a:lnTo>
                        <a:pt x="1108" y="1048"/>
                      </a:lnTo>
                      <a:lnTo>
                        <a:pt x="1073" y="1059"/>
                      </a:lnTo>
                      <a:lnTo>
                        <a:pt x="1040" y="1072"/>
                      </a:lnTo>
                      <a:lnTo>
                        <a:pt x="1007" y="1085"/>
                      </a:lnTo>
                      <a:lnTo>
                        <a:pt x="973" y="1097"/>
                      </a:lnTo>
                      <a:lnTo>
                        <a:pt x="940" y="1110"/>
                      </a:lnTo>
                      <a:lnTo>
                        <a:pt x="907" y="1123"/>
                      </a:lnTo>
                      <a:lnTo>
                        <a:pt x="872" y="1136"/>
                      </a:lnTo>
                      <a:lnTo>
                        <a:pt x="839" y="1150"/>
                      </a:lnTo>
                      <a:lnTo>
                        <a:pt x="805" y="1164"/>
                      </a:lnTo>
                      <a:lnTo>
                        <a:pt x="772" y="1177"/>
                      </a:lnTo>
                      <a:lnTo>
                        <a:pt x="738" y="1192"/>
                      </a:lnTo>
                      <a:lnTo>
                        <a:pt x="704" y="1206"/>
                      </a:lnTo>
                      <a:lnTo>
                        <a:pt x="671" y="1221"/>
                      </a:lnTo>
                      <a:lnTo>
                        <a:pt x="638" y="1236"/>
                      </a:lnTo>
                      <a:lnTo>
                        <a:pt x="603" y="1250"/>
                      </a:lnTo>
                      <a:lnTo>
                        <a:pt x="570" y="1265"/>
                      </a:lnTo>
                      <a:lnTo>
                        <a:pt x="537" y="1280"/>
                      </a:lnTo>
                      <a:lnTo>
                        <a:pt x="503" y="1295"/>
                      </a:lnTo>
                      <a:lnTo>
                        <a:pt x="470" y="1310"/>
                      </a:lnTo>
                      <a:lnTo>
                        <a:pt x="437" y="1326"/>
                      </a:lnTo>
                      <a:lnTo>
                        <a:pt x="402" y="1342"/>
                      </a:lnTo>
                      <a:lnTo>
                        <a:pt x="369" y="1357"/>
                      </a:lnTo>
                      <a:lnTo>
                        <a:pt x="335" y="1373"/>
                      </a:lnTo>
                      <a:lnTo>
                        <a:pt x="302" y="1389"/>
                      </a:lnTo>
                      <a:lnTo>
                        <a:pt x="268" y="1405"/>
                      </a:lnTo>
                      <a:lnTo>
                        <a:pt x="234" y="1421"/>
                      </a:lnTo>
                      <a:lnTo>
                        <a:pt x="201" y="1437"/>
                      </a:lnTo>
                      <a:lnTo>
                        <a:pt x="168" y="1453"/>
                      </a:lnTo>
                      <a:lnTo>
                        <a:pt x="134" y="1470"/>
                      </a:lnTo>
                      <a:lnTo>
                        <a:pt x="100" y="1486"/>
                      </a:lnTo>
                      <a:lnTo>
                        <a:pt x="67" y="1502"/>
                      </a:lnTo>
                      <a:lnTo>
                        <a:pt x="33" y="1519"/>
                      </a:lnTo>
                      <a:lnTo>
                        <a:pt x="0" y="1535"/>
                      </a:lnTo>
                      <a:lnTo>
                        <a:pt x="0" y="999"/>
                      </a:lnTo>
                      <a:close/>
                    </a:path>
                  </a:pathLst>
                </a:cu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9" name="Freeform 124">
                  <a:extLst>
                    <a:ext uri="{FF2B5EF4-FFF2-40B4-BE49-F238E27FC236}">
                      <a16:creationId xmlns:a16="http://schemas.microsoft.com/office/drawing/2014/main" id="{0CFCD6C0-9B3F-B75E-7609-8E596C56B34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778625" y="2531514"/>
                  <a:ext cx="4208462" cy="1585913"/>
                </a:xfrm>
                <a:custGeom>
                  <a:avLst/>
                  <a:gdLst>
                    <a:gd name="T0" fmla="*/ 33 w 2651"/>
                    <a:gd name="T1" fmla="*/ 992 h 999"/>
                    <a:gd name="T2" fmla="*/ 100 w 2651"/>
                    <a:gd name="T3" fmla="*/ 978 h 999"/>
                    <a:gd name="T4" fmla="*/ 168 w 2651"/>
                    <a:gd name="T5" fmla="*/ 963 h 999"/>
                    <a:gd name="T6" fmla="*/ 234 w 2651"/>
                    <a:gd name="T7" fmla="*/ 949 h 999"/>
                    <a:gd name="T8" fmla="*/ 302 w 2651"/>
                    <a:gd name="T9" fmla="*/ 933 h 999"/>
                    <a:gd name="T10" fmla="*/ 369 w 2651"/>
                    <a:gd name="T11" fmla="*/ 918 h 999"/>
                    <a:gd name="T12" fmla="*/ 437 w 2651"/>
                    <a:gd name="T13" fmla="*/ 901 h 999"/>
                    <a:gd name="T14" fmla="*/ 503 w 2651"/>
                    <a:gd name="T15" fmla="*/ 885 h 999"/>
                    <a:gd name="T16" fmla="*/ 570 w 2651"/>
                    <a:gd name="T17" fmla="*/ 867 h 999"/>
                    <a:gd name="T18" fmla="*/ 638 w 2651"/>
                    <a:gd name="T19" fmla="*/ 850 h 999"/>
                    <a:gd name="T20" fmla="*/ 704 w 2651"/>
                    <a:gd name="T21" fmla="*/ 832 h 999"/>
                    <a:gd name="T22" fmla="*/ 772 w 2651"/>
                    <a:gd name="T23" fmla="*/ 813 h 999"/>
                    <a:gd name="T24" fmla="*/ 839 w 2651"/>
                    <a:gd name="T25" fmla="*/ 793 h 999"/>
                    <a:gd name="T26" fmla="*/ 907 w 2651"/>
                    <a:gd name="T27" fmla="*/ 772 h 999"/>
                    <a:gd name="T28" fmla="*/ 973 w 2651"/>
                    <a:gd name="T29" fmla="*/ 751 h 999"/>
                    <a:gd name="T30" fmla="*/ 1040 w 2651"/>
                    <a:gd name="T31" fmla="*/ 729 h 999"/>
                    <a:gd name="T32" fmla="*/ 1108 w 2651"/>
                    <a:gd name="T33" fmla="*/ 705 h 999"/>
                    <a:gd name="T34" fmla="*/ 1174 w 2651"/>
                    <a:gd name="T35" fmla="*/ 681 h 999"/>
                    <a:gd name="T36" fmla="*/ 1242 w 2651"/>
                    <a:gd name="T37" fmla="*/ 656 h 999"/>
                    <a:gd name="T38" fmla="*/ 1309 w 2651"/>
                    <a:gd name="T39" fmla="*/ 631 h 999"/>
                    <a:gd name="T40" fmla="*/ 1376 w 2651"/>
                    <a:gd name="T41" fmla="*/ 604 h 999"/>
                    <a:gd name="T42" fmla="*/ 1443 w 2651"/>
                    <a:gd name="T43" fmla="*/ 577 h 999"/>
                    <a:gd name="T44" fmla="*/ 1510 w 2651"/>
                    <a:gd name="T45" fmla="*/ 548 h 999"/>
                    <a:gd name="T46" fmla="*/ 1578 w 2651"/>
                    <a:gd name="T47" fmla="*/ 520 h 999"/>
                    <a:gd name="T48" fmla="*/ 1644 w 2651"/>
                    <a:gd name="T49" fmla="*/ 490 h 999"/>
                    <a:gd name="T50" fmla="*/ 1712 w 2651"/>
                    <a:gd name="T51" fmla="*/ 459 h 999"/>
                    <a:gd name="T52" fmla="*/ 1779 w 2651"/>
                    <a:gd name="T53" fmla="*/ 429 h 999"/>
                    <a:gd name="T54" fmla="*/ 1846 w 2651"/>
                    <a:gd name="T55" fmla="*/ 397 h 999"/>
                    <a:gd name="T56" fmla="*/ 1913 w 2651"/>
                    <a:gd name="T57" fmla="*/ 367 h 999"/>
                    <a:gd name="T58" fmla="*/ 1980 w 2651"/>
                    <a:gd name="T59" fmla="*/ 335 h 999"/>
                    <a:gd name="T60" fmla="*/ 2048 w 2651"/>
                    <a:gd name="T61" fmla="*/ 301 h 999"/>
                    <a:gd name="T62" fmla="*/ 2114 w 2651"/>
                    <a:gd name="T63" fmla="*/ 269 h 999"/>
                    <a:gd name="T64" fmla="*/ 2181 w 2651"/>
                    <a:gd name="T65" fmla="*/ 236 h 999"/>
                    <a:gd name="T66" fmla="*/ 2249 w 2651"/>
                    <a:gd name="T67" fmla="*/ 203 h 999"/>
                    <a:gd name="T68" fmla="*/ 2316 w 2651"/>
                    <a:gd name="T69" fmla="*/ 170 h 999"/>
                    <a:gd name="T70" fmla="*/ 2383 w 2651"/>
                    <a:gd name="T71" fmla="*/ 136 h 999"/>
                    <a:gd name="T72" fmla="*/ 2450 w 2651"/>
                    <a:gd name="T73" fmla="*/ 102 h 999"/>
                    <a:gd name="T74" fmla="*/ 2518 w 2651"/>
                    <a:gd name="T75" fmla="*/ 68 h 999"/>
                    <a:gd name="T76" fmla="*/ 2584 w 2651"/>
                    <a:gd name="T77" fmla="*/ 34 h 999"/>
                    <a:gd name="T78" fmla="*/ 2651 w 2651"/>
                    <a:gd name="T79" fmla="*/ 0 h 99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</a:cxnLst>
                  <a:rect l="0" t="0" r="r" b="b"/>
                  <a:pathLst>
                    <a:path w="2651" h="999">
                      <a:moveTo>
                        <a:pt x="0" y="999"/>
                      </a:moveTo>
                      <a:lnTo>
                        <a:pt x="33" y="992"/>
                      </a:lnTo>
                      <a:lnTo>
                        <a:pt x="67" y="985"/>
                      </a:lnTo>
                      <a:lnTo>
                        <a:pt x="100" y="978"/>
                      </a:lnTo>
                      <a:lnTo>
                        <a:pt x="134" y="970"/>
                      </a:lnTo>
                      <a:lnTo>
                        <a:pt x="168" y="963"/>
                      </a:lnTo>
                      <a:lnTo>
                        <a:pt x="201" y="955"/>
                      </a:lnTo>
                      <a:lnTo>
                        <a:pt x="234" y="949"/>
                      </a:lnTo>
                      <a:lnTo>
                        <a:pt x="268" y="941"/>
                      </a:lnTo>
                      <a:lnTo>
                        <a:pt x="302" y="933"/>
                      </a:lnTo>
                      <a:lnTo>
                        <a:pt x="335" y="925"/>
                      </a:lnTo>
                      <a:lnTo>
                        <a:pt x="369" y="918"/>
                      </a:lnTo>
                      <a:lnTo>
                        <a:pt x="402" y="910"/>
                      </a:lnTo>
                      <a:lnTo>
                        <a:pt x="437" y="901"/>
                      </a:lnTo>
                      <a:lnTo>
                        <a:pt x="470" y="893"/>
                      </a:lnTo>
                      <a:lnTo>
                        <a:pt x="503" y="885"/>
                      </a:lnTo>
                      <a:lnTo>
                        <a:pt x="537" y="877"/>
                      </a:lnTo>
                      <a:lnTo>
                        <a:pt x="570" y="867"/>
                      </a:lnTo>
                      <a:lnTo>
                        <a:pt x="603" y="858"/>
                      </a:lnTo>
                      <a:lnTo>
                        <a:pt x="638" y="850"/>
                      </a:lnTo>
                      <a:lnTo>
                        <a:pt x="671" y="841"/>
                      </a:lnTo>
                      <a:lnTo>
                        <a:pt x="704" y="832"/>
                      </a:lnTo>
                      <a:lnTo>
                        <a:pt x="738" y="822"/>
                      </a:lnTo>
                      <a:lnTo>
                        <a:pt x="772" y="813"/>
                      </a:lnTo>
                      <a:lnTo>
                        <a:pt x="805" y="802"/>
                      </a:lnTo>
                      <a:lnTo>
                        <a:pt x="839" y="793"/>
                      </a:lnTo>
                      <a:lnTo>
                        <a:pt x="872" y="783"/>
                      </a:lnTo>
                      <a:lnTo>
                        <a:pt x="907" y="772"/>
                      </a:lnTo>
                      <a:lnTo>
                        <a:pt x="940" y="761"/>
                      </a:lnTo>
                      <a:lnTo>
                        <a:pt x="973" y="751"/>
                      </a:lnTo>
                      <a:lnTo>
                        <a:pt x="1007" y="739"/>
                      </a:lnTo>
                      <a:lnTo>
                        <a:pt x="1040" y="729"/>
                      </a:lnTo>
                      <a:lnTo>
                        <a:pt x="1073" y="718"/>
                      </a:lnTo>
                      <a:lnTo>
                        <a:pt x="1108" y="705"/>
                      </a:lnTo>
                      <a:lnTo>
                        <a:pt x="1141" y="694"/>
                      </a:lnTo>
                      <a:lnTo>
                        <a:pt x="1174" y="681"/>
                      </a:lnTo>
                      <a:lnTo>
                        <a:pt x="1208" y="668"/>
                      </a:lnTo>
                      <a:lnTo>
                        <a:pt x="1242" y="656"/>
                      </a:lnTo>
                      <a:lnTo>
                        <a:pt x="1275" y="643"/>
                      </a:lnTo>
                      <a:lnTo>
                        <a:pt x="1309" y="631"/>
                      </a:lnTo>
                      <a:lnTo>
                        <a:pt x="1342" y="617"/>
                      </a:lnTo>
                      <a:lnTo>
                        <a:pt x="1376" y="604"/>
                      </a:lnTo>
                      <a:lnTo>
                        <a:pt x="1410" y="591"/>
                      </a:lnTo>
                      <a:lnTo>
                        <a:pt x="1443" y="577"/>
                      </a:lnTo>
                      <a:lnTo>
                        <a:pt x="1477" y="562"/>
                      </a:lnTo>
                      <a:lnTo>
                        <a:pt x="1510" y="548"/>
                      </a:lnTo>
                      <a:lnTo>
                        <a:pt x="1543" y="534"/>
                      </a:lnTo>
                      <a:lnTo>
                        <a:pt x="1578" y="520"/>
                      </a:lnTo>
                      <a:lnTo>
                        <a:pt x="1611" y="505"/>
                      </a:lnTo>
                      <a:lnTo>
                        <a:pt x="1644" y="490"/>
                      </a:lnTo>
                      <a:lnTo>
                        <a:pt x="1678" y="475"/>
                      </a:lnTo>
                      <a:lnTo>
                        <a:pt x="1712" y="459"/>
                      </a:lnTo>
                      <a:lnTo>
                        <a:pt x="1746" y="444"/>
                      </a:lnTo>
                      <a:lnTo>
                        <a:pt x="1779" y="429"/>
                      </a:lnTo>
                      <a:lnTo>
                        <a:pt x="1812" y="413"/>
                      </a:lnTo>
                      <a:lnTo>
                        <a:pt x="1846" y="397"/>
                      </a:lnTo>
                      <a:lnTo>
                        <a:pt x="1880" y="383"/>
                      </a:lnTo>
                      <a:lnTo>
                        <a:pt x="1913" y="367"/>
                      </a:lnTo>
                      <a:lnTo>
                        <a:pt x="1947" y="351"/>
                      </a:lnTo>
                      <a:lnTo>
                        <a:pt x="1980" y="335"/>
                      </a:lnTo>
                      <a:lnTo>
                        <a:pt x="2013" y="319"/>
                      </a:lnTo>
                      <a:lnTo>
                        <a:pt x="2048" y="301"/>
                      </a:lnTo>
                      <a:lnTo>
                        <a:pt x="2081" y="285"/>
                      </a:lnTo>
                      <a:lnTo>
                        <a:pt x="2114" y="269"/>
                      </a:lnTo>
                      <a:lnTo>
                        <a:pt x="2148" y="253"/>
                      </a:lnTo>
                      <a:lnTo>
                        <a:pt x="2181" y="236"/>
                      </a:lnTo>
                      <a:lnTo>
                        <a:pt x="2216" y="220"/>
                      </a:lnTo>
                      <a:lnTo>
                        <a:pt x="2249" y="203"/>
                      </a:lnTo>
                      <a:lnTo>
                        <a:pt x="2282" y="186"/>
                      </a:lnTo>
                      <a:lnTo>
                        <a:pt x="2316" y="170"/>
                      </a:lnTo>
                      <a:lnTo>
                        <a:pt x="2350" y="153"/>
                      </a:lnTo>
                      <a:lnTo>
                        <a:pt x="2383" y="136"/>
                      </a:lnTo>
                      <a:lnTo>
                        <a:pt x="2417" y="120"/>
                      </a:lnTo>
                      <a:lnTo>
                        <a:pt x="2450" y="102"/>
                      </a:lnTo>
                      <a:lnTo>
                        <a:pt x="2483" y="85"/>
                      </a:lnTo>
                      <a:lnTo>
                        <a:pt x="2518" y="68"/>
                      </a:lnTo>
                      <a:lnTo>
                        <a:pt x="2551" y="51"/>
                      </a:lnTo>
                      <a:lnTo>
                        <a:pt x="2584" y="34"/>
                      </a:lnTo>
                      <a:lnTo>
                        <a:pt x="2618" y="17"/>
                      </a:lnTo>
                      <a:lnTo>
                        <a:pt x="2651" y="0"/>
                      </a:lnTo>
                    </a:path>
                  </a:pathLst>
                </a:cu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20" name="Freeform 125">
                  <a:extLst>
                    <a:ext uri="{FF2B5EF4-FFF2-40B4-BE49-F238E27FC236}">
                      <a16:creationId xmlns:a16="http://schemas.microsoft.com/office/drawing/2014/main" id="{1036AC90-9BAA-375C-CC8B-850F03812F7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778625" y="3585614"/>
                  <a:ext cx="4208462" cy="1382713"/>
                </a:xfrm>
                <a:custGeom>
                  <a:avLst/>
                  <a:gdLst>
                    <a:gd name="T0" fmla="*/ 2618 w 2651"/>
                    <a:gd name="T1" fmla="*/ 6 h 871"/>
                    <a:gd name="T2" fmla="*/ 2551 w 2651"/>
                    <a:gd name="T3" fmla="*/ 19 h 871"/>
                    <a:gd name="T4" fmla="*/ 2483 w 2651"/>
                    <a:gd name="T5" fmla="*/ 33 h 871"/>
                    <a:gd name="T6" fmla="*/ 2417 w 2651"/>
                    <a:gd name="T7" fmla="*/ 46 h 871"/>
                    <a:gd name="T8" fmla="*/ 2350 w 2651"/>
                    <a:gd name="T9" fmla="*/ 59 h 871"/>
                    <a:gd name="T10" fmla="*/ 2282 w 2651"/>
                    <a:gd name="T11" fmla="*/ 73 h 871"/>
                    <a:gd name="T12" fmla="*/ 2216 w 2651"/>
                    <a:gd name="T13" fmla="*/ 88 h 871"/>
                    <a:gd name="T14" fmla="*/ 2148 w 2651"/>
                    <a:gd name="T15" fmla="*/ 102 h 871"/>
                    <a:gd name="T16" fmla="*/ 2081 w 2651"/>
                    <a:gd name="T17" fmla="*/ 116 h 871"/>
                    <a:gd name="T18" fmla="*/ 2013 w 2651"/>
                    <a:gd name="T19" fmla="*/ 131 h 871"/>
                    <a:gd name="T20" fmla="*/ 1947 w 2651"/>
                    <a:gd name="T21" fmla="*/ 146 h 871"/>
                    <a:gd name="T22" fmla="*/ 1880 w 2651"/>
                    <a:gd name="T23" fmla="*/ 162 h 871"/>
                    <a:gd name="T24" fmla="*/ 1812 w 2651"/>
                    <a:gd name="T25" fmla="*/ 178 h 871"/>
                    <a:gd name="T26" fmla="*/ 1746 w 2651"/>
                    <a:gd name="T27" fmla="*/ 194 h 871"/>
                    <a:gd name="T28" fmla="*/ 1678 w 2651"/>
                    <a:gd name="T29" fmla="*/ 211 h 871"/>
                    <a:gd name="T30" fmla="*/ 1611 w 2651"/>
                    <a:gd name="T31" fmla="*/ 230 h 871"/>
                    <a:gd name="T32" fmla="*/ 1543 w 2651"/>
                    <a:gd name="T33" fmla="*/ 247 h 871"/>
                    <a:gd name="T34" fmla="*/ 1477 w 2651"/>
                    <a:gd name="T35" fmla="*/ 266 h 871"/>
                    <a:gd name="T36" fmla="*/ 1410 w 2651"/>
                    <a:gd name="T37" fmla="*/ 286 h 871"/>
                    <a:gd name="T38" fmla="*/ 1342 w 2651"/>
                    <a:gd name="T39" fmla="*/ 306 h 871"/>
                    <a:gd name="T40" fmla="*/ 1275 w 2651"/>
                    <a:gd name="T41" fmla="*/ 327 h 871"/>
                    <a:gd name="T42" fmla="*/ 1208 w 2651"/>
                    <a:gd name="T43" fmla="*/ 349 h 871"/>
                    <a:gd name="T44" fmla="*/ 1141 w 2651"/>
                    <a:gd name="T45" fmla="*/ 371 h 871"/>
                    <a:gd name="T46" fmla="*/ 1073 w 2651"/>
                    <a:gd name="T47" fmla="*/ 395 h 871"/>
                    <a:gd name="T48" fmla="*/ 1007 w 2651"/>
                    <a:gd name="T49" fmla="*/ 421 h 871"/>
                    <a:gd name="T50" fmla="*/ 940 w 2651"/>
                    <a:gd name="T51" fmla="*/ 446 h 871"/>
                    <a:gd name="T52" fmla="*/ 872 w 2651"/>
                    <a:gd name="T53" fmla="*/ 472 h 871"/>
                    <a:gd name="T54" fmla="*/ 805 w 2651"/>
                    <a:gd name="T55" fmla="*/ 500 h 871"/>
                    <a:gd name="T56" fmla="*/ 738 w 2651"/>
                    <a:gd name="T57" fmla="*/ 528 h 871"/>
                    <a:gd name="T58" fmla="*/ 671 w 2651"/>
                    <a:gd name="T59" fmla="*/ 557 h 871"/>
                    <a:gd name="T60" fmla="*/ 603 w 2651"/>
                    <a:gd name="T61" fmla="*/ 586 h 871"/>
                    <a:gd name="T62" fmla="*/ 537 w 2651"/>
                    <a:gd name="T63" fmla="*/ 616 h 871"/>
                    <a:gd name="T64" fmla="*/ 470 w 2651"/>
                    <a:gd name="T65" fmla="*/ 646 h 871"/>
                    <a:gd name="T66" fmla="*/ 402 w 2651"/>
                    <a:gd name="T67" fmla="*/ 678 h 871"/>
                    <a:gd name="T68" fmla="*/ 335 w 2651"/>
                    <a:gd name="T69" fmla="*/ 709 h 871"/>
                    <a:gd name="T70" fmla="*/ 268 w 2651"/>
                    <a:gd name="T71" fmla="*/ 741 h 871"/>
                    <a:gd name="T72" fmla="*/ 201 w 2651"/>
                    <a:gd name="T73" fmla="*/ 773 h 871"/>
                    <a:gd name="T74" fmla="*/ 134 w 2651"/>
                    <a:gd name="T75" fmla="*/ 806 h 871"/>
                    <a:gd name="T76" fmla="*/ 67 w 2651"/>
                    <a:gd name="T77" fmla="*/ 838 h 871"/>
                    <a:gd name="T78" fmla="*/ 0 w 2651"/>
                    <a:gd name="T79" fmla="*/ 871 h 87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</a:cxnLst>
                  <a:rect l="0" t="0" r="r" b="b"/>
                  <a:pathLst>
                    <a:path w="2651" h="871">
                      <a:moveTo>
                        <a:pt x="2651" y="0"/>
                      </a:moveTo>
                      <a:lnTo>
                        <a:pt x="2618" y="6"/>
                      </a:lnTo>
                      <a:lnTo>
                        <a:pt x="2584" y="12"/>
                      </a:lnTo>
                      <a:lnTo>
                        <a:pt x="2551" y="19"/>
                      </a:lnTo>
                      <a:lnTo>
                        <a:pt x="2518" y="26"/>
                      </a:lnTo>
                      <a:lnTo>
                        <a:pt x="2483" y="33"/>
                      </a:lnTo>
                      <a:lnTo>
                        <a:pt x="2450" y="39"/>
                      </a:lnTo>
                      <a:lnTo>
                        <a:pt x="2417" y="46"/>
                      </a:lnTo>
                      <a:lnTo>
                        <a:pt x="2383" y="52"/>
                      </a:lnTo>
                      <a:lnTo>
                        <a:pt x="2350" y="59"/>
                      </a:lnTo>
                      <a:lnTo>
                        <a:pt x="2316" y="66"/>
                      </a:lnTo>
                      <a:lnTo>
                        <a:pt x="2282" y="73"/>
                      </a:lnTo>
                      <a:lnTo>
                        <a:pt x="2249" y="81"/>
                      </a:lnTo>
                      <a:lnTo>
                        <a:pt x="2216" y="88"/>
                      </a:lnTo>
                      <a:lnTo>
                        <a:pt x="2181" y="95"/>
                      </a:lnTo>
                      <a:lnTo>
                        <a:pt x="2148" y="102"/>
                      </a:lnTo>
                      <a:lnTo>
                        <a:pt x="2114" y="110"/>
                      </a:lnTo>
                      <a:lnTo>
                        <a:pt x="2081" y="116"/>
                      </a:lnTo>
                      <a:lnTo>
                        <a:pt x="2048" y="123"/>
                      </a:lnTo>
                      <a:lnTo>
                        <a:pt x="2013" y="131"/>
                      </a:lnTo>
                      <a:lnTo>
                        <a:pt x="1980" y="139"/>
                      </a:lnTo>
                      <a:lnTo>
                        <a:pt x="1947" y="146"/>
                      </a:lnTo>
                      <a:lnTo>
                        <a:pt x="1913" y="154"/>
                      </a:lnTo>
                      <a:lnTo>
                        <a:pt x="1880" y="162"/>
                      </a:lnTo>
                      <a:lnTo>
                        <a:pt x="1846" y="170"/>
                      </a:lnTo>
                      <a:lnTo>
                        <a:pt x="1812" y="178"/>
                      </a:lnTo>
                      <a:lnTo>
                        <a:pt x="1779" y="186"/>
                      </a:lnTo>
                      <a:lnTo>
                        <a:pt x="1746" y="194"/>
                      </a:lnTo>
                      <a:lnTo>
                        <a:pt x="1712" y="203"/>
                      </a:lnTo>
                      <a:lnTo>
                        <a:pt x="1678" y="211"/>
                      </a:lnTo>
                      <a:lnTo>
                        <a:pt x="1644" y="221"/>
                      </a:lnTo>
                      <a:lnTo>
                        <a:pt x="1611" y="230"/>
                      </a:lnTo>
                      <a:lnTo>
                        <a:pt x="1578" y="238"/>
                      </a:lnTo>
                      <a:lnTo>
                        <a:pt x="1543" y="247"/>
                      </a:lnTo>
                      <a:lnTo>
                        <a:pt x="1510" y="257"/>
                      </a:lnTo>
                      <a:lnTo>
                        <a:pt x="1477" y="266"/>
                      </a:lnTo>
                      <a:lnTo>
                        <a:pt x="1443" y="275"/>
                      </a:lnTo>
                      <a:lnTo>
                        <a:pt x="1410" y="286"/>
                      </a:lnTo>
                      <a:lnTo>
                        <a:pt x="1376" y="296"/>
                      </a:lnTo>
                      <a:lnTo>
                        <a:pt x="1342" y="306"/>
                      </a:lnTo>
                      <a:lnTo>
                        <a:pt x="1309" y="317"/>
                      </a:lnTo>
                      <a:lnTo>
                        <a:pt x="1275" y="327"/>
                      </a:lnTo>
                      <a:lnTo>
                        <a:pt x="1242" y="338"/>
                      </a:lnTo>
                      <a:lnTo>
                        <a:pt x="1208" y="349"/>
                      </a:lnTo>
                      <a:lnTo>
                        <a:pt x="1174" y="360"/>
                      </a:lnTo>
                      <a:lnTo>
                        <a:pt x="1141" y="371"/>
                      </a:lnTo>
                      <a:lnTo>
                        <a:pt x="1108" y="384"/>
                      </a:lnTo>
                      <a:lnTo>
                        <a:pt x="1073" y="395"/>
                      </a:lnTo>
                      <a:lnTo>
                        <a:pt x="1040" y="408"/>
                      </a:lnTo>
                      <a:lnTo>
                        <a:pt x="1007" y="421"/>
                      </a:lnTo>
                      <a:lnTo>
                        <a:pt x="973" y="433"/>
                      </a:lnTo>
                      <a:lnTo>
                        <a:pt x="940" y="446"/>
                      </a:lnTo>
                      <a:lnTo>
                        <a:pt x="907" y="459"/>
                      </a:lnTo>
                      <a:lnTo>
                        <a:pt x="872" y="472"/>
                      </a:lnTo>
                      <a:lnTo>
                        <a:pt x="839" y="486"/>
                      </a:lnTo>
                      <a:lnTo>
                        <a:pt x="805" y="500"/>
                      </a:lnTo>
                      <a:lnTo>
                        <a:pt x="772" y="513"/>
                      </a:lnTo>
                      <a:lnTo>
                        <a:pt x="738" y="528"/>
                      </a:lnTo>
                      <a:lnTo>
                        <a:pt x="704" y="542"/>
                      </a:lnTo>
                      <a:lnTo>
                        <a:pt x="671" y="557"/>
                      </a:lnTo>
                      <a:lnTo>
                        <a:pt x="638" y="572"/>
                      </a:lnTo>
                      <a:lnTo>
                        <a:pt x="603" y="586"/>
                      </a:lnTo>
                      <a:lnTo>
                        <a:pt x="570" y="601"/>
                      </a:lnTo>
                      <a:lnTo>
                        <a:pt x="537" y="616"/>
                      </a:lnTo>
                      <a:lnTo>
                        <a:pt x="503" y="631"/>
                      </a:lnTo>
                      <a:lnTo>
                        <a:pt x="470" y="646"/>
                      </a:lnTo>
                      <a:lnTo>
                        <a:pt x="437" y="662"/>
                      </a:lnTo>
                      <a:lnTo>
                        <a:pt x="402" y="678"/>
                      </a:lnTo>
                      <a:lnTo>
                        <a:pt x="369" y="693"/>
                      </a:lnTo>
                      <a:lnTo>
                        <a:pt x="335" y="709"/>
                      </a:lnTo>
                      <a:lnTo>
                        <a:pt x="302" y="725"/>
                      </a:lnTo>
                      <a:lnTo>
                        <a:pt x="268" y="741"/>
                      </a:lnTo>
                      <a:lnTo>
                        <a:pt x="234" y="757"/>
                      </a:lnTo>
                      <a:lnTo>
                        <a:pt x="201" y="773"/>
                      </a:lnTo>
                      <a:lnTo>
                        <a:pt x="168" y="789"/>
                      </a:lnTo>
                      <a:lnTo>
                        <a:pt x="134" y="806"/>
                      </a:lnTo>
                      <a:lnTo>
                        <a:pt x="100" y="822"/>
                      </a:lnTo>
                      <a:lnTo>
                        <a:pt x="67" y="838"/>
                      </a:lnTo>
                      <a:lnTo>
                        <a:pt x="33" y="855"/>
                      </a:lnTo>
                      <a:lnTo>
                        <a:pt x="0" y="871"/>
                      </a:lnTo>
                    </a:path>
                  </a:pathLst>
                </a:cu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21" name="Freeform 126">
                  <a:extLst>
                    <a:ext uri="{FF2B5EF4-FFF2-40B4-BE49-F238E27FC236}">
                      <a16:creationId xmlns:a16="http://schemas.microsoft.com/office/drawing/2014/main" id="{596C4E67-A8FC-659B-9BBD-172800FFDCB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778625" y="3058564"/>
                  <a:ext cx="4208462" cy="1485900"/>
                </a:xfrm>
                <a:custGeom>
                  <a:avLst/>
                  <a:gdLst>
                    <a:gd name="T0" fmla="*/ 33 w 2651"/>
                    <a:gd name="T1" fmla="*/ 924 h 936"/>
                    <a:gd name="T2" fmla="*/ 100 w 2651"/>
                    <a:gd name="T3" fmla="*/ 900 h 936"/>
                    <a:gd name="T4" fmla="*/ 168 w 2651"/>
                    <a:gd name="T5" fmla="*/ 876 h 936"/>
                    <a:gd name="T6" fmla="*/ 234 w 2651"/>
                    <a:gd name="T7" fmla="*/ 852 h 936"/>
                    <a:gd name="T8" fmla="*/ 302 w 2651"/>
                    <a:gd name="T9" fmla="*/ 829 h 936"/>
                    <a:gd name="T10" fmla="*/ 369 w 2651"/>
                    <a:gd name="T11" fmla="*/ 805 h 936"/>
                    <a:gd name="T12" fmla="*/ 437 w 2651"/>
                    <a:gd name="T13" fmla="*/ 781 h 936"/>
                    <a:gd name="T14" fmla="*/ 503 w 2651"/>
                    <a:gd name="T15" fmla="*/ 758 h 936"/>
                    <a:gd name="T16" fmla="*/ 570 w 2651"/>
                    <a:gd name="T17" fmla="*/ 734 h 936"/>
                    <a:gd name="T18" fmla="*/ 638 w 2651"/>
                    <a:gd name="T19" fmla="*/ 710 h 936"/>
                    <a:gd name="T20" fmla="*/ 704 w 2651"/>
                    <a:gd name="T21" fmla="*/ 686 h 936"/>
                    <a:gd name="T22" fmla="*/ 772 w 2651"/>
                    <a:gd name="T23" fmla="*/ 663 h 936"/>
                    <a:gd name="T24" fmla="*/ 839 w 2651"/>
                    <a:gd name="T25" fmla="*/ 639 h 936"/>
                    <a:gd name="T26" fmla="*/ 907 w 2651"/>
                    <a:gd name="T27" fmla="*/ 615 h 936"/>
                    <a:gd name="T28" fmla="*/ 973 w 2651"/>
                    <a:gd name="T29" fmla="*/ 591 h 936"/>
                    <a:gd name="T30" fmla="*/ 1040 w 2651"/>
                    <a:gd name="T31" fmla="*/ 569 h 936"/>
                    <a:gd name="T32" fmla="*/ 1108 w 2651"/>
                    <a:gd name="T33" fmla="*/ 545 h 936"/>
                    <a:gd name="T34" fmla="*/ 1174 w 2651"/>
                    <a:gd name="T35" fmla="*/ 521 h 936"/>
                    <a:gd name="T36" fmla="*/ 1242 w 2651"/>
                    <a:gd name="T37" fmla="*/ 498 h 936"/>
                    <a:gd name="T38" fmla="*/ 1309 w 2651"/>
                    <a:gd name="T39" fmla="*/ 474 h 936"/>
                    <a:gd name="T40" fmla="*/ 1376 w 2651"/>
                    <a:gd name="T41" fmla="*/ 450 h 936"/>
                    <a:gd name="T42" fmla="*/ 1443 w 2651"/>
                    <a:gd name="T43" fmla="*/ 426 h 936"/>
                    <a:gd name="T44" fmla="*/ 1510 w 2651"/>
                    <a:gd name="T45" fmla="*/ 403 h 936"/>
                    <a:gd name="T46" fmla="*/ 1578 w 2651"/>
                    <a:gd name="T47" fmla="*/ 379 h 936"/>
                    <a:gd name="T48" fmla="*/ 1644 w 2651"/>
                    <a:gd name="T49" fmla="*/ 355 h 936"/>
                    <a:gd name="T50" fmla="*/ 1712 w 2651"/>
                    <a:gd name="T51" fmla="*/ 332 h 936"/>
                    <a:gd name="T52" fmla="*/ 1779 w 2651"/>
                    <a:gd name="T53" fmla="*/ 308 h 936"/>
                    <a:gd name="T54" fmla="*/ 1846 w 2651"/>
                    <a:gd name="T55" fmla="*/ 284 h 936"/>
                    <a:gd name="T56" fmla="*/ 1913 w 2651"/>
                    <a:gd name="T57" fmla="*/ 260 h 936"/>
                    <a:gd name="T58" fmla="*/ 1980 w 2651"/>
                    <a:gd name="T59" fmla="*/ 237 h 936"/>
                    <a:gd name="T60" fmla="*/ 2048 w 2651"/>
                    <a:gd name="T61" fmla="*/ 213 h 936"/>
                    <a:gd name="T62" fmla="*/ 2114 w 2651"/>
                    <a:gd name="T63" fmla="*/ 189 h 936"/>
                    <a:gd name="T64" fmla="*/ 2181 w 2651"/>
                    <a:gd name="T65" fmla="*/ 166 h 936"/>
                    <a:gd name="T66" fmla="*/ 2249 w 2651"/>
                    <a:gd name="T67" fmla="*/ 142 h 936"/>
                    <a:gd name="T68" fmla="*/ 2316 w 2651"/>
                    <a:gd name="T69" fmla="*/ 118 h 936"/>
                    <a:gd name="T70" fmla="*/ 2383 w 2651"/>
                    <a:gd name="T71" fmla="*/ 94 h 936"/>
                    <a:gd name="T72" fmla="*/ 2450 w 2651"/>
                    <a:gd name="T73" fmla="*/ 71 h 936"/>
                    <a:gd name="T74" fmla="*/ 2518 w 2651"/>
                    <a:gd name="T75" fmla="*/ 47 h 936"/>
                    <a:gd name="T76" fmla="*/ 2584 w 2651"/>
                    <a:gd name="T77" fmla="*/ 23 h 936"/>
                    <a:gd name="T78" fmla="*/ 2651 w 2651"/>
                    <a:gd name="T79" fmla="*/ 0 h 9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</a:cxnLst>
                  <a:rect l="0" t="0" r="r" b="b"/>
                  <a:pathLst>
                    <a:path w="2651" h="936">
                      <a:moveTo>
                        <a:pt x="0" y="936"/>
                      </a:moveTo>
                      <a:lnTo>
                        <a:pt x="33" y="924"/>
                      </a:lnTo>
                      <a:lnTo>
                        <a:pt x="67" y="912"/>
                      </a:lnTo>
                      <a:lnTo>
                        <a:pt x="100" y="900"/>
                      </a:lnTo>
                      <a:lnTo>
                        <a:pt x="134" y="888"/>
                      </a:lnTo>
                      <a:lnTo>
                        <a:pt x="168" y="876"/>
                      </a:lnTo>
                      <a:lnTo>
                        <a:pt x="201" y="865"/>
                      </a:lnTo>
                      <a:lnTo>
                        <a:pt x="234" y="852"/>
                      </a:lnTo>
                      <a:lnTo>
                        <a:pt x="268" y="841"/>
                      </a:lnTo>
                      <a:lnTo>
                        <a:pt x="302" y="829"/>
                      </a:lnTo>
                      <a:lnTo>
                        <a:pt x="335" y="817"/>
                      </a:lnTo>
                      <a:lnTo>
                        <a:pt x="369" y="805"/>
                      </a:lnTo>
                      <a:lnTo>
                        <a:pt x="402" y="794"/>
                      </a:lnTo>
                      <a:lnTo>
                        <a:pt x="437" y="781"/>
                      </a:lnTo>
                      <a:lnTo>
                        <a:pt x="470" y="770"/>
                      </a:lnTo>
                      <a:lnTo>
                        <a:pt x="503" y="758"/>
                      </a:lnTo>
                      <a:lnTo>
                        <a:pt x="537" y="746"/>
                      </a:lnTo>
                      <a:lnTo>
                        <a:pt x="570" y="734"/>
                      </a:lnTo>
                      <a:lnTo>
                        <a:pt x="603" y="722"/>
                      </a:lnTo>
                      <a:lnTo>
                        <a:pt x="638" y="710"/>
                      </a:lnTo>
                      <a:lnTo>
                        <a:pt x="671" y="699"/>
                      </a:lnTo>
                      <a:lnTo>
                        <a:pt x="704" y="686"/>
                      </a:lnTo>
                      <a:lnTo>
                        <a:pt x="738" y="675"/>
                      </a:lnTo>
                      <a:lnTo>
                        <a:pt x="772" y="663"/>
                      </a:lnTo>
                      <a:lnTo>
                        <a:pt x="805" y="651"/>
                      </a:lnTo>
                      <a:lnTo>
                        <a:pt x="839" y="639"/>
                      </a:lnTo>
                      <a:lnTo>
                        <a:pt x="872" y="628"/>
                      </a:lnTo>
                      <a:lnTo>
                        <a:pt x="907" y="615"/>
                      </a:lnTo>
                      <a:lnTo>
                        <a:pt x="940" y="604"/>
                      </a:lnTo>
                      <a:lnTo>
                        <a:pt x="973" y="591"/>
                      </a:lnTo>
                      <a:lnTo>
                        <a:pt x="1007" y="580"/>
                      </a:lnTo>
                      <a:lnTo>
                        <a:pt x="1040" y="569"/>
                      </a:lnTo>
                      <a:lnTo>
                        <a:pt x="1073" y="556"/>
                      </a:lnTo>
                      <a:lnTo>
                        <a:pt x="1108" y="545"/>
                      </a:lnTo>
                      <a:lnTo>
                        <a:pt x="1141" y="533"/>
                      </a:lnTo>
                      <a:lnTo>
                        <a:pt x="1174" y="521"/>
                      </a:lnTo>
                      <a:lnTo>
                        <a:pt x="1208" y="509"/>
                      </a:lnTo>
                      <a:lnTo>
                        <a:pt x="1242" y="498"/>
                      </a:lnTo>
                      <a:lnTo>
                        <a:pt x="1275" y="485"/>
                      </a:lnTo>
                      <a:lnTo>
                        <a:pt x="1309" y="474"/>
                      </a:lnTo>
                      <a:lnTo>
                        <a:pt x="1342" y="462"/>
                      </a:lnTo>
                      <a:lnTo>
                        <a:pt x="1376" y="450"/>
                      </a:lnTo>
                      <a:lnTo>
                        <a:pt x="1410" y="438"/>
                      </a:lnTo>
                      <a:lnTo>
                        <a:pt x="1443" y="426"/>
                      </a:lnTo>
                      <a:lnTo>
                        <a:pt x="1477" y="414"/>
                      </a:lnTo>
                      <a:lnTo>
                        <a:pt x="1510" y="403"/>
                      </a:lnTo>
                      <a:lnTo>
                        <a:pt x="1543" y="390"/>
                      </a:lnTo>
                      <a:lnTo>
                        <a:pt x="1578" y="379"/>
                      </a:lnTo>
                      <a:lnTo>
                        <a:pt x="1611" y="367"/>
                      </a:lnTo>
                      <a:lnTo>
                        <a:pt x="1644" y="355"/>
                      </a:lnTo>
                      <a:lnTo>
                        <a:pt x="1678" y="343"/>
                      </a:lnTo>
                      <a:lnTo>
                        <a:pt x="1712" y="332"/>
                      </a:lnTo>
                      <a:lnTo>
                        <a:pt x="1746" y="319"/>
                      </a:lnTo>
                      <a:lnTo>
                        <a:pt x="1779" y="308"/>
                      </a:lnTo>
                      <a:lnTo>
                        <a:pt x="1812" y="295"/>
                      </a:lnTo>
                      <a:lnTo>
                        <a:pt x="1846" y="284"/>
                      </a:lnTo>
                      <a:lnTo>
                        <a:pt x="1880" y="272"/>
                      </a:lnTo>
                      <a:lnTo>
                        <a:pt x="1913" y="260"/>
                      </a:lnTo>
                      <a:lnTo>
                        <a:pt x="1947" y="248"/>
                      </a:lnTo>
                      <a:lnTo>
                        <a:pt x="1980" y="237"/>
                      </a:lnTo>
                      <a:lnTo>
                        <a:pt x="2013" y="224"/>
                      </a:lnTo>
                      <a:lnTo>
                        <a:pt x="2048" y="213"/>
                      </a:lnTo>
                      <a:lnTo>
                        <a:pt x="2081" y="202"/>
                      </a:lnTo>
                      <a:lnTo>
                        <a:pt x="2114" y="189"/>
                      </a:lnTo>
                      <a:lnTo>
                        <a:pt x="2148" y="178"/>
                      </a:lnTo>
                      <a:lnTo>
                        <a:pt x="2181" y="166"/>
                      </a:lnTo>
                      <a:lnTo>
                        <a:pt x="2216" y="154"/>
                      </a:lnTo>
                      <a:lnTo>
                        <a:pt x="2249" y="142"/>
                      </a:lnTo>
                      <a:lnTo>
                        <a:pt x="2282" y="129"/>
                      </a:lnTo>
                      <a:lnTo>
                        <a:pt x="2316" y="118"/>
                      </a:lnTo>
                      <a:lnTo>
                        <a:pt x="2350" y="107"/>
                      </a:lnTo>
                      <a:lnTo>
                        <a:pt x="2383" y="94"/>
                      </a:lnTo>
                      <a:lnTo>
                        <a:pt x="2417" y="83"/>
                      </a:lnTo>
                      <a:lnTo>
                        <a:pt x="2450" y="71"/>
                      </a:lnTo>
                      <a:lnTo>
                        <a:pt x="2483" y="59"/>
                      </a:lnTo>
                      <a:lnTo>
                        <a:pt x="2518" y="47"/>
                      </a:lnTo>
                      <a:lnTo>
                        <a:pt x="2551" y="36"/>
                      </a:lnTo>
                      <a:lnTo>
                        <a:pt x="2584" y="23"/>
                      </a:lnTo>
                      <a:lnTo>
                        <a:pt x="2618" y="12"/>
                      </a:lnTo>
                      <a:lnTo>
                        <a:pt x="2651" y="0"/>
                      </a:lnTo>
                    </a:path>
                  </a:pathLst>
                </a:custGeom>
                <a:noFill/>
                <a:ln w="0" cap="flat">
                  <a:solidFill>
                    <a:srgbClr val="3366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22" name="Rectangle 127">
                  <a:extLst>
                    <a:ext uri="{FF2B5EF4-FFF2-40B4-BE49-F238E27FC236}">
                      <a16:creationId xmlns:a16="http://schemas.microsoft.com/office/drawing/2014/main" id="{765BB0D0-61E0-637D-4435-CA8FD874243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558246" y="2934739"/>
                  <a:ext cx="822607" cy="4620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1100" b="1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R</a:t>
                  </a:r>
                  <a:r>
                    <a:rPr kumimoji="0" lang="en-US" altLang="hu-HU" sz="1100" b="1" i="0" u="none" strike="noStrike" cap="none" normalizeH="0" baseline="3000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2</a:t>
                  </a:r>
                  <a:r>
                    <a:rPr kumimoji="0" lang="en-US" altLang="hu-HU" sz="11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=0.80</a:t>
                  </a:r>
                </a:p>
                <a:p>
                  <a:r>
                    <a:rPr lang="en-US" altLang="hu-HU" sz="1100" b="1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p&lt;0.02</a:t>
                  </a:r>
                  <a:endParaRPr kumimoji="0" lang="en-US" altLang="hu-HU" sz="11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" name="Line 128">
                  <a:extLst>
                    <a:ext uri="{FF2B5EF4-FFF2-40B4-BE49-F238E27FC236}">
                      <a16:creationId xmlns:a16="http://schemas.microsoft.com/office/drawing/2014/main" id="{EB262FCC-EBF4-D594-FDAC-BFAB2C4C5DE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6567487" y="2409277"/>
                  <a:ext cx="0" cy="2682875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24" name="Rectangle 129">
                  <a:extLst>
                    <a:ext uri="{FF2B5EF4-FFF2-40B4-BE49-F238E27FC236}">
                      <a16:creationId xmlns:a16="http://schemas.microsoft.com/office/drawing/2014/main" id="{2FF8D2B3-5E14-87A7-F27F-747048F77F4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325145" y="4659744"/>
                  <a:ext cx="185666" cy="1680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10</a:t>
                  </a:r>
                </a:p>
              </p:txBody>
            </p:sp>
            <p:sp>
              <p:nvSpPr>
                <p:cNvPr id="25" name="Rectangle 130">
                  <a:extLst>
                    <a:ext uri="{FF2B5EF4-FFF2-40B4-BE49-F238E27FC236}">
                      <a16:creationId xmlns:a16="http://schemas.microsoft.com/office/drawing/2014/main" id="{2F6BC42F-5AE3-1C92-CDC7-374693A1755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325145" y="4059669"/>
                  <a:ext cx="185666" cy="1680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20</a:t>
                  </a:r>
                </a:p>
              </p:txBody>
            </p:sp>
            <p:sp>
              <p:nvSpPr>
                <p:cNvPr id="26" name="Rectangle 131">
                  <a:extLst>
                    <a:ext uri="{FF2B5EF4-FFF2-40B4-BE49-F238E27FC236}">
                      <a16:creationId xmlns:a16="http://schemas.microsoft.com/office/drawing/2014/main" id="{FC742CD4-1E85-7F94-1367-70F2999A5E7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325145" y="3459594"/>
                  <a:ext cx="185666" cy="1680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30</a:t>
                  </a:r>
                </a:p>
              </p:txBody>
            </p:sp>
            <p:sp>
              <p:nvSpPr>
                <p:cNvPr id="27" name="Rectangle 132">
                  <a:extLst>
                    <a:ext uri="{FF2B5EF4-FFF2-40B4-BE49-F238E27FC236}">
                      <a16:creationId xmlns:a16="http://schemas.microsoft.com/office/drawing/2014/main" id="{FA9F5EF0-93BC-C543-DF3B-DF183D13925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325145" y="2861106"/>
                  <a:ext cx="185666" cy="1680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40</a:t>
                  </a:r>
                </a:p>
              </p:txBody>
            </p:sp>
            <p:sp>
              <p:nvSpPr>
                <p:cNvPr id="28" name="Line 133">
                  <a:extLst>
                    <a:ext uri="{FF2B5EF4-FFF2-40B4-BE49-F238E27FC236}">
                      <a16:creationId xmlns:a16="http://schemas.microsoft.com/office/drawing/2014/main" id="{D6CABC23-879A-36EE-AE74-F02FF663DC6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545262" y="4763539"/>
                  <a:ext cx="22225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29" name="Line 134">
                  <a:extLst>
                    <a:ext uri="{FF2B5EF4-FFF2-40B4-BE49-F238E27FC236}">
                      <a16:creationId xmlns:a16="http://schemas.microsoft.com/office/drawing/2014/main" id="{878F0383-3F29-3BD6-A629-87B4046F9CD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545262" y="4161877"/>
                  <a:ext cx="22225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0" name="Line 135">
                  <a:extLst>
                    <a:ext uri="{FF2B5EF4-FFF2-40B4-BE49-F238E27FC236}">
                      <a16:creationId xmlns:a16="http://schemas.microsoft.com/office/drawing/2014/main" id="{EE302933-7FB4-93FC-808E-52059547C2C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545262" y="3563389"/>
                  <a:ext cx="22225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1" name="Line 136">
                  <a:extLst>
                    <a:ext uri="{FF2B5EF4-FFF2-40B4-BE49-F238E27FC236}">
                      <a16:creationId xmlns:a16="http://schemas.microsoft.com/office/drawing/2014/main" id="{4C39C1FA-164D-5DA4-6807-57D1D33774D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545262" y="2963314"/>
                  <a:ext cx="22225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2" name="Line 137">
                  <a:extLst>
                    <a:ext uri="{FF2B5EF4-FFF2-40B4-BE49-F238E27FC236}">
                      <a16:creationId xmlns:a16="http://schemas.microsoft.com/office/drawing/2014/main" id="{B8D979DD-AA3F-22F8-4387-1F4445AF32C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567487" y="5092152"/>
                  <a:ext cx="4630737" cy="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3" name="Line 138">
                  <a:extLst>
                    <a:ext uri="{FF2B5EF4-FFF2-40B4-BE49-F238E27FC236}">
                      <a16:creationId xmlns:a16="http://schemas.microsoft.com/office/drawing/2014/main" id="{F40A5909-6ADA-55F0-5074-3CDA6D27B59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7202487" y="5092152"/>
                  <a:ext cx="0" cy="1905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4" name="Line 139">
                  <a:extLst>
                    <a:ext uri="{FF2B5EF4-FFF2-40B4-BE49-F238E27FC236}">
                      <a16:creationId xmlns:a16="http://schemas.microsoft.com/office/drawing/2014/main" id="{F646DAEB-172D-DC89-B5C5-894D9DE9865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8172450" y="5092152"/>
                  <a:ext cx="0" cy="1905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5" name="Line 140">
                  <a:extLst>
                    <a:ext uri="{FF2B5EF4-FFF2-40B4-BE49-F238E27FC236}">
                      <a16:creationId xmlns:a16="http://schemas.microsoft.com/office/drawing/2014/main" id="{0120408A-3334-7D61-B795-56AF0C54170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9142412" y="5092152"/>
                  <a:ext cx="0" cy="1905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6" name="Line 141">
                  <a:extLst>
                    <a:ext uri="{FF2B5EF4-FFF2-40B4-BE49-F238E27FC236}">
                      <a16:creationId xmlns:a16="http://schemas.microsoft.com/office/drawing/2014/main" id="{5505292B-3A64-9A53-2A2E-AA8BB28DDC4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10110787" y="5092152"/>
                  <a:ext cx="0" cy="1905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7" name="Line 142">
                  <a:extLst>
                    <a:ext uri="{FF2B5EF4-FFF2-40B4-BE49-F238E27FC236}">
                      <a16:creationId xmlns:a16="http://schemas.microsoft.com/office/drawing/2014/main" id="{8BE8F8AA-1702-96B3-72A3-5824D67E3A8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11079162" y="5092152"/>
                  <a:ext cx="0" cy="1905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8" name="Rectangle 143">
                  <a:extLst>
                    <a:ext uri="{FF2B5EF4-FFF2-40B4-BE49-F238E27FC236}">
                      <a16:creationId xmlns:a16="http://schemas.microsoft.com/office/drawing/2014/main" id="{07D9CC82-7B53-C0EF-F614-6A8A1FCC8B3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048070" y="5111202"/>
                  <a:ext cx="371333" cy="1680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2000</a:t>
                  </a:r>
                </a:p>
              </p:txBody>
            </p:sp>
            <p:sp>
              <p:nvSpPr>
                <p:cNvPr id="39" name="Rectangle 144">
                  <a:extLst>
                    <a:ext uri="{FF2B5EF4-FFF2-40B4-BE49-F238E27FC236}">
                      <a16:creationId xmlns:a16="http://schemas.microsoft.com/office/drawing/2014/main" id="{4DCD9DEB-D941-AD38-8E0F-545D1E9AFD4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016448" y="5111202"/>
                  <a:ext cx="371333" cy="1680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3000</a:t>
                  </a:r>
                </a:p>
              </p:txBody>
            </p:sp>
            <p:sp>
              <p:nvSpPr>
                <p:cNvPr id="40" name="Rectangle 145">
                  <a:extLst>
                    <a:ext uri="{FF2B5EF4-FFF2-40B4-BE49-F238E27FC236}">
                      <a16:creationId xmlns:a16="http://schemas.microsoft.com/office/drawing/2014/main" id="{884C4604-33BE-66DA-CAA7-18412211452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984830" y="5111202"/>
                  <a:ext cx="371333" cy="1680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n-US" altLang="hu-HU" sz="800" dirty="0">
                      <a:cs typeface="Arial" panose="020B0604020202020204" pitchFamily="34" charset="0"/>
                    </a:rPr>
                    <a:t>4</a:t>
                  </a: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000</a:t>
                  </a:r>
                </a:p>
              </p:txBody>
            </p:sp>
            <p:sp>
              <p:nvSpPr>
                <p:cNvPr id="41" name="Rectangle 146">
                  <a:extLst>
                    <a:ext uri="{FF2B5EF4-FFF2-40B4-BE49-F238E27FC236}">
                      <a16:creationId xmlns:a16="http://schemas.microsoft.com/office/drawing/2014/main" id="{25326FA6-2D69-9DAB-251F-515C8E2E2A6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954791" y="5111202"/>
                  <a:ext cx="371333" cy="1680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5000</a:t>
                  </a:r>
                </a:p>
              </p:txBody>
            </p:sp>
            <p:sp>
              <p:nvSpPr>
                <p:cNvPr id="42" name="Rectangle 147">
                  <a:extLst>
                    <a:ext uri="{FF2B5EF4-FFF2-40B4-BE49-F238E27FC236}">
                      <a16:creationId xmlns:a16="http://schemas.microsoft.com/office/drawing/2014/main" id="{CDAB3CFB-D4B7-985C-35EF-CEE40455718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924757" y="5111202"/>
                  <a:ext cx="371333" cy="1680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800" b="0" i="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6000</a:t>
                  </a:r>
                </a:p>
              </p:txBody>
            </p:sp>
            <p:sp>
              <p:nvSpPr>
                <p:cNvPr id="43" name="Rectangle 150">
                  <a:extLst>
                    <a:ext uri="{FF2B5EF4-FFF2-40B4-BE49-F238E27FC236}">
                      <a16:creationId xmlns:a16="http://schemas.microsoft.com/office/drawing/2014/main" id="{7B7A388B-C9BC-B136-C73F-172F223AF2C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565898" y="2115589"/>
                  <a:ext cx="4586278" cy="29402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hu-HU" sz="14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Survived</a:t>
                  </a:r>
                  <a:endParaRPr kumimoji="0" lang="en-US" altLang="hu-HU" sz="14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8" name="Szövegdoboz 7">
                <a:extLst>
                  <a:ext uri="{FF2B5EF4-FFF2-40B4-BE49-F238E27FC236}">
                    <a16:creationId xmlns:a16="http://schemas.microsoft.com/office/drawing/2014/main" id="{DCAA30B5-7B3E-2B02-70A9-DF22FA026C3F}"/>
                  </a:ext>
                </a:extLst>
              </p:cNvPr>
              <p:cNvSpPr txBox="1"/>
              <p:nvPr/>
            </p:nvSpPr>
            <p:spPr>
              <a:xfrm rot="16200000">
                <a:off x="-600101" y="3580194"/>
                <a:ext cx="2988742" cy="538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Intracellular perforin expression by NKdim cells (%)</a:t>
                </a:r>
              </a:p>
            </p:txBody>
          </p:sp>
          <p:sp>
            <p:nvSpPr>
              <p:cNvPr id="9" name="Szövegdoboz 8">
                <a:extLst>
                  <a:ext uri="{FF2B5EF4-FFF2-40B4-BE49-F238E27FC236}">
                    <a16:creationId xmlns:a16="http://schemas.microsoft.com/office/drawing/2014/main" id="{86E1253E-7280-4307-1EDA-D21750F4D369}"/>
                  </a:ext>
                </a:extLst>
              </p:cNvPr>
              <p:cNvSpPr txBox="1"/>
              <p:nvPr/>
            </p:nvSpPr>
            <p:spPr>
              <a:xfrm>
                <a:off x="1300898" y="5474224"/>
                <a:ext cx="3635912" cy="3570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oluble perforin level in serum (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g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/ml)</a:t>
                </a:r>
              </a:p>
            </p:txBody>
          </p:sp>
          <p:cxnSp>
            <p:nvCxnSpPr>
              <p:cNvPr id="10" name="Egyenes összekötő nyíllal 9">
                <a:extLst>
                  <a:ext uri="{FF2B5EF4-FFF2-40B4-BE49-F238E27FC236}">
                    <a16:creationId xmlns:a16="http://schemas.microsoft.com/office/drawing/2014/main" id="{31F15B02-F497-DB69-9683-D8401B0E615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375792" y="5678920"/>
                <a:ext cx="4036485" cy="2185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71430613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Csoportba foglalás 1">
            <a:extLst>
              <a:ext uri="{FF2B5EF4-FFF2-40B4-BE49-F238E27FC236}">
                <a16:creationId xmlns:a16="http://schemas.microsoft.com/office/drawing/2014/main" id="{0DE01CBB-6EDA-4A0C-8840-08E6603A43FB}"/>
              </a:ext>
            </a:extLst>
          </p:cNvPr>
          <p:cNvGrpSpPr/>
          <p:nvPr/>
        </p:nvGrpSpPr>
        <p:grpSpPr>
          <a:xfrm>
            <a:off x="-16935" y="66133"/>
            <a:ext cx="5440835" cy="4102969"/>
            <a:chOff x="-16935" y="66133"/>
            <a:chExt cx="5440835" cy="4102969"/>
          </a:xfrm>
        </p:grpSpPr>
        <p:sp>
          <p:nvSpPr>
            <p:cNvPr id="4" name="Szövegdoboz 3">
              <a:extLst>
                <a:ext uri="{FF2B5EF4-FFF2-40B4-BE49-F238E27FC236}">
                  <a16:creationId xmlns:a16="http://schemas.microsoft.com/office/drawing/2014/main" id="{249DC5A7-E8C6-00CC-A9A8-2C0B1FCBF163}"/>
                </a:ext>
              </a:extLst>
            </p:cNvPr>
            <p:cNvSpPr txBox="1"/>
            <p:nvPr/>
          </p:nvSpPr>
          <p:spPr>
            <a:xfrm>
              <a:off x="-16935" y="66133"/>
              <a:ext cx="331167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6.</a:t>
              </a:r>
            </a:p>
          </p:txBody>
        </p:sp>
        <p:grpSp>
          <p:nvGrpSpPr>
            <p:cNvPr id="5" name="Csoportba foglalás 4">
              <a:extLst>
                <a:ext uri="{FF2B5EF4-FFF2-40B4-BE49-F238E27FC236}">
                  <a16:creationId xmlns:a16="http://schemas.microsoft.com/office/drawing/2014/main" id="{44B266AA-0B6D-DA1C-2D28-BA664EA07C6C}"/>
                </a:ext>
              </a:extLst>
            </p:cNvPr>
            <p:cNvGrpSpPr/>
            <p:nvPr/>
          </p:nvGrpSpPr>
          <p:grpSpPr>
            <a:xfrm>
              <a:off x="583234" y="861881"/>
              <a:ext cx="3258799" cy="3307221"/>
              <a:chOff x="7987051" y="33829"/>
              <a:chExt cx="3258799" cy="3307221"/>
            </a:xfrm>
          </p:grpSpPr>
          <p:sp>
            <p:nvSpPr>
              <p:cNvPr id="6" name="Oval 369">
                <a:extLst>
                  <a:ext uri="{FF2B5EF4-FFF2-40B4-BE49-F238E27FC236}">
                    <a16:creationId xmlns:a16="http://schemas.microsoft.com/office/drawing/2014/main" id="{8960D913-F5E1-3218-85F6-C6BF0BE178D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37588" y="2765426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7" name="Oval 370">
                <a:extLst>
                  <a:ext uri="{FF2B5EF4-FFF2-40B4-BE49-F238E27FC236}">
                    <a16:creationId xmlns:a16="http://schemas.microsoft.com/office/drawing/2014/main" id="{DDD67DDF-0E77-775F-7FA8-DC7C0FF38F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37588" y="1039813"/>
                <a:ext cx="26988" cy="28575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8" name="Oval 371">
                <a:extLst>
                  <a:ext uri="{FF2B5EF4-FFF2-40B4-BE49-F238E27FC236}">
                    <a16:creationId xmlns:a16="http://schemas.microsoft.com/office/drawing/2014/main" id="{DE67B4F9-7A86-D0E5-516C-323C63A9110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701088" y="1344613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9" name="Oval 372">
                <a:extLst>
                  <a:ext uri="{FF2B5EF4-FFF2-40B4-BE49-F238E27FC236}">
                    <a16:creationId xmlns:a16="http://schemas.microsoft.com/office/drawing/2014/main" id="{8736FC46-4221-443D-6E09-F814537653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37588" y="935038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0" name="Oval 373">
                <a:extLst>
                  <a:ext uri="{FF2B5EF4-FFF2-40B4-BE49-F238E27FC236}">
                    <a16:creationId xmlns:a16="http://schemas.microsoft.com/office/drawing/2014/main" id="{399F9498-58AC-5313-662A-FA0E73D9AC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701088" y="1693863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1" name="Oval 374">
                <a:extLst>
                  <a:ext uri="{FF2B5EF4-FFF2-40B4-BE49-F238E27FC236}">
                    <a16:creationId xmlns:a16="http://schemas.microsoft.com/office/drawing/2014/main" id="{E9A9187F-4961-3E6D-96FF-0F177481FDF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37588" y="2401888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2" name="Oval 375">
                <a:extLst>
                  <a:ext uri="{FF2B5EF4-FFF2-40B4-BE49-F238E27FC236}">
                    <a16:creationId xmlns:a16="http://schemas.microsoft.com/office/drawing/2014/main" id="{398312CB-BB7C-B5E0-8A4B-09EF74B67A3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37588" y="1912938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3" name="Oval 376">
                <a:extLst>
                  <a:ext uri="{FF2B5EF4-FFF2-40B4-BE49-F238E27FC236}">
                    <a16:creationId xmlns:a16="http://schemas.microsoft.com/office/drawing/2014/main" id="{9A65D007-B78D-05D3-9401-A5A17D492FB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701088" y="2660651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4" name="Oval 377">
                <a:extLst>
                  <a:ext uri="{FF2B5EF4-FFF2-40B4-BE49-F238E27FC236}">
                    <a16:creationId xmlns:a16="http://schemas.microsoft.com/office/drawing/2014/main" id="{FA5307F7-D143-3101-6305-8A82F2FEF8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37588" y="2100263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5" name="Oval 378">
                <a:extLst>
                  <a:ext uri="{FF2B5EF4-FFF2-40B4-BE49-F238E27FC236}">
                    <a16:creationId xmlns:a16="http://schemas.microsoft.com/office/drawing/2014/main" id="{5936AF6F-A707-75C3-BE45-DEB593F36B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12175" y="2392363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6" name="Oval 379">
                <a:extLst>
                  <a:ext uri="{FF2B5EF4-FFF2-40B4-BE49-F238E27FC236}">
                    <a16:creationId xmlns:a16="http://schemas.microsoft.com/office/drawing/2014/main" id="{A7892FD4-0933-D926-3ADC-BDB45107AC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75675" y="1295401"/>
                <a:ext cx="26988" cy="28575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7" name="Oval 380">
                <a:extLst>
                  <a:ext uri="{FF2B5EF4-FFF2-40B4-BE49-F238E27FC236}">
                    <a16:creationId xmlns:a16="http://schemas.microsoft.com/office/drawing/2014/main" id="{310EBFF8-41E5-1DD2-DB60-A31861CB5D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764588" y="2300288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8" name="Oval 381">
                <a:extLst>
                  <a:ext uri="{FF2B5EF4-FFF2-40B4-BE49-F238E27FC236}">
                    <a16:creationId xmlns:a16="http://schemas.microsoft.com/office/drawing/2014/main" id="{154C680A-A382-8921-799D-5F735CF1A5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75675" y="2544763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19" name="Oval 382">
                <a:extLst>
                  <a:ext uri="{FF2B5EF4-FFF2-40B4-BE49-F238E27FC236}">
                    <a16:creationId xmlns:a16="http://schemas.microsoft.com/office/drawing/2014/main" id="{0028F439-CD5B-8072-7C7B-EFED4EBA4DC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75675" y="1679576"/>
                <a:ext cx="26988" cy="28575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0" name="Freeform 383">
                <a:extLst>
                  <a:ext uri="{FF2B5EF4-FFF2-40B4-BE49-F238E27FC236}">
                    <a16:creationId xmlns:a16="http://schemas.microsoft.com/office/drawing/2014/main" id="{5BF5DD82-CB25-7B82-C510-FA96262A73A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462963" y="1358901"/>
                <a:ext cx="377825" cy="1057275"/>
              </a:xfrm>
              <a:custGeom>
                <a:avLst/>
                <a:gdLst>
                  <a:gd name="T0" fmla="*/ 0 w 238"/>
                  <a:gd name="T1" fmla="*/ 666 h 666"/>
                  <a:gd name="T2" fmla="*/ 238 w 238"/>
                  <a:gd name="T3" fmla="*/ 666 h 666"/>
                  <a:gd name="T4" fmla="*/ 238 w 238"/>
                  <a:gd name="T5" fmla="*/ 666 h 666"/>
                  <a:gd name="T6" fmla="*/ 238 w 238"/>
                  <a:gd name="T7" fmla="*/ 417 h 666"/>
                  <a:gd name="T8" fmla="*/ 238 w 238"/>
                  <a:gd name="T9" fmla="*/ 0 h 666"/>
                  <a:gd name="T10" fmla="*/ 238 w 238"/>
                  <a:gd name="T11" fmla="*/ 0 h 666"/>
                  <a:gd name="T12" fmla="*/ 0 w 238"/>
                  <a:gd name="T13" fmla="*/ 0 h 666"/>
                  <a:gd name="T14" fmla="*/ 0 w 238"/>
                  <a:gd name="T15" fmla="*/ 0 h 666"/>
                  <a:gd name="T16" fmla="*/ 0 w 238"/>
                  <a:gd name="T17" fmla="*/ 417 h 666"/>
                  <a:gd name="T18" fmla="*/ 0 w 238"/>
                  <a:gd name="T19" fmla="*/ 666 h 6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238" h="666">
                    <a:moveTo>
                      <a:pt x="0" y="666"/>
                    </a:moveTo>
                    <a:lnTo>
                      <a:pt x="238" y="666"/>
                    </a:lnTo>
                    <a:lnTo>
                      <a:pt x="238" y="666"/>
                    </a:lnTo>
                    <a:lnTo>
                      <a:pt x="238" y="417"/>
                    </a:lnTo>
                    <a:lnTo>
                      <a:pt x="238" y="0"/>
                    </a:lnTo>
                    <a:lnTo>
                      <a:pt x="238" y="0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0" y="417"/>
                    </a:lnTo>
                    <a:lnTo>
                      <a:pt x="0" y="666"/>
                    </a:lnTo>
                  </a:path>
                </a:pathLst>
              </a:cu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1" name="Line 384">
                <a:extLst>
                  <a:ext uri="{FF2B5EF4-FFF2-40B4-BE49-F238E27FC236}">
                    <a16:creationId xmlns:a16="http://schemas.microsoft.com/office/drawing/2014/main" id="{5F84C39C-9028-75D8-6850-60485C7F8D7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462963" y="2416176"/>
                <a:ext cx="0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2" name="Line 385">
                <a:extLst>
                  <a:ext uri="{FF2B5EF4-FFF2-40B4-BE49-F238E27FC236}">
                    <a16:creationId xmlns:a16="http://schemas.microsoft.com/office/drawing/2014/main" id="{C7A602EA-5706-01C3-705E-6356672F0E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8462963" y="2020888"/>
                <a:ext cx="377825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3" name="Line 386">
                <a:extLst>
                  <a:ext uri="{FF2B5EF4-FFF2-40B4-BE49-F238E27FC236}">
                    <a16:creationId xmlns:a16="http://schemas.microsoft.com/office/drawing/2014/main" id="{56F1B369-DBF2-384B-84E7-7DD9A0ED161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651875" y="1358901"/>
                <a:ext cx="0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4" name="Line 387">
                <a:extLst>
                  <a:ext uri="{FF2B5EF4-FFF2-40B4-BE49-F238E27FC236}">
                    <a16:creationId xmlns:a16="http://schemas.microsoft.com/office/drawing/2014/main" id="{51285E30-8694-6484-D05B-0F485ACEF93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651875" y="2416176"/>
                <a:ext cx="0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5" name="Line 388">
                <a:extLst>
                  <a:ext uri="{FF2B5EF4-FFF2-40B4-BE49-F238E27FC236}">
                    <a16:creationId xmlns:a16="http://schemas.microsoft.com/office/drawing/2014/main" id="{65452518-3D3A-D731-5DDC-827225500DC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651875" y="947738"/>
                <a:ext cx="0" cy="411163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6" name="Line 389">
                <a:extLst>
                  <a:ext uri="{FF2B5EF4-FFF2-40B4-BE49-F238E27FC236}">
                    <a16:creationId xmlns:a16="http://schemas.microsoft.com/office/drawing/2014/main" id="{E54B1CFB-A259-51A3-568C-6BA2B045A8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651875" y="2416176"/>
                <a:ext cx="0" cy="363538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7" name="Line 390">
                <a:extLst>
                  <a:ext uri="{FF2B5EF4-FFF2-40B4-BE49-F238E27FC236}">
                    <a16:creationId xmlns:a16="http://schemas.microsoft.com/office/drawing/2014/main" id="{EC7CD6D6-0FD8-3721-3CB9-BCABBC4C1D9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8628063" y="947738"/>
                <a:ext cx="47625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8" name="Line 391">
                <a:extLst>
                  <a:ext uri="{FF2B5EF4-FFF2-40B4-BE49-F238E27FC236}">
                    <a16:creationId xmlns:a16="http://schemas.microsoft.com/office/drawing/2014/main" id="{AF34F2BB-05FF-A459-A889-11A6E398AE9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8628063" y="2779713"/>
                <a:ext cx="47625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9" name="Rectangle 392">
                <a:extLst>
                  <a:ext uri="{FF2B5EF4-FFF2-40B4-BE49-F238E27FC236}">
                    <a16:creationId xmlns:a16="http://schemas.microsoft.com/office/drawing/2014/main" id="{892E147D-6211-5686-A8C4-3C99D5AB309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39175" y="1935163"/>
                <a:ext cx="23813" cy="23813"/>
              </a:xfrm>
              <a:prstGeom prst="rect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30" name="Oval 394">
                <a:extLst>
                  <a:ext uri="{FF2B5EF4-FFF2-40B4-BE49-F238E27FC236}">
                    <a16:creationId xmlns:a16="http://schemas.microsoft.com/office/drawing/2014/main" id="{A4C564DA-3223-1AF9-2573-B8331AA9BE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061460" y="2135188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31" name="Oval 396">
                <a:extLst>
                  <a:ext uri="{FF2B5EF4-FFF2-40B4-BE49-F238E27FC236}">
                    <a16:creationId xmlns:a16="http://schemas.microsoft.com/office/drawing/2014/main" id="{BF2452AA-735D-2EA8-3F8B-8DC80A47C8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015423" y="1420813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32" name="Oval 397">
                <a:extLst>
                  <a:ext uri="{FF2B5EF4-FFF2-40B4-BE49-F238E27FC236}">
                    <a16:creationId xmlns:a16="http://schemas.microsoft.com/office/drawing/2014/main" id="{2153C96C-A0E2-6447-7FFF-A83EEE575E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967798" y="2276476"/>
                <a:ext cx="26988" cy="28575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33" name="Oval 406">
                <a:extLst>
                  <a:ext uri="{FF2B5EF4-FFF2-40B4-BE49-F238E27FC236}">
                    <a16:creationId xmlns:a16="http://schemas.microsoft.com/office/drawing/2014/main" id="{5E611F9F-DABC-1343-3D0E-C021C5F9FB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967798" y="2206626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34" name="Freeform 407">
                <a:extLst>
                  <a:ext uri="{FF2B5EF4-FFF2-40B4-BE49-F238E27FC236}">
                    <a16:creationId xmlns:a16="http://schemas.microsoft.com/office/drawing/2014/main" id="{D212F9B9-5FAB-405D-0456-F714C1036EA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839210" y="2290763"/>
                <a:ext cx="377825" cy="374650"/>
              </a:xfrm>
              <a:custGeom>
                <a:avLst/>
                <a:gdLst>
                  <a:gd name="T0" fmla="*/ 0 w 238"/>
                  <a:gd name="T1" fmla="*/ 236 h 236"/>
                  <a:gd name="T2" fmla="*/ 238 w 238"/>
                  <a:gd name="T3" fmla="*/ 236 h 236"/>
                  <a:gd name="T4" fmla="*/ 238 w 238"/>
                  <a:gd name="T5" fmla="*/ 236 h 236"/>
                  <a:gd name="T6" fmla="*/ 238 w 238"/>
                  <a:gd name="T7" fmla="*/ 127 h 236"/>
                  <a:gd name="T8" fmla="*/ 238 w 238"/>
                  <a:gd name="T9" fmla="*/ 0 h 236"/>
                  <a:gd name="T10" fmla="*/ 238 w 238"/>
                  <a:gd name="T11" fmla="*/ 0 h 236"/>
                  <a:gd name="T12" fmla="*/ 0 w 238"/>
                  <a:gd name="T13" fmla="*/ 0 h 236"/>
                  <a:gd name="T14" fmla="*/ 0 w 238"/>
                  <a:gd name="T15" fmla="*/ 0 h 236"/>
                  <a:gd name="T16" fmla="*/ 0 w 238"/>
                  <a:gd name="T17" fmla="*/ 127 h 236"/>
                  <a:gd name="T18" fmla="*/ 0 w 238"/>
                  <a:gd name="T19" fmla="*/ 236 h 2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238" h="236">
                    <a:moveTo>
                      <a:pt x="0" y="236"/>
                    </a:moveTo>
                    <a:lnTo>
                      <a:pt x="238" y="236"/>
                    </a:lnTo>
                    <a:lnTo>
                      <a:pt x="238" y="236"/>
                    </a:lnTo>
                    <a:lnTo>
                      <a:pt x="238" y="127"/>
                    </a:lnTo>
                    <a:lnTo>
                      <a:pt x="238" y="0"/>
                    </a:lnTo>
                    <a:lnTo>
                      <a:pt x="238" y="0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0" y="127"/>
                    </a:lnTo>
                    <a:lnTo>
                      <a:pt x="0" y="236"/>
                    </a:lnTo>
                  </a:path>
                </a:pathLst>
              </a:custGeom>
              <a:pattFill prst="pct25">
                <a:fgClr>
                  <a:schemeClr val="tx1"/>
                </a:fgClr>
                <a:bgClr>
                  <a:schemeClr val="bg1"/>
                </a:bgClr>
              </a:pattFill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35" name="Line 412">
                <a:extLst>
                  <a:ext uri="{FF2B5EF4-FFF2-40B4-BE49-F238E27FC236}">
                    <a16:creationId xmlns:a16="http://schemas.microsoft.com/office/drawing/2014/main" id="{214D36CB-DE99-D591-CEDE-7EFD07BE9E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9028123" y="2149476"/>
                <a:ext cx="0" cy="141288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36" name="Line 414">
                <a:extLst>
                  <a:ext uri="{FF2B5EF4-FFF2-40B4-BE49-F238E27FC236}">
                    <a16:creationId xmlns:a16="http://schemas.microsoft.com/office/drawing/2014/main" id="{2027A978-5468-E09D-5F20-3412140D089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9004310" y="2149476"/>
                <a:ext cx="47625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37" name="Rectangle 527">
                <a:extLst>
                  <a:ext uri="{FF2B5EF4-FFF2-40B4-BE49-F238E27FC236}">
                    <a16:creationId xmlns:a16="http://schemas.microsoft.com/office/drawing/2014/main" id="{B296453F-BB88-7593-4D9B-5FECC7695D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294688" y="2844801"/>
                <a:ext cx="5770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hu-HU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en-US" altLang="hu-HU" sz="2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8" name="Rectangle 528">
                <a:extLst>
                  <a:ext uri="{FF2B5EF4-FFF2-40B4-BE49-F238E27FC236}">
                    <a16:creationId xmlns:a16="http://schemas.microsoft.com/office/drawing/2014/main" id="{E8447C24-9C28-21CB-88E2-80DF994E5A7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243888" y="2428876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hu-HU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</a:t>
                </a:r>
                <a:endParaRPr kumimoji="0" lang="en-US" altLang="hu-HU" sz="2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9" name="Rectangle 529">
                <a:extLst>
                  <a:ext uri="{FF2B5EF4-FFF2-40B4-BE49-F238E27FC236}">
                    <a16:creationId xmlns:a16="http://schemas.microsoft.com/office/drawing/2014/main" id="{DAFA5F2B-A3BA-6515-6CC3-ACDB9A92C8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243888" y="2014538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hu-HU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0</a:t>
                </a:r>
                <a:endParaRPr kumimoji="0" lang="en-US" altLang="hu-HU" sz="2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0" name="Rectangle 530">
                <a:extLst>
                  <a:ext uri="{FF2B5EF4-FFF2-40B4-BE49-F238E27FC236}">
                    <a16:creationId xmlns:a16="http://schemas.microsoft.com/office/drawing/2014/main" id="{50AB57A6-AD89-4A5A-0BF4-70909EC69C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243888" y="1598613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hu-HU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0</a:t>
                </a:r>
                <a:endParaRPr kumimoji="0" lang="en-US" altLang="hu-HU" sz="2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1" name="Rectangle 531">
                <a:extLst>
                  <a:ext uri="{FF2B5EF4-FFF2-40B4-BE49-F238E27FC236}">
                    <a16:creationId xmlns:a16="http://schemas.microsoft.com/office/drawing/2014/main" id="{0696C004-5A21-4A9A-FB4C-49D83C574D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243888" y="1182688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hu-HU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0</a:t>
                </a:r>
                <a:endParaRPr kumimoji="0" lang="en-US" altLang="hu-HU" sz="2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2" name="Rectangle 532">
                <a:extLst>
                  <a:ext uri="{FF2B5EF4-FFF2-40B4-BE49-F238E27FC236}">
                    <a16:creationId xmlns:a16="http://schemas.microsoft.com/office/drawing/2014/main" id="{F142943D-C0A0-ADE5-49BB-F4E723988F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93088" y="766763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hu-HU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0</a:t>
                </a:r>
                <a:endParaRPr kumimoji="0" lang="en-US" altLang="hu-HU" sz="2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3" name="Line 533">
                <a:extLst>
                  <a:ext uri="{FF2B5EF4-FFF2-40B4-BE49-F238E27FC236}">
                    <a16:creationId xmlns:a16="http://schemas.microsoft.com/office/drawing/2014/main" id="{5A87F7EE-EE9E-0FEB-4E29-C6530A228E8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651875" y="2905126"/>
                <a:ext cx="0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44" name="Line 534">
                <a:extLst>
                  <a:ext uri="{FF2B5EF4-FFF2-40B4-BE49-F238E27FC236}">
                    <a16:creationId xmlns:a16="http://schemas.microsoft.com/office/drawing/2014/main" id="{CDFBB483-9A52-B6B1-885F-4EF55C1E703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028123" y="2905126"/>
                <a:ext cx="0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45" name="Line 539">
                <a:extLst>
                  <a:ext uri="{FF2B5EF4-FFF2-40B4-BE49-F238E27FC236}">
                    <a16:creationId xmlns:a16="http://schemas.microsoft.com/office/drawing/2014/main" id="{9E414190-7311-C507-CBB1-22D89EA7F1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416925" y="2905126"/>
                <a:ext cx="2828925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46" name="Line 540">
                <a:extLst>
                  <a:ext uri="{FF2B5EF4-FFF2-40B4-BE49-F238E27FC236}">
                    <a16:creationId xmlns:a16="http://schemas.microsoft.com/office/drawing/2014/main" id="{609FA444-776B-502A-41BC-AF79367063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374063" y="2905126"/>
                <a:ext cx="42863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47" name="Line 542">
                <a:extLst>
                  <a:ext uri="{FF2B5EF4-FFF2-40B4-BE49-F238E27FC236}">
                    <a16:creationId xmlns:a16="http://schemas.microsoft.com/office/drawing/2014/main" id="{EB67E298-E025-E0E4-F130-9FB3937966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374063" y="2489201"/>
                <a:ext cx="42863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48" name="Line 544">
                <a:extLst>
                  <a:ext uri="{FF2B5EF4-FFF2-40B4-BE49-F238E27FC236}">
                    <a16:creationId xmlns:a16="http://schemas.microsoft.com/office/drawing/2014/main" id="{10BD5D34-4319-DAAC-DE35-535FCBCBC8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374063" y="2073276"/>
                <a:ext cx="42863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49" name="Line 546">
                <a:extLst>
                  <a:ext uri="{FF2B5EF4-FFF2-40B4-BE49-F238E27FC236}">
                    <a16:creationId xmlns:a16="http://schemas.microsoft.com/office/drawing/2014/main" id="{D6113E21-66F7-CAE6-EB52-66010DB2532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374063" y="1658938"/>
                <a:ext cx="42863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50" name="Line 548">
                <a:extLst>
                  <a:ext uri="{FF2B5EF4-FFF2-40B4-BE49-F238E27FC236}">
                    <a16:creationId xmlns:a16="http://schemas.microsoft.com/office/drawing/2014/main" id="{AF7651A8-BDA6-6F4E-C820-EB632A5B80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374063" y="1243013"/>
                <a:ext cx="42863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51" name="Line 550">
                <a:extLst>
                  <a:ext uri="{FF2B5EF4-FFF2-40B4-BE49-F238E27FC236}">
                    <a16:creationId xmlns:a16="http://schemas.microsoft.com/office/drawing/2014/main" id="{0DB81558-A060-7F92-85C9-A4F116C547E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374063" y="827088"/>
                <a:ext cx="42863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52" name="Line 551">
                <a:extLst>
                  <a:ext uri="{FF2B5EF4-FFF2-40B4-BE49-F238E27FC236}">
                    <a16:creationId xmlns:a16="http://schemas.microsoft.com/office/drawing/2014/main" id="{A96D63A1-2287-82DB-29FA-D760012E414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416925" y="827088"/>
                <a:ext cx="0" cy="2078038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53" name="Rectangle 552">
                <a:extLst>
                  <a:ext uri="{FF2B5EF4-FFF2-40B4-BE49-F238E27FC236}">
                    <a16:creationId xmlns:a16="http://schemas.microsoft.com/office/drawing/2014/main" id="{971DE19B-D3EE-3F21-82CB-73F7C6CD573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6985655" y="1768902"/>
                <a:ext cx="2172069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hu-HU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D69</a:t>
                </a:r>
                <a:r>
                  <a:rPr kumimoji="0" lang="en-US" altLang="hu-HU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expression by </a:t>
                </a:r>
                <a:r>
                  <a:rPr kumimoji="0" lang="en-US" altLang="hu-HU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NKT</a:t>
                </a:r>
                <a:r>
                  <a:rPr kumimoji="0" lang="en-US" altLang="hu-HU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cells (%)</a:t>
                </a:r>
                <a:endParaRPr kumimoji="0" lang="en-US" altLang="hu-HU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4" name="Oval 393">
                <a:extLst>
                  <a:ext uri="{FF2B5EF4-FFF2-40B4-BE49-F238E27FC236}">
                    <a16:creationId xmlns:a16="http://schemas.microsoft.com/office/drawing/2014/main" id="{02CFC9C1-1AD6-5AD1-5BDD-701F22ACF76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015423" y="2767013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55" name="Oval 395">
                <a:extLst>
                  <a:ext uri="{FF2B5EF4-FFF2-40B4-BE49-F238E27FC236}">
                    <a16:creationId xmlns:a16="http://schemas.microsoft.com/office/drawing/2014/main" id="{FBE58472-D97A-08AF-0CAC-1C6714B8D1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061460" y="2417763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56" name="Oval 398">
                <a:extLst>
                  <a:ext uri="{FF2B5EF4-FFF2-40B4-BE49-F238E27FC236}">
                    <a16:creationId xmlns:a16="http://schemas.microsoft.com/office/drawing/2014/main" id="{C5576641-8B67-51CE-9992-C89F4D7AD85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061460" y="2652713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57" name="Oval 399">
                <a:extLst>
                  <a:ext uri="{FF2B5EF4-FFF2-40B4-BE49-F238E27FC236}">
                    <a16:creationId xmlns:a16="http://schemas.microsoft.com/office/drawing/2014/main" id="{B6935456-580E-BAEF-E7E3-EC75D186F1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967798" y="2486026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58" name="Oval 400">
                <a:extLst>
                  <a:ext uri="{FF2B5EF4-FFF2-40B4-BE49-F238E27FC236}">
                    <a16:creationId xmlns:a16="http://schemas.microsoft.com/office/drawing/2014/main" id="{FB3A12E3-AEE2-7B21-B638-3D46F328E40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920173" y="2735263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59" name="Oval 401">
                <a:extLst>
                  <a:ext uri="{FF2B5EF4-FFF2-40B4-BE49-F238E27FC236}">
                    <a16:creationId xmlns:a16="http://schemas.microsoft.com/office/drawing/2014/main" id="{F3C501AC-5943-9686-5E4E-E16EF738B5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156710" y="2605088"/>
                <a:ext cx="26988" cy="28575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60" name="Oval 402">
                <a:extLst>
                  <a:ext uri="{FF2B5EF4-FFF2-40B4-BE49-F238E27FC236}">
                    <a16:creationId xmlns:a16="http://schemas.microsoft.com/office/drawing/2014/main" id="{53E3941F-D4C4-1363-DA8D-BDC7A64566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109085" y="2751138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61" name="Oval 403">
                <a:extLst>
                  <a:ext uri="{FF2B5EF4-FFF2-40B4-BE49-F238E27FC236}">
                    <a16:creationId xmlns:a16="http://schemas.microsoft.com/office/drawing/2014/main" id="{7F1C3E09-CBEA-3AFB-8658-12AB4C6B34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156710" y="2428876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62" name="Oval 404">
                <a:extLst>
                  <a:ext uri="{FF2B5EF4-FFF2-40B4-BE49-F238E27FC236}">
                    <a16:creationId xmlns:a16="http://schemas.microsoft.com/office/drawing/2014/main" id="{8F8492AE-32F5-F053-4036-2A1E795015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872548" y="2471738"/>
                <a:ext cx="26988" cy="28575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63" name="Oval 405">
                <a:extLst>
                  <a:ext uri="{FF2B5EF4-FFF2-40B4-BE49-F238E27FC236}">
                    <a16:creationId xmlns:a16="http://schemas.microsoft.com/office/drawing/2014/main" id="{D07BF8CF-E949-B036-95A4-A030B06A43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872548" y="2527301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64" name="Line 408">
                <a:extLst>
                  <a:ext uri="{FF2B5EF4-FFF2-40B4-BE49-F238E27FC236}">
                    <a16:creationId xmlns:a16="http://schemas.microsoft.com/office/drawing/2014/main" id="{401FA660-BD68-D0BF-7C36-0D3B145CD0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839210" y="2665413"/>
                <a:ext cx="0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65" name="Line 409">
                <a:extLst>
                  <a:ext uri="{FF2B5EF4-FFF2-40B4-BE49-F238E27FC236}">
                    <a16:creationId xmlns:a16="http://schemas.microsoft.com/office/drawing/2014/main" id="{8583D427-1020-BAF9-5393-CE27C76C81C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8839210" y="2492376"/>
                <a:ext cx="377825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66" name="Line 410">
                <a:extLst>
                  <a:ext uri="{FF2B5EF4-FFF2-40B4-BE49-F238E27FC236}">
                    <a16:creationId xmlns:a16="http://schemas.microsoft.com/office/drawing/2014/main" id="{15AEDDD8-B67F-C851-0DF6-2094044418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028123" y="2290763"/>
                <a:ext cx="0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67" name="Line 411">
                <a:extLst>
                  <a:ext uri="{FF2B5EF4-FFF2-40B4-BE49-F238E27FC236}">
                    <a16:creationId xmlns:a16="http://schemas.microsoft.com/office/drawing/2014/main" id="{B7C69C76-ECEC-DBAB-916B-2B23DDC04C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028123" y="2665413"/>
                <a:ext cx="0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68" name="Line 413">
                <a:extLst>
                  <a:ext uri="{FF2B5EF4-FFF2-40B4-BE49-F238E27FC236}">
                    <a16:creationId xmlns:a16="http://schemas.microsoft.com/office/drawing/2014/main" id="{BFA9F39B-141C-6788-7589-DD4FEDA368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028123" y="2665413"/>
                <a:ext cx="0" cy="115888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69" name="Line 415">
                <a:extLst>
                  <a:ext uri="{FF2B5EF4-FFF2-40B4-BE49-F238E27FC236}">
                    <a16:creationId xmlns:a16="http://schemas.microsoft.com/office/drawing/2014/main" id="{7598B4CE-39A8-87E1-A435-6C4DFBEC5BB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9004310" y="2781301"/>
                <a:ext cx="47625" cy="0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70" name="Rectangle 416">
                <a:extLst>
                  <a:ext uri="{FF2B5EF4-FFF2-40B4-BE49-F238E27FC236}">
                    <a16:creationId xmlns:a16="http://schemas.microsoft.com/office/drawing/2014/main" id="{3ACF058C-31BD-7D40-1621-01629513F6B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017010" y="2422526"/>
                <a:ext cx="23813" cy="23813"/>
              </a:xfrm>
              <a:prstGeom prst="rect">
                <a:avLst/>
              </a:prstGeom>
              <a:noFill/>
              <a:ln w="1588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71" name="Szövegdoboz 70">
                <a:extLst>
                  <a:ext uri="{FF2B5EF4-FFF2-40B4-BE49-F238E27FC236}">
                    <a16:creationId xmlns:a16="http://schemas.microsoft.com/office/drawing/2014/main" id="{5CF91EF6-62E6-B3E0-22D4-6D4D9DB2763E}"/>
                  </a:ext>
                </a:extLst>
              </p:cNvPr>
              <p:cNvSpPr txBox="1"/>
              <p:nvPr/>
            </p:nvSpPr>
            <p:spPr>
              <a:xfrm>
                <a:off x="8328960" y="2909596"/>
                <a:ext cx="1027484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Healthy control</a:t>
                </a:r>
                <a:r>
                  <a:rPr lang="hu-HU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Line 175">
                <a:extLst>
                  <a:ext uri="{FF2B5EF4-FFF2-40B4-BE49-F238E27FC236}">
                    <a16:creationId xmlns:a16="http://schemas.microsoft.com/office/drawing/2014/main" id="{2DBB39B9-8EC9-C9A8-B56D-1E6BB9C591A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670783" y="796095"/>
                <a:ext cx="382275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grpSp>
            <p:nvGrpSpPr>
              <p:cNvPr id="73" name="Csoportba foglalás 72">
                <a:extLst>
                  <a:ext uri="{FF2B5EF4-FFF2-40B4-BE49-F238E27FC236}">
                    <a16:creationId xmlns:a16="http://schemas.microsoft.com/office/drawing/2014/main" id="{3936769A-92A3-8BDF-21DC-D7D9D3BAF3DD}"/>
                  </a:ext>
                </a:extLst>
              </p:cNvPr>
              <p:cNvGrpSpPr/>
              <p:nvPr/>
            </p:nvGrpSpPr>
            <p:grpSpPr>
              <a:xfrm>
                <a:off x="9274089" y="767323"/>
                <a:ext cx="1027484" cy="2573727"/>
                <a:chOff x="10205952" y="767323"/>
                <a:chExt cx="1027484" cy="2573727"/>
              </a:xfrm>
            </p:grpSpPr>
            <p:sp>
              <p:nvSpPr>
                <p:cNvPr id="140" name="Oval 471">
                  <a:extLst>
                    <a:ext uri="{FF2B5EF4-FFF2-40B4-BE49-F238E27FC236}">
                      <a16:creationId xmlns:a16="http://schemas.microsoft.com/office/drawing/2014/main" id="{9342C4D3-96A9-AC69-077F-26C7FD6835D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512425" y="1357313"/>
                  <a:ext cx="26988" cy="26988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41" name="Oval 472">
                  <a:extLst>
                    <a:ext uri="{FF2B5EF4-FFF2-40B4-BE49-F238E27FC236}">
                      <a16:creationId xmlns:a16="http://schemas.microsoft.com/office/drawing/2014/main" id="{04237151-8346-58D6-CAAF-B54D8417FC5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448925" y="1417638"/>
                  <a:ext cx="26988" cy="26988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42" name="Oval 473">
                  <a:extLst>
                    <a:ext uri="{FF2B5EF4-FFF2-40B4-BE49-F238E27FC236}">
                      <a16:creationId xmlns:a16="http://schemas.microsoft.com/office/drawing/2014/main" id="{A6E947B4-B66D-3307-D1ED-6711613BD49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542588" y="1703388"/>
                  <a:ext cx="26988" cy="26988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43" name="Oval 474">
                  <a:extLst>
                    <a:ext uri="{FF2B5EF4-FFF2-40B4-BE49-F238E27FC236}">
                      <a16:creationId xmlns:a16="http://schemas.microsoft.com/office/drawing/2014/main" id="{5FD0A213-C5B4-53A9-B401-4E8FA772B2F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542588" y="1049338"/>
                  <a:ext cx="26988" cy="28575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44" name="Oval 475">
                  <a:extLst>
                    <a:ext uri="{FF2B5EF4-FFF2-40B4-BE49-F238E27FC236}">
                      <a16:creationId xmlns:a16="http://schemas.microsoft.com/office/drawing/2014/main" id="{40F3C852-8AE7-8757-DB4C-2449FD2EBA6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512425" y="871538"/>
                  <a:ext cx="26988" cy="26988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45" name="Oval 476">
                  <a:extLst>
                    <a:ext uri="{FF2B5EF4-FFF2-40B4-BE49-F238E27FC236}">
                      <a16:creationId xmlns:a16="http://schemas.microsoft.com/office/drawing/2014/main" id="{3208E5BA-9F12-08A2-D353-1A5A85D17B7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542588" y="1462088"/>
                  <a:ext cx="26988" cy="28575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46" name="Oval 477">
                  <a:extLst>
                    <a:ext uri="{FF2B5EF4-FFF2-40B4-BE49-F238E27FC236}">
                      <a16:creationId xmlns:a16="http://schemas.microsoft.com/office/drawing/2014/main" id="{767D520E-D694-CDCA-ED29-F6074AD580A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480675" y="1093788"/>
                  <a:ext cx="26988" cy="28575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47" name="Oval 478">
                  <a:extLst>
                    <a:ext uri="{FF2B5EF4-FFF2-40B4-BE49-F238E27FC236}">
                      <a16:creationId xmlns:a16="http://schemas.microsoft.com/office/drawing/2014/main" id="{D09228BA-FF18-DEC1-809D-534EC19DFFD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606088" y="1196976"/>
                  <a:ext cx="26988" cy="28575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48" name="Oval 479">
                  <a:extLst>
                    <a:ext uri="{FF2B5EF4-FFF2-40B4-BE49-F238E27FC236}">
                      <a16:creationId xmlns:a16="http://schemas.microsoft.com/office/drawing/2014/main" id="{D31C0391-42AD-219F-B4FF-2DD7EB39A9A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512425" y="2076451"/>
                  <a:ext cx="26988" cy="26988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49" name="Oval 480">
                  <a:extLst>
                    <a:ext uri="{FF2B5EF4-FFF2-40B4-BE49-F238E27FC236}">
                      <a16:creationId xmlns:a16="http://schemas.microsoft.com/office/drawing/2014/main" id="{63A504B2-87AB-E87A-CB70-7DB38432999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448925" y="2105026"/>
                  <a:ext cx="26988" cy="26988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50" name="Oval 481">
                  <a:extLst>
                    <a:ext uri="{FF2B5EF4-FFF2-40B4-BE49-F238E27FC236}">
                      <a16:creationId xmlns:a16="http://schemas.microsoft.com/office/drawing/2014/main" id="{0BDEA810-D0E2-3A1F-E29E-82897B9F83D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480675" y="1762126"/>
                  <a:ext cx="26988" cy="26988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51" name="Oval 482">
                  <a:extLst>
                    <a:ext uri="{FF2B5EF4-FFF2-40B4-BE49-F238E27FC236}">
                      <a16:creationId xmlns:a16="http://schemas.microsoft.com/office/drawing/2014/main" id="{BE3AD002-387B-A77A-8223-D2A83EB7D7F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574338" y="1330326"/>
                  <a:ext cx="26988" cy="28575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52" name="Oval 483">
                  <a:extLst>
                    <a:ext uri="{FF2B5EF4-FFF2-40B4-BE49-F238E27FC236}">
                      <a16:creationId xmlns:a16="http://schemas.microsoft.com/office/drawing/2014/main" id="{4909B70B-4940-EA2D-52FA-67C3E42DB36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417175" y="1219201"/>
                  <a:ext cx="26988" cy="26988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53" name="Oval 484">
                  <a:extLst>
                    <a:ext uri="{FF2B5EF4-FFF2-40B4-BE49-F238E27FC236}">
                      <a16:creationId xmlns:a16="http://schemas.microsoft.com/office/drawing/2014/main" id="{CDC5366A-C246-58EA-4C11-B35EC972152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669588" y="1096963"/>
                  <a:ext cx="26988" cy="26988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54" name="Oval 485">
                  <a:extLst>
                    <a:ext uri="{FF2B5EF4-FFF2-40B4-BE49-F238E27FC236}">
                      <a16:creationId xmlns:a16="http://schemas.microsoft.com/office/drawing/2014/main" id="{8B603CD3-CC46-7A84-0887-7A52800D4D2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353675" y="1146176"/>
                  <a:ext cx="28575" cy="28575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55" name="Oval 486">
                  <a:extLst>
                    <a:ext uri="{FF2B5EF4-FFF2-40B4-BE49-F238E27FC236}">
                      <a16:creationId xmlns:a16="http://schemas.microsoft.com/office/drawing/2014/main" id="{ED64FFEE-A55E-EDB3-7887-6B381CCC6CF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574338" y="2152651"/>
                  <a:ext cx="26988" cy="26988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56" name="Oval 487">
                  <a:extLst>
                    <a:ext uri="{FF2B5EF4-FFF2-40B4-BE49-F238E27FC236}">
                      <a16:creationId xmlns:a16="http://schemas.microsoft.com/office/drawing/2014/main" id="{29190F15-F971-0A47-14D9-77323CA1909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480675" y="1509713"/>
                  <a:ext cx="26988" cy="28575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57" name="Oval 488">
                  <a:extLst>
                    <a:ext uri="{FF2B5EF4-FFF2-40B4-BE49-F238E27FC236}">
                      <a16:creationId xmlns:a16="http://schemas.microsoft.com/office/drawing/2014/main" id="{A6C79F56-9DD5-614F-2E7E-E76D3102C3F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512425" y="2565401"/>
                  <a:ext cx="26988" cy="26988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58" name="Freeform 489">
                  <a:extLst>
                    <a:ext uri="{FF2B5EF4-FFF2-40B4-BE49-F238E27FC236}">
                      <a16:creationId xmlns:a16="http://schemas.microsoft.com/office/drawing/2014/main" id="{881C419D-BA65-31DD-62F2-57D8EE4B1D2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0337800" y="1160463"/>
                  <a:ext cx="376238" cy="615950"/>
                </a:xfrm>
                <a:custGeom>
                  <a:avLst/>
                  <a:gdLst>
                    <a:gd name="T0" fmla="*/ 0 w 237"/>
                    <a:gd name="T1" fmla="*/ 388 h 388"/>
                    <a:gd name="T2" fmla="*/ 237 w 237"/>
                    <a:gd name="T3" fmla="*/ 388 h 388"/>
                    <a:gd name="T4" fmla="*/ 237 w 237"/>
                    <a:gd name="T5" fmla="*/ 388 h 388"/>
                    <a:gd name="T6" fmla="*/ 237 w 237"/>
                    <a:gd name="T7" fmla="*/ 152 h 388"/>
                    <a:gd name="T8" fmla="*/ 237 w 237"/>
                    <a:gd name="T9" fmla="*/ 0 h 388"/>
                    <a:gd name="T10" fmla="*/ 237 w 237"/>
                    <a:gd name="T11" fmla="*/ 0 h 388"/>
                    <a:gd name="T12" fmla="*/ 0 w 237"/>
                    <a:gd name="T13" fmla="*/ 0 h 388"/>
                    <a:gd name="T14" fmla="*/ 0 w 237"/>
                    <a:gd name="T15" fmla="*/ 0 h 388"/>
                    <a:gd name="T16" fmla="*/ 0 w 237"/>
                    <a:gd name="T17" fmla="*/ 152 h 388"/>
                    <a:gd name="T18" fmla="*/ 0 w 237"/>
                    <a:gd name="T19" fmla="*/ 388 h 38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237" h="388">
                      <a:moveTo>
                        <a:pt x="0" y="388"/>
                      </a:moveTo>
                      <a:lnTo>
                        <a:pt x="237" y="388"/>
                      </a:lnTo>
                      <a:lnTo>
                        <a:pt x="237" y="388"/>
                      </a:lnTo>
                      <a:lnTo>
                        <a:pt x="237" y="152"/>
                      </a:lnTo>
                      <a:lnTo>
                        <a:pt x="237" y="0"/>
                      </a:lnTo>
                      <a:lnTo>
                        <a:pt x="237" y="0"/>
                      </a:ln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0" y="152"/>
                      </a:lnTo>
                      <a:lnTo>
                        <a:pt x="0" y="388"/>
                      </a:lnTo>
                    </a:path>
                  </a:pathLst>
                </a:cu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59" name="Line 490">
                  <a:extLst>
                    <a:ext uri="{FF2B5EF4-FFF2-40B4-BE49-F238E27FC236}">
                      <a16:creationId xmlns:a16="http://schemas.microsoft.com/office/drawing/2014/main" id="{783E05D2-E660-12BD-A6EF-8EEC50626A7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0337800" y="1776413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60" name="Line 491">
                  <a:extLst>
                    <a:ext uri="{FF2B5EF4-FFF2-40B4-BE49-F238E27FC236}">
                      <a16:creationId xmlns:a16="http://schemas.microsoft.com/office/drawing/2014/main" id="{A21F2918-506D-0B64-37B9-E04C71F8764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0337800" y="1401763"/>
                  <a:ext cx="376238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61" name="Line 492">
                  <a:extLst>
                    <a:ext uri="{FF2B5EF4-FFF2-40B4-BE49-F238E27FC236}">
                      <a16:creationId xmlns:a16="http://schemas.microsoft.com/office/drawing/2014/main" id="{85C8AD2C-BC2A-24DD-6C3E-4D1BA7D1CC3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0525125" y="1160463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62" name="Line 493">
                  <a:extLst>
                    <a:ext uri="{FF2B5EF4-FFF2-40B4-BE49-F238E27FC236}">
                      <a16:creationId xmlns:a16="http://schemas.microsoft.com/office/drawing/2014/main" id="{FA7319E2-AF62-FE6C-409C-93E9C7BC1BC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0525125" y="1776413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63" name="Line 494">
                  <a:extLst>
                    <a:ext uri="{FF2B5EF4-FFF2-40B4-BE49-F238E27FC236}">
                      <a16:creationId xmlns:a16="http://schemas.microsoft.com/office/drawing/2014/main" id="{38347005-6F37-4664-8B83-7D904C81D45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10525125" y="885826"/>
                  <a:ext cx="0" cy="274638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64" name="Line 495">
                  <a:extLst>
                    <a:ext uri="{FF2B5EF4-FFF2-40B4-BE49-F238E27FC236}">
                      <a16:creationId xmlns:a16="http://schemas.microsoft.com/office/drawing/2014/main" id="{82BA5B0C-7A85-6AC2-B907-0FA65D90C2F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0525125" y="1776413"/>
                  <a:ext cx="0" cy="803275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65" name="Line 496">
                  <a:extLst>
                    <a:ext uri="{FF2B5EF4-FFF2-40B4-BE49-F238E27FC236}">
                      <a16:creationId xmlns:a16="http://schemas.microsoft.com/office/drawing/2014/main" id="{853CB14D-1BBB-43E8-2BA5-EB9FD335581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0501313" y="885826"/>
                  <a:ext cx="47625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66" name="Line 497">
                  <a:extLst>
                    <a:ext uri="{FF2B5EF4-FFF2-40B4-BE49-F238E27FC236}">
                      <a16:creationId xmlns:a16="http://schemas.microsoft.com/office/drawing/2014/main" id="{B6D3C287-8F95-5A0F-9DB4-11F49537D9D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0501313" y="2579688"/>
                  <a:ext cx="47625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67" name="Rectangle 498">
                  <a:extLst>
                    <a:ext uri="{FF2B5EF4-FFF2-40B4-BE49-F238E27FC236}">
                      <a16:creationId xmlns:a16="http://schemas.microsoft.com/office/drawing/2014/main" id="{13E2270A-46DB-E304-1F8E-20786AA869A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514013" y="1508126"/>
                  <a:ext cx="23813" cy="23813"/>
                </a:xfrm>
                <a:prstGeom prst="rect">
                  <a:avLst/>
                </a:prstGeom>
                <a:noFill/>
                <a:ln w="1588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68" name="Oval 499">
                  <a:extLst>
                    <a:ext uri="{FF2B5EF4-FFF2-40B4-BE49-F238E27FC236}">
                      <a16:creationId xmlns:a16="http://schemas.microsoft.com/office/drawing/2014/main" id="{D229CA00-914D-CF3A-EB29-BB6FE193201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925185" y="1535113"/>
                  <a:ext cx="28575" cy="26988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69" name="Oval 503">
                  <a:extLst>
                    <a:ext uri="{FF2B5EF4-FFF2-40B4-BE49-F238E27FC236}">
                      <a16:creationId xmlns:a16="http://schemas.microsoft.com/office/drawing/2014/main" id="{54CEB5FC-4B63-681A-B136-29B52BC5609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888673" y="1109663"/>
                  <a:ext cx="26988" cy="28575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70" name="Oval 505">
                  <a:extLst>
                    <a:ext uri="{FF2B5EF4-FFF2-40B4-BE49-F238E27FC236}">
                      <a16:creationId xmlns:a16="http://schemas.microsoft.com/office/drawing/2014/main" id="{ABE470E8-72F7-A811-7D41-0B1485C6685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850573" y="1468438"/>
                  <a:ext cx="26988" cy="26988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71" name="Oval 506">
                  <a:extLst>
                    <a:ext uri="{FF2B5EF4-FFF2-40B4-BE49-F238E27FC236}">
                      <a16:creationId xmlns:a16="http://schemas.microsoft.com/office/drawing/2014/main" id="{EE281035-E0F9-371E-DF87-1221DEE1311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850573" y="1719263"/>
                  <a:ext cx="26988" cy="26988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72" name="Oval 507">
                  <a:extLst>
                    <a:ext uri="{FF2B5EF4-FFF2-40B4-BE49-F238E27FC236}">
                      <a16:creationId xmlns:a16="http://schemas.microsoft.com/office/drawing/2014/main" id="{413830D9-84AD-82AB-5482-3171D242AA8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888673" y="2660651"/>
                  <a:ext cx="26988" cy="26988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73" name="Oval 516">
                  <a:extLst>
                    <a:ext uri="{FF2B5EF4-FFF2-40B4-BE49-F238E27FC236}">
                      <a16:creationId xmlns:a16="http://schemas.microsoft.com/office/drawing/2014/main" id="{5EBBB6E8-9E22-B013-9669-45EC4048A44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039485" y="2470151"/>
                  <a:ext cx="26988" cy="26988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74" name="Freeform 517">
                  <a:extLst>
                    <a:ext uri="{FF2B5EF4-FFF2-40B4-BE49-F238E27FC236}">
                      <a16:creationId xmlns:a16="http://schemas.microsoft.com/office/drawing/2014/main" id="{51BDD2B7-5D0C-01BA-9297-73E4372983E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0712460" y="1846263"/>
                  <a:ext cx="377825" cy="504825"/>
                </a:xfrm>
                <a:custGeom>
                  <a:avLst/>
                  <a:gdLst>
                    <a:gd name="T0" fmla="*/ 0 w 238"/>
                    <a:gd name="T1" fmla="*/ 318 h 318"/>
                    <a:gd name="T2" fmla="*/ 238 w 238"/>
                    <a:gd name="T3" fmla="*/ 318 h 318"/>
                    <a:gd name="T4" fmla="*/ 238 w 238"/>
                    <a:gd name="T5" fmla="*/ 318 h 318"/>
                    <a:gd name="T6" fmla="*/ 238 w 238"/>
                    <a:gd name="T7" fmla="*/ 158 h 318"/>
                    <a:gd name="T8" fmla="*/ 238 w 238"/>
                    <a:gd name="T9" fmla="*/ 0 h 318"/>
                    <a:gd name="T10" fmla="*/ 238 w 238"/>
                    <a:gd name="T11" fmla="*/ 0 h 318"/>
                    <a:gd name="T12" fmla="*/ 0 w 238"/>
                    <a:gd name="T13" fmla="*/ 0 h 318"/>
                    <a:gd name="T14" fmla="*/ 0 w 238"/>
                    <a:gd name="T15" fmla="*/ 0 h 318"/>
                    <a:gd name="T16" fmla="*/ 0 w 238"/>
                    <a:gd name="T17" fmla="*/ 158 h 318"/>
                    <a:gd name="T18" fmla="*/ 0 w 238"/>
                    <a:gd name="T19" fmla="*/ 318 h 31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238" h="318">
                      <a:moveTo>
                        <a:pt x="0" y="318"/>
                      </a:moveTo>
                      <a:lnTo>
                        <a:pt x="238" y="318"/>
                      </a:lnTo>
                      <a:lnTo>
                        <a:pt x="238" y="318"/>
                      </a:lnTo>
                      <a:lnTo>
                        <a:pt x="238" y="158"/>
                      </a:lnTo>
                      <a:lnTo>
                        <a:pt x="238" y="0"/>
                      </a:lnTo>
                      <a:lnTo>
                        <a:pt x="238" y="0"/>
                      </a:ln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0" y="158"/>
                      </a:lnTo>
                      <a:lnTo>
                        <a:pt x="0" y="318"/>
                      </a:lnTo>
                    </a:path>
                  </a:pathLst>
                </a:custGeom>
                <a:pattFill prst="pct50">
                  <a:fgClr>
                    <a:schemeClr val="accent1"/>
                  </a:fgClr>
                  <a:bgClr>
                    <a:schemeClr val="bg1"/>
                  </a:bgClr>
                </a:pattFill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75" name="Line 522">
                  <a:extLst>
                    <a:ext uri="{FF2B5EF4-FFF2-40B4-BE49-F238E27FC236}">
                      <a16:creationId xmlns:a16="http://schemas.microsoft.com/office/drawing/2014/main" id="{D24B89EC-2713-25B9-AB44-BCCF33E975F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10901373" y="1123951"/>
                  <a:ext cx="0" cy="722313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76" name="Line 523">
                  <a:extLst>
                    <a:ext uri="{FF2B5EF4-FFF2-40B4-BE49-F238E27FC236}">
                      <a16:creationId xmlns:a16="http://schemas.microsoft.com/office/drawing/2014/main" id="{EDE64AC2-4084-019A-1F7B-DA4A72B8665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0901373" y="2351088"/>
                  <a:ext cx="0" cy="322263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77" name="Line 524">
                  <a:extLst>
                    <a:ext uri="{FF2B5EF4-FFF2-40B4-BE49-F238E27FC236}">
                      <a16:creationId xmlns:a16="http://schemas.microsoft.com/office/drawing/2014/main" id="{8AB954FF-6909-7D08-FE9E-1461D1C5542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0877560" y="1123951"/>
                  <a:ext cx="47625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78" name="Line 525">
                  <a:extLst>
                    <a:ext uri="{FF2B5EF4-FFF2-40B4-BE49-F238E27FC236}">
                      <a16:creationId xmlns:a16="http://schemas.microsoft.com/office/drawing/2014/main" id="{E8340F09-DB9F-2774-5810-323E18D12BA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0877560" y="2673351"/>
                  <a:ext cx="47625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79" name="Line 537">
                  <a:extLst>
                    <a:ext uri="{FF2B5EF4-FFF2-40B4-BE49-F238E27FC236}">
                      <a16:creationId xmlns:a16="http://schemas.microsoft.com/office/drawing/2014/main" id="{1D026D95-BE26-330A-AD8D-15B72D8704C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0537825" y="2905126"/>
                  <a:ext cx="0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80" name="Line 538">
                  <a:extLst>
                    <a:ext uri="{FF2B5EF4-FFF2-40B4-BE49-F238E27FC236}">
                      <a16:creationId xmlns:a16="http://schemas.microsoft.com/office/drawing/2014/main" id="{7FEDAA25-48F9-B027-65F7-5A2D86F73C9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1009313" y="2905126"/>
                  <a:ext cx="0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81" name="Oval 500">
                  <a:extLst>
                    <a:ext uri="{FF2B5EF4-FFF2-40B4-BE49-F238E27FC236}">
                      <a16:creationId xmlns:a16="http://schemas.microsoft.com/office/drawing/2014/main" id="{964275CA-2E1E-2ED6-0F89-9A2BD666B37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925185" y="2058988"/>
                  <a:ext cx="28575" cy="28575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82" name="Oval 501">
                  <a:extLst>
                    <a:ext uri="{FF2B5EF4-FFF2-40B4-BE49-F238E27FC236}">
                      <a16:creationId xmlns:a16="http://schemas.microsoft.com/office/drawing/2014/main" id="{7288F9F6-8BE2-E0D7-9723-DD42182C5DB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888673" y="2106613"/>
                  <a:ext cx="26988" cy="26988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83" name="Oval 502">
                  <a:extLst>
                    <a:ext uri="{FF2B5EF4-FFF2-40B4-BE49-F238E27FC236}">
                      <a16:creationId xmlns:a16="http://schemas.microsoft.com/office/drawing/2014/main" id="{1E819937-D9C5-BBA3-C85E-DA002763590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925185" y="1831976"/>
                  <a:ext cx="28575" cy="26988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84" name="Oval 504">
                  <a:extLst>
                    <a:ext uri="{FF2B5EF4-FFF2-40B4-BE49-F238E27FC236}">
                      <a16:creationId xmlns:a16="http://schemas.microsoft.com/office/drawing/2014/main" id="{3CC352A6-E03C-3330-E7E9-0540C31F717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888673" y="2338388"/>
                  <a:ext cx="26988" cy="26988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85" name="Oval 508">
                  <a:extLst>
                    <a:ext uri="{FF2B5EF4-FFF2-40B4-BE49-F238E27FC236}">
                      <a16:creationId xmlns:a16="http://schemas.microsoft.com/office/drawing/2014/main" id="{87FF905B-2381-A4E2-BD2A-7FBEFE2FCB3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812473" y="2432051"/>
                  <a:ext cx="26988" cy="26988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86" name="Oval 509">
                  <a:extLst>
                    <a:ext uri="{FF2B5EF4-FFF2-40B4-BE49-F238E27FC236}">
                      <a16:creationId xmlns:a16="http://schemas.microsoft.com/office/drawing/2014/main" id="{B797DFA9-81AF-25E3-B872-EC500F7CE62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963285" y="2378076"/>
                  <a:ext cx="26988" cy="26988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87" name="Oval 510">
                  <a:extLst>
                    <a:ext uri="{FF2B5EF4-FFF2-40B4-BE49-F238E27FC236}">
                      <a16:creationId xmlns:a16="http://schemas.microsoft.com/office/drawing/2014/main" id="{956D17AB-F9E2-3482-6D81-345BEFC488C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812473" y="2228851"/>
                  <a:ext cx="26988" cy="28575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88" name="Oval 511">
                  <a:extLst>
                    <a:ext uri="{FF2B5EF4-FFF2-40B4-BE49-F238E27FC236}">
                      <a16:creationId xmlns:a16="http://schemas.microsoft.com/office/drawing/2014/main" id="{F397BDFF-F11A-139B-13E9-C7BD28DC2FD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850573" y="2044701"/>
                  <a:ext cx="26988" cy="26988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89" name="Oval 512">
                  <a:extLst>
                    <a:ext uri="{FF2B5EF4-FFF2-40B4-BE49-F238E27FC236}">
                      <a16:creationId xmlns:a16="http://schemas.microsoft.com/office/drawing/2014/main" id="{0815CDF8-DBE0-A1EA-E428-964B26FE0CB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001385" y="1935163"/>
                  <a:ext cx="26988" cy="26988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90" name="Oval 513">
                  <a:extLst>
                    <a:ext uri="{FF2B5EF4-FFF2-40B4-BE49-F238E27FC236}">
                      <a16:creationId xmlns:a16="http://schemas.microsoft.com/office/drawing/2014/main" id="{C68DF838-C395-FBC9-94D0-C4CF15E310B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963285" y="2127251"/>
                  <a:ext cx="26988" cy="26988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91" name="Oval 514">
                  <a:extLst>
                    <a:ext uri="{FF2B5EF4-FFF2-40B4-BE49-F238E27FC236}">
                      <a16:creationId xmlns:a16="http://schemas.microsoft.com/office/drawing/2014/main" id="{2BFA7A45-9F23-7E79-539A-06062AF3CAB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774373" y="2033588"/>
                  <a:ext cx="26988" cy="26988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92" name="Oval 515">
                  <a:extLst>
                    <a:ext uri="{FF2B5EF4-FFF2-40B4-BE49-F238E27FC236}">
                      <a16:creationId xmlns:a16="http://schemas.microsoft.com/office/drawing/2014/main" id="{AD5BE4F4-E7F2-DEE1-B9DA-3BBE39721E9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736273" y="2332038"/>
                  <a:ext cx="28575" cy="26988"/>
                </a:xfrm>
                <a:prstGeom prst="ellipse">
                  <a:avLst/>
                </a:prstGeom>
                <a:solidFill>
                  <a:srgbClr val="0000FF"/>
                </a:solidFill>
                <a:ln w="15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93" name="Line 518">
                  <a:extLst>
                    <a:ext uri="{FF2B5EF4-FFF2-40B4-BE49-F238E27FC236}">
                      <a16:creationId xmlns:a16="http://schemas.microsoft.com/office/drawing/2014/main" id="{CF712576-C86A-BFC5-CA4A-600133876FF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0712460" y="2351088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94" name="Line 519">
                  <a:extLst>
                    <a:ext uri="{FF2B5EF4-FFF2-40B4-BE49-F238E27FC236}">
                      <a16:creationId xmlns:a16="http://schemas.microsoft.com/office/drawing/2014/main" id="{ACE10A51-A9EA-6D4E-E25D-612981A0B41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0712460" y="2097088"/>
                  <a:ext cx="377825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95" name="Line 520">
                  <a:extLst>
                    <a:ext uri="{FF2B5EF4-FFF2-40B4-BE49-F238E27FC236}">
                      <a16:creationId xmlns:a16="http://schemas.microsoft.com/office/drawing/2014/main" id="{03D8B7F9-6057-D41A-1E48-3012B309C26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0901373" y="1846263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96" name="Line 521">
                  <a:extLst>
                    <a:ext uri="{FF2B5EF4-FFF2-40B4-BE49-F238E27FC236}">
                      <a16:creationId xmlns:a16="http://schemas.microsoft.com/office/drawing/2014/main" id="{9ECA3C3F-BDFD-115E-7B0D-999F018D365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0901373" y="2351088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97" name="Rectangle 526">
                  <a:extLst>
                    <a:ext uri="{FF2B5EF4-FFF2-40B4-BE49-F238E27FC236}">
                      <a16:creationId xmlns:a16="http://schemas.microsoft.com/office/drawing/2014/main" id="{DCC8F0FC-7D9F-3C86-DAF9-C4A7775B67F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890260" y="2046288"/>
                  <a:ext cx="23813" cy="23813"/>
                </a:xfrm>
                <a:prstGeom prst="rect">
                  <a:avLst/>
                </a:prstGeom>
                <a:noFill/>
                <a:ln w="1588">
                  <a:solidFill>
                    <a:srgbClr val="0000FF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98" name="Szövegdoboz 197">
                  <a:extLst>
                    <a:ext uri="{FF2B5EF4-FFF2-40B4-BE49-F238E27FC236}">
                      <a16:creationId xmlns:a16="http://schemas.microsoft.com/office/drawing/2014/main" id="{F2B66BC0-FEE1-C1A5-3738-A3AC9A9B8124}"/>
                    </a:ext>
                  </a:extLst>
                </p:cNvPr>
                <p:cNvSpPr txBox="1"/>
                <p:nvPr/>
              </p:nvSpPr>
              <p:spPr>
                <a:xfrm>
                  <a:off x="10205952" y="2910163"/>
                  <a:ext cx="1027484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hu-HU" sz="11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Moderate</a:t>
                  </a:r>
                  <a:endParaRPr lang="hu-HU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r>
                    <a:rPr lang="hu-HU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VID-19</a:t>
                  </a:r>
                  <a:endParaRPr 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9" name="Line 175">
                  <a:extLst>
                    <a:ext uri="{FF2B5EF4-FFF2-40B4-BE49-F238E27FC236}">
                      <a16:creationId xmlns:a16="http://schemas.microsoft.com/office/drawing/2014/main" id="{632337AC-E4FB-F869-22B3-2336E04CC81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0549383" y="767323"/>
                  <a:ext cx="382275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</p:grpSp>
          <p:sp>
            <p:nvSpPr>
              <p:cNvPr id="74" name="Szövegdoboz 73">
                <a:extLst>
                  <a:ext uri="{FF2B5EF4-FFF2-40B4-BE49-F238E27FC236}">
                    <a16:creationId xmlns:a16="http://schemas.microsoft.com/office/drawing/2014/main" id="{FD98FAC4-7629-77BE-4C05-69218A889A52}"/>
                  </a:ext>
                </a:extLst>
              </p:cNvPr>
              <p:cNvSpPr txBox="1"/>
              <p:nvPr/>
            </p:nvSpPr>
            <p:spPr>
              <a:xfrm>
                <a:off x="8613954" y="561518"/>
                <a:ext cx="47783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*</a:t>
                </a:r>
              </a:p>
            </p:txBody>
          </p:sp>
          <p:grpSp>
            <p:nvGrpSpPr>
              <p:cNvPr id="75" name="Csoportba foglalás 74">
                <a:extLst>
                  <a:ext uri="{FF2B5EF4-FFF2-40B4-BE49-F238E27FC236}">
                    <a16:creationId xmlns:a16="http://schemas.microsoft.com/office/drawing/2014/main" id="{C5970E08-F9B4-7940-781F-6B7610CB7D54}"/>
                  </a:ext>
                </a:extLst>
              </p:cNvPr>
              <p:cNvGrpSpPr/>
              <p:nvPr/>
            </p:nvGrpSpPr>
            <p:grpSpPr>
              <a:xfrm>
                <a:off x="10197904" y="597713"/>
                <a:ext cx="1027484" cy="2743326"/>
                <a:chOff x="9270409" y="597713"/>
                <a:chExt cx="1027484" cy="2743326"/>
              </a:xfrm>
            </p:grpSpPr>
            <p:sp>
              <p:nvSpPr>
                <p:cNvPr id="81" name="Oval 417">
                  <a:extLst>
                    <a:ext uri="{FF2B5EF4-FFF2-40B4-BE49-F238E27FC236}">
                      <a16:creationId xmlns:a16="http://schemas.microsoft.com/office/drawing/2014/main" id="{07940185-40F7-7888-0A17-A94AA43362B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612313" y="1230313"/>
                  <a:ext cx="26988" cy="26988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82" name="Oval 418">
                  <a:extLst>
                    <a:ext uri="{FF2B5EF4-FFF2-40B4-BE49-F238E27FC236}">
                      <a16:creationId xmlns:a16="http://schemas.microsoft.com/office/drawing/2014/main" id="{8B74512C-7998-6BE1-1EAD-FCB7F6EA8FE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580563" y="1452563"/>
                  <a:ext cx="28575" cy="26988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83" name="Oval 419">
                  <a:extLst>
                    <a:ext uri="{FF2B5EF4-FFF2-40B4-BE49-F238E27FC236}">
                      <a16:creationId xmlns:a16="http://schemas.microsoft.com/office/drawing/2014/main" id="{93394A46-DA5A-8103-5700-7C51041DECD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580563" y="962026"/>
                  <a:ext cx="28575" cy="26988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84" name="Oval 420">
                  <a:extLst>
                    <a:ext uri="{FF2B5EF4-FFF2-40B4-BE49-F238E27FC236}">
                      <a16:creationId xmlns:a16="http://schemas.microsoft.com/office/drawing/2014/main" id="{DCE39234-3B6B-9203-D9EA-B37ACE2EFEB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612313" y="1082676"/>
                  <a:ext cx="26988" cy="26988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85" name="Oval 421">
                  <a:extLst>
                    <a:ext uri="{FF2B5EF4-FFF2-40B4-BE49-F238E27FC236}">
                      <a16:creationId xmlns:a16="http://schemas.microsoft.com/office/drawing/2014/main" id="{2D8EF1B0-BBF1-EA87-7B9B-F7A72A775D5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548813" y="1150938"/>
                  <a:ext cx="28575" cy="26988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86" name="Oval 422">
                  <a:extLst>
                    <a:ext uri="{FF2B5EF4-FFF2-40B4-BE49-F238E27FC236}">
                      <a16:creationId xmlns:a16="http://schemas.microsoft.com/office/drawing/2014/main" id="{0E408961-367A-6C0B-5B7F-0C469663407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675813" y="1109663"/>
                  <a:ext cx="26988" cy="28575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87" name="Oval 423">
                  <a:extLst>
                    <a:ext uri="{FF2B5EF4-FFF2-40B4-BE49-F238E27FC236}">
                      <a16:creationId xmlns:a16="http://schemas.microsoft.com/office/drawing/2014/main" id="{86F33791-CE87-BDD2-C456-F0E04E82863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548813" y="1284288"/>
                  <a:ext cx="28575" cy="26988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88" name="Oval 424">
                  <a:extLst>
                    <a:ext uri="{FF2B5EF4-FFF2-40B4-BE49-F238E27FC236}">
                      <a16:creationId xmlns:a16="http://schemas.microsoft.com/office/drawing/2014/main" id="{4CDD2CF3-07AC-5D18-BB1D-A8752267CD0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486900" y="1174751"/>
                  <a:ext cx="26988" cy="26988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89" name="Oval 425">
                  <a:extLst>
                    <a:ext uri="{FF2B5EF4-FFF2-40B4-BE49-F238E27FC236}">
                      <a16:creationId xmlns:a16="http://schemas.microsoft.com/office/drawing/2014/main" id="{26399ADE-B40F-7124-EA26-E9B94CEA321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518650" y="955676"/>
                  <a:ext cx="26988" cy="28575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90" name="Oval 426">
                  <a:extLst>
                    <a:ext uri="{FF2B5EF4-FFF2-40B4-BE49-F238E27FC236}">
                      <a16:creationId xmlns:a16="http://schemas.microsoft.com/office/drawing/2014/main" id="{1F1E66FF-974D-7420-6EE2-C5AB02F2793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737725" y="1047751"/>
                  <a:ext cx="28575" cy="26988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91" name="Oval 427">
                  <a:extLst>
                    <a:ext uri="{FF2B5EF4-FFF2-40B4-BE49-F238E27FC236}">
                      <a16:creationId xmlns:a16="http://schemas.microsoft.com/office/drawing/2014/main" id="{36E58590-BDFB-A834-839D-5715F21016E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423400" y="1089026"/>
                  <a:ext cx="28575" cy="26988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92" name="Oval 428">
                  <a:extLst>
                    <a:ext uri="{FF2B5EF4-FFF2-40B4-BE49-F238E27FC236}">
                      <a16:creationId xmlns:a16="http://schemas.microsoft.com/office/drawing/2014/main" id="{3DE7D7E1-26A9-DBBC-12E1-726EFDBB7C8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580563" y="1665288"/>
                  <a:ext cx="28575" cy="26988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93" name="Oval 429">
                  <a:extLst>
                    <a:ext uri="{FF2B5EF4-FFF2-40B4-BE49-F238E27FC236}">
                      <a16:creationId xmlns:a16="http://schemas.microsoft.com/office/drawing/2014/main" id="{29DCC384-CA85-FAFB-51CD-333A874DDDF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580563" y="2198688"/>
                  <a:ext cx="28575" cy="26988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94" name="Oval 430">
                  <a:extLst>
                    <a:ext uri="{FF2B5EF4-FFF2-40B4-BE49-F238E27FC236}">
                      <a16:creationId xmlns:a16="http://schemas.microsoft.com/office/drawing/2014/main" id="{62710F19-EEF7-EC62-7EAD-9981E0E16D5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675813" y="1300163"/>
                  <a:ext cx="26988" cy="26988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95" name="Oval 431">
                  <a:extLst>
                    <a:ext uri="{FF2B5EF4-FFF2-40B4-BE49-F238E27FC236}">
                      <a16:creationId xmlns:a16="http://schemas.microsoft.com/office/drawing/2014/main" id="{BB5BFC72-34C5-9223-24C6-B4D6D3749FE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486900" y="1250951"/>
                  <a:ext cx="26988" cy="28575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96" name="Oval 432">
                  <a:extLst>
                    <a:ext uri="{FF2B5EF4-FFF2-40B4-BE49-F238E27FC236}">
                      <a16:creationId xmlns:a16="http://schemas.microsoft.com/office/drawing/2014/main" id="{0C008109-A33F-7ABC-3057-8546E74E4E6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644063" y="901701"/>
                  <a:ext cx="26988" cy="28575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97" name="Oval 433">
                  <a:extLst>
                    <a:ext uri="{FF2B5EF4-FFF2-40B4-BE49-F238E27FC236}">
                      <a16:creationId xmlns:a16="http://schemas.microsoft.com/office/drawing/2014/main" id="{BE699D70-E470-41E6-72E8-7245D519CA7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580563" y="2522538"/>
                  <a:ext cx="28575" cy="26988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98" name="Freeform 434">
                  <a:extLst>
                    <a:ext uri="{FF2B5EF4-FFF2-40B4-BE49-F238E27FC236}">
                      <a16:creationId xmlns:a16="http://schemas.microsoft.com/office/drawing/2014/main" id="{8F8481D8-A080-ED49-4B09-25606D46703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9405938" y="1096963"/>
                  <a:ext cx="377825" cy="217488"/>
                </a:xfrm>
                <a:custGeom>
                  <a:avLst/>
                  <a:gdLst>
                    <a:gd name="T0" fmla="*/ 0 w 238"/>
                    <a:gd name="T1" fmla="*/ 137 h 137"/>
                    <a:gd name="T2" fmla="*/ 238 w 238"/>
                    <a:gd name="T3" fmla="*/ 137 h 137"/>
                    <a:gd name="T4" fmla="*/ 238 w 238"/>
                    <a:gd name="T5" fmla="*/ 137 h 137"/>
                    <a:gd name="T6" fmla="*/ 238 w 238"/>
                    <a:gd name="T7" fmla="*/ 58 h 137"/>
                    <a:gd name="T8" fmla="*/ 238 w 238"/>
                    <a:gd name="T9" fmla="*/ 0 h 137"/>
                    <a:gd name="T10" fmla="*/ 238 w 238"/>
                    <a:gd name="T11" fmla="*/ 0 h 137"/>
                    <a:gd name="T12" fmla="*/ 0 w 238"/>
                    <a:gd name="T13" fmla="*/ 0 h 137"/>
                    <a:gd name="T14" fmla="*/ 0 w 238"/>
                    <a:gd name="T15" fmla="*/ 0 h 137"/>
                    <a:gd name="T16" fmla="*/ 0 w 238"/>
                    <a:gd name="T17" fmla="*/ 58 h 137"/>
                    <a:gd name="T18" fmla="*/ 0 w 238"/>
                    <a:gd name="T19" fmla="*/ 137 h 13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238" h="137">
                      <a:moveTo>
                        <a:pt x="0" y="137"/>
                      </a:moveTo>
                      <a:lnTo>
                        <a:pt x="238" y="137"/>
                      </a:lnTo>
                      <a:lnTo>
                        <a:pt x="238" y="137"/>
                      </a:lnTo>
                      <a:lnTo>
                        <a:pt x="238" y="58"/>
                      </a:lnTo>
                      <a:lnTo>
                        <a:pt x="238" y="0"/>
                      </a:lnTo>
                      <a:lnTo>
                        <a:pt x="238" y="0"/>
                      </a:ln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0" y="58"/>
                      </a:lnTo>
                      <a:lnTo>
                        <a:pt x="0" y="137"/>
                      </a:lnTo>
                    </a:path>
                  </a:pathLst>
                </a:cu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99" name="Line 435">
                  <a:extLst>
                    <a:ext uri="{FF2B5EF4-FFF2-40B4-BE49-F238E27FC236}">
                      <a16:creationId xmlns:a16="http://schemas.microsoft.com/office/drawing/2014/main" id="{536964E5-579E-C3D9-7CDC-96F054776D8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9405938" y="1314451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00" name="Line 436">
                  <a:extLst>
                    <a:ext uri="{FF2B5EF4-FFF2-40B4-BE49-F238E27FC236}">
                      <a16:creationId xmlns:a16="http://schemas.microsoft.com/office/drawing/2014/main" id="{B16E3D28-FFD3-F27D-7055-EF39182DD3E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9405938" y="1189038"/>
                  <a:ext cx="377825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01" name="Line 437">
                  <a:extLst>
                    <a:ext uri="{FF2B5EF4-FFF2-40B4-BE49-F238E27FC236}">
                      <a16:creationId xmlns:a16="http://schemas.microsoft.com/office/drawing/2014/main" id="{D7A57500-396D-9115-5813-C66ADC72035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9594850" y="1096963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02" name="Line 438">
                  <a:extLst>
                    <a:ext uri="{FF2B5EF4-FFF2-40B4-BE49-F238E27FC236}">
                      <a16:creationId xmlns:a16="http://schemas.microsoft.com/office/drawing/2014/main" id="{E6D6F92B-A246-5307-97DC-E20345A6377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9594850" y="1314451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03" name="Line 439">
                  <a:extLst>
                    <a:ext uri="{FF2B5EF4-FFF2-40B4-BE49-F238E27FC236}">
                      <a16:creationId xmlns:a16="http://schemas.microsoft.com/office/drawing/2014/main" id="{20478687-6F86-A297-F3E6-0C5EC8EEE39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9594850" y="915988"/>
                  <a:ext cx="0" cy="180975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04" name="Line 440">
                  <a:extLst>
                    <a:ext uri="{FF2B5EF4-FFF2-40B4-BE49-F238E27FC236}">
                      <a16:creationId xmlns:a16="http://schemas.microsoft.com/office/drawing/2014/main" id="{A778106B-FCD6-1B48-2FFE-DD6676D0913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9594850" y="1314451"/>
                  <a:ext cx="0" cy="15240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05" name="Line 441">
                  <a:extLst>
                    <a:ext uri="{FF2B5EF4-FFF2-40B4-BE49-F238E27FC236}">
                      <a16:creationId xmlns:a16="http://schemas.microsoft.com/office/drawing/2014/main" id="{C3AC71CD-7678-8F82-A62A-1437371A219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9571038" y="915988"/>
                  <a:ext cx="47625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06" name="Line 442">
                  <a:extLst>
                    <a:ext uri="{FF2B5EF4-FFF2-40B4-BE49-F238E27FC236}">
                      <a16:creationId xmlns:a16="http://schemas.microsoft.com/office/drawing/2014/main" id="{23DD67B2-C592-9FF6-B7EF-F79FAF1DD45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9571038" y="1466851"/>
                  <a:ext cx="47625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07" name="Rectangle 443">
                  <a:extLst>
                    <a:ext uri="{FF2B5EF4-FFF2-40B4-BE49-F238E27FC236}">
                      <a16:creationId xmlns:a16="http://schemas.microsoft.com/office/drawing/2014/main" id="{4D2D1225-351F-41DB-84FA-86B23054756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583738" y="1317626"/>
                  <a:ext cx="23813" cy="23813"/>
                </a:xfrm>
                <a:prstGeom prst="rect">
                  <a:avLst/>
                </a:prstGeom>
                <a:noFill/>
                <a:ln w="1588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08" name="Oval 446">
                  <a:extLst>
                    <a:ext uri="{FF2B5EF4-FFF2-40B4-BE49-F238E27FC236}">
                      <a16:creationId xmlns:a16="http://schemas.microsoft.com/office/drawing/2014/main" id="{48B53E37-32C2-35A3-CF5B-26D8AA8BEDD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956810" y="1806576"/>
                  <a:ext cx="28575" cy="26988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09" name="Oval 447">
                  <a:extLst>
                    <a:ext uri="{FF2B5EF4-FFF2-40B4-BE49-F238E27FC236}">
                      <a16:creationId xmlns:a16="http://schemas.microsoft.com/office/drawing/2014/main" id="{5F2F30C9-7A6F-DFC7-94A0-EEE845EAA87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956810" y="1633538"/>
                  <a:ext cx="28575" cy="26988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10" name="Oval 451">
                  <a:extLst>
                    <a:ext uri="{FF2B5EF4-FFF2-40B4-BE49-F238E27FC236}">
                      <a16:creationId xmlns:a16="http://schemas.microsoft.com/office/drawing/2014/main" id="{8AE230D6-7403-4611-C8A1-DD49394C56A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004435" y="1436688"/>
                  <a:ext cx="28575" cy="26988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11" name="Oval 455">
                  <a:extLst>
                    <a:ext uri="{FF2B5EF4-FFF2-40B4-BE49-F238E27FC236}">
                      <a16:creationId xmlns:a16="http://schemas.microsoft.com/office/drawing/2014/main" id="{0F1252D0-B91E-16D7-D2BC-D5EA62621D9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956810" y="2587626"/>
                  <a:ext cx="28575" cy="26988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12" name="Oval 459">
                  <a:extLst>
                    <a:ext uri="{FF2B5EF4-FFF2-40B4-BE49-F238E27FC236}">
                      <a16:creationId xmlns:a16="http://schemas.microsoft.com/office/drawing/2014/main" id="{7249D279-A1F0-51C1-8969-A3EF9002185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910773" y="1381126"/>
                  <a:ext cx="26988" cy="26988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13" name="Freeform 461">
                  <a:extLst>
                    <a:ext uri="{FF2B5EF4-FFF2-40B4-BE49-F238E27FC236}">
                      <a16:creationId xmlns:a16="http://schemas.microsoft.com/office/drawing/2014/main" id="{AD010FE6-3F05-0377-243C-73D1B25B621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9782185" y="1858963"/>
                  <a:ext cx="377825" cy="527050"/>
                </a:xfrm>
                <a:custGeom>
                  <a:avLst/>
                  <a:gdLst>
                    <a:gd name="T0" fmla="*/ 0 w 238"/>
                    <a:gd name="T1" fmla="*/ 332 h 332"/>
                    <a:gd name="T2" fmla="*/ 238 w 238"/>
                    <a:gd name="T3" fmla="*/ 332 h 332"/>
                    <a:gd name="T4" fmla="*/ 238 w 238"/>
                    <a:gd name="T5" fmla="*/ 332 h 332"/>
                    <a:gd name="T6" fmla="*/ 238 w 238"/>
                    <a:gd name="T7" fmla="*/ 73 h 332"/>
                    <a:gd name="T8" fmla="*/ 238 w 238"/>
                    <a:gd name="T9" fmla="*/ 0 h 332"/>
                    <a:gd name="T10" fmla="*/ 238 w 238"/>
                    <a:gd name="T11" fmla="*/ 0 h 332"/>
                    <a:gd name="T12" fmla="*/ 0 w 238"/>
                    <a:gd name="T13" fmla="*/ 0 h 332"/>
                    <a:gd name="T14" fmla="*/ 0 w 238"/>
                    <a:gd name="T15" fmla="*/ 0 h 332"/>
                    <a:gd name="T16" fmla="*/ 0 w 238"/>
                    <a:gd name="T17" fmla="*/ 73 h 332"/>
                    <a:gd name="T18" fmla="*/ 0 w 238"/>
                    <a:gd name="T19" fmla="*/ 332 h 33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238" h="332">
                      <a:moveTo>
                        <a:pt x="0" y="332"/>
                      </a:moveTo>
                      <a:lnTo>
                        <a:pt x="238" y="332"/>
                      </a:lnTo>
                      <a:lnTo>
                        <a:pt x="238" y="332"/>
                      </a:lnTo>
                      <a:lnTo>
                        <a:pt x="238" y="73"/>
                      </a:lnTo>
                      <a:lnTo>
                        <a:pt x="238" y="0"/>
                      </a:lnTo>
                      <a:lnTo>
                        <a:pt x="238" y="0"/>
                      </a:lnTo>
                      <a:lnTo>
                        <a:pt x="0" y="0"/>
                      </a:lnTo>
                      <a:lnTo>
                        <a:pt x="0" y="0"/>
                      </a:lnTo>
                      <a:lnTo>
                        <a:pt x="0" y="73"/>
                      </a:lnTo>
                      <a:lnTo>
                        <a:pt x="0" y="332"/>
                      </a:lnTo>
                    </a:path>
                  </a:pathLst>
                </a:custGeom>
                <a:pattFill prst="pct25">
                  <a:fgClr>
                    <a:srgbClr val="FF0000"/>
                  </a:fgClr>
                  <a:bgClr>
                    <a:schemeClr val="bg1"/>
                  </a:bgClr>
                </a:pattFill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14" name="Line 466">
                  <a:extLst>
                    <a:ext uri="{FF2B5EF4-FFF2-40B4-BE49-F238E27FC236}">
                      <a16:creationId xmlns:a16="http://schemas.microsoft.com/office/drawing/2014/main" id="{762AABF6-187D-6E38-93DA-319F38C403D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9971098" y="1395413"/>
                  <a:ext cx="0" cy="46355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15" name="Line 467">
                  <a:extLst>
                    <a:ext uri="{FF2B5EF4-FFF2-40B4-BE49-F238E27FC236}">
                      <a16:creationId xmlns:a16="http://schemas.microsoft.com/office/drawing/2014/main" id="{01E1D1DA-4126-DEF4-6F68-7BE5C7F8097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9971098" y="2386013"/>
                  <a:ext cx="0" cy="21590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16" name="Line 468">
                  <a:extLst>
                    <a:ext uri="{FF2B5EF4-FFF2-40B4-BE49-F238E27FC236}">
                      <a16:creationId xmlns:a16="http://schemas.microsoft.com/office/drawing/2014/main" id="{4B672CA5-39AC-31BC-B0F9-4477FDE7E57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9947285" y="1395413"/>
                  <a:ext cx="47625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17" name="Line 469">
                  <a:extLst>
                    <a:ext uri="{FF2B5EF4-FFF2-40B4-BE49-F238E27FC236}">
                      <a16:creationId xmlns:a16="http://schemas.microsoft.com/office/drawing/2014/main" id="{92B773A8-391B-AF19-4433-A1E5C02F173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9947285" y="2601913"/>
                  <a:ext cx="47625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18" name="Line 535">
                  <a:extLst>
                    <a:ext uri="{FF2B5EF4-FFF2-40B4-BE49-F238E27FC236}">
                      <a16:creationId xmlns:a16="http://schemas.microsoft.com/office/drawing/2014/main" id="{5C3D5A8D-1218-A741-82BB-7D0719A5EF0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9594850" y="2905126"/>
                  <a:ext cx="0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19" name="Line 536">
                  <a:extLst>
                    <a:ext uri="{FF2B5EF4-FFF2-40B4-BE49-F238E27FC236}">
                      <a16:creationId xmlns:a16="http://schemas.microsoft.com/office/drawing/2014/main" id="{1811256C-0189-BAA6-A79D-0ABF675D498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0066338" y="2905126"/>
                  <a:ext cx="0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20" name="Oval 444">
                  <a:extLst>
                    <a:ext uri="{FF2B5EF4-FFF2-40B4-BE49-F238E27FC236}">
                      <a16:creationId xmlns:a16="http://schemas.microsoft.com/office/drawing/2014/main" id="{3BE89553-F533-E3EB-C592-46BAA414A9C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956810" y="1927226"/>
                  <a:ext cx="28575" cy="26988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21" name="Oval 445">
                  <a:extLst>
                    <a:ext uri="{FF2B5EF4-FFF2-40B4-BE49-F238E27FC236}">
                      <a16:creationId xmlns:a16="http://schemas.microsoft.com/office/drawing/2014/main" id="{D6F836D5-47F4-B623-DD57-8F34DB7AFDE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956810" y="2111376"/>
                  <a:ext cx="28575" cy="28575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22" name="Oval 448">
                  <a:extLst>
                    <a:ext uri="{FF2B5EF4-FFF2-40B4-BE49-F238E27FC236}">
                      <a16:creationId xmlns:a16="http://schemas.microsoft.com/office/drawing/2014/main" id="{C1978FAD-9EBB-BF24-A42E-0CBDBE71088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004435" y="2466976"/>
                  <a:ext cx="28575" cy="26988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23" name="Oval 449">
                  <a:extLst>
                    <a:ext uri="{FF2B5EF4-FFF2-40B4-BE49-F238E27FC236}">
                      <a16:creationId xmlns:a16="http://schemas.microsoft.com/office/drawing/2014/main" id="{3B14AD43-E647-2700-BB87-E12D7A45523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910773" y="2371726"/>
                  <a:ext cx="26988" cy="26988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24" name="Oval 450">
                  <a:extLst>
                    <a:ext uri="{FF2B5EF4-FFF2-40B4-BE49-F238E27FC236}">
                      <a16:creationId xmlns:a16="http://schemas.microsoft.com/office/drawing/2014/main" id="{292FA9A6-AD83-EF98-C656-82C1935A57D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863148" y="2068513"/>
                  <a:ext cx="26988" cy="26988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25" name="Oval 452">
                  <a:extLst>
                    <a:ext uri="{FF2B5EF4-FFF2-40B4-BE49-F238E27FC236}">
                      <a16:creationId xmlns:a16="http://schemas.microsoft.com/office/drawing/2014/main" id="{6D808079-F619-31B9-E9AC-9ED64A69D5A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863148" y="1844676"/>
                  <a:ext cx="26988" cy="26988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26" name="Oval 453">
                  <a:extLst>
                    <a:ext uri="{FF2B5EF4-FFF2-40B4-BE49-F238E27FC236}">
                      <a16:creationId xmlns:a16="http://schemas.microsoft.com/office/drawing/2014/main" id="{996FAE1A-EC56-E7E8-5E47-86D926948B1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863148" y="1960563"/>
                  <a:ext cx="26988" cy="26988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27" name="Oval 454">
                  <a:extLst>
                    <a:ext uri="{FF2B5EF4-FFF2-40B4-BE49-F238E27FC236}">
                      <a16:creationId xmlns:a16="http://schemas.microsoft.com/office/drawing/2014/main" id="{1FC39986-B2DA-292B-32F7-ECF0C350604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052060" y="2063751"/>
                  <a:ext cx="26988" cy="26988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28" name="Oval 456">
                  <a:extLst>
                    <a:ext uri="{FF2B5EF4-FFF2-40B4-BE49-F238E27FC236}">
                      <a16:creationId xmlns:a16="http://schemas.microsoft.com/office/drawing/2014/main" id="{EC651A2C-93F8-4C7F-CC4A-3F59771D221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098098" y="2428876"/>
                  <a:ext cx="28575" cy="26988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29" name="Oval 457">
                  <a:extLst>
                    <a:ext uri="{FF2B5EF4-FFF2-40B4-BE49-F238E27FC236}">
                      <a16:creationId xmlns:a16="http://schemas.microsoft.com/office/drawing/2014/main" id="{8D65C09D-4C7C-6692-44A2-22E68EAD8EC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052060" y="1849438"/>
                  <a:ext cx="26988" cy="28575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30" name="Oval 458">
                  <a:extLst>
                    <a:ext uri="{FF2B5EF4-FFF2-40B4-BE49-F238E27FC236}">
                      <a16:creationId xmlns:a16="http://schemas.microsoft.com/office/drawing/2014/main" id="{642D0BAB-A605-73D6-9132-D8904813EF5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052060" y="1878013"/>
                  <a:ext cx="26988" cy="28575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31" name="Oval 460">
                  <a:extLst>
                    <a:ext uri="{FF2B5EF4-FFF2-40B4-BE49-F238E27FC236}">
                      <a16:creationId xmlns:a16="http://schemas.microsoft.com/office/drawing/2014/main" id="{F61DE219-6F15-855A-9314-86D37BDD297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815523" y="2417763"/>
                  <a:ext cx="28575" cy="28575"/>
                </a:xfrm>
                <a:prstGeom prst="ellipse">
                  <a:avLst/>
                </a:prstGeom>
                <a:solidFill>
                  <a:srgbClr val="FF0000"/>
                </a:solidFill>
                <a:ln w="15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32" name="Line 462">
                  <a:extLst>
                    <a:ext uri="{FF2B5EF4-FFF2-40B4-BE49-F238E27FC236}">
                      <a16:creationId xmlns:a16="http://schemas.microsoft.com/office/drawing/2014/main" id="{AF84CDD0-093C-8EC4-EEAD-F49B1F982DA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9782185" y="2386013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33" name="Line 463">
                  <a:extLst>
                    <a:ext uri="{FF2B5EF4-FFF2-40B4-BE49-F238E27FC236}">
                      <a16:creationId xmlns:a16="http://schemas.microsoft.com/office/drawing/2014/main" id="{9C08412E-F648-1D37-B939-D5729BEE2D8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9782185" y="1974851"/>
                  <a:ext cx="377825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34" name="Line 464">
                  <a:extLst>
                    <a:ext uri="{FF2B5EF4-FFF2-40B4-BE49-F238E27FC236}">
                      <a16:creationId xmlns:a16="http://schemas.microsoft.com/office/drawing/2014/main" id="{24327689-BE73-E242-F7AF-001D84D446D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9971098" y="1858963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35" name="Line 465">
                  <a:extLst>
                    <a:ext uri="{FF2B5EF4-FFF2-40B4-BE49-F238E27FC236}">
                      <a16:creationId xmlns:a16="http://schemas.microsoft.com/office/drawing/2014/main" id="{F0464505-3FF6-DECF-B7E4-694FD186763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9971098" y="2386013"/>
                  <a:ext cx="0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36" name="Rectangle 470">
                  <a:extLst>
                    <a:ext uri="{FF2B5EF4-FFF2-40B4-BE49-F238E27FC236}">
                      <a16:creationId xmlns:a16="http://schemas.microsoft.com/office/drawing/2014/main" id="{785D0351-0EBF-496A-A469-1267A67217F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958398" y="2016126"/>
                  <a:ext cx="23813" cy="23813"/>
                </a:xfrm>
                <a:prstGeom prst="rect">
                  <a:avLst/>
                </a:prstGeom>
                <a:noFill/>
                <a:ln w="1588">
                  <a:solidFill>
                    <a:srgbClr val="FF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37" name="Szövegdoboz 136">
                  <a:extLst>
                    <a:ext uri="{FF2B5EF4-FFF2-40B4-BE49-F238E27FC236}">
                      <a16:creationId xmlns:a16="http://schemas.microsoft.com/office/drawing/2014/main" id="{828D8694-B4A5-2245-3384-344315FCDF6D}"/>
                    </a:ext>
                  </a:extLst>
                </p:cNvPr>
                <p:cNvSpPr txBox="1"/>
                <p:nvPr/>
              </p:nvSpPr>
              <p:spPr>
                <a:xfrm>
                  <a:off x="9270409" y="2910152"/>
                  <a:ext cx="1027484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hu-HU" sz="11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evere</a:t>
                  </a:r>
                  <a:endParaRPr lang="hu-HU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r>
                    <a:rPr lang="hu-HU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VID-19</a:t>
                  </a:r>
                  <a:endParaRPr 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8" name="Line 175">
                  <a:extLst>
                    <a:ext uri="{FF2B5EF4-FFF2-40B4-BE49-F238E27FC236}">
                      <a16:creationId xmlns:a16="http://schemas.microsoft.com/office/drawing/2014/main" id="{E460368E-AD95-70C9-2B0B-6301D5E8021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9622423" y="822139"/>
                  <a:ext cx="382275" cy="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139" name="Szövegdoboz 138">
                  <a:extLst>
                    <a:ext uri="{FF2B5EF4-FFF2-40B4-BE49-F238E27FC236}">
                      <a16:creationId xmlns:a16="http://schemas.microsoft.com/office/drawing/2014/main" id="{0AB04232-00E4-EFF3-580C-1579A37A22A4}"/>
                    </a:ext>
                  </a:extLst>
                </p:cNvPr>
                <p:cNvSpPr txBox="1"/>
                <p:nvPr/>
              </p:nvSpPr>
              <p:spPr>
                <a:xfrm>
                  <a:off x="9580415" y="597713"/>
                  <a:ext cx="47783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dirty="0"/>
                    <a:t>**</a:t>
                  </a:r>
                </a:p>
              </p:txBody>
            </p:sp>
          </p:grpSp>
          <p:sp>
            <p:nvSpPr>
              <p:cNvPr id="76" name="Szövegdoboz 75">
                <a:extLst>
                  <a:ext uri="{FF2B5EF4-FFF2-40B4-BE49-F238E27FC236}">
                    <a16:creationId xmlns:a16="http://schemas.microsoft.com/office/drawing/2014/main" id="{B1865A37-1061-9BBE-3DB2-CA7477066381}"/>
                  </a:ext>
                </a:extLst>
              </p:cNvPr>
              <p:cNvSpPr txBox="1"/>
              <p:nvPr/>
            </p:nvSpPr>
            <p:spPr>
              <a:xfrm>
                <a:off x="9590576" y="594874"/>
                <a:ext cx="47783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**</a:t>
                </a:r>
              </a:p>
            </p:txBody>
          </p:sp>
          <p:sp>
            <p:nvSpPr>
              <p:cNvPr id="77" name="Line 175">
                <a:extLst>
                  <a:ext uri="{FF2B5EF4-FFF2-40B4-BE49-F238E27FC236}">
                    <a16:creationId xmlns:a16="http://schemas.microsoft.com/office/drawing/2014/main" id="{9A1F551A-5AA0-8BEB-E249-087683C39E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667191" y="523565"/>
                <a:ext cx="936000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78" name="Szövegdoboz 77">
                <a:extLst>
                  <a:ext uri="{FF2B5EF4-FFF2-40B4-BE49-F238E27FC236}">
                    <a16:creationId xmlns:a16="http://schemas.microsoft.com/office/drawing/2014/main" id="{955BE781-4307-9D0F-96F1-921BB37EC512}"/>
                  </a:ext>
                </a:extLst>
              </p:cNvPr>
              <p:cNvSpPr txBox="1"/>
              <p:nvPr/>
            </p:nvSpPr>
            <p:spPr>
              <a:xfrm>
                <a:off x="8691003" y="293393"/>
                <a:ext cx="89957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0.08</a:t>
                </a:r>
              </a:p>
            </p:txBody>
          </p:sp>
          <p:sp>
            <p:nvSpPr>
              <p:cNvPr id="79" name="Line 175">
                <a:extLst>
                  <a:ext uri="{FF2B5EF4-FFF2-40B4-BE49-F238E27FC236}">
                    <a16:creationId xmlns:a16="http://schemas.microsoft.com/office/drawing/2014/main" id="{45063B25-1C2D-DD4E-B0B1-73E5D2E19AE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659812" y="255751"/>
                <a:ext cx="1893600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80" name="Szövegdoboz 79">
                <a:extLst>
                  <a:ext uri="{FF2B5EF4-FFF2-40B4-BE49-F238E27FC236}">
                    <a16:creationId xmlns:a16="http://schemas.microsoft.com/office/drawing/2014/main" id="{93286CC6-1CB5-EB7D-02CE-0E8926DE704C}"/>
                  </a:ext>
                </a:extLst>
              </p:cNvPr>
              <p:cNvSpPr txBox="1"/>
              <p:nvPr/>
            </p:nvSpPr>
            <p:spPr>
              <a:xfrm>
                <a:off x="8648699" y="33829"/>
                <a:ext cx="191293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**</a:t>
                </a:r>
              </a:p>
            </p:txBody>
          </p:sp>
        </p:grpSp>
        <p:grpSp>
          <p:nvGrpSpPr>
            <p:cNvPr id="211" name="Csoportba foglalás 210">
              <a:extLst>
                <a:ext uri="{FF2B5EF4-FFF2-40B4-BE49-F238E27FC236}">
                  <a16:creationId xmlns:a16="http://schemas.microsoft.com/office/drawing/2014/main" id="{D2EDA300-8AD9-57F2-3B3F-9C3F295AB56F}"/>
                </a:ext>
              </a:extLst>
            </p:cNvPr>
            <p:cNvGrpSpPr/>
            <p:nvPr/>
          </p:nvGrpSpPr>
          <p:grpSpPr>
            <a:xfrm>
              <a:off x="4071423" y="2175334"/>
              <a:ext cx="1352477" cy="540256"/>
              <a:chOff x="7775273" y="2190113"/>
              <a:chExt cx="1352477" cy="540256"/>
            </a:xfrm>
          </p:grpSpPr>
          <p:sp>
            <p:nvSpPr>
              <p:cNvPr id="212" name="Szövegdoboz 211">
                <a:extLst>
                  <a:ext uri="{FF2B5EF4-FFF2-40B4-BE49-F238E27FC236}">
                    <a16:creationId xmlns:a16="http://schemas.microsoft.com/office/drawing/2014/main" id="{0FE3CF4C-1292-D39E-74A8-3D761056069E}"/>
                  </a:ext>
                </a:extLst>
              </p:cNvPr>
              <p:cNvSpPr txBox="1"/>
              <p:nvPr/>
            </p:nvSpPr>
            <p:spPr>
              <a:xfrm>
                <a:off x="8231281" y="2190113"/>
                <a:ext cx="89170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D107a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+</a:t>
                </a:r>
              </a:p>
            </p:txBody>
          </p:sp>
          <p:sp>
            <p:nvSpPr>
              <p:cNvPr id="213" name="Freeform 153">
                <a:extLst>
                  <a:ext uri="{FF2B5EF4-FFF2-40B4-BE49-F238E27FC236}">
                    <a16:creationId xmlns:a16="http://schemas.microsoft.com/office/drawing/2014/main" id="{70A09B8A-C551-87F5-C79D-0928A19E15F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775273" y="2269105"/>
                <a:ext cx="135872" cy="127784"/>
              </a:xfrm>
              <a:custGeom>
                <a:avLst/>
                <a:gdLst>
                  <a:gd name="T0" fmla="*/ 0 w 238"/>
                  <a:gd name="T1" fmla="*/ 424 h 424"/>
                  <a:gd name="T2" fmla="*/ 238 w 238"/>
                  <a:gd name="T3" fmla="*/ 424 h 424"/>
                  <a:gd name="T4" fmla="*/ 238 w 238"/>
                  <a:gd name="T5" fmla="*/ 424 h 424"/>
                  <a:gd name="T6" fmla="*/ 238 w 238"/>
                  <a:gd name="T7" fmla="*/ 287 h 424"/>
                  <a:gd name="T8" fmla="*/ 238 w 238"/>
                  <a:gd name="T9" fmla="*/ 0 h 424"/>
                  <a:gd name="T10" fmla="*/ 238 w 238"/>
                  <a:gd name="T11" fmla="*/ 0 h 424"/>
                  <a:gd name="T12" fmla="*/ 0 w 238"/>
                  <a:gd name="T13" fmla="*/ 0 h 424"/>
                  <a:gd name="T14" fmla="*/ 0 w 238"/>
                  <a:gd name="T15" fmla="*/ 0 h 424"/>
                  <a:gd name="T16" fmla="*/ 0 w 238"/>
                  <a:gd name="T17" fmla="*/ 287 h 424"/>
                  <a:gd name="T18" fmla="*/ 0 w 238"/>
                  <a:gd name="T19" fmla="*/ 424 h 4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238" h="424">
                    <a:moveTo>
                      <a:pt x="0" y="424"/>
                    </a:moveTo>
                    <a:lnTo>
                      <a:pt x="238" y="424"/>
                    </a:lnTo>
                    <a:lnTo>
                      <a:pt x="238" y="424"/>
                    </a:lnTo>
                    <a:lnTo>
                      <a:pt x="238" y="287"/>
                    </a:lnTo>
                    <a:lnTo>
                      <a:pt x="238" y="0"/>
                    </a:lnTo>
                    <a:lnTo>
                      <a:pt x="238" y="0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0" y="287"/>
                    </a:lnTo>
                    <a:lnTo>
                      <a:pt x="0" y="424"/>
                    </a:lnTo>
                  </a:path>
                </a:pathLst>
              </a:custGeom>
              <a:noFill/>
              <a:ln w="4763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14" name="Freeform 153">
                <a:extLst>
                  <a:ext uri="{FF2B5EF4-FFF2-40B4-BE49-F238E27FC236}">
                    <a16:creationId xmlns:a16="http://schemas.microsoft.com/office/drawing/2014/main" id="{259B2BE9-477F-A391-FA53-AAD6DEB28A5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958672" y="2268744"/>
                <a:ext cx="135872" cy="127784"/>
              </a:xfrm>
              <a:custGeom>
                <a:avLst/>
                <a:gdLst>
                  <a:gd name="T0" fmla="*/ 0 w 238"/>
                  <a:gd name="T1" fmla="*/ 424 h 424"/>
                  <a:gd name="T2" fmla="*/ 238 w 238"/>
                  <a:gd name="T3" fmla="*/ 424 h 424"/>
                  <a:gd name="T4" fmla="*/ 238 w 238"/>
                  <a:gd name="T5" fmla="*/ 424 h 424"/>
                  <a:gd name="T6" fmla="*/ 238 w 238"/>
                  <a:gd name="T7" fmla="*/ 287 h 424"/>
                  <a:gd name="T8" fmla="*/ 238 w 238"/>
                  <a:gd name="T9" fmla="*/ 0 h 424"/>
                  <a:gd name="T10" fmla="*/ 238 w 238"/>
                  <a:gd name="T11" fmla="*/ 0 h 424"/>
                  <a:gd name="T12" fmla="*/ 0 w 238"/>
                  <a:gd name="T13" fmla="*/ 0 h 424"/>
                  <a:gd name="T14" fmla="*/ 0 w 238"/>
                  <a:gd name="T15" fmla="*/ 0 h 424"/>
                  <a:gd name="T16" fmla="*/ 0 w 238"/>
                  <a:gd name="T17" fmla="*/ 287 h 424"/>
                  <a:gd name="T18" fmla="*/ 0 w 238"/>
                  <a:gd name="T19" fmla="*/ 424 h 4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238" h="424">
                    <a:moveTo>
                      <a:pt x="0" y="424"/>
                    </a:moveTo>
                    <a:lnTo>
                      <a:pt x="238" y="424"/>
                    </a:lnTo>
                    <a:lnTo>
                      <a:pt x="238" y="424"/>
                    </a:lnTo>
                    <a:lnTo>
                      <a:pt x="238" y="287"/>
                    </a:lnTo>
                    <a:lnTo>
                      <a:pt x="238" y="0"/>
                    </a:lnTo>
                    <a:lnTo>
                      <a:pt x="238" y="0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0" y="287"/>
                    </a:lnTo>
                    <a:lnTo>
                      <a:pt x="0" y="424"/>
                    </a:lnTo>
                  </a:path>
                </a:pathLst>
              </a:cu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15" name="Freeform 153">
                <a:extLst>
                  <a:ext uri="{FF2B5EF4-FFF2-40B4-BE49-F238E27FC236}">
                    <a16:creationId xmlns:a16="http://schemas.microsoft.com/office/drawing/2014/main" id="{B4764D90-8DBF-38D2-A523-9EF772EA14D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142070" y="2269752"/>
                <a:ext cx="135872" cy="127784"/>
              </a:xfrm>
              <a:custGeom>
                <a:avLst/>
                <a:gdLst>
                  <a:gd name="T0" fmla="*/ 0 w 238"/>
                  <a:gd name="T1" fmla="*/ 424 h 424"/>
                  <a:gd name="T2" fmla="*/ 238 w 238"/>
                  <a:gd name="T3" fmla="*/ 424 h 424"/>
                  <a:gd name="T4" fmla="*/ 238 w 238"/>
                  <a:gd name="T5" fmla="*/ 424 h 424"/>
                  <a:gd name="T6" fmla="*/ 238 w 238"/>
                  <a:gd name="T7" fmla="*/ 287 h 424"/>
                  <a:gd name="T8" fmla="*/ 238 w 238"/>
                  <a:gd name="T9" fmla="*/ 0 h 424"/>
                  <a:gd name="T10" fmla="*/ 238 w 238"/>
                  <a:gd name="T11" fmla="*/ 0 h 424"/>
                  <a:gd name="T12" fmla="*/ 0 w 238"/>
                  <a:gd name="T13" fmla="*/ 0 h 424"/>
                  <a:gd name="T14" fmla="*/ 0 w 238"/>
                  <a:gd name="T15" fmla="*/ 0 h 424"/>
                  <a:gd name="T16" fmla="*/ 0 w 238"/>
                  <a:gd name="T17" fmla="*/ 287 h 424"/>
                  <a:gd name="T18" fmla="*/ 0 w 238"/>
                  <a:gd name="T19" fmla="*/ 424 h 4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238" h="424">
                    <a:moveTo>
                      <a:pt x="0" y="424"/>
                    </a:moveTo>
                    <a:lnTo>
                      <a:pt x="238" y="424"/>
                    </a:lnTo>
                    <a:lnTo>
                      <a:pt x="238" y="424"/>
                    </a:lnTo>
                    <a:lnTo>
                      <a:pt x="238" y="287"/>
                    </a:lnTo>
                    <a:lnTo>
                      <a:pt x="238" y="0"/>
                    </a:lnTo>
                    <a:lnTo>
                      <a:pt x="238" y="0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0" y="287"/>
                    </a:lnTo>
                    <a:lnTo>
                      <a:pt x="0" y="424"/>
                    </a:lnTo>
                  </a:path>
                </a:pathLst>
              </a:cu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16" name="Freeform 153">
                <a:extLst>
                  <a:ext uri="{FF2B5EF4-FFF2-40B4-BE49-F238E27FC236}">
                    <a16:creationId xmlns:a16="http://schemas.microsoft.com/office/drawing/2014/main" id="{587C029B-EFC3-86EC-780E-8CFB9C2D3F9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776358" y="2526268"/>
                <a:ext cx="135872" cy="131858"/>
              </a:xfrm>
              <a:custGeom>
                <a:avLst/>
                <a:gdLst>
                  <a:gd name="T0" fmla="*/ 0 w 238"/>
                  <a:gd name="T1" fmla="*/ 424 h 424"/>
                  <a:gd name="T2" fmla="*/ 238 w 238"/>
                  <a:gd name="T3" fmla="*/ 424 h 424"/>
                  <a:gd name="T4" fmla="*/ 238 w 238"/>
                  <a:gd name="T5" fmla="*/ 424 h 424"/>
                  <a:gd name="T6" fmla="*/ 238 w 238"/>
                  <a:gd name="T7" fmla="*/ 287 h 424"/>
                  <a:gd name="T8" fmla="*/ 238 w 238"/>
                  <a:gd name="T9" fmla="*/ 0 h 424"/>
                  <a:gd name="T10" fmla="*/ 238 w 238"/>
                  <a:gd name="T11" fmla="*/ 0 h 424"/>
                  <a:gd name="T12" fmla="*/ 0 w 238"/>
                  <a:gd name="T13" fmla="*/ 0 h 424"/>
                  <a:gd name="T14" fmla="*/ 0 w 238"/>
                  <a:gd name="T15" fmla="*/ 0 h 424"/>
                  <a:gd name="T16" fmla="*/ 0 w 238"/>
                  <a:gd name="T17" fmla="*/ 287 h 424"/>
                  <a:gd name="T18" fmla="*/ 0 w 238"/>
                  <a:gd name="T19" fmla="*/ 424 h 4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238" h="424">
                    <a:moveTo>
                      <a:pt x="0" y="424"/>
                    </a:moveTo>
                    <a:lnTo>
                      <a:pt x="238" y="424"/>
                    </a:lnTo>
                    <a:lnTo>
                      <a:pt x="238" y="424"/>
                    </a:lnTo>
                    <a:lnTo>
                      <a:pt x="238" y="287"/>
                    </a:lnTo>
                    <a:lnTo>
                      <a:pt x="238" y="0"/>
                    </a:lnTo>
                    <a:lnTo>
                      <a:pt x="238" y="0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0" y="287"/>
                    </a:lnTo>
                    <a:lnTo>
                      <a:pt x="0" y="424"/>
                    </a:lnTo>
                  </a:path>
                </a:pathLst>
              </a:custGeom>
              <a:pattFill prst="pct25">
                <a:fgClr>
                  <a:schemeClr val="tx1"/>
                </a:fgClr>
                <a:bgClr>
                  <a:schemeClr val="bg1"/>
                </a:bgClr>
              </a:pattFill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17" name="Freeform 153">
                <a:extLst>
                  <a:ext uri="{FF2B5EF4-FFF2-40B4-BE49-F238E27FC236}">
                    <a16:creationId xmlns:a16="http://schemas.microsoft.com/office/drawing/2014/main" id="{E5298D93-64A2-86DE-BC4F-D363AE47548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959757" y="2525906"/>
                <a:ext cx="135872" cy="131858"/>
              </a:xfrm>
              <a:custGeom>
                <a:avLst/>
                <a:gdLst>
                  <a:gd name="T0" fmla="*/ 0 w 238"/>
                  <a:gd name="T1" fmla="*/ 424 h 424"/>
                  <a:gd name="T2" fmla="*/ 238 w 238"/>
                  <a:gd name="T3" fmla="*/ 424 h 424"/>
                  <a:gd name="T4" fmla="*/ 238 w 238"/>
                  <a:gd name="T5" fmla="*/ 424 h 424"/>
                  <a:gd name="T6" fmla="*/ 238 w 238"/>
                  <a:gd name="T7" fmla="*/ 287 h 424"/>
                  <a:gd name="T8" fmla="*/ 238 w 238"/>
                  <a:gd name="T9" fmla="*/ 0 h 424"/>
                  <a:gd name="T10" fmla="*/ 238 w 238"/>
                  <a:gd name="T11" fmla="*/ 0 h 424"/>
                  <a:gd name="T12" fmla="*/ 0 w 238"/>
                  <a:gd name="T13" fmla="*/ 0 h 424"/>
                  <a:gd name="T14" fmla="*/ 0 w 238"/>
                  <a:gd name="T15" fmla="*/ 0 h 424"/>
                  <a:gd name="T16" fmla="*/ 0 w 238"/>
                  <a:gd name="T17" fmla="*/ 287 h 424"/>
                  <a:gd name="T18" fmla="*/ 0 w 238"/>
                  <a:gd name="T19" fmla="*/ 424 h 4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238" h="424">
                    <a:moveTo>
                      <a:pt x="0" y="424"/>
                    </a:moveTo>
                    <a:lnTo>
                      <a:pt x="238" y="424"/>
                    </a:lnTo>
                    <a:lnTo>
                      <a:pt x="238" y="424"/>
                    </a:lnTo>
                    <a:lnTo>
                      <a:pt x="238" y="287"/>
                    </a:lnTo>
                    <a:lnTo>
                      <a:pt x="238" y="0"/>
                    </a:lnTo>
                    <a:lnTo>
                      <a:pt x="238" y="0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0" y="287"/>
                    </a:lnTo>
                    <a:lnTo>
                      <a:pt x="0" y="424"/>
                    </a:lnTo>
                  </a:path>
                </a:pathLst>
              </a:custGeom>
              <a:pattFill prst="pct25">
                <a:fgClr>
                  <a:srgbClr val="FF0000"/>
                </a:fgClr>
                <a:bgClr>
                  <a:schemeClr val="bg1"/>
                </a:bgClr>
              </a:pattFill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18" name="Freeform 153">
                <a:extLst>
                  <a:ext uri="{FF2B5EF4-FFF2-40B4-BE49-F238E27FC236}">
                    <a16:creationId xmlns:a16="http://schemas.microsoft.com/office/drawing/2014/main" id="{1FBA7AA9-7EB7-36E4-6879-153C072BE4A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143156" y="2526916"/>
                <a:ext cx="135872" cy="131858"/>
              </a:xfrm>
              <a:custGeom>
                <a:avLst/>
                <a:gdLst>
                  <a:gd name="T0" fmla="*/ 0 w 238"/>
                  <a:gd name="T1" fmla="*/ 424 h 424"/>
                  <a:gd name="T2" fmla="*/ 238 w 238"/>
                  <a:gd name="T3" fmla="*/ 424 h 424"/>
                  <a:gd name="T4" fmla="*/ 238 w 238"/>
                  <a:gd name="T5" fmla="*/ 424 h 424"/>
                  <a:gd name="T6" fmla="*/ 238 w 238"/>
                  <a:gd name="T7" fmla="*/ 287 h 424"/>
                  <a:gd name="T8" fmla="*/ 238 w 238"/>
                  <a:gd name="T9" fmla="*/ 0 h 424"/>
                  <a:gd name="T10" fmla="*/ 238 w 238"/>
                  <a:gd name="T11" fmla="*/ 0 h 424"/>
                  <a:gd name="T12" fmla="*/ 0 w 238"/>
                  <a:gd name="T13" fmla="*/ 0 h 424"/>
                  <a:gd name="T14" fmla="*/ 0 w 238"/>
                  <a:gd name="T15" fmla="*/ 0 h 424"/>
                  <a:gd name="T16" fmla="*/ 0 w 238"/>
                  <a:gd name="T17" fmla="*/ 287 h 424"/>
                  <a:gd name="T18" fmla="*/ 0 w 238"/>
                  <a:gd name="T19" fmla="*/ 424 h 4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238" h="424">
                    <a:moveTo>
                      <a:pt x="0" y="424"/>
                    </a:moveTo>
                    <a:lnTo>
                      <a:pt x="238" y="424"/>
                    </a:lnTo>
                    <a:lnTo>
                      <a:pt x="238" y="424"/>
                    </a:lnTo>
                    <a:lnTo>
                      <a:pt x="238" y="287"/>
                    </a:lnTo>
                    <a:lnTo>
                      <a:pt x="238" y="0"/>
                    </a:lnTo>
                    <a:lnTo>
                      <a:pt x="238" y="0"/>
                    </a:lnTo>
                    <a:lnTo>
                      <a:pt x="0" y="0"/>
                    </a:lnTo>
                    <a:lnTo>
                      <a:pt x="0" y="0"/>
                    </a:lnTo>
                    <a:lnTo>
                      <a:pt x="0" y="287"/>
                    </a:lnTo>
                    <a:lnTo>
                      <a:pt x="0" y="424"/>
                    </a:lnTo>
                  </a:path>
                </a:pathLst>
              </a:custGeom>
              <a:pattFill prst="pct50">
                <a:fgClr>
                  <a:schemeClr val="accent1"/>
                </a:fgClr>
                <a:bgClr>
                  <a:schemeClr val="bg1"/>
                </a:bgClr>
              </a:pattFill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/>
              </a:p>
            </p:txBody>
          </p:sp>
          <p:sp>
            <p:nvSpPr>
              <p:cNvPr id="219" name="Szövegdoboz 218">
                <a:extLst>
                  <a:ext uri="{FF2B5EF4-FFF2-40B4-BE49-F238E27FC236}">
                    <a16:creationId xmlns:a16="http://schemas.microsoft.com/office/drawing/2014/main" id="{C20AAB1D-776C-0C75-9E34-803B0050E4B7}"/>
                  </a:ext>
                </a:extLst>
              </p:cNvPr>
              <p:cNvSpPr txBox="1"/>
              <p:nvPr/>
            </p:nvSpPr>
            <p:spPr>
              <a:xfrm>
                <a:off x="8230118" y="2453370"/>
                <a:ext cx="8976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D107a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-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2680999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52</TotalTime>
  <Words>432</Words>
  <Application>Microsoft Office PowerPoint</Application>
  <PresentationFormat>Widescreen</PresentationFormat>
  <Paragraphs>297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Helvetica</vt:lpstr>
      <vt:lpstr>Office-téma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Dr. Meggyes Mátyás</dc:creator>
  <cp:lastModifiedBy>Dr. Szereday László</cp:lastModifiedBy>
  <cp:revision>22</cp:revision>
  <dcterms:created xsi:type="dcterms:W3CDTF">2023-10-02T09:04:53Z</dcterms:created>
  <dcterms:modified xsi:type="dcterms:W3CDTF">2024-11-20T09:40:14Z</dcterms:modified>
</cp:coreProperties>
</file>